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8" r:id="rId3"/>
  </p:sldIdLst>
  <p:sldSz cx="9144000" cy="6858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980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0A545302-2B77-4B27-879C-E2938CE1C4BE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00FF5A2A-FAA2-4263-826D-44E0F45096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0581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054C7-AAFF-4554-8D79-91919F796AE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96096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054C7-AAFF-4554-8D79-91919F796AE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41682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065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1279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6499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850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30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412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6261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229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4960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319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4268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9116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12" Type="http://schemas.openxmlformats.org/officeDocument/2006/relationships/image" Target="../media/image2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18358" y="2852936"/>
            <a:ext cx="8988801" cy="2101356"/>
            <a:chOff x="18358" y="772191"/>
            <a:chExt cx="8988801" cy="2101356"/>
          </a:xfrm>
        </p:grpSpPr>
        <p:pic>
          <p:nvPicPr>
            <p:cNvPr id="1036" name="Picture 1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80502" y="772191"/>
              <a:ext cx="2115501" cy="20917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12886" y="1267399"/>
              <a:ext cx="1655531" cy="16047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70" y="1268760"/>
              <a:ext cx="1655531" cy="16047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29220" y="1268760"/>
              <a:ext cx="1655531" cy="16047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04931" y="1259135"/>
              <a:ext cx="1655531" cy="16047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7" name="テキスト ボックス 46"/>
            <p:cNvSpPr txBox="1"/>
            <p:nvPr/>
          </p:nvSpPr>
          <p:spPr>
            <a:xfrm>
              <a:off x="18358" y="871838"/>
              <a:ext cx="172717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ALS case </a:t>
              </a:r>
              <a:r>
                <a:rPr kumimoji="1" lang="en-US" altLang="ja-JP" sz="1400" b="1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(</a:t>
              </a:r>
              <a:r>
                <a:rPr lang="en-US" altLang="ja-JP" sz="1400" b="1" dirty="0" err="1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PtB</a:t>
              </a:r>
              <a:r>
                <a:rPr kumimoji="1" lang="en-US" altLang="ja-JP" sz="1400" b="1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)</a:t>
              </a:r>
              <a:endParaRPr kumimoji="1" lang="ja-JP" altLang="en-US" sz="14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233655" y="1230949"/>
              <a:ext cx="15373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 smtClean="0">
                  <a:solidFill>
                    <a:srgbClr val="92D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NEAT1_2/</a:t>
              </a:r>
              <a:r>
                <a:rPr lang="en-US" altLang="ja-JP" sz="1200" b="1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Hoechst</a:t>
              </a:r>
              <a:endParaRPr lang="ja-JP" altLang="en-US" sz="1200" b="1" dirty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58" name="テキスト ボックス 57"/>
            <p:cNvSpPr txBox="1"/>
            <p:nvPr/>
          </p:nvSpPr>
          <p:spPr>
            <a:xfrm>
              <a:off x="2258119" y="1244877"/>
              <a:ext cx="14531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solidFill>
                    <a:schemeClr val="bg1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NEAT1_2</a:t>
              </a:r>
              <a:endParaRPr lang="en-US" altLang="ja-JP" sz="1200" b="1" dirty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3869222" y="1239885"/>
              <a:ext cx="1475656" cy="276999"/>
            </a:xfrm>
            <a:prstGeom prst="rect">
              <a:avLst/>
            </a:prstGeom>
            <a:noFill/>
            <a:ln w="34925"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 smtClean="0">
                  <a:solidFill>
                    <a:srgbClr val="FF000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PSP1/</a:t>
              </a:r>
              <a:r>
                <a:rPr kumimoji="1" lang="en-US" altLang="ja-JP" sz="1200" b="1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Hoechst</a:t>
              </a:r>
              <a:endParaRPr kumimoji="1" lang="ja-JP" altLang="en-US" sz="1200" b="1" dirty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6189577" y="1259135"/>
              <a:ext cx="590925" cy="276999"/>
            </a:xfrm>
            <a:prstGeom prst="rect">
              <a:avLst/>
            </a:prstGeom>
            <a:noFill/>
            <a:ln w="34925"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 smtClean="0">
                  <a:solidFill>
                    <a:schemeClr val="bg1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PSP1</a:t>
              </a:r>
              <a:endParaRPr kumimoji="1" lang="ja-JP" altLang="en-US" sz="1200" b="1" dirty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7206959" y="1250288"/>
              <a:ext cx="1800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 smtClean="0">
                  <a:solidFill>
                    <a:srgbClr val="92D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NEAT1_2/</a:t>
              </a:r>
              <a:r>
                <a:rPr lang="en-US" altLang="ja-JP" sz="1200" b="1" dirty="0" smtClean="0">
                  <a:solidFill>
                    <a:srgbClr val="FF000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PSP1</a:t>
              </a:r>
              <a:endParaRPr lang="ja-JP" altLang="en-US" sz="1200" b="1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cxnSp>
          <p:nvCxnSpPr>
            <p:cNvPr id="131" name="直線コネクタ 130"/>
            <p:cNvCxnSpPr/>
            <p:nvPr/>
          </p:nvCxnSpPr>
          <p:spPr>
            <a:xfrm>
              <a:off x="6054039" y="2780928"/>
              <a:ext cx="619497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フリーフォーム 8"/>
            <p:cNvSpPr/>
            <p:nvPr/>
          </p:nvSpPr>
          <p:spPr>
            <a:xfrm>
              <a:off x="3609975" y="1701800"/>
              <a:ext cx="1134325" cy="679450"/>
            </a:xfrm>
            <a:custGeom>
              <a:avLst/>
              <a:gdLst>
                <a:gd name="connsiteX0" fmla="*/ 806450 w 1134325"/>
                <a:gd name="connsiteY0" fmla="*/ 12700 h 679450"/>
                <a:gd name="connsiteX1" fmla="*/ 762000 w 1134325"/>
                <a:gd name="connsiteY1" fmla="*/ 15875 h 679450"/>
                <a:gd name="connsiteX2" fmla="*/ 742950 w 1134325"/>
                <a:gd name="connsiteY2" fmla="*/ 22225 h 679450"/>
                <a:gd name="connsiteX3" fmla="*/ 723900 w 1134325"/>
                <a:gd name="connsiteY3" fmla="*/ 34925 h 679450"/>
                <a:gd name="connsiteX4" fmla="*/ 708025 w 1134325"/>
                <a:gd name="connsiteY4" fmla="*/ 38100 h 679450"/>
                <a:gd name="connsiteX5" fmla="*/ 650875 w 1134325"/>
                <a:gd name="connsiteY5" fmla="*/ 41275 h 679450"/>
                <a:gd name="connsiteX6" fmla="*/ 587375 w 1134325"/>
                <a:gd name="connsiteY6" fmla="*/ 38100 h 679450"/>
                <a:gd name="connsiteX7" fmla="*/ 574675 w 1134325"/>
                <a:gd name="connsiteY7" fmla="*/ 34925 h 679450"/>
                <a:gd name="connsiteX8" fmla="*/ 447675 w 1134325"/>
                <a:gd name="connsiteY8" fmla="*/ 38100 h 679450"/>
                <a:gd name="connsiteX9" fmla="*/ 425450 w 1134325"/>
                <a:gd name="connsiteY9" fmla="*/ 44450 h 679450"/>
                <a:gd name="connsiteX10" fmla="*/ 412750 w 1134325"/>
                <a:gd name="connsiteY10" fmla="*/ 47625 h 679450"/>
                <a:gd name="connsiteX11" fmla="*/ 393700 w 1134325"/>
                <a:gd name="connsiteY11" fmla="*/ 53975 h 679450"/>
                <a:gd name="connsiteX12" fmla="*/ 384175 w 1134325"/>
                <a:gd name="connsiteY12" fmla="*/ 57150 h 679450"/>
                <a:gd name="connsiteX13" fmla="*/ 355600 w 1134325"/>
                <a:gd name="connsiteY13" fmla="*/ 60325 h 679450"/>
                <a:gd name="connsiteX14" fmla="*/ 327025 w 1134325"/>
                <a:gd name="connsiteY14" fmla="*/ 66675 h 679450"/>
                <a:gd name="connsiteX15" fmla="*/ 282575 w 1134325"/>
                <a:gd name="connsiteY15" fmla="*/ 73025 h 679450"/>
                <a:gd name="connsiteX16" fmla="*/ 244475 w 1134325"/>
                <a:gd name="connsiteY16" fmla="*/ 85725 h 679450"/>
                <a:gd name="connsiteX17" fmla="*/ 215900 w 1134325"/>
                <a:gd name="connsiteY17" fmla="*/ 92075 h 679450"/>
                <a:gd name="connsiteX18" fmla="*/ 196850 w 1134325"/>
                <a:gd name="connsiteY18" fmla="*/ 98425 h 679450"/>
                <a:gd name="connsiteX19" fmla="*/ 187325 w 1134325"/>
                <a:gd name="connsiteY19" fmla="*/ 101600 h 679450"/>
                <a:gd name="connsiteX20" fmla="*/ 165100 w 1134325"/>
                <a:gd name="connsiteY20" fmla="*/ 130175 h 679450"/>
                <a:gd name="connsiteX21" fmla="*/ 149225 w 1134325"/>
                <a:gd name="connsiteY21" fmla="*/ 158750 h 679450"/>
                <a:gd name="connsiteX22" fmla="*/ 142875 w 1134325"/>
                <a:gd name="connsiteY22" fmla="*/ 168275 h 679450"/>
                <a:gd name="connsiteX23" fmla="*/ 133350 w 1134325"/>
                <a:gd name="connsiteY23" fmla="*/ 171450 h 679450"/>
                <a:gd name="connsiteX24" fmla="*/ 104775 w 1134325"/>
                <a:gd name="connsiteY24" fmla="*/ 190500 h 679450"/>
                <a:gd name="connsiteX25" fmla="*/ 85725 w 1134325"/>
                <a:gd name="connsiteY25" fmla="*/ 206375 h 679450"/>
                <a:gd name="connsiteX26" fmla="*/ 73025 w 1134325"/>
                <a:gd name="connsiteY26" fmla="*/ 234950 h 679450"/>
                <a:gd name="connsiteX27" fmla="*/ 63500 w 1134325"/>
                <a:gd name="connsiteY27" fmla="*/ 244475 h 679450"/>
                <a:gd name="connsiteX28" fmla="*/ 50800 w 1134325"/>
                <a:gd name="connsiteY28" fmla="*/ 263525 h 679450"/>
                <a:gd name="connsiteX29" fmla="*/ 34925 w 1134325"/>
                <a:gd name="connsiteY29" fmla="*/ 282575 h 679450"/>
                <a:gd name="connsiteX30" fmla="*/ 28575 w 1134325"/>
                <a:gd name="connsiteY30" fmla="*/ 301625 h 679450"/>
                <a:gd name="connsiteX31" fmla="*/ 22225 w 1134325"/>
                <a:gd name="connsiteY31" fmla="*/ 311150 h 679450"/>
                <a:gd name="connsiteX32" fmla="*/ 12700 w 1134325"/>
                <a:gd name="connsiteY32" fmla="*/ 330200 h 679450"/>
                <a:gd name="connsiteX33" fmla="*/ 3175 w 1134325"/>
                <a:gd name="connsiteY33" fmla="*/ 361950 h 679450"/>
                <a:gd name="connsiteX34" fmla="*/ 0 w 1134325"/>
                <a:gd name="connsiteY34" fmla="*/ 371475 h 679450"/>
                <a:gd name="connsiteX35" fmla="*/ 3175 w 1134325"/>
                <a:gd name="connsiteY35" fmla="*/ 406400 h 679450"/>
                <a:gd name="connsiteX36" fmla="*/ 9525 w 1134325"/>
                <a:gd name="connsiteY36" fmla="*/ 425450 h 679450"/>
                <a:gd name="connsiteX37" fmla="*/ 22225 w 1134325"/>
                <a:gd name="connsiteY37" fmla="*/ 463550 h 679450"/>
                <a:gd name="connsiteX38" fmla="*/ 28575 w 1134325"/>
                <a:gd name="connsiteY38" fmla="*/ 473075 h 679450"/>
                <a:gd name="connsiteX39" fmla="*/ 47625 w 1134325"/>
                <a:gd name="connsiteY39" fmla="*/ 511175 h 679450"/>
                <a:gd name="connsiteX40" fmla="*/ 60325 w 1134325"/>
                <a:gd name="connsiteY40" fmla="*/ 539750 h 679450"/>
                <a:gd name="connsiteX41" fmla="*/ 69850 w 1134325"/>
                <a:gd name="connsiteY41" fmla="*/ 546100 h 679450"/>
                <a:gd name="connsiteX42" fmla="*/ 85725 w 1134325"/>
                <a:gd name="connsiteY42" fmla="*/ 568325 h 679450"/>
                <a:gd name="connsiteX43" fmla="*/ 95250 w 1134325"/>
                <a:gd name="connsiteY43" fmla="*/ 571500 h 679450"/>
                <a:gd name="connsiteX44" fmla="*/ 98425 w 1134325"/>
                <a:gd name="connsiteY44" fmla="*/ 581025 h 679450"/>
                <a:gd name="connsiteX45" fmla="*/ 117475 w 1134325"/>
                <a:gd name="connsiteY45" fmla="*/ 593725 h 679450"/>
                <a:gd name="connsiteX46" fmla="*/ 127000 w 1134325"/>
                <a:gd name="connsiteY46" fmla="*/ 612775 h 679450"/>
                <a:gd name="connsiteX47" fmla="*/ 136525 w 1134325"/>
                <a:gd name="connsiteY47" fmla="*/ 619125 h 679450"/>
                <a:gd name="connsiteX48" fmla="*/ 165100 w 1134325"/>
                <a:gd name="connsiteY48" fmla="*/ 641350 h 679450"/>
                <a:gd name="connsiteX49" fmla="*/ 184150 w 1134325"/>
                <a:gd name="connsiteY49" fmla="*/ 647700 h 679450"/>
                <a:gd name="connsiteX50" fmla="*/ 206375 w 1134325"/>
                <a:gd name="connsiteY50" fmla="*/ 644525 h 679450"/>
                <a:gd name="connsiteX51" fmla="*/ 225425 w 1134325"/>
                <a:gd name="connsiteY51" fmla="*/ 638175 h 679450"/>
                <a:gd name="connsiteX52" fmla="*/ 238125 w 1134325"/>
                <a:gd name="connsiteY52" fmla="*/ 619125 h 679450"/>
                <a:gd name="connsiteX53" fmla="*/ 266700 w 1134325"/>
                <a:gd name="connsiteY53" fmla="*/ 600075 h 679450"/>
                <a:gd name="connsiteX54" fmla="*/ 276225 w 1134325"/>
                <a:gd name="connsiteY54" fmla="*/ 593725 h 679450"/>
                <a:gd name="connsiteX55" fmla="*/ 285750 w 1134325"/>
                <a:gd name="connsiteY55" fmla="*/ 587375 h 679450"/>
                <a:gd name="connsiteX56" fmla="*/ 292100 w 1134325"/>
                <a:gd name="connsiteY56" fmla="*/ 565150 h 679450"/>
                <a:gd name="connsiteX57" fmla="*/ 295275 w 1134325"/>
                <a:gd name="connsiteY57" fmla="*/ 555625 h 679450"/>
                <a:gd name="connsiteX58" fmla="*/ 314325 w 1134325"/>
                <a:gd name="connsiteY58" fmla="*/ 549275 h 679450"/>
                <a:gd name="connsiteX59" fmla="*/ 339725 w 1134325"/>
                <a:gd name="connsiteY59" fmla="*/ 552450 h 679450"/>
                <a:gd name="connsiteX60" fmla="*/ 349250 w 1134325"/>
                <a:gd name="connsiteY60" fmla="*/ 555625 h 679450"/>
                <a:gd name="connsiteX61" fmla="*/ 365125 w 1134325"/>
                <a:gd name="connsiteY61" fmla="*/ 584200 h 679450"/>
                <a:gd name="connsiteX62" fmla="*/ 371475 w 1134325"/>
                <a:gd name="connsiteY62" fmla="*/ 593725 h 679450"/>
                <a:gd name="connsiteX63" fmla="*/ 374650 w 1134325"/>
                <a:gd name="connsiteY63" fmla="*/ 603250 h 679450"/>
                <a:gd name="connsiteX64" fmla="*/ 381000 w 1134325"/>
                <a:gd name="connsiteY64" fmla="*/ 612775 h 679450"/>
                <a:gd name="connsiteX65" fmla="*/ 390525 w 1134325"/>
                <a:gd name="connsiteY65" fmla="*/ 631825 h 679450"/>
                <a:gd name="connsiteX66" fmla="*/ 400050 w 1134325"/>
                <a:gd name="connsiteY66" fmla="*/ 638175 h 679450"/>
                <a:gd name="connsiteX67" fmla="*/ 406400 w 1134325"/>
                <a:gd name="connsiteY67" fmla="*/ 647700 h 679450"/>
                <a:gd name="connsiteX68" fmla="*/ 425450 w 1134325"/>
                <a:gd name="connsiteY68" fmla="*/ 654050 h 679450"/>
                <a:gd name="connsiteX69" fmla="*/ 434975 w 1134325"/>
                <a:gd name="connsiteY69" fmla="*/ 657225 h 679450"/>
                <a:gd name="connsiteX70" fmla="*/ 444500 w 1134325"/>
                <a:gd name="connsiteY70" fmla="*/ 660400 h 679450"/>
                <a:gd name="connsiteX71" fmla="*/ 457200 w 1134325"/>
                <a:gd name="connsiteY71" fmla="*/ 666750 h 679450"/>
                <a:gd name="connsiteX72" fmla="*/ 469900 w 1134325"/>
                <a:gd name="connsiteY72" fmla="*/ 669925 h 679450"/>
                <a:gd name="connsiteX73" fmla="*/ 488950 w 1134325"/>
                <a:gd name="connsiteY73" fmla="*/ 676275 h 679450"/>
                <a:gd name="connsiteX74" fmla="*/ 498475 w 1134325"/>
                <a:gd name="connsiteY74" fmla="*/ 679450 h 679450"/>
                <a:gd name="connsiteX75" fmla="*/ 593725 w 1134325"/>
                <a:gd name="connsiteY75" fmla="*/ 676275 h 679450"/>
                <a:gd name="connsiteX76" fmla="*/ 615950 w 1134325"/>
                <a:gd name="connsiteY76" fmla="*/ 669925 h 679450"/>
                <a:gd name="connsiteX77" fmla="*/ 631825 w 1134325"/>
                <a:gd name="connsiteY77" fmla="*/ 666750 h 679450"/>
                <a:gd name="connsiteX78" fmla="*/ 673100 w 1134325"/>
                <a:gd name="connsiteY78" fmla="*/ 663575 h 679450"/>
                <a:gd name="connsiteX79" fmla="*/ 698500 w 1134325"/>
                <a:gd name="connsiteY79" fmla="*/ 660400 h 679450"/>
                <a:gd name="connsiteX80" fmla="*/ 708025 w 1134325"/>
                <a:gd name="connsiteY80" fmla="*/ 657225 h 679450"/>
                <a:gd name="connsiteX81" fmla="*/ 742950 w 1134325"/>
                <a:gd name="connsiteY81" fmla="*/ 650875 h 679450"/>
                <a:gd name="connsiteX82" fmla="*/ 752475 w 1134325"/>
                <a:gd name="connsiteY82" fmla="*/ 647700 h 679450"/>
                <a:gd name="connsiteX83" fmla="*/ 762000 w 1134325"/>
                <a:gd name="connsiteY83" fmla="*/ 641350 h 679450"/>
                <a:gd name="connsiteX84" fmla="*/ 781050 w 1134325"/>
                <a:gd name="connsiteY84" fmla="*/ 635000 h 679450"/>
                <a:gd name="connsiteX85" fmla="*/ 790575 w 1134325"/>
                <a:gd name="connsiteY85" fmla="*/ 628650 h 679450"/>
                <a:gd name="connsiteX86" fmla="*/ 809625 w 1134325"/>
                <a:gd name="connsiteY86" fmla="*/ 622300 h 679450"/>
                <a:gd name="connsiteX87" fmla="*/ 831850 w 1134325"/>
                <a:gd name="connsiteY87" fmla="*/ 615950 h 679450"/>
                <a:gd name="connsiteX88" fmla="*/ 860425 w 1134325"/>
                <a:gd name="connsiteY88" fmla="*/ 596900 h 679450"/>
                <a:gd name="connsiteX89" fmla="*/ 879475 w 1134325"/>
                <a:gd name="connsiteY89" fmla="*/ 590550 h 679450"/>
                <a:gd name="connsiteX90" fmla="*/ 889000 w 1134325"/>
                <a:gd name="connsiteY90" fmla="*/ 584200 h 679450"/>
                <a:gd name="connsiteX91" fmla="*/ 898525 w 1134325"/>
                <a:gd name="connsiteY91" fmla="*/ 574675 h 679450"/>
                <a:gd name="connsiteX92" fmla="*/ 908050 w 1134325"/>
                <a:gd name="connsiteY92" fmla="*/ 571500 h 679450"/>
                <a:gd name="connsiteX93" fmla="*/ 920750 w 1134325"/>
                <a:gd name="connsiteY93" fmla="*/ 552450 h 679450"/>
                <a:gd name="connsiteX94" fmla="*/ 923925 w 1134325"/>
                <a:gd name="connsiteY94" fmla="*/ 542925 h 679450"/>
                <a:gd name="connsiteX95" fmla="*/ 933450 w 1134325"/>
                <a:gd name="connsiteY95" fmla="*/ 536575 h 679450"/>
                <a:gd name="connsiteX96" fmla="*/ 942975 w 1134325"/>
                <a:gd name="connsiteY96" fmla="*/ 517525 h 679450"/>
                <a:gd name="connsiteX97" fmla="*/ 946150 w 1134325"/>
                <a:gd name="connsiteY97" fmla="*/ 508000 h 679450"/>
                <a:gd name="connsiteX98" fmla="*/ 965200 w 1134325"/>
                <a:gd name="connsiteY98" fmla="*/ 498475 h 679450"/>
                <a:gd name="connsiteX99" fmla="*/ 987425 w 1134325"/>
                <a:gd name="connsiteY99" fmla="*/ 485775 h 679450"/>
                <a:gd name="connsiteX100" fmla="*/ 1006475 w 1134325"/>
                <a:gd name="connsiteY100" fmla="*/ 476250 h 679450"/>
                <a:gd name="connsiteX101" fmla="*/ 1092200 w 1134325"/>
                <a:gd name="connsiteY101" fmla="*/ 469900 h 679450"/>
                <a:gd name="connsiteX102" fmla="*/ 1111250 w 1134325"/>
                <a:gd name="connsiteY102" fmla="*/ 460375 h 679450"/>
                <a:gd name="connsiteX103" fmla="*/ 1114425 w 1134325"/>
                <a:gd name="connsiteY103" fmla="*/ 450850 h 679450"/>
                <a:gd name="connsiteX104" fmla="*/ 1120775 w 1134325"/>
                <a:gd name="connsiteY104" fmla="*/ 441325 h 679450"/>
                <a:gd name="connsiteX105" fmla="*/ 1127125 w 1134325"/>
                <a:gd name="connsiteY105" fmla="*/ 422275 h 679450"/>
                <a:gd name="connsiteX106" fmla="*/ 1130300 w 1134325"/>
                <a:gd name="connsiteY106" fmla="*/ 412750 h 679450"/>
                <a:gd name="connsiteX107" fmla="*/ 1133475 w 1134325"/>
                <a:gd name="connsiteY107" fmla="*/ 361950 h 679450"/>
                <a:gd name="connsiteX108" fmla="*/ 1123950 w 1134325"/>
                <a:gd name="connsiteY108" fmla="*/ 257175 h 679450"/>
                <a:gd name="connsiteX109" fmla="*/ 1120775 w 1134325"/>
                <a:gd name="connsiteY109" fmla="*/ 238125 h 679450"/>
                <a:gd name="connsiteX110" fmla="*/ 1114425 w 1134325"/>
                <a:gd name="connsiteY110" fmla="*/ 228600 h 679450"/>
                <a:gd name="connsiteX111" fmla="*/ 1098550 w 1134325"/>
                <a:gd name="connsiteY111" fmla="*/ 209550 h 679450"/>
                <a:gd name="connsiteX112" fmla="*/ 1089025 w 1134325"/>
                <a:gd name="connsiteY112" fmla="*/ 190500 h 679450"/>
                <a:gd name="connsiteX113" fmla="*/ 1082675 w 1134325"/>
                <a:gd name="connsiteY113" fmla="*/ 180975 h 679450"/>
                <a:gd name="connsiteX114" fmla="*/ 1079500 w 1134325"/>
                <a:gd name="connsiteY114" fmla="*/ 171450 h 679450"/>
                <a:gd name="connsiteX115" fmla="*/ 1069975 w 1134325"/>
                <a:gd name="connsiteY115" fmla="*/ 165100 h 679450"/>
                <a:gd name="connsiteX116" fmla="*/ 1057275 w 1134325"/>
                <a:gd name="connsiteY116" fmla="*/ 146050 h 679450"/>
                <a:gd name="connsiteX117" fmla="*/ 1047750 w 1134325"/>
                <a:gd name="connsiteY117" fmla="*/ 136525 h 679450"/>
                <a:gd name="connsiteX118" fmla="*/ 1025525 w 1134325"/>
                <a:gd name="connsiteY118" fmla="*/ 114300 h 679450"/>
                <a:gd name="connsiteX119" fmla="*/ 993775 w 1134325"/>
                <a:gd name="connsiteY119" fmla="*/ 98425 h 679450"/>
                <a:gd name="connsiteX120" fmla="*/ 965200 w 1134325"/>
                <a:gd name="connsiteY120" fmla="*/ 82550 h 679450"/>
                <a:gd name="connsiteX121" fmla="*/ 946150 w 1134325"/>
                <a:gd name="connsiteY121" fmla="*/ 73025 h 679450"/>
                <a:gd name="connsiteX122" fmla="*/ 936625 w 1134325"/>
                <a:gd name="connsiteY122" fmla="*/ 66675 h 679450"/>
                <a:gd name="connsiteX123" fmla="*/ 914400 w 1134325"/>
                <a:gd name="connsiteY123" fmla="*/ 38100 h 679450"/>
                <a:gd name="connsiteX124" fmla="*/ 895350 w 1134325"/>
                <a:gd name="connsiteY124" fmla="*/ 31750 h 679450"/>
                <a:gd name="connsiteX125" fmla="*/ 866775 w 1134325"/>
                <a:gd name="connsiteY125" fmla="*/ 19050 h 679450"/>
                <a:gd name="connsiteX126" fmla="*/ 857250 w 1134325"/>
                <a:gd name="connsiteY126" fmla="*/ 15875 h 679450"/>
                <a:gd name="connsiteX127" fmla="*/ 828675 w 1134325"/>
                <a:gd name="connsiteY127" fmla="*/ 3175 h 679450"/>
                <a:gd name="connsiteX128" fmla="*/ 819150 w 1134325"/>
                <a:gd name="connsiteY128" fmla="*/ 0 h 679450"/>
                <a:gd name="connsiteX129" fmla="*/ 790575 w 1134325"/>
                <a:gd name="connsiteY129" fmla="*/ 3175 h 679450"/>
                <a:gd name="connsiteX130" fmla="*/ 771525 w 1134325"/>
                <a:gd name="connsiteY130" fmla="*/ 12700 h 679450"/>
                <a:gd name="connsiteX131" fmla="*/ 806450 w 1134325"/>
                <a:gd name="connsiteY131" fmla="*/ 12700 h 6794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</a:cxnLst>
              <a:rect l="l" t="t" r="r" b="b"/>
              <a:pathLst>
                <a:path w="1134325" h="679450">
                  <a:moveTo>
                    <a:pt x="806450" y="12700"/>
                  </a:moveTo>
                  <a:cubicBezTo>
                    <a:pt x="804863" y="13229"/>
                    <a:pt x="776690" y="13671"/>
                    <a:pt x="762000" y="15875"/>
                  </a:cubicBezTo>
                  <a:cubicBezTo>
                    <a:pt x="755381" y="16868"/>
                    <a:pt x="742950" y="22225"/>
                    <a:pt x="742950" y="22225"/>
                  </a:cubicBezTo>
                  <a:lnTo>
                    <a:pt x="723900" y="34925"/>
                  </a:lnTo>
                  <a:cubicBezTo>
                    <a:pt x="719410" y="37918"/>
                    <a:pt x="713401" y="37633"/>
                    <a:pt x="708025" y="38100"/>
                  </a:cubicBezTo>
                  <a:cubicBezTo>
                    <a:pt x="689017" y="39753"/>
                    <a:pt x="669925" y="40217"/>
                    <a:pt x="650875" y="41275"/>
                  </a:cubicBezTo>
                  <a:cubicBezTo>
                    <a:pt x="629708" y="40217"/>
                    <a:pt x="608495" y="39860"/>
                    <a:pt x="587375" y="38100"/>
                  </a:cubicBezTo>
                  <a:cubicBezTo>
                    <a:pt x="583026" y="37738"/>
                    <a:pt x="579039" y="34925"/>
                    <a:pt x="574675" y="34925"/>
                  </a:cubicBezTo>
                  <a:cubicBezTo>
                    <a:pt x="532328" y="34925"/>
                    <a:pt x="490008" y="37042"/>
                    <a:pt x="447675" y="38100"/>
                  </a:cubicBezTo>
                  <a:cubicBezTo>
                    <a:pt x="407973" y="48026"/>
                    <a:pt x="457334" y="35340"/>
                    <a:pt x="425450" y="44450"/>
                  </a:cubicBezTo>
                  <a:cubicBezTo>
                    <a:pt x="421254" y="45649"/>
                    <a:pt x="416930" y="46371"/>
                    <a:pt x="412750" y="47625"/>
                  </a:cubicBezTo>
                  <a:cubicBezTo>
                    <a:pt x="406339" y="49548"/>
                    <a:pt x="400050" y="51858"/>
                    <a:pt x="393700" y="53975"/>
                  </a:cubicBezTo>
                  <a:cubicBezTo>
                    <a:pt x="390525" y="55033"/>
                    <a:pt x="387501" y="56780"/>
                    <a:pt x="384175" y="57150"/>
                  </a:cubicBezTo>
                  <a:lnTo>
                    <a:pt x="355600" y="60325"/>
                  </a:lnTo>
                  <a:cubicBezTo>
                    <a:pt x="338806" y="65923"/>
                    <a:pt x="351611" y="62205"/>
                    <a:pt x="327025" y="66675"/>
                  </a:cubicBezTo>
                  <a:cubicBezTo>
                    <a:pt x="295254" y="72452"/>
                    <a:pt x="328054" y="67972"/>
                    <a:pt x="282575" y="73025"/>
                  </a:cubicBezTo>
                  <a:lnTo>
                    <a:pt x="244475" y="85725"/>
                  </a:lnTo>
                  <a:cubicBezTo>
                    <a:pt x="231645" y="90002"/>
                    <a:pt x="229740" y="88300"/>
                    <a:pt x="215900" y="92075"/>
                  </a:cubicBezTo>
                  <a:cubicBezTo>
                    <a:pt x="209442" y="93836"/>
                    <a:pt x="203200" y="96308"/>
                    <a:pt x="196850" y="98425"/>
                  </a:cubicBezTo>
                  <a:lnTo>
                    <a:pt x="187325" y="101600"/>
                  </a:lnTo>
                  <a:cubicBezTo>
                    <a:pt x="179107" y="109818"/>
                    <a:pt x="168898" y="118782"/>
                    <a:pt x="165100" y="130175"/>
                  </a:cubicBezTo>
                  <a:cubicBezTo>
                    <a:pt x="159512" y="146940"/>
                    <a:pt x="163781" y="136915"/>
                    <a:pt x="149225" y="158750"/>
                  </a:cubicBezTo>
                  <a:cubicBezTo>
                    <a:pt x="147108" y="161925"/>
                    <a:pt x="146495" y="167068"/>
                    <a:pt x="142875" y="168275"/>
                  </a:cubicBezTo>
                  <a:lnTo>
                    <a:pt x="133350" y="171450"/>
                  </a:lnTo>
                  <a:lnTo>
                    <a:pt x="104775" y="190500"/>
                  </a:lnTo>
                  <a:cubicBezTo>
                    <a:pt x="95409" y="196744"/>
                    <a:pt x="93365" y="197208"/>
                    <a:pt x="85725" y="206375"/>
                  </a:cubicBezTo>
                  <a:cubicBezTo>
                    <a:pt x="77339" y="216438"/>
                    <a:pt x="77640" y="221106"/>
                    <a:pt x="73025" y="234950"/>
                  </a:cubicBezTo>
                  <a:cubicBezTo>
                    <a:pt x="71605" y="239210"/>
                    <a:pt x="66675" y="241300"/>
                    <a:pt x="63500" y="244475"/>
                  </a:cubicBezTo>
                  <a:cubicBezTo>
                    <a:pt x="57920" y="261214"/>
                    <a:pt x="64013" y="247670"/>
                    <a:pt x="50800" y="263525"/>
                  </a:cubicBezTo>
                  <a:cubicBezTo>
                    <a:pt x="28698" y="290047"/>
                    <a:pt x="62752" y="254748"/>
                    <a:pt x="34925" y="282575"/>
                  </a:cubicBezTo>
                  <a:cubicBezTo>
                    <a:pt x="32808" y="288925"/>
                    <a:pt x="32288" y="296056"/>
                    <a:pt x="28575" y="301625"/>
                  </a:cubicBezTo>
                  <a:cubicBezTo>
                    <a:pt x="26458" y="304800"/>
                    <a:pt x="23932" y="307737"/>
                    <a:pt x="22225" y="311150"/>
                  </a:cubicBezTo>
                  <a:cubicBezTo>
                    <a:pt x="9080" y="337440"/>
                    <a:pt x="30898" y="302903"/>
                    <a:pt x="12700" y="330200"/>
                  </a:cubicBezTo>
                  <a:cubicBezTo>
                    <a:pt x="7902" y="349394"/>
                    <a:pt x="10905" y="338760"/>
                    <a:pt x="3175" y="361950"/>
                  </a:cubicBezTo>
                  <a:lnTo>
                    <a:pt x="0" y="371475"/>
                  </a:lnTo>
                  <a:cubicBezTo>
                    <a:pt x="1058" y="383117"/>
                    <a:pt x="1144" y="394888"/>
                    <a:pt x="3175" y="406400"/>
                  </a:cubicBezTo>
                  <a:cubicBezTo>
                    <a:pt x="4338" y="412992"/>
                    <a:pt x="7408" y="419100"/>
                    <a:pt x="9525" y="425450"/>
                  </a:cubicBezTo>
                  <a:lnTo>
                    <a:pt x="22225" y="463550"/>
                  </a:lnTo>
                  <a:cubicBezTo>
                    <a:pt x="23432" y="467170"/>
                    <a:pt x="27025" y="469588"/>
                    <a:pt x="28575" y="473075"/>
                  </a:cubicBezTo>
                  <a:cubicBezTo>
                    <a:pt x="46102" y="512510"/>
                    <a:pt x="21220" y="471568"/>
                    <a:pt x="47625" y="511175"/>
                  </a:cubicBezTo>
                  <a:cubicBezTo>
                    <a:pt x="60200" y="530038"/>
                    <a:pt x="47401" y="526826"/>
                    <a:pt x="60325" y="539750"/>
                  </a:cubicBezTo>
                  <a:cubicBezTo>
                    <a:pt x="63023" y="542448"/>
                    <a:pt x="66675" y="543983"/>
                    <a:pt x="69850" y="546100"/>
                  </a:cubicBezTo>
                  <a:cubicBezTo>
                    <a:pt x="74816" y="556032"/>
                    <a:pt x="76071" y="561889"/>
                    <a:pt x="85725" y="568325"/>
                  </a:cubicBezTo>
                  <a:cubicBezTo>
                    <a:pt x="88510" y="570181"/>
                    <a:pt x="92075" y="570442"/>
                    <a:pt x="95250" y="571500"/>
                  </a:cubicBezTo>
                  <a:cubicBezTo>
                    <a:pt x="96308" y="574675"/>
                    <a:pt x="96058" y="578658"/>
                    <a:pt x="98425" y="581025"/>
                  </a:cubicBezTo>
                  <a:cubicBezTo>
                    <a:pt x="103821" y="586421"/>
                    <a:pt x="117475" y="593725"/>
                    <a:pt x="117475" y="593725"/>
                  </a:cubicBezTo>
                  <a:cubicBezTo>
                    <a:pt x="120057" y="601472"/>
                    <a:pt x="120845" y="606620"/>
                    <a:pt x="127000" y="612775"/>
                  </a:cubicBezTo>
                  <a:cubicBezTo>
                    <a:pt x="129698" y="615473"/>
                    <a:pt x="133594" y="616682"/>
                    <a:pt x="136525" y="619125"/>
                  </a:cubicBezTo>
                  <a:cubicBezTo>
                    <a:pt x="166368" y="643994"/>
                    <a:pt x="116952" y="609252"/>
                    <a:pt x="165100" y="641350"/>
                  </a:cubicBezTo>
                  <a:cubicBezTo>
                    <a:pt x="170669" y="645063"/>
                    <a:pt x="184150" y="647700"/>
                    <a:pt x="184150" y="647700"/>
                  </a:cubicBezTo>
                  <a:cubicBezTo>
                    <a:pt x="191558" y="646642"/>
                    <a:pt x="199083" y="646208"/>
                    <a:pt x="206375" y="644525"/>
                  </a:cubicBezTo>
                  <a:cubicBezTo>
                    <a:pt x="212897" y="643020"/>
                    <a:pt x="225425" y="638175"/>
                    <a:pt x="225425" y="638175"/>
                  </a:cubicBezTo>
                  <a:lnTo>
                    <a:pt x="238125" y="619125"/>
                  </a:lnTo>
                  <a:lnTo>
                    <a:pt x="266700" y="600075"/>
                  </a:lnTo>
                  <a:lnTo>
                    <a:pt x="276225" y="593725"/>
                  </a:lnTo>
                  <a:lnTo>
                    <a:pt x="285750" y="587375"/>
                  </a:lnTo>
                  <a:cubicBezTo>
                    <a:pt x="293363" y="564537"/>
                    <a:pt x="284127" y="593057"/>
                    <a:pt x="292100" y="565150"/>
                  </a:cubicBezTo>
                  <a:cubicBezTo>
                    <a:pt x="293019" y="561932"/>
                    <a:pt x="292552" y="557570"/>
                    <a:pt x="295275" y="555625"/>
                  </a:cubicBezTo>
                  <a:cubicBezTo>
                    <a:pt x="300722" y="551734"/>
                    <a:pt x="314325" y="549275"/>
                    <a:pt x="314325" y="549275"/>
                  </a:cubicBezTo>
                  <a:cubicBezTo>
                    <a:pt x="322792" y="550333"/>
                    <a:pt x="331330" y="550924"/>
                    <a:pt x="339725" y="552450"/>
                  </a:cubicBezTo>
                  <a:cubicBezTo>
                    <a:pt x="343018" y="553049"/>
                    <a:pt x="346883" y="553258"/>
                    <a:pt x="349250" y="555625"/>
                  </a:cubicBezTo>
                  <a:cubicBezTo>
                    <a:pt x="369272" y="575647"/>
                    <a:pt x="357140" y="568230"/>
                    <a:pt x="365125" y="584200"/>
                  </a:cubicBezTo>
                  <a:cubicBezTo>
                    <a:pt x="366832" y="587613"/>
                    <a:pt x="369768" y="590312"/>
                    <a:pt x="371475" y="593725"/>
                  </a:cubicBezTo>
                  <a:cubicBezTo>
                    <a:pt x="372972" y="596718"/>
                    <a:pt x="373153" y="600257"/>
                    <a:pt x="374650" y="603250"/>
                  </a:cubicBezTo>
                  <a:cubicBezTo>
                    <a:pt x="376357" y="606663"/>
                    <a:pt x="379293" y="609362"/>
                    <a:pt x="381000" y="612775"/>
                  </a:cubicBezTo>
                  <a:cubicBezTo>
                    <a:pt x="386165" y="623104"/>
                    <a:pt x="381426" y="622726"/>
                    <a:pt x="390525" y="631825"/>
                  </a:cubicBezTo>
                  <a:cubicBezTo>
                    <a:pt x="393223" y="634523"/>
                    <a:pt x="396875" y="636058"/>
                    <a:pt x="400050" y="638175"/>
                  </a:cubicBezTo>
                  <a:cubicBezTo>
                    <a:pt x="402167" y="641350"/>
                    <a:pt x="403164" y="645678"/>
                    <a:pt x="406400" y="647700"/>
                  </a:cubicBezTo>
                  <a:cubicBezTo>
                    <a:pt x="412076" y="651248"/>
                    <a:pt x="419100" y="651933"/>
                    <a:pt x="425450" y="654050"/>
                  </a:cubicBezTo>
                  <a:lnTo>
                    <a:pt x="434975" y="657225"/>
                  </a:lnTo>
                  <a:cubicBezTo>
                    <a:pt x="438150" y="658283"/>
                    <a:pt x="441507" y="658903"/>
                    <a:pt x="444500" y="660400"/>
                  </a:cubicBezTo>
                  <a:cubicBezTo>
                    <a:pt x="448733" y="662517"/>
                    <a:pt x="452768" y="665088"/>
                    <a:pt x="457200" y="666750"/>
                  </a:cubicBezTo>
                  <a:cubicBezTo>
                    <a:pt x="461286" y="668282"/>
                    <a:pt x="465720" y="668671"/>
                    <a:pt x="469900" y="669925"/>
                  </a:cubicBezTo>
                  <a:cubicBezTo>
                    <a:pt x="476311" y="671848"/>
                    <a:pt x="482600" y="674158"/>
                    <a:pt x="488950" y="676275"/>
                  </a:cubicBezTo>
                  <a:lnTo>
                    <a:pt x="498475" y="679450"/>
                  </a:lnTo>
                  <a:cubicBezTo>
                    <a:pt x="530225" y="678392"/>
                    <a:pt x="562012" y="678140"/>
                    <a:pt x="593725" y="676275"/>
                  </a:cubicBezTo>
                  <a:cubicBezTo>
                    <a:pt x="601491" y="675818"/>
                    <a:pt x="608560" y="671773"/>
                    <a:pt x="615950" y="669925"/>
                  </a:cubicBezTo>
                  <a:cubicBezTo>
                    <a:pt x="621185" y="668616"/>
                    <a:pt x="626462" y="667346"/>
                    <a:pt x="631825" y="666750"/>
                  </a:cubicBezTo>
                  <a:cubicBezTo>
                    <a:pt x="645540" y="665226"/>
                    <a:pt x="659363" y="664883"/>
                    <a:pt x="673100" y="663575"/>
                  </a:cubicBezTo>
                  <a:cubicBezTo>
                    <a:pt x="681594" y="662766"/>
                    <a:pt x="690033" y="661458"/>
                    <a:pt x="698500" y="660400"/>
                  </a:cubicBezTo>
                  <a:cubicBezTo>
                    <a:pt x="701675" y="659342"/>
                    <a:pt x="704778" y="658037"/>
                    <a:pt x="708025" y="657225"/>
                  </a:cubicBezTo>
                  <a:cubicBezTo>
                    <a:pt x="716900" y="655006"/>
                    <a:pt x="734458" y="652290"/>
                    <a:pt x="742950" y="650875"/>
                  </a:cubicBezTo>
                  <a:cubicBezTo>
                    <a:pt x="746125" y="649817"/>
                    <a:pt x="749482" y="649197"/>
                    <a:pt x="752475" y="647700"/>
                  </a:cubicBezTo>
                  <a:cubicBezTo>
                    <a:pt x="755888" y="645993"/>
                    <a:pt x="758513" y="642900"/>
                    <a:pt x="762000" y="641350"/>
                  </a:cubicBezTo>
                  <a:cubicBezTo>
                    <a:pt x="768117" y="638632"/>
                    <a:pt x="781050" y="635000"/>
                    <a:pt x="781050" y="635000"/>
                  </a:cubicBezTo>
                  <a:cubicBezTo>
                    <a:pt x="784225" y="632883"/>
                    <a:pt x="787088" y="630200"/>
                    <a:pt x="790575" y="628650"/>
                  </a:cubicBezTo>
                  <a:cubicBezTo>
                    <a:pt x="796692" y="625932"/>
                    <a:pt x="803275" y="624417"/>
                    <a:pt x="809625" y="622300"/>
                  </a:cubicBezTo>
                  <a:cubicBezTo>
                    <a:pt x="823290" y="617745"/>
                    <a:pt x="815903" y="619937"/>
                    <a:pt x="831850" y="615950"/>
                  </a:cubicBezTo>
                  <a:lnTo>
                    <a:pt x="860425" y="596900"/>
                  </a:lnTo>
                  <a:cubicBezTo>
                    <a:pt x="865994" y="593187"/>
                    <a:pt x="879475" y="590550"/>
                    <a:pt x="879475" y="590550"/>
                  </a:cubicBezTo>
                  <a:cubicBezTo>
                    <a:pt x="882650" y="588433"/>
                    <a:pt x="886069" y="586643"/>
                    <a:pt x="889000" y="584200"/>
                  </a:cubicBezTo>
                  <a:cubicBezTo>
                    <a:pt x="892449" y="581325"/>
                    <a:pt x="894789" y="577166"/>
                    <a:pt x="898525" y="574675"/>
                  </a:cubicBezTo>
                  <a:cubicBezTo>
                    <a:pt x="901310" y="572819"/>
                    <a:pt x="904875" y="572558"/>
                    <a:pt x="908050" y="571500"/>
                  </a:cubicBezTo>
                  <a:cubicBezTo>
                    <a:pt x="912283" y="565150"/>
                    <a:pt x="918337" y="559690"/>
                    <a:pt x="920750" y="552450"/>
                  </a:cubicBezTo>
                  <a:cubicBezTo>
                    <a:pt x="921808" y="549275"/>
                    <a:pt x="921834" y="545538"/>
                    <a:pt x="923925" y="542925"/>
                  </a:cubicBezTo>
                  <a:cubicBezTo>
                    <a:pt x="926309" y="539945"/>
                    <a:pt x="930275" y="538692"/>
                    <a:pt x="933450" y="536575"/>
                  </a:cubicBezTo>
                  <a:cubicBezTo>
                    <a:pt x="941430" y="512634"/>
                    <a:pt x="930665" y="542144"/>
                    <a:pt x="942975" y="517525"/>
                  </a:cubicBezTo>
                  <a:cubicBezTo>
                    <a:pt x="944472" y="514532"/>
                    <a:pt x="944059" y="510613"/>
                    <a:pt x="946150" y="508000"/>
                  </a:cubicBezTo>
                  <a:cubicBezTo>
                    <a:pt x="950626" y="502405"/>
                    <a:pt x="958925" y="500567"/>
                    <a:pt x="965200" y="498475"/>
                  </a:cubicBezTo>
                  <a:cubicBezTo>
                    <a:pt x="983295" y="480380"/>
                    <a:pt x="965039" y="495369"/>
                    <a:pt x="987425" y="485775"/>
                  </a:cubicBezTo>
                  <a:cubicBezTo>
                    <a:pt x="1001388" y="479791"/>
                    <a:pt x="991880" y="478682"/>
                    <a:pt x="1006475" y="476250"/>
                  </a:cubicBezTo>
                  <a:cubicBezTo>
                    <a:pt x="1030244" y="472289"/>
                    <a:pt x="1072801" y="470978"/>
                    <a:pt x="1092200" y="469900"/>
                  </a:cubicBezTo>
                  <a:cubicBezTo>
                    <a:pt x="1098475" y="467808"/>
                    <a:pt x="1106774" y="465970"/>
                    <a:pt x="1111250" y="460375"/>
                  </a:cubicBezTo>
                  <a:cubicBezTo>
                    <a:pt x="1113341" y="457762"/>
                    <a:pt x="1112928" y="453843"/>
                    <a:pt x="1114425" y="450850"/>
                  </a:cubicBezTo>
                  <a:cubicBezTo>
                    <a:pt x="1116132" y="447437"/>
                    <a:pt x="1119225" y="444812"/>
                    <a:pt x="1120775" y="441325"/>
                  </a:cubicBezTo>
                  <a:cubicBezTo>
                    <a:pt x="1123493" y="435208"/>
                    <a:pt x="1125008" y="428625"/>
                    <a:pt x="1127125" y="422275"/>
                  </a:cubicBezTo>
                  <a:lnTo>
                    <a:pt x="1130300" y="412750"/>
                  </a:lnTo>
                  <a:cubicBezTo>
                    <a:pt x="1131358" y="395817"/>
                    <a:pt x="1133475" y="378916"/>
                    <a:pt x="1133475" y="361950"/>
                  </a:cubicBezTo>
                  <a:cubicBezTo>
                    <a:pt x="1133475" y="279804"/>
                    <a:pt x="1138541" y="300949"/>
                    <a:pt x="1123950" y="257175"/>
                  </a:cubicBezTo>
                  <a:cubicBezTo>
                    <a:pt x="1121914" y="251068"/>
                    <a:pt x="1122811" y="244232"/>
                    <a:pt x="1120775" y="238125"/>
                  </a:cubicBezTo>
                  <a:cubicBezTo>
                    <a:pt x="1119568" y="234505"/>
                    <a:pt x="1116318" y="231913"/>
                    <a:pt x="1114425" y="228600"/>
                  </a:cubicBezTo>
                  <a:cubicBezTo>
                    <a:pt x="1104509" y="211248"/>
                    <a:pt x="1113512" y="219525"/>
                    <a:pt x="1098550" y="209550"/>
                  </a:cubicBezTo>
                  <a:cubicBezTo>
                    <a:pt x="1080352" y="182253"/>
                    <a:pt x="1102170" y="216790"/>
                    <a:pt x="1089025" y="190500"/>
                  </a:cubicBezTo>
                  <a:cubicBezTo>
                    <a:pt x="1087318" y="187087"/>
                    <a:pt x="1084382" y="184388"/>
                    <a:pt x="1082675" y="180975"/>
                  </a:cubicBezTo>
                  <a:cubicBezTo>
                    <a:pt x="1081178" y="177982"/>
                    <a:pt x="1081591" y="174063"/>
                    <a:pt x="1079500" y="171450"/>
                  </a:cubicBezTo>
                  <a:cubicBezTo>
                    <a:pt x="1077116" y="168470"/>
                    <a:pt x="1073150" y="167217"/>
                    <a:pt x="1069975" y="165100"/>
                  </a:cubicBezTo>
                  <a:cubicBezTo>
                    <a:pt x="1065742" y="158750"/>
                    <a:pt x="1062671" y="151446"/>
                    <a:pt x="1057275" y="146050"/>
                  </a:cubicBezTo>
                  <a:cubicBezTo>
                    <a:pt x="1054100" y="142875"/>
                    <a:pt x="1050507" y="140069"/>
                    <a:pt x="1047750" y="136525"/>
                  </a:cubicBezTo>
                  <a:cubicBezTo>
                    <a:pt x="1029918" y="113599"/>
                    <a:pt x="1043726" y="120367"/>
                    <a:pt x="1025525" y="114300"/>
                  </a:cubicBezTo>
                  <a:cubicBezTo>
                    <a:pt x="1002844" y="99179"/>
                    <a:pt x="1013879" y="103451"/>
                    <a:pt x="993775" y="98425"/>
                  </a:cubicBezTo>
                  <a:cubicBezTo>
                    <a:pt x="971940" y="83869"/>
                    <a:pt x="981965" y="88138"/>
                    <a:pt x="965200" y="82550"/>
                  </a:cubicBezTo>
                  <a:cubicBezTo>
                    <a:pt x="937903" y="64352"/>
                    <a:pt x="972440" y="86170"/>
                    <a:pt x="946150" y="73025"/>
                  </a:cubicBezTo>
                  <a:cubicBezTo>
                    <a:pt x="942737" y="71318"/>
                    <a:pt x="939800" y="68792"/>
                    <a:pt x="936625" y="66675"/>
                  </a:cubicBezTo>
                  <a:cubicBezTo>
                    <a:pt x="933369" y="61791"/>
                    <a:pt x="922300" y="42489"/>
                    <a:pt x="914400" y="38100"/>
                  </a:cubicBezTo>
                  <a:cubicBezTo>
                    <a:pt x="908549" y="34849"/>
                    <a:pt x="895350" y="31750"/>
                    <a:pt x="895350" y="31750"/>
                  </a:cubicBezTo>
                  <a:cubicBezTo>
                    <a:pt x="880256" y="21687"/>
                    <a:pt x="889445" y="26607"/>
                    <a:pt x="866775" y="19050"/>
                  </a:cubicBezTo>
                  <a:lnTo>
                    <a:pt x="857250" y="15875"/>
                  </a:lnTo>
                  <a:cubicBezTo>
                    <a:pt x="842156" y="5812"/>
                    <a:pt x="851345" y="10732"/>
                    <a:pt x="828675" y="3175"/>
                  </a:cubicBezTo>
                  <a:lnTo>
                    <a:pt x="819150" y="0"/>
                  </a:lnTo>
                  <a:cubicBezTo>
                    <a:pt x="809625" y="1058"/>
                    <a:pt x="800028" y="1599"/>
                    <a:pt x="790575" y="3175"/>
                  </a:cubicBezTo>
                  <a:cubicBezTo>
                    <a:pt x="780825" y="4800"/>
                    <a:pt x="779964" y="7637"/>
                    <a:pt x="771525" y="12700"/>
                  </a:cubicBezTo>
                  <a:cubicBezTo>
                    <a:pt x="769496" y="13918"/>
                    <a:pt x="808037" y="12171"/>
                    <a:pt x="806450" y="12700"/>
                  </a:cubicBezTo>
                  <a:close/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35" name="フリーフォーム 134"/>
            <p:cNvSpPr/>
            <p:nvPr/>
          </p:nvSpPr>
          <p:spPr>
            <a:xfrm>
              <a:off x="5288905" y="1684933"/>
              <a:ext cx="1134325" cy="679450"/>
            </a:xfrm>
            <a:custGeom>
              <a:avLst/>
              <a:gdLst>
                <a:gd name="connsiteX0" fmla="*/ 806450 w 1134325"/>
                <a:gd name="connsiteY0" fmla="*/ 12700 h 679450"/>
                <a:gd name="connsiteX1" fmla="*/ 762000 w 1134325"/>
                <a:gd name="connsiteY1" fmla="*/ 15875 h 679450"/>
                <a:gd name="connsiteX2" fmla="*/ 742950 w 1134325"/>
                <a:gd name="connsiteY2" fmla="*/ 22225 h 679450"/>
                <a:gd name="connsiteX3" fmla="*/ 723900 w 1134325"/>
                <a:gd name="connsiteY3" fmla="*/ 34925 h 679450"/>
                <a:gd name="connsiteX4" fmla="*/ 708025 w 1134325"/>
                <a:gd name="connsiteY4" fmla="*/ 38100 h 679450"/>
                <a:gd name="connsiteX5" fmla="*/ 650875 w 1134325"/>
                <a:gd name="connsiteY5" fmla="*/ 41275 h 679450"/>
                <a:gd name="connsiteX6" fmla="*/ 587375 w 1134325"/>
                <a:gd name="connsiteY6" fmla="*/ 38100 h 679450"/>
                <a:gd name="connsiteX7" fmla="*/ 574675 w 1134325"/>
                <a:gd name="connsiteY7" fmla="*/ 34925 h 679450"/>
                <a:gd name="connsiteX8" fmla="*/ 447675 w 1134325"/>
                <a:gd name="connsiteY8" fmla="*/ 38100 h 679450"/>
                <a:gd name="connsiteX9" fmla="*/ 425450 w 1134325"/>
                <a:gd name="connsiteY9" fmla="*/ 44450 h 679450"/>
                <a:gd name="connsiteX10" fmla="*/ 412750 w 1134325"/>
                <a:gd name="connsiteY10" fmla="*/ 47625 h 679450"/>
                <a:gd name="connsiteX11" fmla="*/ 393700 w 1134325"/>
                <a:gd name="connsiteY11" fmla="*/ 53975 h 679450"/>
                <a:gd name="connsiteX12" fmla="*/ 384175 w 1134325"/>
                <a:gd name="connsiteY12" fmla="*/ 57150 h 679450"/>
                <a:gd name="connsiteX13" fmla="*/ 355600 w 1134325"/>
                <a:gd name="connsiteY13" fmla="*/ 60325 h 679450"/>
                <a:gd name="connsiteX14" fmla="*/ 327025 w 1134325"/>
                <a:gd name="connsiteY14" fmla="*/ 66675 h 679450"/>
                <a:gd name="connsiteX15" fmla="*/ 282575 w 1134325"/>
                <a:gd name="connsiteY15" fmla="*/ 73025 h 679450"/>
                <a:gd name="connsiteX16" fmla="*/ 244475 w 1134325"/>
                <a:gd name="connsiteY16" fmla="*/ 85725 h 679450"/>
                <a:gd name="connsiteX17" fmla="*/ 215900 w 1134325"/>
                <a:gd name="connsiteY17" fmla="*/ 92075 h 679450"/>
                <a:gd name="connsiteX18" fmla="*/ 196850 w 1134325"/>
                <a:gd name="connsiteY18" fmla="*/ 98425 h 679450"/>
                <a:gd name="connsiteX19" fmla="*/ 187325 w 1134325"/>
                <a:gd name="connsiteY19" fmla="*/ 101600 h 679450"/>
                <a:gd name="connsiteX20" fmla="*/ 165100 w 1134325"/>
                <a:gd name="connsiteY20" fmla="*/ 130175 h 679450"/>
                <a:gd name="connsiteX21" fmla="*/ 149225 w 1134325"/>
                <a:gd name="connsiteY21" fmla="*/ 158750 h 679450"/>
                <a:gd name="connsiteX22" fmla="*/ 142875 w 1134325"/>
                <a:gd name="connsiteY22" fmla="*/ 168275 h 679450"/>
                <a:gd name="connsiteX23" fmla="*/ 133350 w 1134325"/>
                <a:gd name="connsiteY23" fmla="*/ 171450 h 679450"/>
                <a:gd name="connsiteX24" fmla="*/ 104775 w 1134325"/>
                <a:gd name="connsiteY24" fmla="*/ 190500 h 679450"/>
                <a:gd name="connsiteX25" fmla="*/ 85725 w 1134325"/>
                <a:gd name="connsiteY25" fmla="*/ 206375 h 679450"/>
                <a:gd name="connsiteX26" fmla="*/ 73025 w 1134325"/>
                <a:gd name="connsiteY26" fmla="*/ 234950 h 679450"/>
                <a:gd name="connsiteX27" fmla="*/ 63500 w 1134325"/>
                <a:gd name="connsiteY27" fmla="*/ 244475 h 679450"/>
                <a:gd name="connsiteX28" fmla="*/ 50800 w 1134325"/>
                <a:gd name="connsiteY28" fmla="*/ 263525 h 679450"/>
                <a:gd name="connsiteX29" fmla="*/ 34925 w 1134325"/>
                <a:gd name="connsiteY29" fmla="*/ 282575 h 679450"/>
                <a:gd name="connsiteX30" fmla="*/ 28575 w 1134325"/>
                <a:gd name="connsiteY30" fmla="*/ 301625 h 679450"/>
                <a:gd name="connsiteX31" fmla="*/ 22225 w 1134325"/>
                <a:gd name="connsiteY31" fmla="*/ 311150 h 679450"/>
                <a:gd name="connsiteX32" fmla="*/ 12700 w 1134325"/>
                <a:gd name="connsiteY32" fmla="*/ 330200 h 679450"/>
                <a:gd name="connsiteX33" fmla="*/ 3175 w 1134325"/>
                <a:gd name="connsiteY33" fmla="*/ 361950 h 679450"/>
                <a:gd name="connsiteX34" fmla="*/ 0 w 1134325"/>
                <a:gd name="connsiteY34" fmla="*/ 371475 h 679450"/>
                <a:gd name="connsiteX35" fmla="*/ 3175 w 1134325"/>
                <a:gd name="connsiteY35" fmla="*/ 406400 h 679450"/>
                <a:gd name="connsiteX36" fmla="*/ 9525 w 1134325"/>
                <a:gd name="connsiteY36" fmla="*/ 425450 h 679450"/>
                <a:gd name="connsiteX37" fmla="*/ 22225 w 1134325"/>
                <a:gd name="connsiteY37" fmla="*/ 463550 h 679450"/>
                <a:gd name="connsiteX38" fmla="*/ 28575 w 1134325"/>
                <a:gd name="connsiteY38" fmla="*/ 473075 h 679450"/>
                <a:gd name="connsiteX39" fmla="*/ 47625 w 1134325"/>
                <a:gd name="connsiteY39" fmla="*/ 511175 h 679450"/>
                <a:gd name="connsiteX40" fmla="*/ 60325 w 1134325"/>
                <a:gd name="connsiteY40" fmla="*/ 539750 h 679450"/>
                <a:gd name="connsiteX41" fmla="*/ 69850 w 1134325"/>
                <a:gd name="connsiteY41" fmla="*/ 546100 h 679450"/>
                <a:gd name="connsiteX42" fmla="*/ 85725 w 1134325"/>
                <a:gd name="connsiteY42" fmla="*/ 568325 h 679450"/>
                <a:gd name="connsiteX43" fmla="*/ 95250 w 1134325"/>
                <a:gd name="connsiteY43" fmla="*/ 571500 h 679450"/>
                <a:gd name="connsiteX44" fmla="*/ 98425 w 1134325"/>
                <a:gd name="connsiteY44" fmla="*/ 581025 h 679450"/>
                <a:gd name="connsiteX45" fmla="*/ 117475 w 1134325"/>
                <a:gd name="connsiteY45" fmla="*/ 593725 h 679450"/>
                <a:gd name="connsiteX46" fmla="*/ 127000 w 1134325"/>
                <a:gd name="connsiteY46" fmla="*/ 612775 h 679450"/>
                <a:gd name="connsiteX47" fmla="*/ 136525 w 1134325"/>
                <a:gd name="connsiteY47" fmla="*/ 619125 h 679450"/>
                <a:gd name="connsiteX48" fmla="*/ 165100 w 1134325"/>
                <a:gd name="connsiteY48" fmla="*/ 641350 h 679450"/>
                <a:gd name="connsiteX49" fmla="*/ 184150 w 1134325"/>
                <a:gd name="connsiteY49" fmla="*/ 647700 h 679450"/>
                <a:gd name="connsiteX50" fmla="*/ 206375 w 1134325"/>
                <a:gd name="connsiteY50" fmla="*/ 644525 h 679450"/>
                <a:gd name="connsiteX51" fmla="*/ 225425 w 1134325"/>
                <a:gd name="connsiteY51" fmla="*/ 638175 h 679450"/>
                <a:gd name="connsiteX52" fmla="*/ 238125 w 1134325"/>
                <a:gd name="connsiteY52" fmla="*/ 619125 h 679450"/>
                <a:gd name="connsiteX53" fmla="*/ 266700 w 1134325"/>
                <a:gd name="connsiteY53" fmla="*/ 600075 h 679450"/>
                <a:gd name="connsiteX54" fmla="*/ 276225 w 1134325"/>
                <a:gd name="connsiteY54" fmla="*/ 593725 h 679450"/>
                <a:gd name="connsiteX55" fmla="*/ 285750 w 1134325"/>
                <a:gd name="connsiteY55" fmla="*/ 587375 h 679450"/>
                <a:gd name="connsiteX56" fmla="*/ 292100 w 1134325"/>
                <a:gd name="connsiteY56" fmla="*/ 565150 h 679450"/>
                <a:gd name="connsiteX57" fmla="*/ 295275 w 1134325"/>
                <a:gd name="connsiteY57" fmla="*/ 555625 h 679450"/>
                <a:gd name="connsiteX58" fmla="*/ 314325 w 1134325"/>
                <a:gd name="connsiteY58" fmla="*/ 549275 h 679450"/>
                <a:gd name="connsiteX59" fmla="*/ 339725 w 1134325"/>
                <a:gd name="connsiteY59" fmla="*/ 552450 h 679450"/>
                <a:gd name="connsiteX60" fmla="*/ 349250 w 1134325"/>
                <a:gd name="connsiteY60" fmla="*/ 555625 h 679450"/>
                <a:gd name="connsiteX61" fmla="*/ 365125 w 1134325"/>
                <a:gd name="connsiteY61" fmla="*/ 584200 h 679450"/>
                <a:gd name="connsiteX62" fmla="*/ 371475 w 1134325"/>
                <a:gd name="connsiteY62" fmla="*/ 593725 h 679450"/>
                <a:gd name="connsiteX63" fmla="*/ 374650 w 1134325"/>
                <a:gd name="connsiteY63" fmla="*/ 603250 h 679450"/>
                <a:gd name="connsiteX64" fmla="*/ 381000 w 1134325"/>
                <a:gd name="connsiteY64" fmla="*/ 612775 h 679450"/>
                <a:gd name="connsiteX65" fmla="*/ 390525 w 1134325"/>
                <a:gd name="connsiteY65" fmla="*/ 631825 h 679450"/>
                <a:gd name="connsiteX66" fmla="*/ 400050 w 1134325"/>
                <a:gd name="connsiteY66" fmla="*/ 638175 h 679450"/>
                <a:gd name="connsiteX67" fmla="*/ 406400 w 1134325"/>
                <a:gd name="connsiteY67" fmla="*/ 647700 h 679450"/>
                <a:gd name="connsiteX68" fmla="*/ 425450 w 1134325"/>
                <a:gd name="connsiteY68" fmla="*/ 654050 h 679450"/>
                <a:gd name="connsiteX69" fmla="*/ 434975 w 1134325"/>
                <a:gd name="connsiteY69" fmla="*/ 657225 h 679450"/>
                <a:gd name="connsiteX70" fmla="*/ 444500 w 1134325"/>
                <a:gd name="connsiteY70" fmla="*/ 660400 h 679450"/>
                <a:gd name="connsiteX71" fmla="*/ 457200 w 1134325"/>
                <a:gd name="connsiteY71" fmla="*/ 666750 h 679450"/>
                <a:gd name="connsiteX72" fmla="*/ 469900 w 1134325"/>
                <a:gd name="connsiteY72" fmla="*/ 669925 h 679450"/>
                <a:gd name="connsiteX73" fmla="*/ 488950 w 1134325"/>
                <a:gd name="connsiteY73" fmla="*/ 676275 h 679450"/>
                <a:gd name="connsiteX74" fmla="*/ 498475 w 1134325"/>
                <a:gd name="connsiteY74" fmla="*/ 679450 h 679450"/>
                <a:gd name="connsiteX75" fmla="*/ 593725 w 1134325"/>
                <a:gd name="connsiteY75" fmla="*/ 676275 h 679450"/>
                <a:gd name="connsiteX76" fmla="*/ 615950 w 1134325"/>
                <a:gd name="connsiteY76" fmla="*/ 669925 h 679450"/>
                <a:gd name="connsiteX77" fmla="*/ 631825 w 1134325"/>
                <a:gd name="connsiteY77" fmla="*/ 666750 h 679450"/>
                <a:gd name="connsiteX78" fmla="*/ 673100 w 1134325"/>
                <a:gd name="connsiteY78" fmla="*/ 663575 h 679450"/>
                <a:gd name="connsiteX79" fmla="*/ 698500 w 1134325"/>
                <a:gd name="connsiteY79" fmla="*/ 660400 h 679450"/>
                <a:gd name="connsiteX80" fmla="*/ 708025 w 1134325"/>
                <a:gd name="connsiteY80" fmla="*/ 657225 h 679450"/>
                <a:gd name="connsiteX81" fmla="*/ 742950 w 1134325"/>
                <a:gd name="connsiteY81" fmla="*/ 650875 h 679450"/>
                <a:gd name="connsiteX82" fmla="*/ 752475 w 1134325"/>
                <a:gd name="connsiteY82" fmla="*/ 647700 h 679450"/>
                <a:gd name="connsiteX83" fmla="*/ 762000 w 1134325"/>
                <a:gd name="connsiteY83" fmla="*/ 641350 h 679450"/>
                <a:gd name="connsiteX84" fmla="*/ 781050 w 1134325"/>
                <a:gd name="connsiteY84" fmla="*/ 635000 h 679450"/>
                <a:gd name="connsiteX85" fmla="*/ 790575 w 1134325"/>
                <a:gd name="connsiteY85" fmla="*/ 628650 h 679450"/>
                <a:gd name="connsiteX86" fmla="*/ 809625 w 1134325"/>
                <a:gd name="connsiteY86" fmla="*/ 622300 h 679450"/>
                <a:gd name="connsiteX87" fmla="*/ 831850 w 1134325"/>
                <a:gd name="connsiteY87" fmla="*/ 615950 h 679450"/>
                <a:gd name="connsiteX88" fmla="*/ 860425 w 1134325"/>
                <a:gd name="connsiteY88" fmla="*/ 596900 h 679450"/>
                <a:gd name="connsiteX89" fmla="*/ 879475 w 1134325"/>
                <a:gd name="connsiteY89" fmla="*/ 590550 h 679450"/>
                <a:gd name="connsiteX90" fmla="*/ 889000 w 1134325"/>
                <a:gd name="connsiteY90" fmla="*/ 584200 h 679450"/>
                <a:gd name="connsiteX91" fmla="*/ 898525 w 1134325"/>
                <a:gd name="connsiteY91" fmla="*/ 574675 h 679450"/>
                <a:gd name="connsiteX92" fmla="*/ 908050 w 1134325"/>
                <a:gd name="connsiteY92" fmla="*/ 571500 h 679450"/>
                <a:gd name="connsiteX93" fmla="*/ 920750 w 1134325"/>
                <a:gd name="connsiteY93" fmla="*/ 552450 h 679450"/>
                <a:gd name="connsiteX94" fmla="*/ 923925 w 1134325"/>
                <a:gd name="connsiteY94" fmla="*/ 542925 h 679450"/>
                <a:gd name="connsiteX95" fmla="*/ 933450 w 1134325"/>
                <a:gd name="connsiteY95" fmla="*/ 536575 h 679450"/>
                <a:gd name="connsiteX96" fmla="*/ 942975 w 1134325"/>
                <a:gd name="connsiteY96" fmla="*/ 517525 h 679450"/>
                <a:gd name="connsiteX97" fmla="*/ 946150 w 1134325"/>
                <a:gd name="connsiteY97" fmla="*/ 508000 h 679450"/>
                <a:gd name="connsiteX98" fmla="*/ 965200 w 1134325"/>
                <a:gd name="connsiteY98" fmla="*/ 498475 h 679450"/>
                <a:gd name="connsiteX99" fmla="*/ 987425 w 1134325"/>
                <a:gd name="connsiteY99" fmla="*/ 485775 h 679450"/>
                <a:gd name="connsiteX100" fmla="*/ 1006475 w 1134325"/>
                <a:gd name="connsiteY100" fmla="*/ 476250 h 679450"/>
                <a:gd name="connsiteX101" fmla="*/ 1092200 w 1134325"/>
                <a:gd name="connsiteY101" fmla="*/ 469900 h 679450"/>
                <a:gd name="connsiteX102" fmla="*/ 1111250 w 1134325"/>
                <a:gd name="connsiteY102" fmla="*/ 460375 h 679450"/>
                <a:gd name="connsiteX103" fmla="*/ 1114425 w 1134325"/>
                <a:gd name="connsiteY103" fmla="*/ 450850 h 679450"/>
                <a:gd name="connsiteX104" fmla="*/ 1120775 w 1134325"/>
                <a:gd name="connsiteY104" fmla="*/ 441325 h 679450"/>
                <a:gd name="connsiteX105" fmla="*/ 1127125 w 1134325"/>
                <a:gd name="connsiteY105" fmla="*/ 422275 h 679450"/>
                <a:gd name="connsiteX106" fmla="*/ 1130300 w 1134325"/>
                <a:gd name="connsiteY106" fmla="*/ 412750 h 679450"/>
                <a:gd name="connsiteX107" fmla="*/ 1133475 w 1134325"/>
                <a:gd name="connsiteY107" fmla="*/ 361950 h 679450"/>
                <a:gd name="connsiteX108" fmla="*/ 1123950 w 1134325"/>
                <a:gd name="connsiteY108" fmla="*/ 257175 h 679450"/>
                <a:gd name="connsiteX109" fmla="*/ 1120775 w 1134325"/>
                <a:gd name="connsiteY109" fmla="*/ 238125 h 679450"/>
                <a:gd name="connsiteX110" fmla="*/ 1114425 w 1134325"/>
                <a:gd name="connsiteY110" fmla="*/ 228600 h 679450"/>
                <a:gd name="connsiteX111" fmla="*/ 1098550 w 1134325"/>
                <a:gd name="connsiteY111" fmla="*/ 209550 h 679450"/>
                <a:gd name="connsiteX112" fmla="*/ 1089025 w 1134325"/>
                <a:gd name="connsiteY112" fmla="*/ 190500 h 679450"/>
                <a:gd name="connsiteX113" fmla="*/ 1082675 w 1134325"/>
                <a:gd name="connsiteY113" fmla="*/ 180975 h 679450"/>
                <a:gd name="connsiteX114" fmla="*/ 1079500 w 1134325"/>
                <a:gd name="connsiteY114" fmla="*/ 171450 h 679450"/>
                <a:gd name="connsiteX115" fmla="*/ 1069975 w 1134325"/>
                <a:gd name="connsiteY115" fmla="*/ 165100 h 679450"/>
                <a:gd name="connsiteX116" fmla="*/ 1057275 w 1134325"/>
                <a:gd name="connsiteY116" fmla="*/ 146050 h 679450"/>
                <a:gd name="connsiteX117" fmla="*/ 1047750 w 1134325"/>
                <a:gd name="connsiteY117" fmla="*/ 136525 h 679450"/>
                <a:gd name="connsiteX118" fmla="*/ 1025525 w 1134325"/>
                <a:gd name="connsiteY118" fmla="*/ 114300 h 679450"/>
                <a:gd name="connsiteX119" fmla="*/ 993775 w 1134325"/>
                <a:gd name="connsiteY119" fmla="*/ 98425 h 679450"/>
                <a:gd name="connsiteX120" fmla="*/ 965200 w 1134325"/>
                <a:gd name="connsiteY120" fmla="*/ 82550 h 679450"/>
                <a:gd name="connsiteX121" fmla="*/ 946150 w 1134325"/>
                <a:gd name="connsiteY121" fmla="*/ 73025 h 679450"/>
                <a:gd name="connsiteX122" fmla="*/ 936625 w 1134325"/>
                <a:gd name="connsiteY122" fmla="*/ 66675 h 679450"/>
                <a:gd name="connsiteX123" fmla="*/ 914400 w 1134325"/>
                <a:gd name="connsiteY123" fmla="*/ 38100 h 679450"/>
                <a:gd name="connsiteX124" fmla="*/ 895350 w 1134325"/>
                <a:gd name="connsiteY124" fmla="*/ 31750 h 679450"/>
                <a:gd name="connsiteX125" fmla="*/ 866775 w 1134325"/>
                <a:gd name="connsiteY125" fmla="*/ 19050 h 679450"/>
                <a:gd name="connsiteX126" fmla="*/ 857250 w 1134325"/>
                <a:gd name="connsiteY126" fmla="*/ 15875 h 679450"/>
                <a:gd name="connsiteX127" fmla="*/ 828675 w 1134325"/>
                <a:gd name="connsiteY127" fmla="*/ 3175 h 679450"/>
                <a:gd name="connsiteX128" fmla="*/ 819150 w 1134325"/>
                <a:gd name="connsiteY128" fmla="*/ 0 h 679450"/>
                <a:gd name="connsiteX129" fmla="*/ 790575 w 1134325"/>
                <a:gd name="connsiteY129" fmla="*/ 3175 h 679450"/>
                <a:gd name="connsiteX130" fmla="*/ 771525 w 1134325"/>
                <a:gd name="connsiteY130" fmla="*/ 12700 h 679450"/>
                <a:gd name="connsiteX131" fmla="*/ 806450 w 1134325"/>
                <a:gd name="connsiteY131" fmla="*/ 12700 h 6794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</a:cxnLst>
              <a:rect l="l" t="t" r="r" b="b"/>
              <a:pathLst>
                <a:path w="1134325" h="679450">
                  <a:moveTo>
                    <a:pt x="806450" y="12700"/>
                  </a:moveTo>
                  <a:cubicBezTo>
                    <a:pt x="804863" y="13229"/>
                    <a:pt x="776690" y="13671"/>
                    <a:pt x="762000" y="15875"/>
                  </a:cubicBezTo>
                  <a:cubicBezTo>
                    <a:pt x="755381" y="16868"/>
                    <a:pt x="742950" y="22225"/>
                    <a:pt x="742950" y="22225"/>
                  </a:cubicBezTo>
                  <a:lnTo>
                    <a:pt x="723900" y="34925"/>
                  </a:lnTo>
                  <a:cubicBezTo>
                    <a:pt x="719410" y="37918"/>
                    <a:pt x="713401" y="37633"/>
                    <a:pt x="708025" y="38100"/>
                  </a:cubicBezTo>
                  <a:cubicBezTo>
                    <a:pt x="689017" y="39753"/>
                    <a:pt x="669925" y="40217"/>
                    <a:pt x="650875" y="41275"/>
                  </a:cubicBezTo>
                  <a:cubicBezTo>
                    <a:pt x="629708" y="40217"/>
                    <a:pt x="608495" y="39860"/>
                    <a:pt x="587375" y="38100"/>
                  </a:cubicBezTo>
                  <a:cubicBezTo>
                    <a:pt x="583026" y="37738"/>
                    <a:pt x="579039" y="34925"/>
                    <a:pt x="574675" y="34925"/>
                  </a:cubicBezTo>
                  <a:cubicBezTo>
                    <a:pt x="532328" y="34925"/>
                    <a:pt x="490008" y="37042"/>
                    <a:pt x="447675" y="38100"/>
                  </a:cubicBezTo>
                  <a:cubicBezTo>
                    <a:pt x="407973" y="48026"/>
                    <a:pt x="457334" y="35340"/>
                    <a:pt x="425450" y="44450"/>
                  </a:cubicBezTo>
                  <a:cubicBezTo>
                    <a:pt x="421254" y="45649"/>
                    <a:pt x="416930" y="46371"/>
                    <a:pt x="412750" y="47625"/>
                  </a:cubicBezTo>
                  <a:cubicBezTo>
                    <a:pt x="406339" y="49548"/>
                    <a:pt x="400050" y="51858"/>
                    <a:pt x="393700" y="53975"/>
                  </a:cubicBezTo>
                  <a:cubicBezTo>
                    <a:pt x="390525" y="55033"/>
                    <a:pt x="387501" y="56780"/>
                    <a:pt x="384175" y="57150"/>
                  </a:cubicBezTo>
                  <a:lnTo>
                    <a:pt x="355600" y="60325"/>
                  </a:lnTo>
                  <a:cubicBezTo>
                    <a:pt x="338806" y="65923"/>
                    <a:pt x="351611" y="62205"/>
                    <a:pt x="327025" y="66675"/>
                  </a:cubicBezTo>
                  <a:cubicBezTo>
                    <a:pt x="295254" y="72452"/>
                    <a:pt x="328054" y="67972"/>
                    <a:pt x="282575" y="73025"/>
                  </a:cubicBezTo>
                  <a:lnTo>
                    <a:pt x="244475" y="85725"/>
                  </a:lnTo>
                  <a:cubicBezTo>
                    <a:pt x="231645" y="90002"/>
                    <a:pt x="229740" y="88300"/>
                    <a:pt x="215900" y="92075"/>
                  </a:cubicBezTo>
                  <a:cubicBezTo>
                    <a:pt x="209442" y="93836"/>
                    <a:pt x="203200" y="96308"/>
                    <a:pt x="196850" y="98425"/>
                  </a:cubicBezTo>
                  <a:lnTo>
                    <a:pt x="187325" y="101600"/>
                  </a:lnTo>
                  <a:cubicBezTo>
                    <a:pt x="179107" y="109818"/>
                    <a:pt x="168898" y="118782"/>
                    <a:pt x="165100" y="130175"/>
                  </a:cubicBezTo>
                  <a:cubicBezTo>
                    <a:pt x="159512" y="146940"/>
                    <a:pt x="163781" y="136915"/>
                    <a:pt x="149225" y="158750"/>
                  </a:cubicBezTo>
                  <a:cubicBezTo>
                    <a:pt x="147108" y="161925"/>
                    <a:pt x="146495" y="167068"/>
                    <a:pt x="142875" y="168275"/>
                  </a:cubicBezTo>
                  <a:lnTo>
                    <a:pt x="133350" y="171450"/>
                  </a:lnTo>
                  <a:lnTo>
                    <a:pt x="104775" y="190500"/>
                  </a:lnTo>
                  <a:cubicBezTo>
                    <a:pt x="95409" y="196744"/>
                    <a:pt x="93365" y="197208"/>
                    <a:pt x="85725" y="206375"/>
                  </a:cubicBezTo>
                  <a:cubicBezTo>
                    <a:pt x="77339" y="216438"/>
                    <a:pt x="77640" y="221106"/>
                    <a:pt x="73025" y="234950"/>
                  </a:cubicBezTo>
                  <a:cubicBezTo>
                    <a:pt x="71605" y="239210"/>
                    <a:pt x="66675" y="241300"/>
                    <a:pt x="63500" y="244475"/>
                  </a:cubicBezTo>
                  <a:cubicBezTo>
                    <a:pt x="57920" y="261214"/>
                    <a:pt x="64013" y="247670"/>
                    <a:pt x="50800" y="263525"/>
                  </a:cubicBezTo>
                  <a:cubicBezTo>
                    <a:pt x="28698" y="290047"/>
                    <a:pt x="62752" y="254748"/>
                    <a:pt x="34925" y="282575"/>
                  </a:cubicBezTo>
                  <a:cubicBezTo>
                    <a:pt x="32808" y="288925"/>
                    <a:pt x="32288" y="296056"/>
                    <a:pt x="28575" y="301625"/>
                  </a:cubicBezTo>
                  <a:cubicBezTo>
                    <a:pt x="26458" y="304800"/>
                    <a:pt x="23932" y="307737"/>
                    <a:pt x="22225" y="311150"/>
                  </a:cubicBezTo>
                  <a:cubicBezTo>
                    <a:pt x="9080" y="337440"/>
                    <a:pt x="30898" y="302903"/>
                    <a:pt x="12700" y="330200"/>
                  </a:cubicBezTo>
                  <a:cubicBezTo>
                    <a:pt x="7902" y="349394"/>
                    <a:pt x="10905" y="338760"/>
                    <a:pt x="3175" y="361950"/>
                  </a:cubicBezTo>
                  <a:lnTo>
                    <a:pt x="0" y="371475"/>
                  </a:lnTo>
                  <a:cubicBezTo>
                    <a:pt x="1058" y="383117"/>
                    <a:pt x="1144" y="394888"/>
                    <a:pt x="3175" y="406400"/>
                  </a:cubicBezTo>
                  <a:cubicBezTo>
                    <a:pt x="4338" y="412992"/>
                    <a:pt x="7408" y="419100"/>
                    <a:pt x="9525" y="425450"/>
                  </a:cubicBezTo>
                  <a:lnTo>
                    <a:pt x="22225" y="463550"/>
                  </a:lnTo>
                  <a:cubicBezTo>
                    <a:pt x="23432" y="467170"/>
                    <a:pt x="27025" y="469588"/>
                    <a:pt x="28575" y="473075"/>
                  </a:cubicBezTo>
                  <a:cubicBezTo>
                    <a:pt x="46102" y="512510"/>
                    <a:pt x="21220" y="471568"/>
                    <a:pt x="47625" y="511175"/>
                  </a:cubicBezTo>
                  <a:cubicBezTo>
                    <a:pt x="60200" y="530038"/>
                    <a:pt x="47401" y="526826"/>
                    <a:pt x="60325" y="539750"/>
                  </a:cubicBezTo>
                  <a:cubicBezTo>
                    <a:pt x="63023" y="542448"/>
                    <a:pt x="66675" y="543983"/>
                    <a:pt x="69850" y="546100"/>
                  </a:cubicBezTo>
                  <a:cubicBezTo>
                    <a:pt x="74816" y="556032"/>
                    <a:pt x="76071" y="561889"/>
                    <a:pt x="85725" y="568325"/>
                  </a:cubicBezTo>
                  <a:cubicBezTo>
                    <a:pt x="88510" y="570181"/>
                    <a:pt x="92075" y="570442"/>
                    <a:pt x="95250" y="571500"/>
                  </a:cubicBezTo>
                  <a:cubicBezTo>
                    <a:pt x="96308" y="574675"/>
                    <a:pt x="96058" y="578658"/>
                    <a:pt x="98425" y="581025"/>
                  </a:cubicBezTo>
                  <a:cubicBezTo>
                    <a:pt x="103821" y="586421"/>
                    <a:pt x="117475" y="593725"/>
                    <a:pt x="117475" y="593725"/>
                  </a:cubicBezTo>
                  <a:cubicBezTo>
                    <a:pt x="120057" y="601472"/>
                    <a:pt x="120845" y="606620"/>
                    <a:pt x="127000" y="612775"/>
                  </a:cubicBezTo>
                  <a:cubicBezTo>
                    <a:pt x="129698" y="615473"/>
                    <a:pt x="133594" y="616682"/>
                    <a:pt x="136525" y="619125"/>
                  </a:cubicBezTo>
                  <a:cubicBezTo>
                    <a:pt x="166368" y="643994"/>
                    <a:pt x="116952" y="609252"/>
                    <a:pt x="165100" y="641350"/>
                  </a:cubicBezTo>
                  <a:cubicBezTo>
                    <a:pt x="170669" y="645063"/>
                    <a:pt x="184150" y="647700"/>
                    <a:pt x="184150" y="647700"/>
                  </a:cubicBezTo>
                  <a:cubicBezTo>
                    <a:pt x="191558" y="646642"/>
                    <a:pt x="199083" y="646208"/>
                    <a:pt x="206375" y="644525"/>
                  </a:cubicBezTo>
                  <a:cubicBezTo>
                    <a:pt x="212897" y="643020"/>
                    <a:pt x="225425" y="638175"/>
                    <a:pt x="225425" y="638175"/>
                  </a:cubicBezTo>
                  <a:lnTo>
                    <a:pt x="238125" y="619125"/>
                  </a:lnTo>
                  <a:lnTo>
                    <a:pt x="266700" y="600075"/>
                  </a:lnTo>
                  <a:lnTo>
                    <a:pt x="276225" y="593725"/>
                  </a:lnTo>
                  <a:lnTo>
                    <a:pt x="285750" y="587375"/>
                  </a:lnTo>
                  <a:cubicBezTo>
                    <a:pt x="293363" y="564537"/>
                    <a:pt x="284127" y="593057"/>
                    <a:pt x="292100" y="565150"/>
                  </a:cubicBezTo>
                  <a:cubicBezTo>
                    <a:pt x="293019" y="561932"/>
                    <a:pt x="292552" y="557570"/>
                    <a:pt x="295275" y="555625"/>
                  </a:cubicBezTo>
                  <a:cubicBezTo>
                    <a:pt x="300722" y="551734"/>
                    <a:pt x="314325" y="549275"/>
                    <a:pt x="314325" y="549275"/>
                  </a:cubicBezTo>
                  <a:cubicBezTo>
                    <a:pt x="322792" y="550333"/>
                    <a:pt x="331330" y="550924"/>
                    <a:pt x="339725" y="552450"/>
                  </a:cubicBezTo>
                  <a:cubicBezTo>
                    <a:pt x="343018" y="553049"/>
                    <a:pt x="346883" y="553258"/>
                    <a:pt x="349250" y="555625"/>
                  </a:cubicBezTo>
                  <a:cubicBezTo>
                    <a:pt x="369272" y="575647"/>
                    <a:pt x="357140" y="568230"/>
                    <a:pt x="365125" y="584200"/>
                  </a:cubicBezTo>
                  <a:cubicBezTo>
                    <a:pt x="366832" y="587613"/>
                    <a:pt x="369768" y="590312"/>
                    <a:pt x="371475" y="593725"/>
                  </a:cubicBezTo>
                  <a:cubicBezTo>
                    <a:pt x="372972" y="596718"/>
                    <a:pt x="373153" y="600257"/>
                    <a:pt x="374650" y="603250"/>
                  </a:cubicBezTo>
                  <a:cubicBezTo>
                    <a:pt x="376357" y="606663"/>
                    <a:pt x="379293" y="609362"/>
                    <a:pt x="381000" y="612775"/>
                  </a:cubicBezTo>
                  <a:cubicBezTo>
                    <a:pt x="386165" y="623104"/>
                    <a:pt x="381426" y="622726"/>
                    <a:pt x="390525" y="631825"/>
                  </a:cubicBezTo>
                  <a:cubicBezTo>
                    <a:pt x="393223" y="634523"/>
                    <a:pt x="396875" y="636058"/>
                    <a:pt x="400050" y="638175"/>
                  </a:cubicBezTo>
                  <a:cubicBezTo>
                    <a:pt x="402167" y="641350"/>
                    <a:pt x="403164" y="645678"/>
                    <a:pt x="406400" y="647700"/>
                  </a:cubicBezTo>
                  <a:cubicBezTo>
                    <a:pt x="412076" y="651248"/>
                    <a:pt x="419100" y="651933"/>
                    <a:pt x="425450" y="654050"/>
                  </a:cubicBezTo>
                  <a:lnTo>
                    <a:pt x="434975" y="657225"/>
                  </a:lnTo>
                  <a:cubicBezTo>
                    <a:pt x="438150" y="658283"/>
                    <a:pt x="441507" y="658903"/>
                    <a:pt x="444500" y="660400"/>
                  </a:cubicBezTo>
                  <a:cubicBezTo>
                    <a:pt x="448733" y="662517"/>
                    <a:pt x="452768" y="665088"/>
                    <a:pt x="457200" y="666750"/>
                  </a:cubicBezTo>
                  <a:cubicBezTo>
                    <a:pt x="461286" y="668282"/>
                    <a:pt x="465720" y="668671"/>
                    <a:pt x="469900" y="669925"/>
                  </a:cubicBezTo>
                  <a:cubicBezTo>
                    <a:pt x="476311" y="671848"/>
                    <a:pt x="482600" y="674158"/>
                    <a:pt x="488950" y="676275"/>
                  </a:cubicBezTo>
                  <a:lnTo>
                    <a:pt x="498475" y="679450"/>
                  </a:lnTo>
                  <a:cubicBezTo>
                    <a:pt x="530225" y="678392"/>
                    <a:pt x="562012" y="678140"/>
                    <a:pt x="593725" y="676275"/>
                  </a:cubicBezTo>
                  <a:cubicBezTo>
                    <a:pt x="601491" y="675818"/>
                    <a:pt x="608560" y="671773"/>
                    <a:pt x="615950" y="669925"/>
                  </a:cubicBezTo>
                  <a:cubicBezTo>
                    <a:pt x="621185" y="668616"/>
                    <a:pt x="626462" y="667346"/>
                    <a:pt x="631825" y="666750"/>
                  </a:cubicBezTo>
                  <a:cubicBezTo>
                    <a:pt x="645540" y="665226"/>
                    <a:pt x="659363" y="664883"/>
                    <a:pt x="673100" y="663575"/>
                  </a:cubicBezTo>
                  <a:cubicBezTo>
                    <a:pt x="681594" y="662766"/>
                    <a:pt x="690033" y="661458"/>
                    <a:pt x="698500" y="660400"/>
                  </a:cubicBezTo>
                  <a:cubicBezTo>
                    <a:pt x="701675" y="659342"/>
                    <a:pt x="704778" y="658037"/>
                    <a:pt x="708025" y="657225"/>
                  </a:cubicBezTo>
                  <a:cubicBezTo>
                    <a:pt x="716900" y="655006"/>
                    <a:pt x="734458" y="652290"/>
                    <a:pt x="742950" y="650875"/>
                  </a:cubicBezTo>
                  <a:cubicBezTo>
                    <a:pt x="746125" y="649817"/>
                    <a:pt x="749482" y="649197"/>
                    <a:pt x="752475" y="647700"/>
                  </a:cubicBezTo>
                  <a:cubicBezTo>
                    <a:pt x="755888" y="645993"/>
                    <a:pt x="758513" y="642900"/>
                    <a:pt x="762000" y="641350"/>
                  </a:cubicBezTo>
                  <a:cubicBezTo>
                    <a:pt x="768117" y="638632"/>
                    <a:pt x="781050" y="635000"/>
                    <a:pt x="781050" y="635000"/>
                  </a:cubicBezTo>
                  <a:cubicBezTo>
                    <a:pt x="784225" y="632883"/>
                    <a:pt x="787088" y="630200"/>
                    <a:pt x="790575" y="628650"/>
                  </a:cubicBezTo>
                  <a:cubicBezTo>
                    <a:pt x="796692" y="625932"/>
                    <a:pt x="803275" y="624417"/>
                    <a:pt x="809625" y="622300"/>
                  </a:cubicBezTo>
                  <a:cubicBezTo>
                    <a:pt x="823290" y="617745"/>
                    <a:pt x="815903" y="619937"/>
                    <a:pt x="831850" y="615950"/>
                  </a:cubicBezTo>
                  <a:lnTo>
                    <a:pt x="860425" y="596900"/>
                  </a:lnTo>
                  <a:cubicBezTo>
                    <a:pt x="865994" y="593187"/>
                    <a:pt x="879475" y="590550"/>
                    <a:pt x="879475" y="590550"/>
                  </a:cubicBezTo>
                  <a:cubicBezTo>
                    <a:pt x="882650" y="588433"/>
                    <a:pt x="886069" y="586643"/>
                    <a:pt x="889000" y="584200"/>
                  </a:cubicBezTo>
                  <a:cubicBezTo>
                    <a:pt x="892449" y="581325"/>
                    <a:pt x="894789" y="577166"/>
                    <a:pt x="898525" y="574675"/>
                  </a:cubicBezTo>
                  <a:cubicBezTo>
                    <a:pt x="901310" y="572819"/>
                    <a:pt x="904875" y="572558"/>
                    <a:pt x="908050" y="571500"/>
                  </a:cubicBezTo>
                  <a:cubicBezTo>
                    <a:pt x="912283" y="565150"/>
                    <a:pt x="918337" y="559690"/>
                    <a:pt x="920750" y="552450"/>
                  </a:cubicBezTo>
                  <a:cubicBezTo>
                    <a:pt x="921808" y="549275"/>
                    <a:pt x="921834" y="545538"/>
                    <a:pt x="923925" y="542925"/>
                  </a:cubicBezTo>
                  <a:cubicBezTo>
                    <a:pt x="926309" y="539945"/>
                    <a:pt x="930275" y="538692"/>
                    <a:pt x="933450" y="536575"/>
                  </a:cubicBezTo>
                  <a:cubicBezTo>
                    <a:pt x="941430" y="512634"/>
                    <a:pt x="930665" y="542144"/>
                    <a:pt x="942975" y="517525"/>
                  </a:cubicBezTo>
                  <a:cubicBezTo>
                    <a:pt x="944472" y="514532"/>
                    <a:pt x="944059" y="510613"/>
                    <a:pt x="946150" y="508000"/>
                  </a:cubicBezTo>
                  <a:cubicBezTo>
                    <a:pt x="950626" y="502405"/>
                    <a:pt x="958925" y="500567"/>
                    <a:pt x="965200" y="498475"/>
                  </a:cubicBezTo>
                  <a:cubicBezTo>
                    <a:pt x="983295" y="480380"/>
                    <a:pt x="965039" y="495369"/>
                    <a:pt x="987425" y="485775"/>
                  </a:cubicBezTo>
                  <a:cubicBezTo>
                    <a:pt x="1001388" y="479791"/>
                    <a:pt x="991880" y="478682"/>
                    <a:pt x="1006475" y="476250"/>
                  </a:cubicBezTo>
                  <a:cubicBezTo>
                    <a:pt x="1030244" y="472289"/>
                    <a:pt x="1072801" y="470978"/>
                    <a:pt x="1092200" y="469900"/>
                  </a:cubicBezTo>
                  <a:cubicBezTo>
                    <a:pt x="1098475" y="467808"/>
                    <a:pt x="1106774" y="465970"/>
                    <a:pt x="1111250" y="460375"/>
                  </a:cubicBezTo>
                  <a:cubicBezTo>
                    <a:pt x="1113341" y="457762"/>
                    <a:pt x="1112928" y="453843"/>
                    <a:pt x="1114425" y="450850"/>
                  </a:cubicBezTo>
                  <a:cubicBezTo>
                    <a:pt x="1116132" y="447437"/>
                    <a:pt x="1119225" y="444812"/>
                    <a:pt x="1120775" y="441325"/>
                  </a:cubicBezTo>
                  <a:cubicBezTo>
                    <a:pt x="1123493" y="435208"/>
                    <a:pt x="1125008" y="428625"/>
                    <a:pt x="1127125" y="422275"/>
                  </a:cubicBezTo>
                  <a:lnTo>
                    <a:pt x="1130300" y="412750"/>
                  </a:lnTo>
                  <a:cubicBezTo>
                    <a:pt x="1131358" y="395817"/>
                    <a:pt x="1133475" y="378916"/>
                    <a:pt x="1133475" y="361950"/>
                  </a:cubicBezTo>
                  <a:cubicBezTo>
                    <a:pt x="1133475" y="279804"/>
                    <a:pt x="1138541" y="300949"/>
                    <a:pt x="1123950" y="257175"/>
                  </a:cubicBezTo>
                  <a:cubicBezTo>
                    <a:pt x="1121914" y="251068"/>
                    <a:pt x="1122811" y="244232"/>
                    <a:pt x="1120775" y="238125"/>
                  </a:cubicBezTo>
                  <a:cubicBezTo>
                    <a:pt x="1119568" y="234505"/>
                    <a:pt x="1116318" y="231913"/>
                    <a:pt x="1114425" y="228600"/>
                  </a:cubicBezTo>
                  <a:cubicBezTo>
                    <a:pt x="1104509" y="211248"/>
                    <a:pt x="1113512" y="219525"/>
                    <a:pt x="1098550" y="209550"/>
                  </a:cubicBezTo>
                  <a:cubicBezTo>
                    <a:pt x="1080352" y="182253"/>
                    <a:pt x="1102170" y="216790"/>
                    <a:pt x="1089025" y="190500"/>
                  </a:cubicBezTo>
                  <a:cubicBezTo>
                    <a:pt x="1087318" y="187087"/>
                    <a:pt x="1084382" y="184388"/>
                    <a:pt x="1082675" y="180975"/>
                  </a:cubicBezTo>
                  <a:cubicBezTo>
                    <a:pt x="1081178" y="177982"/>
                    <a:pt x="1081591" y="174063"/>
                    <a:pt x="1079500" y="171450"/>
                  </a:cubicBezTo>
                  <a:cubicBezTo>
                    <a:pt x="1077116" y="168470"/>
                    <a:pt x="1073150" y="167217"/>
                    <a:pt x="1069975" y="165100"/>
                  </a:cubicBezTo>
                  <a:cubicBezTo>
                    <a:pt x="1065742" y="158750"/>
                    <a:pt x="1062671" y="151446"/>
                    <a:pt x="1057275" y="146050"/>
                  </a:cubicBezTo>
                  <a:cubicBezTo>
                    <a:pt x="1054100" y="142875"/>
                    <a:pt x="1050507" y="140069"/>
                    <a:pt x="1047750" y="136525"/>
                  </a:cubicBezTo>
                  <a:cubicBezTo>
                    <a:pt x="1029918" y="113599"/>
                    <a:pt x="1043726" y="120367"/>
                    <a:pt x="1025525" y="114300"/>
                  </a:cubicBezTo>
                  <a:cubicBezTo>
                    <a:pt x="1002844" y="99179"/>
                    <a:pt x="1013879" y="103451"/>
                    <a:pt x="993775" y="98425"/>
                  </a:cubicBezTo>
                  <a:cubicBezTo>
                    <a:pt x="971940" y="83869"/>
                    <a:pt x="981965" y="88138"/>
                    <a:pt x="965200" y="82550"/>
                  </a:cubicBezTo>
                  <a:cubicBezTo>
                    <a:pt x="937903" y="64352"/>
                    <a:pt x="972440" y="86170"/>
                    <a:pt x="946150" y="73025"/>
                  </a:cubicBezTo>
                  <a:cubicBezTo>
                    <a:pt x="942737" y="71318"/>
                    <a:pt x="939800" y="68792"/>
                    <a:pt x="936625" y="66675"/>
                  </a:cubicBezTo>
                  <a:cubicBezTo>
                    <a:pt x="933369" y="61791"/>
                    <a:pt x="922300" y="42489"/>
                    <a:pt x="914400" y="38100"/>
                  </a:cubicBezTo>
                  <a:cubicBezTo>
                    <a:pt x="908549" y="34849"/>
                    <a:pt x="895350" y="31750"/>
                    <a:pt x="895350" y="31750"/>
                  </a:cubicBezTo>
                  <a:cubicBezTo>
                    <a:pt x="880256" y="21687"/>
                    <a:pt x="889445" y="26607"/>
                    <a:pt x="866775" y="19050"/>
                  </a:cubicBezTo>
                  <a:lnTo>
                    <a:pt x="857250" y="15875"/>
                  </a:lnTo>
                  <a:cubicBezTo>
                    <a:pt x="842156" y="5812"/>
                    <a:pt x="851345" y="10732"/>
                    <a:pt x="828675" y="3175"/>
                  </a:cubicBezTo>
                  <a:lnTo>
                    <a:pt x="819150" y="0"/>
                  </a:lnTo>
                  <a:cubicBezTo>
                    <a:pt x="809625" y="1058"/>
                    <a:pt x="800028" y="1599"/>
                    <a:pt x="790575" y="3175"/>
                  </a:cubicBezTo>
                  <a:cubicBezTo>
                    <a:pt x="780825" y="4800"/>
                    <a:pt x="779964" y="7637"/>
                    <a:pt x="771525" y="12700"/>
                  </a:cubicBezTo>
                  <a:cubicBezTo>
                    <a:pt x="769496" y="13918"/>
                    <a:pt x="808037" y="12171"/>
                    <a:pt x="806450" y="12700"/>
                  </a:cubicBezTo>
                  <a:close/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36" name="フリーフォーム 135"/>
            <p:cNvSpPr/>
            <p:nvPr/>
          </p:nvSpPr>
          <p:spPr>
            <a:xfrm>
              <a:off x="1912807" y="1710333"/>
              <a:ext cx="1134325" cy="679450"/>
            </a:xfrm>
            <a:custGeom>
              <a:avLst/>
              <a:gdLst>
                <a:gd name="connsiteX0" fmla="*/ 806450 w 1134325"/>
                <a:gd name="connsiteY0" fmla="*/ 12700 h 679450"/>
                <a:gd name="connsiteX1" fmla="*/ 762000 w 1134325"/>
                <a:gd name="connsiteY1" fmla="*/ 15875 h 679450"/>
                <a:gd name="connsiteX2" fmla="*/ 742950 w 1134325"/>
                <a:gd name="connsiteY2" fmla="*/ 22225 h 679450"/>
                <a:gd name="connsiteX3" fmla="*/ 723900 w 1134325"/>
                <a:gd name="connsiteY3" fmla="*/ 34925 h 679450"/>
                <a:gd name="connsiteX4" fmla="*/ 708025 w 1134325"/>
                <a:gd name="connsiteY4" fmla="*/ 38100 h 679450"/>
                <a:gd name="connsiteX5" fmla="*/ 650875 w 1134325"/>
                <a:gd name="connsiteY5" fmla="*/ 41275 h 679450"/>
                <a:gd name="connsiteX6" fmla="*/ 587375 w 1134325"/>
                <a:gd name="connsiteY6" fmla="*/ 38100 h 679450"/>
                <a:gd name="connsiteX7" fmla="*/ 574675 w 1134325"/>
                <a:gd name="connsiteY7" fmla="*/ 34925 h 679450"/>
                <a:gd name="connsiteX8" fmla="*/ 447675 w 1134325"/>
                <a:gd name="connsiteY8" fmla="*/ 38100 h 679450"/>
                <a:gd name="connsiteX9" fmla="*/ 425450 w 1134325"/>
                <a:gd name="connsiteY9" fmla="*/ 44450 h 679450"/>
                <a:gd name="connsiteX10" fmla="*/ 412750 w 1134325"/>
                <a:gd name="connsiteY10" fmla="*/ 47625 h 679450"/>
                <a:gd name="connsiteX11" fmla="*/ 393700 w 1134325"/>
                <a:gd name="connsiteY11" fmla="*/ 53975 h 679450"/>
                <a:gd name="connsiteX12" fmla="*/ 384175 w 1134325"/>
                <a:gd name="connsiteY12" fmla="*/ 57150 h 679450"/>
                <a:gd name="connsiteX13" fmla="*/ 355600 w 1134325"/>
                <a:gd name="connsiteY13" fmla="*/ 60325 h 679450"/>
                <a:gd name="connsiteX14" fmla="*/ 327025 w 1134325"/>
                <a:gd name="connsiteY14" fmla="*/ 66675 h 679450"/>
                <a:gd name="connsiteX15" fmla="*/ 282575 w 1134325"/>
                <a:gd name="connsiteY15" fmla="*/ 73025 h 679450"/>
                <a:gd name="connsiteX16" fmla="*/ 244475 w 1134325"/>
                <a:gd name="connsiteY16" fmla="*/ 85725 h 679450"/>
                <a:gd name="connsiteX17" fmla="*/ 215900 w 1134325"/>
                <a:gd name="connsiteY17" fmla="*/ 92075 h 679450"/>
                <a:gd name="connsiteX18" fmla="*/ 196850 w 1134325"/>
                <a:gd name="connsiteY18" fmla="*/ 98425 h 679450"/>
                <a:gd name="connsiteX19" fmla="*/ 187325 w 1134325"/>
                <a:gd name="connsiteY19" fmla="*/ 101600 h 679450"/>
                <a:gd name="connsiteX20" fmla="*/ 165100 w 1134325"/>
                <a:gd name="connsiteY20" fmla="*/ 130175 h 679450"/>
                <a:gd name="connsiteX21" fmla="*/ 149225 w 1134325"/>
                <a:gd name="connsiteY21" fmla="*/ 158750 h 679450"/>
                <a:gd name="connsiteX22" fmla="*/ 142875 w 1134325"/>
                <a:gd name="connsiteY22" fmla="*/ 168275 h 679450"/>
                <a:gd name="connsiteX23" fmla="*/ 133350 w 1134325"/>
                <a:gd name="connsiteY23" fmla="*/ 171450 h 679450"/>
                <a:gd name="connsiteX24" fmla="*/ 104775 w 1134325"/>
                <a:gd name="connsiteY24" fmla="*/ 190500 h 679450"/>
                <a:gd name="connsiteX25" fmla="*/ 85725 w 1134325"/>
                <a:gd name="connsiteY25" fmla="*/ 206375 h 679450"/>
                <a:gd name="connsiteX26" fmla="*/ 73025 w 1134325"/>
                <a:gd name="connsiteY26" fmla="*/ 234950 h 679450"/>
                <a:gd name="connsiteX27" fmla="*/ 63500 w 1134325"/>
                <a:gd name="connsiteY27" fmla="*/ 244475 h 679450"/>
                <a:gd name="connsiteX28" fmla="*/ 50800 w 1134325"/>
                <a:gd name="connsiteY28" fmla="*/ 263525 h 679450"/>
                <a:gd name="connsiteX29" fmla="*/ 34925 w 1134325"/>
                <a:gd name="connsiteY29" fmla="*/ 282575 h 679450"/>
                <a:gd name="connsiteX30" fmla="*/ 28575 w 1134325"/>
                <a:gd name="connsiteY30" fmla="*/ 301625 h 679450"/>
                <a:gd name="connsiteX31" fmla="*/ 22225 w 1134325"/>
                <a:gd name="connsiteY31" fmla="*/ 311150 h 679450"/>
                <a:gd name="connsiteX32" fmla="*/ 12700 w 1134325"/>
                <a:gd name="connsiteY32" fmla="*/ 330200 h 679450"/>
                <a:gd name="connsiteX33" fmla="*/ 3175 w 1134325"/>
                <a:gd name="connsiteY33" fmla="*/ 361950 h 679450"/>
                <a:gd name="connsiteX34" fmla="*/ 0 w 1134325"/>
                <a:gd name="connsiteY34" fmla="*/ 371475 h 679450"/>
                <a:gd name="connsiteX35" fmla="*/ 3175 w 1134325"/>
                <a:gd name="connsiteY35" fmla="*/ 406400 h 679450"/>
                <a:gd name="connsiteX36" fmla="*/ 9525 w 1134325"/>
                <a:gd name="connsiteY36" fmla="*/ 425450 h 679450"/>
                <a:gd name="connsiteX37" fmla="*/ 22225 w 1134325"/>
                <a:gd name="connsiteY37" fmla="*/ 463550 h 679450"/>
                <a:gd name="connsiteX38" fmla="*/ 28575 w 1134325"/>
                <a:gd name="connsiteY38" fmla="*/ 473075 h 679450"/>
                <a:gd name="connsiteX39" fmla="*/ 47625 w 1134325"/>
                <a:gd name="connsiteY39" fmla="*/ 511175 h 679450"/>
                <a:gd name="connsiteX40" fmla="*/ 60325 w 1134325"/>
                <a:gd name="connsiteY40" fmla="*/ 539750 h 679450"/>
                <a:gd name="connsiteX41" fmla="*/ 69850 w 1134325"/>
                <a:gd name="connsiteY41" fmla="*/ 546100 h 679450"/>
                <a:gd name="connsiteX42" fmla="*/ 85725 w 1134325"/>
                <a:gd name="connsiteY42" fmla="*/ 568325 h 679450"/>
                <a:gd name="connsiteX43" fmla="*/ 95250 w 1134325"/>
                <a:gd name="connsiteY43" fmla="*/ 571500 h 679450"/>
                <a:gd name="connsiteX44" fmla="*/ 98425 w 1134325"/>
                <a:gd name="connsiteY44" fmla="*/ 581025 h 679450"/>
                <a:gd name="connsiteX45" fmla="*/ 117475 w 1134325"/>
                <a:gd name="connsiteY45" fmla="*/ 593725 h 679450"/>
                <a:gd name="connsiteX46" fmla="*/ 127000 w 1134325"/>
                <a:gd name="connsiteY46" fmla="*/ 612775 h 679450"/>
                <a:gd name="connsiteX47" fmla="*/ 136525 w 1134325"/>
                <a:gd name="connsiteY47" fmla="*/ 619125 h 679450"/>
                <a:gd name="connsiteX48" fmla="*/ 165100 w 1134325"/>
                <a:gd name="connsiteY48" fmla="*/ 641350 h 679450"/>
                <a:gd name="connsiteX49" fmla="*/ 184150 w 1134325"/>
                <a:gd name="connsiteY49" fmla="*/ 647700 h 679450"/>
                <a:gd name="connsiteX50" fmla="*/ 206375 w 1134325"/>
                <a:gd name="connsiteY50" fmla="*/ 644525 h 679450"/>
                <a:gd name="connsiteX51" fmla="*/ 225425 w 1134325"/>
                <a:gd name="connsiteY51" fmla="*/ 638175 h 679450"/>
                <a:gd name="connsiteX52" fmla="*/ 238125 w 1134325"/>
                <a:gd name="connsiteY52" fmla="*/ 619125 h 679450"/>
                <a:gd name="connsiteX53" fmla="*/ 266700 w 1134325"/>
                <a:gd name="connsiteY53" fmla="*/ 600075 h 679450"/>
                <a:gd name="connsiteX54" fmla="*/ 276225 w 1134325"/>
                <a:gd name="connsiteY54" fmla="*/ 593725 h 679450"/>
                <a:gd name="connsiteX55" fmla="*/ 285750 w 1134325"/>
                <a:gd name="connsiteY55" fmla="*/ 587375 h 679450"/>
                <a:gd name="connsiteX56" fmla="*/ 292100 w 1134325"/>
                <a:gd name="connsiteY56" fmla="*/ 565150 h 679450"/>
                <a:gd name="connsiteX57" fmla="*/ 295275 w 1134325"/>
                <a:gd name="connsiteY57" fmla="*/ 555625 h 679450"/>
                <a:gd name="connsiteX58" fmla="*/ 314325 w 1134325"/>
                <a:gd name="connsiteY58" fmla="*/ 549275 h 679450"/>
                <a:gd name="connsiteX59" fmla="*/ 339725 w 1134325"/>
                <a:gd name="connsiteY59" fmla="*/ 552450 h 679450"/>
                <a:gd name="connsiteX60" fmla="*/ 349250 w 1134325"/>
                <a:gd name="connsiteY60" fmla="*/ 555625 h 679450"/>
                <a:gd name="connsiteX61" fmla="*/ 365125 w 1134325"/>
                <a:gd name="connsiteY61" fmla="*/ 584200 h 679450"/>
                <a:gd name="connsiteX62" fmla="*/ 371475 w 1134325"/>
                <a:gd name="connsiteY62" fmla="*/ 593725 h 679450"/>
                <a:gd name="connsiteX63" fmla="*/ 374650 w 1134325"/>
                <a:gd name="connsiteY63" fmla="*/ 603250 h 679450"/>
                <a:gd name="connsiteX64" fmla="*/ 381000 w 1134325"/>
                <a:gd name="connsiteY64" fmla="*/ 612775 h 679450"/>
                <a:gd name="connsiteX65" fmla="*/ 390525 w 1134325"/>
                <a:gd name="connsiteY65" fmla="*/ 631825 h 679450"/>
                <a:gd name="connsiteX66" fmla="*/ 400050 w 1134325"/>
                <a:gd name="connsiteY66" fmla="*/ 638175 h 679450"/>
                <a:gd name="connsiteX67" fmla="*/ 406400 w 1134325"/>
                <a:gd name="connsiteY67" fmla="*/ 647700 h 679450"/>
                <a:gd name="connsiteX68" fmla="*/ 425450 w 1134325"/>
                <a:gd name="connsiteY68" fmla="*/ 654050 h 679450"/>
                <a:gd name="connsiteX69" fmla="*/ 434975 w 1134325"/>
                <a:gd name="connsiteY69" fmla="*/ 657225 h 679450"/>
                <a:gd name="connsiteX70" fmla="*/ 444500 w 1134325"/>
                <a:gd name="connsiteY70" fmla="*/ 660400 h 679450"/>
                <a:gd name="connsiteX71" fmla="*/ 457200 w 1134325"/>
                <a:gd name="connsiteY71" fmla="*/ 666750 h 679450"/>
                <a:gd name="connsiteX72" fmla="*/ 469900 w 1134325"/>
                <a:gd name="connsiteY72" fmla="*/ 669925 h 679450"/>
                <a:gd name="connsiteX73" fmla="*/ 488950 w 1134325"/>
                <a:gd name="connsiteY73" fmla="*/ 676275 h 679450"/>
                <a:gd name="connsiteX74" fmla="*/ 498475 w 1134325"/>
                <a:gd name="connsiteY74" fmla="*/ 679450 h 679450"/>
                <a:gd name="connsiteX75" fmla="*/ 593725 w 1134325"/>
                <a:gd name="connsiteY75" fmla="*/ 676275 h 679450"/>
                <a:gd name="connsiteX76" fmla="*/ 615950 w 1134325"/>
                <a:gd name="connsiteY76" fmla="*/ 669925 h 679450"/>
                <a:gd name="connsiteX77" fmla="*/ 631825 w 1134325"/>
                <a:gd name="connsiteY77" fmla="*/ 666750 h 679450"/>
                <a:gd name="connsiteX78" fmla="*/ 673100 w 1134325"/>
                <a:gd name="connsiteY78" fmla="*/ 663575 h 679450"/>
                <a:gd name="connsiteX79" fmla="*/ 698500 w 1134325"/>
                <a:gd name="connsiteY79" fmla="*/ 660400 h 679450"/>
                <a:gd name="connsiteX80" fmla="*/ 708025 w 1134325"/>
                <a:gd name="connsiteY80" fmla="*/ 657225 h 679450"/>
                <a:gd name="connsiteX81" fmla="*/ 742950 w 1134325"/>
                <a:gd name="connsiteY81" fmla="*/ 650875 h 679450"/>
                <a:gd name="connsiteX82" fmla="*/ 752475 w 1134325"/>
                <a:gd name="connsiteY82" fmla="*/ 647700 h 679450"/>
                <a:gd name="connsiteX83" fmla="*/ 762000 w 1134325"/>
                <a:gd name="connsiteY83" fmla="*/ 641350 h 679450"/>
                <a:gd name="connsiteX84" fmla="*/ 781050 w 1134325"/>
                <a:gd name="connsiteY84" fmla="*/ 635000 h 679450"/>
                <a:gd name="connsiteX85" fmla="*/ 790575 w 1134325"/>
                <a:gd name="connsiteY85" fmla="*/ 628650 h 679450"/>
                <a:gd name="connsiteX86" fmla="*/ 809625 w 1134325"/>
                <a:gd name="connsiteY86" fmla="*/ 622300 h 679450"/>
                <a:gd name="connsiteX87" fmla="*/ 831850 w 1134325"/>
                <a:gd name="connsiteY87" fmla="*/ 615950 h 679450"/>
                <a:gd name="connsiteX88" fmla="*/ 860425 w 1134325"/>
                <a:gd name="connsiteY88" fmla="*/ 596900 h 679450"/>
                <a:gd name="connsiteX89" fmla="*/ 879475 w 1134325"/>
                <a:gd name="connsiteY89" fmla="*/ 590550 h 679450"/>
                <a:gd name="connsiteX90" fmla="*/ 889000 w 1134325"/>
                <a:gd name="connsiteY90" fmla="*/ 584200 h 679450"/>
                <a:gd name="connsiteX91" fmla="*/ 898525 w 1134325"/>
                <a:gd name="connsiteY91" fmla="*/ 574675 h 679450"/>
                <a:gd name="connsiteX92" fmla="*/ 908050 w 1134325"/>
                <a:gd name="connsiteY92" fmla="*/ 571500 h 679450"/>
                <a:gd name="connsiteX93" fmla="*/ 920750 w 1134325"/>
                <a:gd name="connsiteY93" fmla="*/ 552450 h 679450"/>
                <a:gd name="connsiteX94" fmla="*/ 923925 w 1134325"/>
                <a:gd name="connsiteY94" fmla="*/ 542925 h 679450"/>
                <a:gd name="connsiteX95" fmla="*/ 933450 w 1134325"/>
                <a:gd name="connsiteY95" fmla="*/ 536575 h 679450"/>
                <a:gd name="connsiteX96" fmla="*/ 942975 w 1134325"/>
                <a:gd name="connsiteY96" fmla="*/ 517525 h 679450"/>
                <a:gd name="connsiteX97" fmla="*/ 946150 w 1134325"/>
                <a:gd name="connsiteY97" fmla="*/ 508000 h 679450"/>
                <a:gd name="connsiteX98" fmla="*/ 965200 w 1134325"/>
                <a:gd name="connsiteY98" fmla="*/ 498475 h 679450"/>
                <a:gd name="connsiteX99" fmla="*/ 987425 w 1134325"/>
                <a:gd name="connsiteY99" fmla="*/ 485775 h 679450"/>
                <a:gd name="connsiteX100" fmla="*/ 1006475 w 1134325"/>
                <a:gd name="connsiteY100" fmla="*/ 476250 h 679450"/>
                <a:gd name="connsiteX101" fmla="*/ 1092200 w 1134325"/>
                <a:gd name="connsiteY101" fmla="*/ 469900 h 679450"/>
                <a:gd name="connsiteX102" fmla="*/ 1111250 w 1134325"/>
                <a:gd name="connsiteY102" fmla="*/ 460375 h 679450"/>
                <a:gd name="connsiteX103" fmla="*/ 1114425 w 1134325"/>
                <a:gd name="connsiteY103" fmla="*/ 450850 h 679450"/>
                <a:gd name="connsiteX104" fmla="*/ 1120775 w 1134325"/>
                <a:gd name="connsiteY104" fmla="*/ 441325 h 679450"/>
                <a:gd name="connsiteX105" fmla="*/ 1127125 w 1134325"/>
                <a:gd name="connsiteY105" fmla="*/ 422275 h 679450"/>
                <a:gd name="connsiteX106" fmla="*/ 1130300 w 1134325"/>
                <a:gd name="connsiteY106" fmla="*/ 412750 h 679450"/>
                <a:gd name="connsiteX107" fmla="*/ 1133475 w 1134325"/>
                <a:gd name="connsiteY107" fmla="*/ 361950 h 679450"/>
                <a:gd name="connsiteX108" fmla="*/ 1123950 w 1134325"/>
                <a:gd name="connsiteY108" fmla="*/ 257175 h 679450"/>
                <a:gd name="connsiteX109" fmla="*/ 1120775 w 1134325"/>
                <a:gd name="connsiteY109" fmla="*/ 238125 h 679450"/>
                <a:gd name="connsiteX110" fmla="*/ 1114425 w 1134325"/>
                <a:gd name="connsiteY110" fmla="*/ 228600 h 679450"/>
                <a:gd name="connsiteX111" fmla="*/ 1098550 w 1134325"/>
                <a:gd name="connsiteY111" fmla="*/ 209550 h 679450"/>
                <a:gd name="connsiteX112" fmla="*/ 1089025 w 1134325"/>
                <a:gd name="connsiteY112" fmla="*/ 190500 h 679450"/>
                <a:gd name="connsiteX113" fmla="*/ 1082675 w 1134325"/>
                <a:gd name="connsiteY113" fmla="*/ 180975 h 679450"/>
                <a:gd name="connsiteX114" fmla="*/ 1079500 w 1134325"/>
                <a:gd name="connsiteY114" fmla="*/ 171450 h 679450"/>
                <a:gd name="connsiteX115" fmla="*/ 1069975 w 1134325"/>
                <a:gd name="connsiteY115" fmla="*/ 165100 h 679450"/>
                <a:gd name="connsiteX116" fmla="*/ 1057275 w 1134325"/>
                <a:gd name="connsiteY116" fmla="*/ 146050 h 679450"/>
                <a:gd name="connsiteX117" fmla="*/ 1047750 w 1134325"/>
                <a:gd name="connsiteY117" fmla="*/ 136525 h 679450"/>
                <a:gd name="connsiteX118" fmla="*/ 1025525 w 1134325"/>
                <a:gd name="connsiteY118" fmla="*/ 114300 h 679450"/>
                <a:gd name="connsiteX119" fmla="*/ 993775 w 1134325"/>
                <a:gd name="connsiteY119" fmla="*/ 98425 h 679450"/>
                <a:gd name="connsiteX120" fmla="*/ 965200 w 1134325"/>
                <a:gd name="connsiteY120" fmla="*/ 82550 h 679450"/>
                <a:gd name="connsiteX121" fmla="*/ 946150 w 1134325"/>
                <a:gd name="connsiteY121" fmla="*/ 73025 h 679450"/>
                <a:gd name="connsiteX122" fmla="*/ 936625 w 1134325"/>
                <a:gd name="connsiteY122" fmla="*/ 66675 h 679450"/>
                <a:gd name="connsiteX123" fmla="*/ 914400 w 1134325"/>
                <a:gd name="connsiteY123" fmla="*/ 38100 h 679450"/>
                <a:gd name="connsiteX124" fmla="*/ 895350 w 1134325"/>
                <a:gd name="connsiteY124" fmla="*/ 31750 h 679450"/>
                <a:gd name="connsiteX125" fmla="*/ 866775 w 1134325"/>
                <a:gd name="connsiteY125" fmla="*/ 19050 h 679450"/>
                <a:gd name="connsiteX126" fmla="*/ 857250 w 1134325"/>
                <a:gd name="connsiteY126" fmla="*/ 15875 h 679450"/>
                <a:gd name="connsiteX127" fmla="*/ 828675 w 1134325"/>
                <a:gd name="connsiteY127" fmla="*/ 3175 h 679450"/>
                <a:gd name="connsiteX128" fmla="*/ 819150 w 1134325"/>
                <a:gd name="connsiteY128" fmla="*/ 0 h 679450"/>
                <a:gd name="connsiteX129" fmla="*/ 790575 w 1134325"/>
                <a:gd name="connsiteY129" fmla="*/ 3175 h 679450"/>
                <a:gd name="connsiteX130" fmla="*/ 771525 w 1134325"/>
                <a:gd name="connsiteY130" fmla="*/ 12700 h 679450"/>
                <a:gd name="connsiteX131" fmla="*/ 806450 w 1134325"/>
                <a:gd name="connsiteY131" fmla="*/ 12700 h 6794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</a:cxnLst>
              <a:rect l="l" t="t" r="r" b="b"/>
              <a:pathLst>
                <a:path w="1134325" h="679450">
                  <a:moveTo>
                    <a:pt x="806450" y="12700"/>
                  </a:moveTo>
                  <a:cubicBezTo>
                    <a:pt x="804863" y="13229"/>
                    <a:pt x="776690" y="13671"/>
                    <a:pt x="762000" y="15875"/>
                  </a:cubicBezTo>
                  <a:cubicBezTo>
                    <a:pt x="755381" y="16868"/>
                    <a:pt x="742950" y="22225"/>
                    <a:pt x="742950" y="22225"/>
                  </a:cubicBezTo>
                  <a:lnTo>
                    <a:pt x="723900" y="34925"/>
                  </a:lnTo>
                  <a:cubicBezTo>
                    <a:pt x="719410" y="37918"/>
                    <a:pt x="713401" y="37633"/>
                    <a:pt x="708025" y="38100"/>
                  </a:cubicBezTo>
                  <a:cubicBezTo>
                    <a:pt x="689017" y="39753"/>
                    <a:pt x="669925" y="40217"/>
                    <a:pt x="650875" y="41275"/>
                  </a:cubicBezTo>
                  <a:cubicBezTo>
                    <a:pt x="629708" y="40217"/>
                    <a:pt x="608495" y="39860"/>
                    <a:pt x="587375" y="38100"/>
                  </a:cubicBezTo>
                  <a:cubicBezTo>
                    <a:pt x="583026" y="37738"/>
                    <a:pt x="579039" y="34925"/>
                    <a:pt x="574675" y="34925"/>
                  </a:cubicBezTo>
                  <a:cubicBezTo>
                    <a:pt x="532328" y="34925"/>
                    <a:pt x="490008" y="37042"/>
                    <a:pt x="447675" y="38100"/>
                  </a:cubicBezTo>
                  <a:cubicBezTo>
                    <a:pt x="407973" y="48026"/>
                    <a:pt x="457334" y="35340"/>
                    <a:pt x="425450" y="44450"/>
                  </a:cubicBezTo>
                  <a:cubicBezTo>
                    <a:pt x="421254" y="45649"/>
                    <a:pt x="416930" y="46371"/>
                    <a:pt x="412750" y="47625"/>
                  </a:cubicBezTo>
                  <a:cubicBezTo>
                    <a:pt x="406339" y="49548"/>
                    <a:pt x="400050" y="51858"/>
                    <a:pt x="393700" y="53975"/>
                  </a:cubicBezTo>
                  <a:cubicBezTo>
                    <a:pt x="390525" y="55033"/>
                    <a:pt x="387501" y="56780"/>
                    <a:pt x="384175" y="57150"/>
                  </a:cubicBezTo>
                  <a:lnTo>
                    <a:pt x="355600" y="60325"/>
                  </a:lnTo>
                  <a:cubicBezTo>
                    <a:pt x="338806" y="65923"/>
                    <a:pt x="351611" y="62205"/>
                    <a:pt x="327025" y="66675"/>
                  </a:cubicBezTo>
                  <a:cubicBezTo>
                    <a:pt x="295254" y="72452"/>
                    <a:pt x="328054" y="67972"/>
                    <a:pt x="282575" y="73025"/>
                  </a:cubicBezTo>
                  <a:lnTo>
                    <a:pt x="244475" y="85725"/>
                  </a:lnTo>
                  <a:cubicBezTo>
                    <a:pt x="231645" y="90002"/>
                    <a:pt x="229740" y="88300"/>
                    <a:pt x="215900" y="92075"/>
                  </a:cubicBezTo>
                  <a:cubicBezTo>
                    <a:pt x="209442" y="93836"/>
                    <a:pt x="203200" y="96308"/>
                    <a:pt x="196850" y="98425"/>
                  </a:cubicBezTo>
                  <a:lnTo>
                    <a:pt x="187325" y="101600"/>
                  </a:lnTo>
                  <a:cubicBezTo>
                    <a:pt x="179107" y="109818"/>
                    <a:pt x="168898" y="118782"/>
                    <a:pt x="165100" y="130175"/>
                  </a:cubicBezTo>
                  <a:cubicBezTo>
                    <a:pt x="159512" y="146940"/>
                    <a:pt x="163781" y="136915"/>
                    <a:pt x="149225" y="158750"/>
                  </a:cubicBezTo>
                  <a:cubicBezTo>
                    <a:pt x="147108" y="161925"/>
                    <a:pt x="146495" y="167068"/>
                    <a:pt x="142875" y="168275"/>
                  </a:cubicBezTo>
                  <a:lnTo>
                    <a:pt x="133350" y="171450"/>
                  </a:lnTo>
                  <a:lnTo>
                    <a:pt x="104775" y="190500"/>
                  </a:lnTo>
                  <a:cubicBezTo>
                    <a:pt x="95409" y="196744"/>
                    <a:pt x="93365" y="197208"/>
                    <a:pt x="85725" y="206375"/>
                  </a:cubicBezTo>
                  <a:cubicBezTo>
                    <a:pt x="77339" y="216438"/>
                    <a:pt x="77640" y="221106"/>
                    <a:pt x="73025" y="234950"/>
                  </a:cubicBezTo>
                  <a:cubicBezTo>
                    <a:pt x="71605" y="239210"/>
                    <a:pt x="66675" y="241300"/>
                    <a:pt x="63500" y="244475"/>
                  </a:cubicBezTo>
                  <a:cubicBezTo>
                    <a:pt x="57920" y="261214"/>
                    <a:pt x="64013" y="247670"/>
                    <a:pt x="50800" y="263525"/>
                  </a:cubicBezTo>
                  <a:cubicBezTo>
                    <a:pt x="28698" y="290047"/>
                    <a:pt x="62752" y="254748"/>
                    <a:pt x="34925" y="282575"/>
                  </a:cubicBezTo>
                  <a:cubicBezTo>
                    <a:pt x="32808" y="288925"/>
                    <a:pt x="32288" y="296056"/>
                    <a:pt x="28575" y="301625"/>
                  </a:cubicBezTo>
                  <a:cubicBezTo>
                    <a:pt x="26458" y="304800"/>
                    <a:pt x="23932" y="307737"/>
                    <a:pt x="22225" y="311150"/>
                  </a:cubicBezTo>
                  <a:cubicBezTo>
                    <a:pt x="9080" y="337440"/>
                    <a:pt x="30898" y="302903"/>
                    <a:pt x="12700" y="330200"/>
                  </a:cubicBezTo>
                  <a:cubicBezTo>
                    <a:pt x="7902" y="349394"/>
                    <a:pt x="10905" y="338760"/>
                    <a:pt x="3175" y="361950"/>
                  </a:cubicBezTo>
                  <a:lnTo>
                    <a:pt x="0" y="371475"/>
                  </a:lnTo>
                  <a:cubicBezTo>
                    <a:pt x="1058" y="383117"/>
                    <a:pt x="1144" y="394888"/>
                    <a:pt x="3175" y="406400"/>
                  </a:cubicBezTo>
                  <a:cubicBezTo>
                    <a:pt x="4338" y="412992"/>
                    <a:pt x="7408" y="419100"/>
                    <a:pt x="9525" y="425450"/>
                  </a:cubicBezTo>
                  <a:lnTo>
                    <a:pt x="22225" y="463550"/>
                  </a:lnTo>
                  <a:cubicBezTo>
                    <a:pt x="23432" y="467170"/>
                    <a:pt x="27025" y="469588"/>
                    <a:pt x="28575" y="473075"/>
                  </a:cubicBezTo>
                  <a:cubicBezTo>
                    <a:pt x="46102" y="512510"/>
                    <a:pt x="21220" y="471568"/>
                    <a:pt x="47625" y="511175"/>
                  </a:cubicBezTo>
                  <a:cubicBezTo>
                    <a:pt x="60200" y="530038"/>
                    <a:pt x="47401" y="526826"/>
                    <a:pt x="60325" y="539750"/>
                  </a:cubicBezTo>
                  <a:cubicBezTo>
                    <a:pt x="63023" y="542448"/>
                    <a:pt x="66675" y="543983"/>
                    <a:pt x="69850" y="546100"/>
                  </a:cubicBezTo>
                  <a:cubicBezTo>
                    <a:pt x="74816" y="556032"/>
                    <a:pt x="76071" y="561889"/>
                    <a:pt x="85725" y="568325"/>
                  </a:cubicBezTo>
                  <a:cubicBezTo>
                    <a:pt x="88510" y="570181"/>
                    <a:pt x="92075" y="570442"/>
                    <a:pt x="95250" y="571500"/>
                  </a:cubicBezTo>
                  <a:cubicBezTo>
                    <a:pt x="96308" y="574675"/>
                    <a:pt x="96058" y="578658"/>
                    <a:pt x="98425" y="581025"/>
                  </a:cubicBezTo>
                  <a:cubicBezTo>
                    <a:pt x="103821" y="586421"/>
                    <a:pt x="117475" y="593725"/>
                    <a:pt x="117475" y="593725"/>
                  </a:cubicBezTo>
                  <a:cubicBezTo>
                    <a:pt x="120057" y="601472"/>
                    <a:pt x="120845" y="606620"/>
                    <a:pt x="127000" y="612775"/>
                  </a:cubicBezTo>
                  <a:cubicBezTo>
                    <a:pt x="129698" y="615473"/>
                    <a:pt x="133594" y="616682"/>
                    <a:pt x="136525" y="619125"/>
                  </a:cubicBezTo>
                  <a:cubicBezTo>
                    <a:pt x="166368" y="643994"/>
                    <a:pt x="116952" y="609252"/>
                    <a:pt x="165100" y="641350"/>
                  </a:cubicBezTo>
                  <a:cubicBezTo>
                    <a:pt x="170669" y="645063"/>
                    <a:pt x="184150" y="647700"/>
                    <a:pt x="184150" y="647700"/>
                  </a:cubicBezTo>
                  <a:cubicBezTo>
                    <a:pt x="191558" y="646642"/>
                    <a:pt x="199083" y="646208"/>
                    <a:pt x="206375" y="644525"/>
                  </a:cubicBezTo>
                  <a:cubicBezTo>
                    <a:pt x="212897" y="643020"/>
                    <a:pt x="225425" y="638175"/>
                    <a:pt x="225425" y="638175"/>
                  </a:cubicBezTo>
                  <a:lnTo>
                    <a:pt x="238125" y="619125"/>
                  </a:lnTo>
                  <a:lnTo>
                    <a:pt x="266700" y="600075"/>
                  </a:lnTo>
                  <a:lnTo>
                    <a:pt x="276225" y="593725"/>
                  </a:lnTo>
                  <a:lnTo>
                    <a:pt x="285750" y="587375"/>
                  </a:lnTo>
                  <a:cubicBezTo>
                    <a:pt x="293363" y="564537"/>
                    <a:pt x="284127" y="593057"/>
                    <a:pt x="292100" y="565150"/>
                  </a:cubicBezTo>
                  <a:cubicBezTo>
                    <a:pt x="293019" y="561932"/>
                    <a:pt x="292552" y="557570"/>
                    <a:pt x="295275" y="555625"/>
                  </a:cubicBezTo>
                  <a:cubicBezTo>
                    <a:pt x="300722" y="551734"/>
                    <a:pt x="314325" y="549275"/>
                    <a:pt x="314325" y="549275"/>
                  </a:cubicBezTo>
                  <a:cubicBezTo>
                    <a:pt x="322792" y="550333"/>
                    <a:pt x="331330" y="550924"/>
                    <a:pt x="339725" y="552450"/>
                  </a:cubicBezTo>
                  <a:cubicBezTo>
                    <a:pt x="343018" y="553049"/>
                    <a:pt x="346883" y="553258"/>
                    <a:pt x="349250" y="555625"/>
                  </a:cubicBezTo>
                  <a:cubicBezTo>
                    <a:pt x="369272" y="575647"/>
                    <a:pt x="357140" y="568230"/>
                    <a:pt x="365125" y="584200"/>
                  </a:cubicBezTo>
                  <a:cubicBezTo>
                    <a:pt x="366832" y="587613"/>
                    <a:pt x="369768" y="590312"/>
                    <a:pt x="371475" y="593725"/>
                  </a:cubicBezTo>
                  <a:cubicBezTo>
                    <a:pt x="372972" y="596718"/>
                    <a:pt x="373153" y="600257"/>
                    <a:pt x="374650" y="603250"/>
                  </a:cubicBezTo>
                  <a:cubicBezTo>
                    <a:pt x="376357" y="606663"/>
                    <a:pt x="379293" y="609362"/>
                    <a:pt x="381000" y="612775"/>
                  </a:cubicBezTo>
                  <a:cubicBezTo>
                    <a:pt x="386165" y="623104"/>
                    <a:pt x="381426" y="622726"/>
                    <a:pt x="390525" y="631825"/>
                  </a:cubicBezTo>
                  <a:cubicBezTo>
                    <a:pt x="393223" y="634523"/>
                    <a:pt x="396875" y="636058"/>
                    <a:pt x="400050" y="638175"/>
                  </a:cubicBezTo>
                  <a:cubicBezTo>
                    <a:pt x="402167" y="641350"/>
                    <a:pt x="403164" y="645678"/>
                    <a:pt x="406400" y="647700"/>
                  </a:cubicBezTo>
                  <a:cubicBezTo>
                    <a:pt x="412076" y="651248"/>
                    <a:pt x="419100" y="651933"/>
                    <a:pt x="425450" y="654050"/>
                  </a:cubicBezTo>
                  <a:lnTo>
                    <a:pt x="434975" y="657225"/>
                  </a:lnTo>
                  <a:cubicBezTo>
                    <a:pt x="438150" y="658283"/>
                    <a:pt x="441507" y="658903"/>
                    <a:pt x="444500" y="660400"/>
                  </a:cubicBezTo>
                  <a:cubicBezTo>
                    <a:pt x="448733" y="662517"/>
                    <a:pt x="452768" y="665088"/>
                    <a:pt x="457200" y="666750"/>
                  </a:cubicBezTo>
                  <a:cubicBezTo>
                    <a:pt x="461286" y="668282"/>
                    <a:pt x="465720" y="668671"/>
                    <a:pt x="469900" y="669925"/>
                  </a:cubicBezTo>
                  <a:cubicBezTo>
                    <a:pt x="476311" y="671848"/>
                    <a:pt x="482600" y="674158"/>
                    <a:pt x="488950" y="676275"/>
                  </a:cubicBezTo>
                  <a:lnTo>
                    <a:pt x="498475" y="679450"/>
                  </a:lnTo>
                  <a:cubicBezTo>
                    <a:pt x="530225" y="678392"/>
                    <a:pt x="562012" y="678140"/>
                    <a:pt x="593725" y="676275"/>
                  </a:cubicBezTo>
                  <a:cubicBezTo>
                    <a:pt x="601491" y="675818"/>
                    <a:pt x="608560" y="671773"/>
                    <a:pt x="615950" y="669925"/>
                  </a:cubicBezTo>
                  <a:cubicBezTo>
                    <a:pt x="621185" y="668616"/>
                    <a:pt x="626462" y="667346"/>
                    <a:pt x="631825" y="666750"/>
                  </a:cubicBezTo>
                  <a:cubicBezTo>
                    <a:pt x="645540" y="665226"/>
                    <a:pt x="659363" y="664883"/>
                    <a:pt x="673100" y="663575"/>
                  </a:cubicBezTo>
                  <a:cubicBezTo>
                    <a:pt x="681594" y="662766"/>
                    <a:pt x="690033" y="661458"/>
                    <a:pt x="698500" y="660400"/>
                  </a:cubicBezTo>
                  <a:cubicBezTo>
                    <a:pt x="701675" y="659342"/>
                    <a:pt x="704778" y="658037"/>
                    <a:pt x="708025" y="657225"/>
                  </a:cubicBezTo>
                  <a:cubicBezTo>
                    <a:pt x="716900" y="655006"/>
                    <a:pt x="734458" y="652290"/>
                    <a:pt x="742950" y="650875"/>
                  </a:cubicBezTo>
                  <a:cubicBezTo>
                    <a:pt x="746125" y="649817"/>
                    <a:pt x="749482" y="649197"/>
                    <a:pt x="752475" y="647700"/>
                  </a:cubicBezTo>
                  <a:cubicBezTo>
                    <a:pt x="755888" y="645993"/>
                    <a:pt x="758513" y="642900"/>
                    <a:pt x="762000" y="641350"/>
                  </a:cubicBezTo>
                  <a:cubicBezTo>
                    <a:pt x="768117" y="638632"/>
                    <a:pt x="781050" y="635000"/>
                    <a:pt x="781050" y="635000"/>
                  </a:cubicBezTo>
                  <a:cubicBezTo>
                    <a:pt x="784225" y="632883"/>
                    <a:pt x="787088" y="630200"/>
                    <a:pt x="790575" y="628650"/>
                  </a:cubicBezTo>
                  <a:cubicBezTo>
                    <a:pt x="796692" y="625932"/>
                    <a:pt x="803275" y="624417"/>
                    <a:pt x="809625" y="622300"/>
                  </a:cubicBezTo>
                  <a:cubicBezTo>
                    <a:pt x="823290" y="617745"/>
                    <a:pt x="815903" y="619937"/>
                    <a:pt x="831850" y="615950"/>
                  </a:cubicBezTo>
                  <a:lnTo>
                    <a:pt x="860425" y="596900"/>
                  </a:lnTo>
                  <a:cubicBezTo>
                    <a:pt x="865994" y="593187"/>
                    <a:pt x="879475" y="590550"/>
                    <a:pt x="879475" y="590550"/>
                  </a:cubicBezTo>
                  <a:cubicBezTo>
                    <a:pt x="882650" y="588433"/>
                    <a:pt x="886069" y="586643"/>
                    <a:pt x="889000" y="584200"/>
                  </a:cubicBezTo>
                  <a:cubicBezTo>
                    <a:pt x="892449" y="581325"/>
                    <a:pt x="894789" y="577166"/>
                    <a:pt x="898525" y="574675"/>
                  </a:cubicBezTo>
                  <a:cubicBezTo>
                    <a:pt x="901310" y="572819"/>
                    <a:pt x="904875" y="572558"/>
                    <a:pt x="908050" y="571500"/>
                  </a:cubicBezTo>
                  <a:cubicBezTo>
                    <a:pt x="912283" y="565150"/>
                    <a:pt x="918337" y="559690"/>
                    <a:pt x="920750" y="552450"/>
                  </a:cubicBezTo>
                  <a:cubicBezTo>
                    <a:pt x="921808" y="549275"/>
                    <a:pt x="921834" y="545538"/>
                    <a:pt x="923925" y="542925"/>
                  </a:cubicBezTo>
                  <a:cubicBezTo>
                    <a:pt x="926309" y="539945"/>
                    <a:pt x="930275" y="538692"/>
                    <a:pt x="933450" y="536575"/>
                  </a:cubicBezTo>
                  <a:cubicBezTo>
                    <a:pt x="941430" y="512634"/>
                    <a:pt x="930665" y="542144"/>
                    <a:pt x="942975" y="517525"/>
                  </a:cubicBezTo>
                  <a:cubicBezTo>
                    <a:pt x="944472" y="514532"/>
                    <a:pt x="944059" y="510613"/>
                    <a:pt x="946150" y="508000"/>
                  </a:cubicBezTo>
                  <a:cubicBezTo>
                    <a:pt x="950626" y="502405"/>
                    <a:pt x="958925" y="500567"/>
                    <a:pt x="965200" y="498475"/>
                  </a:cubicBezTo>
                  <a:cubicBezTo>
                    <a:pt x="983295" y="480380"/>
                    <a:pt x="965039" y="495369"/>
                    <a:pt x="987425" y="485775"/>
                  </a:cubicBezTo>
                  <a:cubicBezTo>
                    <a:pt x="1001388" y="479791"/>
                    <a:pt x="991880" y="478682"/>
                    <a:pt x="1006475" y="476250"/>
                  </a:cubicBezTo>
                  <a:cubicBezTo>
                    <a:pt x="1030244" y="472289"/>
                    <a:pt x="1072801" y="470978"/>
                    <a:pt x="1092200" y="469900"/>
                  </a:cubicBezTo>
                  <a:cubicBezTo>
                    <a:pt x="1098475" y="467808"/>
                    <a:pt x="1106774" y="465970"/>
                    <a:pt x="1111250" y="460375"/>
                  </a:cubicBezTo>
                  <a:cubicBezTo>
                    <a:pt x="1113341" y="457762"/>
                    <a:pt x="1112928" y="453843"/>
                    <a:pt x="1114425" y="450850"/>
                  </a:cubicBezTo>
                  <a:cubicBezTo>
                    <a:pt x="1116132" y="447437"/>
                    <a:pt x="1119225" y="444812"/>
                    <a:pt x="1120775" y="441325"/>
                  </a:cubicBezTo>
                  <a:cubicBezTo>
                    <a:pt x="1123493" y="435208"/>
                    <a:pt x="1125008" y="428625"/>
                    <a:pt x="1127125" y="422275"/>
                  </a:cubicBezTo>
                  <a:lnTo>
                    <a:pt x="1130300" y="412750"/>
                  </a:lnTo>
                  <a:cubicBezTo>
                    <a:pt x="1131358" y="395817"/>
                    <a:pt x="1133475" y="378916"/>
                    <a:pt x="1133475" y="361950"/>
                  </a:cubicBezTo>
                  <a:cubicBezTo>
                    <a:pt x="1133475" y="279804"/>
                    <a:pt x="1138541" y="300949"/>
                    <a:pt x="1123950" y="257175"/>
                  </a:cubicBezTo>
                  <a:cubicBezTo>
                    <a:pt x="1121914" y="251068"/>
                    <a:pt x="1122811" y="244232"/>
                    <a:pt x="1120775" y="238125"/>
                  </a:cubicBezTo>
                  <a:cubicBezTo>
                    <a:pt x="1119568" y="234505"/>
                    <a:pt x="1116318" y="231913"/>
                    <a:pt x="1114425" y="228600"/>
                  </a:cubicBezTo>
                  <a:cubicBezTo>
                    <a:pt x="1104509" y="211248"/>
                    <a:pt x="1113512" y="219525"/>
                    <a:pt x="1098550" y="209550"/>
                  </a:cubicBezTo>
                  <a:cubicBezTo>
                    <a:pt x="1080352" y="182253"/>
                    <a:pt x="1102170" y="216790"/>
                    <a:pt x="1089025" y="190500"/>
                  </a:cubicBezTo>
                  <a:cubicBezTo>
                    <a:pt x="1087318" y="187087"/>
                    <a:pt x="1084382" y="184388"/>
                    <a:pt x="1082675" y="180975"/>
                  </a:cubicBezTo>
                  <a:cubicBezTo>
                    <a:pt x="1081178" y="177982"/>
                    <a:pt x="1081591" y="174063"/>
                    <a:pt x="1079500" y="171450"/>
                  </a:cubicBezTo>
                  <a:cubicBezTo>
                    <a:pt x="1077116" y="168470"/>
                    <a:pt x="1073150" y="167217"/>
                    <a:pt x="1069975" y="165100"/>
                  </a:cubicBezTo>
                  <a:cubicBezTo>
                    <a:pt x="1065742" y="158750"/>
                    <a:pt x="1062671" y="151446"/>
                    <a:pt x="1057275" y="146050"/>
                  </a:cubicBezTo>
                  <a:cubicBezTo>
                    <a:pt x="1054100" y="142875"/>
                    <a:pt x="1050507" y="140069"/>
                    <a:pt x="1047750" y="136525"/>
                  </a:cubicBezTo>
                  <a:cubicBezTo>
                    <a:pt x="1029918" y="113599"/>
                    <a:pt x="1043726" y="120367"/>
                    <a:pt x="1025525" y="114300"/>
                  </a:cubicBezTo>
                  <a:cubicBezTo>
                    <a:pt x="1002844" y="99179"/>
                    <a:pt x="1013879" y="103451"/>
                    <a:pt x="993775" y="98425"/>
                  </a:cubicBezTo>
                  <a:cubicBezTo>
                    <a:pt x="971940" y="83869"/>
                    <a:pt x="981965" y="88138"/>
                    <a:pt x="965200" y="82550"/>
                  </a:cubicBezTo>
                  <a:cubicBezTo>
                    <a:pt x="937903" y="64352"/>
                    <a:pt x="972440" y="86170"/>
                    <a:pt x="946150" y="73025"/>
                  </a:cubicBezTo>
                  <a:cubicBezTo>
                    <a:pt x="942737" y="71318"/>
                    <a:pt x="939800" y="68792"/>
                    <a:pt x="936625" y="66675"/>
                  </a:cubicBezTo>
                  <a:cubicBezTo>
                    <a:pt x="933369" y="61791"/>
                    <a:pt x="922300" y="42489"/>
                    <a:pt x="914400" y="38100"/>
                  </a:cubicBezTo>
                  <a:cubicBezTo>
                    <a:pt x="908549" y="34849"/>
                    <a:pt x="895350" y="31750"/>
                    <a:pt x="895350" y="31750"/>
                  </a:cubicBezTo>
                  <a:cubicBezTo>
                    <a:pt x="880256" y="21687"/>
                    <a:pt x="889445" y="26607"/>
                    <a:pt x="866775" y="19050"/>
                  </a:cubicBezTo>
                  <a:lnTo>
                    <a:pt x="857250" y="15875"/>
                  </a:lnTo>
                  <a:cubicBezTo>
                    <a:pt x="842156" y="5812"/>
                    <a:pt x="851345" y="10732"/>
                    <a:pt x="828675" y="3175"/>
                  </a:cubicBezTo>
                  <a:lnTo>
                    <a:pt x="819150" y="0"/>
                  </a:lnTo>
                  <a:cubicBezTo>
                    <a:pt x="809625" y="1058"/>
                    <a:pt x="800028" y="1599"/>
                    <a:pt x="790575" y="3175"/>
                  </a:cubicBezTo>
                  <a:cubicBezTo>
                    <a:pt x="780825" y="4800"/>
                    <a:pt x="779964" y="7637"/>
                    <a:pt x="771525" y="12700"/>
                  </a:cubicBezTo>
                  <a:cubicBezTo>
                    <a:pt x="769496" y="13918"/>
                    <a:pt x="808037" y="12171"/>
                    <a:pt x="806450" y="12700"/>
                  </a:cubicBezTo>
                  <a:close/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37" name="フリーフォーム 136"/>
            <p:cNvSpPr/>
            <p:nvPr/>
          </p:nvSpPr>
          <p:spPr>
            <a:xfrm>
              <a:off x="240747" y="1713508"/>
              <a:ext cx="1134326" cy="679450"/>
            </a:xfrm>
            <a:custGeom>
              <a:avLst/>
              <a:gdLst>
                <a:gd name="connsiteX0" fmla="*/ 806450 w 1134325"/>
                <a:gd name="connsiteY0" fmla="*/ 12700 h 679450"/>
                <a:gd name="connsiteX1" fmla="*/ 762000 w 1134325"/>
                <a:gd name="connsiteY1" fmla="*/ 15875 h 679450"/>
                <a:gd name="connsiteX2" fmla="*/ 742950 w 1134325"/>
                <a:gd name="connsiteY2" fmla="*/ 22225 h 679450"/>
                <a:gd name="connsiteX3" fmla="*/ 723900 w 1134325"/>
                <a:gd name="connsiteY3" fmla="*/ 34925 h 679450"/>
                <a:gd name="connsiteX4" fmla="*/ 708025 w 1134325"/>
                <a:gd name="connsiteY4" fmla="*/ 38100 h 679450"/>
                <a:gd name="connsiteX5" fmla="*/ 650875 w 1134325"/>
                <a:gd name="connsiteY5" fmla="*/ 41275 h 679450"/>
                <a:gd name="connsiteX6" fmla="*/ 587375 w 1134325"/>
                <a:gd name="connsiteY6" fmla="*/ 38100 h 679450"/>
                <a:gd name="connsiteX7" fmla="*/ 574675 w 1134325"/>
                <a:gd name="connsiteY7" fmla="*/ 34925 h 679450"/>
                <a:gd name="connsiteX8" fmla="*/ 447675 w 1134325"/>
                <a:gd name="connsiteY8" fmla="*/ 38100 h 679450"/>
                <a:gd name="connsiteX9" fmla="*/ 425450 w 1134325"/>
                <a:gd name="connsiteY9" fmla="*/ 44450 h 679450"/>
                <a:gd name="connsiteX10" fmla="*/ 412750 w 1134325"/>
                <a:gd name="connsiteY10" fmla="*/ 47625 h 679450"/>
                <a:gd name="connsiteX11" fmla="*/ 393700 w 1134325"/>
                <a:gd name="connsiteY11" fmla="*/ 53975 h 679450"/>
                <a:gd name="connsiteX12" fmla="*/ 384175 w 1134325"/>
                <a:gd name="connsiteY12" fmla="*/ 57150 h 679450"/>
                <a:gd name="connsiteX13" fmla="*/ 355600 w 1134325"/>
                <a:gd name="connsiteY13" fmla="*/ 60325 h 679450"/>
                <a:gd name="connsiteX14" fmla="*/ 327025 w 1134325"/>
                <a:gd name="connsiteY14" fmla="*/ 66675 h 679450"/>
                <a:gd name="connsiteX15" fmla="*/ 282575 w 1134325"/>
                <a:gd name="connsiteY15" fmla="*/ 73025 h 679450"/>
                <a:gd name="connsiteX16" fmla="*/ 244475 w 1134325"/>
                <a:gd name="connsiteY16" fmla="*/ 85725 h 679450"/>
                <a:gd name="connsiteX17" fmla="*/ 215900 w 1134325"/>
                <a:gd name="connsiteY17" fmla="*/ 92075 h 679450"/>
                <a:gd name="connsiteX18" fmla="*/ 196850 w 1134325"/>
                <a:gd name="connsiteY18" fmla="*/ 98425 h 679450"/>
                <a:gd name="connsiteX19" fmla="*/ 187325 w 1134325"/>
                <a:gd name="connsiteY19" fmla="*/ 101600 h 679450"/>
                <a:gd name="connsiteX20" fmla="*/ 165100 w 1134325"/>
                <a:gd name="connsiteY20" fmla="*/ 130175 h 679450"/>
                <a:gd name="connsiteX21" fmla="*/ 149225 w 1134325"/>
                <a:gd name="connsiteY21" fmla="*/ 158750 h 679450"/>
                <a:gd name="connsiteX22" fmla="*/ 142875 w 1134325"/>
                <a:gd name="connsiteY22" fmla="*/ 168275 h 679450"/>
                <a:gd name="connsiteX23" fmla="*/ 133350 w 1134325"/>
                <a:gd name="connsiteY23" fmla="*/ 171450 h 679450"/>
                <a:gd name="connsiteX24" fmla="*/ 104775 w 1134325"/>
                <a:gd name="connsiteY24" fmla="*/ 190500 h 679450"/>
                <a:gd name="connsiteX25" fmla="*/ 85725 w 1134325"/>
                <a:gd name="connsiteY25" fmla="*/ 206375 h 679450"/>
                <a:gd name="connsiteX26" fmla="*/ 73025 w 1134325"/>
                <a:gd name="connsiteY26" fmla="*/ 234950 h 679450"/>
                <a:gd name="connsiteX27" fmla="*/ 63500 w 1134325"/>
                <a:gd name="connsiteY27" fmla="*/ 244475 h 679450"/>
                <a:gd name="connsiteX28" fmla="*/ 50800 w 1134325"/>
                <a:gd name="connsiteY28" fmla="*/ 263525 h 679450"/>
                <a:gd name="connsiteX29" fmla="*/ 34925 w 1134325"/>
                <a:gd name="connsiteY29" fmla="*/ 282575 h 679450"/>
                <a:gd name="connsiteX30" fmla="*/ 28575 w 1134325"/>
                <a:gd name="connsiteY30" fmla="*/ 301625 h 679450"/>
                <a:gd name="connsiteX31" fmla="*/ 22225 w 1134325"/>
                <a:gd name="connsiteY31" fmla="*/ 311150 h 679450"/>
                <a:gd name="connsiteX32" fmla="*/ 12700 w 1134325"/>
                <a:gd name="connsiteY32" fmla="*/ 330200 h 679450"/>
                <a:gd name="connsiteX33" fmla="*/ 3175 w 1134325"/>
                <a:gd name="connsiteY33" fmla="*/ 361950 h 679450"/>
                <a:gd name="connsiteX34" fmla="*/ 0 w 1134325"/>
                <a:gd name="connsiteY34" fmla="*/ 371475 h 679450"/>
                <a:gd name="connsiteX35" fmla="*/ 3175 w 1134325"/>
                <a:gd name="connsiteY35" fmla="*/ 406400 h 679450"/>
                <a:gd name="connsiteX36" fmla="*/ 9525 w 1134325"/>
                <a:gd name="connsiteY36" fmla="*/ 425450 h 679450"/>
                <a:gd name="connsiteX37" fmla="*/ 22225 w 1134325"/>
                <a:gd name="connsiteY37" fmla="*/ 463550 h 679450"/>
                <a:gd name="connsiteX38" fmla="*/ 28575 w 1134325"/>
                <a:gd name="connsiteY38" fmla="*/ 473075 h 679450"/>
                <a:gd name="connsiteX39" fmla="*/ 47625 w 1134325"/>
                <a:gd name="connsiteY39" fmla="*/ 511175 h 679450"/>
                <a:gd name="connsiteX40" fmla="*/ 60325 w 1134325"/>
                <a:gd name="connsiteY40" fmla="*/ 539750 h 679450"/>
                <a:gd name="connsiteX41" fmla="*/ 69850 w 1134325"/>
                <a:gd name="connsiteY41" fmla="*/ 546100 h 679450"/>
                <a:gd name="connsiteX42" fmla="*/ 85725 w 1134325"/>
                <a:gd name="connsiteY42" fmla="*/ 568325 h 679450"/>
                <a:gd name="connsiteX43" fmla="*/ 95250 w 1134325"/>
                <a:gd name="connsiteY43" fmla="*/ 571500 h 679450"/>
                <a:gd name="connsiteX44" fmla="*/ 98425 w 1134325"/>
                <a:gd name="connsiteY44" fmla="*/ 581025 h 679450"/>
                <a:gd name="connsiteX45" fmla="*/ 117475 w 1134325"/>
                <a:gd name="connsiteY45" fmla="*/ 593725 h 679450"/>
                <a:gd name="connsiteX46" fmla="*/ 127000 w 1134325"/>
                <a:gd name="connsiteY46" fmla="*/ 612775 h 679450"/>
                <a:gd name="connsiteX47" fmla="*/ 136525 w 1134325"/>
                <a:gd name="connsiteY47" fmla="*/ 619125 h 679450"/>
                <a:gd name="connsiteX48" fmla="*/ 165100 w 1134325"/>
                <a:gd name="connsiteY48" fmla="*/ 641350 h 679450"/>
                <a:gd name="connsiteX49" fmla="*/ 184150 w 1134325"/>
                <a:gd name="connsiteY49" fmla="*/ 647700 h 679450"/>
                <a:gd name="connsiteX50" fmla="*/ 206375 w 1134325"/>
                <a:gd name="connsiteY50" fmla="*/ 644525 h 679450"/>
                <a:gd name="connsiteX51" fmla="*/ 225425 w 1134325"/>
                <a:gd name="connsiteY51" fmla="*/ 638175 h 679450"/>
                <a:gd name="connsiteX52" fmla="*/ 238125 w 1134325"/>
                <a:gd name="connsiteY52" fmla="*/ 619125 h 679450"/>
                <a:gd name="connsiteX53" fmla="*/ 266700 w 1134325"/>
                <a:gd name="connsiteY53" fmla="*/ 600075 h 679450"/>
                <a:gd name="connsiteX54" fmla="*/ 276225 w 1134325"/>
                <a:gd name="connsiteY54" fmla="*/ 593725 h 679450"/>
                <a:gd name="connsiteX55" fmla="*/ 285750 w 1134325"/>
                <a:gd name="connsiteY55" fmla="*/ 587375 h 679450"/>
                <a:gd name="connsiteX56" fmla="*/ 292100 w 1134325"/>
                <a:gd name="connsiteY56" fmla="*/ 565150 h 679450"/>
                <a:gd name="connsiteX57" fmla="*/ 295275 w 1134325"/>
                <a:gd name="connsiteY57" fmla="*/ 555625 h 679450"/>
                <a:gd name="connsiteX58" fmla="*/ 314325 w 1134325"/>
                <a:gd name="connsiteY58" fmla="*/ 549275 h 679450"/>
                <a:gd name="connsiteX59" fmla="*/ 339725 w 1134325"/>
                <a:gd name="connsiteY59" fmla="*/ 552450 h 679450"/>
                <a:gd name="connsiteX60" fmla="*/ 349250 w 1134325"/>
                <a:gd name="connsiteY60" fmla="*/ 555625 h 679450"/>
                <a:gd name="connsiteX61" fmla="*/ 365125 w 1134325"/>
                <a:gd name="connsiteY61" fmla="*/ 584200 h 679450"/>
                <a:gd name="connsiteX62" fmla="*/ 371475 w 1134325"/>
                <a:gd name="connsiteY62" fmla="*/ 593725 h 679450"/>
                <a:gd name="connsiteX63" fmla="*/ 374650 w 1134325"/>
                <a:gd name="connsiteY63" fmla="*/ 603250 h 679450"/>
                <a:gd name="connsiteX64" fmla="*/ 381000 w 1134325"/>
                <a:gd name="connsiteY64" fmla="*/ 612775 h 679450"/>
                <a:gd name="connsiteX65" fmla="*/ 390525 w 1134325"/>
                <a:gd name="connsiteY65" fmla="*/ 631825 h 679450"/>
                <a:gd name="connsiteX66" fmla="*/ 400050 w 1134325"/>
                <a:gd name="connsiteY66" fmla="*/ 638175 h 679450"/>
                <a:gd name="connsiteX67" fmla="*/ 406400 w 1134325"/>
                <a:gd name="connsiteY67" fmla="*/ 647700 h 679450"/>
                <a:gd name="connsiteX68" fmla="*/ 425450 w 1134325"/>
                <a:gd name="connsiteY68" fmla="*/ 654050 h 679450"/>
                <a:gd name="connsiteX69" fmla="*/ 434975 w 1134325"/>
                <a:gd name="connsiteY69" fmla="*/ 657225 h 679450"/>
                <a:gd name="connsiteX70" fmla="*/ 444500 w 1134325"/>
                <a:gd name="connsiteY70" fmla="*/ 660400 h 679450"/>
                <a:gd name="connsiteX71" fmla="*/ 457200 w 1134325"/>
                <a:gd name="connsiteY71" fmla="*/ 666750 h 679450"/>
                <a:gd name="connsiteX72" fmla="*/ 469900 w 1134325"/>
                <a:gd name="connsiteY72" fmla="*/ 669925 h 679450"/>
                <a:gd name="connsiteX73" fmla="*/ 488950 w 1134325"/>
                <a:gd name="connsiteY73" fmla="*/ 676275 h 679450"/>
                <a:gd name="connsiteX74" fmla="*/ 498475 w 1134325"/>
                <a:gd name="connsiteY74" fmla="*/ 679450 h 679450"/>
                <a:gd name="connsiteX75" fmla="*/ 593725 w 1134325"/>
                <a:gd name="connsiteY75" fmla="*/ 676275 h 679450"/>
                <a:gd name="connsiteX76" fmla="*/ 615950 w 1134325"/>
                <a:gd name="connsiteY76" fmla="*/ 669925 h 679450"/>
                <a:gd name="connsiteX77" fmla="*/ 631825 w 1134325"/>
                <a:gd name="connsiteY77" fmla="*/ 666750 h 679450"/>
                <a:gd name="connsiteX78" fmla="*/ 673100 w 1134325"/>
                <a:gd name="connsiteY78" fmla="*/ 663575 h 679450"/>
                <a:gd name="connsiteX79" fmla="*/ 698500 w 1134325"/>
                <a:gd name="connsiteY79" fmla="*/ 660400 h 679450"/>
                <a:gd name="connsiteX80" fmla="*/ 708025 w 1134325"/>
                <a:gd name="connsiteY80" fmla="*/ 657225 h 679450"/>
                <a:gd name="connsiteX81" fmla="*/ 742950 w 1134325"/>
                <a:gd name="connsiteY81" fmla="*/ 650875 h 679450"/>
                <a:gd name="connsiteX82" fmla="*/ 752475 w 1134325"/>
                <a:gd name="connsiteY82" fmla="*/ 647700 h 679450"/>
                <a:gd name="connsiteX83" fmla="*/ 762000 w 1134325"/>
                <a:gd name="connsiteY83" fmla="*/ 641350 h 679450"/>
                <a:gd name="connsiteX84" fmla="*/ 781050 w 1134325"/>
                <a:gd name="connsiteY84" fmla="*/ 635000 h 679450"/>
                <a:gd name="connsiteX85" fmla="*/ 790575 w 1134325"/>
                <a:gd name="connsiteY85" fmla="*/ 628650 h 679450"/>
                <a:gd name="connsiteX86" fmla="*/ 809625 w 1134325"/>
                <a:gd name="connsiteY86" fmla="*/ 622300 h 679450"/>
                <a:gd name="connsiteX87" fmla="*/ 831850 w 1134325"/>
                <a:gd name="connsiteY87" fmla="*/ 615950 h 679450"/>
                <a:gd name="connsiteX88" fmla="*/ 860425 w 1134325"/>
                <a:gd name="connsiteY88" fmla="*/ 596900 h 679450"/>
                <a:gd name="connsiteX89" fmla="*/ 879475 w 1134325"/>
                <a:gd name="connsiteY89" fmla="*/ 590550 h 679450"/>
                <a:gd name="connsiteX90" fmla="*/ 889000 w 1134325"/>
                <a:gd name="connsiteY90" fmla="*/ 584200 h 679450"/>
                <a:gd name="connsiteX91" fmla="*/ 898525 w 1134325"/>
                <a:gd name="connsiteY91" fmla="*/ 574675 h 679450"/>
                <a:gd name="connsiteX92" fmla="*/ 908050 w 1134325"/>
                <a:gd name="connsiteY92" fmla="*/ 571500 h 679450"/>
                <a:gd name="connsiteX93" fmla="*/ 920750 w 1134325"/>
                <a:gd name="connsiteY93" fmla="*/ 552450 h 679450"/>
                <a:gd name="connsiteX94" fmla="*/ 923925 w 1134325"/>
                <a:gd name="connsiteY94" fmla="*/ 542925 h 679450"/>
                <a:gd name="connsiteX95" fmla="*/ 933450 w 1134325"/>
                <a:gd name="connsiteY95" fmla="*/ 536575 h 679450"/>
                <a:gd name="connsiteX96" fmla="*/ 942975 w 1134325"/>
                <a:gd name="connsiteY96" fmla="*/ 517525 h 679450"/>
                <a:gd name="connsiteX97" fmla="*/ 946150 w 1134325"/>
                <a:gd name="connsiteY97" fmla="*/ 508000 h 679450"/>
                <a:gd name="connsiteX98" fmla="*/ 965200 w 1134325"/>
                <a:gd name="connsiteY98" fmla="*/ 498475 h 679450"/>
                <a:gd name="connsiteX99" fmla="*/ 987425 w 1134325"/>
                <a:gd name="connsiteY99" fmla="*/ 485775 h 679450"/>
                <a:gd name="connsiteX100" fmla="*/ 1006475 w 1134325"/>
                <a:gd name="connsiteY100" fmla="*/ 476250 h 679450"/>
                <a:gd name="connsiteX101" fmla="*/ 1092200 w 1134325"/>
                <a:gd name="connsiteY101" fmla="*/ 469900 h 679450"/>
                <a:gd name="connsiteX102" fmla="*/ 1111250 w 1134325"/>
                <a:gd name="connsiteY102" fmla="*/ 460375 h 679450"/>
                <a:gd name="connsiteX103" fmla="*/ 1114425 w 1134325"/>
                <a:gd name="connsiteY103" fmla="*/ 450850 h 679450"/>
                <a:gd name="connsiteX104" fmla="*/ 1120775 w 1134325"/>
                <a:gd name="connsiteY104" fmla="*/ 441325 h 679450"/>
                <a:gd name="connsiteX105" fmla="*/ 1127125 w 1134325"/>
                <a:gd name="connsiteY105" fmla="*/ 422275 h 679450"/>
                <a:gd name="connsiteX106" fmla="*/ 1130300 w 1134325"/>
                <a:gd name="connsiteY106" fmla="*/ 412750 h 679450"/>
                <a:gd name="connsiteX107" fmla="*/ 1133475 w 1134325"/>
                <a:gd name="connsiteY107" fmla="*/ 361950 h 679450"/>
                <a:gd name="connsiteX108" fmla="*/ 1123950 w 1134325"/>
                <a:gd name="connsiteY108" fmla="*/ 257175 h 679450"/>
                <a:gd name="connsiteX109" fmla="*/ 1120775 w 1134325"/>
                <a:gd name="connsiteY109" fmla="*/ 238125 h 679450"/>
                <a:gd name="connsiteX110" fmla="*/ 1114425 w 1134325"/>
                <a:gd name="connsiteY110" fmla="*/ 228600 h 679450"/>
                <a:gd name="connsiteX111" fmla="*/ 1098550 w 1134325"/>
                <a:gd name="connsiteY111" fmla="*/ 209550 h 679450"/>
                <a:gd name="connsiteX112" fmla="*/ 1089025 w 1134325"/>
                <a:gd name="connsiteY112" fmla="*/ 190500 h 679450"/>
                <a:gd name="connsiteX113" fmla="*/ 1082675 w 1134325"/>
                <a:gd name="connsiteY113" fmla="*/ 180975 h 679450"/>
                <a:gd name="connsiteX114" fmla="*/ 1079500 w 1134325"/>
                <a:gd name="connsiteY114" fmla="*/ 171450 h 679450"/>
                <a:gd name="connsiteX115" fmla="*/ 1069975 w 1134325"/>
                <a:gd name="connsiteY115" fmla="*/ 165100 h 679450"/>
                <a:gd name="connsiteX116" fmla="*/ 1057275 w 1134325"/>
                <a:gd name="connsiteY116" fmla="*/ 146050 h 679450"/>
                <a:gd name="connsiteX117" fmla="*/ 1047750 w 1134325"/>
                <a:gd name="connsiteY117" fmla="*/ 136525 h 679450"/>
                <a:gd name="connsiteX118" fmla="*/ 1025525 w 1134325"/>
                <a:gd name="connsiteY118" fmla="*/ 114300 h 679450"/>
                <a:gd name="connsiteX119" fmla="*/ 993775 w 1134325"/>
                <a:gd name="connsiteY119" fmla="*/ 98425 h 679450"/>
                <a:gd name="connsiteX120" fmla="*/ 965200 w 1134325"/>
                <a:gd name="connsiteY120" fmla="*/ 82550 h 679450"/>
                <a:gd name="connsiteX121" fmla="*/ 946150 w 1134325"/>
                <a:gd name="connsiteY121" fmla="*/ 73025 h 679450"/>
                <a:gd name="connsiteX122" fmla="*/ 936625 w 1134325"/>
                <a:gd name="connsiteY122" fmla="*/ 66675 h 679450"/>
                <a:gd name="connsiteX123" fmla="*/ 914400 w 1134325"/>
                <a:gd name="connsiteY123" fmla="*/ 38100 h 679450"/>
                <a:gd name="connsiteX124" fmla="*/ 895350 w 1134325"/>
                <a:gd name="connsiteY124" fmla="*/ 31750 h 679450"/>
                <a:gd name="connsiteX125" fmla="*/ 866775 w 1134325"/>
                <a:gd name="connsiteY125" fmla="*/ 19050 h 679450"/>
                <a:gd name="connsiteX126" fmla="*/ 857250 w 1134325"/>
                <a:gd name="connsiteY126" fmla="*/ 15875 h 679450"/>
                <a:gd name="connsiteX127" fmla="*/ 828675 w 1134325"/>
                <a:gd name="connsiteY127" fmla="*/ 3175 h 679450"/>
                <a:gd name="connsiteX128" fmla="*/ 819150 w 1134325"/>
                <a:gd name="connsiteY128" fmla="*/ 0 h 679450"/>
                <a:gd name="connsiteX129" fmla="*/ 790575 w 1134325"/>
                <a:gd name="connsiteY129" fmla="*/ 3175 h 679450"/>
                <a:gd name="connsiteX130" fmla="*/ 771525 w 1134325"/>
                <a:gd name="connsiteY130" fmla="*/ 12700 h 679450"/>
                <a:gd name="connsiteX131" fmla="*/ 806450 w 1134325"/>
                <a:gd name="connsiteY131" fmla="*/ 12700 h 6794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</a:cxnLst>
              <a:rect l="l" t="t" r="r" b="b"/>
              <a:pathLst>
                <a:path w="1134325" h="679450">
                  <a:moveTo>
                    <a:pt x="806450" y="12700"/>
                  </a:moveTo>
                  <a:cubicBezTo>
                    <a:pt x="804863" y="13229"/>
                    <a:pt x="776690" y="13671"/>
                    <a:pt x="762000" y="15875"/>
                  </a:cubicBezTo>
                  <a:cubicBezTo>
                    <a:pt x="755381" y="16868"/>
                    <a:pt x="742950" y="22225"/>
                    <a:pt x="742950" y="22225"/>
                  </a:cubicBezTo>
                  <a:lnTo>
                    <a:pt x="723900" y="34925"/>
                  </a:lnTo>
                  <a:cubicBezTo>
                    <a:pt x="719410" y="37918"/>
                    <a:pt x="713401" y="37633"/>
                    <a:pt x="708025" y="38100"/>
                  </a:cubicBezTo>
                  <a:cubicBezTo>
                    <a:pt x="689017" y="39753"/>
                    <a:pt x="669925" y="40217"/>
                    <a:pt x="650875" y="41275"/>
                  </a:cubicBezTo>
                  <a:cubicBezTo>
                    <a:pt x="629708" y="40217"/>
                    <a:pt x="608495" y="39860"/>
                    <a:pt x="587375" y="38100"/>
                  </a:cubicBezTo>
                  <a:cubicBezTo>
                    <a:pt x="583026" y="37738"/>
                    <a:pt x="579039" y="34925"/>
                    <a:pt x="574675" y="34925"/>
                  </a:cubicBezTo>
                  <a:cubicBezTo>
                    <a:pt x="532328" y="34925"/>
                    <a:pt x="490008" y="37042"/>
                    <a:pt x="447675" y="38100"/>
                  </a:cubicBezTo>
                  <a:cubicBezTo>
                    <a:pt x="407973" y="48026"/>
                    <a:pt x="457334" y="35340"/>
                    <a:pt x="425450" y="44450"/>
                  </a:cubicBezTo>
                  <a:cubicBezTo>
                    <a:pt x="421254" y="45649"/>
                    <a:pt x="416930" y="46371"/>
                    <a:pt x="412750" y="47625"/>
                  </a:cubicBezTo>
                  <a:cubicBezTo>
                    <a:pt x="406339" y="49548"/>
                    <a:pt x="400050" y="51858"/>
                    <a:pt x="393700" y="53975"/>
                  </a:cubicBezTo>
                  <a:cubicBezTo>
                    <a:pt x="390525" y="55033"/>
                    <a:pt x="387501" y="56780"/>
                    <a:pt x="384175" y="57150"/>
                  </a:cubicBezTo>
                  <a:lnTo>
                    <a:pt x="355600" y="60325"/>
                  </a:lnTo>
                  <a:cubicBezTo>
                    <a:pt x="338806" y="65923"/>
                    <a:pt x="351611" y="62205"/>
                    <a:pt x="327025" y="66675"/>
                  </a:cubicBezTo>
                  <a:cubicBezTo>
                    <a:pt x="295254" y="72452"/>
                    <a:pt x="328054" y="67972"/>
                    <a:pt x="282575" y="73025"/>
                  </a:cubicBezTo>
                  <a:lnTo>
                    <a:pt x="244475" y="85725"/>
                  </a:lnTo>
                  <a:cubicBezTo>
                    <a:pt x="231645" y="90002"/>
                    <a:pt x="229740" y="88300"/>
                    <a:pt x="215900" y="92075"/>
                  </a:cubicBezTo>
                  <a:cubicBezTo>
                    <a:pt x="209442" y="93836"/>
                    <a:pt x="203200" y="96308"/>
                    <a:pt x="196850" y="98425"/>
                  </a:cubicBezTo>
                  <a:lnTo>
                    <a:pt x="187325" y="101600"/>
                  </a:lnTo>
                  <a:cubicBezTo>
                    <a:pt x="179107" y="109818"/>
                    <a:pt x="168898" y="118782"/>
                    <a:pt x="165100" y="130175"/>
                  </a:cubicBezTo>
                  <a:cubicBezTo>
                    <a:pt x="159512" y="146940"/>
                    <a:pt x="163781" y="136915"/>
                    <a:pt x="149225" y="158750"/>
                  </a:cubicBezTo>
                  <a:cubicBezTo>
                    <a:pt x="147108" y="161925"/>
                    <a:pt x="146495" y="167068"/>
                    <a:pt x="142875" y="168275"/>
                  </a:cubicBezTo>
                  <a:lnTo>
                    <a:pt x="133350" y="171450"/>
                  </a:lnTo>
                  <a:lnTo>
                    <a:pt x="104775" y="190500"/>
                  </a:lnTo>
                  <a:cubicBezTo>
                    <a:pt x="95409" y="196744"/>
                    <a:pt x="93365" y="197208"/>
                    <a:pt x="85725" y="206375"/>
                  </a:cubicBezTo>
                  <a:cubicBezTo>
                    <a:pt x="77339" y="216438"/>
                    <a:pt x="77640" y="221106"/>
                    <a:pt x="73025" y="234950"/>
                  </a:cubicBezTo>
                  <a:cubicBezTo>
                    <a:pt x="71605" y="239210"/>
                    <a:pt x="66675" y="241300"/>
                    <a:pt x="63500" y="244475"/>
                  </a:cubicBezTo>
                  <a:cubicBezTo>
                    <a:pt x="57920" y="261214"/>
                    <a:pt x="64013" y="247670"/>
                    <a:pt x="50800" y="263525"/>
                  </a:cubicBezTo>
                  <a:cubicBezTo>
                    <a:pt x="28698" y="290047"/>
                    <a:pt x="62752" y="254748"/>
                    <a:pt x="34925" y="282575"/>
                  </a:cubicBezTo>
                  <a:cubicBezTo>
                    <a:pt x="32808" y="288925"/>
                    <a:pt x="32288" y="296056"/>
                    <a:pt x="28575" y="301625"/>
                  </a:cubicBezTo>
                  <a:cubicBezTo>
                    <a:pt x="26458" y="304800"/>
                    <a:pt x="23932" y="307737"/>
                    <a:pt x="22225" y="311150"/>
                  </a:cubicBezTo>
                  <a:cubicBezTo>
                    <a:pt x="9080" y="337440"/>
                    <a:pt x="30898" y="302903"/>
                    <a:pt x="12700" y="330200"/>
                  </a:cubicBezTo>
                  <a:cubicBezTo>
                    <a:pt x="7902" y="349394"/>
                    <a:pt x="10905" y="338760"/>
                    <a:pt x="3175" y="361950"/>
                  </a:cubicBezTo>
                  <a:lnTo>
                    <a:pt x="0" y="371475"/>
                  </a:lnTo>
                  <a:cubicBezTo>
                    <a:pt x="1058" y="383117"/>
                    <a:pt x="1144" y="394888"/>
                    <a:pt x="3175" y="406400"/>
                  </a:cubicBezTo>
                  <a:cubicBezTo>
                    <a:pt x="4338" y="412992"/>
                    <a:pt x="7408" y="419100"/>
                    <a:pt x="9525" y="425450"/>
                  </a:cubicBezTo>
                  <a:lnTo>
                    <a:pt x="22225" y="463550"/>
                  </a:lnTo>
                  <a:cubicBezTo>
                    <a:pt x="23432" y="467170"/>
                    <a:pt x="27025" y="469588"/>
                    <a:pt x="28575" y="473075"/>
                  </a:cubicBezTo>
                  <a:cubicBezTo>
                    <a:pt x="46102" y="512510"/>
                    <a:pt x="21220" y="471568"/>
                    <a:pt x="47625" y="511175"/>
                  </a:cubicBezTo>
                  <a:cubicBezTo>
                    <a:pt x="60200" y="530038"/>
                    <a:pt x="47401" y="526826"/>
                    <a:pt x="60325" y="539750"/>
                  </a:cubicBezTo>
                  <a:cubicBezTo>
                    <a:pt x="63023" y="542448"/>
                    <a:pt x="66675" y="543983"/>
                    <a:pt x="69850" y="546100"/>
                  </a:cubicBezTo>
                  <a:cubicBezTo>
                    <a:pt x="74816" y="556032"/>
                    <a:pt x="76071" y="561889"/>
                    <a:pt x="85725" y="568325"/>
                  </a:cubicBezTo>
                  <a:cubicBezTo>
                    <a:pt x="88510" y="570181"/>
                    <a:pt x="92075" y="570442"/>
                    <a:pt x="95250" y="571500"/>
                  </a:cubicBezTo>
                  <a:cubicBezTo>
                    <a:pt x="96308" y="574675"/>
                    <a:pt x="96058" y="578658"/>
                    <a:pt x="98425" y="581025"/>
                  </a:cubicBezTo>
                  <a:cubicBezTo>
                    <a:pt x="103821" y="586421"/>
                    <a:pt x="117475" y="593725"/>
                    <a:pt x="117475" y="593725"/>
                  </a:cubicBezTo>
                  <a:cubicBezTo>
                    <a:pt x="120057" y="601472"/>
                    <a:pt x="120845" y="606620"/>
                    <a:pt x="127000" y="612775"/>
                  </a:cubicBezTo>
                  <a:cubicBezTo>
                    <a:pt x="129698" y="615473"/>
                    <a:pt x="133594" y="616682"/>
                    <a:pt x="136525" y="619125"/>
                  </a:cubicBezTo>
                  <a:cubicBezTo>
                    <a:pt x="166368" y="643994"/>
                    <a:pt x="116952" y="609252"/>
                    <a:pt x="165100" y="641350"/>
                  </a:cubicBezTo>
                  <a:cubicBezTo>
                    <a:pt x="170669" y="645063"/>
                    <a:pt x="184150" y="647700"/>
                    <a:pt x="184150" y="647700"/>
                  </a:cubicBezTo>
                  <a:cubicBezTo>
                    <a:pt x="191558" y="646642"/>
                    <a:pt x="199083" y="646208"/>
                    <a:pt x="206375" y="644525"/>
                  </a:cubicBezTo>
                  <a:cubicBezTo>
                    <a:pt x="212897" y="643020"/>
                    <a:pt x="225425" y="638175"/>
                    <a:pt x="225425" y="638175"/>
                  </a:cubicBezTo>
                  <a:lnTo>
                    <a:pt x="238125" y="619125"/>
                  </a:lnTo>
                  <a:lnTo>
                    <a:pt x="266700" y="600075"/>
                  </a:lnTo>
                  <a:lnTo>
                    <a:pt x="276225" y="593725"/>
                  </a:lnTo>
                  <a:lnTo>
                    <a:pt x="285750" y="587375"/>
                  </a:lnTo>
                  <a:cubicBezTo>
                    <a:pt x="293363" y="564537"/>
                    <a:pt x="284127" y="593057"/>
                    <a:pt x="292100" y="565150"/>
                  </a:cubicBezTo>
                  <a:cubicBezTo>
                    <a:pt x="293019" y="561932"/>
                    <a:pt x="292552" y="557570"/>
                    <a:pt x="295275" y="555625"/>
                  </a:cubicBezTo>
                  <a:cubicBezTo>
                    <a:pt x="300722" y="551734"/>
                    <a:pt x="314325" y="549275"/>
                    <a:pt x="314325" y="549275"/>
                  </a:cubicBezTo>
                  <a:cubicBezTo>
                    <a:pt x="322792" y="550333"/>
                    <a:pt x="331330" y="550924"/>
                    <a:pt x="339725" y="552450"/>
                  </a:cubicBezTo>
                  <a:cubicBezTo>
                    <a:pt x="343018" y="553049"/>
                    <a:pt x="346883" y="553258"/>
                    <a:pt x="349250" y="555625"/>
                  </a:cubicBezTo>
                  <a:cubicBezTo>
                    <a:pt x="369272" y="575647"/>
                    <a:pt x="357140" y="568230"/>
                    <a:pt x="365125" y="584200"/>
                  </a:cubicBezTo>
                  <a:cubicBezTo>
                    <a:pt x="366832" y="587613"/>
                    <a:pt x="369768" y="590312"/>
                    <a:pt x="371475" y="593725"/>
                  </a:cubicBezTo>
                  <a:cubicBezTo>
                    <a:pt x="372972" y="596718"/>
                    <a:pt x="373153" y="600257"/>
                    <a:pt x="374650" y="603250"/>
                  </a:cubicBezTo>
                  <a:cubicBezTo>
                    <a:pt x="376357" y="606663"/>
                    <a:pt x="379293" y="609362"/>
                    <a:pt x="381000" y="612775"/>
                  </a:cubicBezTo>
                  <a:cubicBezTo>
                    <a:pt x="386165" y="623104"/>
                    <a:pt x="381426" y="622726"/>
                    <a:pt x="390525" y="631825"/>
                  </a:cubicBezTo>
                  <a:cubicBezTo>
                    <a:pt x="393223" y="634523"/>
                    <a:pt x="396875" y="636058"/>
                    <a:pt x="400050" y="638175"/>
                  </a:cubicBezTo>
                  <a:cubicBezTo>
                    <a:pt x="402167" y="641350"/>
                    <a:pt x="403164" y="645678"/>
                    <a:pt x="406400" y="647700"/>
                  </a:cubicBezTo>
                  <a:cubicBezTo>
                    <a:pt x="412076" y="651248"/>
                    <a:pt x="419100" y="651933"/>
                    <a:pt x="425450" y="654050"/>
                  </a:cubicBezTo>
                  <a:lnTo>
                    <a:pt x="434975" y="657225"/>
                  </a:lnTo>
                  <a:cubicBezTo>
                    <a:pt x="438150" y="658283"/>
                    <a:pt x="441507" y="658903"/>
                    <a:pt x="444500" y="660400"/>
                  </a:cubicBezTo>
                  <a:cubicBezTo>
                    <a:pt x="448733" y="662517"/>
                    <a:pt x="452768" y="665088"/>
                    <a:pt x="457200" y="666750"/>
                  </a:cubicBezTo>
                  <a:cubicBezTo>
                    <a:pt x="461286" y="668282"/>
                    <a:pt x="465720" y="668671"/>
                    <a:pt x="469900" y="669925"/>
                  </a:cubicBezTo>
                  <a:cubicBezTo>
                    <a:pt x="476311" y="671848"/>
                    <a:pt x="482600" y="674158"/>
                    <a:pt x="488950" y="676275"/>
                  </a:cubicBezTo>
                  <a:lnTo>
                    <a:pt x="498475" y="679450"/>
                  </a:lnTo>
                  <a:cubicBezTo>
                    <a:pt x="530225" y="678392"/>
                    <a:pt x="562012" y="678140"/>
                    <a:pt x="593725" y="676275"/>
                  </a:cubicBezTo>
                  <a:cubicBezTo>
                    <a:pt x="601491" y="675818"/>
                    <a:pt x="608560" y="671773"/>
                    <a:pt x="615950" y="669925"/>
                  </a:cubicBezTo>
                  <a:cubicBezTo>
                    <a:pt x="621185" y="668616"/>
                    <a:pt x="626462" y="667346"/>
                    <a:pt x="631825" y="666750"/>
                  </a:cubicBezTo>
                  <a:cubicBezTo>
                    <a:pt x="645540" y="665226"/>
                    <a:pt x="659363" y="664883"/>
                    <a:pt x="673100" y="663575"/>
                  </a:cubicBezTo>
                  <a:cubicBezTo>
                    <a:pt x="681594" y="662766"/>
                    <a:pt x="690033" y="661458"/>
                    <a:pt x="698500" y="660400"/>
                  </a:cubicBezTo>
                  <a:cubicBezTo>
                    <a:pt x="701675" y="659342"/>
                    <a:pt x="704778" y="658037"/>
                    <a:pt x="708025" y="657225"/>
                  </a:cubicBezTo>
                  <a:cubicBezTo>
                    <a:pt x="716900" y="655006"/>
                    <a:pt x="734458" y="652290"/>
                    <a:pt x="742950" y="650875"/>
                  </a:cubicBezTo>
                  <a:cubicBezTo>
                    <a:pt x="746125" y="649817"/>
                    <a:pt x="749482" y="649197"/>
                    <a:pt x="752475" y="647700"/>
                  </a:cubicBezTo>
                  <a:cubicBezTo>
                    <a:pt x="755888" y="645993"/>
                    <a:pt x="758513" y="642900"/>
                    <a:pt x="762000" y="641350"/>
                  </a:cubicBezTo>
                  <a:cubicBezTo>
                    <a:pt x="768117" y="638632"/>
                    <a:pt x="781050" y="635000"/>
                    <a:pt x="781050" y="635000"/>
                  </a:cubicBezTo>
                  <a:cubicBezTo>
                    <a:pt x="784225" y="632883"/>
                    <a:pt x="787088" y="630200"/>
                    <a:pt x="790575" y="628650"/>
                  </a:cubicBezTo>
                  <a:cubicBezTo>
                    <a:pt x="796692" y="625932"/>
                    <a:pt x="803275" y="624417"/>
                    <a:pt x="809625" y="622300"/>
                  </a:cubicBezTo>
                  <a:cubicBezTo>
                    <a:pt x="823290" y="617745"/>
                    <a:pt x="815903" y="619937"/>
                    <a:pt x="831850" y="615950"/>
                  </a:cubicBezTo>
                  <a:lnTo>
                    <a:pt x="860425" y="596900"/>
                  </a:lnTo>
                  <a:cubicBezTo>
                    <a:pt x="865994" y="593187"/>
                    <a:pt x="879475" y="590550"/>
                    <a:pt x="879475" y="590550"/>
                  </a:cubicBezTo>
                  <a:cubicBezTo>
                    <a:pt x="882650" y="588433"/>
                    <a:pt x="886069" y="586643"/>
                    <a:pt x="889000" y="584200"/>
                  </a:cubicBezTo>
                  <a:cubicBezTo>
                    <a:pt x="892449" y="581325"/>
                    <a:pt x="894789" y="577166"/>
                    <a:pt x="898525" y="574675"/>
                  </a:cubicBezTo>
                  <a:cubicBezTo>
                    <a:pt x="901310" y="572819"/>
                    <a:pt x="904875" y="572558"/>
                    <a:pt x="908050" y="571500"/>
                  </a:cubicBezTo>
                  <a:cubicBezTo>
                    <a:pt x="912283" y="565150"/>
                    <a:pt x="918337" y="559690"/>
                    <a:pt x="920750" y="552450"/>
                  </a:cubicBezTo>
                  <a:cubicBezTo>
                    <a:pt x="921808" y="549275"/>
                    <a:pt x="921834" y="545538"/>
                    <a:pt x="923925" y="542925"/>
                  </a:cubicBezTo>
                  <a:cubicBezTo>
                    <a:pt x="926309" y="539945"/>
                    <a:pt x="930275" y="538692"/>
                    <a:pt x="933450" y="536575"/>
                  </a:cubicBezTo>
                  <a:cubicBezTo>
                    <a:pt x="941430" y="512634"/>
                    <a:pt x="930665" y="542144"/>
                    <a:pt x="942975" y="517525"/>
                  </a:cubicBezTo>
                  <a:cubicBezTo>
                    <a:pt x="944472" y="514532"/>
                    <a:pt x="944059" y="510613"/>
                    <a:pt x="946150" y="508000"/>
                  </a:cubicBezTo>
                  <a:cubicBezTo>
                    <a:pt x="950626" y="502405"/>
                    <a:pt x="958925" y="500567"/>
                    <a:pt x="965200" y="498475"/>
                  </a:cubicBezTo>
                  <a:cubicBezTo>
                    <a:pt x="983295" y="480380"/>
                    <a:pt x="965039" y="495369"/>
                    <a:pt x="987425" y="485775"/>
                  </a:cubicBezTo>
                  <a:cubicBezTo>
                    <a:pt x="1001388" y="479791"/>
                    <a:pt x="991880" y="478682"/>
                    <a:pt x="1006475" y="476250"/>
                  </a:cubicBezTo>
                  <a:cubicBezTo>
                    <a:pt x="1030244" y="472289"/>
                    <a:pt x="1072801" y="470978"/>
                    <a:pt x="1092200" y="469900"/>
                  </a:cubicBezTo>
                  <a:cubicBezTo>
                    <a:pt x="1098475" y="467808"/>
                    <a:pt x="1106774" y="465970"/>
                    <a:pt x="1111250" y="460375"/>
                  </a:cubicBezTo>
                  <a:cubicBezTo>
                    <a:pt x="1113341" y="457762"/>
                    <a:pt x="1112928" y="453843"/>
                    <a:pt x="1114425" y="450850"/>
                  </a:cubicBezTo>
                  <a:cubicBezTo>
                    <a:pt x="1116132" y="447437"/>
                    <a:pt x="1119225" y="444812"/>
                    <a:pt x="1120775" y="441325"/>
                  </a:cubicBezTo>
                  <a:cubicBezTo>
                    <a:pt x="1123493" y="435208"/>
                    <a:pt x="1125008" y="428625"/>
                    <a:pt x="1127125" y="422275"/>
                  </a:cubicBezTo>
                  <a:lnTo>
                    <a:pt x="1130300" y="412750"/>
                  </a:lnTo>
                  <a:cubicBezTo>
                    <a:pt x="1131358" y="395817"/>
                    <a:pt x="1133475" y="378916"/>
                    <a:pt x="1133475" y="361950"/>
                  </a:cubicBezTo>
                  <a:cubicBezTo>
                    <a:pt x="1133475" y="279804"/>
                    <a:pt x="1138541" y="300949"/>
                    <a:pt x="1123950" y="257175"/>
                  </a:cubicBezTo>
                  <a:cubicBezTo>
                    <a:pt x="1121914" y="251068"/>
                    <a:pt x="1122811" y="244232"/>
                    <a:pt x="1120775" y="238125"/>
                  </a:cubicBezTo>
                  <a:cubicBezTo>
                    <a:pt x="1119568" y="234505"/>
                    <a:pt x="1116318" y="231913"/>
                    <a:pt x="1114425" y="228600"/>
                  </a:cubicBezTo>
                  <a:cubicBezTo>
                    <a:pt x="1104509" y="211248"/>
                    <a:pt x="1113512" y="219525"/>
                    <a:pt x="1098550" y="209550"/>
                  </a:cubicBezTo>
                  <a:cubicBezTo>
                    <a:pt x="1080352" y="182253"/>
                    <a:pt x="1102170" y="216790"/>
                    <a:pt x="1089025" y="190500"/>
                  </a:cubicBezTo>
                  <a:cubicBezTo>
                    <a:pt x="1087318" y="187087"/>
                    <a:pt x="1084382" y="184388"/>
                    <a:pt x="1082675" y="180975"/>
                  </a:cubicBezTo>
                  <a:cubicBezTo>
                    <a:pt x="1081178" y="177982"/>
                    <a:pt x="1081591" y="174063"/>
                    <a:pt x="1079500" y="171450"/>
                  </a:cubicBezTo>
                  <a:cubicBezTo>
                    <a:pt x="1077116" y="168470"/>
                    <a:pt x="1073150" y="167217"/>
                    <a:pt x="1069975" y="165100"/>
                  </a:cubicBezTo>
                  <a:cubicBezTo>
                    <a:pt x="1065742" y="158750"/>
                    <a:pt x="1062671" y="151446"/>
                    <a:pt x="1057275" y="146050"/>
                  </a:cubicBezTo>
                  <a:cubicBezTo>
                    <a:pt x="1054100" y="142875"/>
                    <a:pt x="1050507" y="140069"/>
                    <a:pt x="1047750" y="136525"/>
                  </a:cubicBezTo>
                  <a:cubicBezTo>
                    <a:pt x="1029918" y="113599"/>
                    <a:pt x="1043726" y="120367"/>
                    <a:pt x="1025525" y="114300"/>
                  </a:cubicBezTo>
                  <a:cubicBezTo>
                    <a:pt x="1002844" y="99179"/>
                    <a:pt x="1013879" y="103451"/>
                    <a:pt x="993775" y="98425"/>
                  </a:cubicBezTo>
                  <a:cubicBezTo>
                    <a:pt x="971940" y="83869"/>
                    <a:pt x="981965" y="88138"/>
                    <a:pt x="965200" y="82550"/>
                  </a:cubicBezTo>
                  <a:cubicBezTo>
                    <a:pt x="937903" y="64352"/>
                    <a:pt x="972440" y="86170"/>
                    <a:pt x="946150" y="73025"/>
                  </a:cubicBezTo>
                  <a:cubicBezTo>
                    <a:pt x="942737" y="71318"/>
                    <a:pt x="939800" y="68792"/>
                    <a:pt x="936625" y="66675"/>
                  </a:cubicBezTo>
                  <a:cubicBezTo>
                    <a:pt x="933369" y="61791"/>
                    <a:pt x="922300" y="42489"/>
                    <a:pt x="914400" y="38100"/>
                  </a:cubicBezTo>
                  <a:cubicBezTo>
                    <a:pt x="908549" y="34849"/>
                    <a:pt x="895350" y="31750"/>
                    <a:pt x="895350" y="31750"/>
                  </a:cubicBezTo>
                  <a:cubicBezTo>
                    <a:pt x="880256" y="21687"/>
                    <a:pt x="889445" y="26607"/>
                    <a:pt x="866775" y="19050"/>
                  </a:cubicBezTo>
                  <a:lnTo>
                    <a:pt x="857250" y="15875"/>
                  </a:lnTo>
                  <a:cubicBezTo>
                    <a:pt x="842156" y="5812"/>
                    <a:pt x="851345" y="10732"/>
                    <a:pt x="828675" y="3175"/>
                  </a:cubicBezTo>
                  <a:lnTo>
                    <a:pt x="819150" y="0"/>
                  </a:lnTo>
                  <a:cubicBezTo>
                    <a:pt x="809625" y="1058"/>
                    <a:pt x="800028" y="1599"/>
                    <a:pt x="790575" y="3175"/>
                  </a:cubicBezTo>
                  <a:cubicBezTo>
                    <a:pt x="780825" y="4800"/>
                    <a:pt x="779964" y="7637"/>
                    <a:pt x="771525" y="12700"/>
                  </a:cubicBezTo>
                  <a:cubicBezTo>
                    <a:pt x="769496" y="13918"/>
                    <a:pt x="808037" y="12171"/>
                    <a:pt x="806450" y="12700"/>
                  </a:cubicBezTo>
                  <a:close/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45" name="フリーフォーム 44"/>
            <p:cNvSpPr/>
            <p:nvPr/>
          </p:nvSpPr>
          <p:spPr>
            <a:xfrm>
              <a:off x="6948265" y="1628800"/>
              <a:ext cx="1277672" cy="764158"/>
            </a:xfrm>
            <a:custGeom>
              <a:avLst/>
              <a:gdLst>
                <a:gd name="connsiteX0" fmla="*/ 806450 w 1134325"/>
                <a:gd name="connsiteY0" fmla="*/ 12700 h 679450"/>
                <a:gd name="connsiteX1" fmla="*/ 762000 w 1134325"/>
                <a:gd name="connsiteY1" fmla="*/ 15875 h 679450"/>
                <a:gd name="connsiteX2" fmla="*/ 742950 w 1134325"/>
                <a:gd name="connsiteY2" fmla="*/ 22225 h 679450"/>
                <a:gd name="connsiteX3" fmla="*/ 723900 w 1134325"/>
                <a:gd name="connsiteY3" fmla="*/ 34925 h 679450"/>
                <a:gd name="connsiteX4" fmla="*/ 708025 w 1134325"/>
                <a:gd name="connsiteY4" fmla="*/ 38100 h 679450"/>
                <a:gd name="connsiteX5" fmla="*/ 650875 w 1134325"/>
                <a:gd name="connsiteY5" fmla="*/ 41275 h 679450"/>
                <a:gd name="connsiteX6" fmla="*/ 587375 w 1134325"/>
                <a:gd name="connsiteY6" fmla="*/ 38100 h 679450"/>
                <a:gd name="connsiteX7" fmla="*/ 574675 w 1134325"/>
                <a:gd name="connsiteY7" fmla="*/ 34925 h 679450"/>
                <a:gd name="connsiteX8" fmla="*/ 447675 w 1134325"/>
                <a:gd name="connsiteY8" fmla="*/ 38100 h 679450"/>
                <a:gd name="connsiteX9" fmla="*/ 425450 w 1134325"/>
                <a:gd name="connsiteY9" fmla="*/ 44450 h 679450"/>
                <a:gd name="connsiteX10" fmla="*/ 412750 w 1134325"/>
                <a:gd name="connsiteY10" fmla="*/ 47625 h 679450"/>
                <a:gd name="connsiteX11" fmla="*/ 393700 w 1134325"/>
                <a:gd name="connsiteY11" fmla="*/ 53975 h 679450"/>
                <a:gd name="connsiteX12" fmla="*/ 384175 w 1134325"/>
                <a:gd name="connsiteY12" fmla="*/ 57150 h 679450"/>
                <a:gd name="connsiteX13" fmla="*/ 355600 w 1134325"/>
                <a:gd name="connsiteY13" fmla="*/ 60325 h 679450"/>
                <a:gd name="connsiteX14" fmla="*/ 327025 w 1134325"/>
                <a:gd name="connsiteY14" fmla="*/ 66675 h 679450"/>
                <a:gd name="connsiteX15" fmla="*/ 282575 w 1134325"/>
                <a:gd name="connsiteY15" fmla="*/ 73025 h 679450"/>
                <a:gd name="connsiteX16" fmla="*/ 244475 w 1134325"/>
                <a:gd name="connsiteY16" fmla="*/ 85725 h 679450"/>
                <a:gd name="connsiteX17" fmla="*/ 215900 w 1134325"/>
                <a:gd name="connsiteY17" fmla="*/ 92075 h 679450"/>
                <a:gd name="connsiteX18" fmla="*/ 196850 w 1134325"/>
                <a:gd name="connsiteY18" fmla="*/ 98425 h 679450"/>
                <a:gd name="connsiteX19" fmla="*/ 187325 w 1134325"/>
                <a:gd name="connsiteY19" fmla="*/ 101600 h 679450"/>
                <a:gd name="connsiteX20" fmla="*/ 165100 w 1134325"/>
                <a:gd name="connsiteY20" fmla="*/ 130175 h 679450"/>
                <a:gd name="connsiteX21" fmla="*/ 149225 w 1134325"/>
                <a:gd name="connsiteY21" fmla="*/ 158750 h 679450"/>
                <a:gd name="connsiteX22" fmla="*/ 142875 w 1134325"/>
                <a:gd name="connsiteY22" fmla="*/ 168275 h 679450"/>
                <a:gd name="connsiteX23" fmla="*/ 133350 w 1134325"/>
                <a:gd name="connsiteY23" fmla="*/ 171450 h 679450"/>
                <a:gd name="connsiteX24" fmla="*/ 104775 w 1134325"/>
                <a:gd name="connsiteY24" fmla="*/ 190500 h 679450"/>
                <a:gd name="connsiteX25" fmla="*/ 85725 w 1134325"/>
                <a:gd name="connsiteY25" fmla="*/ 206375 h 679450"/>
                <a:gd name="connsiteX26" fmla="*/ 73025 w 1134325"/>
                <a:gd name="connsiteY26" fmla="*/ 234950 h 679450"/>
                <a:gd name="connsiteX27" fmla="*/ 63500 w 1134325"/>
                <a:gd name="connsiteY27" fmla="*/ 244475 h 679450"/>
                <a:gd name="connsiteX28" fmla="*/ 50800 w 1134325"/>
                <a:gd name="connsiteY28" fmla="*/ 263525 h 679450"/>
                <a:gd name="connsiteX29" fmla="*/ 34925 w 1134325"/>
                <a:gd name="connsiteY29" fmla="*/ 282575 h 679450"/>
                <a:gd name="connsiteX30" fmla="*/ 28575 w 1134325"/>
                <a:gd name="connsiteY30" fmla="*/ 301625 h 679450"/>
                <a:gd name="connsiteX31" fmla="*/ 22225 w 1134325"/>
                <a:gd name="connsiteY31" fmla="*/ 311150 h 679450"/>
                <a:gd name="connsiteX32" fmla="*/ 12700 w 1134325"/>
                <a:gd name="connsiteY32" fmla="*/ 330200 h 679450"/>
                <a:gd name="connsiteX33" fmla="*/ 3175 w 1134325"/>
                <a:gd name="connsiteY33" fmla="*/ 361950 h 679450"/>
                <a:gd name="connsiteX34" fmla="*/ 0 w 1134325"/>
                <a:gd name="connsiteY34" fmla="*/ 371475 h 679450"/>
                <a:gd name="connsiteX35" fmla="*/ 3175 w 1134325"/>
                <a:gd name="connsiteY35" fmla="*/ 406400 h 679450"/>
                <a:gd name="connsiteX36" fmla="*/ 9525 w 1134325"/>
                <a:gd name="connsiteY36" fmla="*/ 425450 h 679450"/>
                <a:gd name="connsiteX37" fmla="*/ 22225 w 1134325"/>
                <a:gd name="connsiteY37" fmla="*/ 463550 h 679450"/>
                <a:gd name="connsiteX38" fmla="*/ 28575 w 1134325"/>
                <a:gd name="connsiteY38" fmla="*/ 473075 h 679450"/>
                <a:gd name="connsiteX39" fmla="*/ 47625 w 1134325"/>
                <a:gd name="connsiteY39" fmla="*/ 511175 h 679450"/>
                <a:gd name="connsiteX40" fmla="*/ 60325 w 1134325"/>
                <a:gd name="connsiteY40" fmla="*/ 539750 h 679450"/>
                <a:gd name="connsiteX41" fmla="*/ 69850 w 1134325"/>
                <a:gd name="connsiteY41" fmla="*/ 546100 h 679450"/>
                <a:gd name="connsiteX42" fmla="*/ 85725 w 1134325"/>
                <a:gd name="connsiteY42" fmla="*/ 568325 h 679450"/>
                <a:gd name="connsiteX43" fmla="*/ 95250 w 1134325"/>
                <a:gd name="connsiteY43" fmla="*/ 571500 h 679450"/>
                <a:gd name="connsiteX44" fmla="*/ 98425 w 1134325"/>
                <a:gd name="connsiteY44" fmla="*/ 581025 h 679450"/>
                <a:gd name="connsiteX45" fmla="*/ 117475 w 1134325"/>
                <a:gd name="connsiteY45" fmla="*/ 593725 h 679450"/>
                <a:gd name="connsiteX46" fmla="*/ 127000 w 1134325"/>
                <a:gd name="connsiteY46" fmla="*/ 612775 h 679450"/>
                <a:gd name="connsiteX47" fmla="*/ 136525 w 1134325"/>
                <a:gd name="connsiteY47" fmla="*/ 619125 h 679450"/>
                <a:gd name="connsiteX48" fmla="*/ 165100 w 1134325"/>
                <a:gd name="connsiteY48" fmla="*/ 641350 h 679450"/>
                <a:gd name="connsiteX49" fmla="*/ 184150 w 1134325"/>
                <a:gd name="connsiteY49" fmla="*/ 647700 h 679450"/>
                <a:gd name="connsiteX50" fmla="*/ 206375 w 1134325"/>
                <a:gd name="connsiteY50" fmla="*/ 644525 h 679450"/>
                <a:gd name="connsiteX51" fmla="*/ 225425 w 1134325"/>
                <a:gd name="connsiteY51" fmla="*/ 638175 h 679450"/>
                <a:gd name="connsiteX52" fmla="*/ 238125 w 1134325"/>
                <a:gd name="connsiteY52" fmla="*/ 619125 h 679450"/>
                <a:gd name="connsiteX53" fmla="*/ 266700 w 1134325"/>
                <a:gd name="connsiteY53" fmla="*/ 600075 h 679450"/>
                <a:gd name="connsiteX54" fmla="*/ 276225 w 1134325"/>
                <a:gd name="connsiteY54" fmla="*/ 593725 h 679450"/>
                <a:gd name="connsiteX55" fmla="*/ 285750 w 1134325"/>
                <a:gd name="connsiteY55" fmla="*/ 587375 h 679450"/>
                <a:gd name="connsiteX56" fmla="*/ 292100 w 1134325"/>
                <a:gd name="connsiteY56" fmla="*/ 565150 h 679450"/>
                <a:gd name="connsiteX57" fmla="*/ 295275 w 1134325"/>
                <a:gd name="connsiteY57" fmla="*/ 555625 h 679450"/>
                <a:gd name="connsiteX58" fmla="*/ 314325 w 1134325"/>
                <a:gd name="connsiteY58" fmla="*/ 549275 h 679450"/>
                <a:gd name="connsiteX59" fmla="*/ 339725 w 1134325"/>
                <a:gd name="connsiteY59" fmla="*/ 552450 h 679450"/>
                <a:gd name="connsiteX60" fmla="*/ 349250 w 1134325"/>
                <a:gd name="connsiteY60" fmla="*/ 555625 h 679450"/>
                <a:gd name="connsiteX61" fmla="*/ 365125 w 1134325"/>
                <a:gd name="connsiteY61" fmla="*/ 584200 h 679450"/>
                <a:gd name="connsiteX62" fmla="*/ 371475 w 1134325"/>
                <a:gd name="connsiteY62" fmla="*/ 593725 h 679450"/>
                <a:gd name="connsiteX63" fmla="*/ 374650 w 1134325"/>
                <a:gd name="connsiteY63" fmla="*/ 603250 h 679450"/>
                <a:gd name="connsiteX64" fmla="*/ 381000 w 1134325"/>
                <a:gd name="connsiteY64" fmla="*/ 612775 h 679450"/>
                <a:gd name="connsiteX65" fmla="*/ 390525 w 1134325"/>
                <a:gd name="connsiteY65" fmla="*/ 631825 h 679450"/>
                <a:gd name="connsiteX66" fmla="*/ 400050 w 1134325"/>
                <a:gd name="connsiteY66" fmla="*/ 638175 h 679450"/>
                <a:gd name="connsiteX67" fmla="*/ 406400 w 1134325"/>
                <a:gd name="connsiteY67" fmla="*/ 647700 h 679450"/>
                <a:gd name="connsiteX68" fmla="*/ 425450 w 1134325"/>
                <a:gd name="connsiteY68" fmla="*/ 654050 h 679450"/>
                <a:gd name="connsiteX69" fmla="*/ 434975 w 1134325"/>
                <a:gd name="connsiteY69" fmla="*/ 657225 h 679450"/>
                <a:gd name="connsiteX70" fmla="*/ 444500 w 1134325"/>
                <a:gd name="connsiteY70" fmla="*/ 660400 h 679450"/>
                <a:gd name="connsiteX71" fmla="*/ 457200 w 1134325"/>
                <a:gd name="connsiteY71" fmla="*/ 666750 h 679450"/>
                <a:gd name="connsiteX72" fmla="*/ 469900 w 1134325"/>
                <a:gd name="connsiteY72" fmla="*/ 669925 h 679450"/>
                <a:gd name="connsiteX73" fmla="*/ 488950 w 1134325"/>
                <a:gd name="connsiteY73" fmla="*/ 676275 h 679450"/>
                <a:gd name="connsiteX74" fmla="*/ 498475 w 1134325"/>
                <a:gd name="connsiteY74" fmla="*/ 679450 h 679450"/>
                <a:gd name="connsiteX75" fmla="*/ 593725 w 1134325"/>
                <a:gd name="connsiteY75" fmla="*/ 676275 h 679450"/>
                <a:gd name="connsiteX76" fmla="*/ 615950 w 1134325"/>
                <a:gd name="connsiteY76" fmla="*/ 669925 h 679450"/>
                <a:gd name="connsiteX77" fmla="*/ 631825 w 1134325"/>
                <a:gd name="connsiteY77" fmla="*/ 666750 h 679450"/>
                <a:gd name="connsiteX78" fmla="*/ 673100 w 1134325"/>
                <a:gd name="connsiteY78" fmla="*/ 663575 h 679450"/>
                <a:gd name="connsiteX79" fmla="*/ 698500 w 1134325"/>
                <a:gd name="connsiteY79" fmla="*/ 660400 h 679450"/>
                <a:gd name="connsiteX80" fmla="*/ 708025 w 1134325"/>
                <a:gd name="connsiteY80" fmla="*/ 657225 h 679450"/>
                <a:gd name="connsiteX81" fmla="*/ 742950 w 1134325"/>
                <a:gd name="connsiteY81" fmla="*/ 650875 h 679450"/>
                <a:gd name="connsiteX82" fmla="*/ 752475 w 1134325"/>
                <a:gd name="connsiteY82" fmla="*/ 647700 h 679450"/>
                <a:gd name="connsiteX83" fmla="*/ 762000 w 1134325"/>
                <a:gd name="connsiteY83" fmla="*/ 641350 h 679450"/>
                <a:gd name="connsiteX84" fmla="*/ 781050 w 1134325"/>
                <a:gd name="connsiteY84" fmla="*/ 635000 h 679450"/>
                <a:gd name="connsiteX85" fmla="*/ 790575 w 1134325"/>
                <a:gd name="connsiteY85" fmla="*/ 628650 h 679450"/>
                <a:gd name="connsiteX86" fmla="*/ 809625 w 1134325"/>
                <a:gd name="connsiteY86" fmla="*/ 622300 h 679450"/>
                <a:gd name="connsiteX87" fmla="*/ 831850 w 1134325"/>
                <a:gd name="connsiteY87" fmla="*/ 615950 h 679450"/>
                <a:gd name="connsiteX88" fmla="*/ 860425 w 1134325"/>
                <a:gd name="connsiteY88" fmla="*/ 596900 h 679450"/>
                <a:gd name="connsiteX89" fmla="*/ 879475 w 1134325"/>
                <a:gd name="connsiteY89" fmla="*/ 590550 h 679450"/>
                <a:gd name="connsiteX90" fmla="*/ 889000 w 1134325"/>
                <a:gd name="connsiteY90" fmla="*/ 584200 h 679450"/>
                <a:gd name="connsiteX91" fmla="*/ 898525 w 1134325"/>
                <a:gd name="connsiteY91" fmla="*/ 574675 h 679450"/>
                <a:gd name="connsiteX92" fmla="*/ 908050 w 1134325"/>
                <a:gd name="connsiteY92" fmla="*/ 571500 h 679450"/>
                <a:gd name="connsiteX93" fmla="*/ 920750 w 1134325"/>
                <a:gd name="connsiteY93" fmla="*/ 552450 h 679450"/>
                <a:gd name="connsiteX94" fmla="*/ 923925 w 1134325"/>
                <a:gd name="connsiteY94" fmla="*/ 542925 h 679450"/>
                <a:gd name="connsiteX95" fmla="*/ 933450 w 1134325"/>
                <a:gd name="connsiteY95" fmla="*/ 536575 h 679450"/>
                <a:gd name="connsiteX96" fmla="*/ 942975 w 1134325"/>
                <a:gd name="connsiteY96" fmla="*/ 517525 h 679450"/>
                <a:gd name="connsiteX97" fmla="*/ 946150 w 1134325"/>
                <a:gd name="connsiteY97" fmla="*/ 508000 h 679450"/>
                <a:gd name="connsiteX98" fmla="*/ 965200 w 1134325"/>
                <a:gd name="connsiteY98" fmla="*/ 498475 h 679450"/>
                <a:gd name="connsiteX99" fmla="*/ 987425 w 1134325"/>
                <a:gd name="connsiteY99" fmla="*/ 485775 h 679450"/>
                <a:gd name="connsiteX100" fmla="*/ 1006475 w 1134325"/>
                <a:gd name="connsiteY100" fmla="*/ 476250 h 679450"/>
                <a:gd name="connsiteX101" fmla="*/ 1092200 w 1134325"/>
                <a:gd name="connsiteY101" fmla="*/ 469900 h 679450"/>
                <a:gd name="connsiteX102" fmla="*/ 1111250 w 1134325"/>
                <a:gd name="connsiteY102" fmla="*/ 460375 h 679450"/>
                <a:gd name="connsiteX103" fmla="*/ 1114425 w 1134325"/>
                <a:gd name="connsiteY103" fmla="*/ 450850 h 679450"/>
                <a:gd name="connsiteX104" fmla="*/ 1120775 w 1134325"/>
                <a:gd name="connsiteY104" fmla="*/ 441325 h 679450"/>
                <a:gd name="connsiteX105" fmla="*/ 1127125 w 1134325"/>
                <a:gd name="connsiteY105" fmla="*/ 422275 h 679450"/>
                <a:gd name="connsiteX106" fmla="*/ 1130300 w 1134325"/>
                <a:gd name="connsiteY106" fmla="*/ 412750 h 679450"/>
                <a:gd name="connsiteX107" fmla="*/ 1133475 w 1134325"/>
                <a:gd name="connsiteY107" fmla="*/ 361950 h 679450"/>
                <a:gd name="connsiteX108" fmla="*/ 1123950 w 1134325"/>
                <a:gd name="connsiteY108" fmla="*/ 257175 h 679450"/>
                <a:gd name="connsiteX109" fmla="*/ 1120775 w 1134325"/>
                <a:gd name="connsiteY109" fmla="*/ 238125 h 679450"/>
                <a:gd name="connsiteX110" fmla="*/ 1114425 w 1134325"/>
                <a:gd name="connsiteY110" fmla="*/ 228600 h 679450"/>
                <a:gd name="connsiteX111" fmla="*/ 1098550 w 1134325"/>
                <a:gd name="connsiteY111" fmla="*/ 209550 h 679450"/>
                <a:gd name="connsiteX112" fmla="*/ 1089025 w 1134325"/>
                <a:gd name="connsiteY112" fmla="*/ 190500 h 679450"/>
                <a:gd name="connsiteX113" fmla="*/ 1082675 w 1134325"/>
                <a:gd name="connsiteY113" fmla="*/ 180975 h 679450"/>
                <a:gd name="connsiteX114" fmla="*/ 1079500 w 1134325"/>
                <a:gd name="connsiteY114" fmla="*/ 171450 h 679450"/>
                <a:gd name="connsiteX115" fmla="*/ 1069975 w 1134325"/>
                <a:gd name="connsiteY115" fmla="*/ 165100 h 679450"/>
                <a:gd name="connsiteX116" fmla="*/ 1057275 w 1134325"/>
                <a:gd name="connsiteY116" fmla="*/ 146050 h 679450"/>
                <a:gd name="connsiteX117" fmla="*/ 1047750 w 1134325"/>
                <a:gd name="connsiteY117" fmla="*/ 136525 h 679450"/>
                <a:gd name="connsiteX118" fmla="*/ 1025525 w 1134325"/>
                <a:gd name="connsiteY118" fmla="*/ 114300 h 679450"/>
                <a:gd name="connsiteX119" fmla="*/ 993775 w 1134325"/>
                <a:gd name="connsiteY119" fmla="*/ 98425 h 679450"/>
                <a:gd name="connsiteX120" fmla="*/ 965200 w 1134325"/>
                <a:gd name="connsiteY120" fmla="*/ 82550 h 679450"/>
                <a:gd name="connsiteX121" fmla="*/ 946150 w 1134325"/>
                <a:gd name="connsiteY121" fmla="*/ 73025 h 679450"/>
                <a:gd name="connsiteX122" fmla="*/ 936625 w 1134325"/>
                <a:gd name="connsiteY122" fmla="*/ 66675 h 679450"/>
                <a:gd name="connsiteX123" fmla="*/ 914400 w 1134325"/>
                <a:gd name="connsiteY123" fmla="*/ 38100 h 679450"/>
                <a:gd name="connsiteX124" fmla="*/ 895350 w 1134325"/>
                <a:gd name="connsiteY124" fmla="*/ 31750 h 679450"/>
                <a:gd name="connsiteX125" fmla="*/ 866775 w 1134325"/>
                <a:gd name="connsiteY125" fmla="*/ 19050 h 679450"/>
                <a:gd name="connsiteX126" fmla="*/ 857250 w 1134325"/>
                <a:gd name="connsiteY126" fmla="*/ 15875 h 679450"/>
                <a:gd name="connsiteX127" fmla="*/ 828675 w 1134325"/>
                <a:gd name="connsiteY127" fmla="*/ 3175 h 679450"/>
                <a:gd name="connsiteX128" fmla="*/ 819150 w 1134325"/>
                <a:gd name="connsiteY128" fmla="*/ 0 h 679450"/>
                <a:gd name="connsiteX129" fmla="*/ 790575 w 1134325"/>
                <a:gd name="connsiteY129" fmla="*/ 3175 h 679450"/>
                <a:gd name="connsiteX130" fmla="*/ 771525 w 1134325"/>
                <a:gd name="connsiteY130" fmla="*/ 12700 h 679450"/>
                <a:gd name="connsiteX131" fmla="*/ 806450 w 1134325"/>
                <a:gd name="connsiteY131" fmla="*/ 12700 h 6794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</a:cxnLst>
              <a:rect l="l" t="t" r="r" b="b"/>
              <a:pathLst>
                <a:path w="1134325" h="679450">
                  <a:moveTo>
                    <a:pt x="806450" y="12700"/>
                  </a:moveTo>
                  <a:cubicBezTo>
                    <a:pt x="804863" y="13229"/>
                    <a:pt x="776690" y="13671"/>
                    <a:pt x="762000" y="15875"/>
                  </a:cubicBezTo>
                  <a:cubicBezTo>
                    <a:pt x="755381" y="16868"/>
                    <a:pt x="742950" y="22225"/>
                    <a:pt x="742950" y="22225"/>
                  </a:cubicBezTo>
                  <a:lnTo>
                    <a:pt x="723900" y="34925"/>
                  </a:lnTo>
                  <a:cubicBezTo>
                    <a:pt x="719410" y="37918"/>
                    <a:pt x="713401" y="37633"/>
                    <a:pt x="708025" y="38100"/>
                  </a:cubicBezTo>
                  <a:cubicBezTo>
                    <a:pt x="689017" y="39753"/>
                    <a:pt x="669925" y="40217"/>
                    <a:pt x="650875" y="41275"/>
                  </a:cubicBezTo>
                  <a:cubicBezTo>
                    <a:pt x="629708" y="40217"/>
                    <a:pt x="608495" y="39860"/>
                    <a:pt x="587375" y="38100"/>
                  </a:cubicBezTo>
                  <a:cubicBezTo>
                    <a:pt x="583026" y="37738"/>
                    <a:pt x="579039" y="34925"/>
                    <a:pt x="574675" y="34925"/>
                  </a:cubicBezTo>
                  <a:cubicBezTo>
                    <a:pt x="532328" y="34925"/>
                    <a:pt x="490008" y="37042"/>
                    <a:pt x="447675" y="38100"/>
                  </a:cubicBezTo>
                  <a:cubicBezTo>
                    <a:pt x="407973" y="48026"/>
                    <a:pt x="457334" y="35340"/>
                    <a:pt x="425450" y="44450"/>
                  </a:cubicBezTo>
                  <a:cubicBezTo>
                    <a:pt x="421254" y="45649"/>
                    <a:pt x="416930" y="46371"/>
                    <a:pt x="412750" y="47625"/>
                  </a:cubicBezTo>
                  <a:cubicBezTo>
                    <a:pt x="406339" y="49548"/>
                    <a:pt x="400050" y="51858"/>
                    <a:pt x="393700" y="53975"/>
                  </a:cubicBezTo>
                  <a:cubicBezTo>
                    <a:pt x="390525" y="55033"/>
                    <a:pt x="387501" y="56780"/>
                    <a:pt x="384175" y="57150"/>
                  </a:cubicBezTo>
                  <a:lnTo>
                    <a:pt x="355600" y="60325"/>
                  </a:lnTo>
                  <a:cubicBezTo>
                    <a:pt x="338806" y="65923"/>
                    <a:pt x="351611" y="62205"/>
                    <a:pt x="327025" y="66675"/>
                  </a:cubicBezTo>
                  <a:cubicBezTo>
                    <a:pt x="295254" y="72452"/>
                    <a:pt x="328054" y="67972"/>
                    <a:pt x="282575" y="73025"/>
                  </a:cubicBezTo>
                  <a:lnTo>
                    <a:pt x="244475" y="85725"/>
                  </a:lnTo>
                  <a:cubicBezTo>
                    <a:pt x="231645" y="90002"/>
                    <a:pt x="229740" y="88300"/>
                    <a:pt x="215900" y="92075"/>
                  </a:cubicBezTo>
                  <a:cubicBezTo>
                    <a:pt x="209442" y="93836"/>
                    <a:pt x="203200" y="96308"/>
                    <a:pt x="196850" y="98425"/>
                  </a:cubicBezTo>
                  <a:lnTo>
                    <a:pt x="187325" y="101600"/>
                  </a:lnTo>
                  <a:cubicBezTo>
                    <a:pt x="179107" y="109818"/>
                    <a:pt x="168898" y="118782"/>
                    <a:pt x="165100" y="130175"/>
                  </a:cubicBezTo>
                  <a:cubicBezTo>
                    <a:pt x="159512" y="146940"/>
                    <a:pt x="163781" y="136915"/>
                    <a:pt x="149225" y="158750"/>
                  </a:cubicBezTo>
                  <a:cubicBezTo>
                    <a:pt x="147108" y="161925"/>
                    <a:pt x="146495" y="167068"/>
                    <a:pt x="142875" y="168275"/>
                  </a:cubicBezTo>
                  <a:lnTo>
                    <a:pt x="133350" y="171450"/>
                  </a:lnTo>
                  <a:lnTo>
                    <a:pt x="104775" y="190500"/>
                  </a:lnTo>
                  <a:cubicBezTo>
                    <a:pt x="95409" y="196744"/>
                    <a:pt x="93365" y="197208"/>
                    <a:pt x="85725" y="206375"/>
                  </a:cubicBezTo>
                  <a:cubicBezTo>
                    <a:pt x="77339" y="216438"/>
                    <a:pt x="77640" y="221106"/>
                    <a:pt x="73025" y="234950"/>
                  </a:cubicBezTo>
                  <a:cubicBezTo>
                    <a:pt x="71605" y="239210"/>
                    <a:pt x="66675" y="241300"/>
                    <a:pt x="63500" y="244475"/>
                  </a:cubicBezTo>
                  <a:cubicBezTo>
                    <a:pt x="57920" y="261214"/>
                    <a:pt x="64013" y="247670"/>
                    <a:pt x="50800" y="263525"/>
                  </a:cubicBezTo>
                  <a:cubicBezTo>
                    <a:pt x="28698" y="290047"/>
                    <a:pt x="62752" y="254748"/>
                    <a:pt x="34925" y="282575"/>
                  </a:cubicBezTo>
                  <a:cubicBezTo>
                    <a:pt x="32808" y="288925"/>
                    <a:pt x="32288" y="296056"/>
                    <a:pt x="28575" y="301625"/>
                  </a:cubicBezTo>
                  <a:cubicBezTo>
                    <a:pt x="26458" y="304800"/>
                    <a:pt x="23932" y="307737"/>
                    <a:pt x="22225" y="311150"/>
                  </a:cubicBezTo>
                  <a:cubicBezTo>
                    <a:pt x="9080" y="337440"/>
                    <a:pt x="30898" y="302903"/>
                    <a:pt x="12700" y="330200"/>
                  </a:cubicBezTo>
                  <a:cubicBezTo>
                    <a:pt x="7902" y="349394"/>
                    <a:pt x="10905" y="338760"/>
                    <a:pt x="3175" y="361950"/>
                  </a:cubicBezTo>
                  <a:lnTo>
                    <a:pt x="0" y="371475"/>
                  </a:lnTo>
                  <a:cubicBezTo>
                    <a:pt x="1058" y="383117"/>
                    <a:pt x="1144" y="394888"/>
                    <a:pt x="3175" y="406400"/>
                  </a:cubicBezTo>
                  <a:cubicBezTo>
                    <a:pt x="4338" y="412992"/>
                    <a:pt x="7408" y="419100"/>
                    <a:pt x="9525" y="425450"/>
                  </a:cubicBezTo>
                  <a:lnTo>
                    <a:pt x="22225" y="463550"/>
                  </a:lnTo>
                  <a:cubicBezTo>
                    <a:pt x="23432" y="467170"/>
                    <a:pt x="27025" y="469588"/>
                    <a:pt x="28575" y="473075"/>
                  </a:cubicBezTo>
                  <a:cubicBezTo>
                    <a:pt x="46102" y="512510"/>
                    <a:pt x="21220" y="471568"/>
                    <a:pt x="47625" y="511175"/>
                  </a:cubicBezTo>
                  <a:cubicBezTo>
                    <a:pt x="60200" y="530038"/>
                    <a:pt x="47401" y="526826"/>
                    <a:pt x="60325" y="539750"/>
                  </a:cubicBezTo>
                  <a:cubicBezTo>
                    <a:pt x="63023" y="542448"/>
                    <a:pt x="66675" y="543983"/>
                    <a:pt x="69850" y="546100"/>
                  </a:cubicBezTo>
                  <a:cubicBezTo>
                    <a:pt x="74816" y="556032"/>
                    <a:pt x="76071" y="561889"/>
                    <a:pt x="85725" y="568325"/>
                  </a:cubicBezTo>
                  <a:cubicBezTo>
                    <a:pt x="88510" y="570181"/>
                    <a:pt x="92075" y="570442"/>
                    <a:pt x="95250" y="571500"/>
                  </a:cubicBezTo>
                  <a:cubicBezTo>
                    <a:pt x="96308" y="574675"/>
                    <a:pt x="96058" y="578658"/>
                    <a:pt x="98425" y="581025"/>
                  </a:cubicBezTo>
                  <a:cubicBezTo>
                    <a:pt x="103821" y="586421"/>
                    <a:pt x="117475" y="593725"/>
                    <a:pt x="117475" y="593725"/>
                  </a:cubicBezTo>
                  <a:cubicBezTo>
                    <a:pt x="120057" y="601472"/>
                    <a:pt x="120845" y="606620"/>
                    <a:pt x="127000" y="612775"/>
                  </a:cubicBezTo>
                  <a:cubicBezTo>
                    <a:pt x="129698" y="615473"/>
                    <a:pt x="133594" y="616682"/>
                    <a:pt x="136525" y="619125"/>
                  </a:cubicBezTo>
                  <a:cubicBezTo>
                    <a:pt x="166368" y="643994"/>
                    <a:pt x="116952" y="609252"/>
                    <a:pt x="165100" y="641350"/>
                  </a:cubicBezTo>
                  <a:cubicBezTo>
                    <a:pt x="170669" y="645063"/>
                    <a:pt x="184150" y="647700"/>
                    <a:pt x="184150" y="647700"/>
                  </a:cubicBezTo>
                  <a:cubicBezTo>
                    <a:pt x="191558" y="646642"/>
                    <a:pt x="199083" y="646208"/>
                    <a:pt x="206375" y="644525"/>
                  </a:cubicBezTo>
                  <a:cubicBezTo>
                    <a:pt x="212897" y="643020"/>
                    <a:pt x="225425" y="638175"/>
                    <a:pt x="225425" y="638175"/>
                  </a:cubicBezTo>
                  <a:lnTo>
                    <a:pt x="238125" y="619125"/>
                  </a:lnTo>
                  <a:lnTo>
                    <a:pt x="266700" y="600075"/>
                  </a:lnTo>
                  <a:lnTo>
                    <a:pt x="276225" y="593725"/>
                  </a:lnTo>
                  <a:lnTo>
                    <a:pt x="285750" y="587375"/>
                  </a:lnTo>
                  <a:cubicBezTo>
                    <a:pt x="293363" y="564537"/>
                    <a:pt x="284127" y="593057"/>
                    <a:pt x="292100" y="565150"/>
                  </a:cubicBezTo>
                  <a:cubicBezTo>
                    <a:pt x="293019" y="561932"/>
                    <a:pt x="292552" y="557570"/>
                    <a:pt x="295275" y="555625"/>
                  </a:cubicBezTo>
                  <a:cubicBezTo>
                    <a:pt x="300722" y="551734"/>
                    <a:pt x="314325" y="549275"/>
                    <a:pt x="314325" y="549275"/>
                  </a:cubicBezTo>
                  <a:cubicBezTo>
                    <a:pt x="322792" y="550333"/>
                    <a:pt x="331330" y="550924"/>
                    <a:pt x="339725" y="552450"/>
                  </a:cubicBezTo>
                  <a:cubicBezTo>
                    <a:pt x="343018" y="553049"/>
                    <a:pt x="346883" y="553258"/>
                    <a:pt x="349250" y="555625"/>
                  </a:cubicBezTo>
                  <a:cubicBezTo>
                    <a:pt x="369272" y="575647"/>
                    <a:pt x="357140" y="568230"/>
                    <a:pt x="365125" y="584200"/>
                  </a:cubicBezTo>
                  <a:cubicBezTo>
                    <a:pt x="366832" y="587613"/>
                    <a:pt x="369768" y="590312"/>
                    <a:pt x="371475" y="593725"/>
                  </a:cubicBezTo>
                  <a:cubicBezTo>
                    <a:pt x="372972" y="596718"/>
                    <a:pt x="373153" y="600257"/>
                    <a:pt x="374650" y="603250"/>
                  </a:cubicBezTo>
                  <a:cubicBezTo>
                    <a:pt x="376357" y="606663"/>
                    <a:pt x="379293" y="609362"/>
                    <a:pt x="381000" y="612775"/>
                  </a:cubicBezTo>
                  <a:cubicBezTo>
                    <a:pt x="386165" y="623104"/>
                    <a:pt x="381426" y="622726"/>
                    <a:pt x="390525" y="631825"/>
                  </a:cubicBezTo>
                  <a:cubicBezTo>
                    <a:pt x="393223" y="634523"/>
                    <a:pt x="396875" y="636058"/>
                    <a:pt x="400050" y="638175"/>
                  </a:cubicBezTo>
                  <a:cubicBezTo>
                    <a:pt x="402167" y="641350"/>
                    <a:pt x="403164" y="645678"/>
                    <a:pt x="406400" y="647700"/>
                  </a:cubicBezTo>
                  <a:cubicBezTo>
                    <a:pt x="412076" y="651248"/>
                    <a:pt x="419100" y="651933"/>
                    <a:pt x="425450" y="654050"/>
                  </a:cubicBezTo>
                  <a:lnTo>
                    <a:pt x="434975" y="657225"/>
                  </a:lnTo>
                  <a:cubicBezTo>
                    <a:pt x="438150" y="658283"/>
                    <a:pt x="441507" y="658903"/>
                    <a:pt x="444500" y="660400"/>
                  </a:cubicBezTo>
                  <a:cubicBezTo>
                    <a:pt x="448733" y="662517"/>
                    <a:pt x="452768" y="665088"/>
                    <a:pt x="457200" y="666750"/>
                  </a:cubicBezTo>
                  <a:cubicBezTo>
                    <a:pt x="461286" y="668282"/>
                    <a:pt x="465720" y="668671"/>
                    <a:pt x="469900" y="669925"/>
                  </a:cubicBezTo>
                  <a:cubicBezTo>
                    <a:pt x="476311" y="671848"/>
                    <a:pt x="482600" y="674158"/>
                    <a:pt x="488950" y="676275"/>
                  </a:cubicBezTo>
                  <a:lnTo>
                    <a:pt x="498475" y="679450"/>
                  </a:lnTo>
                  <a:cubicBezTo>
                    <a:pt x="530225" y="678392"/>
                    <a:pt x="562012" y="678140"/>
                    <a:pt x="593725" y="676275"/>
                  </a:cubicBezTo>
                  <a:cubicBezTo>
                    <a:pt x="601491" y="675818"/>
                    <a:pt x="608560" y="671773"/>
                    <a:pt x="615950" y="669925"/>
                  </a:cubicBezTo>
                  <a:cubicBezTo>
                    <a:pt x="621185" y="668616"/>
                    <a:pt x="626462" y="667346"/>
                    <a:pt x="631825" y="666750"/>
                  </a:cubicBezTo>
                  <a:cubicBezTo>
                    <a:pt x="645540" y="665226"/>
                    <a:pt x="659363" y="664883"/>
                    <a:pt x="673100" y="663575"/>
                  </a:cubicBezTo>
                  <a:cubicBezTo>
                    <a:pt x="681594" y="662766"/>
                    <a:pt x="690033" y="661458"/>
                    <a:pt x="698500" y="660400"/>
                  </a:cubicBezTo>
                  <a:cubicBezTo>
                    <a:pt x="701675" y="659342"/>
                    <a:pt x="704778" y="658037"/>
                    <a:pt x="708025" y="657225"/>
                  </a:cubicBezTo>
                  <a:cubicBezTo>
                    <a:pt x="716900" y="655006"/>
                    <a:pt x="734458" y="652290"/>
                    <a:pt x="742950" y="650875"/>
                  </a:cubicBezTo>
                  <a:cubicBezTo>
                    <a:pt x="746125" y="649817"/>
                    <a:pt x="749482" y="649197"/>
                    <a:pt x="752475" y="647700"/>
                  </a:cubicBezTo>
                  <a:cubicBezTo>
                    <a:pt x="755888" y="645993"/>
                    <a:pt x="758513" y="642900"/>
                    <a:pt x="762000" y="641350"/>
                  </a:cubicBezTo>
                  <a:cubicBezTo>
                    <a:pt x="768117" y="638632"/>
                    <a:pt x="781050" y="635000"/>
                    <a:pt x="781050" y="635000"/>
                  </a:cubicBezTo>
                  <a:cubicBezTo>
                    <a:pt x="784225" y="632883"/>
                    <a:pt x="787088" y="630200"/>
                    <a:pt x="790575" y="628650"/>
                  </a:cubicBezTo>
                  <a:cubicBezTo>
                    <a:pt x="796692" y="625932"/>
                    <a:pt x="803275" y="624417"/>
                    <a:pt x="809625" y="622300"/>
                  </a:cubicBezTo>
                  <a:cubicBezTo>
                    <a:pt x="823290" y="617745"/>
                    <a:pt x="815903" y="619937"/>
                    <a:pt x="831850" y="615950"/>
                  </a:cubicBezTo>
                  <a:lnTo>
                    <a:pt x="860425" y="596900"/>
                  </a:lnTo>
                  <a:cubicBezTo>
                    <a:pt x="865994" y="593187"/>
                    <a:pt x="879475" y="590550"/>
                    <a:pt x="879475" y="590550"/>
                  </a:cubicBezTo>
                  <a:cubicBezTo>
                    <a:pt x="882650" y="588433"/>
                    <a:pt x="886069" y="586643"/>
                    <a:pt x="889000" y="584200"/>
                  </a:cubicBezTo>
                  <a:cubicBezTo>
                    <a:pt x="892449" y="581325"/>
                    <a:pt x="894789" y="577166"/>
                    <a:pt x="898525" y="574675"/>
                  </a:cubicBezTo>
                  <a:cubicBezTo>
                    <a:pt x="901310" y="572819"/>
                    <a:pt x="904875" y="572558"/>
                    <a:pt x="908050" y="571500"/>
                  </a:cubicBezTo>
                  <a:cubicBezTo>
                    <a:pt x="912283" y="565150"/>
                    <a:pt x="918337" y="559690"/>
                    <a:pt x="920750" y="552450"/>
                  </a:cubicBezTo>
                  <a:cubicBezTo>
                    <a:pt x="921808" y="549275"/>
                    <a:pt x="921834" y="545538"/>
                    <a:pt x="923925" y="542925"/>
                  </a:cubicBezTo>
                  <a:cubicBezTo>
                    <a:pt x="926309" y="539945"/>
                    <a:pt x="930275" y="538692"/>
                    <a:pt x="933450" y="536575"/>
                  </a:cubicBezTo>
                  <a:cubicBezTo>
                    <a:pt x="941430" y="512634"/>
                    <a:pt x="930665" y="542144"/>
                    <a:pt x="942975" y="517525"/>
                  </a:cubicBezTo>
                  <a:cubicBezTo>
                    <a:pt x="944472" y="514532"/>
                    <a:pt x="944059" y="510613"/>
                    <a:pt x="946150" y="508000"/>
                  </a:cubicBezTo>
                  <a:cubicBezTo>
                    <a:pt x="950626" y="502405"/>
                    <a:pt x="958925" y="500567"/>
                    <a:pt x="965200" y="498475"/>
                  </a:cubicBezTo>
                  <a:cubicBezTo>
                    <a:pt x="983295" y="480380"/>
                    <a:pt x="965039" y="495369"/>
                    <a:pt x="987425" y="485775"/>
                  </a:cubicBezTo>
                  <a:cubicBezTo>
                    <a:pt x="1001388" y="479791"/>
                    <a:pt x="991880" y="478682"/>
                    <a:pt x="1006475" y="476250"/>
                  </a:cubicBezTo>
                  <a:cubicBezTo>
                    <a:pt x="1030244" y="472289"/>
                    <a:pt x="1072801" y="470978"/>
                    <a:pt x="1092200" y="469900"/>
                  </a:cubicBezTo>
                  <a:cubicBezTo>
                    <a:pt x="1098475" y="467808"/>
                    <a:pt x="1106774" y="465970"/>
                    <a:pt x="1111250" y="460375"/>
                  </a:cubicBezTo>
                  <a:cubicBezTo>
                    <a:pt x="1113341" y="457762"/>
                    <a:pt x="1112928" y="453843"/>
                    <a:pt x="1114425" y="450850"/>
                  </a:cubicBezTo>
                  <a:cubicBezTo>
                    <a:pt x="1116132" y="447437"/>
                    <a:pt x="1119225" y="444812"/>
                    <a:pt x="1120775" y="441325"/>
                  </a:cubicBezTo>
                  <a:cubicBezTo>
                    <a:pt x="1123493" y="435208"/>
                    <a:pt x="1125008" y="428625"/>
                    <a:pt x="1127125" y="422275"/>
                  </a:cubicBezTo>
                  <a:lnTo>
                    <a:pt x="1130300" y="412750"/>
                  </a:lnTo>
                  <a:cubicBezTo>
                    <a:pt x="1131358" y="395817"/>
                    <a:pt x="1133475" y="378916"/>
                    <a:pt x="1133475" y="361950"/>
                  </a:cubicBezTo>
                  <a:cubicBezTo>
                    <a:pt x="1133475" y="279804"/>
                    <a:pt x="1138541" y="300949"/>
                    <a:pt x="1123950" y="257175"/>
                  </a:cubicBezTo>
                  <a:cubicBezTo>
                    <a:pt x="1121914" y="251068"/>
                    <a:pt x="1122811" y="244232"/>
                    <a:pt x="1120775" y="238125"/>
                  </a:cubicBezTo>
                  <a:cubicBezTo>
                    <a:pt x="1119568" y="234505"/>
                    <a:pt x="1116318" y="231913"/>
                    <a:pt x="1114425" y="228600"/>
                  </a:cubicBezTo>
                  <a:cubicBezTo>
                    <a:pt x="1104509" y="211248"/>
                    <a:pt x="1113512" y="219525"/>
                    <a:pt x="1098550" y="209550"/>
                  </a:cubicBezTo>
                  <a:cubicBezTo>
                    <a:pt x="1080352" y="182253"/>
                    <a:pt x="1102170" y="216790"/>
                    <a:pt x="1089025" y="190500"/>
                  </a:cubicBezTo>
                  <a:cubicBezTo>
                    <a:pt x="1087318" y="187087"/>
                    <a:pt x="1084382" y="184388"/>
                    <a:pt x="1082675" y="180975"/>
                  </a:cubicBezTo>
                  <a:cubicBezTo>
                    <a:pt x="1081178" y="177982"/>
                    <a:pt x="1081591" y="174063"/>
                    <a:pt x="1079500" y="171450"/>
                  </a:cubicBezTo>
                  <a:cubicBezTo>
                    <a:pt x="1077116" y="168470"/>
                    <a:pt x="1073150" y="167217"/>
                    <a:pt x="1069975" y="165100"/>
                  </a:cubicBezTo>
                  <a:cubicBezTo>
                    <a:pt x="1065742" y="158750"/>
                    <a:pt x="1062671" y="151446"/>
                    <a:pt x="1057275" y="146050"/>
                  </a:cubicBezTo>
                  <a:cubicBezTo>
                    <a:pt x="1054100" y="142875"/>
                    <a:pt x="1050507" y="140069"/>
                    <a:pt x="1047750" y="136525"/>
                  </a:cubicBezTo>
                  <a:cubicBezTo>
                    <a:pt x="1029918" y="113599"/>
                    <a:pt x="1043726" y="120367"/>
                    <a:pt x="1025525" y="114300"/>
                  </a:cubicBezTo>
                  <a:cubicBezTo>
                    <a:pt x="1002844" y="99179"/>
                    <a:pt x="1013879" y="103451"/>
                    <a:pt x="993775" y="98425"/>
                  </a:cubicBezTo>
                  <a:cubicBezTo>
                    <a:pt x="971940" y="83869"/>
                    <a:pt x="981965" y="88138"/>
                    <a:pt x="965200" y="82550"/>
                  </a:cubicBezTo>
                  <a:cubicBezTo>
                    <a:pt x="937903" y="64352"/>
                    <a:pt x="972440" y="86170"/>
                    <a:pt x="946150" y="73025"/>
                  </a:cubicBezTo>
                  <a:cubicBezTo>
                    <a:pt x="942737" y="71318"/>
                    <a:pt x="939800" y="68792"/>
                    <a:pt x="936625" y="66675"/>
                  </a:cubicBezTo>
                  <a:cubicBezTo>
                    <a:pt x="933369" y="61791"/>
                    <a:pt x="922300" y="42489"/>
                    <a:pt x="914400" y="38100"/>
                  </a:cubicBezTo>
                  <a:cubicBezTo>
                    <a:pt x="908549" y="34849"/>
                    <a:pt x="895350" y="31750"/>
                    <a:pt x="895350" y="31750"/>
                  </a:cubicBezTo>
                  <a:cubicBezTo>
                    <a:pt x="880256" y="21687"/>
                    <a:pt x="889445" y="26607"/>
                    <a:pt x="866775" y="19050"/>
                  </a:cubicBezTo>
                  <a:lnTo>
                    <a:pt x="857250" y="15875"/>
                  </a:lnTo>
                  <a:cubicBezTo>
                    <a:pt x="842156" y="5812"/>
                    <a:pt x="851345" y="10732"/>
                    <a:pt x="828675" y="3175"/>
                  </a:cubicBezTo>
                  <a:lnTo>
                    <a:pt x="819150" y="0"/>
                  </a:lnTo>
                  <a:cubicBezTo>
                    <a:pt x="809625" y="1058"/>
                    <a:pt x="800028" y="1599"/>
                    <a:pt x="790575" y="3175"/>
                  </a:cubicBezTo>
                  <a:cubicBezTo>
                    <a:pt x="780825" y="4800"/>
                    <a:pt x="779964" y="7637"/>
                    <a:pt x="771525" y="12700"/>
                  </a:cubicBezTo>
                  <a:cubicBezTo>
                    <a:pt x="769496" y="13918"/>
                    <a:pt x="808037" y="12171"/>
                    <a:pt x="806450" y="12700"/>
                  </a:cubicBezTo>
                  <a:close/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</p:grpSp>
      <p:grpSp>
        <p:nvGrpSpPr>
          <p:cNvPr id="3" name="グループ化 2"/>
          <p:cNvGrpSpPr/>
          <p:nvPr/>
        </p:nvGrpSpPr>
        <p:grpSpPr>
          <a:xfrm>
            <a:off x="19952" y="476672"/>
            <a:ext cx="8976988" cy="2203327"/>
            <a:chOff x="19952" y="3537076"/>
            <a:chExt cx="8976988" cy="2203327"/>
          </a:xfrm>
        </p:grpSpPr>
        <p:pic>
          <p:nvPicPr>
            <p:cNvPr id="1043" name="Picture 19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92618" y="3537076"/>
              <a:ext cx="2204322" cy="21980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7" name="Picture 13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04931" y="4069925"/>
              <a:ext cx="1700625" cy="16633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8" name="Picture 14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19588" y="4069925"/>
              <a:ext cx="1700625" cy="16633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9" name="Picture 15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37719" y="4069925"/>
              <a:ext cx="1700625" cy="16633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0" name="Picture 16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70" y="4077072"/>
              <a:ext cx="1700625" cy="16633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7" name="テキスト ボックス 66"/>
            <p:cNvSpPr txBox="1"/>
            <p:nvPr/>
          </p:nvSpPr>
          <p:spPr>
            <a:xfrm>
              <a:off x="19952" y="3705422"/>
              <a:ext cx="16744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b="1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ALS </a:t>
              </a:r>
              <a:r>
                <a:rPr kumimoji="1" lang="en-US" altLang="ja-JP" sz="1600" b="1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case </a:t>
              </a:r>
              <a:r>
                <a:rPr kumimoji="1" lang="en-US" altLang="ja-JP" sz="1400" b="1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(</a:t>
              </a:r>
              <a:r>
                <a:rPr lang="en-US" altLang="ja-JP" sz="1400" b="1" dirty="0" err="1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PtD</a:t>
              </a:r>
              <a:r>
                <a:rPr kumimoji="1" lang="en-US" altLang="ja-JP" sz="1400" b="1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)</a:t>
              </a:r>
              <a:endParaRPr kumimoji="1" lang="ja-JP" altLang="en-US" sz="14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68" name="テキスト ボックス 67"/>
            <p:cNvSpPr txBox="1"/>
            <p:nvPr/>
          </p:nvSpPr>
          <p:spPr>
            <a:xfrm>
              <a:off x="258247" y="4054569"/>
              <a:ext cx="15373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 smtClean="0">
                  <a:solidFill>
                    <a:srgbClr val="92D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NEAT1_2</a:t>
              </a:r>
              <a:r>
                <a:rPr lang="en-US" altLang="ja-JP" sz="1200" b="1" dirty="0" smtClean="0">
                  <a:solidFill>
                    <a:srgbClr val="00800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/</a:t>
              </a:r>
              <a:r>
                <a:rPr lang="en-US" altLang="ja-JP" sz="1200" b="1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Hoechst</a:t>
              </a:r>
              <a:endParaRPr lang="ja-JP" altLang="en-US" sz="1200" b="1" dirty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69" name="テキスト ボックス 68"/>
            <p:cNvSpPr txBox="1"/>
            <p:nvPr/>
          </p:nvSpPr>
          <p:spPr>
            <a:xfrm>
              <a:off x="2270930" y="4067293"/>
              <a:ext cx="14531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solidFill>
                    <a:schemeClr val="bg1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NEAT1_2</a:t>
              </a:r>
              <a:endParaRPr lang="en-US" altLang="ja-JP" sz="1200" b="1" dirty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3995799" y="4069856"/>
              <a:ext cx="1147699" cy="276999"/>
            </a:xfrm>
            <a:prstGeom prst="rect">
              <a:avLst/>
            </a:prstGeom>
            <a:noFill/>
            <a:ln w="34925"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 smtClean="0">
                  <a:solidFill>
                    <a:srgbClr val="FF000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PSF/</a:t>
              </a:r>
              <a:r>
                <a:rPr kumimoji="1" lang="en-US" altLang="ja-JP" sz="1200" b="1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Hoechst</a:t>
              </a:r>
              <a:endParaRPr kumimoji="1" lang="ja-JP" altLang="en-US" sz="1200" b="1" dirty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71" name="テキスト ボックス 70"/>
            <p:cNvSpPr txBox="1"/>
            <p:nvPr/>
          </p:nvSpPr>
          <p:spPr>
            <a:xfrm>
              <a:off x="6246656" y="4056618"/>
              <a:ext cx="590925" cy="276999"/>
            </a:xfrm>
            <a:prstGeom prst="rect">
              <a:avLst/>
            </a:prstGeom>
            <a:noFill/>
            <a:ln w="34925"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 smtClean="0">
                  <a:solidFill>
                    <a:schemeClr val="bg1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PSF</a:t>
              </a:r>
              <a:endParaRPr kumimoji="1" lang="ja-JP" altLang="en-US" sz="1200" b="1" dirty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72" name="テキスト ボックス 71"/>
            <p:cNvSpPr txBox="1"/>
            <p:nvPr/>
          </p:nvSpPr>
          <p:spPr>
            <a:xfrm>
              <a:off x="7317540" y="4063483"/>
              <a:ext cx="12729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 smtClean="0">
                  <a:solidFill>
                    <a:srgbClr val="92D05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NEAT1_2</a:t>
              </a:r>
              <a:r>
                <a:rPr lang="en-US" altLang="ja-JP" sz="1200" b="1" dirty="0" smtClean="0">
                  <a:solidFill>
                    <a:srgbClr val="00800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/</a:t>
              </a:r>
              <a:r>
                <a:rPr lang="en-US" altLang="ja-JP" sz="1200" b="1" dirty="0" smtClean="0">
                  <a:solidFill>
                    <a:srgbClr val="FF000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PSF</a:t>
              </a:r>
              <a:endParaRPr lang="ja-JP" altLang="en-US" sz="1200" b="1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cxnSp>
          <p:nvCxnSpPr>
            <p:cNvPr id="143" name="直線コネクタ 142"/>
            <p:cNvCxnSpPr/>
            <p:nvPr/>
          </p:nvCxnSpPr>
          <p:spPr>
            <a:xfrm>
              <a:off x="5918791" y="5618424"/>
              <a:ext cx="750014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フリーフォーム 19"/>
            <p:cNvSpPr/>
            <p:nvPr/>
          </p:nvSpPr>
          <p:spPr>
            <a:xfrm>
              <a:off x="3679825" y="4298950"/>
              <a:ext cx="1187450" cy="1143000"/>
            </a:xfrm>
            <a:custGeom>
              <a:avLst/>
              <a:gdLst>
                <a:gd name="connsiteX0" fmla="*/ 857250 w 1187450"/>
                <a:gd name="connsiteY0" fmla="*/ 117475 h 1143000"/>
                <a:gd name="connsiteX1" fmla="*/ 841375 w 1187450"/>
                <a:gd name="connsiteY1" fmla="*/ 107950 h 1143000"/>
                <a:gd name="connsiteX2" fmla="*/ 765175 w 1187450"/>
                <a:gd name="connsiteY2" fmla="*/ 98425 h 1143000"/>
                <a:gd name="connsiteX3" fmla="*/ 755650 w 1187450"/>
                <a:gd name="connsiteY3" fmla="*/ 95250 h 1143000"/>
                <a:gd name="connsiteX4" fmla="*/ 736600 w 1187450"/>
                <a:gd name="connsiteY4" fmla="*/ 82550 h 1143000"/>
                <a:gd name="connsiteX5" fmla="*/ 720725 w 1187450"/>
                <a:gd name="connsiteY5" fmla="*/ 69850 h 1143000"/>
                <a:gd name="connsiteX6" fmla="*/ 701675 w 1187450"/>
                <a:gd name="connsiteY6" fmla="*/ 57150 h 1143000"/>
                <a:gd name="connsiteX7" fmla="*/ 695325 w 1187450"/>
                <a:gd name="connsiteY7" fmla="*/ 47625 h 1143000"/>
                <a:gd name="connsiteX8" fmla="*/ 676275 w 1187450"/>
                <a:gd name="connsiteY8" fmla="*/ 38100 h 1143000"/>
                <a:gd name="connsiteX9" fmla="*/ 657225 w 1187450"/>
                <a:gd name="connsiteY9" fmla="*/ 22225 h 1143000"/>
                <a:gd name="connsiteX10" fmla="*/ 638175 w 1187450"/>
                <a:gd name="connsiteY10" fmla="*/ 15875 h 1143000"/>
                <a:gd name="connsiteX11" fmla="*/ 628650 w 1187450"/>
                <a:gd name="connsiteY11" fmla="*/ 12700 h 1143000"/>
                <a:gd name="connsiteX12" fmla="*/ 619125 w 1187450"/>
                <a:gd name="connsiteY12" fmla="*/ 6350 h 1143000"/>
                <a:gd name="connsiteX13" fmla="*/ 596900 w 1187450"/>
                <a:gd name="connsiteY13" fmla="*/ 0 h 1143000"/>
                <a:gd name="connsiteX14" fmla="*/ 539750 w 1187450"/>
                <a:gd name="connsiteY14" fmla="*/ 3175 h 1143000"/>
                <a:gd name="connsiteX15" fmla="*/ 520700 w 1187450"/>
                <a:gd name="connsiteY15" fmla="*/ 9525 h 1143000"/>
                <a:gd name="connsiteX16" fmla="*/ 511175 w 1187450"/>
                <a:gd name="connsiteY16" fmla="*/ 12700 h 1143000"/>
                <a:gd name="connsiteX17" fmla="*/ 501650 w 1187450"/>
                <a:gd name="connsiteY17" fmla="*/ 15875 h 1143000"/>
                <a:gd name="connsiteX18" fmla="*/ 482600 w 1187450"/>
                <a:gd name="connsiteY18" fmla="*/ 19050 h 1143000"/>
                <a:gd name="connsiteX19" fmla="*/ 444500 w 1187450"/>
                <a:gd name="connsiteY19" fmla="*/ 28575 h 1143000"/>
                <a:gd name="connsiteX20" fmla="*/ 431800 w 1187450"/>
                <a:gd name="connsiteY20" fmla="*/ 31750 h 1143000"/>
                <a:gd name="connsiteX21" fmla="*/ 409575 w 1187450"/>
                <a:gd name="connsiteY21" fmla="*/ 38100 h 1143000"/>
                <a:gd name="connsiteX22" fmla="*/ 381000 w 1187450"/>
                <a:gd name="connsiteY22" fmla="*/ 41275 h 1143000"/>
                <a:gd name="connsiteX23" fmla="*/ 361950 w 1187450"/>
                <a:gd name="connsiteY23" fmla="*/ 47625 h 1143000"/>
                <a:gd name="connsiteX24" fmla="*/ 352425 w 1187450"/>
                <a:gd name="connsiteY24" fmla="*/ 53975 h 1143000"/>
                <a:gd name="connsiteX25" fmla="*/ 333375 w 1187450"/>
                <a:gd name="connsiteY25" fmla="*/ 60325 h 1143000"/>
                <a:gd name="connsiteX26" fmla="*/ 311150 w 1187450"/>
                <a:gd name="connsiteY26" fmla="*/ 69850 h 1143000"/>
                <a:gd name="connsiteX27" fmla="*/ 282575 w 1187450"/>
                <a:gd name="connsiteY27" fmla="*/ 85725 h 1143000"/>
                <a:gd name="connsiteX28" fmla="*/ 276225 w 1187450"/>
                <a:gd name="connsiteY28" fmla="*/ 95250 h 1143000"/>
                <a:gd name="connsiteX29" fmla="*/ 257175 w 1187450"/>
                <a:gd name="connsiteY29" fmla="*/ 101600 h 1143000"/>
                <a:gd name="connsiteX30" fmla="*/ 250825 w 1187450"/>
                <a:gd name="connsiteY30" fmla="*/ 111125 h 1143000"/>
                <a:gd name="connsiteX31" fmla="*/ 222250 w 1187450"/>
                <a:gd name="connsiteY31" fmla="*/ 127000 h 1143000"/>
                <a:gd name="connsiteX32" fmla="*/ 193675 w 1187450"/>
                <a:gd name="connsiteY32" fmla="*/ 149225 h 1143000"/>
                <a:gd name="connsiteX33" fmla="*/ 174625 w 1187450"/>
                <a:gd name="connsiteY33" fmla="*/ 165100 h 1143000"/>
                <a:gd name="connsiteX34" fmla="*/ 146050 w 1187450"/>
                <a:gd name="connsiteY34" fmla="*/ 187325 h 1143000"/>
                <a:gd name="connsiteX35" fmla="*/ 136525 w 1187450"/>
                <a:gd name="connsiteY35" fmla="*/ 196850 h 1143000"/>
                <a:gd name="connsiteX36" fmla="*/ 127000 w 1187450"/>
                <a:gd name="connsiteY36" fmla="*/ 203200 h 1143000"/>
                <a:gd name="connsiteX37" fmla="*/ 114300 w 1187450"/>
                <a:gd name="connsiteY37" fmla="*/ 219075 h 1143000"/>
                <a:gd name="connsiteX38" fmla="*/ 101600 w 1187450"/>
                <a:gd name="connsiteY38" fmla="*/ 238125 h 1143000"/>
                <a:gd name="connsiteX39" fmla="*/ 88900 w 1187450"/>
                <a:gd name="connsiteY39" fmla="*/ 257175 h 1143000"/>
                <a:gd name="connsiteX40" fmla="*/ 76200 w 1187450"/>
                <a:gd name="connsiteY40" fmla="*/ 285750 h 1143000"/>
                <a:gd name="connsiteX41" fmla="*/ 73025 w 1187450"/>
                <a:gd name="connsiteY41" fmla="*/ 295275 h 1143000"/>
                <a:gd name="connsiteX42" fmla="*/ 60325 w 1187450"/>
                <a:gd name="connsiteY42" fmla="*/ 314325 h 1143000"/>
                <a:gd name="connsiteX43" fmla="*/ 57150 w 1187450"/>
                <a:gd name="connsiteY43" fmla="*/ 323850 h 1143000"/>
                <a:gd name="connsiteX44" fmla="*/ 50800 w 1187450"/>
                <a:gd name="connsiteY44" fmla="*/ 333375 h 1143000"/>
                <a:gd name="connsiteX45" fmla="*/ 47625 w 1187450"/>
                <a:gd name="connsiteY45" fmla="*/ 342900 h 1143000"/>
                <a:gd name="connsiteX46" fmla="*/ 28575 w 1187450"/>
                <a:gd name="connsiteY46" fmla="*/ 381000 h 1143000"/>
                <a:gd name="connsiteX47" fmla="*/ 22225 w 1187450"/>
                <a:gd name="connsiteY47" fmla="*/ 400050 h 1143000"/>
                <a:gd name="connsiteX48" fmla="*/ 19050 w 1187450"/>
                <a:gd name="connsiteY48" fmla="*/ 409575 h 1143000"/>
                <a:gd name="connsiteX49" fmla="*/ 15875 w 1187450"/>
                <a:gd name="connsiteY49" fmla="*/ 431800 h 1143000"/>
                <a:gd name="connsiteX50" fmla="*/ 12700 w 1187450"/>
                <a:gd name="connsiteY50" fmla="*/ 447675 h 1143000"/>
                <a:gd name="connsiteX51" fmla="*/ 3175 w 1187450"/>
                <a:gd name="connsiteY51" fmla="*/ 501650 h 1143000"/>
                <a:gd name="connsiteX52" fmla="*/ 0 w 1187450"/>
                <a:gd name="connsiteY52" fmla="*/ 511175 h 1143000"/>
                <a:gd name="connsiteX53" fmla="*/ 3175 w 1187450"/>
                <a:gd name="connsiteY53" fmla="*/ 552450 h 1143000"/>
                <a:gd name="connsiteX54" fmla="*/ 12700 w 1187450"/>
                <a:gd name="connsiteY54" fmla="*/ 571500 h 1143000"/>
                <a:gd name="connsiteX55" fmla="*/ 15875 w 1187450"/>
                <a:gd name="connsiteY55" fmla="*/ 581025 h 1143000"/>
                <a:gd name="connsiteX56" fmla="*/ 22225 w 1187450"/>
                <a:gd name="connsiteY56" fmla="*/ 590550 h 1143000"/>
                <a:gd name="connsiteX57" fmla="*/ 28575 w 1187450"/>
                <a:gd name="connsiteY57" fmla="*/ 609600 h 1143000"/>
                <a:gd name="connsiteX58" fmla="*/ 34925 w 1187450"/>
                <a:gd name="connsiteY58" fmla="*/ 628650 h 1143000"/>
                <a:gd name="connsiteX59" fmla="*/ 44450 w 1187450"/>
                <a:gd name="connsiteY59" fmla="*/ 638175 h 1143000"/>
                <a:gd name="connsiteX60" fmla="*/ 50800 w 1187450"/>
                <a:gd name="connsiteY60" fmla="*/ 657225 h 1143000"/>
                <a:gd name="connsiteX61" fmla="*/ 69850 w 1187450"/>
                <a:gd name="connsiteY61" fmla="*/ 685800 h 1143000"/>
                <a:gd name="connsiteX62" fmla="*/ 76200 w 1187450"/>
                <a:gd name="connsiteY62" fmla="*/ 704850 h 1143000"/>
                <a:gd name="connsiteX63" fmla="*/ 79375 w 1187450"/>
                <a:gd name="connsiteY63" fmla="*/ 717550 h 1143000"/>
                <a:gd name="connsiteX64" fmla="*/ 82550 w 1187450"/>
                <a:gd name="connsiteY64" fmla="*/ 727075 h 1143000"/>
                <a:gd name="connsiteX65" fmla="*/ 88900 w 1187450"/>
                <a:gd name="connsiteY65" fmla="*/ 765175 h 1143000"/>
                <a:gd name="connsiteX66" fmla="*/ 92075 w 1187450"/>
                <a:gd name="connsiteY66" fmla="*/ 825500 h 1143000"/>
                <a:gd name="connsiteX67" fmla="*/ 95250 w 1187450"/>
                <a:gd name="connsiteY67" fmla="*/ 838200 h 1143000"/>
                <a:gd name="connsiteX68" fmla="*/ 101600 w 1187450"/>
                <a:gd name="connsiteY68" fmla="*/ 869950 h 1143000"/>
                <a:gd name="connsiteX69" fmla="*/ 120650 w 1187450"/>
                <a:gd name="connsiteY69" fmla="*/ 908050 h 1143000"/>
                <a:gd name="connsiteX70" fmla="*/ 123825 w 1187450"/>
                <a:gd name="connsiteY70" fmla="*/ 917575 h 1143000"/>
                <a:gd name="connsiteX71" fmla="*/ 139700 w 1187450"/>
                <a:gd name="connsiteY71" fmla="*/ 936625 h 1143000"/>
                <a:gd name="connsiteX72" fmla="*/ 152400 w 1187450"/>
                <a:gd name="connsiteY72" fmla="*/ 965200 h 1143000"/>
                <a:gd name="connsiteX73" fmla="*/ 171450 w 1187450"/>
                <a:gd name="connsiteY73" fmla="*/ 977900 h 1143000"/>
                <a:gd name="connsiteX74" fmla="*/ 193675 w 1187450"/>
                <a:gd name="connsiteY74" fmla="*/ 1003300 h 1143000"/>
                <a:gd name="connsiteX75" fmla="*/ 200025 w 1187450"/>
                <a:gd name="connsiteY75" fmla="*/ 1012825 h 1143000"/>
                <a:gd name="connsiteX76" fmla="*/ 209550 w 1187450"/>
                <a:gd name="connsiteY76" fmla="*/ 1019175 h 1143000"/>
                <a:gd name="connsiteX77" fmla="*/ 241300 w 1187450"/>
                <a:gd name="connsiteY77" fmla="*/ 1041400 h 1143000"/>
                <a:gd name="connsiteX78" fmla="*/ 260350 w 1187450"/>
                <a:gd name="connsiteY78" fmla="*/ 1054100 h 1143000"/>
                <a:gd name="connsiteX79" fmla="*/ 276225 w 1187450"/>
                <a:gd name="connsiteY79" fmla="*/ 1063625 h 1143000"/>
                <a:gd name="connsiteX80" fmla="*/ 295275 w 1187450"/>
                <a:gd name="connsiteY80" fmla="*/ 1073150 h 1143000"/>
                <a:gd name="connsiteX81" fmla="*/ 323850 w 1187450"/>
                <a:gd name="connsiteY81" fmla="*/ 1085850 h 1143000"/>
                <a:gd name="connsiteX82" fmla="*/ 352425 w 1187450"/>
                <a:gd name="connsiteY82" fmla="*/ 1095375 h 1143000"/>
                <a:gd name="connsiteX83" fmla="*/ 371475 w 1187450"/>
                <a:gd name="connsiteY83" fmla="*/ 1098550 h 1143000"/>
                <a:gd name="connsiteX84" fmla="*/ 384175 w 1187450"/>
                <a:gd name="connsiteY84" fmla="*/ 1101725 h 1143000"/>
                <a:gd name="connsiteX85" fmla="*/ 403225 w 1187450"/>
                <a:gd name="connsiteY85" fmla="*/ 1111250 h 1143000"/>
                <a:gd name="connsiteX86" fmla="*/ 412750 w 1187450"/>
                <a:gd name="connsiteY86" fmla="*/ 1117600 h 1143000"/>
                <a:gd name="connsiteX87" fmla="*/ 431800 w 1187450"/>
                <a:gd name="connsiteY87" fmla="*/ 1123950 h 1143000"/>
                <a:gd name="connsiteX88" fmla="*/ 441325 w 1187450"/>
                <a:gd name="connsiteY88" fmla="*/ 1127125 h 1143000"/>
                <a:gd name="connsiteX89" fmla="*/ 450850 w 1187450"/>
                <a:gd name="connsiteY89" fmla="*/ 1133475 h 1143000"/>
                <a:gd name="connsiteX90" fmla="*/ 463550 w 1187450"/>
                <a:gd name="connsiteY90" fmla="*/ 1136650 h 1143000"/>
                <a:gd name="connsiteX91" fmla="*/ 495300 w 1187450"/>
                <a:gd name="connsiteY91" fmla="*/ 1143000 h 1143000"/>
                <a:gd name="connsiteX92" fmla="*/ 619125 w 1187450"/>
                <a:gd name="connsiteY92" fmla="*/ 1139825 h 1143000"/>
                <a:gd name="connsiteX93" fmla="*/ 660400 w 1187450"/>
                <a:gd name="connsiteY93" fmla="*/ 1130300 h 1143000"/>
                <a:gd name="connsiteX94" fmla="*/ 673100 w 1187450"/>
                <a:gd name="connsiteY94" fmla="*/ 1127125 h 1143000"/>
                <a:gd name="connsiteX95" fmla="*/ 682625 w 1187450"/>
                <a:gd name="connsiteY95" fmla="*/ 1123950 h 1143000"/>
                <a:gd name="connsiteX96" fmla="*/ 704850 w 1187450"/>
                <a:gd name="connsiteY96" fmla="*/ 1117600 h 1143000"/>
                <a:gd name="connsiteX97" fmla="*/ 723900 w 1187450"/>
                <a:gd name="connsiteY97" fmla="*/ 1108075 h 1143000"/>
                <a:gd name="connsiteX98" fmla="*/ 746125 w 1187450"/>
                <a:gd name="connsiteY98" fmla="*/ 1098550 h 1143000"/>
                <a:gd name="connsiteX99" fmla="*/ 774700 w 1187450"/>
                <a:gd name="connsiteY99" fmla="*/ 1085850 h 1143000"/>
                <a:gd name="connsiteX100" fmla="*/ 796925 w 1187450"/>
                <a:gd name="connsiteY100" fmla="*/ 1073150 h 1143000"/>
                <a:gd name="connsiteX101" fmla="*/ 806450 w 1187450"/>
                <a:gd name="connsiteY101" fmla="*/ 1069975 h 1143000"/>
                <a:gd name="connsiteX102" fmla="*/ 815975 w 1187450"/>
                <a:gd name="connsiteY102" fmla="*/ 1063625 h 1143000"/>
                <a:gd name="connsiteX103" fmla="*/ 825500 w 1187450"/>
                <a:gd name="connsiteY103" fmla="*/ 1054100 h 1143000"/>
                <a:gd name="connsiteX104" fmla="*/ 835025 w 1187450"/>
                <a:gd name="connsiteY104" fmla="*/ 1050925 h 1143000"/>
                <a:gd name="connsiteX105" fmla="*/ 854075 w 1187450"/>
                <a:gd name="connsiteY105" fmla="*/ 1041400 h 1143000"/>
                <a:gd name="connsiteX106" fmla="*/ 863600 w 1187450"/>
                <a:gd name="connsiteY106" fmla="*/ 1035050 h 1143000"/>
                <a:gd name="connsiteX107" fmla="*/ 882650 w 1187450"/>
                <a:gd name="connsiteY107" fmla="*/ 1028700 h 1143000"/>
                <a:gd name="connsiteX108" fmla="*/ 901700 w 1187450"/>
                <a:gd name="connsiteY108" fmla="*/ 1019175 h 1143000"/>
                <a:gd name="connsiteX109" fmla="*/ 911225 w 1187450"/>
                <a:gd name="connsiteY109" fmla="*/ 1012825 h 1143000"/>
                <a:gd name="connsiteX110" fmla="*/ 930275 w 1187450"/>
                <a:gd name="connsiteY110" fmla="*/ 1006475 h 1143000"/>
                <a:gd name="connsiteX111" fmla="*/ 958850 w 1187450"/>
                <a:gd name="connsiteY111" fmla="*/ 987425 h 1143000"/>
                <a:gd name="connsiteX112" fmla="*/ 968375 w 1187450"/>
                <a:gd name="connsiteY112" fmla="*/ 984250 h 1143000"/>
                <a:gd name="connsiteX113" fmla="*/ 977900 w 1187450"/>
                <a:gd name="connsiteY113" fmla="*/ 974725 h 1143000"/>
                <a:gd name="connsiteX114" fmla="*/ 996950 w 1187450"/>
                <a:gd name="connsiteY114" fmla="*/ 962025 h 1143000"/>
                <a:gd name="connsiteX115" fmla="*/ 1012825 w 1187450"/>
                <a:gd name="connsiteY115" fmla="*/ 949325 h 1143000"/>
                <a:gd name="connsiteX116" fmla="*/ 1041400 w 1187450"/>
                <a:gd name="connsiteY116" fmla="*/ 930275 h 1143000"/>
                <a:gd name="connsiteX117" fmla="*/ 1054100 w 1187450"/>
                <a:gd name="connsiteY117" fmla="*/ 920750 h 1143000"/>
                <a:gd name="connsiteX118" fmla="*/ 1063625 w 1187450"/>
                <a:gd name="connsiteY118" fmla="*/ 917575 h 1143000"/>
                <a:gd name="connsiteX119" fmla="*/ 1076325 w 1187450"/>
                <a:gd name="connsiteY119" fmla="*/ 889000 h 1143000"/>
                <a:gd name="connsiteX120" fmla="*/ 1085850 w 1187450"/>
                <a:gd name="connsiteY120" fmla="*/ 879475 h 1143000"/>
                <a:gd name="connsiteX121" fmla="*/ 1104900 w 1187450"/>
                <a:gd name="connsiteY121" fmla="*/ 866775 h 1143000"/>
                <a:gd name="connsiteX122" fmla="*/ 1111250 w 1187450"/>
                <a:gd name="connsiteY122" fmla="*/ 857250 h 1143000"/>
                <a:gd name="connsiteX123" fmla="*/ 1130300 w 1187450"/>
                <a:gd name="connsiteY123" fmla="*/ 838200 h 1143000"/>
                <a:gd name="connsiteX124" fmla="*/ 1143000 w 1187450"/>
                <a:gd name="connsiteY124" fmla="*/ 819150 h 1143000"/>
                <a:gd name="connsiteX125" fmla="*/ 1146175 w 1187450"/>
                <a:gd name="connsiteY125" fmla="*/ 809625 h 1143000"/>
                <a:gd name="connsiteX126" fmla="*/ 1152525 w 1187450"/>
                <a:gd name="connsiteY126" fmla="*/ 800100 h 1143000"/>
                <a:gd name="connsiteX127" fmla="*/ 1158875 w 1187450"/>
                <a:gd name="connsiteY127" fmla="*/ 781050 h 1143000"/>
                <a:gd name="connsiteX128" fmla="*/ 1162050 w 1187450"/>
                <a:gd name="connsiteY128" fmla="*/ 771525 h 1143000"/>
                <a:gd name="connsiteX129" fmla="*/ 1171575 w 1187450"/>
                <a:gd name="connsiteY129" fmla="*/ 765175 h 1143000"/>
                <a:gd name="connsiteX130" fmla="*/ 1181100 w 1187450"/>
                <a:gd name="connsiteY130" fmla="*/ 736600 h 1143000"/>
                <a:gd name="connsiteX131" fmla="*/ 1184275 w 1187450"/>
                <a:gd name="connsiteY131" fmla="*/ 727075 h 1143000"/>
                <a:gd name="connsiteX132" fmla="*/ 1187450 w 1187450"/>
                <a:gd name="connsiteY132" fmla="*/ 717550 h 1143000"/>
                <a:gd name="connsiteX133" fmla="*/ 1184275 w 1187450"/>
                <a:gd name="connsiteY133" fmla="*/ 701675 h 1143000"/>
                <a:gd name="connsiteX134" fmla="*/ 1174750 w 1187450"/>
                <a:gd name="connsiteY134" fmla="*/ 673100 h 1143000"/>
                <a:gd name="connsiteX135" fmla="*/ 1171575 w 1187450"/>
                <a:gd name="connsiteY135" fmla="*/ 663575 h 1143000"/>
                <a:gd name="connsiteX136" fmla="*/ 1168400 w 1187450"/>
                <a:gd name="connsiteY136" fmla="*/ 654050 h 1143000"/>
                <a:gd name="connsiteX137" fmla="*/ 1165225 w 1187450"/>
                <a:gd name="connsiteY137" fmla="*/ 574675 h 1143000"/>
                <a:gd name="connsiteX138" fmla="*/ 1158875 w 1187450"/>
                <a:gd name="connsiteY138" fmla="*/ 555625 h 1143000"/>
                <a:gd name="connsiteX139" fmla="*/ 1143000 w 1187450"/>
                <a:gd name="connsiteY139" fmla="*/ 527050 h 1143000"/>
                <a:gd name="connsiteX140" fmla="*/ 1136650 w 1187450"/>
                <a:gd name="connsiteY140" fmla="*/ 517525 h 1143000"/>
                <a:gd name="connsiteX141" fmla="*/ 1133475 w 1187450"/>
                <a:gd name="connsiteY141" fmla="*/ 508000 h 1143000"/>
                <a:gd name="connsiteX142" fmla="*/ 1117600 w 1187450"/>
                <a:gd name="connsiteY142" fmla="*/ 479425 h 1143000"/>
                <a:gd name="connsiteX143" fmla="*/ 1114425 w 1187450"/>
                <a:gd name="connsiteY143" fmla="*/ 466725 h 1143000"/>
                <a:gd name="connsiteX144" fmla="*/ 1111250 w 1187450"/>
                <a:gd name="connsiteY144" fmla="*/ 450850 h 1143000"/>
                <a:gd name="connsiteX145" fmla="*/ 1104900 w 1187450"/>
                <a:gd name="connsiteY145" fmla="*/ 431800 h 1143000"/>
                <a:gd name="connsiteX146" fmla="*/ 1092200 w 1187450"/>
                <a:gd name="connsiteY146" fmla="*/ 393700 h 1143000"/>
                <a:gd name="connsiteX147" fmla="*/ 1085850 w 1187450"/>
                <a:gd name="connsiteY147" fmla="*/ 384175 h 1143000"/>
                <a:gd name="connsiteX148" fmla="*/ 1079500 w 1187450"/>
                <a:gd name="connsiteY148" fmla="*/ 365125 h 1143000"/>
                <a:gd name="connsiteX149" fmla="*/ 1066800 w 1187450"/>
                <a:gd name="connsiteY149" fmla="*/ 327025 h 1143000"/>
                <a:gd name="connsiteX150" fmla="*/ 1060450 w 1187450"/>
                <a:gd name="connsiteY150" fmla="*/ 317500 h 1143000"/>
                <a:gd name="connsiteX151" fmla="*/ 1047750 w 1187450"/>
                <a:gd name="connsiteY151" fmla="*/ 288925 h 1143000"/>
                <a:gd name="connsiteX152" fmla="*/ 1044575 w 1187450"/>
                <a:gd name="connsiteY152" fmla="*/ 276225 h 1143000"/>
                <a:gd name="connsiteX153" fmla="*/ 1028700 w 1187450"/>
                <a:gd name="connsiteY153" fmla="*/ 257175 h 1143000"/>
                <a:gd name="connsiteX154" fmla="*/ 1016000 w 1187450"/>
                <a:gd name="connsiteY154" fmla="*/ 238125 h 1143000"/>
                <a:gd name="connsiteX155" fmla="*/ 1006475 w 1187450"/>
                <a:gd name="connsiteY155" fmla="*/ 231775 h 1143000"/>
                <a:gd name="connsiteX156" fmla="*/ 987425 w 1187450"/>
                <a:gd name="connsiteY156" fmla="*/ 215900 h 1143000"/>
                <a:gd name="connsiteX157" fmla="*/ 977900 w 1187450"/>
                <a:gd name="connsiteY157" fmla="*/ 212725 h 1143000"/>
                <a:gd name="connsiteX158" fmla="*/ 958850 w 1187450"/>
                <a:gd name="connsiteY158" fmla="*/ 200025 h 1143000"/>
                <a:gd name="connsiteX159" fmla="*/ 942975 w 1187450"/>
                <a:gd name="connsiteY159" fmla="*/ 171450 h 1143000"/>
                <a:gd name="connsiteX160" fmla="*/ 930275 w 1187450"/>
                <a:gd name="connsiteY160" fmla="*/ 152400 h 1143000"/>
                <a:gd name="connsiteX161" fmla="*/ 920750 w 1187450"/>
                <a:gd name="connsiteY161" fmla="*/ 146050 h 1143000"/>
                <a:gd name="connsiteX162" fmla="*/ 917575 w 1187450"/>
                <a:gd name="connsiteY162" fmla="*/ 136525 h 1143000"/>
                <a:gd name="connsiteX163" fmla="*/ 885825 w 1187450"/>
                <a:gd name="connsiteY163" fmla="*/ 120650 h 1143000"/>
                <a:gd name="connsiteX164" fmla="*/ 876300 w 1187450"/>
                <a:gd name="connsiteY164" fmla="*/ 117475 h 1143000"/>
                <a:gd name="connsiteX165" fmla="*/ 857250 w 1187450"/>
                <a:gd name="connsiteY165" fmla="*/ 117475 h 1143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</a:cxnLst>
              <a:rect l="l" t="t" r="r" b="b"/>
              <a:pathLst>
                <a:path w="1187450" h="1143000">
                  <a:moveTo>
                    <a:pt x="857250" y="117475"/>
                  </a:moveTo>
                  <a:cubicBezTo>
                    <a:pt x="851429" y="115887"/>
                    <a:pt x="846993" y="110504"/>
                    <a:pt x="841375" y="107950"/>
                  </a:cubicBezTo>
                  <a:cubicBezTo>
                    <a:pt x="815511" y="96194"/>
                    <a:pt x="796838" y="100184"/>
                    <a:pt x="765175" y="98425"/>
                  </a:cubicBezTo>
                  <a:cubicBezTo>
                    <a:pt x="762000" y="97367"/>
                    <a:pt x="758576" y="96875"/>
                    <a:pt x="755650" y="95250"/>
                  </a:cubicBezTo>
                  <a:cubicBezTo>
                    <a:pt x="748979" y="91544"/>
                    <a:pt x="736600" y="82550"/>
                    <a:pt x="736600" y="82550"/>
                  </a:cubicBezTo>
                  <a:cubicBezTo>
                    <a:pt x="724867" y="64951"/>
                    <a:pt x="736963" y="78871"/>
                    <a:pt x="720725" y="69850"/>
                  </a:cubicBezTo>
                  <a:cubicBezTo>
                    <a:pt x="714054" y="66144"/>
                    <a:pt x="701675" y="57150"/>
                    <a:pt x="701675" y="57150"/>
                  </a:cubicBezTo>
                  <a:cubicBezTo>
                    <a:pt x="699558" y="53975"/>
                    <a:pt x="698023" y="50323"/>
                    <a:pt x="695325" y="47625"/>
                  </a:cubicBezTo>
                  <a:cubicBezTo>
                    <a:pt x="689170" y="41470"/>
                    <a:pt x="684022" y="40682"/>
                    <a:pt x="676275" y="38100"/>
                  </a:cubicBezTo>
                  <a:cubicBezTo>
                    <a:pt x="670293" y="32118"/>
                    <a:pt x="665182" y="25761"/>
                    <a:pt x="657225" y="22225"/>
                  </a:cubicBezTo>
                  <a:cubicBezTo>
                    <a:pt x="651108" y="19507"/>
                    <a:pt x="644525" y="17992"/>
                    <a:pt x="638175" y="15875"/>
                  </a:cubicBezTo>
                  <a:lnTo>
                    <a:pt x="628650" y="12700"/>
                  </a:lnTo>
                  <a:cubicBezTo>
                    <a:pt x="625475" y="10583"/>
                    <a:pt x="622538" y="8057"/>
                    <a:pt x="619125" y="6350"/>
                  </a:cubicBezTo>
                  <a:cubicBezTo>
                    <a:pt x="614570" y="4073"/>
                    <a:pt x="600969" y="1017"/>
                    <a:pt x="596900" y="0"/>
                  </a:cubicBezTo>
                  <a:cubicBezTo>
                    <a:pt x="577850" y="1058"/>
                    <a:pt x="558682" y="808"/>
                    <a:pt x="539750" y="3175"/>
                  </a:cubicBezTo>
                  <a:cubicBezTo>
                    <a:pt x="533108" y="4005"/>
                    <a:pt x="527050" y="7408"/>
                    <a:pt x="520700" y="9525"/>
                  </a:cubicBezTo>
                  <a:lnTo>
                    <a:pt x="511175" y="12700"/>
                  </a:lnTo>
                  <a:cubicBezTo>
                    <a:pt x="508000" y="13758"/>
                    <a:pt x="504951" y="15325"/>
                    <a:pt x="501650" y="15875"/>
                  </a:cubicBezTo>
                  <a:lnTo>
                    <a:pt x="482600" y="19050"/>
                  </a:lnTo>
                  <a:cubicBezTo>
                    <a:pt x="450775" y="29658"/>
                    <a:pt x="476566" y="22162"/>
                    <a:pt x="444500" y="28575"/>
                  </a:cubicBezTo>
                  <a:cubicBezTo>
                    <a:pt x="440221" y="29431"/>
                    <a:pt x="435996" y="30551"/>
                    <a:pt x="431800" y="31750"/>
                  </a:cubicBezTo>
                  <a:cubicBezTo>
                    <a:pt x="422119" y="34516"/>
                    <a:pt x="420328" y="36446"/>
                    <a:pt x="409575" y="38100"/>
                  </a:cubicBezTo>
                  <a:cubicBezTo>
                    <a:pt x="400103" y="39557"/>
                    <a:pt x="390525" y="40217"/>
                    <a:pt x="381000" y="41275"/>
                  </a:cubicBezTo>
                  <a:cubicBezTo>
                    <a:pt x="374650" y="43392"/>
                    <a:pt x="367519" y="43912"/>
                    <a:pt x="361950" y="47625"/>
                  </a:cubicBezTo>
                  <a:cubicBezTo>
                    <a:pt x="358775" y="49742"/>
                    <a:pt x="355912" y="52425"/>
                    <a:pt x="352425" y="53975"/>
                  </a:cubicBezTo>
                  <a:cubicBezTo>
                    <a:pt x="346308" y="56693"/>
                    <a:pt x="333375" y="60325"/>
                    <a:pt x="333375" y="60325"/>
                  </a:cubicBezTo>
                  <a:cubicBezTo>
                    <a:pt x="298705" y="83439"/>
                    <a:pt x="352155" y="49348"/>
                    <a:pt x="311150" y="69850"/>
                  </a:cubicBezTo>
                  <a:cubicBezTo>
                    <a:pt x="267481" y="91685"/>
                    <a:pt x="308915" y="76945"/>
                    <a:pt x="282575" y="85725"/>
                  </a:cubicBezTo>
                  <a:cubicBezTo>
                    <a:pt x="280458" y="88900"/>
                    <a:pt x="279461" y="93228"/>
                    <a:pt x="276225" y="95250"/>
                  </a:cubicBezTo>
                  <a:cubicBezTo>
                    <a:pt x="270549" y="98798"/>
                    <a:pt x="257175" y="101600"/>
                    <a:pt x="257175" y="101600"/>
                  </a:cubicBezTo>
                  <a:cubicBezTo>
                    <a:pt x="255058" y="104775"/>
                    <a:pt x="253697" y="108612"/>
                    <a:pt x="250825" y="111125"/>
                  </a:cubicBezTo>
                  <a:cubicBezTo>
                    <a:pt x="237388" y="122882"/>
                    <a:pt x="235332" y="122639"/>
                    <a:pt x="222250" y="127000"/>
                  </a:cubicBezTo>
                  <a:cubicBezTo>
                    <a:pt x="200833" y="148417"/>
                    <a:pt x="211719" y="143210"/>
                    <a:pt x="193675" y="149225"/>
                  </a:cubicBezTo>
                  <a:cubicBezTo>
                    <a:pt x="165848" y="177052"/>
                    <a:pt x="201147" y="142998"/>
                    <a:pt x="174625" y="165100"/>
                  </a:cubicBezTo>
                  <a:cubicBezTo>
                    <a:pt x="144782" y="189969"/>
                    <a:pt x="194198" y="155227"/>
                    <a:pt x="146050" y="187325"/>
                  </a:cubicBezTo>
                  <a:cubicBezTo>
                    <a:pt x="142314" y="189816"/>
                    <a:pt x="139974" y="193975"/>
                    <a:pt x="136525" y="196850"/>
                  </a:cubicBezTo>
                  <a:cubicBezTo>
                    <a:pt x="133594" y="199293"/>
                    <a:pt x="130175" y="201083"/>
                    <a:pt x="127000" y="203200"/>
                  </a:cubicBezTo>
                  <a:cubicBezTo>
                    <a:pt x="119850" y="224650"/>
                    <a:pt x="129766" y="201400"/>
                    <a:pt x="114300" y="219075"/>
                  </a:cubicBezTo>
                  <a:cubicBezTo>
                    <a:pt x="109274" y="224818"/>
                    <a:pt x="105833" y="231775"/>
                    <a:pt x="101600" y="238125"/>
                  </a:cubicBezTo>
                  <a:lnTo>
                    <a:pt x="88900" y="257175"/>
                  </a:lnTo>
                  <a:cubicBezTo>
                    <a:pt x="78837" y="272269"/>
                    <a:pt x="83757" y="263080"/>
                    <a:pt x="76200" y="285750"/>
                  </a:cubicBezTo>
                  <a:cubicBezTo>
                    <a:pt x="75142" y="288925"/>
                    <a:pt x="74881" y="292490"/>
                    <a:pt x="73025" y="295275"/>
                  </a:cubicBezTo>
                  <a:cubicBezTo>
                    <a:pt x="68792" y="301625"/>
                    <a:pt x="62738" y="307085"/>
                    <a:pt x="60325" y="314325"/>
                  </a:cubicBezTo>
                  <a:cubicBezTo>
                    <a:pt x="59267" y="317500"/>
                    <a:pt x="58647" y="320857"/>
                    <a:pt x="57150" y="323850"/>
                  </a:cubicBezTo>
                  <a:cubicBezTo>
                    <a:pt x="55443" y="327263"/>
                    <a:pt x="52507" y="329962"/>
                    <a:pt x="50800" y="333375"/>
                  </a:cubicBezTo>
                  <a:cubicBezTo>
                    <a:pt x="49303" y="336368"/>
                    <a:pt x="49250" y="339974"/>
                    <a:pt x="47625" y="342900"/>
                  </a:cubicBezTo>
                  <a:cubicBezTo>
                    <a:pt x="27109" y="379829"/>
                    <a:pt x="40937" y="343914"/>
                    <a:pt x="28575" y="381000"/>
                  </a:cubicBezTo>
                  <a:lnTo>
                    <a:pt x="22225" y="400050"/>
                  </a:lnTo>
                  <a:lnTo>
                    <a:pt x="19050" y="409575"/>
                  </a:lnTo>
                  <a:cubicBezTo>
                    <a:pt x="17992" y="416983"/>
                    <a:pt x="17105" y="424418"/>
                    <a:pt x="15875" y="431800"/>
                  </a:cubicBezTo>
                  <a:cubicBezTo>
                    <a:pt x="14988" y="437123"/>
                    <a:pt x="13587" y="442352"/>
                    <a:pt x="12700" y="447675"/>
                  </a:cubicBezTo>
                  <a:cubicBezTo>
                    <a:pt x="10045" y="463604"/>
                    <a:pt x="8041" y="487052"/>
                    <a:pt x="3175" y="501650"/>
                  </a:cubicBezTo>
                  <a:lnTo>
                    <a:pt x="0" y="511175"/>
                  </a:lnTo>
                  <a:cubicBezTo>
                    <a:pt x="1058" y="524933"/>
                    <a:pt x="1463" y="538758"/>
                    <a:pt x="3175" y="552450"/>
                  </a:cubicBezTo>
                  <a:cubicBezTo>
                    <a:pt x="4505" y="563091"/>
                    <a:pt x="7973" y="562046"/>
                    <a:pt x="12700" y="571500"/>
                  </a:cubicBezTo>
                  <a:cubicBezTo>
                    <a:pt x="14197" y="574493"/>
                    <a:pt x="14378" y="578032"/>
                    <a:pt x="15875" y="581025"/>
                  </a:cubicBezTo>
                  <a:cubicBezTo>
                    <a:pt x="17582" y="584438"/>
                    <a:pt x="20675" y="587063"/>
                    <a:pt x="22225" y="590550"/>
                  </a:cubicBezTo>
                  <a:cubicBezTo>
                    <a:pt x="24943" y="596667"/>
                    <a:pt x="26458" y="603250"/>
                    <a:pt x="28575" y="609600"/>
                  </a:cubicBezTo>
                  <a:lnTo>
                    <a:pt x="34925" y="628650"/>
                  </a:lnTo>
                  <a:cubicBezTo>
                    <a:pt x="36345" y="632910"/>
                    <a:pt x="41275" y="635000"/>
                    <a:pt x="44450" y="638175"/>
                  </a:cubicBezTo>
                  <a:lnTo>
                    <a:pt x="50800" y="657225"/>
                  </a:lnTo>
                  <a:lnTo>
                    <a:pt x="69850" y="685800"/>
                  </a:lnTo>
                  <a:cubicBezTo>
                    <a:pt x="73563" y="691369"/>
                    <a:pt x="74083" y="698500"/>
                    <a:pt x="76200" y="704850"/>
                  </a:cubicBezTo>
                  <a:cubicBezTo>
                    <a:pt x="77580" y="708990"/>
                    <a:pt x="78176" y="713354"/>
                    <a:pt x="79375" y="717550"/>
                  </a:cubicBezTo>
                  <a:cubicBezTo>
                    <a:pt x="80294" y="720768"/>
                    <a:pt x="81738" y="723828"/>
                    <a:pt x="82550" y="727075"/>
                  </a:cubicBezTo>
                  <a:cubicBezTo>
                    <a:pt x="85645" y="739455"/>
                    <a:pt x="87108" y="752630"/>
                    <a:pt x="88900" y="765175"/>
                  </a:cubicBezTo>
                  <a:cubicBezTo>
                    <a:pt x="89958" y="785283"/>
                    <a:pt x="90331" y="805440"/>
                    <a:pt x="92075" y="825500"/>
                  </a:cubicBezTo>
                  <a:cubicBezTo>
                    <a:pt x="92453" y="829847"/>
                    <a:pt x="94336" y="833933"/>
                    <a:pt x="95250" y="838200"/>
                  </a:cubicBezTo>
                  <a:cubicBezTo>
                    <a:pt x="97511" y="848753"/>
                    <a:pt x="99483" y="859367"/>
                    <a:pt x="101600" y="869950"/>
                  </a:cubicBezTo>
                  <a:cubicBezTo>
                    <a:pt x="112396" y="923931"/>
                    <a:pt x="101919" y="851858"/>
                    <a:pt x="120650" y="908050"/>
                  </a:cubicBezTo>
                  <a:cubicBezTo>
                    <a:pt x="121708" y="911225"/>
                    <a:pt x="122328" y="914582"/>
                    <a:pt x="123825" y="917575"/>
                  </a:cubicBezTo>
                  <a:cubicBezTo>
                    <a:pt x="128245" y="926416"/>
                    <a:pt x="132678" y="929603"/>
                    <a:pt x="139700" y="936625"/>
                  </a:cubicBezTo>
                  <a:cubicBezTo>
                    <a:pt x="142065" y="943720"/>
                    <a:pt x="145297" y="958985"/>
                    <a:pt x="152400" y="965200"/>
                  </a:cubicBezTo>
                  <a:cubicBezTo>
                    <a:pt x="158143" y="970226"/>
                    <a:pt x="171450" y="977900"/>
                    <a:pt x="171450" y="977900"/>
                  </a:cubicBezTo>
                  <a:cubicBezTo>
                    <a:pt x="186267" y="1000125"/>
                    <a:pt x="177800" y="992717"/>
                    <a:pt x="193675" y="1003300"/>
                  </a:cubicBezTo>
                  <a:cubicBezTo>
                    <a:pt x="195792" y="1006475"/>
                    <a:pt x="197327" y="1010127"/>
                    <a:pt x="200025" y="1012825"/>
                  </a:cubicBezTo>
                  <a:cubicBezTo>
                    <a:pt x="202723" y="1015523"/>
                    <a:pt x="206445" y="1016957"/>
                    <a:pt x="209550" y="1019175"/>
                  </a:cubicBezTo>
                  <a:cubicBezTo>
                    <a:pt x="242459" y="1042682"/>
                    <a:pt x="197506" y="1012204"/>
                    <a:pt x="241300" y="1041400"/>
                  </a:cubicBezTo>
                  <a:cubicBezTo>
                    <a:pt x="247650" y="1045633"/>
                    <a:pt x="253878" y="1050055"/>
                    <a:pt x="260350" y="1054100"/>
                  </a:cubicBezTo>
                  <a:cubicBezTo>
                    <a:pt x="265583" y="1057371"/>
                    <a:pt x="271090" y="1060202"/>
                    <a:pt x="276225" y="1063625"/>
                  </a:cubicBezTo>
                  <a:cubicBezTo>
                    <a:pt x="288535" y="1071831"/>
                    <a:pt x="282130" y="1068768"/>
                    <a:pt x="295275" y="1073150"/>
                  </a:cubicBezTo>
                  <a:cubicBezTo>
                    <a:pt x="310369" y="1083213"/>
                    <a:pt x="301180" y="1078293"/>
                    <a:pt x="323850" y="1085850"/>
                  </a:cubicBezTo>
                  <a:lnTo>
                    <a:pt x="352425" y="1095375"/>
                  </a:lnTo>
                  <a:cubicBezTo>
                    <a:pt x="358532" y="1097411"/>
                    <a:pt x="365162" y="1097287"/>
                    <a:pt x="371475" y="1098550"/>
                  </a:cubicBezTo>
                  <a:cubicBezTo>
                    <a:pt x="375754" y="1099406"/>
                    <a:pt x="379942" y="1100667"/>
                    <a:pt x="384175" y="1101725"/>
                  </a:cubicBezTo>
                  <a:cubicBezTo>
                    <a:pt x="411472" y="1119923"/>
                    <a:pt x="376935" y="1098105"/>
                    <a:pt x="403225" y="1111250"/>
                  </a:cubicBezTo>
                  <a:cubicBezTo>
                    <a:pt x="406638" y="1112957"/>
                    <a:pt x="409263" y="1116050"/>
                    <a:pt x="412750" y="1117600"/>
                  </a:cubicBezTo>
                  <a:cubicBezTo>
                    <a:pt x="418867" y="1120318"/>
                    <a:pt x="425450" y="1121833"/>
                    <a:pt x="431800" y="1123950"/>
                  </a:cubicBezTo>
                  <a:lnTo>
                    <a:pt x="441325" y="1127125"/>
                  </a:lnTo>
                  <a:cubicBezTo>
                    <a:pt x="444500" y="1129242"/>
                    <a:pt x="447343" y="1131972"/>
                    <a:pt x="450850" y="1133475"/>
                  </a:cubicBezTo>
                  <a:cubicBezTo>
                    <a:pt x="454861" y="1135194"/>
                    <a:pt x="459271" y="1135794"/>
                    <a:pt x="463550" y="1136650"/>
                  </a:cubicBezTo>
                  <a:cubicBezTo>
                    <a:pt x="502474" y="1144435"/>
                    <a:pt x="465801" y="1135625"/>
                    <a:pt x="495300" y="1143000"/>
                  </a:cubicBezTo>
                  <a:cubicBezTo>
                    <a:pt x="536575" y="1141942"/>
                    <a:pt x="577914" y="1142348"/>
                    <a:pt x="619125" y="1139825"/>
                  </a:cubicBezTo>
                  <a:cubicBezTo>
                    <a:pt x="646021" y="1138178"/>
                    <a:pt x="643159" y="1135226"/>
                    <a:pt x="660400" y="1130300"/>
                  </a:cubicBezTo>
                  <a:cubicBezTo>
                    <a:pt x="664596" y="1129101"/>
                    <a:pt x="668904" y="1128324"/>
                    <a:pt x="673100" y="1127125"/>
                  </a:cubicBezTo>
                  <a:cubicBezTo>
                    <a:pt x="676318" y="1126206"/>
                    <a:pt x="679407" y="1124869"/>
                    <a:pt x="682625" y="1123950"/>
                  </a:cubicBezTo>
                  <a:cubicBezTo>
                    <a:pt x="710532" y="1115977"/>
                    <a:pt x="682012" y="1125213"/>
                    <a:pt x="704850" y="1117600"/>
                  </a:cubicBezTo>
                  <a:cubicBezTo>
                    <a:pt x="732147" y="1099402"/>
                    <a:pt x="697610" y="1121220"/>
                    <a:pt x="723900" y="1108075"/>
                  </a:cubicBezTo>
                  <a:cubicBezTo>
                    <a:pt x="745826" y="1097112"/>
                    <a:pt x="719694" y="1105158"/>
                    <a:pt x="746125" y="1098550"/>
                  </a:cubicBezTo>
                  <a:cubicBezTo>
                    <a:pt x="761219" y="1088487"/>
                    <a:pt x="752030" y="1093407"/>
                    <a:pt x="774700" y="1085850"/>
                  </a:cubicBezTo>
                  <a:cubicBezTo>
                    <a:pt x="791399" y="1080284"/>
                    <a:pt x="782990" y="1080118"/>
                    <a:pt x="796925" y="1073150"/>
                  </a:cubicBezTo>
                  <a:cubicBezTo>
                    <a:pt x="799918" y="1071653"/>
                    <a:pt x="803275" y="1071033"/>
                    <a:pt x="806450" y="1069975"/>
                  </a:cubicBezTo>
                  <a:cubicBezTo>
                    <a:pt x="809625" y="1067858"/>
                    <a:pt x="813044" y="1066068"/>
                    <a:pt x="815975" y="1063625"/>
                  </a:cubicBezTo>
                  <a:cubicBezTo>
                    <a:pt x="819424" y="1060750"/>
                    <a:pt x="821764" y="1056591"/>
                    <a:pt x="825500" y="1054100"/>
                  </a:cubicBezTo>
                  <a:cubicBezTo>
                    <a:pt x="828285" y="1052244"/>
                    <a:pt x="831850" y="1051983"/>
                    <a:pt x="835025" y="1050925"/>
                  </a:cubicBezTo>
                  <a:cubicBezTo>
                    <a:pt x="862322" y="1032727"/>
                    <a:pt x="827785" y="1054545"/>
                    <a:pt x="854075" y="1041400"/>
                  </a:cubicBezTo>
                  <a:cubicBezTo>
                    <a:pt x="857488" y="1039693"/>
                    <a:pt x="860113" y="1036600"/>
                    <a:pt x="863600" y="1035050"/>
                  </a:cubicBezTo>
                  <a:cubicBezTo>
                    <a:pt x="869717" y="1032332"/>
                    <a:pt x="882650" y="1028700"/>
                    <a:pt x="882650" y="1028700"/>
                  </a:cubicBezTo>
                  <a:cubicBezTo>
                    <a:pt x="909947" y="1010502"/>
                    <a:pt x="875410" y="1032320"/>
                    <a:pt x="901700" y="1019175"/>
                  </a:cubicBezTo>
                  <a:cubicBezTo>
                    <a:pt x="905113" y="1017468"/>
                    <a:pt x="907738" y="1014375"/>
                    <a:pt x="911225" y="1012825"/>
                  </a:cubicBezTo>
                  <a:cubicBezTo>
                    <a:pt x="917342" y="1010107"/>
                    <a:pt x="930275" y="1006475"/>
                    <a:pt x="930275" y="1006475"/>
                  </a:cubicBezTo>
                  <a:lnTo>
                    <a:pt x="958850" y="987425"/>
                  </a:lnTo>
                  <a:cubicBezTo>
                    <a:pt x="961635" y="985569"/>
                    <a:pt x="965200" y="985308"/>
                    <a:pt x="968375" y="984250"/>
                  </a:cubicBezTo>
                  <a:cubicBezTo>
                    <a:pt x="971550" y="981075"/>
                    <a:pt x="974356" y="977482"/>
                    <a:pt x="977900" y="974725"/>
                  </a:cubicBezTo>
                  <a:cubicBezTo>
                    <a:pt x="983924" y="970040"/>
                    <a:pt x="996950" y="962025"/>
                    <a:pt x="996950" y="962025"/>
                  </a:cubicBezTo>
                  <a:cubicBezTo>
                    <a:pt x="1008683" y="944426"/>
                    <a:pt x="996587" y="958346"/>
                    <a:pt x="1012825" y="949325"/>
                  </a:cubicBezTo>
                  <a:lnTo>
                    <a:pt x="1041400" y="930275"/>
                  </a:lnTo>
                  <a:cubicBezTo>
                    <a:pt x="1045803" y="927340"/>
                    <a:pt x="1049506" y="923375"/>
                    <a:pt x="1054100" y="920750"/>
                  </a:cubicBezTo>
                  <a:cubicBezTo>
                    <a:pt x="1057006" y="919090"/>
                    <a:pt x="1060450" y="918633"/>
                    <a:pt x="1063625" y="917575"/>
                  </a:cubicBezTo>
                  <a:cubicBezTo>
                    <a:pt x="1068240" y="903731"/>
                    <a:pt x="1067939" y="899063"/>
                    <a:pt x="1076325" y="889000"/>
                  </a:cubicBezTo>
                  <a:cubicBezTo>
                    <a:pt x="1079200" y="885551"/>
                    <a:pt x="1082306" y="882232"/>
                    <a:pt x="1085850" y="879475"/>
                  </a:cubicBezTo>
                  <a:cubicBezTo>
                    <a:pt x="1091874" y="874790"/>
                    <a:pt x="1104900" y="866775"/>
                    <a:pt x="1104900" y="866775"/>
                  </a:cubicBezTo>
                  <a:cubicBezTo>
                    <a:pt x="1107017" y="863600"/>
                    <a:pt x="1108715" y="860102"/>
                    <a:pt x="1111250" y="857250"/>
                  </a:cubicBezTo>
                  <a:cubicBezTo>
                    <a:pt x="1117216" y="850538"/>
                    <a:pt x="1130300" y="838200"/>
                    <a:pt x="1130300" y="838200"/>
                  </a:cubicBezTo>
                  <a:cubicBezTo>
                    <a:pt x="1137849" y="815552"/>
                    <a:pt x="1127145" y="842933"/>
                    <a:pt x="1143000" y="819150"/>
                  </a:cubicBezTo>
                  <a:cubicBezTo>
                    <a:pt x="1144856" y="816365"/>
                    <a:pt x="1144678" y="812618"/>
                    <a:pt x="1146175" y="809625"/>
                  </a:cubicBezTo>
                  <a:cubicBezTo>
                    <a:pt x="1147882" y="806212"/>
                    <a:pt x="1150975" y="803587"/>
                    <a:pt x="1152525" y="800100"/>
                  </a:cubicBezTo>
                  <a:cubicBezTo>
                    <a:pt x="1155243" y="793983"/>
                    <a:pt x="1156758" y="787400"/>
                    <a:pt x="1158875" y="781050"/>
                  </a:cubicBezTo>
                  <a:cubicBezTo>
                    <a:pt x="1159933" y="777875"/>
                    <a:pt x="1159265" y="773381"/>
                    <a:pt x="1162050" y="771525"/>
                  </a:cubicBezTo>
                  <a:lnTo>
                    <a:pt x="1171575" y="765175"/>
                  </a:lnTo>
                  <a:lnTo>
                    <a:pt x="1181100" y="736600"/>
                  </a:lnTo>
                  <a:lnTo>
                    <a:pt x="1184275" y="727075"/>
                  </a:lnTo>
                  <a:lnTo>
                    <a:pt x="1187450" y="717550"/>
                  </a:lnTo>
                  <a:cubicBezTo>
                    <a:pt x="1186392" y="712258"/>
                    <a:pt x="1185695" y="706881"/>
                    <a:pt x="1184275" y="701675"/>
                  </a:cubicBezTo>
                  <a:lnTo>
                    <a:pt x="1174750" y="673100"/>
                  </a:lnTo>
                  <a:lnTo>
                    <a:pt x="1171575" y="663575"/>
                  </a:lnTo>
                  <a:lnTo>
                    <a:pt x="1168400" y="654050"/>
                  </a:lnTo>
                  <a:cubicBezTo>
                    <a:pt x="1167342" y="627592"/>
                    <a:pt x="1167776" y="601031"/>
                    <a:pt x="1165225" y="574675"/>
                  </a:cubicBezTo>
                  <a:cubicBezTo>
                    <a:pt x="1164580" y="568013"/>
                    <a:pt x="1160992" y="561975"/>
                    <a:pt x="1158875" y="555625"/>
                  </a:cubicBezTo>
                  <a:cubicBezTo>
                    <a:pt x="1153287" y="538860"/>
                    <a:pt x="1157556" y="548885"/>
                    <a:pt x="1143000" y="527050"/>
                  </a:cubicBezTo>
                  <a:cubicBezTo>
                    <a:pt x="1140883" y="523875"/>
                    <a:pt x="1137857" y="521145"/>
                    <a:pt x="1136650" y="517525"/>
                  </a:cubicBezTo>
                  <a:cubicBezTo>
                    <a:pt x="1135592" y="514350"/>
                    <a:pt x="1135100" y="510926"/>
                    <a:pt x="1133475" y="508000"/>
                  </a:cubicBezTo>
                  <a:cubicBezTo>
                    <a:pt x="1120098" y="483921"/>
                    <a:pt x="1122671" y="497174"/>
                    <a:pt x="1117600" y="479425"/>
                  </a:cubicBezTo>
                  <a:cubicBezTo>
                    <a:pt x="1116401" y="475229"/>
                    <a:pt x="1115372" y="470985"/>
                    <a:pt x="1114425" y="466725"/>
                  </a:cubicBezTo>
                  <a:cubicBezTo>
                    <a:pt x="1113254" y="461457"/>
                    <a:pt x="1112670" y="456056"/>
                    <a:pt x="1111250" y="450850"/>
                  </a:cubicBezTo>
                  <a:cubicBezTo>
                    <a:pt x="1109489" y="444392"/>
                    <a:pt x="1107017" y="438150"/>
                    <a:pt x="1104900" y="431800"/>
                  </a:cubicBezTo>
                  <a:lnTo>
                    <a:pt x="1092200" y="393700"/>
                  </a:lnTo>
                  <a:cubicBezTo>
                    <a:pt x="1090993" y="390080"/>
                    <a:pt x="1087400" y="387662"/>
                    <a:pt x="1085850" y="384175"/>
                  </a:cubicBezTo>
                  <a:cubicBezTo>
                    <a:pt x="1083132" y="378058"/>
                    <a:pt x="1081617" y="371475"/>
                    <a:pt x="1079500" y="365125"/>
                  </a:cubicBezTo>
                  <a:lnTo>
                    <a:pt x="1066800" y="327025"/>
                  </a:lnTo>
                  <a:cubicBezTo>
                    <a:pt x="1065593" y="323405"/>
                    <a:pt x="1062000" y="320987"/>
                    <a:pt x="1060450" y="317500"/>
                  </a:cubicBezTo>
                  <a:cubicBezTo>
                    <a:pt x="1045337" y="283495"/>
                    <a:pt x="1062121" y="310481"/>
                    <a:pt x="1047750" y="288925"/>
                  </a:cubicBezTo>
                  <a:cubicBezTo>
                    <a:pt x="1046692" y="284692"/>
                    <a:pt x="1046294" y="280236"/>
                    <a:pt x="1044575" y="276225"/>
                  </a:cubicBezTo>
                  <a:cubicBezTo>
                    <a:pt x="1039934" y="265395"/>
                    <a:pt x="1035982" y="266537"/>
                    <a:pt x="1028700" y="257175"/>
                  </a:cubicBezTo>
                  <a:cubicBezTo>
                    <a:pt x="1024015" y="251151"/>
                    <a:pt x="1022350" y="242358"/>
                    <a:pt x="1016000" y="238125"/>
                  </a:cubicBezTo>
                  <a:cubicBezTo>
                    <a:pt x="1012825" y="236008"/>
                    <a:pt x="1009406" y="234218"/>
                    <a:pt x="1006475" y="231775"/>
                  </a:cubicBezTo>
                  <a:cubicBezTo>
                    <a:pt x="995942" y="222998"/>
                    <a:pt x="999249" y="221812"/>
                    <a:pt x="987425" y="215900"/>
                  </a:cubicBezTo>
                  <a:cubicBezTo>
                    <a:pt x="984432" y="214403"/>
                    <a:pt x="981075" y="213783"/>
                    <a:pt x="977900" y="212725"/>
                  </a:cubicBezTo>
                  <a:cubicBezTo>
                    <a:pt x="971550" y="208492"/>
                    <a:pt x="961263" y="207265"/>
                    <a:pt x="958850" y="200025"/>
                  </a:cubicBezTo>
                  <a:cubicBezTo>
                    <a:pt x="953262" y="183260"/>
                    <a:pt x="957531" y="193285"/>
                    <a:pt x="942975" y="171450"/>
                  </a:cubicBezTo>
                  <a:lnTo>
                    <a:pt x="930275" y="152400"/>
                  </a:lnTo>
                  <a:cubicBezTo>
                    <a:pt x="928158" y="149225"/>
                    <a:pt x="923925" y="148167"/>
                    <a:pt x="920750" y="146050"/>
                  </a:cubicBezTo>
                  <a:cubicBezTo>
                    <a:pt x="919692" y="142875"/>
                    <a:pt x="919942" y="138892"/>
                    <a:pt x="917575" y="136525"/>
                  </a:cubicBezTo>
                  <a:cubicBezTo>
                    <a:pt x="903721" y="122671"/>
                    <a:pt x="900882" y="124952"/>
                    <a:pt x="885825" y="120650"/>
                  </a:cubicBezTo>
                  <a:cubicBezTo>
                    <a:pt x="882607" y="119731"/>
                    <a:pt x="879640" y="117684"/>
                    <a:pt x="876300" y="117475"/>
                  </a:cubicBezTo>
                  <a:cubicBezTo>
                    <a:pt x="862568" y="116617"/>
                    <a:pt x="863071" y="119063"/>
                    <a:pt x="857250" y="117475"/>
                  </a:cubicBezTo>
                  <a:close/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50" name="フリーフォーム 149"/>
            <p:cNvSpPr/>
            <p:nvPr/>
          </p:nvSpPr>
          <p:spPr>
            <a:xfrm>
              <a:off x="5392618" y="4290938"/>
              <a:ext cx="1187450" cy="1143000"/>
            </a:xfrm>
            <a:custGeom>
              <a:avLst/>
              <a:gdLst>
                <a:gd name="connsiteX0" fmla="*/ 857250 w 1187450"/>
                <a:gd name="connsiteY0" fmla="*/ 117475 h 1143000"/>
                <a:gd name="connsiteX1" fmla="*/ 841375 w 1187450"/>
                <a:gd name="connsiteY1" fmla="*/ 107950 h 1143000"/>
                <a:gd name="connsiteX2" fmla="*/ 765175 w 1187450"/>
                <a:gd name="connsiteY2" fmla="*/ 98425 h 1143000"/>
                <a:gd name="connsiteX3" fmla="*/ 755650 w 1187450"/>
                <a:gd name="connsiteY3" fmla="*/ 95250 h 1143000"/>
                <a:gd name="connsiteX4" fmla="*/ 736600 w 1187450"/>
                <a:gd name="connsiteY4" fmla="*/ 82550 h 1143000"/>
                <a:gd name="connsiteX5" fmla="*/ 720725 w 1187450"/>
                <a:gd name="connsiteY5" fmla="*/ 69850 h 1143000"/>
                <a:gd name="connsiteX6" fmla="*/ 701675 w 1187450"/>
                <a:gd name="connsiteY6" fmla="*/ 57150 h 1143000"/>
                <a:gd name="connsiteX7" fmla="*/ 695325 w 1187450"/>
                <a:gd name="connsiteY7" fmla="*/ 47625 h 1143000"/>
                <a:gd name="connsiteX8" fmla="*/ 676275 w 1187450"/>
                <a:gd name="connsiteY8" fmla="*/ 38100 h 1143000"/>
                <a:gd name="connsiteX9" fmla="*/ 657225 w 1187450"/>
                <a:gd name="connsiteY9" fmla="*/ 22225 h 1143000"/>
                <a:gd name="connsiteX10" fmla="*/ 638175 w 1187450"/>
                <a:gd name="connsiteY10" fmla="*/ 15875 h 1143000"/>
                <a:gd name="connsiteX11" fmla="*/ 628650 w 1187450"/>
                <a:gd name="connsiteY11" fmla="*/ 12700 h 1143000"/>
                <a:gd name="connsiteX12" fmla="*/ 619125 w 1187450"/>
                <a:gd name="connsiteY12" fmla="*/ 6350 h 1143000"/>
                <a:gd name="connsiteX13" fmla="*/ 596900 w 1187450"/>
                <a:gd name="connsiteY13" fmla="*/ 0 h 1143000"/>
                <a:gd name="connsiteX14" fmla="*/ 539750 w 1187450"/>
                <a:gd name="connsiteY14" fmla="*/ 3175 h 1143000"/>
                <a:gd name="connsiteX15" fmla="*/ 520700 w 1187450"/>
                <a:gd name="connsiteY15" fmla="*/ 9525 h 1143000"/>
                <a:gd name="connsiteX16" fmla="*/ 511175 w 1187450"/>
                <a:gd name="connsiteY16" fmla="*/ 12700 h 1143000"/>
                <a:gd name="connsiteX17" fmla="*/ 501650 w 1187450"/>
                <a:gd name="connsiteY17" fmla="*/ 15875 h 1143000"/>
                <a:gd name="connsiteX18" fmla="*/ 482600 w 1187450"/>
                <a:gd name="connsiteY18" fmla="*/ 19050 h 1143000"/>
                <a:gd name="connsiteX19" fmla="*/ 444500 w 1187450"/>
                <a:gd name="connsiteY19" fmla="*/ 28575 h 1143000"/>
                <a:gd name="connsiteX20" fmla="*/ 431800 w 1187450"/>
                <a:gd name="connsiteY20" fmla="*/ 31750 h 1143000"/>
                <a:gd name="connsiteX21" fmla="*/ 409575 w 1187450"/>
                <a:gd name="connsiteY21" fmla="*/ 38100 h 1143000"/>
                <a:gd name="connsiteX22" fmla="*/ 381000 w 1187450"/>
                <a:gd name="connsiteY22" fmla="*/ 41275 h 1143000"/>
                <a:gd name="connsiteX23" fmla="*/ 361950 w 1187450"/>
                <a:gd name="connsiteY23" fmla="*/ 47625 h 1143000"/>
                <a:gd name="connsiteX24" fmla="*/ 352425 w 1187450"/>
                <a:gd name="connsiteY24" fmla="*/ 53975 h 1143000"/>
                <a:gd name="connsiteX25" fmla="*/ 333375 w 1187450"/>
                <a:gd name="connsiteY25" fmla="*/ 60325 h 1143000"/>
                <a:gd name="connsiteX26" fmla="*/ 311150 w 1187450"/>
                <a:gd name="connsiteY26" fmla="*/ 69850 h 1143000"/>
                <a:gd name="connsiteX27" fmla="*/ 282575 w 1187450"/>
                <a:gd name="connsiteY27" fmla="*/ 85725 h 1143000"/>
                <a:gd name="connsiteX28" fmla="*/ 276225 w 1187450"/>
                <a:gd name="connsiteY28" fmla="*/ 95250 h 1143000"/>
                <a:gd name="connsiteX29" fmla="*/ 257175 w 1187450"/>
                <a:gd name="connsiteY29" fmla="*/ 101600 h 1143000"/>
                <a:gd name="connsiteX30" fmla="*/ 250825 w 1187450"/>
                <a:gd name="connsiteY30" fmla="*/ 111125 h 1143000"/>
                <a:gd name="connsiteX31" fmla="*/ 222250 w 1187450"/>
                <a:gd name="connsiteY31" fmla="*/ 127000 h 1143000"/>
                <a:gd name="connsiteX32" fmla="*/ 193675 w 1187450"/>
                <a:gd name="connsiteY32" fmla="*/ 149225 h 1143000"/>
                <a:gd name="connsiteX33" fmla="*/ 174625 w 1187450"/>
                <a:gd name="connsiteY33" fmla="*/ 165100 h 1143000"/>
                <a:gd name="connsiteX34" fmla="*/ 146050 w 1187450"/>
                <a:gd name="connsiteY34" fmla="*/ 187325 h 1143000"/>
                <a:gd name="connsiteX35" fmla="*/ 136525 w 1187450"/>
                <a:gd name="connsiteY35" fmla="*/ 196850 h 1143000"/>
                <a:gd name="connsiteX36" fmla="*/ 127000 w 1187450"/>
                <a:gd name="connsiteY36" fmla="*/ 203200 h 1143000"/>
                <a:gd name="connsiteX37" fmla="*/ 114300 w 1187450"/>
                <a:gd name="connsiteY37" fmla="*/ 219075 h 1143000"/>
                <a:gd name="connsiteX38" fmla="*/ 101600 w 1187450"/>
                <a:gd name="connsiteY38" fmla="*/ 238125 h 1143000"/>
                <a:gd name="connsiteX39" fmla="*/ 88900 w 1187450"/>
                <a:gd name="connsiteY39" fmla="*/ 257175 h 1143000"/>
                <a:gd name="connsiteX40" fmla="*/ 76200 w 1187450"/>
                <a:gd name="connsiteY40" fmla="*/ 285750 h 1143000"/>
                <a:gd name="connsiteX41" fmla="*/ 73025 w 1187450"/>
                <a:gd name="connsiteY41" fmla="*/ 295275 h 1143000"/>
                <a:gd name="connsiteX42" fmla="*/ 60325 w 1187450"/>
                <a:gd name="connsiteY42" fmla="*/ 314325 h 1143000"/>
                <a:gd name="connsiteX43" fmla="*/ 57150 w 1187450"/>
                <a:gd name="connsiteY43" fmla="*/ 323850 h 1143000"/>
                <a:gd name="connsiteX44" fmla="*/ 50800 w 1187450"/>
                <a:gd name="connsiteY44" fmla="*/ 333375 h 1143000"/>
                <a:gd name="connsiteX45" fmla="*/ 47625 w 1187450"/>
                <a:gd name="connsiteY45" fmla="*/ 342900 h 1143000"/>
                <a:gd name="connsiteX46" fmla="*/ 28575 w 1187450"/>
                <a:gd name="connsiteY46" fmla="*/ 381000 h 1143000"/>
                <a:gd name="connsiteX47" fmla="*/ 22225 w 1187450"/>
                <a:gd name="connsiteY47" fmla="*/ 400050 h 1143000"/>
                <a:gd name="connsiteX48" fmla="*/ 19050 w 1187450"/>
                <a:gd name="connsiteY48" fmla="*/ 409575 h 1143000"/>
                <a:gd name="connsiteX49" fmla="*/ 15875 w 1187450"/>
                <a:gd name="connsiteY49" fmla="*/ 431800 h 1143000"/>
                <a:gd name="connsiteX50" fmla="*/ 12700 w 1187450"/>
                <a:gd name="connsiteY50" fmla="*/ 447675 h 1143000"/>
                <a:gd name="connsiteX51" fmla="*/ 3175 w 1187450"/>
                <a:gd name="connsiteY51" fmla="*/ 501650 h 1143000"/>
                <a:gd name="connsiteX52" fmla="*/ 0 w 1187450"/>
                <a:gd name="connsiteY52" fmla="*/ 511175 h 1143000"/>
                <a:gd name="connsiteX53" fmla="*/ 3175 w 1187450"/>
                <a:gd name="connsiteY53" fmla="*/ 552450 h 1143000"/>
                <a:gd name="connsiteX54" fmla="*/ 12700 w 1187450"/>
                <a:gd name="connsiteY54" fmla="*/ 571500 h 1143000"/>
                <a:gd name="connsiteX55" fmla="*/ 15875 w 1187450"/>
                <a:gd name="connsiteY55" fmla="*/ 581025 h 1143000"/>
                <a:gd name="connsiteX56" fmla="*/ 22225 w 1187450"/>
                <a:gd name="connsiteY56" fmla="*/ 590550 h 1143000"/>
                <a:gd name="connsiteX57" fmla="*/ 28575 w 1187450"/>
                <a:gd name="connsiteY57" fmla="*/ 609600 h 1143000"/>
                <a:gd name="connsiteX58" fmla="*/ 34925 w 1187450"/>
                <a:gd name="connsiteY58" fmla="*/ 628650 h 1143000"/>
                <a:gd name="connsiteX59" fmla="*/ 44450 w 1187450"/>
                <a:gd name="connsiteY59" fmla="*/ 638175 h 1143000"/>
                <a:gd name="connsiteX60" fmla="*/ 50800 w 1187450"/>
                <a:gd name="connsiteY60" fmla="*/ 657225 h 1143000"/>
                <a:gd name="connsiteX61" fmla="*/ 69850 w 1187450"/>
                <a:gd name="connsiteY61" fmla="*/ 685800 h 1143000"/>
                <a:gd name="connsiteX62" fmla="*/ 76200 w 1187450"/>
                <a:gd name="connsiteY62" fmla="*/ 704850 h 1143000"/>
                <a:gd name="connsiteX63" fmla="*/ 79375 w 1187450"/>
                <a:gd name="connsiteY63" fmla="*/ 717550 h 1143000"/>
                <a:gd name="connsiteX64" fmla="*/ 82550 w 1187450"/>
                <a:gd name="connsiteY64" fmla="*/ 727075 h 1143000"/>
                <a:gd name="connsiteX65" fmla="*/ 88900 w 1187450"/>
                <a:gd name="connsiteY65" fmla="*/ 765175 h 1143000"/>
                <a:gd name="connsiteX66" fmla="*/ 92075 w 1187450"/>
                <a:gd name="connsiteY66" fmla="*/ 825500 h 1143000"/>
                <a:gd name="connsiteX67" fmla="*/ 95250 w 1187450"/>
                <a:gd name="connsiteY67" fmla="*/ 838200 h 1143000"/>
                <a:gd name="connsiteX68" fmla="*/ 101600 w 1187450"/>
                <a:gd name="connsiteY68" fmla="*/ 869950 h 1143000"/>
                <a:gd name="connsiteX69" fmla="*/ 120650 w 1187450"/>
                <a:gd name="connsiteY69" fmla="*/ 908050 h 1143000"/>
                <a:gd name="connsiteX70" fmla="*/ 123825 w 1187450"/>
                <a:gd name="connsiteY70" fmla="*/ 917575 h 1143000"/>
                <a:gd name="connsiteX71" fmla="*/ 139700 w 1187450"/>
                <a:gd name="connsiteY71" fmla="*/ 936625 h 1143000"/>
                <a:gd name="connsiteX72" fmla="*/ 152400 w 1187450"/>
                <a:gd name="connsiteY72" fmla="*/ 965200 h 1143000"/>
                <a:gd name="connsiteX73" fmla="*/ 171450 w 1187450"/>
                <a:gd name="connsiteY73" fmla="*/ 977900 h 1143000"/>
                <a:gd name="connsiteX74" fmla="*/ 193675 w 1187450"/>
                <a:gd name="connsiteY74" fmla="*/ 1003300 h 1143000"/>
                <a:gd name="connsiteX75" fmla="*/ 200025 w 1187450"/>
                <a:gd name="connsiteY75" fmla="*/ 1012825 h 1143000"/>
                <a:gd name="connsiteX76" fmla="*/ 209550 w 1187450"/>
                <a:gd name="connsiteY76" fmla="*/ 1019175 h 1143000"/>
                <a:gd name="connsiteX77" fmla="*/ 241300 w 1187450"/>
                <a:gd name="connsiteY77" fmla="*/ 1041400 h 1143000"/>
                <a:gd name="connsiteX78" fmla="*/ 260350 w 1187450"/>
                <a:gd name="connsiteY78" fmla="*/ 1054100 h 1143000"/>
                <a:gd name="connsiteX79" fmla="*/ 276225 w 1187450"/>
                <a:gd name="connsiteY79" fmla="*/ 1063625 h 1143000"/>
                <a:gd name="connsiteX80" fmla="*/ 295275 w 1187450"/>
                <a:gd name="connsiteY80" fmla="*/ 1073150 h 1143000"/>
                <a:gd name="connsiteX81" fmla="*/ 323850 w 1187450"/>
                <a:gd name="connsiteY81" fmla="*/ 1085850 h 1143000"/>
                <a:gd name="connsiteX82" fmla="*/ 352425 w 1187450"/>
                <a:gd name="connsiteY82" fmla="*/ 1095375 h 1143000"/>
                <a:gd name="connsiteX83" fmla="*/ 371475 w 1187450"/>
                <a:gd name="connsiteY83" fmla="*/ 1098550 h 1143000"/>
                <a:gd name="connsiteX84" fmla="*/ 384175 w 1187450"/>
                <a:gd name="connsiteY84" fmla="*/ 1101725 h 1143000"/>
                <a:gd name="connsiteX85" fmla="*/ 403225 w 1187450"/>
                <a:gd name="connsiteY85" fmla="*/ 1111250 h 1143000"/>
                <a:gd name="connsiteX86" fmla="*/ 412750 w 1187450"/>
                <a:gd name="connsiteY86" fmla="*/ 1117600 h 1143000"/>
                <a:gd name="connsiteX87" fmla="*/ 431800 w 1187450"/>
                <a:gd name="connsiteY87" fmla="*/ 1123950 h 1143000"/>
                <a:gd name="connsiteX88" fmla="*/ 441325 w 1187450"/>
                <a:gd name="connsiteY88" fmla="*/ 1127125 h 1143000"/>
                <a:gd name="connsiteX89" fmla="*/ 450850 w 1187450"/>
                <a:gd name="connsiteY89" fmla="*/ 1133475 h 1143000"/>
                <a:gd name="connsiteX90" fmla="*/ 463550 w 1187450"/>
                <a:gd name="connsiteY90" fmla="*/ 1136650 h 1143000"/>
                <a:gd name="connsiteX91" fmla="*/ 495300 w 1187450"/>
                <a:gd name="connsiteY91" fmla="*/ 1143000 h 1143000"/>
                <a:gd name="connsiteX92" fmla="*/ 619125 w 1187450"/>
                <a:gd name="connsiteY92" fmla="*/ 1139825 h 1143000"/>
                <a:gd name="connsiteX93" fmla="*/ 660400 w 1187450"/>
                <a:gd name="connsiteY93" fmla="*/ 1130300 h 1143000"/>
                <a:gd name="connsiteX94" fmla="*/ 673100 w 1187450"/>
                <a:gd name="connsiteY94" fmla="*/ 1127125 h 1143000"/>
                <a:gd name="connsiteX95" fmla="*/ 682625 w 1187450"/>
                <a:gd name="connsiteY95" fmla="*/ 1123950 h 1143000"/>
                <a:gd name="connsiteX96" fmla="*/ 704850 w 1187450"/>
                <a:gd name="connsiteY96" fmla="*/ 1117600 h 1143000"/>
                <a:gd name="connsiteX97" fmla="*/ 723900 w 1187450"/>
                <a:gd name="connsiteY97" fmla="*/ 1108075 h 1143000"/>
                <a:gd name="connsiteX98" fmla="*/ 746125 w 1187450"/>
                <a:gd name="connsiteY98" fmla="*/ 1098550 h 1143000"/>
                <a:gd name="connsiteX99" fmla="*/ 774700 w 1187450"/>
                <a:gd name="connsiteY99" fmla="*/ 1085850 h 1143000"/>
                <a:gd name="connsiteX100" fmla="*/ 796925 w 1187450"/>
                <a:gd name="connsiteY100" fmla="*/ 1073150 h 1143000"/>
                <a:gd name="connsiteX101" fmla="*/ 806450 w 1187450"/>
                <a:gd name="connsiteY101" fmla="*/ 1069975 h 1143000"/>
                <a:gd name="connsiteX102" fmla="*/ 815975 w 1187450"/>
                <a:gd name="connsiteY102" fmla="*/ 1063625 h 1143000"/>
                <a:gd name="connsiteX103" fmla="*/ 825500 w 1187450"/>
                <a:gd name="connsiteY103" fmla="*/ 1054100 h 1143000"/>
                <a:gd name="connsiteX104" fmla="*/ 835025 w 1187450"/>
                <a:gd name="connsiteY104" fmla="*/ 1050925 h 1143000"/>
                <a:gd name="connsiteX105" fmla="*/ 854075 w 1187450"/>
                <a:gd name="connsiteY105" fmla="*/ 1041400 h 1143000"/>
                <a:gd name="connsiteX106" fmla="*/ 863600 w 1187450"/>
                <a:gd name="connsiteY106" fmla="*/ 1035050 h 1143000"/>
                <a:gd name="connsiteX107" fmla="*/ 882650 w 1187450"/>
                <a:gd name="connsiteY107" fmla="*/ 1028700 h 1143000"/>
                <a:gd name="connsiteX108" fmla="*/ 901700 w 1187450"/>
                <a:gd name="connsiteY108" fmla="*/ 1019175 h 1143000"/>
                <a:gd name="connsiteX109" fmla="*/ 911225 w 1187450"/>
                <a:gd name="connsiteY109" fmla="*/ 1012825 h 1143000"/>
                <a:gd name="connsiteX110" fmla="*/ 930275 w 1187450"/>
                <a:gd name="connsiteY110" fmla="*/ 1006475 h 1143000"/>
                <a:gd name="connsiteX111" fmla="*/ 958850 w 1187450"/>
                <a:gd name="connsiteY111" fmla="*/ 987425 h 1143000"/>
                <a:gd name="connsiteX112" fmla="*/ 968375 w 1187450"/>
                <a:gd name="connsiteY112" fmla="*/ 984250 h 1143000"/>
                <a:gd name="connsiteX113" fmla="*/ 977900 w 1187450"/>
                <a:gd name="connsiteY113" fmla="*/ 974725 h 1143000"/>
                <a:gd name="connsiteX114" fmla="*/ 996950 w 1187450"/>
                <a:gd name="connsiteY114" fmla="*/ 962025 h 1143000"/>
                <a:gd name="connsiteX115" fmla="*/ 1012825 w 1187450"/>
                <a:gd name="connsiteY115" fmla="*/ 949325 h 1143000"/>
                <a:gd name="connsiteX116" fmla="*/ 1041400 w 1187450"/>
                <a:gd name="connsiteY116" fmla="*/ 930275 h 1143000"/>
                <a:gd name="connsiteX117" fmla="*/ 1054100 w 1187450"/>
                <a:gd name="connsiteY117" fmla="*/ 920750 h 1143000"/>
                <a:gd name="connsiteX118" fmla="*/ 1063625 w 1187450"/>
                <a:gd name="connsiteY118" fmla="*/ 917575 h 1143000"/>
                <a:gd name="connsiteX119" fmla="*/ 1076325 w 1187450"/>
                <a:gd name="connsiteY119" fmla="*/ 889000 h 1143000"/>
                <a:gd name="connsiteX120" fmla="*/ 1085850 w 1187450"/>
                <a:gd name="connsiteY120" fmla="*/ 879475 h 1143000"/>
                <a:gd name="connsiteX121" fmla="*/ 1104900 w 1187450"/>
                <a:gd name="connsiteY121" fmla="*/ 866775 h 1143000"/>
                <a:gd name="connsiteX122" fmla="*/ 1111250 w 1187450"/>
                <a:gd name="connsiteY122" fmla="*/ 857250 h 1143000"/>
                <a:gd name="connsiteX123" fmla="*/ 1130300 w 1187450"/>
                <a:gd name="connsiteY123" fmla="*/ 838200 h 1143000"/>
                <a:gd name="connsiteX124" fmla="*/ 1143000 w 1187450"/>
                <a:gd name="connsiteY124" fmla="*/ 819150 h 1143000"/>
                <a:gd name="connsiteX125" fmla="*/ 1146175 w 1187450"/>
                <a:gd name="connsiteY125" fmla="*/ 809625 h 1143000"/>
                <a:gd name="connsiteX126" fmla="*/ 1152525 w 1187450"/>
                <a:gd name="connsiteY126" fmla="*/ 800100 h 1143000"/>
                <a:gd name="connsiteX127" fmla="*/ 1158875 w 1187450"/>
                <a:gd name="connsiteY127" fmla="*/ 781050 h 1143000"/>
                <a:gd name="connsiteX128" fmla="*/ 1162050 w 1187450"/>
                <a:gd name="connsiteY128" fmla="*/ 771525 h 1143000"/>
                <a:gd name="connsiteX129" fmla="*/ 1171575 w 1187450"/>
                <a:gd name="connsiteY129" fmla="*/ 765175 h 1143000"/>
                <a:gd name="connsiteX130" fmla="*/ 1181100 w 1187450"/>
                <a:gd name="connsiteY130" fmla="*/ 736600 h 1143000"/>
                <a:gd name="connsiteX131" fmla="*/ 1184275 w 1187450"/>
                <a:gd name="connsiteY131" fmla="*/ 727075 h 1143000"/>
                <a:gd name="connsiteX132" fmla="*/ 1187450 w 1187450"/>
                <a:gd name="connsiteY132" fmla="*/ 717550 h 1143000"/>
                <a:gd name="connsiteX133" fmla="*/ 1184275 w 1187450"/>
                <a:gd name="connsiteY133" fmla="*/ 701675 h 1143000"/>
                <a:gd name="connsiteX134" fmla="*/ 1174750 w 1187450"/>
                <a:gd name="connsiteY134" fmla="*/ 673100 h 1143000"/>
                <a:gd name="connsiteX135" fmla="*/ 1171575 w 1187450"/>
                <a:gd name="connsiteY135" fmla="*/ 663575 h 1143000"/>
                <a:gd name="connsiteX136" fmla="*/ 1168400 w 1187450"/>
                <a:gd name="connsiteY136" fmla="*/ 654050 h 1143000"/>
                <a:gd name="connsiteX137" fmla="*/ 1165225 w 1187450"/>
                <a:gd name="connsiteY137" fmla="*/ 574675 h 1143000"/>
                <a:gd name="connsiteX138" fmla="*/ 1158875 w 1187450"/>
                <a:gd name="connsiteY138" fmla="*/ 555625 h 1143000"/>
                <a:gd name="connsiteX139" fmla="*/ 1143000 w 1187450"/>
                <a:gd name="connsiteY139" fmla="*/ 527050 h 1143000"/>
                <a:gd name="connsiteX140" fmla="*/ 1136650 w 1187450"/>
                <a:gd name="connsiteY140" fmla="*/ 517525 h 1143000"/>
                <a:gd name="connsiteX141" fmla="*/ 1133475 w 1187450"/>
                <a:gd name="connsiteY141" fmla="*/ 508000 h 1143000"/>
                <a:gd name="connsiteX142" fmla="*/ 1117600 w 1187450"/>
                <a:gd name="connsiteY142" fmla="*/ 479425 h 1143000"/>
                <a:gd name="connsiteX143" fmla="*/ 1114425 w 1187450"/>
                <a:gd name="connsiteY143" fmla="*/ 466725 h 1143000"/>
                <a:gd name="connsiteX144" fmla="*/ 1111250 w 1187450"/>
                <a:gd name="connsiteY144" fmla="*/ 450850 h 1143000"/>
                <a:gd name="connsiteX145" fmla="*/ 1104900 w 1187450"/>
                <a:gd name="connsiteY145" fmla="*/ 431800 h 1143000"/>
                <a:gd name="connsiteX146" fmla="*/ 1092200 w 1187450"/>
                <a:gd name="connsiteY146" fmla="*/ 393700 h 1143000"/>
                <a:gd name="connsiteX147" fmla="*/ 1085850 w 1187450"/>
                <a:gd name="connsiteY147" fmla="*/ 384175 h 1143000"/>
                <a:gd name="connsiteX148" fmla="*/ 1079500 w 1187450"/>
                <a:gd name="connsiteY148" fmla="*/ 365125 h 1143000"/>
                <a:gd name="connsiteX149" fmla="*/ 1066800 w 1187450"/>
                <a:gd name="connsiteY149" fmla="*/ 327025 h 1143000"/>
                <a:gd name="connsiteX150" fmla="*/ 1060450 w 1187450"/>
                <a:gd name="connsiteY150" fmla="*/ 317500 h 1143000"/>
                <a:gd name="connsiteX151" fmla="*/ 1047750 w 1187450"/>
                <a:gd name="connsiteY151" fmla="*/ 288925 h 1143000"/>
                <a:gd name="connsiteX152" fmla="*/ 1044575 w 1187450"/>
                <a:gd name="connsiteY152" fmla="*/ 276225 h 1143000"/>
                <a:gd name="connsiteX153" fmla="*/ 1028700 w 1187450"/>
                <a:gd name="connsiteY153" fmla="*/ 257175 h 1143000"/>
                <a:gd name="connsiteX154" fmla="*/ 1016000 w 1187450"/>
                <a:gd name="connsiteY154" fmla="*/ 238125 h 1143000"/>
                <a:gd name="connsiteX155" fmla="*/ 1006475 w 1187450"/>
                <a:gd name="connsiteY155" fmla="*/ 231775 h 1143000"/>
                <a:gd name="connsiteX156" fmla="*/ 987425 w 1187450"/>
                <a:gd name="connsiteY156" fmla="*/ 215900 h 1143000"/>
                <a:gd name="connsiteX157" fmla="*/ 977900 w 1187450"/>
                <a:gd name="connsiteY157" fmla="*/ 212725 h 1143000"/>
                <a:gd name="connsiteX158" fmla="*/ 958850 w 1187450"/>
                <a:gd name="connsiteY158" fmla="*/ 200025 h 1143000"/>
                <a:gd name="connsiteX159" fmla="*/ 942975 w 1187450"/>
                <a:gd name="connsiteY159" fmla="*/ 171450 h 1143000"/>
                <a:gd name="connsiteX160" fmla="*/ 930275 w 1187450"/>
                <a:gd name="connsiteY160" fmla="*/ 152400 h 1143000"/>
                <a:gd name="connsiteX161" fmla="*/ 920750 w 1187450"/>
                <a:gd name="connsiteY161" fmla="*/ 146050 h 1143000"/>
                <a:gd name="connsiteX162" fmla="*/ 917575 w 1187450"/>
                <a:gd name="connsiteY162" fmla="*/ 136525 h 1143000"/>
                <a:gd name="connsiteX163" fmla="*/ 885825 w 1187450"/>
                <a:gd name="connsiteY163" fmla="*/ 120650 h 1143000"/>
                <a:gd name="connsiteX164" fmla="*/ 876300 w 1187450"/>
                <a:gd name="connsiteY164" fmla="*/ 117475 h 1143000"/>
                <a:gd name="connsiteX165" fmla="*/ 857250 w 1187450"/>
                <a:gd name="connsiteY165" fmla="*/ 117475 h 1143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</a:cxnLst>
              <a:rect l="l" t="t" r="r" b="b"/>
              <a:pathLst>
                <a:path w="1187450" h="1143000">
                  <a:moveTo>
                    <a:pt x="857250" y="117475"/>
                  </a:moveTo>
                  <a:cubicBezTo>
                    <a:pt x="851429" y="115887"/>
                    <a:pt x="846993" y="110504"/>
                    <a:pt x="841375" y="107950"/>
                  </a:cubicBezTo>
                  <a:cubicBezTo>
                    <a:pt x="815511" y="96194"/>
                    <a:pt x="796838" y="100184"/>
                    <a:pt x="765175" y="98425"/>
                  </a:cubicBezTo>
                  <a:cubicBezTo>
                    <a:pt x="762000" y="97367"/>
                    <a:pt x="758576" y="96875"/>
                    <a:pt x="755650" y="95250"/>
                  </a:cubicBezTo>
                  <a:cubicBezTo>
                    <a:pt x="748979" y="91544"/>
                    <a:pt x="736600" y="82550"/>
                    <a:pt x="736600" y="82550"/>
                  </a:cubicBezTo>
                  <a:cubicBezTo>
                    <a:pt x="724867" y="64951"/>
                    <a:pt x="736963" y="78871"/>
                    <a:pt x="720725" y="69850"/>
                  </a:cubicBezTo>
                  <a:cubicBezTo>
                    <a:pt x="714054" y="66144"/>
                    <a:pt x="701675" y="57150"/>
                    <a:pt x="701675" y="57150"/>
                  </a:cubicBezTo>
                  <a:cubicBezTo>
                    <a:pt x="699558" y="53975"/>
                    <a:pt x="698023" y="50323"/>
                    <a:pt x="695325" y="47625"/>
                  </a:cubicBezTo>
                  <a:cubicBezTo>
                    <a:pt x="689170" y="41470"/>
                    <a:pt x="684022" y="40682"/>
                    <a:pt x="676275" y="38100"/>
                  </a:cubicBezTo>
                  <a:cubicBezTo>
                    <a:pt x="670293" y="32118"/>
                    <a:pt x="665182" y="25761"/>
                    <a:pt x="657225" y="22225"/>
                  </a:cubicBezTo>
                  <a:cubicBezTo>
                    <a:pt x="651108" y="19507"/>
                    <a:pt x="644525" y="17992"/>
                    <a:pt x="638175" y="15875"/>
                  </a:cubicBezTo>
                  <a:lnTo>
                    <a:pt x="628650" y="12700"/>
                  </a:lnTo>
                  <a:cubicBezTo>
                    <a:pt x="625475" y="10583"/>
                    <a:pt x="622538" y="8057"/>
                    <a:pt x="619125" y="6350"/>
                  </a:cubicBezTo>
                  <a:cubicBezTo>
                    <a:pt x="614570" y="4073"/>
                    <a:pt x="600969" y="1017"/>
                    <a:pt x="596900" y="0"/>
                  </a:cubicBezTo>
                  <a:cubicBezTo>
                    <a:pt x="577850" y="1058"/>
                    <a:pt x="558682" y="808"/>
                    <a:pt x="539750" y="3175"/>
                  </a:cubicBezTo>
                  <a:cubicBezTo>
                    <a:pt x="533108" y="4005"/>
                    <a:pt x="527050" y="7408"/>
                    <a:pt x="520700" y="9525"/>
                  </a:cubicBezTo>
                  <a:lnTo>
                    <a:pt x="511175" y="12700"/>
                  </a:lnTo>
                  <a:cubicBezTo>
                    <a:pt x="508000" y="13758"/>
                    <a:pt x="504951" y="15325"/>
                    <a:pt x="501650" y="15875"/>
                  </a:cubicBezTo>
                  <a:lnTo>
                    <a:pt x="482600" y="19050"/>
                  </a:lnTo>
                  <a:cubicBezTo>
                    <a:pt x="450775" y="29658"/>
                    <a:pt x="476566" y="22162"/>
                    <a:pt x="444500" y="28575"/>
                  </a:cubicBezTo>
                  <a:cubicBezTo>
                    <a:pt x="440221" y="29431"/>
                    <a:pt x="435996" y="30551"/>
                    <a:pt x="431800" y="31750"/>
                  </a:cubicBezTo>
                  <a:cubicBezTo>
                    <a:pt x="422119" y="34516"/>
                    <a:pt x="420328" y="36446"/>
                    <a:pt x="409575" y="38100"/>
                  </a:cubicBezTo>
                  <a:cubicBezTo>
                    <a:pt x="400103" y="39557"/>
                    <a:pt x="390525" y="40217"/>
                    <a:pt x="381000" y="41275"/>
                  </a:cubicBezTo>
                  <a:cubicBezTo>
                    <a:pt x="374650" y="43392"/>
                    <a:pt x="367519" y="43912"/>
                    <a:pt x="361950" y="47625"/>
                  </a:cubicBezTo>
                  <a:cubicBezTo>
                    <a:pt x="358775" y="49742"/>
                    <a:pt x="355912" y="52425"/>
                    <a:pt x="352425" y="53975"/>
                  </a:cubicBezTo>
                  <a:cubicBezTo>
                    <a:pt x="346308" y="56693"/>
                    <a:pt x="333375" y="60325"/>
                    <a:pt x="333375" y="60325"/>
                  </a:cubicBezTo>
                  <a:cubicBezTo>
                    <a:pt x="298705" y="83439"/>
                    <a:pt x="352155" y="49348"/>
                    <a:pt x="311150" y="69850"/>
                  </a:cubicBezTo>
                  <a:cubicBezTo>
                    <a:pt x="267481" y="91685"/>
                    <a:pt x="308915" y="76945"/>
                    <a:pt x="282575" y="85725"/>
                  </a:cubicBezTo>
                  <a:cubicBezTo>
                    <a:pt x="280458" y="88900"/>
                    <a:pt x="279461" y="93228"/>
                    <a:pt x="276225" y="95250"/>
                  </a:cubicBezTo>
                  <a:cubicBezTo>
                    <a:pt x="270549" y="98798"/>
                    <a:pt x="257175" y="101600"/>
                    <a:pt x="257175" y="101600"/>
                  </a:cubicBezTo>
                  <a:cubicBezTo>
                    <a:pt x="255058" y="104775"/>
                    <a:pt x="253697" y="108612"/>
                    <a:pt x="250825" y="111125"/>
                  </a:cubicBezTo>
                  <a:cubicBezTo>
                    <a:pt x="237388" y="122882"/>
                    <a:pt x="235332" y="122639"/>
                    <a:pt x="222250" y="127000"/>
                  </a:cubicBezTo>
                  <a:cubicBezTo>
                    <a:pt x="200833" y="148417"/>
                    <a:pt x="211719" y="143210"/>
                    <a:pt x="193675" y="149225"/>
                  </a:cubicBezTo>
                  <a:cubicBezTo>
                    <a:pt x="165848" y="177052"/>
                    <a:pt x="201147" y="142998"/>
                    <a:pt x="174625" y="165100"/>
                  </a:cubicBezTo>
                  <a:cubicBezTo>
                    <a:pt x="144782" y="189969"/>
                    <a:pt x="194198" y="155227"/>
                    <a:pt x="146050" y="187325"/>
                  </a:cubicBezTo>
                  <a:cubicBezTo>
                    <a:pt x="142314" y="189816"/>
                    <a:pt x="139974" y="193975"/>
                    <a:pt x="136525" y="196850"/>
                  </a:cubicBezTo>
                  <a:cubicBezTo>
                    <a:pt x="133594" y="199293"/>
                    <a:pt x="130175" y="201083"/>
                    <a:pt x="127000" y="203200"/>
                  </a:cubicBezTo>
                  <a:cubicBezTo>
                    <a:pt x="119850" y="224650"/>
                    <a:pt x="129766" y="201400"/>
                    <a:pt x="114300" y="219075"/>
                  </a:cubicBezTo>
                  <a:cubicBezTo>
                    <a:pt x="109274" y="224818"/>
                    <a:pt x="105833" y="231775"/>
                    <a:pt x="101600" y="238125"/>
                  </a:cubicBezTo>
                  <a:lnTo>
                    <a:pt x="88900" y="257175"/>
                  </a:lnTo>
                  <a:cubicBezTo>
                    <a:pt x="78837" y="272269"/>
                    <a:pt x="83757" y="263080"/>
                    <a:pt x="76200" y="285750"/>
                  </a:cubicBezTo>
                  <a:cubicBezTo>
                    <a:pt x="75142" y="288925"/>
                    <a:pt x="74881" y="292490"/>
                    <a:pt x="73025" y="295275"/>
                  </a:cubicBezTo>
                  <a:cubicBezTo>
                    <a:pt x="68792" y="301625"/>
                    <a:pt x="62738" y="307085"/>
                    <a:pt x="60325" y="314325"/>
                  </a:cubicBezTo>
                  <a:cubicBezTo>
                    <a:pt x="59267" y="317500"/>
                    <a:pt x="58647" y="320857"/>
                    <a:pt x="57150" y="323850"/>
                  </a:cubicBezTo>
                  <a:cubicBezTo>
                    <a:pt x="55443" y="327263"/>
                    <a:pt x="52507" y="329962"/>
                    <a:pt x="50800" y="333375"/>
                  </a:cubicBezTo>
                  <a:cubicBezTo>
                    <a:pt x="49303" y="336368"/>
                    <a:pt x="49250" y="339974"/>
                    <a:pt x="47625" y="342900"/>
                  </a:cubicBezTo>
                  <a:cubicBezTo>
                    <a:pt x="27109" y="379829"/>
                    <a:pt x="40937" y="343914"/>
                    <a:pt x="28575" y="381000"/>
                  </a:cubicBezTo>
                  <a:lnTo>
                    <a:pt x="22225" y="400050"/>
                  </a:lnTo>
                  <a:lnTo>
                    <a:pt x="19050" y="409575"/>
                  </a:lnTo>
                  <a:cubicBezTo>
                    <a:pt x="17992" y="416983"/>
                    <a:pt x="17105" y="424418"/>
                    <a:pt x="15875" y="431800"/>
                  </a:cubicBezTo>
                  <a:cubicBezTo>
                    <a:pt x="14988" y="437123"/>
                    <a:pt x="13587" y="442352"/>
                    <a:pt x="12700" y="447675"/>
                  </a:cubicBezTo>
                  <a:cubicBezTo>
                    <a:pt x="10045" y="463604"/>
                    <a:pt x="8041" y="487052"/>
                    <a:pt x="3175" y="501650"/>
                  </a:cubicBezTo>
                  <a:lnTo>
                    <a:pt x="0" y="511175"/>
                  </a:lnTo>
                  <a:cubicBezTo>
                    <a:pt x="1058" y="524933"/>
                    <a:pt x="1463" y="538758"/>
                    <a:pt x="3175" y="552450"/>
                  </a:cubicBezTo>
                  <a:cubicBezTo>
                    <a:pt x="4505" y="563091"/>
                    <a:pt x="7973" y="562046"/>
                    <a:pt x="12700" y="571500"/>
                  </a:cubicBezTo>
                  <a:cubicBezTo>
                    <a:pt x="14197" y="574493"/>
                    <a:pt x="14378" y="578032"/>
                    <a:pt x="15875" y="581025"/>
                  </a:cubicBezTo>
                  <a:cubicBezTo>
                    <a:pt x="17582" y="584438"/>
                    <a:pt x="20675" y="587063"/>
                    <a:pt x="22225" y="590550"/>
                  </a:cubicBezTo>
                  <a:cubicBezTo>
                    <a:pt x="24943" y="596667"/>
                    <a:pt x="26458" y="603250"/>
                    <a:pt x="28575" y="609600"/>
                  </a:cubicBezTo>
                  <a:lnTo>
                    <a:pt x="34925" y="628650"/>
                  </a:lnTo>
                  <a:cubicBezTo>
                    <a:pt x="36345" y="632910"/>
                    <a:pt x="41275" y="635000"/>
                    <a:pt x="44450" y="638175"/>
                  </a:cubicBezTo>
                  <a:lnTo>
                    <a:pt x="50800" y="657225"/>
                  </a:lnTo>
                  <a:lnTo>
                    <a:pt x="69850" y="685800"/>
                  </a:lnTo>
                  <a:cubicBezTo>
                    <a:pt x="73563" y="691369"/>
                    <a:pt x="74083" y="698500"/>
                    <a:pt x="76200" y="704850"/>
                  </a:cubicBezTo>
                  <a:cubicBezTo>
                    <a:pt x="77580" y="708990"/>
                    <a:pt x="78176" y="713354"/>
                    <a:pt x="79375" y="717550"/>
                  </a:cubicBezTo>
                  <a:cubicBezTo>
                    <a:pt x="80294" y="720768"/>
                    <a:pt x="81738" y="723828"/>
                    <a:pt x="82550" y="727075"/>
                  </a:cubicBezTo>
                  <a:cubicBezTo>
                    <a:pt x="85645" y="739455"/>
                    <a:pt x="87108" y="752630"/>
                    <a:pt x="88900" y="765175"/>
                  </a:cubicBezTo>
                  <a:cubicBezTo>
                    <a:pt x="89958" y="785283"/>
                    <a:pt x="90331" y="805440"/>
                    <a:pt x="92075" y="825500"/>
                  </a:cubicBezTo>
                  <a:cubicBezTo>
                    <a:pt x="92453" y="829847"/>
                    <a:pt x="94336" y="833933"/>
                    <a:pt x="95250" y="838200"/>
                  </a:cubicBezTo>
                  <a:cubicBezTo>
                    <a:pt x="97511" y="848753"/>
                    <a:pt x="99483" y="859367"/>
                    <a:pt x="101600" y="869950"/>
                  </a:cubicBezTo>
                  <a:cubicBezTo>
                    <a:pt x="112396" y="923931"/>
                    <a:pt x="101919" y="851858"/>
                    <a:pt x="120650" y="908050"/>
                  </a:cubicBezTo>
                  <a:cubicBezTo>
                    <a:pt x="121708" y="911225"/>
                    <a:pt x="122328" y="914582"/>
                    <a:pt x="123825" y="917575"/>
                  </a:cubicBezTo>
                  <a:cubicBezTo>
                    <a:pt x="128245" y="926416"/>
                    <a:pt x="132678" y="929603"/>
                    <a:pt x="139700" y="936625"/>
                  </a:cubicBezTo>
                  <a:cubicBezTo>
                    <a:pt x="142065" y="943720"/>
                    <a:pt x="145297" y="958985"/>
                    <a:pt x="152400" y="965200"/>
                  </a:cubicBezTo>
                  <a:cubicBezTo>
                    <a:pt x="158143" y="970226"/>
                    <a:pt x="171450" y="977900"/>
                    <a:pt x="171450" y="977900"/>
                  </a:cubicBezTo>
                  <a:cubicBezTo>
                    <a:pt x="186267" y="1000125"/>
                    <a:pt x="177800" y="992717"/>
                    <a:pt x="193675" y="1003300"/>
                  </a:cubicBezTo>
                  <a:cubicBezTo>
                    <a:pt x="195792" y="1006475"/>
                    <a:pt x="197327" y="1010127"/>
                    <a:pt x="200025" y="1012825"/>
                  </a:cubicBezTo>
                  <a:cubicBezTo>
                    <a:pt x="202723" y="1015523"/>
                    <a:pt x="206445" y="1016957"/>
                    <a:pt x="209550" y="1019175"/>
                  </a:cubicBezTo>
                  <a:cubicBezTo>
                    <a:pt x="242459" y="1042682"/>
                    <a:pt x="197506" y="1012204"/>
                    <a:pt x="241300" y="1041400"/>
                  </a:cubicBezTo>
                  <a:cubicBezTo>
                    <a:pt x="247650" y="1045633"/>
                    <a:pt x="253878" y="1050055"/>
                    <a:pt x="260350" y="1054100"/>
                  </a:cubicBezTo>
                  <a:cubicBezTo>
                    <a:pt x="265583" y="1057371"/>
                    <a:pt x="271090" y="1060202"/>
                    <a:pt x="276225" y="1063625"/>
                  </a:cubicBezTo>
                  <a:cubicBezTo>
                    <a:pt x="288535" y="1071831"/>
                    <a:pt x="282130" y="1068768"/>
                    <a:pt x="295275" y="1073150"/>
                  </a:cubicBezTo>
                  <a:cubicBezTo>
                    <a:pt x="310369" y="1083213"/>
                    <a:pt x="301180" y="1078293"/>
                    <a:pt x="323850" y="1085850"/>
                  </a:cubicBezTo>
                  <a:lnTo>
                    <a:pt x="352425" y="1095375"/>
                  </a:lnTo>
                  <a:cubicBezTo>
                    <a:pt x="358532" y="1097411"/>
                    <a:pt x="365162" y="1097287"/>
                    <a:pt x="371475" y="1098550"/>
                  </a:cubicBezTo>
                  <a:cubicBezTo>
                    <a:pt x="375754" y="1099406"/>
                    <a:pt x="379942" y="1100667"/>
                    <a:pt x="384175" y="1101725"/>
                  </a:cubicBezTo>
                  <a:cubicBezTo>
                    <a:pt x="411472" y="1119923"/>
                    <a:pt x="376935" y="1098105"/>
                    <a:pt x="403225" y="1111250"/>
                  </a:cubicBezTo>
                  <a:cubicBezTo>
                    <a:pt x="406638" y="1112957"/>
                    <a:pt x="409263" y="1116050"/>
                    <a:pt x="412750" y="1117600"/>
                  </a:cubicBezTo>
                  <a:cubicBezTo>
                    <a:pt x="418867" y="1120318"/>
                    <a:pt x="425450" y="1121833"/>
                    <a:pt x="431800" y="1123950"/>
                  </a:cubicBezTo>
                  <a:lnTo>
                    <a:pt x="441325" y="1127125"/>
                  </a:lnTo>
                  <a:cubicBezTo>
                    <a:pt x="444500" y="1129242"/>
                    <a:pt x="447343" y="1131972"/>
                    <a:pt x="450850" y="1133475"/>
                  </a:cubicBezTo>
                  <a:cubicBezTo>
                    <a:pt x="454861" y="1135194"/>
                    <a:pt x="459271" y="1135794"/>
                    <a:pt x="463550" y="1136650"/>
                  </a:cubicBezTo>
                  <a:cubicBezTo>
                    <a:pt x="502474" y="1144435"/>
                    <a:pt x="465801" y="1135625"/>
                    <a:pt x="495300" y="1143000"/>
                  </a:cubicBezTo>
                  <a:cubicBezTo>
                    <a:pt x="536575" y="1141942"/>
                    <a:pt x="577914" y="1142348"/>
                    <a:pt x="619125" y="1139825"/>
                  </a:cubicBezTo>
                  <a:cubicBezTo>
                    <a:pt x="646021" y="1138178"/>
                    <a:pt x="643159" y="1135226"/>
                    <a:pt x="660400" y="1130300"/>
                  </a:cubicBezTo>
                  <a:cubicBezTo>
                    <a:pt x="664596" y="1129101"/>
                    <a:pt x="668904" y="1128324"/>
                    <a:pt x="673100" y="1127125"/>
                  </a:cubicBezTo>
                  <a:cubicBezTo>
                    <a:pt x="676318" y="1126206"/>
                    <a:pt x="679407" y="1124869"/>
                    <a:pt x="682625" y="1123950"/>
                  </a:cubicBezTo>
                  <a:cubicBezTo>
                    <a:pt x="710532" y="1115977"/>
                    <a:pt x="682012" y="1125213"/>
                    <a:pt x="704850" y="1117600"/>
                  </a:cubicBezTo>
                  <a:cubicBezTo>
                    <a:pt x="732147" y="1099402"/>
                    <a:pt x="697610" y="1121220"/>
                    <a:pt x="723900" y="1108075"/>
                  </a:cubicBezTo>
                  <a:cubicBezTo>
                    <a:pt x="745826" y="1097112"/>
                    <a:pt x="719694" y="1105158"/>
                    <a:pt x="746125" y="1098550"/>
                  </a:cubicBezTo>
                  <a:cubicBezTo>
                    <a:pt x="761219" y="1088487"/>
                    <a:pt x="752030" y="1093407"/>
                    <a:pt x="774700" y="1085850"/>
                  </a:cubicBezTo>
                  <a:cubicBezTo>
                    <a:pt x="791399" y="1080284"/>
                    <a:pt x="782990" y="1080118"/>
                    <a:pt x="796925" y="1073150"/>
                  </a:cubicBezTo>
                  <a:cubicBezTo>
                    <a:pt x="799918" y="1071653"/>
                    <a:pt x="803275" y="1071033"/>
                    <a:pt x="806450" y="1069975"/>
                  </a:cubicBezTo>
                  <a:cubicBezTo>
                    <a:pt x="809625" y="1067858"/>
                    <a:pt x="813044" y="1066068"/>
                    <a:pt x="815975" y="1063625"/>
                  </a:cubicBezTo>
                  <a:cubicBezTo>
                    <a:pt x="819424" y="1060750"/>
                    <a:pt x="821764" y="1056591"/>
                    <a:pt x="825500" y="1054100"/>
                  </a:cubicBezTo>
                  <a:cubicBezTo>
                    <a:pt x="828285" y="1052244"/>
                    <a:pt x="831850" y="1051983"/>
                    <a:pt x="835025" y="1050925"/>
                  </a:cubicBezTo>
                  <a:cubicBezTo>
                    <a:pt x="862322" y="1032727"/>
                    <a:pt x="827785" y="1054545"/>
                    <a:pt x="854075" y="1041400"/>
                  </a:cubicBezTo>
                  <a:cubicBezTo>
                    <a:pt x="857488" y="1039693"/>
                    <a:pt x="860113" y="1036600"/>
                    <a:pt x="863600" y="1035050"/>
                  </a:cubicBezTo>
                  <a:cubicBezTo>
                    <a:pt x="869717" y="1032332"/>
                    <a:pt x="882650" y="1028700"/>
                    <a:pt x="882650" y="1028700"/>
                  </a:cubicBezTo>
                  <a:cubicBezTo>
                    <a:pt x="909947" y="1010502"/>
                    <a:pt x="875410" y="1032320"/>
                    <a:pt x="901700" y="1019175"/>
                  </a:cubicBezTo>
                  <a:cubicBezTo>
                    <a:pt x="905113" y="1017468"/>
                    <a:pt x="907738" y="1014375"/>
                    <a:pt x="911225" y="1012825"/>
                  </a:cubicBezTo>
                  <a:cubicBezTo>
                    <a:pt x="917342" y="1010107"/>
                    <a:pt x="930275" y="1006475"/>
                    <a:pt x="930275" y="1006475"/>
                  </a:cubicBezTo>
                  <a:lnTo>
                    <a:pt x="958850" y="987425"/>
                  </a:lnTo>
                  <a:cubicBezTo>
                    <a:pt x="961635" y="985569"/>
                    <a:pt x="965200" y="985308"/>
                    <a:pt x="968375" y="984250"/>
                  </a:cubicBezTo>
                  <a:cubicBezTo>
                    <a:pt x="971550" y="981075"/>
                    <a:pt x="974356" y="977482"/>
                    <a:pt x="977900" y="974725"/>
                  </a:cubicBezTo>
                  <a:cubicBezTo>
                    <a:pt x="983924" y="970040"/>
                    <a:pt x="996950" y="962025"/>
                    <a:pt x="996950" y="962025"/>
                  </a:cubicBezTo>
                  <a:cubicBezTo>
                    <a:pt x="1008683" y="944426"/>
                    <a:pt x="996587" y="958346"/>
                    <a:pt x="1012825" y="949325"/>
                  </a:cubicBezTo>
                  <a:lnTo>
                    <a:pt x="1041400" y="930275"/>
                  </a:lnTo>
                  <a:cubicBezTo>
                    <a:pt x="1045803" y="927340"/>
                    <a:pt x="1049506" y="923375"/>
                    <a:pt x="1054100" y="920750"/>
                  </a:cubicBezTo>
                  <a:cubicBezTo>
                    <a:pt x="1057006" y="919090"/>
                    <a:pt x="1060450" y="918633"/>
                    <a:pt x="1063625" y="917575"/>
                  </a:cubicBezTo>
                  <a:cubicBezTo>
                    <a:pt x="1068240" y="903731"/>
                    <a:pt x="1067939" y="899063"/>
                    <a:pt x="1076325" y="889000"/>
                  </a:cubicBezTo>
                  <a:cubicBezTo>
                    <a:pt x="1079200" y="885551"/>
                    <a:pt x="1082306" y="882232"/>
                    <a:pt x="1085850" y="879475"/>
                  </a:cubicBezTo>
                  <a:cubicBezTo>
                    <a:pt x="1091874" y="874790"/>
                    <a:pt x="1104900" y="866775"/>
                    <a:pt x="1104900" y="866775"/>
                  </a:cubicBezTo>
                  <a:cubicBezTo>
                    <a:pt x="1107017" y="863600"/>
                    <a:pt x="1108715" y="860102"/>
                    <a:pt x="1111250" y="857250"/>
                  </a:cubicBezTo>
                  <a:cubicBezTo>
                    <a:pt x="1117216" y="850538"/>
                    <a:pt x="1130300" y="838200"/>
                    <a:pt x="1130300" y="838200"/>
                  </a:cubicBezTo>
                  <a:cubicBezTo>
                    <a:pt x="1137849" y="815552"/>
                    <a:pt x="1127145" y="842933"/>
                    <a:pt x="1143000" y="819150"/>
                  </a:cubicBezTo>
                  <a:cubicBezTo>
                    <a:pt x="1144856" y="816365"/>
                    <a:pt x="1144678" y="812618"/>
                    <a:pt x="1146175" y="809625"/>
                  </a:cubicBezTo>
                  <a:cubicBezTo>
                    <a:pt x="1147882" y="806212"/>
                    <a:pt x="1150975" y="803587"/>
                    <a:pt x="1152525" y="800100"/>
                  </a:cubicBezTo>
                  <a:cubicBezTo>
                    <a:pt x="1155243" y="793983"/>
                    <a:pt x="1156758" y="787400"/>
                    <a:pt x="1158875" y="781050"/>
                  </a:cubicBezTo>
                  <a:cubicBezTo>
                    <a:pt x="1159933" y="777875"/>
                    <a:pt x="1159265" y="773381"/>
                    <a:pt x="1162050" y="771525"/>
                  </a:cubicBezTo>
                  <a:lnTo>
                    <a:pt x="1171575" y="765175"/>
                  </a:lnTo>
                  <a:lnTo>
                    <a:pt x="1181100" y="736600"/>
                  </a:lnTo>
                  <a:lnTo>
                    <a:pt x="1184275" y="727075"/>
                  </a:lnTo>
                  <a:lnTo>
                    <a:pt x="1187450" y="717550"/>
                  </a:lnTo>
                  <a:cubicBezTo>
                    <a:pt x="1186392" y="712258"/>
                    <a:pt x="1185695" y="706881"/>
                    <a:pt x="1184275" y="701675"/>
                  </a:cubicBezTo>
                  <a:lnTo>
                    <a:pt x="1174750" y="673100"/>
                  </a:lnTo>
                  <a:lnTo>
                    <a:pt x="1171575" y="663575"/>
                  </a:lnTo>
                  <a:lnTo>
                    <a:pt x="1168400" y="654050"/>
                  </a:lnTo>
                  <a:cubicBezTo>
                    <a:pt x="1167342" y="627592"/>
                    <a:pt x="1167776" y="601031"/>
                    <a:pt x="1165225" y="574675"/>
                  </a:cubicBezTo>
                  <a:cubicBezTo>
                    <a:pt x="1164580" y="568013"/>
                    <a:pt x="1160992" y="561975"/>
                    <a:pt x="1158875" y="555625"/>
                  </a:cubicBezTo>
                  <a:cubicBezTo>
                    <a:pt x="1153287" y="538860"/>
                    <a:pt x="1157556" y="548885"/>
                    <a:pt x="1143000" y="527050"/>
                  </a:cubicBezTo>
                  <a:cubicBezTo>
                    <a:pt x="1140883" y="523875"/>
                    <a:pt x="1137857" y="521145"/>
                    <a:pt x="1136650" y="517525"/>
                  </a:cubicBezTo>
                  <a:cubicBezTo>
                    <a:pt x="1135592" y="514350"/>
                    <a:pt x="1135100" y="510926"/>
                    <a:pt x="1133475" y="508000"/>
                  </a:cubicBezTo>
                  <a:cubicBezTo>
                    <a:pt x="1120098" y="483921"/>
                    <a:pt x="1122671" y="497174"/>
                    <a:pt x="1117600" y="479425"/>
                  </a:cubicBezTo>
                  <a:cubicBezTo>
                    <a:pt x="1116401" y="475229"/>
                    <a:pt x="1115372" y="470985"/>
                    <a:pt x="1114425" y="466725"/>
                  </a:cubicBezTo>
                  <a:cubicBezTo>
                    <a:pt x="1113254" y="461457"/>
                    <a:pt x="1112670" y="456056"/>
                    <a:pt x="1111250" y="450850"/>
                  </a:cubicBezTo>
                  <a:cubicBezTo>
                    <a:pt x="1109489" y="444392"/>
                    <a:pt x="1107017" y="438150"/>
                    <a:pt x="1104900" y="431800"/>
                  </a:cubicBezTo>
                  <a:lnTo>
                    <a:pt x="1092200" y="393700"/>
                  </a:lnTo>
                  <a:cubicBezTo>
                    <a:pt x="1090993" y="390080"/>
                    <a:pt x="1087400" y="387662"/>
                    <a:pt x="1085850" y="384175"/>
                  </a:cubicBezTo>
                  <a:cubicBezTo>
                    <a:pt x="1083132" y="378058"/>
                    <a:pt x="1081617" y="371475"/>
                    <a:pt x="1079500" y="365125"/>
                  </a:cubicBezTo>
                  <a:lnTo>
                    <a:pt x="1066800" y="327025"/>
                  </a:lnTo>
                  <a:cubicBezTo>
                    <a:pt x="1065593" y="323405"/>
                    <a:pt x="1062000" y="320987"/>
                    <a:pt x="1060450" y="317500"/>
                  </a:cubicBezTo>
                  <a:cubicBezTo>
                    <a:pt x="1045337" y="283495"/>
                    <a:pt x="1062121" y="310481"/>
                    <a:pt x="1047750" y="288925"/>
                  </a:cubicBezTo>
                  <a:cubicBezTo>
                    <a:pt x="1046692" y="284692"/>
                    <a:pt x="1046294" y="280236"/>
                    <a:pt x="1044575" y="276225"/>
                  </a:cubicBezTo>
                  <a:cubicBezTo>
                    <a:pt x="1039934" y="265395"/>
                    <a:pt x="1035982" y="266537"/>
                    <a:pt x="1028700" y="257175"/>
                  </a:cubicBezTo>
                  <a:cubicBezTo>
                    <a:pt x="1024015" y="251151"/>
                    <a:pt x="1022350" y="242358"/>
                    <a:pt x="1016000" y="238125"/>
                  </a:cubicBezTo>
                  <a:cubicBezTo>
                    <a:pt x="1012825" y="236008"/>
                    <a:pt x="1009406" y="234218"/>
                    <a:pt x="1006475" y="231775"/>
                  </a:cubicBezTo>
                  <a:cubicBezTo>
                    <a:pt x="995942" y="222998"/>
                    <a:pt x="999249" y="221812"/>
                    <a:pt x="987425" y="215900"/>
                  </a:cubicBezTo>
                  <a:cubicBezTo>
                    <a:pt x="984432" y="214403"/>
                    <a:pt x="981075" y="213783"/>
                    <a:pt x="977900" y="212725"/>
                  </a:cubicBezTo>
                  <a:cubicBezTo>
                    <a:pt x="971550" y="208492"/>
                    <a:pt x="961263" y="207265"/>
                    <a:pt x="958850" y="200025"/>
                  </a:cubicBezTo>
                  <a:cubicBezTo>
                    <a:pt x="953262" y="183260"/>
                    <a:pt x="957531" y="193285"/>
                    <a:pt x="942975" y="171450"/>
                  </a:cubicBezTo>
                  <a:lnTo>
                    <a:pt x="930275" y="152400"/>
                  </a:lnTo>
                  <a:cubicBezTo>
                    <a:pt x="928158" y="149225"/>
                    <a:pt x="923925" y="148167"/>
                    <a:pt x="920750" y="146050"/>
                  </a:cubicBezTo>
                  <a:cubicBezTo>
                    <a:pt x="919692" y="142875"/>
                    <a:pt x="919942" y="138892"/>
                    <a:pt x="917575" y="136525"/>
                  </a:cubicBezTo>
                  <a:cubicBezTo>
                    <a:pt x="903721" y="122671"/>
                    <a:pt x="900882" y="124952"/>
                    <a:pt x="885825" y="120650"/>
                  </a:cubicBezTo>
                  <a:cubicBezTo>
                    <a:pt x="882607" y="119731"/>
                    <a:pt x="879640" y="117684"/>
                    <a:pt x="876300" y="117475"/>
                  </a:cubicBezTo>
                  <a:cubicBezTo>
                    <a:pt x="862568" y="116617"/>
                    <a:pt x="863071" y="119063"/>
                    <a:pt x="857250" y="117475"/>
                  </a:cubicBezTo>
                  <a:close/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51" name="フリーフォーム 150"/>
            <p:cNvSpPr/>
            <p:nvPr/>
          </p:nvSpPr>
          <p:spPr>
            <a:xfrm>
              <a:off x="322114" y="4318496"/>
              <a:ext cx="1187450" cy="1143000"/>
            </a:xfrm>
            <a:custGeom>
              <a:avLst/>
              <a:gdLst>
                <a:gd name="connsiteX0" fmla="*/ 857250 w 1187450"/>
                <a:gd name="connsiteY0" fmla="*/ 117475 h 1143000"/>
                <a:gd name="connsiteX1" fmla="*/ 841375 w 1187450"/>
                <a:gd name="connsiteY1" fmla="*/ 107950 h 1143000"/>
                <a:gd name="connsiteX2" fmla="*/ 765175 w 1187450"/>
                <a:gd name="connsiteY2" fmla="*/ 98425 h 1143000"/>
                <a:gd name="connsiteX3" fmla="*/ 755650 w 1187450"/>
                <a:gd name="connsiteY3" fmla="*/ 95250 h 1143000"/>
                <a:gd name="connsiteX4" fmla="*/ 736600 w 1187450"/>
                <a:gd name="connsiteY4" fmla="*/ 82550 h 1143000"/>
                <a:gd name="connsiteX5" fmla="*/ 720725 w 1187450"/>
                <a:gd name="connsiteY5" fmla="*/ 69850 h 1143000"/>
                <a:gd name="connsiteX6" fmla="*/ 701675 w 1187450"/>
                <a:gd name="connsiteY6" fmla="*/ 57150 h 1143000"/>
                <a:gd name="connsiteX7" fmla="*/ 695325 w 1187450"/>
                <a:gd name="connsiteY7" fmla="*/ 47625 h 1143000"/>
                <a:gd name="connsiteX8" fmla="*/ 676275 w 1187450"/>
                <a:gd name="connsiteY8" fmla="*/ 38100 h 1143000"/>
                <a:gd name="connsiteX9" fmla="*/ 657225 w 1187450"/>
                <a:gd name="connsiteY9" fmla="*/ 22225 h 1143000"/>
                <a:gd name="connsiteX10" fmla="*/ 638175 w 1187450"/>
                <a:gd name="connsiteY10" fmla="*/ 15875 h 1143000"/>
                <a:gd name="connsiteX11" fmla="*/ 628650 w 1187450"/>
                <a:gd name="connsiteY11" fmla="*/ 12700 h 1143000"/>
                <a:gd name="connsiteX12" fmla="*/ 619125 w 1187450"/>
                <a:gd name="connsiteY12" fmla="*/ 6350 h 1143000"/>
                <a:gd name="connsiteX13" fmla="*/ 596900 w 1187450"/>
                <a:gd name="connsiteY13" fmla="*/ 0 h 1143000"/>
                <a:gd name="connsiteX14" fmla="*/ 539750 w 1187450"/>
                <a:gd name="connsiteY14" fmla="*/ 3175 h 1143000"/>
                <a:gd name="connsiteX15" fmla="*/ 520700 w 1187450"/>
                <a:gd name="connsiteY15" fmla="*/ 9525 h 1143000"/>
                <a:gd name="connsiteX16" fmla="*/ 511175 w 1187450"/>
                <a:gd name="connsiteY16" fmla="*/ 12700 h 1143000"/>
                <a:gd name="connsiteX17" fmla="*/ 501650 w 1187450"/>
                <a:gd name="connsiteY17" fmla="*/ 15875 h 1143000"/>
                <a:gd name="connsiteX18" fmla="*/ 482600 w 1187450"/>
                <a:gd name="connsiteY18" fmla="*/ 19050 h 1143000"/>
                <a:gd name="connsiteX19" fmla="*/ 444500 w 1187450"/>
                <a:gd name="connsiteY19" fmla="*/ 28575 h 1143000"/>
                <a:gd name="connsiteX20" fmla="*/ 431800 w 1187450"/>
                <a:gd name="connsiteY20" fmla="*/ 31750 h 1143000"/>
                <a:gd name="connsiteX21" fmla="*/ 409575 w 1187450"/>
                <a:gd name="connsiteY21" fmla="*/ 38100 h 1143000"/>
                <a:gd name="connsiteX22" fmla="*/ 381000 w 1187450"/>
                <a:gd name="connsiteY22" fmla="*/ 41275 h 1143000"/>
                <a:gd name="connsiteX23" fmla="*/ 361950 w 1187450"/>
                <a:gd name="connsiteY23" fmla="*/ 47625 h 1143000"/>
                <a:gd name="connsiteX24" fmla="*/ 352425 w 1187450"/>
                <a:gd name="connsiteY24" fmla="*/ 53975 h 1143000"/>
                <a:gd name="connsiteX25" fmla="*/ 333375 w 1187450"/>
                <a:gd name="connsiteY25" fmla="*/ 60325 h 1143000"/>
                <a:gd name="connsiteX26" fmla="*/ 311150 w 1187450"/>
                <a:gd name="connsiteY26" fmla="*/ 69850 h 1143000"/>
                <a:gd name="connsiteX27" fmla="*/ 282575 w 1187450"/>
                <a:gd name="connsiteY27" fmla="*/ 85725 h 1143000"/>
                <a:gd name="connsiteX28" fmla="*/ 276225 w 1187450"/>
                <a:gd name="connsiteY28" fmla="*/ 95250 h 1143000"/>
                <a:gd name="connsiteX29" fmla="*/ 257175 w 1187450"/>
                <a:gd name="connsiteY29" fmla="*/ 101600 h 1143000"/>
                <a:gd name="connsiteX30" fmla="*/ 250825 w 1187450"/>
                <a:gd name="connsiteY30" fmla="*/ 111125 h 1143000"/>
                <a:gd name="connsiteX31" fmla="*/ 222250 w 1187450"/>
                <a:gd name="connsiteY31" fmla="*/ 127000 h 1143000"/>
                <a:gd name="connsiteX32" fmla="*/ 193675 w 1187450"/>
                <a:gd name="connsiteY32" fmla="*/ 149225 h 1143000"/>
                <a:gd name="connsiteX33" fmla="*/ 174625 w 1187450"/>
                <a:gd name="connsiteY33" fmla="*/ 165100 h 1143000"/>
                <a:gd name="connsiteX34" fmla="*/ 146050 w 1187450"/>
                <a:gd name="connsiteY34" fmla="*/ 187325 h 1143000"/>
                <a:gd name="connsiteX35" fmla="*/ 136525 w 1187450"/>
                <a:gd name="connsiteY35" fmla="*/ 196850 h 1143000"/>
                <a:gd name="connsiteX36" fmla="*/ 127000 w 1187450"/>
                <a:gd name="connsiteY36" fmla="*/ 203200 h 1143000"/>
                <a:gd name="connsiteX37" fmla="*/ 114300 w 1187450"/>
                <a:gd name="connsiteY37" fmla="*/ 219075 h 1143000"/>
                <a:gd name="connsiteX38" fmla="*/ 101600 w 1187450"/>
                <a:gd name="connsiteY38" fmla="*/ 238125 h 1143000"/>
                <a:gd name="connsiteX39" fmla="*/ 88900 w 1187450"/>
                <a:gd name="connsiteY39" fmla="*/ 257175 h 1143000"/>
                <a:gd name="connsiteX40" fmla="*/ 76200 w 1187450"/>
                <a:gd name="connsiteY40" fmla="*/ 285750 h 1143000"/>
                <a:gd name="connsiteX41" fmla="*/ 73025 w 1187450"/>
                <a:gd name="connsiteY41" fmla="*/ 295275 h 1143000"/>
                <a:gd name="connsiteX42" fmla="*/ 60325 w 1187450"/>
                <a:gd name="connsiteY42" fmla="*/ 314325 h 1143000"/>
                <a:gd name="connsiteX43" fmla="*/ 57150 w 1187450"/>
                <a:gd name="connsiteY43" fmla="*/ 323850 h 1143000"/>
                <a:gd name="connsiteX44" fmla="*/ 50800 w 1187450"/>
                <a:gd name="connsiteY44" fmla="*/ 333375 h 1143000"/>
                <a:gd name="connsiteX45" fmla="*/ 47625 w 1187450"/>
                <a:gd name="connsiteY45" fmla="*/ 342900 h 1143000"/>
                <a:gd name="connsiteX46" fmla="*/ 28575 w 1187450"/>
                <a:gd name="connsiteY46" fmla="*/ 381000 h 1143000"/>
                <a:gd name="connsiteX47" fmla="*/ 22225 w 1187450"/>
                <a:gd name="connsiteY47" fmla="*/ 400050 h 1143000"/>
                <a:gd name="connsiteX48" fmla="*/ 19050 w 1187450"/>
                <a:gd name="connsiteY48" fmla="*/ 409575 h 1143000"/>
                <a:gd name="connsiteX49" fmla="*/ 15875 w 1187450"/>
                <a:gd name="connsiteY49" fmla="*/ 431800 h 1143000"/>
                <a:gd name="connsiteX50" fmla="*/ 12700 w 1187450"/>
                <a:gd name="connsiteY50" fmla="*/ 447675 h 1143000"/>
                <a:gd name="connsiteX51" fmla="*/ 3175 w 1187450"/>
                <a:gd name="connsiteY51" fmla="*/ 501650 h 1143000"/>
                <a:gd name="connsiteX52" fmla="*/ 0 w 1187450"/>
                <a:gd name="connsiteY52" fmla="*/ 511175 h 1143000"/>
                <a:gd name="connsiteX53" fmla="*/ 3175 w 1187450"/>
                <a:gd name="connsiteY53" fmla="*/ 552450 h 1143000"/>
                <a:gd name="connsiteX54" fmla="*/ 12700 w 1187450"/>
                <a:gd name="connsiteY54" fmla="*/ 571500 h 1143000"/>
                <a:gd name="connsiteX55" fmla="*/ 15875 w 1187450"/>
                <a:gd name="connsiteY55" fmla="*/ 581025 h 1143000"/>
                <a:gd name="connsiteX56" fmla="*/ 22225 w 1187450"/>
                <a:gd name="connsiteY56" fmla="*/ 590550 h 1143000"/>
                <a:gd name="connsiteX57" fmla="*/ 28575 w 1187450"/>
                <a:gd name="connsiteY57" fmla="*/ 609600 h 1143000"/>
                <a:gd name="connsiteX58" fmla="*/ 34925 w 1187450"/>
                <a:gd name="connsiteY58" fmla="*/ 628650 h 1143000"/>
                <a:gd name="connsiteX59" fmla="*/ 44450 w 1187450"/>
                <a:gd name="connsiteY59" fmla="*/ 638175 h 1143000"/>
                <a:gd name="connsiteX60" fmla="*/ 50800 w 1187450"/>
                <a:gd name="connsiteY60" fmla="*/ 657225 h 1143000"/>
                <a:gd name="connsiteX61" fmla="*/ 69850 w 1187450"/>
                <a:gd name="connsiteY61" fmla="*/ 685800 h 1143000"/>
                <a:gd name="connsiteX62" fmla="*/ 76200 w 1187450"/>
                <a:gd name="connsiteY62" fmla="*/ 704850 h 1143000"/>
                <a:gd name="connsiteX63" fmla="*/ 79375 w 1187450"/>
                <a:gd name="connsiteY63" fmla="*/ 717550 h 1143000"/>
                <a:gd name="connsiteX64" fmla="*/ 82550 w 1187450"/>
                <a:gd name="connsiteY64" fmla="*/ 727075 h 1143000"/>
                <a:gd name="connsiteX65" fmla="*/ 88900 w 1187450"/>
                <a:gd name="connsiteY65" fmla="*/ 765175 h 1143000"/>
                <a:gd name="connsiteX66" fmla="*/ 92075 w 1187450"/>
                <a:gd name="connsiteY66" fmla="*/ 825500 h 1143000"/>
                <a:gd name="connsiteX67" fmla="*/ 95250 w 1187450"/>
                <a:gd name="connsiteY67" fmla="*/ 838200 h 1143000"/>
                <a:gd name="connsiteX68" fmla="*/ 101600 w 1187450"/>
                <a:gd name="connsiteY68" fmla="*/ 869950 h 1143000"/>
                <a:gd name="connsiteX69" fmla="*/ 120650 w 1187450"/>
                <a:gd name="connsiteY69" fmla="*/ 908050 h 1143000"/>
                <a:gd name="connsiteX70" fmla="*/ 123825 w 1187450"/>
                <a:gd name="connsiteY70" fmla="*/ 917575 h 1143000"/>
                <a:gd name="connsiteX71" fmla="*/ 139700 w 1187450"/>
                <a:gd name="connsiteY71" fmla="*/ 936625 h 1143000"/>
                <a:gd name="connsiteX72" fmla="*/ 152400 w 1187450"/>
                <a:gd name="connsiteY72" fmla="*/ 965200 h 1143000"/>
                <a:gd name="connsiteX73" fmla="*/ 171450 w 1187450"/>
                <a:gd name="connsiteY73" fmla="*/ 977900 h 1143000"/>
                <a:gd name="connsiteX74" fmla="*/ 193675 w 1187450"/>
                <a:gd name="connsiteY74" fmla="*/ 1003300 h 1143000"/>
                <a:gd name="connsiteX75" fmla="*/ 200025 w 1187450"/>
                <a:gd name="connsiteY75" fmla="*/ 1012825 h 1143000"/>
                <a:gd name="connsiteX76" fmla="*/ 209550 w 1187450"/>
                <a:gd name="connsiteY76" fmla="*/ 1019175 h 1143000"/>
                <a:gd name="connsiteX77" fmla="*/ 241300 w 1187450"/>
                <a:gd name="connsiteY77" fmla="*/ 1041400 h 1143000"/>
                <a:gd name="connsiteX78" fmla="*/ 260350 w 1187450"/>
                <a:gd name="connsiteY78" fmla="*/ 1054100 h 1143000"/>
                <a:gd name="connsiteX79" fmla="*/ 276225 w 1187450"/>
                <a:gd name="connsiteY79" fmla="*/ 1063625 h 1143000"/>
                <a:gd name="connsiteX80" fmla="*/ 295275 w 1187450"/>
                <a:gd name="connsiteY80" fmla="*/ 1073150 h 1143000"/>
                <a:gd name="connsiteX81" fmla="*/ 323850 w 1187450"/>
                <a:gd name="connsiteY81" fmla="*/ 1085850 h 1143000"/>
                <a:gd name="connsiteX82" fmla="*/ 352425 w 1187450"/>
                <a:gd name="connsiteY82" fmla="*/ 1095375 h 1143000"/>
                <a:gd name="connsiteX83" fmla="*/ 371475 w 1187450"/>
                <a:gd name="connsiteY83" fmla="*/ 1098550 h 1143000"/>
                <a:gd name="connsiteX84" fmla="*/ 384175 w 1187450"/>
                <a:gd name="connsiteY84" fmla="*/ 1101725 h 1143000"/>
                <a:gd name="connsiteX85" fmla="*/ 403225 w 1187450"/>
                <a:gd name="connsiteY85" fmla="*/ 1111250 h 1143000"/>
                <a:gd name="connsiteX86" fmla="*/ 412750 w 1187450"/>
                <a:gd name="connsiteY86" fmla="*/ 1117600 h 1143000"/>
                <a:gd name="connsiteX87" fmla="*/ 431800 w 1187450"/>
                <a:gd name="connsiteY87" fmla="*/ 1123950 h 1143000"/>
                <a:gd name="connsiteX88" fmla="*/ 441325 w 1187450"/>
                <a:gd name="connsiteY88" fmla="*/ 1127125 h 1143000"/>
                <a:gd name="connsiteX89" fmla="*/ 450850 w 1187450"/>
                <a:gd name="connsiteY89" fmla="*/ 1133475 h 1143000"/>
                <a:gd name="connsiteX90" fmla="*/ 463550 w 1187450"/>
                <a:gd name="connsiteY90" fmla="*/ 1136650 h 1143000"/>
                <a:gd name="connsiteX91" fmla="*/ 495300 w 1187450"/>
                <a:gd name="connsiteY91" fmla="*/ 1143000 h 1143000"/>
                <a:gd name="connsiteX92" fmla="*/ 619125 w 1187450"/>
                <a:gd name="connsiteY92" fmla="*/ 1139825 h 1143000"/>
                <a:gd name="connsiteX93" fmla="*/ 660400 w 1187450"/>
                <a:gd name="connsiteY93" fmla="*/ 1130300 h 1143000"/>
                <a:gd name="connsiteX94" fmla="*/ 673100 w 1187450"/>
                <a:gd name="connsiteY94" fmla="*/ 1127125 h 1143000"/>
                <a:gd name="connsiteX95" fmla="*/ 682625 w 1187450"/>
                <a:gd name="connsiteY95" fmla="*/ 1123950 h 1143000"/>
                <a:gd name="connsiteX96" fmla="*/ 704850 w 1187450"/>
                <a:gd name="connsiteY96" fmla="*/ 1117600 h 1143000"/>
                <a:gd name="connsiteX97" fmla="*/ 723900 w 1187450"/>
                <a:gd name="connsiteY97" fmla="*/ 1108075 h 1143000"/>
                <a:gd name="connsiteX98" fmla="*/ 746125 w 1187450"/>
                <a:gd name="connsiteY98" fmla="*/ 1098550 h 1143000"/>
                <a:gd name="connsiteX99" fmla="*/ 774700 w 1187450"/>
                <a:gd name="connsiteY99" fmla="*/ 1085850 h 1143000"/>
                <a:gd name="connsiteX100" fmla="*/ 796925 w 1187450"/>
                <a:gd name="connsiteY100" fmla="*/ 1073150 h 1143000"/>
                <a:gd name="connsiteX101" fmla="*/ 806450 w 1187450"/>
                <a:gd name="connsiteY101" fmla="*/ 1069975 h 1143000"/>
                <a:gd name="connsiteX102" fmla="*/ 815975 w 1187450"/>
                <a:gd name="connsiteY102" fmla="*/ 1063625 h 1143000"/>
                <a:gd name="connsiteX103" fmla="*/ 825500 w 1187450"/>
                <a:gd name="connsiteY103" fmla="*/ 1054100 h 1143000"/>
                <a:gd name="connsiteX104" fmla="*/ 835025 w 1187450"/>
                <a:gd name="connsiteY104" fmla="*/ 1050925 h 1143000"/>
                <a:gd name="connsiteX105" fmla="*/ 854075 w 1187450"/>
                <a:gd name="connsiteY105" fmla="*/ 1041400 h 1143000"/>
                <a:gd name="connsiteX106" fmla="*/ 863600 w 1187450"/>
                <a:gd name="connsiteY106" fmla="*/ 1035050 h 1143000"/>
                <a:gd name="connsiteX107" fmla="*/ 882650 w 1187450"/>
                <a:gd name="connsiteY107" fmla="*/ 1028700 h 1143000"/>
                <a:gd name="connsiteX108" fmla="*/ 901700 w 1187450"/>
                <a:gd name="connsiteY108" fmla="*/ 1019175 h 1143000"/>
                <a:gd name="connsiteX109" fmla="*/ 911225 w 1187450"/>
                <a:gd name="connsiteY109" fmla="*/ 1012825 h 1143000"/>
                <a:gd name="connsiteX110" fmla="*/ 930275 w 1187450"/>
                <a:gd name="connsiteY110" fmla="*/ 1006475 h 1143000"/>
                <a:gd name="connsiteX111" fmla="*/ 958850 w 1187450"/>
                <a:gd name="connsiteY111" fmla="*/ 987425 h 1143000"/>
                <a:gd name="connsiteX112" fmla="*/ 968375 w 1187450"/>
                <a:gd name="connsiteY112" fmla="*/ 984250 h 1143000"/>
                <a:gd name="connsiteX113" fmla="*/ 977900 w 1187450"/>
                <a:gd name="connsiteY113" fmla="*/ 974725 h 1143000"/>
                <a:gd name="connsiteX114" fmla="*/ 996950 w 1187450"/>
                <a:gd name="connsiteY114" fmla="*/ 962025 h 1143000"/>
                <a:gd name="connsiteX115" fmla="*/ 1012825 w 1187450"/>
                <a:gd name="connsiteY115" fmla="*/ 949325 h 1143000"/>
                <a:gd name="connsiteX116" fmla="*/ 1041400 w 1187450"/>
                <a:gd name="connsiteY116" fmla="*/ 930275 h 1143000"/>
                <a:gd name="connsiteX117" fmla="*/ 1054100 w 1187450"/>
                <a:gd name="connsiteY117" fmla="*/ 920750 h 1143000"/>
                <a:gd name="connsiteX118" fmla="*/ 1063625 w 1187450"/>
                <a:gd name="connsiteY118" fmla="*/ 917575 h 1143000"/>
                <a:gd name="connsiteX119" fmla="*/ 1076325 w 1187450"/>
                <a:gd name="connsiteY119" fmla="*/ 889000 h 1143000"/>
                <a:gd name="connsiteX120" fmla="*/ 1085850 w 1187450"/>
                <a:gd name="connsiteY120" fmla="*/ 879475 h 1143000"/>
                <a:gd name="connsiteX121" fmla="*/ 1104900 w 1187450"/>
                <a:gd name="connsiteY121" fmla="*/ 866775 h 1143000"/>
                <a:gd name="connsiteX122" fmla="*/ 1111250 w 1187450"/>
                <a:gd name="connsiteY122" fmla="*/ 857250 h 1143000"/>
                <a:gd name="connsiteX123" fmla="*/ 1130300 w 1187450"/>
                <a:gd name="connsiteY123" fmla="*/ 838200 h 1143000"/>
                <a:gd name="connsiteX124" fmla="*/ 1143000 w 1187450"/>
                <a:gd name="connsiteY124" fmla="*/ 819150 h 1143000"/>
                <a:gd name="connsiteX125" fmla="*/ 1146175 w 1187450"/>
                <a:gd name="connsiteY125" fmla="*/ 809625 h 1143000"/>
                <a:gd name="connsiteX126" fmla="*/ 1152525 w 1187450"/>
                <a:gd name="connsiteY126" fmla="*/ 800100 h 1143000"/>
                <a:gd name="connsiteX127" fmla="*/ 1158875 w 1187450"/>
                <a:gd name="connsiteY127" fmla="*/ 781050 h 1143000"/>
                <a:gd name="connsiteX128" fmla="*/ 1162050 w 1187450"/>
                <a:gd name="connsiteY128" fmla="*/ 771525 h 1143000"/>
                <a:gd name="connsiteX129" fmla="*/ 1171575 w 1187450"/>
                <a:gd name="connsiteY129" fmla="*/ 765175 h 1143000"/>
                <a:gd name="connsiteX130" fmla="*/ 1181100 w 1187450"/>
                <a:gd name="connsiteY130" fmla="*/ 736600 h 1143000"/>
                <a:gd name="connsiteX131" fmla="*/ 1184275 w 1187450"/>
                <a:gd name="connsiteY131" fmla="*/ 727075 h 1143000"/>
                <a:gd name="connsiteX132" fmla="*/ 1187450 w 1187450"/>
                <a:gd name="connsiteY132" fmla="*/ 717550 h 1143000"/>
                <a:gd name="connsiteX133" fmla="*/ 1184275 w 1187450"/>
                <a:gd name="connsiteY133" fmla="*/ 701675 h 1143000"/>
                <a:gd name="connsiteX134" fmla="*/ 1174750 w 1187450"/>
                <a:gd name="connsiteY134" fmla="*/ 673100 h 1143000"/>
                <a:gd name="connsiteX135" fmla="*/ 1171575 w 1187450"/>
                <a:gd name="connsiteY135" fmla="*/ 663575 h 1143000"/>
                <a:gd name="connsiteX136" fmla="*/ 1168400 w 1187450"/>
                <a:gd name="connsiteY136" fmla="*/ 654050 h 1143000"/>
                <a:gd name="connsiteX137" fmla="*/ 1165225 w 1187450"/>
                <a:gd name="connsiteY137" fmla="*/ 574675 h 1143000"/>
                <a:gd name="connsiteX138" fmla="*/ 1158875 w 1187450"/>
                <a:gd name="connsiteY138" fmla="*/ 555625 h 1143000"/>
                <a:gd name="connsiteX139" fmla="*/ 1143000 w 1187450"/>
                <a:gd name="connsiteY139" fmla="*/ 527050 h 1143000"/>
                <a:gd name="connsiteX140" fmla="*/ 1136650 w 1187450"/>
                <a:gd name="connsiteY140" fmla="*/ 517525 h 1143000"/>
                <a:gd name="connsiteX141" fmla="*/ 1133475 w 1187450"/>
                <a:gd name="connsiteY141" fmla="*/ 508000 h 1143000"/>
                <a:gd name="connsiteX142" fmla="*/ 1117600 w 1187450"/>
                <a:gd name="connsiteY142" fmla="*/ 479425 h 1143000"/>
                <a:gd name="connsiteX143" fmla="*/ 1114425 w 1187450"/>
                <a:gd name="connsiteY143" fmla="*/ 466725 h 1143000"/>
                <a:gd name="connsiteX144" fmla="*/ 1111250 w 1187450"/>
                <a:gd name="connsiteY144" fmla="*/ 450850 h 1143000"/>
                <a:gd name="connsiteX145" fmla="*/ 1104900 w 1187450"/>
                <a:gd name="connsiteY145" fmla="*/ 431800 h 1143000"/>
                <a:gd name="connsiteX146" fmla="*/ 1092200 w 1187450"/>
                <a:gd name="connsiteY146" fmla="*/ 393700 h 1143000"/>
                <a:gd name="connsiteX147" fmla="*/ 1085850 w 1187450"/>
                <a:gd name="connsiteY147" fmla="*/ 384175 h 1143000"/>
                <a:gd name="connsiteX148" fmla="*/ 1079500 w 1187450"/>
                <a:gd name="connsiteY148" fmla="*/ 365125 h 1143000"/>
                <a:gd name="connsiteX149" fmla="*/ 1066800 w 1187450"/>
                <a:gd name="connsiteY149" fmla="*/ 327025 h 1143000"/>
                <a:gd name="connsiteX150" fmla="*/ 1060450 w 1187450"/>
                <a:gd name="connsiteY150" fmla="*/ 317500 h 1143000"/>
                <a:gd name="connsiteX151" fmla="*/ 1047750 w 1187450"/>
                <a:gd name="connsiteY151" fmla="*/ 288925 h 1143000"/>
                <a:gd name="connsiteX152" fmla="*/ 1044575 w 1187450"/>
                <a:gd name="connsiteY152" fmla="*/ 276225 h 1143000"/>
                <a:gd name="connsiteX153" fmla="*/ 1028700 w 1187450"/>
                <a:gd name="connsiteY153" fmla="*/ 257175 h 1143000"/>
                <a:gd name="connsiteX154" fmla="*/ 1016000 w 1187450"/>
                <a:gd name="connsiteY154" fmla="*/ 238125 h 1143000"/>
                <a:gd name="connsiteX155" fmla="*/ 1006475 w 1187450"/>
                <a:gd name="connsiteY155" fmla="*/ 231775 h 1143000"/>
                <a:gd name="connsiteX156" fmla="*/ 987425 w 1187450"/>
                <a:gd name="connsiteY156" fmla="*/ 215900 h 1143000"/>
                <a:gd name="connsiteX157" fmla="*/ 977900 w 1187450"/>
                <a:gd name="connsiteY157" fmla="*/ 212725 h 1143000"/>
                <a:gd name="connsiteX158" fmla="*/ 958850 w 1187450"/>
                <a:gd name="connsiteY158" fmla="*/ 200025 h 1143000"/>
                <a:gd name="connsiteX159" fmla="*/ 942975 w 1187450"/>
                <a:gd name="connsiteY159" fmla="*/ 171450 h 1143000"/>
                <a:gd name="connsiteX160" fmla="*/ 930275 w 1187450"/>
                <a:gd name="connsiteY160" fmla="*/ 152400 h 1143000"/>
                <a:gd name="connsiteX161" fmla="*/ 920750 w 1187450"/>
                <a:gd name="connsiteY161" fmla="*/ 146050 h 1143000"/>
                <a:gd name="connsiteX162" fmla="*/ 917575 w 1187450"/>
                <a:gd name="connsiteY162" fmla="*/ 136525 h 1143000"/>
                <a:gd name="connsiteX163" fmla="*/ 885825 w 1187450"/>
                <a:gd name="connsiteY163" fmla="*/ 120650 h 1143000"/>
                <a:gd name="connsiteX164" fmla="*/ 876300 w 1187450"/>
                <a:gd name="connsiteY164" fmla="*/ 117475 h 1143000"/>
                <a:gd name="connsiteX165" fmla="*/ 857250 w 1187450"/>
                <a:gd name="connsiteY165" fmla="*/ 117475 h 1143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</a:cxnLst>
              <a:rect l="l" t="t" r="r" b="b"/>
              <a:pathLst>
                <a:path w="1187450" h="1143000">
                  <a:moveTo>
                    <a:pt x="857250" y="117475"/>
                  </a:moveTo>
                  <a:cubicBezTo>
                    <a:pt x="851429" y="115887"/>
                    <a:pt x="846993" y="110504"/>
                    <a:pt x="841375" y="107950"/>
                  </a:cubicBezTo>
                  <a:cubicBezTo>
                    <a:pt x="815511" y="96194"/>
                    <a:pt x="796838" y="100184"/>
                    <a:pt x="765175" y="98425"/>
                  </a:cubicBezTo>
                  <a:cubicBezTo>
                    <a:pt x="762000" y="97367"/>
                    <a:pt x="758576" y="96875"/>
                    <a:pt x="755650" y="95250"/>
                  </a:cubicBezTo>
                  <a:cubicBezTo>
                    <a:pt x="748979" y="91544"/>
                    <a:pt x="736600" y="82550"/>
                    <a:pt x="736600" y="82550"/>
                  </a:cubicBezTo>
                  <a:cubicBezTo>
                    <a:pt x="724867" y="64951"/>
                    <a:pt x="736963" y="78871"/>
                    <a:pt x="720725" y="69850"/>
                  </a:cubicBezTo>
                  <a:cubicBezTo>
                    <a:pt x="714054" y="66144"/>
                    <a:pt x="701675" y="57150"/>
                    <a:pt x="701675" y="57150"/>
                  </a:cubicBezTo>
                  <a:cubicBezTo>
                    <a:pt x="699558" y="53975"/>
                    <a:pt x="698023" y="50323"/>
                    <a:pt x="695325" y="47625"/>
                  </a:cubicBezTo>
                  <a:cubicBezTo>
                    <a:pt x="689170" y="41470"/>
                    <a:pt x="684022" y="40682"/>
                    <a:pt x="676275" y="38100"/>
                  </a:cubicBezTo>
                  <a:cubicBezTo>
                    <a:pt x="670293" y="32118"/>
                    <a:pt x="665182" y="25761"/>
                    <a:pt x="657225" y="22225"/>
                  </a:cubicBezTo>
                  <a:cubicBezTo>
                    <a:pt x="651108" y="19507"/>
                    <a:pt x="644525" y="17992"/>
                    <a:pt x="638175" y="15875"/>
                  </a:cubicBezTo>
                  <a:lnTo>
                    <a:pt x="628650" y="12700"/>
                  </a:lnTo>
                  <a:cubicBezTo>
                    <a:pt x="625475" y="10583"/>
                    <a:pt x="622538" y="8057"/>
                    <a:pt x="619125" y="6350"/>
                  </a:cubicBezTo>
                  <a:cubicBezTo>
                    <a:pt x="614570" y="4073"/>
                    <a:pt x="600969" y="1017"/>
                    <a:pt x="596900" y="0"/>
                  </a:cubicBezTo>
                  <a:cubicBezTo>
                    <a:pt x="577850" y="1058"/>
                    <a:pt x="558682" y="808"/>
                    <a:pt x="539750" y="3175"/>
                  </a:cubicBezTo>
                  <a:cubicBezTo>
                    <a:pt x="533108" y="4005"/>
                    <a:pt x="527050" y="7408"/>
                    <a:pt x="520700" y="9525"/>
                  </a:cubicBezTo>
                  <a:lnTo>
                    <a:pt x="511175" y="12700"/>
                  </a:lnTo>
                  <a:cubicBezTo>
                    <a:pt x="508000" y="13758"/>
                    <a:pt x="504951" y="15325"/>
                    <a:pt x="501650" y="15875"/>
                  </a:cubicBezTo>
                  <a:lnTo>
                    <a:pt x="482600" y="19050"/>
                  </a:lnTo>
                  <a:cubicBezTo>
                    <a:pt x="450775" y="29658"/>
                    <a:pt x="476566" y="22162"/>
                    <a:pt x="444500" y="28575"/>
                  </a:cubicBezTo>
                  <a:cubicBezTo>
                    <a:pt x="440221" y="29431"/>
                    <a:pt x="435996" y="30551"/>
                    <a:pt x="431800" y="31750"/>
                  </a:cubicBezTo>
                  <a:cubicBezTo>
                    <a:pt x="422119" y="34516"/>
                    <a:pt x="420328" y="36446"/>
                    <a:pt x="409575" y="38100"/>
                  </a:cubicBezTo>
                  <a:cubicBezTo>
                    <a:pt x="400103" y="39557"/>
                    <a:pt x="390525" y="40217"/>
                    <a:pt x="381000" y="41275"/>
                  </a:cubicBezTo>
                  <a:cubicBezTo>
                    <a:pt x="374650" y="43392"/>
                    <a:pt x="367519" y="43912"/>
                    <a:pt x="361950" y="47625"/>
                  </a:cubicBezTo>
                  <a:cubicBezTo>
                    <a:pt x="358775" y="49742"/>
                    <a:pt x="355912" y="52425"/>
                    <a:pt x="352425" y="53975"/>
                  </a:cubicBezTo>
                  <a:cubicBezTo>
                    <a:pt x="346308" y="56693"/>
                    <a:pt x="333375" y="60325"/>
                    <a:pt x="333375" y="60325"/>
                  </a:cubicBezTo>
                  <a:cubicBezTo>
                    <a:pt x="298705" y="83439"/>
                    <a:pt x="352155" y="49348"/>
                    <a:pt x="311150" y="69850"/>
                  </a:cubicBezTo>
                  <a:cubicBezTo>
                    <a:pt x="267481" y="91685"/>
                    <a:pt x="308915" y="76945"/>
                    <a:pt x="282575" y="85725"/>
                  </a:cubicBezTo>
                  <a:cubicBezTo>
                    <a:pt x="280458" y="88900"/>
                    <a:pt x="279461" y="93228"/>
                    <a:pt x="276225" y="95250"/>
                  </a:cubicBezTo>
                  <a:cubicBezTo>
                    <a:pt x="270549" y="98798"/>
                    <a:pt x="257175" y="101600"/>
                    <a:pt x="257175" y="101600"/>
                  </a:cubicBezTo>
                  <a:cubicBezTo>
                    <a:pt x="255058" y="104775"/>
                    <a:pt x="253697" y="108612"/>
                    <a:pt x="250825" y="111125"/>
                  </a:cubicBezTo>
                  <a:cubicBezTo>
                    <a:pt x="237388" y="122882"/>
                    <a:pt x="235332" y="122639"/>
                    <a:pt x="222250" y="127000"/>
                  </a:cubicBezTo>
                  <a:cubicBezTo>
                    <a:pt x="200833" y="148417"/>
                    <a:pt x="211719" y="143210"/>
                    <a:pt x="193675" y="149225"/>
                  </a:cubicBezTo>
                  <a:cubicBezTo>
                    <a:pt x="165848" y="177052"/>
                    <a:pt x="201147" y="142998"/>
                    <a:pt x="174625" y="165100"/>
                  </a:cubicBezTo>
                  <a:cubicBezTo>
                    <a:pt x="144782" y="189969"/>
                    <a:pt x="194198" y="155227"/>
                    <a:pt x="146050" y="187325"/>
                  </a:cubicBezTo>
                  <a:cubicBezTo>
                    <a:pt x="142314" y="189816"/>
                    <a:pt x="139974" y="193975"/>
                    <a:pt x="136525" y="196850"/>
                  </a:cubicBezTo>
                  <a:cubicBezTo>
                    <a:pt x="133594" y="199293"/>
                    <a:pt x="130175" y="201083"/>
                    <a:pt x="127000" y="203200"/>
                  </a:cubicBezTo>
                  <a:cubicBezTo>
                    <a:pt x="119850" y="224650"/>
                    <a:pt x="129766" y="201400"/>
                    <a:pt x="114300" y="219075"/>
                  </a:cubicBezTo>
                  <a:cubicBezTo>
                    <a:pt x="109274" y="224818"/>
                    <a:pt x="105833" y="231775"/>
                    <a:pt x="101600" y="238125"/>
                  </a:cubicBezTo>
                  <a:lnTo>
                    <a:pt x="88900" y="257175"/>
                  </a:lnTo>
                  <a:cubicBezTo>
                    <a:pt x="78837" y="272269"/>
                    <a:pt x="83757" y="263080"/>
                    <a:pt x="76200" y="285750"/>
                  </a:cubicBezTo>
                  <a:cubicBezTo>
                    <a:pt x="75142" y="288925"/>
                    <a:pt x="74881" y="292490"/>
                    <a:pt x="73025" y="295275"/>
                  </a:cubicBezTo>
                  <a:cubicBezTo>
                    <a:pt x="68792" y="301625"/>
                    <a:pt x="62738" y="307085"/>
                    <a:pt x="60325" y="314325"/>
                  </a:cubicBezTo>
                  <a:cubicBezTo>
                    <a:pt x="59267" y="317500"/>
                    <a:pt x="58647" y="320857"/>
                    <a:pt x="57150" y="323850"/>
                  </a:cubicBezTo>
                  <a:cubicBezTo>
                    <a:pt x="55443" y="327263"/>
                    <a:pt x="52507" y="329962"/>
                    <a:pt x="50800" y="333375"/>
                  </a:cubicBezTo>
                  <a:cubicBezTo>
                    <a:pt x="49303" y="336368"/>
                    <a:pt x="49250" y="339974"/>
                    <a:pt x="47625" y="342900"/>
                  </a:cubicBezTo>
                  <a:cubicBezTo>
                    <a:pt x="27109" y="379829"/>
                    <a:pt x="40937" y="343914"/>
                    <a:pt x="28575" y="381000"/>
                  </a:cubicBezTo>
                  <a:lnTo>
                    <a:pt x="22225" y="400050"/>
                  </a:lnTo>
                  <a:lnTo>
                    <a:pt x="19050" y="409575"/>
                  </a:lnTo>
                  <a:cubicBezTo>
                    <a:pt x="17992" y="416983"/>
                    <a:pt x="17105" y="424418"/>
                    <a:pt x="15875" y="431800"/>
                  </a:cubicBezTo>
                  <a:cubicBezTo>
                    <a:pt x="14988" y="437123"/>
                    <a:pt x="13587" y="442352"/>
                    <a:pt x="12700" y="447675"/>
                  </a:cubicBezTo>
                  <a:cubicBezTo>
                    <a:pt x="10045" y="463604"/>
                    <a:pt x="8041" y="487052"/>
                    <a:pt x="3175" y="501650"/>
                  </a:cubicBezTo>
                  <a:lnTo>
                    <a:pt x="0" y="511175"/>
                  </a:lnTo>
                  <a:cubicBezTo>
                    <a:pt x="1058" y="524933"/>
                    <a:pt x="1463" y="538758"/>
                    <a:pt x="3175" y="552450"/>
                  </a:cubicBezTo>
                  <a:cubicBezTo>
                    <a:pt x="4505" y="563091"/>
                    <a:pt x="7973" y="562046"/>
                    <a:pt x="12700" y="571500"/>
                  </a:cubicBezTo>
                  <a:cubicBezTo>
                    <a:pt x="14197" y="574493"/>
                    <a:pt x="14378" y="578032"/>
                    <a:pt x="15875" y="581025"/>
                  </a:cubicBezTo>
                  <a:cubicBezTo>
                    <a:pt x="17582" y="584438"/>
                    <a:pt x="20675" y="587063"/>
                    <a:pt x="22225" y="590550"/>
                  </a:cubicBezTo>
                  <a:cubicBezTo>
                    <a:pt x="24943" y="596667"/>
                    <a:pt x="26458" y="603250"/>
                    <a:pt x="28575" y="609600"/>
                  </a:cubicBezTo>
                  <a:lnTo>
                    <a:pt x="34925" y="628650"/>
                  </a:lnTo>
                  <a:cubicBezTo>
                    <a:pt x="36345" y="632910"/>
                    <a:pt x="41275" y="635000"/>
                    <a:pt x="44450" y="638175"/>
                  </a:cubicBezTo>
                  <a:lnTo>
                    <a:pt x="50800" y="657225"/>
                  </a:lnTo>
                  <a:lnTo>
                    <a:pt x="69850" y="685800"/>
                  </a:lnTo>
                  <a:cubicBezTo>
                    <a:pt x="73563" y="691369"/>
                    <a:pt x="74083" y="698500"/>
                    <a:pt x="76200" y="704850"/>
                  </a:cubicBezTo>
                  <a:cubicBezTo>
                    <a:pt x="77580" y="708990"/>
                    <a:pt x="78176" y="713354"/>
                    <a:pt x="79375" y="717550"/>
                  </a:cubicBezTo>
                  <a:cubicBezTo>
                    <a:pt x="80294" y="720768"/>
                    <a:pt x="81738" y="723828"/>
                    <a:pt x="82550" y="727075"/>
                  </a:cubicBezTo>
                  <a:cubicBezTo>
                    <a:pt x="85645" y="739455"/>
                    <a:pt x="87108" y="752630"/>
                    <a:pt x="88900" y="765175"/>
                  </a:cubicBezTo>
                  <a:cubicBezTo>
                    <a:pt x="89958" y="785283"/>
                    <a:pt x="90331" y="805440"/>
                    <a:pt x="92075" y="825500"/>
                  </a:cubicBezTo>
                  <a:cubicBezTo>
                    <a:pt x="92453" y="829847"/>
                    <a:pt x="94336" y="833933"/>
                    <a:pt x="95250" y="838200"/>
                  </a:cubicBezTo>
                  <a:cubicBezTo>
                    <a:pt x="97511" y="848753"/>
                    <a:pt x="99483" y="859367"/>
                    <a:pt x="101600" y="869950"/>
                  </a:cubicBezTo>
                  <a:cubicBezTo>
                    <a:pt x="112396" y="923931"/>
                    <a:pt x="101919" y="851858"/>
                    <a:pt x="120650" y="908050"/>
                  </a:cubicBezTo>
                  <a:cubicBezTo>
                    <a:pt x="121708" y="911225"/>
                    <a:pt x="122328" y="914582"/>
                    <a:pt x="123825" y="917575"/>
                  </a:cubicBezTo>
                  <a:cubicBezTo>
                    <a:pt x="128245" y="926416"/>
                    <a:pt x="132678" y="929603"/>
                    <a:pt x="139700" y="936625"/>
                  </a:cubicBezTo>
                  <a:cubicBezTo>
                    <a:pt x="142065" y="943720"/>
                    <a:pt x="145297" y="958985"/>
                    <a:pt x="152400" y="965200"/>
                  </a:cubicBezTo>
                  <a:cubicBezTo>
                    <a:pt x="158143" y="970226"/>
                    <a:pt x="171450" y="977900"/>
                    <a:pt x="171450" y="977900"/>
                  </a:cubicBezTo>
                  <a:cubicBezTo>
                    <a:pt x="186267" y="1000125"/>
                    <a:pt x="177800" y="992717"/>
                    <a:pt x="193675" y="1003300"/>
                  </a:cubicBezTo>
                  <a:cubicBezTo>
                    <a:pt x="195792" y="1006475"/>
                    <a:pt x="197327" y="1010127"/>
                    <a:pt x="200025" y="1012825"/>
                  </a:cubicBezTo>
                  <a:cubicBezTo>
                    <a:pt x="202723" y="1015523"/>
                    <a:pt x="206445" y="1016957"/>
                    <a:pt x="209550" y="1019175"/>
                  </a:cubicBezTo>
                  <a:cubicBezTo>
                    <a:pt x="242459" y="1042682"/>
                    <a:pt x="197506" y="1012204"/>
                    <a:pt x="241300" y="1041400"/>
                  </a:cubicBezTo>
                  <a:cubicBezTo>
                    <a:pt x="247650" y="1045633"/>
                    <a:pt x="253878" y="1050055"/>
                    <a:pt x="260350" y="1054100"/>
                  </a:cubicBezTo>
                  <a:cubicBezTo>
                    <a:pt x="265583" y="1057371"/>
                    <a:pt x="271090" y="1060202"/>
                    <a:pt x="276225" y="1063625"/>
                  </a:cubicBezTo>
                  <a:cubicBezTo>
                    <a:pt x="288535" y="1071831"/>
                    <a:pt x="282130" y="1068768"/>
                    <a:pt x="295275" y="1073150"/>
                  </a:cubicBezTo>
                  <a:cubicBezTo>
                    <a:pt x="310369" y="1083213"/>
                    <a:pt x="301180" y="1078293"/>
                    <a:pt x="323850" y="1085850"/>
                  </a:cubicBezTo>
                  <a:lnTo>
                    <a:pt x="352425" y="1095375"/>
                  </a:lnTo>
                  <a:cubicBezTo>
                    <a:pt x="358532" y="1097411"/>
                    <a:pt x="365162" y="1097287"/>
                    <a:pt x="371475" y="1098550"/>
                  </a:cubicBezTo>
                  <a:cubicBezTo>
                    <a:pt x="375754" y="1099406"/>
                    <a:pt x="379942" y="1100667"/>
                    <a:pt x="384175" y="1101725"/>
                  </a:cubicBezTo>
                  <a:cubicBezTo>
                    <a:pt x="411472" y="1119923"/>
                    <a:pt x="376935" y="1098105"/>
                    <a:pt x="403225" y="1111250"/>
                  </a:cubicBezTo>
                  <a:cubicBezTo>
                    <a:pt x="406638" y="1112957"/>
                    <a:pt x="409263" y="1116050"/>
                    <a:pt x="412750" y="1117600"/>
                  </a:cubicBezTo>
                  <a:cubicBezTo>
                    <a:pt x="418867" y="1120318"/>
                    <a:pt x="425450" y="1121833"/>
                    <a:pt x="431800" y="1123950"/>
                  </a:cubicBezTo>
                  <a:lnTo>
                    <a:pt x="441325" y="1127125"/>
                  </a:lnTo>
                  <a:cubicBezTo>
                    <a:pt x="444500" y="1129242"/>
                    <a:pt x="447343" y="1131972"/>
                    <a:pt x="450850" y="1133475"/>
                  </a:cubicBezTo>
                  <a:cubicBezTo>
                    <a:pt x="454861" y="1135194"/>
                    <a:pt x="459271" y="1135794"/>
                    <a:pt x="463550" y="1136650"/>
                  </a:cubicBezTo>
                  <a:cubicBezTo>
                    <a:pt x="502474" y="1144435"/>
                    <a:pt x="465801" y="1135625"/>
                    <a:pt x="495300" y="1143000"/>
                  </a:cubicBezTo>
                  <a:cubicBezTo>
                    <a:pt x="536575" y="1141942"/>
                    <a:pt x="577914" y="1142348"/>
                    <a:pt x="619125" y="1139825"/>
                  </a:cubicBezTo>
                  <a:cubicBezTo>
                    <a:pt x="646021" y="1138178"/>
                    <a:pt x="643159" y="1135226"/>
                    <a:pt x="660400" y="1130300"/>
                  </a:cubicBezTo>
                  <a:cubicBezTo>
                    <a:pt x="664596" y="1129101"/>
                    <a:pt x="668904" y="1128324"/>
                    <a:pt x="673100" y="1127125"/>
                  </a:cubicBezTo>
                  <a:cubicBezTo>
                    <a:pt x="676318" y="1126206"/>
                    <a:pt x="679407" y="1124869"/>
                    <a:pt x="682625" y="1123950"/>
                  </a:cubicBezTo>
                  <a:cubicBezTo>
                    <a:pt x="710532" y="1115977"/>
                    <a:pt x="682012" y="1125213"/>
                    <a:pt x="704850" y="1117600"/>
                  </a:cubicBezTo>
                  <a:cubicBezTo>
                    <a:pt x="732147" y="1099402"/>
                    <a:pt x="697610" y="1121220"/>
                    <a:pt x="723900" y="1108075"/>
                  </a:cubicBezTo>
                  <a:cubicBezTo>
                    <a:pt x="745826" y="1097112"/>
                    <a:pt x="719694" y="1105158"/>
                    <a:pt x="746125" y="1098550"/>
                  </a:cubicBezTo>
                  <a:cubicBezTo>
                    <a:pt x="761219" y="1088487"/>
                    <a:pt x="752030" y="1093407"/>
                    <a:pt x="774700" y="1085850"/>
                  </a:cubicBezTo>
                  <a:cubicBezTo>
                    <a:pt x="791399" y="1080284"/>
                    <a:pt x="782990" y="1080118"/>
                    <a:pt x="796925" y="1073150"/>
                  </a:cubicBezTo>
                  <a:cubicBezTo>
                    <a:pt x="799918" y="1071653"/>
                    <a:pt x="803275" y="1071033"/>
                    <a:pt x="806450" y="1069975"/>
                  </a:cubicBezTo>
                  <a:cubicBezTo>
                    <a:pt x="809625" y="1067858"/>
                    <a:pt x="813044" y="1066068"/>
                    <a:pt x="815975" y="1063625"/>
                  </a:cubicBezTo>
                  <a:cubicBezTo>
                    <a:pt x="819424" y="1060750"/>
                    <a:pt x="821764" y="1056591"/>
                    <a:pt x="825500" y="1054100"/>
                  </a:cubicBezTo>
                  <a:cubicBezTo>
                    <a:pt x="828285" y="1052244"/>
                    <a:pt x="831850" y="1051983"/>
                    <a:pt x="835025" y="1050925"/>
                  </a:cubicBezTo>
                  <a:cubicBezTo>
                    <a:pt x="862322" y="1032727"/>
                    <a:pt x="827785" y="1054545"/>
                    <a:pt x="854075" y="1041400"/>
                  </a:cubicBezTo>
                  <a:cubicBezTo>
                    <a:pt x="857488" y="1039693"/>
                    <a:pt x="860113" y="1036600"/>
                    <a:pt x="863600" y="1035050"/>
                  </a:cubicBezTo>
                  <a:cubicBezTo>
                    <a:pt x="869717" y="1032332"/>
                    <a:pt x="882650" y="1028700"/>
                    <a:pt x="882650" y="1028700"/>
                  </a:cubicBezTo>
                  <a:cubicBezTo>
                    <a:pt x="909947" y="1010502"/>
                    <a:pt x="875410" y="1032320"/>
                    <a:pt x="901700" y="1019175"/>
                  </a:cubicBezTo>
                  <a:cubicBezTo>
                    <a:pt x="905113" y="1017468"/>
                    <a:pt x="907738" y="1014375"/>
                    <a:pt x="911225" y="1012825"/>
                  </a:cubicBezTo>
                  <a:cubicBezTo>
                    <a:pt x="917342" y="1010107"/>
                    <a:pt x="930275" y="1006475"/>
                    <a:pt x="930275" y="1006475"/>
                  </a:cubicBezTo>
                  <a:lnTo>
                    <a:pt x="958850" y="987425"/>
                  </a:lnTo>
                  <a:cubicBezTo>
                    <a:pt x="961635" y="985569"/>
                    <a:pt x="965200" y="985308"/>
                    <a:pt x="968375" y="984250"/>
                  </a:cubicBezTo>
                  <a:cubicBezTo>
                    <a:pt x="971550" y="981075"/>
                    <a:pt x="974356" y="977482"/>
                    <a:pt x="977900" y="974725"/>
                  </a:cubicBezTo>
                  <a:cubicBezTo>
                    <a:pt x="983924" y="970040"/>
                    <a:pt x="996950" y="962025"/>
                    <a:pt x="996950" y="962025"/>
                  </a:cubicBezTo>
                  <a:cubicBezTo>
                    <a:pt x="1008683" y="944426"/>
                    <a:pt x="996587" y="958346"/>
                    <a:pt x="1012825" y="949325"/>
                  </a:cubicBezTo>
                  <a:lnTo>
                    <a:pt x="1041400" y="930275"/>
                  </a:lnTo>
                  <a:cubicBezTo>
                    <a:pt x="1045803" y="927340"/>
                    <a:pt x="1049506" y="923375"/>
                    <a:pt x="1054100" y="920750"/>
                  </a:cubicBezTo>
                  <a:cubicBezTo>
                    <a:pt x="1057006" y="919090"/>
                    <a:pt x="1060450" y="918633"/>
                    <a:pt x="1063625" y="917575"/>
                  </a:cubicBezTo>
                  <a:cubicBezTo>
                    <a:pt x="1068240" y="903731"/>
                    <a:pt x="1067939" y="899063"/>
                    <a:pt x="1076325" y="889000"/>
                  </a:cubicBezTo>
                  <a:cubicBezTo>
                    <a:pt x="1079200" y="885551"/>
                    <a:pt x="1082306" y="882232"/>
                    <a:pt x="1085850" y="879475"/>
                  </a:cubicBezTo>
                  <a:cubicBezTo>
                    <a:pt x="1091874" y="874790"/>
                    <a:pt x="1104900" y="866775"/>
                    <a:pt x="1104900" y="866775"/>
                  </a:cubicBezTo>
                  <a:cubicBezTo>
                    <a:pt x="1107017" y="863600"/>
                    <a:pt x="1108715" y="860102"/>
                    <a:pt x="1111250" y="857250"/>
                  </a:cubicBezTo>
                  <a:cubicBezTo>
                    <a:pt x="1117216" y="850538"/>
                    <a:pt x="1130300" y="838200"/>
                    <a:pt x="1130300" y="838200"/>
                  </a:cubicBezTo>
                  <a:cubicBezTo>
                    <a:pt x="1137849" y="815552"/>
                    <a:pt x="1127145" y="842933"/>
                    <a:pt x="1143000" y="819150"/>
                  </a:cubicBezTo>
                  <a:cubicBezTo>
                    <a:pt x="1144856" y="816365"/>
                    <a:pt x="1144678" y="812618"/>
                    <a:pt x="1146175" y="809625"/>
                  </a:cubicBezTo>
                  <a:cubicBezTo>
                    <a:pt x="1147882" y="806212"/>
                    <a:pt x="1150975" y="803587"/>
                    <a:pt x="1152525" y="800100"/>
                  </a:cubicBezTo>
                  <a:cubicBezTo>
                    <a:pt x="1155243" y="793983"/>
                    <a:pt x="1156758" y="787400"/>
                    <a:pt x="1158875" y="781050"/>
                  </a:cubicBezTo>
                  <a:cubicBezTo>
                    <a:pt x="1159933" y="777875"/>
                    <a:pt x="1159265" y="773381"/>
                    <a:pt x="1162050" y="771525"/>
                  </a:cubicBezTo>
                  <a:lnTo>
                    <a:pt x="1171575" y="765175"/>
                  </a:lnTo>
                  <a:lnTo>
                    <a:pt x="1181100" y="736600"/>
                  </a:lnTo>
                  <a:lnTo>
                    <a:pt x="1184275" y="727075"/>
                  </a:lnTo>
                  <a:lnTo>
                    <a:pt x="1187450" y="717550"/>
                  </a:lnTo>
                  <a:cubicBezTo>
                    <a:pt x="1186392" y="712258"/>
                    <a:pt x="1185695" y="706881"/>
                    <a:pt x="1184275" y="701675"/>
                  </a:cubicBezTo>
                  <a:lnTo>
                    <a:pt x="1174750" y="673100"/>
                  </a:lnTo>
                  <a:lnTo>
                    <a:pt x="1171575" y="663575"/>
                  </a:lnTo>
                  <a:lnTo>
                    <a:pt x="1168400" y="654050"/>
                  </a:lnTo>
                  <a:cubicBezTo>
                    <a:pt x="1167342" y="627592"/>
                    <a:pt x="1167776" y="601031"/>
                    <a:pt x="1165225" y="574675"/>
                  </a:cubicBezTo>
                  <a:cubicBezTo>
                    <a:pt x="1164580" y="568013"/>
                    <a:pt x="1160992" y="561975"/>
                    <a:pt x="1158875" y="555625"/>
                  </a:cubicBezTo>
                  <a:cubicBezTo>
                    <a:pt x="1153287" y="538860"/>
                    <a:pt x="1157556" y="548885"/>
                    <a:pt x="1143000" y="527050"/>
                  </a:cubicBezTo>
                  <a:cubicBezTo>
                    <a:pt x="1140883" y="523875"/>
                    <a:pt x="1137857" y="521145"/>
                    <a:pt x="1136650" y="517525"/>
                  </a:cubicBezTo>
                  <a:cubicBezTo>
                    <a:pt x="1135592" y="514350"/>
                    <a:pt x="1135100" y="510926"/>
                    <a:pt x="1133475" y="508000"/>
                  </a:cubicBezTo>
                  <a:cubicBezTo>
                    <a:pt x="1120098" y="483921"/>
                    <a:pt x="1122671" y="497174"/>
                    <a:pt x="1117600" y="479425"/>
                  </a:cubicBezTo>
                  <a:cubicBezTo>
                    <a:pt x="1116401" y="475229"/>
                    <a:pt x="1115372" y="470985"/>
                    <a:pt x="1114425" y="466725"/>
                  </a:cubicBezTo>
                  <a:cubicBezTo>
                    <a:pt x="1113254" y="461457"/>
                    <a:pt x="1112670" y="456056"/>
                    <a:pt x="1111250" y="450850"/>
                  </a:cubicBezTo>
                  <a:cubicBezTo>
                    <a:pt x="1109489" y="444392"/>
                    <a:pt x="1107017" y="438150"/>
                    <a:pt x="1104900" y="431800"/>
                  </a:cubicBezTo>
                  <a:lnTo>
                    <a:pt x="1092200" y="393700"/>
                  </a:lnTo>
                  <a:cubicBezTo>
                    <a:pt x="1090993" y="390080"/>
                    <a:pt x="1087400" y="387662"/>
                    <a:pt x="1085850" y="384175"/>
                  </a:cubicBezTo>
                  <a:cubicBezTo>
                    <a:pt x="1083132" y="378058"/>
                    <a:pt x="1081617" y="371475"/>
                    <a:pt x="1079500" y="365125"/>
                  </a:cubicBezTo>
                  <a:lnTo>
                    <a:pt x="1066800" y="327025"/>
                  </a:lnTo>
                  <a:cubicBezTo>
                    <a:pt x="1065593" y="323405"/>
                    <a:pt x="1062000" y="320987"/>
                    <a:pt x="1060450" y="317500"/>
                  </a:cubicBezTo>
                  <a:cubicBezTo>
                    <a:pt x="1045337" y="283495"/>
                    <a:pt x="1062121" y="310481"/>
                    <a:pt x="1047750" y="288925"/>
                  </a:cubicBezTo>
                  <a:cubicBezTo>
                    <a:pt x="1046692" y="284692"/>
                    <a:pt x="1046294" y="280236"/>
                    <a:pt x="1044575" y="276225"/>
                  </a:cubicBezTo>
                  <a:cubicBezTo>
                    <a:pt x="1039934" y="265395"/>
                    <a:pt x="1035982" y="266537"/>
                    <a:pt x="1028700" y="257175"/>
                  </a:cubicBezTo>
                  <a:cubicBezTo>
                    <a:pt x="1024015" y="251151"/>
                    <a:pt x="1022350" y="242358"/>
                    <a:pt x="1016000" y="238125"/>
                  </a:cubicBezTo>
                  <a:cubicBezTo>
                    <a:pt x="1012825" y="236008"/>
                    <a:pt x="1009406" y="234218"/>
                    <a:pt x="1006475" y="231775"/>
                  </a:cubicBezTo>
                  <a:cubicBezTo>
                    <a:pt x="995942" y="222998"/>
                    <a:pt x="999249" y="221812"/>
                    <a:pt x="987425" y="215900"/>
                  </a:cubicBezTo>
                  <a:cubicBezTo>
                    <a:pt x="984432" y="214403"/>
                    <a:pt x="981075" y="213783"/>
                    <a:pt x="977900" y="212725"/>
                  </a:cubicBezTo>
                  <a:cubicBezTo>
                    <a:pt x="971550" y="208492"/>
                    <a:pt x="961263" y="207265"/>
                    <a:pt x="958850" y="200025"/>
                  </a:cubicBezTo>
                  <a:cubicBezTo>
                    <a:pt x="953262" y="183260"/>
                    <a:pt x="957531" y="193285"/>
                    <a:pt x="942975" y="171450"/>
                  </a:cubicBezTo>
                  <a:lnTo>
                    <a:pt x="930275" y="152400"/>
                  </a:lnTo>
                  <a:cubicBezTo>
                    <a:pt x="928158" y="149225"/>
                    <a:pt x="923925" y="148167"/>
                    <a:pt x="920750" y="146050"/>
                  </a:cubicBezTo>
                  <a:cubicBezTo>
                    <a:pt x="919692" y="142875"/>
                    <a:pt x="919942" y="138892"/>
                    <a:pt x="917575" y="136525"/>
                  </a:cubicBezTo>
                  <a:cubicBezTo>
                    <a:pt x="903721" y="122671"/>
                    <a:pt x="900882" y="124952"/>
                    <a:pt x="885825" y="120650"/>
                  </a:cubicBezTo>
                  <a:cubicBezTo>
                    <a:pt x="882607" y="119731"/>
                    <a:pt x="879640" y="117684"/>
                    <a:pt x="876300" y="117475"/>
                  </a:cubicBezTo>
                  <a:cubicBezTo>
                    <a:pt x="862568" y="116617"/>
                    <a:pt x="863071" y="119063"/>
                    <a:pt x="857250" y="117475"/>
                  </a:cubicBezTo>
                  <a:close/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52" name="フリーフォーム 151"/>
            <p:cNvSpPr/>
            <p:nvPr/>
          </p:nvSpPr>
          <p:spPr>
            <a:xfrm>
              <a:off x="1997348" y="4311749"/>
              <a:ext cx="1187450" cy="1143000"/>
            </a:xfrm>
            <a:custGeom>
              <a:avLst/>
              <a:gdLst>
                <a:gd name="connsiteX0" fmla="*/ 857250 w 1187450"/>
                <a:gd name="connsiteY0" fmla="*/ 117475 h 1143000"/>
                <a:gd name="connsiteX1" fmla="*/ 841375 w 1187450"/>
                <a:gd name="connsiteY1" fmla="*/ 107950 h 1143000"/>
                <a:gd name="connsiteX2" fmla="*/ 765175 w 1187450"/>
                <a:gd name="connsiteY2" fmla="*/ 98425 h 1143000"/>
                <a:gd name="connsiteX3" fmla="*/ 755650 w 1187450"/>
                <a:gd name="connsiteY3" fmla="*/ 95250 h 1143000"/>
                <a:gd name="connsiteX4" fmla="*/ 736600 w 1187450"/>
                <a:gd name="connsiteY4" fmla="*/ 82550 h 1143000"/>
                <a:gd name="connsiteX5" fmla="*/ 720725 w 1187450"/>
                <a:gd name="connsiteY5" fmla="*/ 69850 h 1143000"/>
                <a:gd name="connsiteX6" fmla="*/ 701675 w 1187450"/>
                <a:gd name="connsiteY6" fmla="*/ 57150 h 1143000"/>
                <a:gd name="connsiteX7" fmla="*/ 695325 w 1187450"/>
                <a:gd name="connsiteY7" fmla="*/ 47625 h 1143000"/>
                <a:gd name="connsiteX8" fmla="*/ 676275 w 1187450"/>
                <a:gd name="connsiteY8" fmla="*/ 38100 h 1143000"/>
                <a:gd name="connsiteX9" fmla="*/ 657225 w 1187450"/>
                <a:gd name="connsiteY9" fmla="*/ 22225 h 1143000"/>
                <a:gd name="connsiteX10" fmla="*/ 638175 w 1187450"/>
                <a:gd name="connsiteY10" fmla="*/ 15875 h 1143000"/>
                <a:gd name="connsiteX11" fmla="*/ 628650 w 1187450"/>
                <a:gd name="connsiteY11" fmla="*/ 12700 h 1143000"/>
                <a:gd name="connsiteX12" fmla="*/ 619125 w 1187450"/>
                <a:gd name="connsiteY12" fmla="*/ 6350 h 1143000"/>
                <a:gd name="connsiteX13" fmla="*/ 596900 w 1187450"/>
                <a:gd name="connsiteY13" fmla="*/ 0 h 1143000"/>
                <a:gd name="connsiteX14" fmla="*/ 539750 w 1187450"/>
                <a:gd name="connsiteY14" fmla="*/ 3175 h 1143000"/>
                <a:gd name="connsiteX15" fmla="*/ 520700 w 1187450"/>
                <a:gd name="connsiteY15" fmla="*/ 9525 h 1143000"/>
                <a:gd name="connsiteX16" fmla="*/ 511175 w 1187450"/>
                <a:gd name="connsiteY16" fmla="*/ 12700 h 1143000"/>
                <a:gd name="connsiteX17" fmla="*/ 501650 w 1187450"/>
                <a:gd name="connsiteY17" fmla="*/ 15875 h 1143000"/>
                <a:gd name="connsiteX18" fmla="*/ 482600 w 1187450"/>
                <a:gd name="connsiteY18" fmla="*/ 19050 h 1143000"/>
                <a:gd name="connsiteX19" fmla="*/ 444500 w 1187450"/>
                <a:gd name="connsiteY19" fmla="*/ 28575 h 1143000"/>
                <a:gd name="connsiteX20" fmla="*/ 431800 w 1187450"/>
                <a:gd name="connsiteY20" fmla="*/ 31750 h 1143000"/>
                <a:gd name="connsiteX21" fmla="*/ 409575 w 1187450"/>
                <a:gd name="connsiteY21" fmla="*/ 38100 h 1143000"/>
                <a:gd name="connsiteX22" fmla="*/ 381000 w 1187450"/>
                <a:gd name="connsiteY22" fmla="*/ 41275 h 1143000"/>
                <a:gd name="connsiteX23" fmla="*/ 361950 w 1187450"/>
                <a:gd name="connsiteY23" fmla="*/ 47625 h 1143000"/>
                <a:gd name="connsiteX24" fmla="*/ 352425 w 1187450"/>
                <a:gd name="connsiteY24" fmla="*/ 53975 h 1143000"/>
                <a:gd name="connsiteX25" fmla="*/ 333375 w 1187450"/>
                <a:gd name="connsiteY25" fmla="*/ 60325 h 1143000"/>
                <a:gd name="connsiteX26" fmla="*/ 311150 w 1187450"/>
                <a:gd name="connsiteY26" fmla="*/ 69850 h 1143000"/>
                <a:gd name="connsiteX27" fmla="*/ 282575 w 1187450"/>
                <a:gd name="connsiteY27" fmla="*/ 85725 h 1143000"/>
                <a:gd name="connsiteX28" fmla="*/ 276225 w 1187450"/>
                <a:gd name="connsiteY28" fmla="*/ 95250 h 1143000"/>
                <a:gd name="connsiteX29" fmla="*/ 257175 w 1187450"/>
                <a:gd name="connsiteY29" fmla="*/ 101600 h 1143000"/>
                <a:gd name="connsiteX30" fmla="*/ 250825 w 1187450"/>
                <a:gd name="connsiteY30" fmla="*/ 111125 h 1143000"/>
                <a:gd name="connsiteX31" fmla="*/ 222250 w 1187450"/>
                <a:gd name="connsiteY31" fmla="*/ 127000 h 1143000"/>
                <a:gd name="connsiteX32" fmla="*/ 193675 w 1187450"/>
                <a:gd name="connsiteY32" fmla="*/ 149225 h 1143000"/>
                <a:gd name="connsiteX33" fmla="*/ 174625 w 1187450"/>
                <a:gd name="connsiteY33" fmla="*/ 165100 h 1143000"/>
                <a:gd name="connsiteX34" fmla="*/ 146050 w 1187450"/>
                <a:gd name="connsiteY34" fmla="*/ 187325 h 1143000"/>
                <a:gd name="connsiteX35" fmla="*/ 136525 w 1187450"/>
                <a:gd name="connsiteY35" fmla="*/ 196850 h 1143000"/>
                <a:gd name="connsiteX36" fmla="*/ 127000 w 1187450"/>
                <a:gd name="connsiteY36" fmla="*/ 203200 h 1143000"/>
                <a:gd name="connsiteX37" fmla="*/ 114300 w 1187450"/>
                <a:gd name="connsiteY37" fmla="*/ 219075 h 1143000"/>
                <a:gd name="connsiteX38" fmla="*/ 101600 w 1187450"/>
                <a:gd name="connsiteY38" fmla="*/ 238125 h 1143000"/>
                <a:gd name="connsiteX39" fmla="*/ 88900 w 1187450"/>
                <a:gd name="connsiteY39" fmla="*/ 257175 h 1143000"/>
                <a:gd name="connsiteX40" fmla="*/ 76200 w 1187450"/>
                <a:gd name="connsiteY40" fmla="*/ 285750 h 1143000"/>
                <a:gd name="connsiteX41" fmla="*/ 73025 w 1187450"/>
                <a:gd name="connsiteY41" fmla="*/ 295275 h 1143000"/>
                <a:gd name="connsiteX42" fmla="*/ 60325 w 1187450"/>
                <a:gd name="connsiteY42" fmla="*/ 314325 h 1143000"/>
                <a:gd name="connsiteX43" fmla="*/ 57150 w 1187450"/>
                <a:gd name="connsiteY43" fmla="*/ 323850 h 1143000"/>
                <a:gd name="connsiteX44" fmla="*/ 50800 w 1187450"/>
                <a:gd name="connsiteY44" fmla="*/ 333375 h 1143000"/>
                <a:gd name="connsiteX45" fmla="*/ 47625 w 1187450"/>
                <a:gd name="connsiteY45" fmla="*/ 342900 h 1143000"/>
                <a:gd name="connsiteX46" fmla="*/ 28575 w 1187450"/>
                <a:gd name="connsiteY46" fmla="*/ 381000 h 1143000"/>
                <a:gd name="connsiteX47" fmla="*/ 22225 w 1187450"/>
                <a:gd name="connsiteY47" fmla="*/ 400050 h 1143000"/>
                <a:gd name="connsiteX48" fmla="*/ 19050 w 1187450"/>
                <a:gd name="connsiteY48" fmla="*/ 409575 h 1143000"/>
                <a:gd name="connsiteX49" fmla="*/ 15875 w 1187450"/>
                <a:gd name="connsiteY49" fmla="*/ 431800 h 1143000"/>
                <a:gd name="connsiteX50" fmla="*/ 12700 w 1187450"/>
                <a:gd name="connsiteY50" fmla="*/ 447675 h 1143000"/>
                <a:gd name="connsiteX51" fmla="*/ 3175 w 1187450"/>
                <a:gd name="connsiteY51" fmla="*/ 501650 h 1143000"/>
                <a:gd name="connsiteX52" fmla="*/ 0 w 1187450"/>
                <a:gd name="connsiteY52" fmla="*/ 511175 h 1143000"/>
                <a:gd name="connsiteX53" fmla="*/ 3175 w 1187450"/>
                <a:gd name="connsiteY53" fmla="*/ 552450 h 1143000"/>
                <a:gd name="connsiteX54" fmla="*/ 12700 w 1187450"/>
                <a:gd name="connsiteY54" fmla="*/ 571500 h 1143000"/>
                <a:gd name="connsiteX55" fmla="*/ 15875 w 1187450"/>
                <a:gd name="connsiteY55" fmla="*/ 581025 h 1143000"/>
                <a:gd name="connsiteX56" fmla="*/ 22225 w 1187450"/>
                <a:gd name="connsiteY56" fmla="*/ 590550 h 1143000"/>
                <a:gd name="connsiteX57" fmla="*/ 28575 w 1187450"/>
                <a:gd name="connsiteY57" fmla="*/ 609600 h 1143000"/>
                <a:gd name="connsiteX58" fmla="*/ 34925 w 1187450"/>
                <a:gd name="connsiteY58" fmla="*/ 628650 h 1143000"/>
                <a:gd name="connsiteX59" fmla="*/ 44450 w 1187450"/>
                <a:gd name="connsiteY59" fmla="*/ 638175 h 1143000"/>
                <a:gd name="connsiteX60" fmla="*/ 50800 w 1187450"/>
                <a:gd name="connsiteY60" fmla="*/ 657225 h 1143000"/>
                <a:gd name="connsiteX61" fmla="*/ 69850 w 1187450"/>
                <a:gd name="connsiteY61" fmla="*/ 685800 h 1143000"/>
                <a:gd name="connsiteX62" fmla="*/ 76200 w 1187450"/>
                <a:gd name="connsiteY62" fmla="*/ 704850 h 1143000"/>
                <a:gd name="connsiteX63" fmla="*/ 79375 w 1187450"/>
                <a:gd name="connsiteY63" fmla="*/ 717550 h 1143000"/>
                <a:gd name="connsiteX64" fmla="*/ 82550 w 1187450"/>
                <a:gd name="connsiteY64" fmla="*/ 727075 h 1143000"/>
                <a:gd name="connsiteX65" fmla="*/ 88900 w 1187450"/>
                <a:gd name="connsiteY65" fmla="*/ 765175 h 1143000"/>
                <a:gd name="connsiteX66" fmla="*/ 92075 w 1187450"/>
                <a:gd name="connsiteY66" fmla="*/ 825500 h 1143000"/>
                <a:gd name="connsiteX67" fmla="*/ 95250 w 1187450"/>
                <a:gd name="connsiteY67" fmla="*/ 838200 h 1143000"/>
                <a:gd name="connsiteX68" fmla="*/ 101600 w 1187450"/>
                <a:gd name="connsiteY68" fmla="*/ 869950 h 1143000"/>
                <a:gd name="connsiteX69" fmla="*/ 120650 w 1187450"/>
                <a:gd name="connsiteY69" fmla="*/ 908050 h 1143000"/>
                <a:gd name="connsiteX70" fmla="*/ 123825 w 1187450"/>
                <a:gd name="connsiteY70" fmla="*/ 917575 h 1143000"/>
                <a:gd name="connsiteX71" fmla="*/ 139700 w 1187450"/>
                <a:gd name="connsiteY71" fmla="*/ 936625 h 1143000"/>
                <a:gd name="connsiteX72" fmla="*/ 152400 w 1187450"/>
                <a:gd name="connsiteY72" fmla="*/ 965200 h 1143000"/>
                <a:gd name="connsiteX73" fmla="*/ 171450 w 1187450"/>
                <a:gd name="connsiteY73" fmla="*/ 977900 h 1143000"/>
                <a:gd name="connsiteX74" fmla="*/ 193675 w 1187450"/>
                <a:gd name="connsiteY74" fmla="*/ 1003300 h 1143000"/>
                <a:gd name="connsiteX75" fmla="*/ 200025 w 1187450"/>
                <a:gd name="connsiteY75" fmla="*/ 1012825 h 1143000"/>
                <a:gd name="connsiteX76" fmla="*/ 209550 w 1187450"/>
                <a:gd name="connsiteY76" fmla="*/ 1019175 h 1143000"/>
                <a:gd name="connsiteX77" fmla="*/ 241300 w 1187450"/>
                <a:gd name="connsiteY77" fmla="*/ 1041400 h 1143000"/>
                <a:gd name="connsiteX78" fmla="*/ 260350 w 1187450"/>
                <a:gd name="connsiteY78" fmla="*/ 1054100 h 1143000"/>
                <a:gd name="connsiteX79" fmla="*/ 276225 w 1187450"/>
                <a:gd name="connsiteY79" fmla="*/ 1063625 h 1143000"/>
                <a:gd name="connsiteX80" fmla="*/ 295275 w 1187450"/>
                <a:gd name="connsiteY80" fmla="*/ 1073150 h 1143000"/>
                <a:gd name="connsiteX81" fmla="*/ 323850 w 1187450"/>
                <a:gd name="connsiteY81" fmla="*/ 1085850 h 1143000"/>
                <a:gd name="connsiteX82" fmla="*/ 352425 w 1187450"/>
                <a:gd name="connsiteY82" fmla="*/ 1095375 h 1143000"/>
                <a:gd name="connsiteX83" fmla="*/ 371475 w 1187450"/>
                <a:gd name="connsiteY83" fmla="*/ 1098550 h 1143000"/>
                <a:gd name="connsiteX84" fmla="*/ 384175 w 1187450"/>
                <a:gd name="connsiteY84" fmla="*/ 1101725 h 1143000"/>
                <a:gd name="connsiteX85" fmla="*/ 403225 w 1187450"/>
                <a:gd name="connsiteY85" fmla="*/ 1111250 h 1143000"/>
                <a:gd name="connsiteX86" fmla="*/ 412750 w 1187450"/>
                <a:gd name="connsiteY86" fmla="*/ 1117600 h 1143000"/>
                <a:gd name="connsiteX87" fmla="*/ 431800 w 1187450"/>
                <a:gd name="connsiteY87" fmla="*/ 1123950 h 1143000"/>
                <a:gd name="connsiteX88" fmla="*/ 441325 w 1187450"/>
                <a:gd name="connsiteY88" fmla="*/ 1127125 h 1143000"/>
                <a:gd name="connsiteX89" fmla="*/ 450850 w 1187450"/>
                <a:gd name="connsiteY89" fmla="*/ 1133475 h 1143000"/>
                <a:gd name="connsiteX90" fmla="*/ 463550 w 1187450"/>
                <a:gd name="connsiteY90" fmla="*/ 1136650 h 1143000"/>
                <a:gd name="connsiteX91" fmla="*/ 495300 w 1187450"/>
                <a:gd name="connsiteY91" fmla="*/ 1143000 h 1143000"/>
                <a:gd name="connsiteX92" fmla="*/ 619125 w 1187450"/>
                <a:gd name="connsiteY92" fmla="*/ 1139825 h 1143000"/>
                <a:gd name="connsiteX93" fmla="*/ 660400 w 1187450"/>
                <a:gd name="connsiteY93" fmla="*/ 1130300 h 1143000"/>
                <a:gd name="connsiteX94" fmla="*/ 673100 w 1187450"/>
                <a:gd name="connsiteY94" fmla="*/ 1127125 h 1143000"/>
                <a:gd name="connsiteX95" fmla="*/ 682625 w 1187450"/>
                <a:gd name="connsiteY95" fmla="*/ 1123950 h 1143000"/>
                <a:gd name="connsiteX96" fmla="*/ 704850 w 1187450"/>
                <a:gd name="connsiteY96" fmla="*/ 1117600 h 1143000"/>
                <a:gd name="connsiteX97" fmla="*/ 723900 w 1187450"/>
                <a:gd name="connsiteY97" fmla="*/ 1108075 h 1143000"/>
                <a:gd name="connsiteX98" fmla="*/ 746125 w 1187450"/>
                <a:gd name="connsiteY98" fmla="*/ 1098550 h 1143000"/>
                <a:gd name="connsiteX99" fmla="*/ 774700 w 1187450"/>
                <a:gd name="connsiteY99" fmla="*/ 1085850 h 1143000"/>
                <a:gd name="connsiteX100" fmla="*/ 796925 w 1187450"/>
                <a:gd name="connsiteY100" fmla="*/ 1073150 h 1143000"/>
                <a:gd name="connsiteX101" fmla="*/ 806450 w 1187450"/>
                <a:gd name="connsiteY101" fmla="*/ 1069975 h 1143000"/>
                <a:gd name="connsiteX102" fmla="*/ 815975 w 1187450"/>
                <a:gd name="connsiteY102" fmla="*/ 1063625 h 1143000"/>
                <a:gd name="connsiteX103" fmla="*/ 825500 w 1187450"/>
                <a:gd name="connsiteY103" fmla="*/ 1054100 h 1143000"/>
                <a:gd name="connsiteX104" fmla="*/ 835025 w 1187450"/>
                <a:gd name="connsiteY104" fmla="*/ 1050925 h 1143000"/>
                <a:gd name="connsiteX105" fmla="*/ 854075 w 1187450"/>
                <a:gd name="connsiteY105" fmla="*/ 1041400 h 1143000"/>
                <a:gd name="connsiteX106" fmla="*/ 863600 w 1187450"/>
                <a:gd name="connsiteY106" fmla="*/ 1035050 h 1143000"/>
                <a:gd name="connsiteX107" fmla="*/ 882650 w 1187450"/>
                <a:gd name="connsiteY107" fmla="*/ 1028700 h 1143000"/>
                <a:gd name="connsiteX108" fmla="*/ 901700 w 1187450"/>
                <a:gd name="connsiteY108" fmla="*/ 1019175 h 1143000"/>
                <a:gd name="connsiteX109" fmla="*/ 911225 w 1187450"/>
                <a:gd name="connsiteY109" fmla="*/ 1012825 h 1143000"/>
                <a:gd name="connsiteX110" fmla="*/ 930275 w 1187450"/>
                <a:gd name="connsiteY110" fmla="*/ 1006475 h 1143000"/>
                <a:gd name="connsiteX111" fmla="*/ 958850 w 1187450"/>
                <a:gd name="connsiteY111" fmla="*/ 987425 h 1143000"/>
                <a:gd name="connsiteX112" fmla="*/ 968375 w 1187450"/>
                <a:gd name="connsiteY112" fmla="*/ 984250 h 1143000"/>
                <a:gd name="connsiteX113" fmla="*/ 977900 w 1187450"/>
                <a:gd name="connsiteY113" fmla="*/ 974725 h 1143000"/>
                <a:gd name="connsiteX114" fmla="*/ 996950 w 1187450"/>
                <a:gd name="connsiteY114" fmla="*/ 962025 h 1143000"/>
                <a:gd name="connsiteX115" fmla="*/ 1012825 w 1187450"/>
                <a:gd name="connsiteY115" fmla="*/ 949325 h 1143000"/>
                <a:gd name="connsiteX116" fmla="*/ 1041400 w 1187450"/>
                <a:gd name="connsiteY116" fmla="*/ 930275 h 1143000"/>
                <a:gd name="connsiteX117" fmla="*/ 1054100 w 1187450"/>
                <a:gd name="connsiteY117" fmla="*/ 920750 h 1143000"/>
                <a:gd name="connsiteX118" fmla="*/ 1063625 w 1187450"/>
                <a:gd name="connsiteY118" fmla="*/ 917575 h 1143000"/>
                <a:gd name="connsiteX119" fmla="*/ 1076325 w 1187450"/>
                <a:gd name="connsiteY119" fmla="*/ 889000 h 1143000"/>
                <a:gd name="connsiteX120" fmla="*/ 1085850 w 1187450"/>
                <a:gd name="connsiteY120" fmla="*/ 879475 h 1143000"/>
                <a:gd name="connsiteX121" fmla="*/ 1104900 w 1187450"/>
                <a:gd name="connsiteY121" fmla="*/ 866775 h 1143000"/>
                <a:gd name="connsiteX122" fmla="*/ 1111250 w 1187450"/>
                <a:gd name="connsiteY122" fmla="*/ 857250 h 1143000"/>
                <a:gd name="connsiteX123" fmla="*/ 1130300 w 1187450"/>
                <a:gd name="connsiteY123" fmla="*/ 838200 h 1143000"/>
                <a:gd name="connsiteX124" fmla="*/ 1143000 w 1187450"/>
                <a:gd name="connsiteY124" fmla="*/ 819150 h 1143000"/>
                <a:gd name="connsiteX125" fmla="*/ 1146175 w 1187450"/>
                <a:gd name="connsiteY125" fmla="*/ 809625 h 1143000"/>
                <a:gd name="connsiteX126" fmla="*/ 1152525 w 1187450"/>
                <a:gd name="connsiteY126" fmla="*/ 800100 h 1143000"/>
                <a:gd name="connsiteX127" fmla="*/ 1158875 w 1187450"/>
                <a:gd name="connsiteY127" fmla="*/ 781050 h 1143000"/>
                <a:gd name="connsiteX128" fmla="*/ 1162050 w 1187450"/>
                <a:gd name="connsiteY128" fmla="*/ 771525 h 1143000"/>
                <a:gd name="connsiteX129" fmla="*/ 1171575 w 1187450"/>
                <a:gd name="connsiteY129" fmla="*/ 765175 h 1143000"/>
                <a:gd name="connsiteX130" fmla="*/ 1181100 w 1187450"/>
                <a:gd name="connsiteY130" fmla="*/ 736600 h 1143000"/>
                <a:gd name="connsiteX131" fmla="*/ 1184275 w 1187450"/>
                <a:gd name="connsiteY131" fmla="*/ 727075 h 1143000"/>
                <a:gd name="connsiteX132" fmla="*/ 1187450 w 1187450"/>
                <a:gd name="connsiteY132" fmla="*/ 717550 h 1143000"/>
                <a:gd name="connsiteX133" fmla="*/ 1184275 w 1187450"/>
                <a:gd name="connsiteY133" fmla="*/ 701675 h 1143000"/>
                <a:gd name="connsiteX134" fmla="*/ 1174750 w 1187450"/>
                <a:gd name="connsiteY134" fmla="*/ 673100 h 1143000"/>
                <a:gd name="connsiteX135" fmla="*/ 1171575 w 1187450"/>
                <a:gd name="connsiteY135" fmla="*/ 663575 h 1143000"/>
                <a:gd name="connsiteX136" fmla="*/ 1168400 w 1187450"/>
                <a:gd name="connsiteY136" fmla="*/ 654050 h 1143000"/>
                <a:gd name="connsiteX137" fmla="*/ 1165225 w 1187450"/>
                <a:gd name="connsiteY137" fmla="*/ 574675 h 1143000"/>
                <a:gd name="connsiteX138" fmla="*/ 1158875 w 1187450"/>
                <a:gd name="connsiteY138" fmla="*/ 555625 h 1143000"/>
                <a:gd name="connsiteX139" fmla="*/ 1143000 w 1187450"/>
                <a:gd name="connsiteY139" fmla="*/ 527050 h 1143000"/>
                <a:gd name="connsiteX140" fmla="*/ 1136650 w 1187450"/>
                <a:gd name="connsiteY140" fmla="*/ 517525 h 1143000"/>
                <a:gd name="connsiteX141" fmla="*/ 1133475 w 1187450"/>
                <a:gd name="connsiteY141" fmla="*/ 508000 h 1143000"/>
                <a:gd name="connsiteX142" fmla="*/ 1117600 w 1187450"/>
                <a:gd name="connsiteY142" fmla="*/ 479425 h 1143000"/>
                <a:gd name="connsiteX143" fmla="*/ 1114425 w 1187450"/>
                <a:gd name="connsiteY143" fmla="*/ 466725 h 1143000"/>
                <a:gd name="connsiteX144" fmla="*/ 1111250 w 1187450"/>
                <a:gd name="connsiteY144" fmla="*/ 450850 h 1143000"/>
                <a:gd name="connsiteX145" fmla="*/ 1104900 w 1187450"/>
                <a:gd name="connsiteY145" fmla="*/ 431800 h 1143000"/>
                <a:gd name="connsiteX146" fmla="*/ 1092200 w 1187450"/>
                <a:gd name="connsiteY146" fmla="*/ 393700 h 1143000"/>
                <a:gd name="connsiteX147" fmla="*/ 1085850 w 1187450"/>
                <a:gd name="connsiteY147" fmla="*/ 384175 h 1143000"/>
                <a:gd name="connsiteX148" fmla="*/ 1079500 w 1187450"/>
                <a:gd name="connsiteY148" fmla="*/ 365125 h 1143000"/>
                <a:gd name="connsiteX149" fmla="*/ 1066800 w 1187450"/>
                <a:gd name="connsiteY149" fmla="*/ 327025 h 1143000"/>
                <a:gd name="connsiteX150" fmla="*/ 1060450 w 1187450"/>
                <a:gd name="connsiteY150" fmla="*/ 317500 h 1143000"/>
                <a:gd name="connsiteX151" fmla="*/ 1047750 w 1187450"/>
                <a:gd name="connsiteY151" fmla="*/ 288925 h 1143000"/>
                <a:gd name="connsiteX152" fmla="*/ 1044575 w 1187450"/>
                <a:gd name="connsiteY152" fmla="*/ 276225 h 1143000"/>
                <a:gd name="connsiteX153" fmla="*/ 1028700 w 1187450"/>
                <a:gd name="connsiteY153" fmla="*/ 257175 h 1143000"/>
                <a:gd name="connsiteX154" fmla="*/ 1016000 w 1187450"/>
                <a:gd name="connsiteY154" fmla="*/ 238125 h 1143000"/>
                <a:gd name="connsiteX155" fmla="*/ 1006475 w 1187450"/>
                <a:gd name="connsiteY155" fmla="*/ 231775 h 1143000"/>
                <a:gd name="connsiteX156" fmla="*/ 987425 w 1187450"/>
                <a:gd name="connsiteY156" fmla="*/ 215900 h 1143000"/>
                <a:gd name="connsiteX157" fmla="*/ 977900 w 1187450"/>
                <a:gd name="connsiteY157" fmla="*/ 212725 h 1143000"/>
                <a:gd name="connsiteX158" fmla="*/ 958850 w 1187450"/>
                <a:gd name="connsiteY158" fmla="*/ 200025 h 1143000"/>
                <a:gd name="connsiteX159" fmla="*/ 942975 w 1187450"/>
                <a:gd name="connsiteY159" fmla="*/ 171450 h 1143000"/>
                <a:gd name="connsiteX160" fmla="*/ 930275 w 1187450"/>
                <a:gd name="connsiteY160" fmla="*/ 152400 h 1143000"/>
                <a:gd name="connsiteX161" fmla="*/ 920750 w 1187450"/>
                <a:gd name="connsiteY161" fmla="*/ 146050 h 1143000"/>
                <a:gd name="connsiteX162" fmla="*/ 917575 w 1187450"/>
                <a:gd name="connsiteY162" fmla="*/ 136525 h 1143000"/>
                <a:gd name="connsiteX163" fmla="*/ 885825 w 1187450"/>
                <a:gd name="connsiteY163" fmla="*/ 120650 h 1143000"/>
                <a:gd name="connsiteX164" fmla="*/ 876300 w 1187450"/>
                <a:gd name="connsiteY164" fmla="*/ 117475 h 1143000"/>
                <a:gd name="connsiteX165" fmla="*/ 857250 w 1187450"/>
                <a:gd name="connsiteY165" fmla="*/ 117475 h 1143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</a:cxnLst>
              <a:rect l="l" t="t" r="r" b="b"/>
              <a:pathLst>
                <a:path w="1187450" h="1143000">
                  <a:moveTo>
                    <a:pt x="857250" y="117475"/>
                  </a:moveTo>
                  <a:cubicBezTo>
                    <a:pt x="851429" y="115887"/>
                    <a:pt x="846993" y="110504"/>
                    <a:pt x="841375" y="107950"/>
                  </a:cubicBezTo>
                  <a:cubicBezTo>
                    <a:pt x="815511" y="96194"/>
                    <a:pt x="796838" y="100184"/>
                    <a:pt x="765175" y="98425"/>
                  </a:cubicBezTo>
                  <a:cubicBezTo>
                    <a:pt x="762000" y="97367"/>
                    <a:pt x="758576" y="96875"/>
                    <a:pt x="755650" y="95250"/>
                  </a:cubicBezTo>
                  <a:cubicBezTo>
                    <a:pt x="748979" y="91544"/>
                    <a:pt x="736600" y="82550"/>
                    <a:pt x="736600" y="82550"/>
                  </a:cubicBezTo>
                  <a:cubicBezTo>
                    <a:pt x="724867" y="64951"/>
                    <a:pt x="736963" y="78871"/>
                    <a:pt x="720725" y="69850"/>
                  </a:cubicBezTo>
                  <a:cubicBezTo>
                    <a:pt x="714054" y="66144"/>
                    <a:pt x="701675" y="57150"/>
                    <a:pt x="701675" y="57150"/>
                  </a:cubicBezTo>
                  <a:cubicBezTo>
                    <a:pt x="699558" y="53975"/>
                    <a:pt x="698023" y="50323"/>
                    <a:pt x="695325" y="47625"/>
                  </a:cubicBezTo>
                  <a:cubicBezTo>
                    <a:pt x="689170" y="41470"/>
                    <a:pt x="684022" y="40682"/>
                    <a:pt x="676275" y="38100"/>
                  </a:cubicBezTo>
                  <a:cubicBezTo>
                    <a:pt x="670293" y="32118"/>
                    <a:pt x="665182" y="25761"/>
                    <a:pt x="657225" y="22225"/>
                  </a:cubicBezTo>
                  <a:cubicBezTo>
                    <a:pt x="651108" y="19507"/>
                    <a:pt x="644525" y="17992"/>
                    <a:pt x="638175" y="15875"/>
                  </a:cubicBezTo>
                  <a:lnTo>
                    <a:pt x="628650" y="12700"/>
                  </a:lnTo>
                  <a:cubicBezTo>
                    <a:pt x="625475" y="10583"/>
                    <a:pt x="622538" y="8057"/>
                    <a:pt x="619125" y="6350"/>
                  </a:cubicBezTo>
                  <a:cubicBezTo>
                    <a:pt x="614570" y="4073"/>
                    <a:pt x="600969" y="1017"/>
                    <a:pt x="596900" y="0"/>
                  </a:cubicBezTo>
                  <a:cubicBezTo>
                    <a:pt x="577850" y="1058"/>
                    <a:pt x="558682" y="808"/>
                    <a:pt x="539750" y="3175"/>
                  </a:cubicBezTo>
                  <a:cubicBezTo>
                    <a:pt x="533108" y="4005"/>
                    <a:pt x="527050" y="7408"/>
                    <a:pt x="520700" y="9525"/>
                  </a:cubicBezTo>
                  <a:lnTo>
                    <a:pt x="511175" y="12700"/>
                  </a:lnTo>
                  <a:cubicBezTo>
                    <a:pt x="508000" y="13758"/>
                    <a:pt x="504951" y="15325"/>
                    <a:pt x="501650" y="15875"/>
                  </a:cubicBezTo>
                  <a:lnTo>
                    <a:pt x="482600" y="19050"/>
                  </a:lnTo>
                  <a:cubicBezTo>
                    <a:pt x="450775" y="29658"/>
                    <a:pt x="476566" y="22162"/>
                    <a:pt x="444500" y="28575"/>
                  </a:cubicBezTo>
                  <a:cubicBezTo>
                    <a:pt x="440221" y="29431"/>
                    <a:pt x="435996" y="30551"/>
                    <a:pt x="431800" y="31750"/>
                  </a:cubicBezTo>
                  <a:cubicBezTo>
                    <a:pt x="422119" y="34516"/>
                    <a:pt x="420328" y="36446"/>
                    <a:pt x="409575" y="38100"/>
                  </a:cubicBezTo>
                  <a:cubicBezTo>
                    <a:pt x="400103" y="39557"/>
                    <a:pt x="390525" y="40217"/>
                    <a:pt x="381000" y="41275"/>
                  </a:cubicBezTo>
                  <a:cubicBezTo>
                    <a:pt x="374650" y="43392"/>
                    <a:pt x="367519" y="43912"/>
                    <a:pt x="361950" y="47625"/>
                  </a:cubicBezTo>
                  <a:cubicBezTo>
                    <a:pt x="358775" y="49742"/>
                    <a:pt x="355912" y="52425"/>
                    <a:pt x="352425" y="53975"/>
                  </a:cubicBezTo>
                  <a:cubicBezTo>
                    <a:pt x="346308" y="56693"/>
                    <a:pt x="333375" y="60325"/>
                    <a:pt x="333375" y="60325"/>
                  </a:cubicBezTo>
                  <a:cubicBezTo>
                    <a:pt x="298705" y="83439"/>
                    <a:pt x="352155" y="49348"/>
                    <a:pt x="311150" y="69850"/>
                  </a:cubicBezTo>
                  <a:cubicBezTo>
                    <a:pt x="267481" y="91685"/>
                    <a:pt x="308915" y="76945"/>
                    <a:pt x="282575" y="85725"/>
                  </a:cubicBezTo>
                  <a:cubicBezTo>
                    <a:pt x="280458" y="88900"/>
                    <a:pt x="279461" y="93228"/>
                    <a:pt x="276225" y="95250"/>
                  </a:cubicBezTo>
                  <a:cubicBezTo>
                    <a:pt x="270549" y="98798"/>
                    <a:pt x="257175" y="101600"/>
                    <a:pt x="257175" y="101600"/>
                  </a:cubicBezTo>
                  <a:cubicBezTo>
                    <a:pt x="255058" y="104775"/>
                    <a:pt x="253697" y="108612"/>
                    <a:pt x="250825" y="111125"/>
                  </a:cubicBezTo>
                  <a:cubicBezTo>
                    <a:pt x="237388" y="122882"/>
                    <a:pt x="235332" y="122639"/>
                    <a:pt x="222250" y="127000"/>
                  </a:cubicBezTo>
                  <a:cubicBezTo>
                    <a:pt x="200833" y="148417"/>
                    <a:pt x="211719" y="143210"/>
                    <a:pt x="193675" y="149225"/>
                  </a:cubicBezTo>
                  <a:cubicBezTo>
                    <a:pt x="165848" y="177052"/>
                    <a:pt x="201147" y="142998"/>
                    <a:pt x="174625" y="165100"/>
                  </a:cubicBezTo>
                  <a:cubicBezTo>
                    <a:pt x="144782" y="189969"/>
                    <a:pt x="194198" y="155227"/>
                    <a:pt x="146050" y="187325"/>
                  </a:cubicBezTo>
                  <a:cubicBezTo>
                    <a:pt x="142314" y="189816"/>
                    <a:pt x="139974" y="193975"/>
                    <a:pt x="136525" y="196850"/>
                  </a:cubicBezTo>
                  <a:cubicBezTo>
                    <a:pt x="133594" y="199293"/>
                    <a:pt x="130175" y="201083"/>
                    <a:pt x="127000" y="203200"/>
                  </a:cubicBezTo>
                  <a:cubicBezTo>
                    <a:pt x="119850" y="224650"/>
                    <a:pt x="129766" y="201400"/>
                    <a:pt x="114300" y="219075"/>
                  </a:cubicBezTo>
                  <a:cubicBezTo>
                    <a:pt x="109274" y="224818"/>
                    <a:pt x="105833" y="231775"/>
                    <a:pt x="101600" y="238125"/>
                  </a:cubicBezTo>
                  <a:lnTo>
                    <a:pt x="88900" y="257175"/>
                  </a:lnTo>
                  <a:cubicBezTo>
                    <a:pt x="78837" y="272269"/>
                    <a:pt x="83757" y="263080"/>
                    <a:pt x="76200" y="285750"/>
                  </a:cubicBezTo>
                  <a:cubicBezTo>
                    <a:pt x="75142" y="288925"/>
                    <a:pt x="74881" y="292490"/>
                    <a:pt x="73025" y="295275"/>
                  </a:cubicBezTo>
                  <a:cubicBezTo>
                    <a:pt x="68792" y="301625"/>
                    <a:pt x="62738" y="307085"/>
                    <a:pt x="60325" y="314325"/>
                  </a:cubicBezTo>
                  <a:cubicBezTo>
                    <a:pt x="59267" y="317500"/>
                    <a:pt x="58647" y="320857"/>
                    <a:pt x="57150" y="323850"/>
                  </a:cubicBezTo>
                  <a:cubicBezTo>
                    <a:pt x="55443" y="327263"/>
                    <a:pt x="52507" y="329962"/>
                    <a:pt x="50800" y="333375"/>
                  </a:cubicBezTo>
                  <a:cubicBezTo>
                    <a:pt x="49303" y="336368"/>
                    <a:pt x="49250" y="339974"/>
                    <a:pt x="47625" y="342900"/>
                  </a:cubicBezTo>
                  <a:cubicBezTo>
                    <a:pt x="27109" y="379829"/>
                    <a:pt x="40937" y="343914"/>
                    <a:pt x="28575" y="381000"/>
                  </a:cubicBezTo>
                  <a:lnTo>
                    <a:pt x="22225" y="400050"/>
                  </a:lnTo>
                  <a:lnTo>
                    <a:pt x="19050" y="409575"/>
                  </a:lnTo>
                  <a:cubicBezTo>
                    <a:pt x="17992" y="416983"/>
                    <a:pt x="17105" y="424418"/>
                    <a:pt x="15875" y="431800"/>
                  </a:cubicBezTo>
                  <a:cubicBezTo>
                    <a:pt x="14988" y="437123"/>
                    <a:pt x="13587" y="442352"/>
                    <a:pt x="12700" y="447675"/>
                  </a:cubicBezTo>
                  <a:cubicBezTo>
                    <a:pt x="10045" y="463604"/>
                    <a:pt x="8041" y="487052"/>
                    <a:pt x="3175" y="501650"/>
                  </a:cubicBezTo>
                  <a:lnTo>
                    <a:pt x="0" y="511175"/>
                  </a:lnTo>
                  <a:cubicBezTo>
                    <a:pt x="1058" y="524933"/>
                    <a:pt x="1463" y="538758"/>
                    <a:pt x="3175" y="552450"/>
                  </a:cubicBezTo>
                  <a:cubicBezTo>
                    <a:pt x="4505" y="563091"/>
                    <a:pt x="7973" y="562046"/>
                    <a:pt x="12700" y="571500"/>
                  </a:cubicBezTo>
                  <a:cubicBezTo>
                    <a:pt x="14197" y="574493"/>
                    <a:pt x="14378" y="578032"/>
                    <a:pt x="15875" y="581025"/>
                  </a:cubicBezTo>
                  <a:cubicBezTo>
                    <a:pt x="17582" y="584438"/>
                    <a:pt x="20675" y="587063"/>
                    <a:pt x="22225" y="590550"/>
                  </a:cubicBezTo>
                  <a:cubicBezTo>
                    <a:pt x="24943" y="596667"/>
                    <a:pt x="26458" y="603250"/>
                    <a:pt x="28575" y="609600"/>
                  </a:cubicBezTo>
                  <a:lnTo>
                    <a:pt x="34925" y="628650"/>
                  </a:lnTo>
                  <a:cubicBezTo>
                    <a:pt x="36345" y="632910"/>
                    <a:pt x="41275" y="635000"/>
                    <a:pt x="44450" y="638175"/>
                  </a:cubicBezTo>
                  <a:lnTo>
                    <a:pt x="50800" y="657225"/>
                  </a:lnTo>
                  <a:lnTo>
                    <a:pt x="69850" y="685800"/>
                  </a:lnTo>
                  <a:cubicBezTo>
                    <a:pt x="73563" y="691369"/>
                    <a:pt x="74083" y="698500"/>
                    <a:pt x="76200" y="704850"/>
                  </a:cubicBezTo>
                  <a:cubicBezTo>
                    <a:pt x="77580" y="708990"/>
                    <a:pt x="78176" y="713354"/>
                    <a:pt x="79375" y="717550"/>
                  </a:cubicBezTo>
                  <a:cubicBezTo>
                    <a:pt x="80294" y="720768"/>
                    <a:pt x="81738" y="723828"/>
                    <a:pt x="82550" y="727075"/>
                  </a:cubicBezTo>
                  <a:cubicBezTo>
                    <a:pt x="85645" y="739455"/>
                    <a:pt x="87108" y="752630"/>
                    <a:pt x="88900" y="765175"/>
                  </a:cubicBezTo>
                  <a:cubicBezTo>
                    <a:pt x="89958" y="785283"/>
                    <a:pt x="90331" y="805440"/>
                    <a:pt x="92075" y="825500"/>
                  </a:cubicBezTo>
                  <a:cubicBezTo>
                    <a:pt x="92453" y="829847"/>
                    <a:pt x="94336" y="833933"/>
                    <a:pt x="95250" y="838200"/>
                  </a:cubicBezTo>
                  <a:cubicBezTo>
                    <a:pt x="97511" y="848753"/>
                    <a:pt x="99483" y="859367"/>
                    <a:pt x="101600" y="869950"/>
                  </a:cubicBezTo>
                  <a:cubicBezTo>
                    <a:pt x="112396" y="923931"/>
                    <a:pt x="101919" y="851858"/>
                    <a:pt x="120650" y="908050"/>
                  </a:cubicBezTo>
                  <a:cubicBezTo>
                    <a:pt x="121708" y="911225"/>
                    <a:pt x="122328" y="914582"/>
                    <a:pt x="123825" y="917575"/>
                  </a:cubicBezTo>
                  <a:cubicBezTo>
                    <a:pt x="128245" y="926416"/>
                    <a:pt x="132678" y="929603"/>
                    <a:pt x="139700" y="936625"/>
                  </a:cubicBezTo>
                  <a:cubicBezTo>
                    <a:pt x="142065" y="943720"/>
                    <a:pt x="145297" y="958985"/>
                    <a:pt x="152400" y="965200"/>
                  </a:cubicBezTo>
                  <a:cubicBezTo>
                    <a:pt x="158143" y="970226"/>
                    <a:pt x="171450" y="977900"/>
                    <a:pt x="171450" y="977900"/>
                  </a:cubicBezTo>
                  <a:cubicBezTo>
                    <a:pt x="186267" y="1000125"/>
                    <a:pt x="177800" y="992717"/>
                    <a:pt x="193675" y="1003300"/>
                  </a:cubicBezTo>
                  <a:cubicBezTo>
                    <a:pt x="195792" y="1006475"/>
                    <a:pt x="197327" y="1010127"/>
                    <a:pt x="200025" y="1012825"/>
                  </a:cubicBezTo>
                  <a:cubicBezTo>
                    <a:pt x="202723" y="1015523"/>
                    <a:pt x="206445" y="1016957"/>
                    <a:pt x="209550" y="1019175"/>
                  </a:cubicBezTo>
                  <a:cubicBezTo>
                    <a:pt x="242459" y="1042682"/>
                    <a:pt x="197506" y="1012204"/>
                    <a:pt x="241300" y="1041400"/>
                  </a:cubicBezTo>
                  <a:cubicBezTo>
                    <a:pt x="247650" y="1045633"/>
                    <a:pt x="253878" y="1050055"/>
                    <a:pt x="260350" y="1054100"/>
                  </a:cubicBezTo>
                  <a:cubicBezTo>
                    <a:pt x="265583" y="1057371"/>
                    <a:pt x="271090" y="1060202"/>
                    <a:pt x="276225" y="1063625"/>
                  </a:cubicBezTo>
                  <a:cubicBezTo>
                    <a:pt x="288535" y="1071831"/>
                    <a:pt x="282130" y="1068768"/>
                    <a:pt x="295275" y="1073150"/>
                  </a:cubicBezTo>
                  <a:cubicBezTo>
                    <a:pt x="310369" y="1083213"/>
                    <a:pt x="301180" y="1078293"/>
                    <a:pt x="323850" y="1085850"/>
                  </a:cubicBezTo>
                  <a:lnTo>
                    <a:pt x="352425" y="1095375"/>
                  </a:lnTo>
                  <a:cubicBezTo>
                    <a:pt x="358532" y="1097411"/>
                    <a:pt x="365162" y="1097287"/>
                    <a:pt x="371475" y="1098550"/>
                  </a:cubicBezTo>
                  <a:cubicBezTo>
                    <a:pt x="375754" y="1099406"/>
                    <a:pt x="379942" y="1100667"/>
                    <a:pt x="384175" y="1101725"/>
                  </a:cubicBezTo>
                  <a:cubicBezTo>
                    <a:pt x="411472" y="1119923"/>
                    <a:pt x="376935" y="1098105"/>
                    <a:pt x="403225" y="1111250"/>
                  </a:cubicBezTo>
                  <a:cubicBezTo>
                    <a:pt x="406638" y="1112957"/>
                    <a:pt x="409263" y="1116050"/>
                    <a:pt x="412750" y="1117600"/>
                  </a:cubicBezTo>
                  <a:cubicBezTo>
                    <a:pt x="418867" y="1120318"/>
                    <a:pt x="425450" y="1121833"/>
                    <a:pt x="431800" y="1123950"/>
                  </a:cubicBezTo>
                  <a:lnTo>
                    <a:pt x="441325" y="1127125"/>
                  </a:lnTo>
                  <a:cubicBezTo>
                    <a:pt x="444500" y="1129242"/>
                    <a:pt x="447343" y="1131972"/>
                    <a:pt x="450850" y="1133475"/>
                  </a:cubicBezTo>
                  <a:cubicBezTo>
                    <a:pt x="454861" y="1135194"/>
                    <a:pt x="459271" y="1135794"/>
                    <a:pt x="463550" y="1136650"/>
                  </a:cubicBezTo>
                  <a:cubicBezTo>
                    <a:pt x="502474" y="1144435"/>
                    <a:pt x="465801" y="1135625"/>
                    <a:pt x="495300" y="1143000"/>
                  </a:cubicBezTo>
                  <a:cubicBezTo>
                    <a:pt x="536575" y="1141942"/>
                    <a:pt x="577914" y="1142348"/>
                    <a:pt x="619125" y="1139825"/>
                  </a:cubicBezTo>
                  <a:cubicBezTo>
                    <a:pt x="646021" y="1138178"/>
                    <a:pt x="643159" y="1135226"/>
                    <a:pt x="660400" y="1130300"/>
                  </a:cubicBezTo>
                  <a:cubicBezTo>
                    <a:pt x="664596" y="1129101"/>
                    <a:pt x="668904" y="1128324"/>
                    <a:pt x="673100" y="1127125"/>
                  </a:cubicBezTo>
                  <a:cubicBezTo>
                    <a:pt x="676318" y="1126206"/>
                    <a:pt x="679407" y="1124869"/>
                    <a:pt x="682625" y="1123950"/>
                  </a:cubicBezTo>
                  <a:cubicBezTo>
                    <a:pt x="710532" y="1115977"/>
                    <a:pt x="682012" y="1125213"/>
                    <a:pt x="704850" y="1117600"/>
                  </a:cubicBezTo>
                  <a:cubicBezTo>
                    <a:pt x="732147" y="1099402"/>
                    <a:pt x="697610" y="1121220"/>
                    <a:pt x="723900" y="1108075"/>
                  </a:cubicBezTo>
                  <a:cubicBezTo>
                    <a:pt x="745826" y="1097112"/>
                    <a:pt x="719694" y="1105158"/>
                    <a:pt x="746125" y="1098550"/>
                  </a:cubicBezTo>
                  <a:cubicBezTo>
                    <a:pt x="761219" y="1088487"/>
                    <a:pt x="752030" y="1093407"/>
                    <a:pt x="774700" y="1085850"/>
                  </a:cubicBezTo>
                  <a:cubicBezTo>
                    <a:pt x="791399" y="1080284"/>
                    <a:pt x="782990" y="1080118"/>
                    <a:pt x="796925" y="1073150"/>
                  </a:cubicBezTo>
                  <a:cubicBezTo>
                    <a:pt x="799918" y="1071653"/>
                    <a:pt x="803275" y="1071033"/>
                    <a:pt x="806450" y="1069975"/>
                  </a:cubicBezTo>
                  <a:cubicBezTo>
                    <a:pt x="809625" y="1067858"/>
                    <a:pt x="813044" y="1066068"/>
                    <a:pt x="815975" y="1063625"/>
                  </a:cubicBezTo>
                  <a:cubicBezTo>
                    <a:pt x="819424" y="1060750"/>
                    <a:pt x="821764" y="1056591"/>
                    <a:pt x="825500" y="1054100"/>
                  </a:cubicBezTo>
                  <a:cubicBezTo>
                    <a:pt x="828285" y="1052244"/>
                    <a:pt x="831850" y="1051983"/>
                    <a:pt x="835025" y="1050925"/>
                  </a:cubicBezTo>
                  <a:cubicBezTo>
                    <a:pt x="862322" y="1032727"/>
                    <a:pt x="827785" y="1054545"/>
                    <a:pt x="854075" y="1041400"/>
                  </a:cubicBezTo>
                  <a:cubicBezTo>
                    <a:pt x="857488" y="1039693"/>
                    <a:pt x="860113" y="1036600"/>
                    <a:pt x="863600" y="1035050"/>
                  </a:cubicBezTo>
                  <a:cubicBezTo>
                    <a:pt x="869717" y="1032332"/>
                    <a:pt x="882650" y="1028700"/>
                    <a:pt x="882650" y="1028700"/>
                  </a:cubicBezTo>
                  <a:cubicBezTo>
                    <a:pt x="909947" y="1010502"/>
                    <a:pt x="875410" y="1032320"/>
                    <a:pt x="901700" y="1019175"/>
                  </a:cubicBezTo>
                  <a:cubicBezTo>
                    <a:pt x="905113" y="1017468"/>
                    <a:pt x="907738" y="1014375"/>
                    <a:pt x="911225" y="1012825"/>
                  </a:cubicBezTo>
                  <a:cubicBezTo>
                    <a:pt x="917342" y="1010107"/>
                    <a:pt x="930275" y="1006475"/>
                    <a:pt x="930275" y="1006475"/>
                  </a:cubicBezTo>
                  <a:lnTo>
                    <a:pt x="958850" y="987425"/>
                  </a:lnTo>
                  <a:cubicBezTo>
                    <a:pt x="961635" y="985569"/>
                    <a:pt x="965200" y="985308"/>
                    <a:pt x="968375" y="984250"/>
                  </a:cubicBezTo>
                  <a:cubicBezTo>
                    <a:pt x="971550" y="981075"/>
                    <a:pt x="974356" y="977482"/>
                    <a:pt x="977900" y="974725"/>
                  </a:cubicBezTo>
                  <a:cubicBezTo>
                    <a:pt x="983924" y="970040"/>
                    <a:pt x="996950" y="962025"/>
                    <a:pt x="996950" y="962025"/>
                  </a:cubicBezTo>
                  <a:cubicBezTo>
                    <a:pt x="1008683" y="944426"/>
                    <a:pt x="996587" y="958346"/>
                    <a:pt x="1012825" y="949325"/>
                  </a:cubicBezTo>
                  <a:lnTo>
                    <a:pt x="1041400" y="930275"/>
                  </a:lnTo>
                  <a:cubicBezTo>
                    <a:pt x="1045803" y="927340"/>
                    <a:pt x="1049506" y="923375"/>
                    <a:pt x="1054100" y="920750"/>
                  </a:cubicBezTo>
                  <a:cubicBezTo>
                    <a:pt x="1057006" y="919090"/>
                    <a:pt x="1060450" y="918633"/>
                    <a:pt x="1063625" y="917575"/>
                  </a:cubicBezTo>
                  <a:cubicBezTo>
                    <a:pt x="1068240" y="903731"/>
                    <a:pt x="1067939" y="899063"/>
                    <a:pt x="1076325" y="889000"/>
                  </a:cubicBezTo>
                  <a:cubicBezTo>
                    <a:pt x="1079200" y="885551"/>
                    <a:pt x="1082306" y="882232"/>
                    <a:pt x="1085850" y="879475"/>
                  </a:cubicBezTo>
                  <a:cubicBezTo>
                    <a:pt x="1091874" y="874790"/>
                    <a:pt x="1104900" y="866775"/>
                    <a:pt x="1104900" y="866775"/>
                  </a:cubicBezTo>
                  <a:cubicBezTo>
                    <a:pt x="1107017" y="863600"/>
                    <a:pt x="1108715" y="860102"/>
                    <a:pt x="1111250" y="857250"/>
                  </a:cubicBezTo>
                  <a:cubicBezTo>
                    <a:pt x="1117216" y="850538"/>
                    <a:pt x="1130300" y="838200"/>
                    <a:pt x="1130300" y="838200"/>
                  </a:cubicBezTo>
                  <a:cubicBezTo>
                    <a:pt x="1137849" y="815552"/>
                    <a:pt x="1127145" y="842933"/>
                    <a:pt x="1143000" y="819150"/>
                  </a:cubicBezTo>
                  <a:cubicBezTo>
                    <a:pt x="1144856" y="816365"/>
                    <a:pt x="1144678" y="812618"/>
                    <a:pt x="1146175" y="809625"/>
                  </a:cubicBezTo>
                  <a:cubicBezTo>
                    <a:pt x="1147882" y="806212"/>
                    <a:pt x="1150975" y="803587"/>
                    <a:pt x="1152525" y="800100"/>
                  </a:cubicBezTo>
                  <a:cubicBezTo>
                    <a:pt x="1155243" y="793983"/>
                    <a:pt x="1156758" y="787400"/>
                    <a:pt x="1158875" y="781050"/>
                  </a:cubicBezTo>
                  <a:cubicBezTo>
                    <a:pt x="1159933" y="777875"/>
                    <a:pt x="1159265" y="773381"/>
                    <a:pt x="1162050" y="771525"/>
                  </a:cubicBezTo>
                  <a:lnTo>
                    <a:pt x="1171575" y="765175"/>
                  </a:lnTo>
                  <a:lnTo>
                    <a:pt x="1181100" y="736600"/>
                  </a:lnTo>
                  <a:lnTo>
                    <a:pt x="1184275" y="727075"/>
                  </a:lnTo>
                  <a:lnTo>
                    <a:pt x="1187450" y="717550"/>
                  </a:lnTo>
                  <a:cubicBezTo>
                    <a:pt x="1186392" y="712258"/>
                    <a:pt x="1185695" y="706881"/>
                    <a:pt x="1184275" y="701675"/>
                  </a:cubicBezTo>
                  <a:lnTo>
                    <a:pt x="1174750" y="673100"/>
                  </a:lnTo>
                  <a:lnTo>
                    <a:pt x="1171575" y="663575"/>
                  </a:lnTo>
                  <a:lnTo>
                    <a:pt x="1168400" y="654050"/>
                  </a:lnTo>
                  <a:cubicBezTo>
                    <a:pt x="1167342" y="627592"/>
                    <a:pt x="1167776" y="601031"/>
                    <a:pt x="1165225" y="574675"/>
                  </a:cubicBezTo>
                  <a:cubicBezTo>
                    <a:pt x="1164580" y="568013"/>
                    <a:pt x="1160992" y="561975"/>
                    <a:pt x="1158875" y="555625"/>
                  </a:cubicBezTo>
                  <a:cubicBezTo>
                    <a:pt x="1153287" y="538860"/>
                    <a:pt x="1157556" y="548885"/>
                    <a:pt x="1143000" y="527050"/>
                  </a:cubicBezTo>
                  <a:cubicBezTo>
                    <a:pt x="1140883" y="523875"/>
                    <a:pt x="1137857" y="521145"/>
                    <a:pt x="1136650" y="517525"/>
                  </a:cubicBezTo>
                  <a:cubicBezTo>
                    <a:pt x="1135592" y="514350"/>
                    <a:pt x="1135100" y="510926"/>
                    <a:pt x="1133475" y="508000"/>
                  </a:cubicBezTo>
                  <a:cubicBezTo>
                    <a:pt x="1120098" y="483921"/>
                    <a:pt x="1122671" y="497174"/>
                    <a:pt x="1117600" y="479425"/>
                  </a:cubicBezTo>
                  <a:cubicBezTo>
                    <a:pt x="1116401" y="475229"/>
                    <a:pt x="1115372" y="470985"/>
                    <a:pt x="1114425" y="466725"/>
                  </a:cubicBezTo>
                  <a:cubicBezTo>
                    <a:pt x="1113254" y="461457"/>
                    <a:pt x="1112670" y="456056"/>
                    <a:pt x="1111250" y="450850"/>
                  </a:cubicBezTo>
                  <a:cubicBezTo>
                    <a:pt x="1109489" y="444392"/>
                    <a:pt x="1107017" y="438150"/>
                    <a:pt x="1104900" y="431800"/>
                  </a:cubicBezTo>
                  <a:lnTo>
                    <a:pt x="1092200" y="393700"/>
                  </a:lnTo>
                  <a:cubicBezTo>
                    <a:pt x="1090993" y="390080"/>
                    <a:pt x="1087400" y="387662"/>
                    <a:pt x="1085850" y="384175"/>
                  </a:cubicBezTo>
                  <a:cubicBezTo>
                    <a:pt x="1083132" y="378058"/>
                    <a:pt x="1081617" y="371475"/>
                    <a:pt x="1079500" y="365125"/>
                  </a:cubicBezTo>
                  <a:lnTo>
                    <a:pt x="1066800" y="327025"/>
                  </a:lnTo>
                  <a:cubicBezTo>
                    <a:pt x="1065593" y="323405"/>
                    <a:pt x="1062000" y="320987"/>
                    <a:pt x="1060450" y="317500"/>
                  </a:cubicBezTo>
                  <a:cubicBezTo>
                    <a:pt x="1045337" y="283495"/>
                    <a:pt x="1062121" y="310481"/>
                    <a:pt x="1047750" y="288925"/>
                  </a:cubicBezTo>
                  <a:cubicBezTo>
                    <a:pt x="1046692" y="284692"/>
                    <a:pt x="1046294" y="280236"/>
                    <a:pt x="1044575" y="276225"/>
                  </a:cubicBezTo>
                  <a:cubicBezTo>
                    <a:pt x="1039934" y="265395"/>
                    <a:pt x="1035982" y="266537"/>
                    <a:pt x="1028700" y="257175"/>
                  </a:cubicBezTo>
                  <a:cubicBezTo>
                    <a:pt x="1024015" y="251151"/>
                    <a:pt x="1022350" y="242358"/>
                    <a:pt x="1016000" y="238125"/>
                  </a:cubicBezTo>
                  <a:cubicBezTo>
                    <a:pt x="1012825" y="236008"/>
                    <a:pt x="1009406" y="234218"/>
                    <a:pt x="1006475" y="231775"/>
                  </a:cubicBezTo>
                  <a:cubicBezTo>
                    <a:pt x="995942" y="222998"/>
                    <a:pt x="999249" y="221812"/>
                    <a:pt x="987425" y="215900"/>
                  </a:cubicBezTo>
                  <a:cubicBezTo>
                    <a:pt x="984432" y="214403"/>
                    <a:pt x="981075" y="213783"/>
                    <a:pt x="977900" y="212725"/>
                  </a:cubicBezTo>
                  <a:cubicBezTo>
                    <a:pt x="971550" y="208492"/>
                    <a:pt x="961263" y="207265"/>
                    <a:pt x="958850" y="200025"/>
                  </a:cubicBezTo>
                  <a:cubicBezTo>
                    <a:pt x="953262" y="183260"/>
                    <a:pt x="957531" y="193285"/>
                    <a:pt x="942975" y="171450"/>
                  </a:cubicBezTo>
                  <a:lnTo>
                    <a:pt x="930275" y="152400"/>
                  </a:lnTo>
                  <a:cubicBezTo>
                    <a:pt x="928158" y="149225"/>
                    <a:pt x="923925" y="148167"/>
                    <a:pt x="920750" y="146050"/>
                  </a:cubicBezTo>
                  <a:cubicBezTo>
                    <a:pt x="919692" y="142875"/>
                    <a:pt x="919942" y="138892"/>
                    <a:pt x="917575" y="136525"/>
                  </a:cubicBezTo>
                  <a:cubicBezTo>
                    <a:pt x="903721" y="122671"/>
                    <a:pt x="900882" y="124952"/>
                    <a:pt x="885825" y="120650"/>
                  </a:cubicBezTo>
                  <a:cubicBezTo>
                    <a:pt x="882607" y="119731"/>
                    <a:pt x="879640" y="117684"/>
                    <a:pt x="876300" y="117475"/>
                  </a:cubicBezTo>
                  <a:cubicBezTo>
                    <a:pt x="862568" y="116617"/>
                    <a:pt x="863071" y="119063"/>
                    <a:pt x="857250" y="117475"/>
                  </a:cubicBezTo>
                  <a:close/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46" name="フリーフォーム 45"/>
            <p:cNvSpPr/>
            <p:nvPr/>
          </p:nvSpPr>
          <p:spPr>
            <a:xfrm>
              <a:off x="7155052" y="4365326"/>
              <a:ext cx="1187450" cy="1107713"/>
            </a:xfrm>
            <a:custGeom>
              <a:avLst/>
              <a:gdLst>
                <a:gd name="connsiteX0" fmla="*/ 857250 w 1187450"/>
                <a:gd name="connsiteY0" fmla="*/ 117475 h 1143000"/>
                <a:gd name="connsiteX1" fmla="*/ 841375 w 1187450"/>
                <a:gd name="connsiteY1" fmla="*/ 107950 h 1143000"/>
                <a:gd name="connsiteX2" fmla="*/ 765175 w 1187450"/>
                <a:gd name="connsiteY2" fmla="*/ 98425 h 1143000"/>
                <a:gd name="connsiteX3" fmla="*/ 755650 w 1187450"/>
                <a:gd name="connsiteY3" fmla="*/ 95250 h 1143000"/>
                <a:gd name="connsiteX4" fmla="*/ 736600 w 1187450"/>
                <a:gd name="connsiteY4" fmla="*/ 82550 h 1143000"/>
                <a:gd name="connsiteX5" fmla="*/ 720725 w 1187450"/>
                <a:gd name="connsiteY5" fmla="*/ 69850 h 1143000"/>
                <a:gd name="connsiteX6" fmla="*/ 701675 w 1187450"/>
                <a:gd name="connsiteY6" fmla="*/ 57150 h 1143000"/>
                <a:gd name="connsiteX7" fmla="*/ 695325 w 1187450"/>
                <a:gd name="connsiteY7" fmla="*/ 47625 h 1143000"/>
                <a:gd name="connsiteX8" fmla="*/ 676275 w 1187450"/>
                <a:gd name="connsiteY8" fmla="*/ 38100 h 1143000"/>
                <a:gd name="connsiteX9" fmla="*/ 657225 w 1187450"/>
                <a:gd name="connsiteY9" fmla="*/ 22225 h 1143000"/>
                <a:gd name="connsiteX10" fmla="*/ 638175 w 1187450"/>
                <a:gd name="connsiteY10" fmla="*/ 15875 h 1143000"/>
                <a:gd name="connsiteX11" fmla="*/ 628650 w 1187450"/>
                <a:gd name="connsiteY11" fmla="*/ 12700 h 1143000"/>
                <a:gd name="connsiteX12" fmla="*/ 619125 w 1187450"/>
                <a:gd name="connsiteY12" fmla="*/ 6350 h 1143000"/>
                <a:gd name="connsiteX13" fmla="*/ 596900 w 1187450"/>
                <a:gd name="connsiteY13" fmla="*/ 0 h 1143000"/>
                <a:gd name="connsiteX14" fmla="*/ 539750 w 1187450"/>
                <a:gd name="connsiteY14" fmla="*/ 3175 h 1143000"/>
                <a:gd name="connsiteX15" fmla="*/ 520700 w 1187450"/>
                <a:gd name="connsiteY15" fmla="*/ 9525 h 1143000"/>
                <a:gd name="connsiteX16" fmla="*/ 511175 w 1187450"/>
                <a:gd name="connsiteY16" fmla="*/ 12700 h 1143000"/>
                <a:gd name="connsiteX17" fmla="*/ 501650 w 1187450"/>
                <a:gd name="connsiteY17" fmla="*/ 15875 h 1143000"/>
                <a:gd name="connsiteX18" fmla="*/ 482600 w 1187450"/>
                <a:gd name="connsiteY18" fmla="*/ 19050 h 1143000"/>
                <a:gd name="connsiteX19" fmla="*/ 444500 w 1187450"/>
                <a:gd name="connsiteY19" fmla="*/ 28575 h 1143000"/>
                <a:gd name="connsiteX20" fmla="*/ 431800 w 1187450"/>
                <a:gd name="connsiteY20" fmla="*/ 31750 h 1143000"/>
                <a:gd name="connsiteX21" fmla="*/ 409575 w 1187450"/>
                <a:gd name="connsiteY21" fmla="*/ 38100 h 1143000"/>
                <a:gd name="connsiteX22" fmla="*/ 381000 w 1187450"/>
                <a:gd name="connsiteY22" fmla="*/ 41275 h 1143000"/>
                <a:gd name="connsiteX23" fmla="*/ 361950 w 1187450"/>
                <a:gd name="connsiteY23" fmla="*/ 47625 h 1143000"/>
                <a:gd name="connsiteX24" fmla="*/ 352425 w 1187450"/>
                <a:gd name="connsiteY24" fmla="*/ 53975 h 1143000"/>
                <a:gd name="connsiteX25" fmla="*/ 333375 w 1187450"/>
                <a:gd name="connsiteY25" fmla="*/ 60325 h 1143000"/>
                <a:gd name="connsiteX26" fmla="*/ 311150 w 1187450"/>
                <a:gd name="connsiteY26" fmla="*/ 69850 h 1143000"/>
                <a:gd name="connsiteX27" fmla="*/ 282575 w 1187450"/>
                <a:gd name="connsiteY27" fmla="*/ 85725 h 1143000"/>
                <a:gd name="connsiteX28" fmla="*/ 276225 w 1187450"/>
                <a:gd name="connsiteY28" fmla="*/ 95250 h 1143000"/>
                <a:gd name="connsiteX29" fmla="*/ 257175 w 1187450"/>
                <a:gd name="connsiteY29" fmla="*/ 101600 h 1143000"/>
                <a:gd name="connsiteX30" fmla="*/ 250825 w 1187450"/>
                <a:gd name="connsiteY30" fmla="*/ 111125 h 1143000"/>
                <a:gd name="connsiteX31" fmla="*/ 222250 w 1187450"/>
                <a:gd name="connsiteY31" fmla="*/ 127000 h 1143000"/>
                <a:gd name="connsiteX32" fmla="*/ 193675 w 1187450"/>
                <a:gd name="connsiteY32" fmla="*/ 149225 h 1143000"/>
                <a:gd name="connsiteX33" fmla="*/ 174625 w 1187450"/>
                <a:gd name="connsiteY33" fmla="*/ 165100 h 1143000"/>
                <a:gd name="connsiteX34" fmla="*/ 146050 w 1187450"/>
                <a:gd name="connsiteY34" fmla="*/ 187325 h 1143000"/>
                <a:gd name="connsiteX35" fmla="*/ 136525 w 1187450"/>
                <a:gd name="connsiteY35" fmla="*/ 196850 h 1143000"/>
                <a:gd name="connsiteX36" fmla="*/ 127000 w 1187450"/>
                <a:gd name="connsiteY36" fmla="*/ 203200 h 1143000"/>
                <a:gd name="connsiteX37" fmla="*/ 114300 w 1187450"/>
                <a:gd name="connsiteY37" fmla="*/ 219075 h 1143000"/>
                <a:gd name="connsiteX38" fmla="*/ 101600 w 1187450"/>
                <a:gd name="connsiteY38" fmla="*/ 238125 h 1143000"/>
                <a:gd name="connsiteX39" fmla="*/ 88900 w 1187450"/>
                <a:gd name="connsiteY39" fmla="*/ 257175 h 1143000"/>
                <a:gd name="connsiteX40" fmla="*/ 76200 w 1187450"/>
                <a:gd name="connsiteY40" fmla="*/ 285750 h 1143000"/>
                <a:gd name="connsiteX41" fmla="*/ 73025 w 1187450"/>
                <a:gd name="connsiteY41" fmla="*/ 295275 h 1143000"/>
                <a:gd name="connsiteX42" fmla="*/ 60325 w 1187450"/>
                <a:gd name="connsiteY42" fmla="*/ 314325 h 1143000"/>
                <a:gd name="connsiteX43" fmla="*/ 57150 w 1187450"/>
                <a:gd name="connsiteY43" fmla="*/ 323850 h 1143000"/>
                <a:gd name="connsiteX44" fmla="*/ 50800 w 1187450"/>
                <a:gd name="connsiteY44" fmla="*/ 333375 h 1143000"/>
                <a:gd name="connsiteX45" fmla="*/ 47625 w 1187450"/>
                <a:gd name="connsiteY45" fmla="*/ 342900 h 1143000"/>
                <a:gd name="connsiteX46" fmla="*/ 28575 w 1187450"/>
                <a:gd name="connsiteY46" fmla="*/ 381000 h 1143000"/>
                <a:gd name="connsiteX47" fmla="*/ 22225 w 1187450"/>
                <a:gd name="connsiteY47" fmla="*/ 400050 h 1143000"/>
                <a:gd name="connsiteX48" fmla="*/ 19050 w 1187450"/>
                <a:gd name="connsiteY48" fmla="*/ 409575 h 1143000"/>
                <a:gd name="connsiteX49" fmla="*/ 15875 w 1187450"/>
                <a:gd name="connsiteY49" fmla="*/ 431800 h 1143000"/>
                <a:gd name="connsiteX50" fmla="*/ 12700 w 1187450"/>
                <a:gd name="connsiteY50" fmla="*/ 447675 h 1143000"/>
                <a:gd name="connsiteX51" fmla="*/ 3175 w 1187450"/>
                <a:gd name="connsiteY51" fmla="*/ 501650 h 1143000"/>
                <a:gd name="connsiteX52" fmla="*/ 0 w 1187450"/>
                <a:gd name="connsiteY52" fmla="*/ 511175 h 1143000"/>
                <a:gd name="connsiteX53" fmla="*/ 3175 w 1187450"/>
                <a:gd name="connsiteY53" fmla="*/ 552450 h 1143000"/>
                <a:gd name="connsiteX54" fmla="*/ 12700 w 1187450"/>
                <a:gd name="connsiteY54" fmla="*/ 571500 h 1143000"/>
                <a:gd name="connsiteX55" fmla="*/ 15875 w 1187450"/>
                <a:gd name="connsiteY55" fmla="*/ 581025 h 1143000"/>
                <a:gd name="connsiteX56" fmla="*/ 22225 w 1187450"/>
                <a:gd name="connsiteY56" fmla="*/ 590550 h 1143000"/>
                <a:gd name="connsiteX57" fmla="*/ 28575 w 1187450"/>
                <a:gd name="connsiteY57" fmla="*/ 609600 h 1143000"/>
                <a:gd name="connsiteX58" fmla="*/ 34925 w 1187450"/>
                <a:gd name="connsiteY58" fmla="*/ 628650 h 1143000"/>
                <a:gd name="connsiteX59" fmla="*/ 44450 w 1187450"/>
                <a:gd name="connsiteY59" fmla="*/ 638175 h 1143000"/>
                <a:gd name="connsiteX60" fmla="*/ 50800 w 1187450"/>
                <a:gd name="connsiteY60" fmla="*/ 657225 h 1143000"/>
                <a:gd name="connsiteX61" fmla="*/ 69850 w 1187450"/>
                <a:gd name="connsiteY61" fmla="*/ 685800 h 1143000"/>
                <a:gd name="connsiteX62" fmla="*/ 76200 w 1187450"/>
                <a:gd name="connsiteY62" fmla="*/ 704850 h 1143000"/>
                <a:gd name="connsiteX63" fmla="*/ 79375 w 1187450"/>
                <a:gd name="connsiteY63" fmla="*/ 717550 h 1143000"/>
                <a:gd name="connsiteX64" fmla="*/ 82550 w 1187450"/>
                <a:gd name="connsiteY64" fmla="*/ 727075 h 1143000"/>
                <a:gd name="connsiteX65" fmla="*/ 88900 w 1187450"/>
                <a:gd name="connsiteY65" fmla="*/ 765175 h 1143000"/>
                <a:gd name="connsiteX66" fmla="*/ 92075 w 1187450"/>
                <a:gd name="connsiteY66" fmla="*/ 825500 h 1143000"/>
                <a:gd name="connsiteX67" fmla="*/ 95250 w 1187450"/>
                <a:gd name="connsiteY67" fmla="*/ 838200 h 1143000"/>
                <a:gd name="connsiteX68" fmla="*/ 101600 w 1187450"/>
                <a:gd name="connsiteY68" fmla="*/ 869950 h 1143000"/>
                <a:gd name="connsiteX69" fmla="*/ 120650 w 1187450"/>
                <a:gd name="connsiteY69" fmla="*/ 908050 h 1143000"/>
                <a:gd name="connsiteX70" fmla="*/ 123825 w 1187450"/>
                <a:gd name="connsiteY70" fmla="*/ 917575 h 1143000"/>
                <a:gd name="connsiteX71" fmla="*/ 139700 w 1187450"/>
                <a:gd name="connsiteY71" fmla="*/ 936625 h 1143000"/>
                <a:gd name="connsiteX72" fmla="*/ 152400 w 1187450"/>
                <a:gd name="connsiteY72" fmla="*/ 965200 h 1143000"/>
                <a:gd name="connsiteX73" fmla="*/ 171450 w 1187450"/>
                <a:gd name="connsiteY73" fmla="*/ 977900 h 1143000"/>
                <a:gd name="connsiteX74" fmla="*/ 193675 w 1187450"/>
                <a:gd name="connsiteY74" fmla="*/ 1003300 h 1143000"/>
                <a:gd name="connsiteX75" fmla="*/ 200025 w 1187450"/>
                <a:gd name="connsiteY75" fmla="*/ 1012825 h 1143000"/>
                <a:gd name="connsiteX76" fmla="*/ 209550 w 1187450"/>
                <a:gd name="connsiteY76" fmla="*/ 1019175 h 1143000"/>
                <a:gd name="connsiteX77" fmla="*/ 241300 w 1187450"/>
                <a:gd name="connsiteY77" fmla="*/ 1041400 h 1143000"/>
                <a:gd name="connsiteX78" fmla="*/ 260350 w 1187450"/>
                <a:gd name="connsiteY78" fmla="*/ 1054100 h 1143000"/>
                <a:gd name="connsiteX79" fmla="*/ 276225 w 1187450"/>
                <a:gd name="connsiteY79" fmla="*/ 1063625 h 1143000"/>
                <a:gd name="connsiteX80" fmla="*/ 295275 w 1187450"/>
                <a:gd name="connsiteY80" fmla="*/ 1073150 h 1143000"/>
                <a:gd name="connsiteX81" fmla="*/ 323850 w 1187450"/>
                <a:gd name="connsiteY81" fmla="*/ 1085850 h 1143000"/>
                <a:gd name="connsiteX82" fmla="*/ 352425 w 1187450"/>
                <a:gd name="connsiteY82" fmla="*/ 1095375 h 1143000"/>
                <a:gd name="connsiteX83" fmla="*/ 371475 w 1187450"/>
                <a:gd name="connsiteY83" fmla="*/ 1098550 h 1143000"/>
                <a:gd name="connsiteX84" fmla="*/ 384175 w 1187450"/>
                <a:gd name="connsiteY84" fmla="*/ 1101725 h 1143000"/>
                <a:gd name="connsiteX85" fmla="*/ 403225 w 1187450"/>
                <a:gd name="connsiteY85" fmla="*/ 1111250 h 1143000"/>
                <a:gd name="connsiteX86" fmla="*/ 412750 w 1187450"/>
                <a:gd name="connsiteY86" fmla="*/ 1117600 h 1143000"/>
                <a:gd name="connsiteX87" fmla="*/ 431800 w 1187450"/>
                <a:gd name="connsiteY87" fmla="*/ 1123950 h 1143000"/>
                <a:gd name="connsiteX88" fmla="*/ 441325 w 1187450"/>
                <a:gd name="connsiteY88" fmla="*/ 1127125 h 1143000"/>
                <a:gd name="connsiteX89" fmla="*/ 450850 w 1187450"/>
                <a:gd name="connsiteY89" fmla="*/ 1133475 h 1143000"/>
                <a:gd name="connsiteX90" fmla="*/ 463550 w 1187450"/>
                <a:gd name="connsiteY90" fmla="*/ 1136650 h 1143000"/>
                <a:gd name="connsiteX91" fmla="*/ 495300 w 1187450"/>
                <a:gd name="connsiteY91" fmla="*/ 1143000 h 1143000"/>
                <a:gd name="connsiteX92" fmla="*/ 619125 w 1187450"/>
                <a:gd name="connsiteY92" fmla="*/ 1139825 h 1143000"/>
                <a:gd name="connsiteX93" fmla="*/ 660400 w 1187450"/>
                <a:gd name="connsiteY93" fmla="*/ 1130300 h 1143000"/>
                <a:gd name="connsiteX94" fmla="*/ 673100 w 1187450"/>
                <a:gd name="connsiteY94" fmla="*/ 1127125 h 1143000"/>
                <a:gd name="connsiteX95" fmla="*/ 682625 w 1187450"/>
                <a:gd name="connsiteY95" fmla="*/ 1123950 h 1143000"/>
                <a:gd name="connsiteX96" fmla="*/ 704850 w 1187450"/>
                <a:gd name="connsiteY96" fmla="*/ 1117600 h 1143000"/>
                <a:gd name="connsiteX97" fmla="*/ 723900 w 1187450"/>
                <a:gd name="connsiteY97" fmla="*/ 1108075 h 1143000"/>
                <a:gd name="connsiteX98" fmla="*/ 746125 w 1187450"/>
                <a:gd name="connsiteY98" fmla="*/ 1098550 h 1143000"/>
                <a:gd name="connsiteX99" fmla="*/ 774700 w 1187450"/>
                <a:gd name="connsiteY99" fmla="*/ 1085850 h 1143000"/>
                <a:gd name="connsiteX100" fmla="*/ 796925 w 1187450"/>
                <a:gd name="connsiteY100" fmla="*/ 1073150 h 1143000"/>
                <a:gd name="connsiteX101" fmla="*/ 806450 w 1187450"/>
                <a:gd name="connsiteY101" fmla="*/ 1069975 h 1143000"/>
                <a:gd name="connsiteX102" fmla="*/ 815975 w 1187450"/>
                <a:gd name="connsiteY102" fmla="*/ 1063625 h 1143000"/>
                <a:gd name="connsiteX103" fmla="*/ 825500 w 1187450"/>
                <a:gd name="connsiteY103" fmla="*/ 1054100 h 1143000"/>
                <a:gd name="connsiteX104" fmla="*/ 835025 w 1187450"/>
                <a:gd name="connsiteY104" fmla="*/ 1050925 h 1143000"/>
                <a:gd name="connsiteX105" fmla="*/ 854075 w 1187450"/>
                <a:gd name="connsiteY105" fmla="*/ 1041400 h 1143000"/>
                <a:gd name="connsiteX106" fmla="*/ 863600 w 1187450"/>
                <a:gd name="connsiteY106" fmla="*/ 1035050 h 1143000"/>
                <a:gd name="connsiteX107" fmla="*/ 882650 w 1187450"/>
                <a:gd name="connsiteY107" fmla="*/ 1028700 h 1143000"/>
                <a:gd name="connsiteX108" fmla="*/ 901700 w 1187450"/>
                <a:gd name="connsiteY108" fmla="*/ 1019175 h 1143000"/>
                <a:gd name="connsiteX109" fmla="*/ 911225 w 1187450"/>
                <a:gd name="connsiteY109" fmla="*/ 1012825 h 1143000"/>
                <a:gd name="connsiteX110" fmla="*/ 930275 w 1187450"/>
                <a:gd name="connsiteY110" fmla="*/ 1006475 h 1143000"/>
                <a:gd name="connsiteX111" fmla="*/ 958850 w 1187450"/>
                <a:gd name="connsiteY111" fmla="*/ 987425 h 1143000"/>
                <a:gd name="connsiteX112" fmla="*/ 968375 w 1187450"/>
                <a:gd name="connsiteY112" fmla="*/ 984250 h 1143000"/>
                <a:gd name="connsiteX113" fmla="*/ 977900 w 1187450"/>
                <a:gd name="connsiteY113" fmla="*/ 974725 h 1143000"/>
                <a:gd name="connsiteX114" fmla="*/ 996950 w 1187450"/>
                <a:gd name="connsiteY114" fmla="*/ 962025 h 1143000"/>
                <a:gd name="connsiteX115" fmla="*/ 1012825 w 1187450"/>
                <a:gd name="connsiteY115" fmla="*/ 949325 h 1143000"/>
                <a:gd name="connsiteX116" fmla="*/ 1041400 w 1187450"/>
                <a:gd name="connsiteY116" fmla="*/ 930275 h 1143000"/>
                <a:gd name="connsiteX117" fmla="*/ 1054100 w 1187450"/>
                <a:gd name="connsiteY117" fmla="*/ 920750 h 1143000"/>
                <a:gd name="connsiteX118" fmla="*/ 1063625 w 1187450"/>
                <a:gd name="connsiteY118" fmla="*/ 917575 h 1143000"/>
                <a:gd name="connsiteX119" fmla="*/ 1076325 w 1187450"/>
                <a:gd name="connsiteY119" fmla="*/ 889000 h 1143000"/>
                <a:gd name="connsiteX120" fmla="*/ 1085850 w 1187450"/>
                <a:gd name="connsiteY120" fmla="*/ 879475 h 1143000"/>
                <a:gd name="connsiteX121" fmla="*/ 1104900 w 1187450"/>
                <a:gd name="connsiteY121" fmla="*/ 866775 h 1143000"/>
                <a:gd name="connsiteX122" fmla="*/ 1111250 w 1187450"/>
                <a:gd name="connsiteY122" fmla="*/ 857250 h 1143000"/>
                <a:gd name="connsiteX123" fmla="*/ 1130300 w 1187450"/>
                <a:gd name="connsiteY123" fmla="*/ 838200 h 1143000"/>
                <a:gd name="connsiteX124" fmla="*/ 1143000 w 1187450"/>
                <a:gd name="connsiteY124" fmla="*/ 819150 h 1143000"/>
                <a:gd name="connsiteX125" fmla="*/ 1146175 w 1187450"/>
                <a:gd name="connsiteY125" fmla="*/ 809625 h 1143000"/>
                <a:gd name="connsiteX126" fmla="*/ 1152525 w 1187450"/>
                <a:gd name="connsiteY126" fmla="*/ 800100 h 1143000"/>
                <a:gd name="connsiteX127" fmla="*/ 1158875 w 1187450"/>
                <a:gd name="connsiteY127" fmla="*/ 781050 h 1143000"/>
                <a:gd name="connsiteX128" fmla="*/ 1162050 w 1187450"/>
                <a:gd name="connsiteY128" fmla="*/ 771525 h 1143000"/>
                <a:gd name="connsiteX129" fmla="*/ 1171575 w 1187450"/>
                <a:gd name="connsiteY129" fmla="*/ 765175 h 1143000"/>
                <a:gd name="connsiteX130" fmla="*/ 1181100 w 1187450"/>
                <a:gd name="connsiteY130" fmla="*/ 736600 h 1143000"/>
                <a:gd name="connsiteX131" fmla="*/ 1184275 w 1187450"/>
                <a:gd name="connsiteY131" fmla="*/ 727075 h 1143000"/>
                <a:gd name="connsiteX132" fmla="*/ 1187450 w 1187450"/>
                <a:gd name="connsiteY132" fmla="*/ 717550 h 1143000"/>
                <a:gd name="connsiteX133" fmla="*/ 1184275 w 1187450"/>
                <a:gd name="connsiteY133" fmla="*/ 701675 h 1143000"/>
                <a:gd name="connsiteX134" fmla="*/ 1174750 w 1187450"/>
                <a:gd name="connsiteY134" fmla="*/ 673100 h 1143000"/>
                <a:gd name="connsiteX135" fmla="*/ 1171575 w 1187450"/>
                <a:gd name="connsiteY135" fmla="*/ 663575 h 1143000"/>
                <a:gd name="connsiteX136" fmla="*/ 1168400 w 1187450"/>
                <a:gd name="connsiteY136" fmla="*/ 654050 h 1143000"/>
                <a:gd name="connsiteX137" fmla="*/ 1165225 w 1187450"/>
                <a:gd name="connsiteY137" fmla="*/ 574675 h 1143000"/>
                <a:gd name="connsiteX138" fmla="*/ 1158875 w 1187450"/>
                <a:gd name="connsiteY138" fmla="*/ 555625 h 1143000"/>
                <a:gd name="connsiteX139" fmla="*/ 1143000 w 1187450"/>
                <a:gd name="connsiteY139" fmla="*/ 527050 h 1143000"/>
                <a:gd name="connsiteX140" fmla="*/ 1136650 w 1187450"/>
                <a:gd name="connsiteY140" fmla="*/ 517525 h 1143000"/>
                <a:gd name="connsiteX141" fmla="*/ 1133475 w 1187450"/>
                <a:gd name="connsiteY141" fmla="*/ 508000 h 1143000"/>
                <a:gd name="connsiteX142" fmla="*/ 1117600 w 1187450"/>
                <a:gd name="connsiteY142" fmla="*/ 479425 h 1143000"/>
                <a:gd name="connsiteX143" fmla="*/ 1114425 w 1187450"/>
                <a:gd name="connsiteY143" fmla="*/ 466725 h 1143000"/>
                <a:gd name="connsiteX144" fmla="*/ 1111250 w 1187450"/>
                <a:gd name="connsiteY144" fmla="*/ 450850 h 1143000"/>
                <a:gd name="connsiteX145" fmla="*/ 1104900 w 1187450"/>
                <a:gd name="connsiteY145" fmla="*/ 431800 h 1143000"/>
                <a:gd name="connsiteX146" fmla="*/ 1092200 w 1187450"/>
                <a:gd name="connsiteY146" fmla="*/ 393700 h 1143000"/>
                <a:gd name="connsiteX147" fmla="*/ 1085850 w 1187450"/>
                <a:gd name="connsiteY147" fmla="*/ 384175 h 1143000"/>
                <a:gd name="connsiteX148" fmla="*/ 1079500 w 1187450"/>
                <a:gd name="connsiteY148" fmla="*/ 365125 h 1143000"/>
                <a:gd name="connsiteX149" fmla="*/ 1066800 w 1187450"/>
                <a:gd name="connsiteY149" fmla="*/ 327025 h 1143000"/>
                <a:gd name="connsiteX150" fmla="*/ 1060450 w 1187450"/>
                <a:gd name="connsiteY150" fmla="*/ 317500 h 1143000"/>
                <a:gd name="connsiteX151" fmla="*/ 1047750 w 1187450"/>
                <a:gd name="connsiteY151" fmla="*/ 288925 h 1143000"/>
                <a:gd name="connsiteX152" fmla="*/ 1044575 w 1187450"/>
                <a:gd name="connsiteY152" fmla="*/ 276225 h 1143000"/>
                <a:gd name="connsiteX153" fmla="*/ 1028700 w 1187450"/>
                <a:gd name="connsiteY153" fmla="*/ 257175 h 1143000"/>
                <a:gd name="connsiteX154" fmla="*/ 1016000 w 1187450"/>
                <a:gd name="connsiteY154" fmla="*/ 238125 h 1143000"/>
                <a:gd name="connsiteX155" fmla="*/ 1006475 w 1187450"/>
                <a:gd name="connsiteY155" fmla="*/ 231775 h 1143000"/>
                <a:gd name="connsiteX156" fmla="*/ 987425 w 1187450"/>
                <a:gd name="connsiteY156" fmla="*/ 215900 h 1143000"/>
                <a:gd name="connsiteX157" fmla="*/ 977900 w 1187450"/>
                <a:gd name="connsiteY157" fmla="*/ 212725 h 1143000"/>
                <a:gd name="connsiteX158" fmla="*/ 958850 w 1187450"/>
                <a:gd name="connsiteY158" fmla="*/ 200025 h 1143000"/>
                <a:gd name="connsiteX159" fmla="*/ 942975 w 1187450"/>
                <a:gd name="connsiteY159" fmla="*/ 171450 h 1143000"/>
                <a:gd name="connsiteX160" fmla="*/ 930275 w 1187450"/>
                <a:gd name="connsiteY160" fmla="*/ 152400 h 1143000"/>
                <a:gd name="connsiteX161" fmla="*/ 920750 w 1187450"/>
                <a:gd name="connsiteY161" fmla="*/ 146050 h 1143000"/>
                <a:gd name="connsiteX162" fmla="*/ 917575 w 1187450"/>
                <a:gd name="connsiteY162" fmla="*/ 136525 h 1143000"/>
                <a:gd name="connsiteX163" fmla="*/ 885825 w 1187450"/>
                <a:gd name="connsiteY163" fmla="*/ 120650 h 1143000"/>
                <a:gd name="connsiteX164" fmla="*/ 876300 w 1187450"/>
                <a:gd name="connsiteY164" fmla="*/ 117475 h 1143000"/>
                <a:gd name="connsiteX165" fmla="*/ 857250 w 1187450"/>
                <a:gd name="connsiteY165" fmla="*/ 117475 h 1143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</a:cxnLst>
              <a:rect l="l" t="t" r="r" b="b"/>
              <a:pathLst>
                <a:path w="1187450" h="1143000">
                  <a:moveTo>
                    <a:pt x="857250" y="117475"/>
                  </a:moveTo>
                  <a:cubicBezTo>
                    <a:pt x="851429" y="115887"/>
                    <a:pt x="846993" y="110504"/>
                    <a:pt x="841375" y="107950"/>
                  </a:cubicBezTo>
                  <a:cubicBezTo>
                    <a:pt x="815511" y="96194"/>
                    <a:pt x="796838" y="100184"/>
                    <a:pt x="765175" y="98425"/>
                  </a:cubicBezTo>
                  <a:cubicBezTo>
                    <a:pt x="762000" y="97367"/>
                    <a:pt x="758576" y="96875"/>
                    <a:pt x="755650" y="95250"/>
                  </a:cubicBezTo>
                  <a:cubicBezTo>
                    <a:pt x="748979" y="91544"/>
                    <a:pt x="736600" y="82550"/>
                    <a:pt x="736600" y="82550"/>
                  </a:cubicBezTo>
                  <a:cubicBezTo>
                    <a:pt x="724867" y="64951"/>
                    <a:pt x="736963" y="78871"/>
                    <a:pt x="720725" y="69850"/>
                  </a:cubicBezTo>
                  <a:cubicBezTo>
                    <a:pt x="714054" y="66144"/>
                    <a:pt x="701675" y="57150"/>
                    <a:pt x="701675" y="57150"/>
                  </a:cubicBezTo>
                  <a:cubicBezTo>
                    <a:pt x="699558" y="53975"/>
                    <a:pt x="698023" y="50323"/>
                    <a:pt x="695325" y="47625"/>
                  </a:cubicBezTo>
                  <a:cubicBezTo>
                    <a:pt x="689170" y="41470"/>
                    <a:pt x="684022" y="40682"/>
                    <a:pt x="676275" y="38100"/>
                  </a:cubicBezTo>
                  <a:cubicBezTo>
                    <a:pt x="670293" y="32118"/>
                    <a:pt x="665182" y="25761"/>
                    <a:pt x="657225" y="22225"/>
                  </a:cubicBezTo>
                  <a:cubicBezTo>
                    <a:pt x="651108" y="19507"/>
                    <a:pt x="644525" y="17992"/>
                    <a:pt x="638175" y="15875"/>
                  </a:cubicBezTo>
                  <a:lnTo>
                    <a:pt x="628650" y="12700"/>
                  </a:lnTo>
                  <a:cubicBezTo>
                    <a:pt x="625475" y="10583"/>
                    <a:pt x="622538" y="8057"/>
                    <a:pt x="619125" y="6350"/>
                  </a:cubicBezTo>
                  <a:cubicBezTo>
                    <a:pt x="614570" y="4073"/>
                    <a:pt x="600969" y="1017"/>
                    <a:pt x="596900" y="0"/>
                  </a:cubicBezTo>
                  <a:cubicBezTo>
                    <a:pt x="577850" y="1058"/>
                    <a:pt x="558682" y="808"/>
                    <a:pt x="539750" y="3175"/>
                  </a:cubicBezTo>
                  <a:cubicBezTo>
                    <a:pt x="533108" y="4005"/>
                    <a:pt x="527050" y="7408"/>
                    <a:pt x="520700" y="9525"/>
                  </a:cubicBezTo>
                  <a:lnTo>
                    <a:pt x="511175" y="12700"/>
                  </a:lnTo>
                  <a:cubicBezTo>
                    <a:pt x="508000" y="13758"/>
                    <a:pt x="504951" y="15325"/>
                    <a:pt x="501650" y="15875"/>
                  </a:cubicBezTo>
                  <a:lnTo>
                    <a:pt x="482600" y="19050"/>
                  </a:lnTo>
                  <a:cubicBezTo>
                    <a:pt x="450775" y="29658"/>
                    <a:pt x="476566" y="22162"/>
                    <a:pt x="444500" y="28575"/>
                  </a:cubicBezTo>
                  <a:cubicBezTo>
                    <a:pt x="440221" y="29431"/>
                    <a:pt x="435996" y="30551"/>
                    <a:pt x="431800" y="31750"/>
                  </a:cubicBezTo>
                  <a:cubicBezTo>
                    <a:pt x="422119" y="34516"/>
                    <a:pt x="420328" y="36446"/>
                    <a:pt x="409575" y="38100"/>
                  </a:cubicBezTo>
                  <a:cubicBezTo>
                    <a:pt x="400103" y="39557"/>
                    <a:pt x="390525" y="40217"/>
                    <a:pt x="381000" y="41275"/>
                  </a:cubicBezTo>
                  <a:cubicBezTo>
                    <a:pt x="374650" y="43392"/>
                    <a:pt x="367519" y="43912"/>
                    <a:pt x="361950" y="47625"/>
                  </a:cubicBezTo>
                  <a:cubicBezTo>
                    <a:pt x="358775" y="49742"/>
                    <a:pt x="355912" y="52425"/>
                    <a:pt x="352425" y="53975"/>
                  </a:cubicBezTo>
                  <a:cubicBezTo>
                    <a:pt x="346308" y="56693"/>
                    <a:pt x="333375" y="60325"/>
                    <a:pt x="333375" y="60325"/>
                  </a:cubicBezTo>
                  <a:cubicBezTo>
                    <a:pt x="298705" y="83439"/>
                    <a:pt x="352155" y="49348"/>
                    <a:pt x="311150" y="69850"/>
                  </a:cubicBezTo>
                  <a:cubicBezTo>
                    <a:pt x="267481" y="91685"/>
                    <a:pt x="308915" y="76945"/>
                    <a:pt x="282575" y="85725"/>
                  </a:cubicBezTo>
                  <a:cubicBezTo>
                    <a:pt x="280458" y="88900"/>
                    <a:pt x="279461" y="93228"/>
                    <a:pt x="276225" y="95250"/>
                  </a:cubicBezTo>
                  <a:cubicBezTo>
                    <a:pt x="270549" y="98798"/>
                    <a:pt x="257175" y="101600"/>
                    <a:pt x="257175" y="101600"/>
                  </a:cubicBezTo>
                  <a:cubicBezTo>
                    <a:pt x="255058" y="104775"/>
                    <a:pt x="253697" y="108612"/>
                    <a:pt x="250825" y="111125"/>
                  </a:cubicBezTo>
                  <a:cubicBezTo>
                    <a:pt x="237388" y="122882"/>
                    <a:pt x="235332" y="122639"/>
                    <a:pt x="222250" y="127000"/>
                  </a:cubicBezTo>
                  <a:cubicBezTo>
                    <a:pt x="200833" y="148417"/>
                    <a:pt x="211719" y="143210"/>
                    <a:pt x="193675" y="149225"/>
                  </a:cubicBezTo>
                  <a:cubicBezTo>
                    <a:pt x="165848" y="177052"/>
                    <a:pt x="201147" y="142998"/>
                    <a:pt x="174625" y="165100"/>
                  </a:cubicBezTo>
                  <a:cubicBezTo>
                    <a:pt x="144782" y="189969"/>
                    <a:pt x="194198" y="155227"/>
                    <a:pt x="146050" y="187325"/>
                  </a:cubicBezTo>
                  <a:cubicBezTo>
                    <a:pt x="142314" y="189816"/>
                    <a:pt x="139974" y="193975"/>
                    <a:pt x="136525" y="196850"/>
                  </a:cubicBezTo>
                  <a:cubicBezTo>
                    <a:pt x="133594" y="199293"/>
                    <a:pt x="130175" y="201083"/>
                    <a:pt x="127000" y="203200"/>
                  </a:cubicBezTo>
                  <a:cubicBezTo>
                    <a:pt x="119850" y="224650"/>
                    <a:pt x="129766" y="201400"/>
                    <a:pt x="114300" y="219075"/>
                  </a:cubicBezTo>
                  <a:cubicBezTo>
                    <a:pt x="109274" y="224818"/>
                    <a:pt x="105833" y="231775"/>
                    <a:pt x="101600" y="238125"/>
                  </a:cubicBezTo>
                  <a:lnTo>
                    <a:pt x="88900" y="257175"/>
                  </a:lnTo>
                  <a:cubicBezTo>
                    <a:pt x="78837" y="272269"/>
                    <a:pt x="83757" y="263080"/>
                    <a:pt x="76200" y="285750"/>
                  </a:cubicBezTo>
                  <a:cubicBezTo>
                    <a:pt x="75142" y="288925"/>
                    <a:pt x="74881" y="292490"/>
                    <a:pt x="73025" y="295275"/>
                  </a:cubicBezTo>
                  <a:cubicBezTo>
                    <a:pt x="68792" y="301625"/>
                    <a:pt x="62738" y="307085"/>
                    <a:pt x="60325" y="314325"/>
                  </a:cubicBezTo>
                  <a:cubicBezTo>
                    <a:pt x="59267" y="317500"/>
                    <a:pt x="58647" y="320857"/>
                    <a:pt x="57150" y="323850"/>
                  </a:cubicBezTo>
                  <a:cubicBezTo>
                    <a:pt x="55443" y="327263"/>
                    <a:pt x="52507" y="329962"/>
                    <a:pt x="50800" y="333375"/>
                  </a:cubicBezTo>
                  <a:cubicBezTo>
                    <a:pt x="49303" y="336368"/>
                    <a:pt x="49250" y="339974"/>
                    <a:pt x="47625" y="342900"/>
                  </a:cubicBezTo>
                  <a:cubicBezTo>
                    <a:pt x="27109" y="379829"/>
                    <a:pt x="40937" y="343914"/>
                    <a:pt x="28575" y="381000"/>
                  </a:cubicBezTo>
                  <a:lnTo>
                    <a:pt x="22225" y="400050"/>
                  </a:lnTo>
                  <a:lnTo>
                    <a:pt x="19050" y="409575"/>
                  </a:lnTo>
                  <a:cubicBezTo>
                    <a:pt x="17992" y="416983"/>
                    <a:pt x="17105" y="424418"/>
                    <a:pt x="15875" y="431800"/>
                  </a:cubicBezTo>
                  <a:cubicBezTo>
                    <a:pt x="14988" y="437123"/>
                    <a:pt x="13587" y="442352"/>
                    <a:pt x="12700" y="447675"/>
                  </a:cubicBezTo>
                  <a:cubicBezTo>
                    <a:pt x="10045" y="463604"/>
                    <a:pt x="8041" y="487052"/>
                    <a:pt x="3175" y="501650"/>
                  </a:cubicBezTo>
                  <a:lnTo>
                    <a:pt x="0" y="511175"/>
                  </a:lnTo>
                  <a:cubicBezTo>
                    <a:pt x="1058" y="524933"/>
                    <a:pt x="1463" y="538758"/>
                    <a:pt x="3175" y="552450"/>
                  </a:cubicBezTo>
                  <a:cubicBezTo>
                    <a:pt x="4505" y="563091"/>
                    <a:pt x="7973" y="562046"/>
                    <a:pt x="12700" y="571500"/>
                  </a:cubicBezTo>
                  <a:cubicBezTo>
                    <a:pt x="14197" y="574493"/>
                    <a:pt x="14378" y="578032"/>
                    <a:pt x="15875" y="581025"/>
                  </a:cubicBezTo>
                  <a:cubicBezTo>
                    <a:pt x="17582" y="584438"/>
                    <a:pt x="20675" y="587063"/>
                    <a:pt x="22225" y="590550"/>
                  </a:cubicBezTo>
                  <a:cubicBezTo>
                    <a:pt x="24943" y="596667"/>
                    <a:pt x="26458" y="603250"/>
                    <a:pt x="28575" y="609600"/>
                  </a:cubicBezTo>
                  <a:lnTo>
                    <a:pt x="34925" y="628650"/>
                  </a:lnTo>
                  <a:cubicBezTo>
                    <a:pt x="36345" y="632910"/>
                    <a:pt x="41275" y="635000"/>
                    <a:pt x="44450" y="638175"/>
                  </a:cubicBezTo>
                  <a:lnTo>
                    <a:pt x="50800" y="657225"/>
                  </a:lnTo>
                  <a:lnTo>
                    <a:pt x="69850" y="685800"/>
                  </a:lnTo>
                  <a:cubicBezTo>
                    <a:pt x="73563" y="691369"/>
                    <a:pt x="74083" y="698500"/>
                    <a:pt x="76200" y="704850"/>
                  </a:cubicBezTo>
                  <a:cubicBezTo>
                    <a:pt x="77580" y="708990"/>
                    <a:pt x="78176" y="713354"/>
                    <a:pt x="79375" y="717550"/>
                  </a:cubicBezTo>
                  <a:cubicBezTo>
                    <a:pt x="80294" y="720768"/>
                    <a:pt x="81738" y="723828"/>
                    <a:pt x="82550" y="727075"/>
                  </a:cubicBezTo>
                  <a:cubicBezTo>
                    <a:pt x="85645" y="739455"/>
                    <a:pt x="87108" y="752630"/>
                    <a:pt x="88900" y="765175"/>
                  </a:cubicBezTo>
                  <a:cubicBezTo>
                    <a:pt x="89958" y="785283"/>
                    <a:pt x="90331" y="805440"/>
                    <a:pt x="92075" y="825500"/>
                  </a:cubicBezTo>
                  <a:cubicBezTo>
                    <a:pt x="92453" y="829847"/>
                    <a:pt x="94336" y="833933"/>
                    <a:pt x="95250" y="838200"/>
                  </a:cubicBezTo>
                  <a:cubicBezTo>
                    <a:pt x="97511" y="848753"/>
                    <a:pt x="99483" y="859367"/>
                    <a:pt x="101600" y="869950"/>
                  </a:cubicBezTo>
                  <a:cubicBezTo>
                    <a:pt x="112396" y="923931"/>
                    <a:pt x="101919" y="851858"/>
                    <a:pt x="120650" y="908050"/>
                  </a:cubicBezTo>
                  <a:cubicBezTo>
                    <a:pt x="121708" y="911225"/>
                    <a:pt x="122328" y="914582"/>
                    <a:pt x="123825" y="917575"/>
                  </a:cubicBezTo>
                  <a:cubicBezTo>
                    <a:pt x="128245" y="926416"/>
                    <a:pt x="132678" y="929603"/>
                    <a:pt x="139700" y="936625"/>
                  </a:cubicBezTo>
                  <a:cubicBezTo>
                    <a:pt x="142065" y="943720"/>
                    <a:pt x="145297" y="958985"/>
                    <a:pt x="152400" y="965200"/>
                  </a:cubicBezTo>
                  <a:cubicBezTo>
                    <a:pt x="158143" y="970226"/>
                    <a:pt x="171450" y="977900"/>
                    <a:pt x="171450" y="977900"/>
                  </a:cubicBezTo>
                  <a:cubicBezTo>
                    <a:pt x="186267" y="1000125"/>
                    <a:pt x="177800" y="992717"/>
                    <a:pt x="193675" y="1003300"/>
                  </a:cubicBezTo>
                  <a:cubicBezTo>
                    <a:pt x="195792" y="1006475"/>
                    <a:pt x="197327" y="1010127"/>
                    <a:pt x="200025" y="1012825"/>
                  </a:cubicBezTo>
                  <a:cubicBezTo>
                    <a:pt x="202723" y="1015523"/>
                    <a:pt x="206445" y="1016957"/>
                    <a:pt x="209550" y="1019175"/>
                  </a:cubicBezTo>
                  <a:cubicBezTo>
                    <a:pt x="242459" y="1042682"/>
                    <a:pt x="197506" y="1012204"/>
                    <a:pt x="241300" y="1041400"/>
                  </a:cubicBezTo>
                  <a:cubicBezTo>
                    <a:pt x="247650" y="1045633"/>
                    <a:pt x="253878" y="1050055"/>
                    <a:pt x="260350" y="1054100"/>
                  </a:cubicBezTo>
                  <a:cubicBezTo>
                    <a:pt x="265583" y="1057371"/>
                    <a:pt x="271090" y="1060202"/>
                    <a:pt x="276225" y="1063625"/>
                  </a:cubicBezTo>
                  <a:cubicBezTo>
                    <a:pt x="288535" y="1071831"/>
                    <a:pt x="282130" y="1068768"/>
                    <a:pt x="295275" y="1073150"/>
                  </a:cubicBezTo>
                  <a:cubicBezTo>
                    <a:pt x="310369" y="1083213"/>
                    <a:pt x="301180" y="1078293"/>
                    <a:pt x="323850" y="1085850"/>
                  </a:cubicBezTo>
                  <a:lnTo>
                    <a:pt x="352425" y="1095375"/>
                  </a:lnTo>
                  <a:cubicBezTo>
                    <a:pt x="358532" y="1097411"/>
                    <a:pt x="365162" y="1097287"/>
                    <a:pt x="371475" y="1098550"/>
                  </a:cubicBezTo>
                  <a:cubicBezTo>
                    <a:pt x="375754" y="1099406"/>
                    <a:pt x="379942" y="1100667"/>
                    <a:pt x="384175" y="1101725"/>
                  </a:cubicBezTo>
                  <a:cubicBezTo>
                    <a:pt x="411472" y="1119923"/>
                    <a:pt x="376935" y="1098105"/>
                    <a:pt x="403225" y="1111250"/>
                  </a:cubicBezTo>
                  <a:cubicBezTo>
                    <a:pt x="406638" y="1112957"/>
                    <a:pt x="409263" y="1116050"/>
                    <a:pt x="412750" y="1117600"/>
                  </a:cubicBezTo>
                  <a:cubicBezTo>
                    <a:pt x="418867" y="1120318"/>
                    <a:pt x="425450" y="1121833"/>
                    <a:pt x="431800" y="1123950"/>
                  </a:cubicBezTo>
                  <a:lnTo>
                    <a:pt x="441325" y="1127125"/>
                  </a:lnTo>
                  <a:cubicBezTo>
                    <a:pt x="444500" y="1129242"/>
                    <a:pt x="447343" y="1131972"/>
                    <a:pt x="450850" y="1133475"/>
                  </a:cubicBezTo>
                  <a:cubicBezTo>
                    <a:pt x="454861" y="1135194"/>
                    <a:pt x="459271" y="1135794"/>
                    <a:pt x="463550" y="1136650"/>
                  </a:cubicBezTo>
                  <a:cubicBezTo>
                    <a:pt x="502474" y="1144435"/>
                    <a:pt x="465801" y="1135625"/>
                    <a:pt x="495300" y="1143000"/>
                  </a:cubicBezTo>
                  <a:cubicBezTo>
                    <a:pt x="536575" y="1141942"/>
                    <a:pt x="577914" y="1142348"/>
                    <a:pt x="619125" y="1139825"/>
                  </a:cubicBezTo>
                  <a:cubicBezTo>
                    <a:pt x="646021" y="1138178"/>
                    <a:pt x="643159" y="1135226"/>
                    <a:pt x="660400" y="1130300"/>
                  </a:cubicBezTo>
                  <a:cubicBezTo>
                    <a:pt x="664596" y="1129101"/>
                    <a:pt x="668904" y="1128324"/>
                    <a:pt x="673100" y="1127125"/>
                  </a:cubicBezTo>
                  <a:cubicBezTo>
                    <a:pt x="676318" y="1126206"/>
                    <a:pt x="679407" y="1124869"/>
                    <a:pt x="682625" y="1123950"/>
                  </a:cubicBezTo>
                  <a:cubicBezTo>
                    <a:pt x="710532" y="1115977"/>
                    <a:pt x="682012" y="1125213"/>
                    <a:pt x="704850" y="1117600"/>
                  </a:cubicBezTo>
                  <a:cubicBezTo>
                    <a:pt x="732147" y="1099402"/>
                    <a:pt x="697610" y="1121220"/>
                    <a:pt x="723900" y="1108075"/>
                  </a:cubicBezTo>
                  <a:cubicBezTo>
                    <a:pt x="745826" y="1097112"/>
                    <a:pt x="719694" y="1105158"/>
                    <a:pt x="746125" y="1098550"/>
                  </a:cubicBezTo>
                  <a:cubicBezTo>
                    <a:pt x="761219" y="1088487"/>
                    <a:pt x="752030" y="1093407"/>
                    <a:pt x="774700" y="1085850"/>
                  </a:cubicBezTo>
                  <a:cubicBezTo>
                    <a:pt x="791399" y="1080284"/>
                    <a:pt x="782990" y="1080118"/>
                    <a:pt x="796925" y="1073150"/>
                  </a:cubicBezTo>
                  <a:cubicBezTo>
                    <a:pt x="799918" y="1071653"/>
                    <a:pt x="803275" y="1071033"/>
                    <a:pt x="806450" y="1069975"/>
                  </a:cubicBezTo>
                  <a:cubicBezTo>
                    <a:pt x="809625" y="1067858"/>
                    <a:pt x="813044" y="1066068"/>
                    <a:pt x="815975" y="1063625"/>
                  </a:cubicBezTo>
                  <a:cubicBezTo>
                    <a:pt x="819424" y="1060750"/>
                    <a:pt x="821764" y="1056591"/>
                    <a:pt x="825500" y="1054100"/>
                  </a:cubicBezTo>
                  <a:cubicBezTo>
                    <a:pt x="828285" y="1052244"/>
                    <a:pt x="831850" y="1051983"/>
                    <a:pt x="835025" y="1050925"/>
                  </a:cubicBezTo>
                  <a:cubicBezTo>
                    <a:pt x="862322" y="1032727"/>
                    <a:pt x="827785" y="1054545"/>
                    <a:pt x="854075" y="1041400"/>
                  </a:cubicBezTo>
                  <a:cubicBezTo>
                    <a:pt x="857488" y="1039693"/>
                    <a:pt x="860113" y="1036600"/>
                    <a:pt x="863600" y="1035050"/>
                  </a:cubicBezTo>
                  <a:cubicBezTo>
                    <a:pt x="869717" y="1032332"/>
                    <a:pt x="882650" y="1028700"/>
                    <a:pt x="882650" y="1028700"/>
                  </a:cubicBezTo>
                  <a:cubicBezTo>
                    <a:pt x="909947" y="1010502"/>
                    <a:pt x="875410" y="1032320"/>
                    <a:pt x="901700" y="1019175"/>
                  </a:cubicBezTo>
                  <a:cubicBezTo>
                    <a:pt x="905113" y="1017468"/>
                    <a:pt x="907738" y="1014375"/>
                    <a:pt x="911225" y="1012825"/>
                  </a:cubicBezTo>
                  <a:cubicBezTo>
                    <a:pt x="917342" y="1010107"/>
                    <a:pt x="930275" y="1006475"/>
                    <a:pt x="930275" y="1006475"/>
                  </a:cubicBezTo>
                  <a:lnTo>
                    <a:pt x="958850" y="987425"/>
                  </a:lnTo>
                  <a:cubicBezTo>
                    <a:pt x="961635" y="985569"/>
                    <a:pt x="965200" y="985308"/>
                    <a:pt x="968375" y="984250"/>
                  </a:cubicBezTo>
                  <a:cubicBezTo>
                    <a:pt x="971550" y="981075"/>
                    <a:pt x="974356" y="977482"/>
                    <a:pt x="977900" y="974725"/>
                  </a:cubicBezTo>
                  <a:cubicBezTo>
                    <a:pt x="983924" y="970040"/>
                    <a:pt x="996950" y="962025"/>
                    <a:pt x="996950" y="962025"/>
                  </a:cubicBezTo>
                  <a:cubicBezTo>
                    <a:pt x="1008683" y="944426"/>
                    <a:pt x="996587" y="958346"/>
                    <a:pt x="1012825" y="949325"/>
                  </a:cubicBezTo>
                  <a:lnTo>
                    <a:pt x="1041400" y="930275"/>
                  </a:lnTo>
                  <a:cubicBezTo>
                    <a:pt x="1045803" y="927340"/>
                    <a:pt x="1049506" y="923375"/>
                    <a:pt x="1054100" y="920750"/>
                  </a:cubicBezTo>
                  <a:cubicBezTo>
                    <a:pt x="1057006" y="919090"/>
                    <a:pt x="1060450" y="918633"/>
                    <a:pt x="1063625" y="917575"/>
                  </a:cubicBezTo>
                  <a:cubicBezTo>
                    <a:pt x="1068240" y="903731"/>
                    <a:pt x="1067939" y="899063"/>
                    <a:pt x="1076325" y="889000"/>
                  </a:cubicBezTo>
                  <a:cubicBezTo>
                    <a:pt x="1079200" y="885551"/>
                    <a:pt x="1082306" y="882232"/>
                    <a:pt x="1085850" y="879475"/>
                  </a:cubicBezTo>
                  <a:cubicBezTo>
                    <a:pt x="1091874" y="874790"/>
                    <a:pt x="1104900" y="866775"/>
                    <a:pt x="1104900" y="866775"/>
                  </a:cubicBezTo>
                  <a:cubicBezTo>
                    <a:pt x="1107017" y="863600"/>
                    <a:pt x="1108715" y="860102"/>
                    <a:pt x="1111250" y="857250"/>
                  </a:cubicBezTo>
                  <a:cubicBezTo>
                    <a:pt x="1117216" y="850538"/>
                    <a:pt x="1130300" y="838200"/>
                    <a:pt x="1130300" y="838200"/>
                  </a:cubicBezTo>
                  <a:cubicBezTo>
                    <a:pt x="1137849" y="815552"/>
                    <a:pt x="1127145" y="842933"/>
                    <a:pt x="1143000" y="819150"/>
                  </a:cubicBezTo>
                  <a:cubicBezTo>
                    <a:pt x="1144856" y="816365"/>
                    <a:pt x="1144678" y="812618"/>
                    <a:pt x="1146175" y="809625"/>
                  </a:cubicBezTo>
                  <a:cubicBezTo>
                    <a:pt x="1147882" y="806212"/>
                    <a:pt x="1150975" y="803587"/>
                    <a:pt x="1152525" y="800100"/>
                  </a:cubicBezTo>
                  <a:cubicBezTo>
                    <a:pt x="1155243" y="793983"/>
                    <a:pt x="1156758" y="787400"/>
                    <a:pt x="1158875" y="781050"/>
                  </a:cubicBezTo>
                  <a:cubicBezTo>
                    <a:pt x="1159933" y="777875"/>
                    <a:pt x="1159265" y="773381"/>
                    <a:pt x="1162050" y="771525"/>
                  </a:cubicBezTo>
                  <a:lnTo>
                    <a:pt x="1171575" y="765175"/>
                  </a:lnTo>
                  <a:lnTo>
                    <a:pt x="1181100" y="736600"/>
                  </a:lnTo>
                  <a:lnTo>
                    <a:pt x="1184275" y="727075"/>
                  </a:lnTo>
                  <a:lnTo>
                    <a:pt x="1187450" y="717550"/>
                  </a:lnTo>
                  <a:cubicBezTo>
                    <a:pt x="1186392" y="712258"/>
                    <a:pt x="1185695" y="706881"/>
                    <a:pt x="1184275" y="701675"/>
                  </a:cubicBezTo>
                  <a:lnTo>
                    <a:pt x="1174750" y="673100"/>
                  </a:lnTo>
                  <a:lnTo>
                    <a:pt x="1171575" y="663575"/>
                  </a:lnTo>
                  <a:lnTo>
                    <a:pt x="1168400" y="654050"/>
                  </a:lnTo>
                  <a:cubicBezTo>
                    <a:pt x="1167342" y="627592"/>
                    <a:pt x="1167776" y="601031"/>
                    <a:pt x="1165225" y="574675"/>
                  </a:cubicBezTo>
                  <a:cubicBezTo>
                    <a:pt x="1164580" y="568013"/>
                    <a:pt x="1160992" y="561975"/>
                    <a:pt x="1158875" y="555625"/>
                  </a:cubicBezTo>
                  <a:cubicBezTo>
                    <a:pt x="1153287" y="538860"/>
                    <a:pt x="1157556" y="548885"/>
                    <a:pt x="1143000" y="527050"/>
                  </a:cubicBezTo>
                  <a:cubicBezTo>
                    <a:pt x="1140883" y="523875"/>
                    <a:pt x="1137857" y="521145"/>
                    <a:pt x="1136650" y="517525"/>
                  </a:cubicBezTo>
                  <a:cubicBezTo>
                    <a:pt x="1135592" y="514350"/>
                    <a:pt x="1135100" y="510926"/>
                    <a:pt x="1133475" y="508000"/>
                  </a:cubicBezTo>
                  <a:cubicBezTo>
                    <a:pt x="1120098" y="483921"/>
                    <a:pt x="1122671" y="497174"/>
                    <a:pt x="1117600" y="479425"/>
                  </a:cubicBezTo>
                  <a:cubicBezTo>
                    <a:pt x="1116401" y="475229"/>
                    <a:pt x="1115372" y="470985"/>
                    <a:pt x="1114425" y="466725"/>
                  </a:cubicBezTo>
                  <a:cubicBezTo>
                    <a:pt x="1113254" y="461457"/>
                    <a:pt x="1112670" y="456056"/>
                    <a:pt x="1111250" y="450850"/>
                  </a:cubicBezTo>
                  <a:cubicBezTo>
                    <a:pt x="1109489" y="444392"/>
                    <a:pt x="1107017" y="438150"/>
                    <a:pt x="1104900" y="431800"/>
                  </a:cubicBezTo>
                  <a:lnTo>
                    <a:pt x="1092200" y="393700"/>
                  </a:lnTo>
                  <a:cubicBezTo>
                    <a:pt x="1090993" y="390080"/>
                    <a:pt x="1087400" y="387662"/>
                    <a:pt x="1085850" y="384175"/>
                  </a:cubicBezTo>
                  <a:cubicBezTo>
                    <a:pt x="1083132" y="378058"/>
                    <a:pt x="1081617" y="371475"/>
                    <a:pt x="1079500" y="365125"/>
                  </a:cubicBezTo>
                  <a:lnTo>
                    <a:pt x="1066800" y="327025"/>
                  </a:lnTo>
                  <a:cubicBezTo>
                    <a:pt x="1065593" y="323405"/>
                    <a:pt x="1062000" y="320987"/>
                    <a:pt x="1060450" y="317500"/>
                  </a:cubicBezTo>
                  <a:cubicBezTo>
                    <a:pt x="1045337" y="283495"/>
                    <a:pt x="1062121" y="310481"/>
                    <a:pt x="1047750" y="288925"/>
                  </a:cubicBezTo>
                  <a:cubicBezTo>
                    <a:pt x="1046692" y="284692"/>
                    <a:pt x="1046294" y="280236"/>
                    <a:pt x="1044575" y="276225"/>
                  </a:cubicBezTo>
                  <a:cubicBezTo>
                    <a:pt x="1039934" y="265395"/>
                    <a:pt x="1035982" y="266537"/>
                    <a:pt x="1028700" y="257175"/>
                  </a:cubicBezTo>
                  <a:cubicBezTo>
                    <a:pt x="1024015" y="251151"/>
                    <a:pt x="1022350" y="242358"/>
                    <a:pt x="1016000" y="238125"/>
                  </a:cubicBezTo>
                  <a:cubicBezTo>
                    <a:pt x="1012825" y="236008"/>
                    <a:pt x="1009406" y="234218"/>
                    <a:pt x="1006475" y="231775"/>
                  </a:cubicBezTo>
                  <a:cubicBezTo>
                    <a:pt x="995942" y="222998"/>
                    <a:pt x="999249" y="221812"/>
                    <a:pt x="987425" y="215900"/>
                  </a:cubicBezTo>
                  <a:cubicBezTo>
                    <a:pt x="984432" y="214403"/>
                    <a:pt x="981075" y="213783"/>
                    <a:pt x="977900" y="212725"/>
                  </a:cubicBezTo>
                  <a:cubicBezTo>
                    <a:pt x="971550" y="208492"/>
                    <a:pt x="961263" y="207265"/>
                    <a:pt x="958850" y="200025"/>
                  </a:cubicBezTo>
                  <a:cubicBezTo>
                    <a:pt x="953262" y="183260"/>
                    <a:pt x="957531" y="193285"/>
                    <a:pt x="942975" y="171450"/>
                  </a:cubicBezTo>
                  <a:lnTo>
                    <a:pt x="930275" y="152400"/>
                  </a:lnTo>
                  <a:cubicBezTo>
                    <a:pt x="928158" y="149225"/>
                    <a:pt x="923925" y="148167"/>
                    <a:pt x="920750" y="146050"/>
                  </a:cubicBezTo>
                  <a:cubicBezTo>
                    <a:pt x="919692" y="142875"/>
                    <a:pt x="919942" y="138892"/>
                    <a:pt x="917575" y="136525"/>
                  </a:cubicBezTo>
                  <a:cubicBezTo>
                    <a:pt x="903721" y="122671"/>
                    <a:pt x="900882" y="124952"/>
                    <a:pt x="885825" y="120650"/>
                  </a:cubicBezTo>
                  <a:cubicBezTo>
                    <a:pt x="882607" y="119731"/>
                    <a:pt x="879640" y="117684"/>
                    <a:pt x="876300" y="117475"/>
                  </a:cubicBezTo>
                  <a:cubicBezTo>
                    <a:pt x="862568" y="116617"/>
                    <a:pt x="863071" y="119063"/>
                    <a:pt x="857250" y="117475"/>
                  </a:cubicBezTo>
                  <a:close/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</p:grpSp>
      <p:sp>
        <p:nvSpPr>
          <p:cNvPr id="2" name="テキスト ボックス 1"/>
          <p:cNvSpPr txBox="1"/>
          <p:nvPr/>
        </p:nvSpPr>
        <p:spPr>
          <a:xfrm>
            <a:off x="7430" y="0"/>
            <a:ext cx="3430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4.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9" name="正方形/長方形 18"/>
          <p:cNvSpPr/>
          <p:nvPr/>
        </p:nvSpPr>
        <p:spPr>
          <a:xfrm>
            <a:off x="1693568" y="700269"/>
            <a:ext cx="45719" cy="51414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47" name="正方形/長方形 146"/>
          <p:cNvSpPr/>
          <p:nvPr/>
        </p:nvSpPr>
        <p:spPr>
          <a:xfrm>
            <a:off x="3392164" y="921844"/>
            <a:ext cx="45719" cy="51414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48" name="正方形/長方形 147"/>
          <p:cNvSpPr/>
          <p:nvPr/>
        </p:nvSpPr>
        <p:spPr>
          <a:xfrm>
            <a:off x="5083873" y="849836"/>
            <a:ext cx="45719" cy="51414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49" name="正方形/長方形 148"/>
          <p:cNvSpPr/>
          <p:nvPr/>
        </p:nvSpPr>
        <p:spPr>
          <a:xfrm>
            <a:off x="6732240" y="849836"/>
            <a:ext cx="45719" cy="51414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2155457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6" name="Picture 1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290" y="369635"/>
            <a:ext cx="2247253" cy="22600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4" name="Picture 1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77"/>
          <a:stretch/>
        </p:blipFill>
        <p:spPr bwMode="auto">
          <a:xfrm>
            <a:off x="3417208" y="932198"/>
            <a:ext cx="1656002" cy="16892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2" name="Picture 10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03"/>
          <a:stretch/>
        </p:blipFill>
        <p:spPr bwMode="auto">
          <a:xfrm>
            <a:off x="53968" y="932198"/>
            <a:ext cx="1656002" cy="16742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3" name="Picture 11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27"/>
          <a:stretch/>
        </p:blipFill>
        <p:spPr bwMode="auto">
          <a:xfrm>
            <a:off x="1732054" y="932198"/>
            <a:ext cx="1656002" cy="1671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5" name="Picture 13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77"/>
          <a:stretch/>
        </p:blipFill>
        <p:spPr bwMode="auto">
          <a:xfrm>
            <a:off x="5111292" y="941434"/>
            <a:ext cx="1656002" cy="16892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テキスト ボックス 1"/>
          <p:cNvSpPr txBox="1"/>
          <p:nvPr/>
        </p:nvSpPr>
        <p:spPr>
          <a:xfrm>
            <a:off x="7430" y="0"/>
            <a:ext cx="2986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4.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0" y="3031720"/>
            <a:ext cx="1834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r>
              <a:rPr kumimoji="1" lang="en-US" altLang="ja-JP" sz="16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ontrol case (C2)</a:t>
            </a:r>
            <a:endParaRPr kumimoji="1" lang="ja-JP" altLang="en-US" sz="1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0" name="フリーフォーム 39"/>
          <p:cNvSpPr/>
          <p:nvPr/>
        </p:nvSpPr>
        <p:spPr>
          <a:xfrm>
            <a:off x="4749155" y="3645900"/>
            <a:ext cx="176407" cy="273222"/>
          </a:xfrm>
          <a:custGeom>
            <a:avLst/>
            <a:gdLst>
              <a:gd name="connsiteX0" fmla="*/ 403761 w 645734"/>
              <a:gd name="connsiteY0" fmla="*/ 0 h 1000124"/>
              <a:gd name="connsiteX1" fmla="*/ 356260 w 645734"/>
              <a:gd name="connsiteY1" fmla="*/ 59377 h 1000124"/>
              <a:gd name="connsiteX2" fmla="*/ 344385 w 645734"/>
              <a:gd name="connsiteY2" fmla="*/ 154380 h 1000124"/>
              <a:gd name="connsiteX3" fmla="*/ 332509 w 645734"/>
              <a:gd name="connsiteY3" fmla="*/ 190006 h 1000124"/>
              <a:gd name="connsiteX4" fmla="*/ 296883 w 645734"/>
              <a:gd name="connsiteY4" fmla="*/ 213756 h 1000124"/>
              <a:gd name="connsiteX5" fmla="*/ 261257 w 645734"/>
              <a:gd name="connsiteY5" fmla="*/ 285008 h 1000124"/>
              <a:gd name="connsiteX6" fmla="*/ 249382 w 645734"/>
              <a:gd name="connsiteY6" fmla="*/ 320634 h 1000124"/>
              <a:gd name="connsiteX7" fmla="*/ 178130 w 645734"/>
              <a:gd name="connsiteY7" fmla="*/ 356260 h 1000124"/>
              <a:gd name="connsiteX8" fmla="*/ 142504 w 645734"/>
              <a:gd name="connsiteY8" fmla="*/ 380011 h 1000124"/>
              <a:gd name="connsiteX9" fmla="*/ 118753 w 645734"/>
              <a:gd name="connsiteY9" fmla="*/ 415637 h 1000124"/>
              <a:gd name="connsiteX10" fmla="*/ 83127 w 645734"/>
              <a:gd name="connsiteY10" fmla="*/ 451263 h 1000124"/>
              <a:gd name="connsiteX11" fmla="*/ 59377 w 645734"/>
              <a:gd name="connsiteY11" fmla="*/ 522515 h 1000124"/>
              <a:gd name="connsiteX12" fmla="*/ 47501 w 645734"/>
              <a:gd name="connsiteY12" fmla="*/ 558141 h 1000124"/>
              <a:gd name="connsiteX13" fmla="*/ 23751 w 645734"/>
              <a:gd name="connsiteY13" fmla="*/ 593767 h 1000124"/>
              <a:gd name="connsiteX14" fmla="*/ 0 w 645734"/>
              <a:gd name="connsiteY14" fmla="*/ 665019 h 1000124"/>
              <a:gd name="connsiteX15" fmla="*/ 11875 w 645734"/>
              <a:gd name="connsiteY15" fmla="*/ 712520 h 1000124"/>
              <a:gd name="connsiteX16" fmla="*/ 118753 w 645734"/>
              <a:gd name="connsiteY16" fmla="*/ 771897 h 1000124"/>
              <a:gd name="connsiteX17" fmla="*/ 154379 w 645734"/>
              <a:gd name="connsiteY17" fmla="*/ 795647 h 1000124"/>
              <a:gd name="connsiteX18" fmla="*/ 190005 w 645734"/>
              <a:gd name="connsiteY18" fmla="*/ 831273 h 1000124"/>
              <a:gd name="connsiteX19" fmla="*/ 213756 w 645734"/>
              <a:gd name="connsiteY19" fmla="*/ 866899 h 1000124"/>
              <a:gd name="connsiteX20" fmla="*/ 249382 w 645734"/>
              <a:gd name="connsiteY20" fmla="*/ 878774 h 1000124"/>
              <a:gd name="connsiteX21" fmla="*/ 285008 w 645734"/>
              <a:gd name="connsiteY21" fmla="*/ 950026 h 1000124"/>
              <a:gd name="connsiteX22" fmla="*/ 320634 w 645734"/>
              <a:gd name="connsiteY22" fmla="*/ 961902 h 1000124"/>
              <a:gd name="connsiteX23" fmla="*/ 344385 w 645734"/>
              <a:gd name="connsiteY23" fmla="*/ 997528 h 1000124"/>
              <a:gd name="connsiteX24" fmla="*/ 486888 w 645734"/>
              <a:gd name="connsiteY24" fmla="*/ 973777 h 1000124"/>
              <a:gd name="connsiteX25" fmla="*/ 522514 w 645734"/>
              <a:gd name="connsiteY25" fmla="*/ 950026 h 1000124"/>
              <a:gd name="connsiteX26" fmla="*/ 534390 w 645734"/>
              <a:gd name="connsiteY26" fmla="*/ 914400 h 1000124"/>
              <a:gd name="connsiteX27" fmla="*/ 558140 w 645734"/>
              <a:gd name="connsiteY27" fmla="*/ 878774 h 1000124"/>
              <a:gd name="connsiteX28" fmla="*/ 605642 w 645734"/>
              <a:gd name="connsiteY28" fmla="*/ 771897 h 1000124"/>
              <a:gd name="connsiteX29" fmla="*/ 617517 w 645734"/>
              <a:gd name="connsiteY29" fmla="*/ 368136 h 1000124"/>
              <a:gd name="connsiteX30" fmla="*/ 581891 w 645734"/>
              <a:gd name="connsiteY30" fmla="*/ 344385 h 1000124"/>
              <a:gd name="connsiteX31" fmla="*/ 558140 w 645734"/>
              <a:gd name="connsiteY31" fmla="*/ 308759 h 1000124"/>
              <a:gd name="connsiteX32" fmla="*/ 534390 w 645734"/>
              <a:gd name="connsiteY32" fmla="*/ 237507 h 1000124"/>
              <a:gd name="connsiteX33" fmla="*/ 486888 w 645734"/>
              <a:gd name="connsiteY33" fmla="*/ 166255 h 1000124"/>
              <a:gd name="connsiteX34" fmla="*/ 427512 w 645734"/>
              <a:gd name="connsiteY34" fmla="*/ 83128 h 1000124"/>
              <a:gd name="connsiteX35" fmla="*/ 391886 w 645734"/>
              <a:gd name="connsiteY35" fmla="*/ 59377 h 1000124"/>
              <a:gd name="connsiteX36" fmla="*/ 403761 w 645734"/>
              <a:gd name="connsiteY36" fmla="*/ 0 h 10001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</a:cxnLst>
            <a:rect l="l" t="t" r="r" b="b"/>
            <a:pathLst>
              <a:path w="645734" h="1000124">
                <a:moveTo>
                  <a:pt x="403761" y="0"/>
                </a:moveTo>
                <a:cubicBezTo>
                  <a:pt x="397823" y="0"/>
                  <a:pt x="365359" y="35720"/>
                  <a:pt x="356260" y="59377"/>
                </a:cubicBezTo>
                <a:cubicBezTo>
                  <a:pt x="344804" y="89164"/>
                  <a:pt x="350094" y="122981"/>
                  <a:pt x="344385" y="154380"/>
                </a:cubicBezTo>
                <a:cubicBezTo>
                  <a:pt x="342146" y="166696"/>
                  <a:pt x="340329" y="180231"/>
                  <a:pt x="332509" y="190006"/>
                </a:cubicBezTo>
                <a:cubicBezTo>
                  <a:pt x="323593" y="201151"/>
                  <a:pt x="308758" y="205839"/>
                  <a:pt x="296883" y="213756"/>
                </a:cubicBezTo>
                <a:cubicBezTo>
                  <a:pt x="267035" y="303303"/>
                  <a:pt x="307298" y="192925"/>
                  <a:pt x="261257" y="285008"/>
                </a:cubicBezTo>
                <a:cubicBezTo>
                  <a:pt x="255659" y="296204"/>
                  <a:pt x="257202" y="310859"/>
                  <a:pt x="249382" y="320634"/>
                </a:cubicBezTo>
                <a:cubicBezTo>
                  <a:pt x="232639" y="341563"/>
                  <a:pt x="201600" y="348437"/>
                  <a:pt x="178130" y="356260"/>
                </a:cubicBezTo>
                <a:cubicBezTo>
                  <a:pt x="166255" y="364177"/>
                  <a:pt x="152596" y="369919"/>
                  <a:pt x="142504" y="380011"/>
                </a:cubicBezTo>
                <a:cubicBezTo>
                  <a:pt x="132412" y="390103"/>
                  <a:pt x="127890" y="404673"/>
                  <a:pt x="118753" y="415637"/>
                </a:cubicBezTo>
                <a:cubicBezTo>
                  <a:pt x="108002" y="428539"/>
                  <a:pt x="95002" y="439388"/>
                  <a:pt x="83127" y="451263"/>
                </a:cubicBezTo>
                <a:lnTo>
                  <a:pt x="59377" y="522515"/>
                </a:lnTo>
                <a:cubicBezTo>
                  <a:pt x="55419" y="534390"/>
                  <a:pt x="54444" y="547725"/>
                  <a:pt x="47501" y="558141"/>
                </a:cubicBezTo>
                <a:cubicBezTo>
                  <a:pt x="39584" y="570016"/>
                  <a:pt x="29547" y="580725"/>
                  <a:pt x="23751" y="593767"/>
                </a:cubicBezTo>
                <a:cubicBezTo>
                  <a:pt x="13583" y="616645"/>
                  <a:pt x="0" y="665019"/>
                  <a:pt x="0" y="665019"/>
                </a:cubicBezTo>
                <a:cubicBezTo>
                  <a:pt x="3958" y="680853"/>
                  <a:pt x="1128" y="700237"/>
                  <a:pt x="11875" y="712520"/>
                </a:cubicBezTo>
                <a:cubicBezTo>
                  <a:pt x="70115" y="779080"/>
                  <a:pt x="66321" y="745681"/>
                  <a:pt x="118753" y="771897"/>
                </a:cubicBezTo>
                <a:cubicBezTo>
                  <a:pt x="131518" y="778280"/>
                  <a:pt x="143415" y="786510"/>
                  <a:pt x="154379" y="795647"/>
                </a:cubicBezTo>
                <a:cubicBezTo>
                  <a:pt x="167281" y="806398"/>
                  <a:pt x="179254" y="818371"/>
                  <a:pt x="190005" y="831273"/>
                </a:cubicBezTo>
                <a:cubicBezTo>
                  <a:pt x="199142" y="842237"/>
                  <a:pt x="202611" y="857983"/>
                  <a:pt x="213756" y="866899"/>
                </a:cubicBezTo>
                <a:cubicBezTo>
                  <a:pt x="223531" y="874719"/>
                  <a:pt x="237507" y="874816"/>
                  <a:pt x="249382" y="878774"/>
                </a:cubicBezTo>
                <a:cubicBezTo>
                  <a:pt x="257205" y="902244"/>
                  <a:pt x="264079" y="933283"/>
                  <a:pt x="285008" y="950026"/>
                </a:cubicBezTo>
                <a:cubicBezTo>
                  <a:pt x="294783" y="957846"/>
                  <a:pt x="308759" y="957943"/>
                  <a:pt x="320634" y="961902"/>
                </a:cubicBezTo>
                <a:cubicBezTo>
                  <a:pt x="328551" y="973777"/>
                  <a:pt x="330343" y="994975"/>
                  <a:pt x="344385" y="997528"/>
                </a:cubicBezTo>
                <a:cubicBezTo>
                  <a:pt x="395853" y="1006886"/>
                  <a:pt x="440951" y="989089"/>
                  <a:pt x="486888" y="973777"/>
                </a:cubicBezTo>
                <a:cubicBezTo>
                  <a:pt x="498763" y="965860"/>
                  <a:pt x="513598" y="961171"/>
                  <a:pt x="522514" y="950026"/>
                </a:cubicBezTo>
                <a:cubicBezTo>
                  <a:pt x="530334" y="940251"/>
                  <a:pt x="528792" y="925596"/>
                  <a:pt x="534390" y="914400"/>
                </a:cubicBezTo>
                <a:cubicBezTo>
                  <a:pt x="540773" y="901635"/>
                  <a:pt x="552343" y="891816"/>
                  <a:pt x="558140" y="878774"/>
                </a:cubicBezTo>
                <a:cubicBezTo>
                  <a:pt x="614665" y="751592"/>
                  <a:pt x="551892" y="852520"/>
                  <a:pt x="605642" y="771897"/>
                </a:cubicBezTo>
                <a:cubicBezTo>
                  <a:pt x="658836" y="612312"/>
                  <a:pt x="655215" y="650874"/>
                  <a:pt x="617517" y="368136"/>
                </a:cubicBezTo>
                <a:cubicBezTo>
                  <a:pt x="615631" y="353989"/>
                  <a:pt x="593766" y="352302"/>
                  <a:pt x="581891" y="344385"/>
                </a:cubicBezTo>
                <a:cubicBezTo>
                  <a:pt x="573974" y="332510"/>
                  <a:pt x="563937" y="321801"/>
                  <a:pt x="558140" y="308759"/>
                </a:cubicBezTo>
                <a:cubicBezTo>
                  <a:pt x="547972" y="285881"/>
                  <a:pt x="548277" y="258338"/>
                  <a:pt x="534390" y="237507"/>
                </a:cubicBezTo>
                <a:lnTo>
                  <a:pt x="486888" y="166255"/>
                </a:lnTo>
                <a:cubicBezTo>
                  <a:pt x="459180" y="83128"/>
                  <a:pt x="486889" y="102920"/>
                  <a:pt x="427512" y="83128"/>
                </a:cubicBezTo>
                <a:cubicBezTo>
                  <a:pt x="415637" y="75211"/>
                  <a:pt x="401978" y="69469"/>
                  <a:pt x="391886" y="59377"/>
                </a:cubicBezTo>
                <a:cubicBezTo>
                  <a:pt x="381794" y="49285"/>
                  <a:pt x="409699" y="0"/>
                  <a:pt x="403761" y="0"/>
                </a:cubicBezTo>
                <a:close/>
              </a:path>
            </a:pathLst>
          </a:custGeom>
          <a:noFill/>
          <a:ln w="1270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50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5084" y="3366953"/>
            <a:ext cx="1661170" cy="16825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" name="Picture 4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0987" y="3366954"/>
            <a:ext cx="1661170" cy="16825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" name="Picture 5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68" y="3367876"/>
            <a:ext cx="1661170" cy="16825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7" name="Picture 6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7222" y="3367875"/>
            <a:ext cx="1661170" cy="16825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2" name="直線コネクタ 61"/>
          <p:cNvCxnSpPr/>
          <p:nvPr/>
        </p:nvCxnSpPr>
        <p:spPr>
          <a:xfrm>
            <a:off x="5934761" y="4935985"/>
            <a:ext cx="72008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/>
          <p:cNvSpPr txBox="1"/>
          <p:nvPr/>
        </p:nvSpPr>
        <p:spPr>
          <a:xfrm>
            <a:off x="291817" y="3327521"/>
            <a:ext cx="1537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</a:t>
            </a:r>
            <a:r>
              <a:rPr lang="en-US" altLang="ja-JP" sz="1200" b="1" dirty="0" smtClean="0">
                <a:solidFill>
                  <a:srgbClr val="008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/</a:t>
            </a:r>
            <a:r>
              <a:rPr lang="en-US" altLang="ja-JP" sz="1200" b="1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Hoechst</a:t>
            </a:r>
            <a:endParaRPr lang="ja-JP" altLang="en-US" sz="1200" b="1" dirty="0">
              <a:solidFill>
                <a:schemeClr val="tx2">
                  <a:lumMod val="60000"/>
                  <a:lumOff val="40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2267744" y="3326755"/>
            <a:ext cx="1453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</a:t>
            </a:r>
            <a:endParaRPr lang="en-US" altLang="ja-JP" sz="120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3927281" y="3329318"/>
            <a:ext cx="1475656" cy="276999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SP1/</a:t>
            </a:r>
            <a:r>
              <a:rPr kumimoji="1" lang="en-US" altLang="ja-JP" sz="1200" b="1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Hoechst</a:t>
            </a:r>
            <a:endParaRPr kumimoji="1" lang="ja-JP" altLang="en-US" sz="1200" b="1" dirty="0">
              <a:solidFill>
                <a:schemeClr val="tx2">
                  <a:lumMod val="60000"/>
                  <a:lumOff val="40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6199202" y="3321962"/>
            <a:ext cx="590925" cy="276999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SP1</a:t>
            </a:r>
            <a:endParaRPr kumimoji="1" lang="ja-JP" altLang="en-US" sz="120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06456" y="2745899"/>
            <a:ext cx="2276087" cy="22991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7" name="テキスト ボックス 66"/>
          <p:cNvSpPr txBox="1"/>
          <p:nvPr/>
        </p:nvSpPr>
        <p:spPr>
          <a:xfrm>
            <a:off x="7234667" y="3307490"/>
            <a:ext cx="18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/</a:t>
            </a:r>
            <a:r>
              <a:rPr lang="en-US" altLang="ja-JP" sz="12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SP1</a:t>
            </a:r>
            <a:endParaRPr lang="ja-JP" altLang="en-US" sz="1200" b="1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" name="フリーフォーム 3"/>
          <p:cNvSpPr/>
          <p:nvPr/>
        </p:nvSpPr>
        <p:spPr>
          <a:xfrm>
            <a:off x="3675400" y="3529631"/>
            <a:ext cx="768774" cy="1086957"/>
          </a:xfrm>
          <a:custGeom>
            <a:avLst/>
            <a:gdLst>
              <a:gd name="connsiteX0" fmla="*/ 486199 w 768774"/>
              <a:gd name="connsiteY0" fmla="*/ 1107 h 1086957"/>
              <a:gd name="connsiteX1" fmla="*/ 470324 w 768774"/>
              <a:gd name="connsiteY1" fmla="*/ 4282 h 1086957"/>
              <a:gd name="connsiteX2" fmla="*/ 457624 w 768774"/>
              <a:gd name="connsiteY2" fmla="*/ 23332 h 1086957"/>
              <a:gd name="connsiteX3" fmla="*/ 444924 w 768774"/>
              <a:gd name="connsiteY3" fmla="*/ 42382 h 1086957"/>
              <a:gd name="connsiteX4" fmla="*/ 441749 w 768774"/>
              <a:gd name="connsiteY4" fmla="*/ 51907 h 1086957"/>
              <a:gd name="connsiteX5" fmla="*/ 425874 w 768774"/>
              <a:gd name="connsiteY5" fmla="*/ 70957 h 1086957"/>
              <a:gd name="connsiteX6" fmla="*/ 416349 w 768774"/>
              <a:gd name="connsiteY6" fmla="*/ 90007 h 1086957"/>
              <a:gd name="connsiteX7" fmla="*/ 406824 w 768774"/>
              <a:gd name="connsiteY7" fmla="*/ 96357 h 1086957"/>
              <a:gd name="connsiteX8" fmla="*/ 400474 w 768774"/>
              <a:gd name="connsiteY8" fmla="*/ 105882 h 1086957"/>
              <a:gd name="connsiteX9" fmla="*/ 381424 w 768774"/>
              <a:gd name="connsiteY9" fmla="*/ 112232 h 1086957"/>
              <a:gd name="connsiteX10" fmla="*/ 362374 w 768774"/>
              <a:gd name="connsiteY10" fmla="*/ 124932 h 1086957"/>
              <a:gd name="connsiteX11" fmla="*/ 352849 w 768774"/>
              <a:gd name="connsiteY11" fmla="*/ 131282 h 1086957"/>
              <a:gd name="connsiteX12" fmla="*/ 340149 w 768774"/>
              <a:gd name="connsiteY12" fmla="*/ 134457 h 1086957"/>
              <a:gd name="connsiteX13" fmla="*/ 311574 w 768774"/>
              <a:gd name="connsiteY13" fmla="*/ 153507 h 1086957"/>
              <a:gd name="connsiteX14" fmla="*/ 302049 w 768774"/>
              <a:gd name="connsiteY14" fmla="*/ 156682 h 1086957"/>
              <a:gd name="connsiteX15" fmla="*/ 292524 w 768774"/>
              <a:gd name="connsiteY15" fmla="*/ 163032 h 1086957"/>
              <a:gd name="connsiteX16" fmla="*/ 282999 w 768774"/>
              <a:gd name="connsiteY16" fmla="*/ 172557 h 1086957"/>
              <a:gd name="connsiteX17" fmla="*/ 273474 w 768774"/>
              <a:gd name="connsiteY17" fmla="*/ 175732 h 1086957"/>
              <a:gd name="connsiteX18" fmla="*/ 260774 w 768774"/>
              <a:gd name="connsiteY18" fmla="*/ 194782 h 1086957"/>
              <a:gd name="connsiteX19" fmla="*/ 241724 w 768774"/>
              <a:gd name="connsiteY19" fmla="*/ 210657 h 1086957"/>
              <a:gd name="connsiteX20" fmla="*/ 225849 w 768774"/>
              <a:gd name="connsiteY20" fmla="*/ 223357 h 1086957"/>
              <a:gd name="connsiteX21" fmla="*/ 219499 w 768774"/>
              <a:gd name="connsiteY21" fmla="*/ 232882 h 1086957"/>
              <a:gd name="connsiteX22" fmla="*/ 216324 w 768774"/>
              <a:gd name="connsiteY22" fmla="*/ 242407 h 1086957"/>
              <a:gd name="connsiteX23" fmla="*/ 206799 w 768774"/>
              <a:gd name="connsiteY23" fmla="*/ 248757 h 1086957"/>
              <a:gd name="connsiteX24" fmla="*/ 181399 w 768774"/>
              <a:gd name="connsiteY24" fmla="*/ 286857 h 1086957"/>
              <a:gd name="connsiteX25" fmla="*/ 168699 w 768774"/>
              <a:gd name="connsiteY25" fmla="*/ 305907 h 1086957"/>
              <a:gd name="connsiteX26" fmla="*/ 159174 w 768774"/>
              <a:gd name="connsiteY26" fmla="*/ 312257 h 1086957"/>
              <a:gd name="connsiteX27" fmla="*/ 155999 w 768774"/>
              <a:gd name="connsiteY27" fmla="*/ 321782 h 1086957"/>
              <a:gd name="connsiteX28" fmla="*/ 146474 w 768774"/>
              <a:gd name="connsiteY28" fmla="*/ 328132 h 1086957"/>
              <a:gd name="connsiteX29" fmla="*/ 136949 w 768774"/>
              <a:gd name="connsiteY29" fmla="*/ 337657 h 1086957"/>
              <a:gd name="connsiteX30" fmla="*/ 133774 w 768774"/>
              <a:gd name="connsiteY30" fmla="*/ 347182 h 1086957"/>
              <a:gd name="connsiteX31" fmla="*/ 121074 w 768774"/>
              <a:gd name="connsiteY31" fmla="*/ 366232 h 1086957"/>
              <a:gd name="connsiteX32" fmla="*/ 114724 w 768774"/>
              <a:gd name="connsiteY32" fmla="*/ 375757 h 1086957"/>
              <a:gd name="connsiteX33" fmla="*/ 95674 w 768774"/>
              <a:gd name="connsiteY33" fmla="*/ 404332 h 1086957"/>
              <a:gd name="connsiteX34" fmla="*/ 89324 w 768774"/>
              <a:gd name="connsiteY34" fmla="*/ 417032 h 1086957"/>
              <a:gd name="connsiteX35" fmla="*/ 79799 w 768774"/>
              <a:gd name="connsiteY35" fmla="*/ 429732 h 1086957"/>
              <a:gd name="connsiteX36" fmla="*/ 76624 w 768774"/>
              <a:gd name="connsiteY36" fmla="*/ 439257 h 1086957"/>
              <a:gd name="connsiteX37" fmla="*/ 60749 w 768774"/>
              <a:gd name="connsiteY37" fmla="*/ 458307 h 1086957"/>
              <a:gd name="connsiteX38" fmla="*/ 54399 w 768774"/>
              <a:gd name="connsiteY38" fmla="*/ 477357 h 1086957"/>
              <a:gd name="connsiteX39" fmla="*/ 48049 w 768774"/>
              <a:gd name="connsiteY39" fmla="*/ 486882 h 1086957"/>
              <a:gd name="connsiteX40" fmla="*/ 41699 w 768774"/>
              <a:gd name="connsiteY40" fmla="*/ 505932 h 1086957"/>
              <a:gd name="connsiteX41" fmla="*/ 35349 w 768774"/>
              <a:gd name="connsiteY41" fmla="*/ 515457 h 1086957"/>
              <a:gd name="connsiteX42" fmla="*/ 28999 w 768774"/>
              <a:gd name="connsiteY42" fmla="*/ 534507 h 1086957"/>
              <a:gd name="connsiteX43" fmla="*/ 22649 w 768774"/>
              <a:gd name="connsiteY43" fmla="*/ 553557 h 1086957"/>
              <a:gd name="connsiteX44" fmla="*/ 19474 w 768774"/>
              <a:gd name="connsiteY44" fmla="*/ 563082 h 1086957"/>
              <a:gd name="connsiteX45" fmla="*/ 13124 w 768774"/>
              <a:gd name="connsiteY45" fmla="*/ 572607 h 1086957"/>
              <a:gd name="connsiteX46" fmla="*/ 9949 w 768774"/>
              <a:gd name="connsiteY46" fmla="*/ 585307 h 1086957"/>
              <a:gd name="connsiteX47" fmla="*/ 3599 w 768774"/>
              <a:gd name="connsiteY47" fmla="*/ 604357 h 1086957"/>
              <a:gd name="connsiteX48" fmla="*/ 3599 w 768774"/>
              <a:gd name="connsiteY48" fmla="*/ 680557 h 1086957"/>
              <a:gd name="connsiteX49" fmla="*/ 19474 w 768774"/>
              <a:gd name="connsiteY49" fmla="*/ 705957 h 1086957"/>
              <a:gd name="connsiteX50" fmla="*/ 22649 w 768774"/>
              <a:gd name="connsiteY50" fmla="*/ 715482 h 1086957"/>
              <a:gd name="connsiteX51" fmla="*/ 38524 w 768774"/>
              <a:gd name="connsiteY51" fmla="*/ 734532 h 1086957"/>
              <a:gd name="connsiteX52" fmla="*/ 57574 w 768774"/>
              <a:gd name="connsiteY52" fmla="*/ 747232 h 1086957"/>
              <a:gd name="connsiteX53" fmla="*/ 73449 w 768774"/>
              <a:gd name="connsiteY53" fmla="*/ 763107 h 1086957"/>
              <a:gd name="connsiteX54" fmla="*/ 79799 w 768774"/>
              <a:gd name="connsiteY54" fmla="*/ 772632 h 1086957"/>
              <a:gd name="connsiteX55" fmla="*/ 89324 w 768774"/>
              <a:gd name="connsiteY55" fmla="*/ 782157 h 1086957"/>
              <a:gd name="connsiteX56" fmla="*/ 102024 w 768774"/>
              <a:gd name="connsiteY56" fmla="*/ 801207 h 1086957"/>
              <a:gd name="connsiteX57" fmla="*/ 108374 w 768774"/>
              <a:gd name="connsiteY57" fmla="*/ 810732 h 1086957"/>
              <a:gd name="connsiteX58" fmla="*/ 117899 w 768774"/>
              <a:gd name="connsiteY58" fmla="*/ 820257 h 1086957"/>
              <a:gd name="connsiteX59" fmla="*/ 130599 w 768774"/>
              <a:gd name="connsiteY59" fmla="*/ 839307 h 1086957"/>
              <a:gd name="connsiteX60" fmla="*/ 143299 w 768774"/>
              <a:gd name="connsiteY60" fmla="*/ 858357 h 1086957"/>
              <a:gd name="connsiteX61" fmla="*/ 155999 w 768774"/>
              <a:gd name="connsiteY61" fmla="*/ 877407 h 1086957"/>
              <a:gd name="connsiteX62" fmla="*/ 165524 w 768774"/>
              <a:gd name="connsiteY62" fmla="*/ 896457 h 1086957"/>
              <a:gd name="connsiteX63" fmla="*/ 168699 w 768774"/>
              <a:gd name="connsiteY63" fmla="*/ 905982 h 1086957"/>
              <a:gd name="connsiteX64" fmla="*/ 187749 w 768774"/>
              <a:gd name="connsiteY64" fmla="*/ 937732 h 1086957"/>
              <a:gd name="connsiteX65" fmla="*/ 194099 w 768774"/>
              <a:gd name="connsiteY65" fmla="*/ 947257 h 1086957"/>
              <a:gd name="connsiteX66" fmla="*/ 203624 w 768774"/>
              <a:gd name="connsiteY66" fmla="*/ 953607 h 1086957"/>
              <a:gd name="connsiteX67" fmla="*/ 222674 w 768774"/>
              <a:gd name="connsiteY67" fmla="*/ 972657 h 1086957"/>
              <a:gd name="connsiteX68" fmla="*/ 251249 w 768774"/>
              <a:gd name="connsiteY68" fmla="*/ 988532 h 1086957"/>
              <a:gd name="connsiteX69" fmla="*/ 270299 w 768774"/>
              <a:gd name="connsiteY69" fmla="*/ 998057 h 1086957"/>
              <a:gd name="connsiteX70" fmla="*/ 279824 w 768774"/>
              <a:gd name="connsiteY70" fmla="*/ 1004407 h 1086957"/>
              <a:gd name="connsiteX71" fmla="*/ 298874 w 768774"/>
              <a:gd name="connsiteY71" fmla="*/ 1010757 h 1086957"/>
              <a:gd name="connsiteX72" fmla="*/ 317924 w 768774"/>
              <a:gd name="connsiteY72" fmla="*/ 1020282 h 1086957"/>
              <a:gd name="connsiteX73" fmla="*/ 327449 w 768774"/>
              <a:gd name="connsiteY73" fmla="*/ 1026632 h 1086957"/>
              <a:gd name="connsiteX74" fmla="*/ 346499 w 768774"/>
              <a:gd name="connsiteY74" fmla="*/ 1032982 h 1086957"/>
              <a:gd name="connsiteX75" fmla="*/ 365549 w 768774"/>
              <a:gd name="connsiteY75" fmla="*/ 1039332 h 1086957"/>
              <a:gd name="connsiteX76" fmla="*/ 387774 w 768774"/>
              <a:gd name="connsiteY76" fmla="*/ 1052032 h 1086957"/>
              <a:gd name="connsiteX77" fmla="*/ 400474 w 768774"/>
              <a:gd name="connsiteY77" fmla="*/ 1055207 h 1086957"/>
              <a:gd name="connsiteX78" fmla="*/ 435399 w 768774"/>
              <a:gd name="connsiteY78" fmla="*/ 1058382 h 1086957"/>
              <a:gd name="connsiteX79" fmla="*/ 454449 w 768774"/>
              <a:gd name="connsiteY79" fmla="*/ 1061557 h 1086957"/>
              <a:gd name="connsiteX80" fmla="*/ 502074 w 768774"/>
              <a:gd name="connsiteY80" fmla="*/ 1077432 h 1086957"/>
              <a:gd name="connsiteX81" fmla="*/ 521124 w 768774"/>
              <a:gd name="connsiteY81" fmla="*/ 1080607 h 1086957"/>
              <a:gd name="connsiteX82" fmla="*/ 543349 w 768774"/>
              <a:gd name="connsiteY82" fmla="*/ 1086957 h 1086957"/>
              <a:gd name="connsiteX83" fmla="*/ 581449 w 768774"/>
              <a:gd name="connsiteY83" fmla="*/ 1083782 h 1086957"/>
              <a:gd name="connsiteX84" fmla="*/ 600499 w 768774"/>
              <a:gd name="connsiteY84" fmla="*/ 1077432 h 1086957"/>
              <a:gd name="connsiteX85" fmla="*/ 610024 w 768774"/>
              <a:gd name="connsiteY85" fmla="*/ 1074257 h 1086957"/>
              <a:gd name="connsiteX86" fmla="*/ 629074 w 768774"/>
              <a:gd name="connsiteY86" fmla="*/ 1061557 h 1086957"/>
              <a:gd name="connsiteX87" fmla="*/ 648124 w 768774"/>
              <a:gd name="connsiteY87" fmla="*/ 1055207 h 1086957"/>
              <a:gd name="connsiteX88" fmla="*/ 667174 w 768774"/>
              <a:gd name="connsiteY88" fmla="*/ 1042507 h 1086957"/>
              <a:gd name="connsiteX89" fmla="*/ 676699 w 768774"/>
              <a:gd name="connsiteY89" fmla="*/ 1036157 h 1086957"/>
              <a:gd name="connsiteX90" fmla="*/ 686224 w 768774"/>
              <a:gd name="connsiteY90" fmla="*/ 1032982 h 1086957"/>
              <a:gd name="connsiteX91" fmla="*/ 692574 w 768774"/>
              <a:gd name="connsiteY91" fmla="*/ 1023457 h 1086957"/>
              <a:gd name="connsiteX92" fmla="*/ 714799 w 768774"/>
              <a:gd name="connsiteY92" fmla="*/ 1001232 h 1086957"/>
              <a:gd name="connsiteX93" fmla="*/ 730674 w 768774"/>
              <a:gd name="connsiteY93" fmla="*/ 972657 h 1086957"/>
              <a:gd name="connsiteX94" fmla="*/ 737024 w 768774"/>
              <a:gd name="connsiteY94" fmla="*/ 963132 h 1086957"/>
              <a:gd name="connsiteX95" fmla="*/ 746549 w 768774"/>
              <a:gd name="connsiteY95" fmla="*/ 944082 h 1086957"/>
              <a:gd name="connsiteX96" fmla="*/ 759249 w 768774"/>
              <a:gd name="connsiteY96" fmla="*/ 915507 h 1086957"/>
              <a:gd name="connsiteX97" fmla="*/ 762424 w 768774"/>
              <a:gd name="connsiteY97" fmla="*/ 899632 h 1086957"/>
              <a:gd name="connsiteX98" fmla="*/ 768774 w 768774"/>
              <a:gd name="connsiteY98" fmla="*/ 836132 h 1086957"/>
              <a:gd name="connsiteX99" fmla="*/ 765599 w 768774"/>
              <a:gd name="connsiteY99" fmla="*/ 756757 h 1086957"/>
              <a:gd name="connsiteX100" fmla="*/ 762424 w 768774"/>
              <a:gd name="connsiteY100" fmla="*/ 744057 h 1086957"/>
              <a:gd name="connsiteX101" fmla="*/ 752899 w 768774"/>
              <a:gd name="connsiteY101" fmla="*/ 705957 h 1086957"/>
              <a:gd name="connsiteX102" fmla="*/ 749724 w 768774"/>
              <a:gd name="connsiteY102" fmla="*/ 696432 h 1086957"/>
              <a:gd name="connsiteX103" fmla="*/ 746549 w 768774"/>
              <a:gd name="connsiteY103" fmla="*/ 667857 h 1086957"/>
              <a:gd name="connsiteX104" fmla="*/ 740199 w 768774"/>
              <a:gd name="connsiteY104" fmla="*/ 648807 h 1086957"/>
              <a:gd name="connsiteX105" fmla="*/ 730674 w 768774"/>
              <a:gd name="connsiteY105" fmla="*/ 626582 h 1086957"/>
              <a:gd name="connsiteX106" fmla="*/ 727499 w 768774"/>
              <a:gd name="connsiteY106" fmla="*/ 610707 h 1086957"/>
              <a:gd name="connsiteX107" fmla="*/ 724324 w 768774"/>
              <a:gd name="connsiteY107" fmla="*/ 601182 h 1086957"/>
              <a:gd name="connsiteX108" fmla="*/ 721149 w 768774"/>
              <a:gd name="connsiteY108" fmla="*/ 556732 h 1086957"/>
              <a:gd name="connsiteX109" fmla="*/ 730674 w 768774"/>
              <a:gd name="connsiteY109" fmla="*/ 480532 h 1086957"/>
              <a:gd name="connsiteX110" fmla="*/ 737024 w 768774"/>
              <a:gd name="connsiteY110" fmla="*/ 471007 h 1086957"/>
              <a:gd name="connsiteX111" fmla="*/ 737024 w 768774"/>
              <a:gd name="connsiteY111" fmla="*/ 356707 h 1086957"/>
              <a:gd name="connsiteX112" fmla="*/ 730674 w 768774"/>
              <a:gd name="connsiteY112" fmla="*/ 328132 h 1086957"/>
              <a:gd name="connsiteX113" fmla="*/ 727499 w 768774"/>
              <a:gd name="connsiteY113" fmla="*/ 315432 h 1086957"/>
              <a:gd name="connsiteX114" fmla="*/ 721149 w 768774"/>
              <a:gd name="connsiteY114" fmla="*/ 274157 h 1086957"/>
              <a:gd name="connsiteX115" fmla="*/ 717974 w 768774"/>
              <a:gd name="connsiteY115" fmla="*/ 261457 h 1086957"/>
              <a:gd name="connsiteX116" fmla="*/ 711624 w 768774"/>
              <a:gd name="connsiteY116" fmla="*/ 251932 h 1086957"/>
              <a:gd name="connsiteX117" fmla="*/ 692574 w 768774"/>
              <a:gd name="connsiteY117" fmla="*/ 220182 h 1086957"/>
              <a:gd name="connsiteX118" fmla="*/ 676699 w 768774"/>
              <a:gd name="connsiteY118" fmla="*/ 201132 h 1086957"/>
              <a:gd name="connsiteX119" fmla="*/ 670349 w 768774"/>
              <a:gd name="connsiteY119" fmla="*/ 178907 h 1086957"/>
              <a:gd name="connsiteX120" fmla="*/ 663999 w 768774"/>
              <a:gd name="connsiteY120" fmla="*/ 169382 h 1086957"/>
              <a:gd name="connsiteX121" fmla="*/ 657649 w 768774"/>
              <a:gd name="connsiteY121" fmla="*/ 150332 h 1086957"/>
              <a:gd name="connsiteX122" fmla="*/ 651299 w 768774"/>
              <a:gd name="connsiteY122" fmla="*/ 140807 h 1086957"/>
              <a:gd name="connsiteX123" fmla="*/ 641774 w 768774"/>
              <a:gd name="connsiteY123" fmla="*/ 121757 h 1086957"/>
              <a:gd name="connsiteX124" fmla="*/ 632249 w 768774"/>
              <a:gd name="connsiteY124" fmla="*/ 115407 h 1086957"/>
              <a:gd name="connsiteX125" fmla="*/ 619549 w 768774"/>
              <a:gd name="connsiteY125" fmla="*/ 99532 h 1086957"/>
              <a:gd name="connsiteX126" fmla="*/ 606849 w 768774"/>
              <a:gd name="connsiteY126" fmla="*/ 80482 h 1086957"/>
              <a:gd name="connsiteX127" fmla="*/ 578274 w 768774"/>
              <a:gd name="connsiteY127" fmla="*/ 61432 h 1086957"/>
              <a:gd name="connsiteX128" fmla="*/ 568749 w 768774"/>
              <a:gd name="connsiteY128" fmla="*/ 55082 h 1086957"/>
              <a:gd name="connsiteX129" fmla="*/ 549699 w 768774"/>
              <a:gd name="connsiteY129" fmla="*/ 42382 h 1086957"/>
              <a:gd name="connsiteX130" fmla="*/ 540174 w 768774"/>
              <a:gd name="connsiteY130" fmla="*/ 36032 h 1086957"/>
              <a:gd name="connsiteX131" fmla="*/ 530649 w 768774"/>
              <a:gd name="connsiteY131" fmla="*/ 32857 h 1086957"/>
              <a:gd name="connsiteX132" fmla="*/ 511599 w 768774"/>
              <a:gd name="connsiteY132" fmla="*/ 20157 h 1086957"/>
              <a:gd name="connsiteX133" fmla="*/ 486199 w 768774"/>
              <a:gd name="connsiteY133" fmla="*/ 1107 h 108695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</a:cxnLst>
            <a:rect l="l" t="t" r="r" b="b"/>
            <a:pathLst>
              <a:path w="768774" h="1086957">
                <a:moveTo>
                  <a:pt x="486199" y="1107"/>
                </a:moveTo>
                <a:cubicBezTo>
                  <a:pt x="479320" y="-1539"/>
                  <a:pt x="474584" y="969"/>
                  <a:pt x="470324" y="4282"/>
                </a:cubicBezTo>
                <a:cubicBezTo>
                  <a:pt x="464300" y="8967"/>
                  <a:pt x="461857" y="16982"/>
                  <a:pt x="457624" y="23332"/>
                </a:cubicBezTo>
                <a:lnTo>
                  <a:pt x="444924" y="42382"/>
                </a:lnTo>
                <a:cubicBezTo>
                  <a:pt x="443068" y="45167"/>
                  <a:pt x="443605" y="49122"/>
                  <a:pt x="441749" y="51907"/>
                </a:cubicBezTo>
                <a:cubicBezTo>
                  <a:pt x="427705" y="72973"/>
                  <a:pt x="436262" y="50182"/>
                  <a:pt x="425874" y="70957"/>
                </a:cubicBezTo>
                <a:cubicBezTo>
                  <a:pt x="420709" y="81286"/>
                  <a:pt x="425448" y="80908"/>
                  <a:pt x="416349" y="90007"/>
                </a:cubicBezTo>
                <a:cubicBezTo>
                  <a:pt x="413651" y="92705"/>
                  <a:pt x="409999" y="94240"/>
                  <a:pt x="406824" y="96357"/>
                </a:cubicBezTo>
                <a:cubicBezTo>
                  <a:pt x="404707" y="99532"/>
                  <a:pt x="403710" y="103860"/>
                  <a:pt x="400474" y="105882"/>
                </a:cubicBezTo>
                <a:cubicBezTo>
                  <a:pt x="394798" y="109430"/>
                  <a:pt x="381424" y="112232"/>
                  <a:pt x="381424" y="112232"/>
                </a:cubicBezTo>
                <a:lnTo>
                  <a:pt x="362374" y="124932"/>
                </a:lnTo>
                <a:cubicBezTo>
                  <a:pt x="359199" y="127049"/>
                  <a:pt x="356551" y="130357"/>
                  <a:pt x="352849" y="131282"/>
                </a:cubicBezTo>
                <a:lnTo>
                  <a:pt x="340149" y="134457"/>
                </a:lnTo>
                <a:lnTo>
                  <a:pt x="311574" y="153507"/>
                </a:lnTo>
                <a:cubicBezTo>
                  <a:pt x="308789" y="155363"/>
                  <a:pt x="305224" y="155624"/>
                  <a:pt x="302049" y="156682"/>
                </a:cubicBezTo>
                <a:cubicBezTo>
                  <a:pt x="298874" y="158799"/>
                  <a:pt x="295455" y="160589"/>
                  <a:pt x="292524" y="163032"/>
                </a:cubicBezTo>
                <a:cubicBezTo>
                  <a:pt x="289075" y="165907"/>
                  <a:pt x="286735" y="170066"/>
                  <a:pt x="282999" y="172557"/>
                </a:cubicBezTo>
                <a:cubicBezTo>
                  <a:pt x="280214" y="174413"/>
                  <a:pt x="276649" y="174674"/>
                  <a:pt x="273474" y="175732"/>
                </a:cubicBezTo>
                <a:cubicBezTo>
                  <a:pt x="269241" y="182082"/>
                  <a:pt x="267124" y="190549"/>
                  <a:pt x="260774" y="194782"/>
                </a:cubicBezTo>
                <a:cubicBezTo>
                  <a:pt x="251408" y="201026"/>
                  <a:pt x="249364" y="201490"/>
                  <a:pt x="241724" y="210657"/>
                </a:cubicBezTo>
                <a:cubicBezTo>
                  <a:pt x="230677" y="223914"/>
                  <a:pt x="241486" y="218145"/>
                  <a:pt x="225849" y="223357"/>
                </a:cubicBezTo>
                <a:cubicBezTo>
                  <a:pt x="223732" y="226532"/>
                  <a:pt x="221206" y="229469"/>
                  <a:pt x="219499" y="232882"/>
                </a:cubicBezTo>
                <a:cubicBezTo>
                  <a:pt x="218002" y="235875"/>
                  <a:pt x="218415" y="239794"/>
                  <a:pt x="216324" y="242407"/>
                </a:cubicBezTo>
                <a:cubicBezTo>
                  <a:pt x="213940" y="245387"/>
                  <a:pt x="209974" y="246640"/>
                  <a:pt x="206799" y="248757"/>
                </a:cubicBezTo>
                <a:lnTo>
                  <a:pt x="181399" y="286857"/>
                </a:lnTo>
                <a:lnTo>
                  <a:pt x="168699" y="305907"/>
                </a:lnTo>
                <a:cubicBezTo>
                  <a:pt x="166582" y="309082"/>
                  <a:pt x="162349" y="310140"/>
                  <a:pt x="159174" y="312257"/>
                </a:cubicBezTo>
                <a:cubicBezTo>
                  <a:pt x="158116" y="315432"/>
                  <a:pt x="158090" y="319169"/>
                  <a:pt x="155999" y="321782"/>
                </a:cubicBezTo>
                <a:cubicBezTo>
                  <a:pt x="153615" y="324762"/>
                  <a:pt x="149405" y="325689"/>
                  <a:pt x="146474" y="328132"/>
                </a:cubicBezTo>
                <a:cubicBezTo>
                  <a:pt x="143025" y="331007"/>
                  <a:pt x="140124" y="334482"/>
                  <a:pt x="136949" y="337657"/>
                </a:cubicBezTo>
                <a:cubicBezTo>
                  <a:pt x="135891" y="340832"/>
                  <a:pt x="135399" y="344256"/>
                  <a:pt x="133774" y="347182"/>
                </a:cubicBezTo>
                <a:cubicBezTo>
                  <a:pt x="130068" y="353853"/>
                  <a:pt x="125307" y="359882"/>
                  <a:pt x="121074" y="366232"/>
                </a:cubicBezTo>
                <a:lnTo>
                  <a:pt x="114724" y="375757"/>
                </a:lnTo>
                <a:lnTo>
                  <a:pt x="95674" y="404332"/>
                </a:lnTo>
                <a:cubicBezTo>
                  <a:pt x="93049" y="408270"/>
                  <a:pt x="91832" y="413018"/>
                  <a:pt x="89324" y="417032"/>
                </a:cubicBezTo>
                <a:cubicBezTo>
                  <a:pt x="86519" y="421519"/>
                  <a:pt x="82974" y="425499"/>
                  <a:pt x="79799" y="429732"/>
                </a:cubicBezTo>
                <a:cubicBezTo>
                  <a:pt x="78741" y="432907"/>
                  <a:pt x="78480" y="436472"/>
                  <a:pt x="76624" y="439257"/>
                </a:cubicBezTo>
                <a:cubicBezTo>
                  <a:pt x="66655" y="454211"/>
                  <a:pt x="67674" y="442725"/>
                  <a:pt x="60749" y="458307"/>
                </a:cubicBezTo>
                <a:cubicBezTo>
                  <a:pt x="58031" y="464424"/>
                  <a:pt x="58112" y="471788"/>
                  <a:pt x="54399" y="477357"/>
                </a:cubicBezTo>
                <a:cubicBezTo>
                  <a:pt x="52282" y="480532"/>
                  <a:pt x="49599" y="483395"/>
                  <a:pt x="48049" y="486882"/>
                </a:cubicBezTo>
                <a:cubicBezTo>
                  <a:pt x="45331" y="492999"/>
                  <a:pt x="45412" y="500363"/>
                  <a:pt x="41699" y="505932"/>
                </a:cubicBezTo>
                <a:cubicBezTo>
                  <a:pt x="39582" y="509107"/>
                  <a:pt x="36899" y="511970"/>
                  <a:pt x="35349" y="515457"/>
                </a:cubicBezTo>
                <a:cubicBezTo>
                  <a:pt x="32631" y="521574"/>
                  <a:pt x="31116" y="528157"/>
                  <a:pt x="28999" y="534507"/>
                </a:cubicBezTo>
                <a:lnTo>
                  <a:pt x="22649" y="553557"/>
                </a:lnTo>
                <a:cubicBezTo>
                  <a:pt x="21591" y="556732"/>
                  <a:pt x="21330" y="560297"/>
                  <a:pt x="19474" y="563082"/>
                </a:cubicBezTo>
                <a:lnTo>
                  <a:pt x="13124" y="572607"/>
                </a:lnTo>
                <a:cubicBezTo>
                  <a:pt x="12066" y="576840"/>
                  <a:pt x="11203" y="581127"/>
                  <a:pt x="9949" y="585307"/>
                </a:cubicBezTo>
                <a:cubicBezTo>
                  <a:pt x="8026" y="591718"/>
                  <a:pt x="3599" y="604357"/>
                  <a:pt x="3599" y="604357"/>
                </a:cubicBezTo>
                <a:cubicBezTo>
                  <a:pt x="-185" y="638411"/>
                  <a:pt x="-2120" y="640526"/>
                  <a:pt x="3599" y="680557"/>
                </a:cubicBezTo>
                <a:cubicBezTo>
                  <a:pt x="6383" y="700045"/>
                  <a:pt x="7101" y="697708"/>
                  <a:pt x="19474" y="705957"/>
                </a:cubicBezTo>
                <a:cubicBezTo>
                  <a:pt x="20532" y="709132"/>
                  <a:pt x="21152" y="712489"/>
                  <a:pt x="22649" y="715482"/>
                </a:cubicBezTo>
                <a:cubicBezTo>
                  <a:pt x="25984" y="722153"/>
                  <a:pt x="32779" y="730064"/>
                  <a:pt x="38524" y="734532"/>
                </a:cubicBezTo>
                <a:cubicBezTo>
                  <a:pt x="44548" y="739217"/>
                  <a:pt x="57574" y="747232"/>
                  <a:pt x="57574" y="747232"/>
                </a:cubicBezTo>
                <a:cubicBezTo>
                  <a:pt x="74507" y="772632"/>
                  <a:pt x="52282" y="741940"/>
                  <a:pt x="73449" y="763107"/>
                </a:cubicBezTo>
                <a:cubicBezTo>
                  <a:pt x="76147" y="765805"/>
                  <a:pt x="77356" y="769701"/>
                  <a:pt x="79799" y="772632"/>
                </a:cubicBezTo>
                <a:cubicBezTo>
                  <a:pt x="82674" y="776081"/>
                  <a:pt x="86567" y="778613"/>
                  <a:pt x="89324" y="782157"/>
                </a:cubicBezTo>
                <a:cubicBezTo>
                  <a:pt x="94009" y="788181"/>
                  <a:pt x="97791" y="794857"/>
                  <a:pt x="102024" y="801207"/>
                </a:cubicBezTo>
                <a:lnTo>
                  <a:pt x="108374" y="810732"/>
                </a:lnTo>
                <a:cubicBezTo>
                  <a:pt x="110865" y="814468"/>
                  <a:pt x="115142" y="816713"/>
                  <a:pt x="117899" y="820257"/>
                </a:cubicBezTo>
                <a:cubicBezTo>
                  <a:pt x="122584" y="826281"/>
                  <a:pt x="126366" y="832957"/>
                  <a:pt x="130599" y="839307"/>
                </a:cubicBezTo>
                <a:lnTo>
                  <a:pt x="143299" y="858357"/>
                </a:lnTo>
                <a:cubicBezTo>
                  <a:pt x="161679" y="885926"/>
                  <a:pt x="125613" y="847021"/>
                  <a:pt x="155999" y="877407"/>
                </a:cubicBezTo>
                <a:cubicBezTo>
                  <a:pt x="163979" y="901348"/>
                  <a:pt x="153214" y="871838"/>
                  <a:pt x="165524" y="896457"/>
                </a:cubicBezTo>
                <a:cubicBezTo>
                  <a:pt x="167021" y="899450"/>
                  <a:pt x="167381" y="902906"/>
                  <a:pt x="168699" y="905982"/>
                </a:cubicBezTo>
                <a:cubicBezTo>
                  <a:pt x="174557" y="919650"/>
                  <a:pt x="178721" y="924189"/>
                  <a:pt x="187749" y="937732"/>
                </a:cubicBezTo>
                <a:cubicBezTo>
                  <a:pt x="189866" y="940907"/>
                  <a:pt x="190924" y="945140"/>
                  <a:pt x="194099" y="947257"/>
                </a:cubicBezTo>
                <a:cubicBezTo>
                  <a:pt x="197274" y="949374"/>
                  <a:pt x="200772" y="951072"/>
                  <a:pt x="203624" y="953607"/>
                </a:cubicBezTo>
                <a:cubicBezTo>
                  <a:pt x="210336" y="959573"/>
                  <a:pt x="215202" y="967676"/>
                  <a:pt x="222674" y="972657"/>
                </a:cubicBezTo>
                <a:cubicBezTo>
                  <a:pt x="244509" y="987213"/>
                  <a:pt x="234484" y="982944"/>
                  <a:pt x="251249" y="988532"/>
                </a:cubicBezTo>
                <a:cubicBezTo>
                  <a:pt x="278546" y="1006730"/>
                  <a:pt x="244009" y="984912"/>
                  <a:pt x="270299" y="998057"/>
                </a:cubicBezTo>
                <a:cubicBezTo>
                  <a:pt x="273712" y="999764"/>
                  <a:pt x="276337" y="1002857"/>
                  <a:pt x="279824" y="1004407"/>
                </a:cubicBezTo>
                <a:cubicBezTo>
                  <a:pt x="285941" y="1007125"/>
                  <a:pt x="298874" y="1010757"/>
                  <a:pt x="298874" y="1010757"/>
                </a:cubicBezTo>
                <a:cubicBezTo>
                  <a:pt x="326171" y="1028955"/>
                  <a:pt x="291634" y="1007137"/>
                  <a:pt x="317924" y="1020282"/>
                </a:cubicBezTo>
                <a:cubicBezTo>
                  <a:pt x="321337" y="1021989"/>
                  <a:pt x="323962" y="1025082"/>
                  <a:pt x="327449" y="1026632"/>
                </a:cubicBezTo>
                <a:cubicBezTo>
                  <a:pt x="333566" y="1029350"/>
                  <a:pt x="340149" y="1030865"/>
                  <a:pt x="346499" y="1032982"/>
                </a:cubicBezTo>
                <a:lnTo>
                  <a:pt x="365549" y="1039332"/>
                </a:lnTo>
                <a:cubicBezTo>
                  <a:pt x="395212" y="1049220"/>
                  <a:pt x="363387" y="1041580"/>
                  <a:pt x="387774" y="1052032"/>
                </a:cubicBezTo>
                <a:cubicBezTo>
                  <a:pt x="391785" y="1053751"/>
                  <a:pt x="396149" y="1054630"/>
                  <a:pt x="400474" y="1055207"/>
                </a:cubicBezTo>
                <a:cubicBezTo>
                  <a:pt x="412061" y="1056752"/>
                  <a:pt x="423789" y="1057016"/>
                  <a:pt x="435399" y="1058382"/>
                </a:cubicBezTo>
                <a:cubicBezTo>
                  <a:pt x="441792" y="1059134"/>
                  <a:pt x="448099" y="1060499"/>
                  <a:pt x="454449" y="1061557"/>
                </a:cubicBezTo>
                <a:lnTo>
                  <a:pt x="502074" y="1077432"/>
                </a:lnTo>
                <a:cubicBezTo>
                  <a:pt x="508181" y="1079468"/>
                  <a:pt x="514774" y="1079549"/>
                  <a:pt x="521124" y="1080607"/>
                </a:cubicBezTo>
                <a:cubicBezTo>
                  <a:pt x="525616" y="1082104"/>
                  <a:pt x="539362" y="1086957"/>
                  <a:pt x="543349" y="1086957"/>
                </a:cubicBezTo>
                <a:cubicBezTo>
                  <a:pt x="556093" y="1086957"/>
                  <a:pt x="568749" y="1084840"/>
                  <a:pt x="581449" y="1083782"/>
                </a:cubicBezTo>
                <a:lnTo>
                  <a:pt x="600499" y="1077432"/>
                </a:lnTo>
                <a:lnTo>
                  <a:pt x="610024" y="1074257"/>
                </a:lnTo>
                <a:cubicBezTo>
                  <a:pt x="616374" y="1070024"/>
                  <a:pt x="621834" y="1063970"/>
                  <a:pt x="629074" y="1061557"/>
                </a:cubicBezTo>
                <a:lnTo>
                  <a:pt x="648124" y="1055207"/>
                </a:lnTo>
                <a:lnTo>
                  <a:pt x="667174" y="1042507"/>
                </a:lnTo>
                <a:cubicBezTo>
                  <a:pt x="670349" y="1040390"/>
                  <a:pt x="673079" y="1037364"/>
                  <a:pt x="676699" y="1036157"/>
                </a:cubicBezTo>
                <a:lnTo>
                  <a:pt x="686224" y="1032982"/>
                </a:lnTo>
                <a:cubicBezTo>
                  <a:pt x="688341" y="1029807"/>
                  <a:pt x="689594" y="1025841"/>
                  <a:pt x="692574" y="1023457"/>
                </a:cubicBezTo>
                <a:cubicBezTo>
                  <a:pt x="708543" y="1010682"/>
                  <a:pt x="702058" y="1039455"/>
                  <a:pt x="714799" y="1001232"/>
                </a:cubicBezTo>
                <a:cubicBezTo>
                  <a:pt x="720387" y="984467"/>
                  <a:pt x="716118" y="994492"/>
                  <a:pt x="730674" y="972657"/>
                </a:cubicBezTo>
                <a:cubicBezTo>
                  <a:pt x="732791" y="969482"/>
                  <a:pt x="735817" y="966752"/>
                  <a:pt x="737024" y="963132"/>
                </a:cubicBezTo>
                <a:cubicBezTo>
                  <a:pt x="748603" y="928394"/>
                  <a:pt x="730136" y="981011"/>
                  <a:pt x="746549" y="944082"/>
                </a:cubicBezTo>
                <a:cubicBezTo>
                  <a:pt x="761662" y="910077"/>
                  <a:pt x="744878" y="937063"/>
                  <a:pt x="759249" y="915507"/>
                </a:cubicBezTo>
                <a:cubicBezTo>
                  <a:pt x="760307" y="910215"/>
                  <a:pt x="761603" y="904966"/>
                  <a:pt x="762424" y="899632"/>
                </a:cubicBezTo>
                <a:cubicBezTo>
                  <a:pt x="765883" y="877151"/>
                  <a:pt x="766828" y="859489"/>
                  <a:pt x="768774" y="836132"/>
                </a:cubicBezTo>
                <a:cubicBezTo>
                  <a:pt x="767716" y="809674"/>
                  <a:pt x="767421" y="783174"/>
                  <a:pt x="765599" y="756757"/>
                </a:cubicBezTo>
                <a:cubicBezTo>
                  <a:pt x="765299" y="752404"/>
                  <a:pt x="763280" y="748336"/>
                  <a:pt x="762424" y="744057"/>
                </a:cubicBezTo>
                <a:cubicBezTo>
                  <a:pt x="756011" y="711991"/>
                  <a:pt x="763507" y="737782"/>
                  <a:pt x="752899" y="705957"/>
                </a:cubicBezTo>
                <a:lnTo>
                  <a:pt x="749724" y="696432"/>
                </a:lnTo>
                <a:cubicBezTo>
                  <a:pt x="748666" y="686907"/>
                  <a:pt x="748429" y="677255"/>
                  <a:pt x="746549" y="667857"/>
                </a:cubicBezTo>
                <a:cubicBezTo>
                  <a:pt x="745236" y="661293"/>
                  <a:pt x="742316" y="655157"/>
                  <a:pt x="740199" y="648807"/>
                </a:cubicBezTo>
                <a:cubicBezTo>
                  <a:pt x="735527" y="634792"/>
                  <a:pt x="738521" y="642275"/>
                  <a:pt x="730674" y="626582"/>
                </a:cubicBezTo>
                <a:cubicBezTo>
                  <a:pt x="729616" y="621290"/>
                  <a:pt x="728808" y="615942"/>
                  <a:pt x="727499" y="610707"/>
                </a:cubicBezTo>
                <a:cubicBezTo>
                  <a:pt x="726687" y="607460"/>
                  <a:pt x="724715" y="604506"/>
                  <a:pt x="724324" y="601182"/>
                </a:cubicBezTo>
                <a:cubicBezTo>
                  <a:pt x="722588" y="586429"/>
                  <a:pt x="722207" y="571549"/>
                  <a:pt x="721149" y="556732"/>
                </a:cubicBezTo>
                <a:cubicBezTo>
                  <a:pt x="724695" y="492899"/>
                  <a:pt x="718291" y="517682"/>
                  <a:pt x="730674" y="480532"/>
                </a:cubicBezTo>
                <a:cubicBezTo>
                  <a:pt x="731881" y="476912"/>
                  <a:pt x="734907" y="474182"/>
                  <a:pt x="737024" y="471007"/>
                </a:cubicBezTo>
                <a:cubicBezTo>
                  <a:pt x="741691" y="415003"/>
                  <a:pt x="741965" y="430818"/>
                  <a:pt x="737024" y="356707"/>
                </a:cubicBezTo>
                <a:cubicBezTo>
                  <a:pt x="735778" y="338023"/>
                  <a:pt x="734596" y="341858"/>
                  <a:pt x="730674" y="328132"/>
                </a:cubicBezTo>
                <a:cubicBezTo>
                  <a:pt x="729475" y="323936"/>
                  <a:pt x="728557" y="319665"/>
                  <a:pt x="727499" y="315432"/>
                </a:cubicBezTo>
                <a:cubicBezTo>
                  <a:pt x="722393" y="264368"/>
                  <a:pt x="728190" y="298802"/>
                  <a:pt x="721149" y="274157"/>
                </a:cubicBezTo>
                <a:cubicBezTo>
                  <a:pt x="719950" y="269961"/>
                  <a:pt x="719693" y="265468"/>
                  <a:pt x="717974" y="261457"/>
                </a:cubicBezTo>
                <a:cubicBezTo>
                  <a:pt x="716471" y="257950"/>
                  <a:pt x="713517" y="255245"/>
                  <a:pt x="711624" y="251932"/>
                </a:cubicBezTo>
                <a:cubicBezTo>
                  <a:pt x="704943" y="240240"/>
                  <a:pt x="702930" y="230538"/>
                  <a:pt x="692574" y="220182"/>
                </a:cubicBezTo>
                <a:cubicBezTo>
                  <a:pt x="680351" y="207959"/>
                  <a:pt x="685540" y="214393"/>
                  <a:pt x="676699" y="201132"/>
                </a:cubicBezTo>
                <a:cubicBezTo>
                  <a:pt x="675682" y="197063"/>
                  <a:pt x="672626" y="183462"/>
                  <a:pt x="670349" y="178907"/>
                </a:cubicBezTo>
                <a:cubicBezTo>
                  <a:pt x="668642" y="175494"/>
                  <a:pt x="665549" y="172869"/>
                  <a:pt x="663999" y="169382"/>
                </a:cubicBezTo>
                <a:cubicBezTo>
                  <a:pt x="661281" y="163265"/>
                  <a:pt x="661362" y="155901"/>
                  <a:pt x="657649" y="150332"/>
                </a:cubicBezTo>
                <a:cubicBezTo>
                  <a:pt x="655532" y="147157"/>
                  <a:pt x="653006" y="144220"/>
                  <a:pt x="651299" y="140807"/>
                </a:cubicBezTo>
                <a:cubicBezTo>
                  <a:pt x="646134" y="130478"/>
                  <a:pt x="650873" y="130856"/>
                  <a:pt x="641774" y="121757"/>
                </a:cubicBezTo>
                <a:cubicBezTo>
                  <a:pt x="639076" y="119059"/>
                  <a:pt x="635424" y="117524"/>
                  <a:pt x="632249" y="115407"/>
                </a:cubicBezTo>
                <a:cubicBezTo>
                  <a:pt x="625099" y="93957"/>
                  <a:pt x="635015" y="117207"/>
                  <a:pt x="619549" y="99532"/>
                </a:cubicBezTo>
                <a:cubicBezTo>
                  <a:pt x="614523" y="93789"/>
                  <a:pt x="613199" y="84715"/>
                  <a:pt x="606849" y="80482"/>
                </a:cubicBezTo>
                <a:lnTo>
                  <a:pt x="578274" y="61432"/>
                </a:lnTo>
                <a:cubicBezTo>
                  <a:pt x="575099" y="59315"/>
                  <a:pt x="571447" y="57780"/>
                  <a:pt x="568749" y="55082"/>
                </a:cubicBezTo>
                <a:cubicBezTo>
                  <a:pt x="556857" y="43190"/>
                  <a:pt x="563484" y="46977"/>
                  <a:pt x="549699" y="42382"/>
                </a:cubicBezTo>
                <a:cubicBezTo>
                  <a:pt x="546524" y="40265"/>
                  <a:pt x="543587" y="37739"/>
                  <a:pt x="540174" y="36032"/>
                </a:cubicBezTo>
                <a:cubicBezTo>
                  <a:pt x="537181" y="34535"/>
                  <a:pt x="533575" y="34482"/>
                  <a:pt x="530649" y="32857"/>
                </a:cubicBezTo>
                <a:cubicBezTo>
                  <a:pt x="523978" y="29151"/>
                  <a:pt x="519003" y="22008"/>
                  <a:pt x="511599" y="20157"/>
                </a:cubicBezTo>
                <a:cubicBezTo>
                  <a:pt x="479012" y="12010"/>
                  <a:pt x="493078" y="3753"/>
                  <a:pt x="486199" y="1107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8" name="フリーフォーム 67"/>
          <p:cNvSpPr/>
          <p:nvPr/>
        </p:nvSpPr>
        <p:spPr>
          <a:xfrm>
            <a:off x="5373035" y="3523917"/>
            <a:ext cx="768774" cy="1086957"/>
          </a:xfrm>
          <a:custGeom>
            <a:avLst/>
            <a:gdLst>
              <a:gd name="connsiteX0" fmla="*/ 486199 w 768774"/>
              <a:gd name="connsiteY0" fmla="*/ 1107 h 1086957"/>
              <a:gd name="connsiteX1" fmla="*/ 470324 w 768774"/>
              <a:gd name="connsiteY1" fmla="*/ 4282 h 1086957"/>
              <a:gd name="connsiteX2" fmla="*/ 457624 w 768774"/>
              <a:gd name="connsiteY2" fmla="*/ 23332 h 1086957"/>
              <a:gd name="connsiteX3" fmla="*/ 444924 w 768774"/>
              <a:gd name="connsiteY3" fmla="*/ 42382 h 1086957"/>
              <a:gd name="connsiteX4" fmla="*/ 441749 w 768774"/>
              <a:gd name="connsiteY4" fmla="*/ 51907 h 1086957"/>
              <a:gd name="connsiteX5" fmla="*/ 425874 w 768774"/>
              <a:gd name="connsiteY5" fmla="*/ 70957 h 1086957"/>
              <a:gd name="connsiteX6" fmla="*/ 416349 w 768774"/>
              <a:gd name="connsiteY6" fmla="*/ 90007 h 1086957"/>
              <a:gd name="connsiteX7" fmla="*/ 406824 w 768774"/>
              <a:gd name="connsiteY7" fmla="*/ 96357 h 1086957"/>
              <a:gd name="connsiteX8" fmla="*/ 400474 w 768774"/>
              <a:gd name="connsiteY8" fmla="*/ 105882 h 1086957"/>
              <a:gd name="connsiteX9" fmla="*/ 381424 w 768774"/>
              <a:gd name="connsiteY9" fmla="*/ 112232 h 1086957"/>
              <a:gd name="connsiteX10" fmla="*/ 362374 w 768774"/>
              <a:gd name="connsiteY10" fmla="*/ 124932 h 1086957"/>
              <a:gd name="connsiteX11" fmla="*/ 352849 w 768774"/>
              <a:gd name="connsiteY11" fmla="*/ 131282 h 1086957"/>
              <a:gd name="connsiteX12" fmla="*/ 340149 w 768774"/>
              <a:gd name="connsiteY12" fmla="*/ 134457 h 1086957"/>
              <a:gd name="connsiteX13" fmla="*/ 311574 w 768774"/>
              <a:gd name="connsiteY13" fmla="*/ 153507 h 1086957"/>
              <a:gd name="connsiteX14" fmla="*/ 302049 w 768774"/>
              <a:gd name="connsiteY14" fmla="*/ 156682 h 1086957"/>
              <a:gd name="connsiteX15" fmla="*/ 292524 w 768774"/>
              <a:gd name="connsiteY15" fmla="*/ 163032 h 1086957"/>
              <a:gd name="connsiteX16" fmla="*/ 282999 w 768774"/>
              <a:gd name="connsiteY16" fmla="*/ 172557 h 1086957"/>
              <a:gd name="connsiteX17" fmla="*/ 273474 w 768774"/>
              <a:gd name="connsiteY17" fmla="*/ 175732 h 1086957"/>
              <a:gd name="connsiteX18" fmla="*/ 260774 w 768774"/>
              <a:gd name="connsiteY18" fmla="*/ 194782 h 1086957"/>
              <a:gd name="connsiteX19" fmla="*/ 241724 w 768774"/>
              <a:gd name="connsiteY19" fmla="*/ 210657 h 1086957"/>
              <a:gd name="connsiteX20" fmla="*/ 225849 w 768774"/>
              <a:gd name="connsiteY20" fmla="*/ 223357 h 1086957"/>
              <a:gd name="connsiteX21" fmla="*/ 219499 w 768774"/>
              <a:gd name="connsiteY21" fmla="*/ 232882 h 1086957"/>
              <a:gd name="connsiteX22" fmla="*/ 216324 w 768774"/>
              <a:gd name="connsiteY22" fmla="*/ 242407 h 1086957"/>
              <a:gd name="connsiteX23" fmla="*/ 206799 w 768774"/>
              <a:gd name="connsiteY23" fmla="*/ 248757 h 1086957"/>
              <a:gd name="connsiteX24" fmla="*/ 181399 w 768774"/>
              <a:gd name="connsiteY24" fmla="*/ 286857 h 1086957"/>
              <a:gd name="connsiteX25" fmla="*/ 168699 w 768774"/>
              <a:gd name="connsiteY25" fmla="*/ 305907 h 1086957"/>
              <a:gd name="connsiteX26" fmla="*/ 159174 w 768774"/>
              <a:gd name="connsiteY26" fmla="*/ 312257 h 1086957"/>
              <a:gd name="connsiteX27" fmla="*/ 155999 w 768774"/>
              <a:gd name="connsiteY27" fmla="*/ 321782 h 1086957"/>
              <a:gd name="connsiteX28" fmla="*/ 146474 w 768774"/>
              <a:gd name="connsiteY28" fmla="*/ 328132 h 1086957"/>
              <a:gd name="connsiteX29" fmla="*/ 136949 w 768774"/>
              <a:gd name="connsiteY29" fmla="*/ 337657 h 1086957"/>
              <a:gd name="connsiteX30" fmla="*/ 133774 w 768774"/>
              <a:gd name="connsiteY30" fmla="*/ 347182 h 1086957"/>
              <a:gd name="connsiteX31" fmla="*/ 121074 w 768774"/>
              <a:gd name="connsiteY31" fmla="*/ 366232 h 1086957"/>
              <a:gd name="connsiteX32" fmla="*/ 114724 w 768774"/>
              <a:gd name="connsiteY32" fmla="*/ 375757 h 1086957"/>
              <a:gd name="connsiteX33" fmla="*/ 95674 w 768774"/>
              <a:gd name="connsiteY33" fmla="*/ 404332 h 1086957"/>
              <a:gd name="connsiteX34" fmla="*/ 89324 w 768774"/>
              <a:gd name="connsiteY34" fmla="*/ 417032 h 1086957"/>
              <a:gd name="connsiteX35" fmla="*/ 79799 w 768774"/>
              <a:gd name="connsiteY35" fmla="*/ 429732 h 1086957"/>
              <a:gd name="connsiteX36" fmla="*/ 76624 w 768774"/>
              <a:gd name="connsiteY36" fmla="*/ 439257 h 1086957"/>
              <a:gd name="connsiteX37" fmla="*/ 60749 w 768774"/>
              <a:gd name="connsiteY37" fmla="*/ 458307 h 1086957"/>
              <a:gd name="connsiteX38" fmla="*/ 54399 w 768774"/>
              <a:gd name="connsiteY38" fmla="*/ 477357 h 1086957"/>
              <a:gd name="connsiteX39" fmla="*/ 48049 w 768774"/>
              <a:gd name="connsiteY39" fmla="*/ 486882 h 1086957"/>
              <a:gd name="connsiteX40" fmla="*/ 41699 w 768774"/>
              <a:gd name="connsiteY40" fmla="*/ 505932 h 1086957"/>
              <a:gd name="connsiteX41" fmla="*/ 35349 w 768774"/>
              <a:gd name="connsiteY41" fmla="*/ 515457 h 1086957"/>
              <a:gd name="connsiteX42" fmla="*/ 28999 w 768774"/>
              <a:gd name="connsiteY42" fmla="*/ 534507 h 1086957"/>
              <a:gd name="connsiteX43" fmla="*/ 22649 w 768774"/>
              <a:gd name="connsiteY43" fmla="*/ 553557 h 1086957"/>
              <a:gd name="connsiteX44" fmla="*/ 19474 w 768774"/>
              <a:gd name="connsiteY44" fmla="*/ 563082 h 1086957"/>
              <a:gd name="connsiteX45" fmla="*/ 13124 w 768774"/>
              <a:gd name="connsiteY45" fmla="*/ 572607 h 1086957"/>
              <a:gd name="connsiteX46" fmla="*/ 9949 w 768774"/>
              <a:gd name="connsiteY46" fmla="*/ 585307 h 1086957"/>
              <a:gd name="connsiteX47" fmla="*/ 3599 w 768774"/>
              <a:gd name="connsiteY47" fmla="*/ 604357 h 1086957"/>
              <a:gd name="connsiteX48" fmla="*/ 3599 w 768774"/>
              <a:gd name="connsiteY48" fmla="*/ 680557 h 1086957"/>
              <a:gd name="connsiteX49" fmla="*/ 19474 w 768774"/>
              <a:gd name="connsiteY49" fmla="*/ 705957 h 1086957"/>
              <a:gd name="connsiteX50" fmla="*/ 22649 w 768774"/>
              <a:gd name="connsiteY50" fmla="*/ 715482 h 1086957"/>
              <a:gd name="connsiteX51" fmla="*/ 38524 w 768774"/>
              <a:gd name="connsiteY51" fmla="*/ 734532 h 1086957"/>
              <a:gd name="connsiteX52" fmla="*/ 57574 w 768774"/>
              <a:gd name="connsiteY52" fmla="*/ 747232 h 1086957"/>
              <a:gd name="connsiteX53" fmla="*/ 73449 w 768774"/>
              <a:gd name="connsiteY53" fmla="*/ 763107 h 1086957"/>
              <a:gd name="connsiteX54" fmla="*/ 79799 w 768774"/>
              <a:gd name="connsiteY54" fmla="*/ 772632 h 1086957"/>
              <a:gd name="connsiteX55" fmla="*/ 89324 w 768774"/>
              <a:gd name="connsiteY55" fmla="*/ 782157 h 1086957"/>
              <a:gd name="connsiteX56" fmla="*/ 102024 w 768774"/>
              <a:gd name="connsiteY56" fmla="*/ 801207 h 1086957"/>
              <a:gd name="connsiteX57" fmla="*/ 108374 w 768774"/>
              <a:gd name="connsiteY57" fmla="*/ 810732 h 1086957"/>
              <a:gd name="connsiteX58" fmla="*/ 117899 w 768774"/>
              <a:gd name="connsiteY58" fmla="*/ 820257 h 1086957"/>
              <a:gd name="connsiteX59" fmla="*/ 130599 w 768774"/>
              <a:gd name="connsiteY59" fmla="*/ 839307 h 1086957"/>
              <a:gd name="connsiteX60" fmla="*/ 143299 w 768774"/>
              <a:gd name="connsiteY60" fmla="*/ 858357 h 1086957"/>
              <a:gd name="connsiteX61" fmla="*/ 155999 w 768774"/>
              <a:gd name="connsiteY61" fmla="*/ 877407 h 1086957"/>
              <a:gd name="connsiteX62" fmla="*/ 165524 w 768774"/>
              <a:gd name="connsiteY62" fmla="*/ 896457 h 1086957"/>
              <a:gd name="connsiteX63" fmla="*/ 168699 w 768774"/>
              <a:gd name="connsiteY63" fmla="*/ 905982 h 1086957"/>
              <a:gd name="connsiteX64" fmla="*/ 187749 w 768774"/>
              <a:gd name="connsiteY64" fmla="*/ 937732 h 1086957"/>
              <a:gd name="connsiteX65" fmla="*/ 194099 w 768774"/>
              <a:gd name="connsiteY65" fmla="*/ 947257 h 1086957"/>
              <a:gd name="connsiteX66" fmla="*/ 203624 w 768774"/>
              <a:gd name="connsiteY66" fmla="*/ 953607 h 1086957"/>
              <a:gd name="connsiteX67" fmla="*/ 222674 w 768774"/>
              <a:gd name="connsiteY67" fmla="*/ 972657 h 1086957"/>
              <a:gd name="connsiteX68" fmla="*/ 251249 w 768774"/>
              <a:gd name="connsiteY68" fmla="*/ 988532 h 1086957"/>
              <a:gd name="connsiteX69" fmla="*/ 270299 w 768774"/>
              <a:gd name="connsiteY69" fmla="*/ 998057 h 1086957"/>
              <a:gd name="connsiteX70" fmla="*/ 279824 w 768774"/>
              <a:gd name="connsiteY70" fmla="*/ 1004407 h 1086957"/>
              <a:gd name="connsiteX71" fmla="*/ 298874 w 768774"/>
              <a:gd name="connsiteY71" fmla="*/ 1010757 h 1086957"/>
              <a:gd name="connsiteX72" fmla="*/ 317924 w 768774"/>
              <a:gd name="connsiteY72" fmla="*/ 1020282 h 1086957"/>
              <a:gd name="connsiteX73" fmla="*/ 327449 w 768774"/>
              <a:gd name="connsiteY73" fmla="*/ 1026632 h 1086957"/>
              <a:gd name="connsiteX74" fmla="*/ 346499 w 768774"/>
              <a:gd name="connsiteY74" fmla="*/ 1032982 h 1086957"/>
              <a:gd name="connsiteX75" fmla="*/ 365549 w 768774"/>
              <a:gd name="connsiteY75" fmla="*/ 1039332 h 1086957"/>
              <a:gd name="connsiteX76" fmla="*/ 387774 w 768774"/>
              <a:gd name="connsiteY76" fmla="*/ 1052032 h 1086957"/>
              <a:gd name="connsiteX77" fmla="*/ 400474 w 768774"/>
              <a:gd name="connsiteY77" fmla="*/ 1055207 h 1086957"/>
              <a:gd name="connsiteX78" fmla="*/ 435399 w 768774"/>
              <a:gd name="connsiteY78" fmla="*/ 1058382 h 1086957"/>
              <a:gd name="connsiteX79" fmla="*/ 454449 w 768774"/>
              <a:gd name="connsiteY79" fmla="*/ 1061557 h 1086957"/>
              <a:gd name="connsiteX80" fmla="*/ 502074 w 768774"/>
              <a:gd name="connsiteY80" fmla="*/ 1077432 h 1086957"/>
              <a:gd name="connsiteX81" fmla="*/ 521124 w 768774"/>
              <a:gd name="connsiteY81" fmla="*/ 1080607 h 1086957"/>
              <a:gd name="connsiteX82" fmla="*/ 543349 w 768774"/>
              <a:gd name="connsiteY82" fmla="*/ 1086957 h 1086957"/>
              <a:gd name="connsiteX83" fmla="*/ 581449 w 768774"/>
              <a:gd name="connsiteY83" fmla="*/ 1083782 h 1086957"/>
              <a:gd name="connsiteX84" fmla="*/ 600499 w 768774"/>
              <a:gd name="connsiteY84" fmla="*/ 1077432 h 1086957"/>
              <a:gd name="connsiteX85" fmla="*/ 610024 w 768774"/>
              <a:gd name="connsiteY85" fmla="*/ 1074257 h 1086957"/>
              <a:gd name="connsiteX86" fmla="*/ 629074 w 768774"/>
              <a:gd name="connsiteY86" fmla="*/ 1061557 h 1086957"/>
              <a:gd name="connsiteX87" fmla="*/ 648124 w 768774"/>
              <a:gd name="connsiteY87" fmla="*/ 1055207 h 1086957"/>
              <a:gd name="connsiteX88" fmla="*/ 667174 w 768774"/>
              <a:gd name="connsiteY88" fmla="*/ 1042507 h 1086957"/>
              <a:gd name="connsiteX89" fmla="*/ 676699 w 768774"/>
              <a:gd name="connsiteY89" fmla="*/ 1036157 h 1086957"/>
              <a:gd name="connsiteX90" fmla="*/ 686224 w 768774"/>
              <a:gd name="connsiteY90" fmla="*/ 1032982 h 1086957"/>
              <a:gd name="connsiteX91" fmla="*/ 692574 w 768774"/>
              <a:gd name="connsiteY91" fmla="*/ 1023457 h 1086957"/>
              <a:gd name="connsiteX92" fmla="*/ 714799 w 768774"/>
              <a:gd name="connsiteY92" fmla="*/ 1001232 h 1086957"/>
              <a:gd name="connsiteX93" fmla="*/ 730674 w 768774"/>
              <a:gd name="connsiteY93" fmla="*/ 972657 h 1086957"/>
              <a:gd name="connsiteX94" fmla="*/ 737024 w 768774"/>
              <a:gd name="connsiteY94" fmla="*/ 963132 h 1086957"/>
              <a:gd name="connsiteX95" fmla="*/ 746549 w 768774"/>
              <a:gd name="connsiteY95" fmla="*/ 944082 h 1086957"/>
              <a:gd name="connsiteX96" fmla="*/ 759249 w 768774"/>
              <a:gd name="connsiteY96" fmla="*/ 915507 h 1086957"/>
              <a:gd name="connsiteX97" fmla="*/ 762424 w 768774"/>
              <a:gd name="connsiteY97" fmla="*/ 899632 h 1086957"/>
              <a:gd name="connsiteX98" fmla="*/ 768774 w 768774"/>
              <a:gd name="connsiteY98" fmla="*/ 836132 h 1086957"/>
              <a:gd name="connsiteX99" fmla="*/ 765599 w 768774"/>
              <a:gd name="connsiteY99" fmla="*/ 756757 h 1086957"/>
              <a:gd name="connsiteX100" fmla="*/ 762424 w 768774"/>
              <a:gd name="connsiteY100" fmla="*/ 744057 h 1086957"/>
              <a:gd name="connsiteX101" fmla="*/ 752899 w 768774"/>
              <a:gd name="connsiteY101" fmla="*/ 705957 h 1086957"/>
              <a:gd name="connsiteX102" fmla="*/ 749724 w 768774"/>
              <a:gd name="connsiteY102" fmla="*/ 696432 h 1086957"/>
              <a:gd name="connsiteX103" fmla="*/ 746549 w 768774"/>
              <a:gd name="connsiteY103" fmla="*/ 667857 h 1086957"/>
              <a:gd name="connsiteX104" fmla="*/ 740199 w 768774"/>
              <a:gd name="connsiteY104" fmla="*/ 648807 h 1086957"/>
              <a:gd name="connsiteX105" fmla="*/ 730674 w 768774"/>
              <a:gd name="connsiteY105" fmla="*/ 626582 h 1086957"/>
              <a:gd name="connsiteX106" fmla="*/ 727499 w 768774"/>
              <a:gd name="connsiteY106" fmla="*/ 610707 h 1086957"/>
              <a:gd name="connsiteX107" fmla="*/ 724324 w 768774"/>
              <a:gd name="connsiteY107" fmla="*/ 601182 h 1086957"/>
              <a:gd name="connsiteX108" fmla="*/ 721149 w 768774"/>
              <a:gd name="connsiteY108" fmla="*/ 556732 h 1086957"/>
              <a:gd name="connsiteX109" fmla="*/ 730674 w 768774"/>
              <a:gd name="connsiteY109" fmla="*/ 480532 h 1086957"/>
              <a:gd name="connsiteX110" fmla="*/ 737024 w 768774"/>
              <a:gd name="connsiteY110" fmla="*/ 471007 h 1086957"/>
              <a:gd name="connsiteX111" fmla="*/ 737024 w 768774"/>
              <a:gd name="connsiteY111" fmla="*/ 356707 h 1086957"/>
              <a:gd name="connsiteX112" fmla="*/ 730674 w 768774"/>
              <a:gd name="connsiteY112" fmla="*/ 328132 h 1086957"/>
              <a:gd name="connsiteX113" fmla="*/ 727499 w 768774"/>
              <a:gd name="connsiteY113" fmla="*/ 315432 h 1086957"/>
              <a:gd name="connsiteX114" fmla="*/ 721149 w 768774"/>
              <a:gd name="connsiteY114" fmla="*/ 274157 h 1086957"/>
              <a:gd name="connsiteX115" fmla="*/ 717974 w 768774"/>
              <a:gd name="connsiteY115" fmla="*/ 261457 h 1086957"/>
              <a:gd name="connsiteX116" fmla="*/ 711624 w 768774"/>
              <a:gd name="connsiteY116" fmla="*/ 251932 h 1086957"/>
              <a:gd name="connsiteX117" fmla="*/ 692574 w 768774"/>
              <a:gd name="connsiteY117" fmla="*/ 220182 h 1086957"/>
              <a:gd name="connsiteX118" fmla="*/ 676699 w 768774"/>
              <a:gd name="connsiteY118" fmla="*/ 201132 h 1086957"/>
              <a:gd name="connsiteX119" fmla="*/ 670349 w 768774"/>
              <a:gd name="connsiteY119" fmla="*/ 178907 h 1086957"/>
              <a:gd name="connsiteX120" fmla="*/ 663999 w 768774"/>
              <a:gd name="connsiteY120" fmla="*/ 169382 h 1086957"/>
              <a:gd name="connsiteX121" fmla="*/ 657649 w 768774"/>
              <a:gd name="connsiteY121" fmla="*/ 150332 h 1086957"/>
              <a:gd name="connsiteX122" fmla="*/ 651299 w 768774"/>
              <a:gd name="connsiteY122" fmla="*/ 140807 h 1086957"/>
              <a:gd name="connsiteX123" fmla="*/ 641774 w 768774"/>
              <a:gd name="connsiteY123" fmla="*/ 121757 h 1086957"/>
              <a:gd name="connsiteX124" fmla="*/ 632249 w 768774"/>
              <a:gd name="connsiteY124" fmla="*/ 115407 h 1086957"/>
              <a:gd name="connsiteX125" fmla="*/ 619549 w 768774"/>
              <a:gd name="connsiteY125" fmla="*/ 99532 h 1086957"/>
              <a:gd name="connsiteX126" fmla="*/ 606849 w 768774"/>
              <a:gd name="connsiteY126" fmla="*/ 80482 h 1086957"/>
              <a:gd name="connsiteX127" fmla="*/ 578274 w 768774"/>
              <a:gd name="connsiteY127" fmla="*/ 61432 h 1086957"/>
              <a:gd name="connsiteX128" fmla="*/ 568749 w 768774"/>
              <a:gd name="connsiteY128" fmla="*/ 55082 h 1086957"/>
              <a:gd name="connsiteX129" fmla="*/ 549699 w 768774"/>
              <a:gd name="connsiteY129" fmla="*/ 42382 h 1086957"/>
              <a:gd name="connsiteX130" fmla="*/ 540174 w 768774"/>
              <a:gd name="connsiteY130" fmla="*/ 36032 h 1086957"/>
              <a:gd name="connsiteX131" fmla="*/ 530649 w 768774"/>
              <a:gd name="connsiteY131" fmla="*/ 32857 h 1086957"/>
              <a:gd name="connsiteX132" fmla="*/ 511599 w 768774"/>
              <a:gd name="connsiteY132" fmla="*/ 20157 h 1086957"/>
              <a:gd name="connsiteX133" fmla="*/ 486199 w 768774"/>
              <a:gd name="connsiteY133" fmla="*/ 1107 h 108695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</a:cxnLst>
            <a:rect l="l" t="t" r="r" b="b"/>
            <a:pathLst>
              <a:path w="768774" h="1086957">
                <a:moveTo>
                  <a:pt x="486199" y="1107"/>
                </a:moveTo>
                <a:cubicBezTo>
                  <a:pt x="479320" y="-1539"/>
                  <a:pt x="474584" y="969"/>
                  <a:pt x="470324" y="4282"/>
                </a:cubicBezTo>
                <a:cubicBezTo>
                  <a:pt x="464300" y="8967"/>
                  <a:pt x="461857" y="16982"/>
                  <a:pt x="457624" y="23332"/>
                </a:cubicBezTo>
                <a:lnTo>
                  <a:pt x="444924" y="42382"/>
                </a:lnTo>
                <a:cubicBezTo>
                  <a:pt x="443068" y="45167"/>
                  <a:pt x="443605" y="49122"/>
                  <a:pt x="441749" y="51907"/>
                </a:cubicBezTo>
                <a:cubicBezTo>
                  <a:pt x="427705" y="72973"/>
                  <a:pt x="436262" y="50182"/>
                  <a:pt x="425874" y="70957"/>
                </a:cubicBezTo>
                <a:cubicBezTo>
                  <a:pt x="420709" y="81286"/>
                  <a:pt x="425448" y="80908"/>
                  <a:pt x="416349" y="90007"/>
                </a:cubicBezTo>
                <a:cubicBezTo>
                  <a:pt x="413651" y="92705"/>
                  <a:pt x="409999" y="94240"/>
                  <a:pt x="406824" y="96357"/>
                </a:cubicBezTo>
                <a:cubicBezTo>
                  <a:pt x="404707" y="99532"/>
                  <a:pt x="403710" y="103860"/>
                  <a:pt x="400474" y="105882"/>
                </a:cubicBezTo>
                <a:cubicBezTo>
                  <a:pt x="394798" y="109430"/>
                  <a:pt x="381424" y="112232"/>
                  <a:pt x="381424" y="112232"/>
                </a:cubicBezTo>
                <a:lnTo>
                  <a:pt x="362374" y="124932"/>
                </a:lnTo>
                <a:cubicBezTo>
                  <a:pt x="359199" y="127049"/>
                  <a:pt x="356551" y="130357"/>
                  <a:pt x="352849" y="131282"/>
                </a:cubicBezTo>
                <a:lnTo>
                  <a:pt x="340149" y="134457"/>
                </a:lnTo>
                <a:lnTo>
                  <a:pt x="311574" y="153507"/>
                </a:lnTo>
                <a:cubicBezTo>
                  <a:pt x="308789" y="155363"/>
                  <a:pt x="305224" y="155624"/>
                  <a:pt x="302049" y="156682"/>
                </a:cubicBezTo>
                <a:cubicBezTo>
                  <a:pt x="298874" y="158799"/>
                  <a:pt x="295455" y="160589"/>
                  <a:pt x="292524" y="163032"/>
                </a:cubicBezTo>
                <a:cubicBezTo>
                  <a:pt x="289075" y="165907"/>
                  <a:pt x="286735" y="170066"/>
                  <a:pt x="282999" y="172557"/>
                </a:cubicBezTo>
                <a:cubicBezTo>
                  <a:pt x="280214" y="174413"/>
                  <a:pt x="276649" y="174674"/>
                  <a:pt x="273474" y="175732"/>
                </a:cubicBezTo>
                <a:cubicBezTo>
                  <a:pt x="269241" y="182082"/>
                  <a:pt x="267124" y="190549"/>
                  <a:pt x="260774" y="194782"/>
                </a:cubicBezTo>
                <a:cubicBezTo>
                  <a:pt x="251408" y="201026"/>
                  <a:pt x="249364" y="201490"/>
                  <a:pt x="241724" y="210657"/>
                </a:cubicBezTo>
                <a:cubicBezTo>
                  <a:pt x="230677" y="223914"/>
                  <a:pt x="241486" y="218145"/>
                  <a:pt x="225849" y="223357"/>
                </a:cubicBezTo>
                <a:cubicBezTo>
                  <a:pt x="223732" y="226532"/>
                  <a:pt x="221206" y="229469"/>
                  <a:pt x="219499" y="232882"/>
                </a:cubicBezTo>
                <a:cubicBezTo>
                  <a:pt x="218002" y="235875"/>
                  <a:pt x="218415" y="239794"/>
                  <a:pt x="216324" y="242407"/>
                </a:cubicBezTo>
                <a:cubicBezTo>
                  <a:pt x="213940" y="245387"/>
                  <a:pt x="209974" y="246640"/>
                  <a:pt x="206799" y="248757"/>
                </a:cubicBezTo>
                <a:lnTo>
                  <a:pt x="181399" y="286857"/>
                </a:lnTo>
                <a:lnTo>
                  <a:pt x="168699" y="305907"/>
                </a:lnTo>
                <a:cubicBezTo>
                  <a:pt x="166582" y="309082"/>
                  <a:pt x="162349" y="310140"/>
                  <a:pt x="159174" y="312257"/>
                </a:cubicBezTo>
                <a:cubicBezTo>
                  <a:pt x="158116" y="315432"/>
                  <a:pt x="158090" y="319169"/>
                  <a:pt x="155999" y="321782"/>
                </a:cubicBezTo>
                <a:cubicBezTo>
                  <a:pt x="153615" y="324762"/>
                  <a:pt x="149405" y="325689"/>
                  <a:pt x="146474" y="328132"/>
                </a:cubicBezTo>
                <a:cubicBezTo>
                  <a:pt x="143025" y="331007"/>
                  <a:pt x="140124" y="334482"/>
                  <a:pt x="136949" y="337657"/>
                </a:cubicBezTo>
                <a:cubicBezTo>
                  <a:pt x="135891" y="340832"/>
                  <a:pt x="135399" y="344256"/>
                  <a:pt x="133774" y="347182"/>
                </a:cubicBezTo>
                <a:cubicBezTo>
                  <a:pt x="130068" y="353853"/>
                  <a:pt x="125307" y="359882"/>
                  <a:pt x="121074" y="366232"/>
                </a:cubicBezTo>
                <a:lnTo>
                  <a:pt x="114724" y="375757"/>
                </a:lnTo>
                <a:lnTo>
                  <a:pt x="95674" y="404332"/>
                </a:lnTo>
                <a:cubicBezTo>
                  <a:pt x="93049" y="408270"/>
                  <a:pt x="91832" y="413018"/>
                  <a:pt x="89324" y="417032"/>
                </a:cubicBezTo>
                <a:cubicBezTo>
                  <a:pt x="86519" y="421519"/>
                  <a:pt x="82974" y="425499"/>
                  <a:pt x="79799" y="429732"/>
                </a:cubicBezTo>
                <a:cubicBezTo>
                  <a:pt x="78741" y="432907"/>
                  <a:pt x="78480" y="436472"/>
                  <a:pt x="76624" y="439257"/>
                </a:cubicBezTo>
                <a:cubicBezTo>
                  <a:pt x="66655" y="454211"/>
                  <a:pt x="67674" y="442725"/>
                  <a:pt x="60749" y="458307"/>
                </a:cubicBezTo>
                <a:cubicBezTo>
                  <a:pt x="58031" y="464424"/>
                  <a:pt x="58112" y="471788"/>
                  <a:pt x="54399" y="477357"/>
                </a:cubicBezTo>
                <a:cubicBezTo>
                  <a:pt x="52282" y="480532"/>
                  <a:pt x="49599" y="483395"/>
                  <a:pt x="48049" y="486882"/>
                </a:cubicBezTo>
                <a:cubicBezTo>
                  <a:pt x="45331" y="492999"/>
                  <a:pt x="45412" y="500363"/>
                  <a:pt x="41699" y="505932"/>
                </a:cubicBezTo>
                <a:cubicBezTo>
                  <a:pt x="39582" y="509107"/>
                  <a:pt x="36899" y="511970"/>
                  <a:pt x="35349" y="515457"/>
                </a:cubicBezTo>
                <a:cubicBezTo>
                  <a:pt x="32631" y="521574"/>
                  <a:pt x="31116" y="528157"/>
                  <a:pt x="28999" y="534507"/>
                </a:cubicBezTo>
                <a:lnTo>
                  <a:pt x="22649" y="553557"/>
                </a:lnTo>
                <a:cubicBezTo>
                  <a:pt x="21591" y="556732"/>
                  <a:pt x="21330" y="560297"/>
                  <a:pt x="19474" y="563082"/>
                </a:cubicBezTo>
                <a:lnTo>
                  <a:pt x="13124" y="572607"/>
                </a:lnTo>
                <a:cubicBezTo>
                  <a:pt x="12066" y="576840"/>
                  <a:pt x="11203" y="581127"/>
                  <a:pt x="9949" y="585307"/>
                </a:cubicBezTo>
                <a:cubicBezTo>
                  <a:pt x="8026" y="591718"/>
                  <a:pt x="3599" y="604357"/>
                  <a:pt x="3599" y="604357"/>
                </a:cubicBezTo>
                <a:cubicBezTo>
                  <a:pt x="-185" y="638411"/>
                  <a:pt x="-2120" y="640526"/>
                  <a:pt x="3599" y="680557"/>
                </a:cubicBezTo>
                <a:cubicBezTo>
                  <a:pt x="6383" y="700045"/>
                  <a:pt x="7101" y="697708"/>
                  <a:pt x="19474" y="705957"/>
                </a:cubicBezTo>
                <a:cubicBezTo>
                  <a:pt x="20532" y="709132"/>
                  <a:pt x="21152" y="712489"/>
                  <a:pt x="22649" y="715482"/>
                </a:cubicBezTo>
                <a:cubicBezTo>
                  <a:pt x="25984" y="722153"/>
                  <a:pt x="32779" y="730064"/>
                  <a:pt x="38524" y="734532"/>
                </a:cubicBezTo>
                <a:cubicBezTo>
                  <a:pt x="44548" y="739217"/>
                  <a:pt x="57574" y="747232"/>
                  <a:pt x="57574" y="747232"/>
                </a:cubicBezTo>
                <a:cubicBezTo>
                  <a:pt x="74507" y="772632"/>
                  <a:pt x="52282" y="741940"/>
                  <a:pt x="73449" y="763107"/>
                </a:cubicBezTo>
                <a:cubicBezTo>
                  <a:pt x="76147" y="765805"/>
                  <a:pt x="77356" y="769701"/>
                  <a:pt x="79799" y="772632"/>
                </a:cubicBezTo>
                <a:cubicBezTo>
                  <a:pt x="82674" y="776081"/>
                  <a:pt x="86567" y="778613"/>
                  <a:pt x="89324" y="782157"/>
                </a:cubicBezTo>
                <a:cubicBezTo>
                  <a:pt x="94009" y="788181"/>
                  <a:pt x="97791" y="794857"/>
                  <a:pt x="102024" y="801207"/>
                </a:cubicBezTo>
                <a:lnTo>
                  <a:pt x="108374" y="810732"/>
                </a:lnTo>
                <a:cubicBezTo>
                  <a:pt x="110865" y="814468"/>
                  <a:pt x="115142" y="816713"/>
                  <a:pt x="117899" y="820257"/>
                </a:cubicBezTo>
                <a:cubicBezTo>
                  <a:pt x="122584" y="826281"/>
                  <a:pt x="126366" y="832957"/>
                  <a:pt x="130599" y="839307"/>
                </a:cubicBezTo>
                <a:lnTo>
                  <a:pt x="143299" y="858357"/>
                </a:lnTo>
                <a:cubicBezTo>
                  <a:pt x="161679" y="885926"/>
                  <a:pt x="125613" y="847021"/>
                  <a:pt x="155999" y="877407"/>
                </a:cubicBezTo>
                <a:cubicBezTo>
                  <a:pt x="163979" y="901348"/>
                  <a:pt x="153214" y="871838"/>
                  <a:pt x="165524" y="896457"/>
                </a:cubicBezTo>
                <a:cubicBezTo>
                  <a:pt x="167021" y="899450"/>
                  <a:pt x="167381" y="902906"/>
                  <a:pt x="168699" y="905982"/>
                </a:cubicBezTo>
                <a:cubicBezTo>
                  <a:pt x="174557" y="919650"/>
                  <a:pt x="178721" y="924189"/>
                  <a:pt x="187749" y="937732"/>
                </a:cubicBezTo>
                <a:cubicBezTo>
                  <a:pt x="189866" y="940907"/>
                  <a:pt x="190924" y="945140"/>
                  <a:pt x="194099" y="947257"/>
                </a:cubicBezTo>
                <a:cubicBezTo>
                  <a:pt x="197274" y="949374"/>
                  <a:pt x="200772" y="951072"/>
                  <a:pt x="203624" y="953607"/>
                </a:cubicBezTo>
                <a:cubicBezTo>
                  <a:pt x="210336" y="959573"/>
                  <a:pt x="215202" y="967676"/>
                  <a:pt x="222674" y="972657"/>
                </a:cubicBezTo>
                <a:cubicBezTo>
                  <a:pt x="244509" y="987213"/>
                  <a:pt x="234484" y="982944"/>
                  <a:pt x="251249" y="988532"/>
                </a:cubicBezTo>
                <a:cubicBezTo>
                  <a:pt x="278546" y="1006730"/>
                  <a:pt x="244009" y="984912"/>
                  <a:pt x="270299" y="998057"/>
                </a:cubicBezTo>
                <a:cubicBezTo>
                  <a:pt x="273712" y="999764"/>
                  <a:pt x="276337" y="1002857"/>
                  <a:pt x="279824" y="1004407"/>
                </a:cubicBezTo>
                <a:cubicBezTo>
                  <a:pt x="285941" y="1007125"/>
                  <a:pt x="298874" y="1010757"/>
                  <a:pt x="298874" y="1010757"/>
                </a:cubicBezTo>
                <a:cubicBezTo>
                  <a:pt x="326171" y="1028955"/>
                  <a:pt x="291634" y="1007137"/>
                  <a:pt x="317924" y="1020282"/>
                </a:cubicBezTo>
                <a:cubicBezTo>
                  <a:pt x="321337" y="1021989"/>
                  <a:pt x="323962" y="1025082"/>
                  <a:pt x="327449" y="1026632"/>
                </a:cubicBezTo>
                <a:cubicBezTo>
                  <a:pt x="333566" y="1029350"/>
                  <a:pt x="340149" y="1030865"/>
                  <a:pt x="346499" y="1032982"/>
                </a:cubicBezTo>
                <a:lnTo>
                  <a:pt x="365549" y="1039332"/>
                </a:lnTo>
                <a:cubicBezTo>
                  <a:pt x="395212" y="1049220"/>
                  <a:pt x="363387" y="1041580"/>
                  <a:pt x="387774" y="1052032"/>
                </a:cubicBezTo>
                <a:cubicBezTo>
                  <a:pt x="391785" y="1053751"/>
                  <a:pt x="396149" y="1054630"/>
                  <a:pt x="400474" y="1055207"/>
                </a:cubicBezTo>
                <a:cubicBezTo>
                  <a:pt x="412061" y="1056752"/>
                  <a:pt x="423789" y="1057016"/>
                  <a:pt x="435399" y="1058382"/>
                </a:cubicBezTo>
                <a:cubicBezTo>
                  <a:pt x="441792" y="1059134"/>
                  <a:pt x="448099" y="1060499"/>
                  <a:pt x="454449" y="1061557"/>
                </a:cubicBezTo>
                <a:lnTo>
                  <a:pt x="502074" y="1077432"/>
                </a:lnTo>
                <a:cubicBezTo>
                  <a:pt x="508181" y="1079468"/>
                  <a:pt x="514774" y="1079549"/>
                  <a:pt x="521124" y="1080607"/>
                </a:cubicBezTo>
                <a:cubicBezTo>
                  <a:pt x="525616" y="1082104"/>
                  <a:pt x="539362" y="1086957"/>
                  <a:pt x="543349" y="1086957"/>
                </a:cubicBezTo>
                <a:cubicBezTo>
                  <a:pt x="556093" y="1086957"/>
                  <a:pt x="568749" y="1084840"/>
                  <a:pt x="581449" y="1083782"/>
                </a:cubicBezTo>
                <a:lnTo>
                  <a:pt x="600499" y="1077432"/>
                </a:lnTo>
                <a:lnTo>
                  <a:pt x="610024" y="1074257"/>
                </a:lnTo>
                <a:cubicBezTo>
                  <a:pt x="616374" y="1070024"/>
                  <a:pt x="621834" y="1063970"/>
                  <a:pt x="629074" y="1061557"/>
                </a:cubicBezTo>
                <a:lnTo>
                  <a:pt x="648124" y="1055207"/>
                </a:lnTo>
                <a:lnTo>
                  <a:pt x="667174" y="1042507"/>
                </a:lnTo>
                <a:cubicBezTo>
                  <a:pt x="670349" y="1040390"/>
                  <a:pt x="673079" y="1037364"/>
                  <a:pt x="676699" y="1036157"/>
                </a:cubicBezTo>
                <a:lnTo>
                  <a:pt x="686224" y="1032982"/>
                </a:lnTo>
                <a:cubicBezTo>
                  <a:pt x="688341" y="1029807"/>
                  <a:pt x="689594" y="1025841"/>
                  <a:pt x="692574" y="1023457"/>
                </a:cubicBezTo>
                <a:cubicBezTo>
                  <a:pt x="708543" y="1010682"/>
                  <a:pt x="702058" y="1039455"/>
                  <a:pt x="714799" y="1001232"/>
                </a:cubicBezTo>
                <a:cubicBezTo>
                  <a:pt x="720387" y="984467"/>
                  <a:pt x="716118" y="994492"/>
                  <a:pt x="730674" y="972657"/>
                </a:cubicBezTo>
                <a:cubicBezTo>
                  <a:pt x="732791" y="969482"/>
                  <a:pt x="735817" y="966752"/>
                  <a:pt x="737024" y="963132"/>
                </a:cubicBezTo>
                <a:cubicBezTo>
                  <a:pt x="748603" y="928394"/>
                  <a:pt x="730136" y="981011"/>
                  <a:pt x="746549" y="944082"/>
                </a:cubicBezTo>
                <a:cubicBezTo>
                  <a:pt x="761662" y="910077"/>
                  <a:pt x="744878" y="937063"/>
                  <a:pt x="759249" y="915507"/>
                </a:cubicBezTo>
                <a:cubicBezTo>
                  <a:pt x="760307" y="910215"/>
                  <a:pt x="761603" y="904966"/>
                  <a:pt x="762424" y="899632"/>
                </a:cubicBezTo>
                <a:cubicBezTo>
                  <a:pt x="765883" y="877151"/>
                  <a:pt x="766828" y="859489"/>
                  <a:pt x="768774" y="836132"/>
                </a:cubicBezTo>
                <a:cubicBezTo>
                  <a:pt x="767716" y="809674"/>
                  <a:pt x="767421" y="783174"/>
                  <a:pt x="765599" y="756757"/>
                </a:cubicBezTo>
                <a:cubicBezTo>
                  <a:pt x="765299" y="752404"/>
                  <a:pt x="763280" y="748336"/>
                  <a:pt x="762424" y="744057"/>
                </a:cubicBezTo>
                <a:cubicBezTo>
                  <a:pt x="756011" y="711991"/>
                  <a:pt x="763507" y="737782"/>
                  <a:pt x="752899" y="705957"/>
                </a:cubicBezTo>
                <a:lnTo>
                  <a:pt x="749724" y="696432"/>
                </a:lnTo>
                <a:cubicBezTo>
                  <a:pt x="748666" y="686907"/>
                  <a:pt x="748429" y="677255"/>
                  <a:pt x="746549" y="667857"/>
                </a:cubicBezTo>
                <a:cubicBezTo>
                  <a:pt x="745236" y="661293"/>
                  <a:pt x="742316" y="655157"/>
                  <a:pt x="740199" y="648807"/>
                </a:cubicBezTo>
                <a:cubicBezTo>
                  <a:pt x="735527" y="634792"/>
                  <a:pt x="738521" y="642275"/>
                  <a:pt x="730674" y="626582"/>
                </a:cubicBezTo>
                <a:cubicBezTo>
                  <a:pt x="729616" y="621290"/>
                  <a:pt x="728808" y="615942"/>
                  <a:pt x="727499" y="610707"/>
                </a:cubicBezTo>
                <a:cubicBezTo>
                  <a:pt x="726687" y="607460"/>
                  <a:pt x="724715" y="604506"/>
                  <a:pt x="724324" y="601182"/>
                </a:cubicBezTo>
                <a:cubicBezTo>
                  <a:pt x="722588" y="586429"/>
                  <a:pt x="722207" y="571549"/>
                  <a:pt x="721149" y="556732"/>
                </a:cubicBezTo>
                <a:cubicBezTo>
                  <a:pt x="724695" y="492899"/>
                  <a:pt x="718291" y="517682"/>
                  <a:pt x="730674" y="480532"/>
                </a:cubicBezTo>
                <a:cubicBezTo>
                  <a:pt x="731881" y="476912"/>
                  <a:pt x="734907" y="474182"/>
                  <a:pt x="737024" y="471007"/>
                </a:cubicBezTo>
                <a:cubicBezTo>
                  <a:pt x="741691" y="415003"/>
                  <a:pt x="741965" y="430818"/>
                  <a:pt x="737024" y="356707"/>
                </a:cubicBezTo>
                <a:cubicBezTo>
                  <a:pt x="735778" y="338023"/>
                  <a:pt x="734596" y="341858"/>
                  <a:pt x="730674" y="328132"/>
                </a:cubicBezTo>
                <a:cubicBezTo>
                  <a:pt x="729475" y="323936"/>
                  <a:pt x="728557" y="319665"/>
                  <a:pt x="727499" y="315432"/>
                </a:cubicBezTo>
                <a:cubicBezTo>
                  <a:pt x="722393" y="264368"/>
                  <a:pt x="728190" y="298802"/>
                  <a:pt x="721149" y="274157"/>
                </a:cubicBezTo>
                <a:cubicBezTo>
                  <a:pt x="719950" y="269961"/>
                  <a:pt x="719693" y="265468"/>
                  <a:pt x="717974" y="261457"/>
                </a:cubicBezTo>
                <a:cubicBezTo>
                  <a:pt x="716471" y="257950"/>
                  <a:pt x="713517" y="255245"/>
                  <a:pt x="711624" y="251932"/>
                </a:cubicBezTo>
                <a:cubicBezTo>
                  <a:pt x="704943" y="240240"/>
                  <a:pt x="702930" y="230538"/>
                  <a:pt x="692574" y="220182"/>
                </a:cubicBezTo>
                <a:cubicBezTo>
                  <a:pt x="680351" y="207959"/>
                  <a:pt x="685540" y="214393"/>
                  <a:pt x="676699" y="201132"/>
                </a:cubicBezTo>
                <a:cubicBezTo>
                  <a:pt x="675682" y="197063"/>
                  <a:pt x="672626" y="183462"/>
                  <a:pt x="670349" y="178907"/>
                </a:cubicBezTo>
                <a:cubicBezTo>
                  <a:pt x="668642" y="175494"/>
                  <a:pt x="665549" y="172869"/>
                  <a:pt x="663999" y="169382"/>
                </a:cubicBezTo>
                <a:cubicBezTo>
                  <a:pt x="661281" y="163265"/>
                  <a:pt x="661362" y="155901"/>
                  <a:pt x="657649" y="150332"/>
                </a:cubicBezTo>
                <a:cubicBezTo>
                  <a:pt x="655532" y="147157"/>
                  <a:pt x="653006" y="144220"/>
                  <a:pt x="651299" y="140807"/>
                </a:cubicBezTo>
                <a:cubicBezTo>
                  <a:pt x="646134" y="130478"/>
                  <a:pt x="650873" y="130856"/>
                  <a:pt x="641774" y="121757"/>
                </a:cubicBezTo>
                <a:cubicBezTo>
                  <a:pt x="639076" y="119059"/>
                  <a:pt x="635424" y="117524"/>
                  <a:pt x="632249" y="115407"/>
                </a:cubicBezTo>
                <a:cubicBezTo>
                  <a:pt x="625099" y="93957"/>
                  <a:pt x="635015" y="117207"/>
                  <a:pt x="619549" y="99532"/>
                </a:cubicBezTo>
                <a:cubicBezTo>
                  <a:pt x="614523" y="93789"/>
                  <a:pt x="613199" y="84715"/>
                  <a:pt x="606849" y="80482"/>
                </a:cubicBezTo>
                <a:lnTo>
                  <a:pt x="578274" y="61432"/>
                </a:lnTo>
                <a:cubicBezTo>
                  <a:pt x="575099" y="59315"/>
                  <a:pt x="571447" y="57780"/>
                  <a:pt x="568749" y="55082"/>
                </a:cubicBezTo>
                <a:cubicBezTo>
                  <a:pt x="556857" y="43190"/>
                  <a:pt x="563484" y="46977"/>
                  <a:pt x="549699" y="42382"/>
                </a:cubicBezTo>
                <a:cubicBezTo>
                  <a:pt x="546524" y="40265"/>
                  <a:pt x="543587" y="37739"/>
                  <a:pt x="540174" y="36032"/>
                </a:cubicBezTo>
                <a:cubicBezTo>
                  <a:pt x="537181" y="34535"/>
                  <a:pt x="533575" y="34482"/>
                  <a:pt x="530649" y="32857"/>
                </a:cubicBezTo>
                <a:cubicBezTo>
                  <a:pt x="523978" y="29151"/>
                  <a:pt x="519003" y="22008"/>
                  <a:pt x="511599" y="20157"/>
                </a:cubicBezTo>
                <a:cubicBezTo>
                  <a:pt x="479012" y="12010"/>
                  <a:pt x="493078" y="3753"/>
                  <a:pt x="486199" y="1107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9" name="フリーフォーム 68"/>
          <p:cNvSpPr/>
          <p:nvPr/>
        </p:nvSpPr>
        <p:spPr>
          <a:xfrm>
            <a:off x="314442" y="3527092"/>
            <a:ext cx="768774" cy="1086957"/>
          </a:xfrm>
          <a:custGeom>
            <a:avLst/>
            <a:gdLst>
              <a:gd name="connsiteX0" fmla="*/ 486199 w 768774"/>
              <a:gd name="connsiteY0" fmla="*/ 1107 h 1086957"/>
              <a:gd name="connsiteX1" fmla="*/ 470324 w 768774"/>
              <a:gd name="connsiteY1" fmla="*/ 4282 h 1086957"/>
              <a:gd name="connsiteX2" fmla="*/ 457624 w 768774"/>
              <a:gd name="connsiteY2" fmla="*/ 23332 h 1086957"/>
              <a:gd name="connsiteX3" fmla="*/ 444924 w 768774"/>
              <a:gd name="connsiteY3" fmla="*/ 42382 h 1086957"/>
              <a:gd name="connsiteX4" fmla="*/ 441749 w 768774"/>
              <a:gd name="connsiteY4" fmla="*/ 51907 h 1086957"/>
              <a:gd name="connsiteX5" fmla="*/ 425874 w 768774"/>
              <a:gd name="connsiteY5" fmla="*/ 70957 h 1086957"/>
              <a:gd name="connsiteX6" fmla="*/ 416349 w 768774"/>
              <a:gd name="connsiteY6" fmla="*/ 90007 h 1086957"/>
              <a:gd name="connsiteX7" fmla="*/ 406824 w 768774"/>
              <a:gd name="connsiteY7" fmla="*/ 96357 h 1086957"/>
              <a:gd name="connsiteX8" fmla="*/ 400474 w 768774"/>
              <a:gd name="connsiteY8" fmla="*/ 105882 h 1086957"/>
              <a:gd name="connsiteX9" fmla="*/ 381424 w 768774"/>
              <a:gd name="connsiteY9" fmla="*/ 112232 h 1086957"/>
              <a:gd name="connsiteX10" fmla="*/ 362374 w 768774"/>
              <a:gd name="connsiteY10" fmla="*/ 124932 h 1086957"/>
              <a:gd name="connsiteX11" fmla="*/ 352849 w 768774"/>
              <a:gd name="connsiteY11" fmla="*/ 131282 h 1086957"/>
              <a:gd name="connsiteX12" fmla="*/ 340149 w 768774"/>
              <a:gd name="connsiteY12" fmla="*/ 134457 h 1086957"/>
              <a:gd name="connsiteX13" fmla="*/ 311574 w 768774"/>
              <a:gd name="connsiteY13" fmla="*/ 153507 h 1086957"/>
              <a:gd name="connsiteX14" fmla="*/ 302049 w 768774"/>
              <a:gd name="connsiteY14" fmla="*/ 156682 h 1086957"/>
              <a:gd name="connsiteX15" fmla="*/ 292524 w 768774"/>
              <a:gd name="connsiteY15" fmla="*/ 163032 h 1086957"/>
              <a:gd name="connsiteX16" fmla="*/ 282999 w 768774"/>
              <a:gd name="connsiteY16" fmla="*/ 172557 h 1086957"/>
              <a:gd name="connsiteX17" fmla="*/ 273474 w 768774"/>
              <a:gd name="connsiteY17" fmla="*/ 175732 h 1086957"/>
              <a:gd name="connsiteX18" fmla="*/ 260774 w 768774"/>
              <a:gd name="connsiteY18" fmla="*/ 194782 h 1086957"/>
              <a:gd name="connsiteX19" fmla="*/ 241724 w 768774"/>
              <a:gd name="connsiteY19" fmla="*/ 210657 h 1086957"/>
              <a:gd name="connsiteX20" fmla="*/ 225849 w 768774"/>
              <a:gd name="connsiteY20" fmla="*/ 223357 h 1086957"/>
              <a:gd name="connsiteX21" fmla="*/ 219499 w 768774"/>
              <a:gd name="connsiteY21" fmla="*/ 232882 h 1086957"/>
              <a:gd name="connsiteX22" fmla="*/ 216324 w 768774"/>
              <a:gd name="connsiteY22" fmla="*/ 242407 h 1086957"/>
              <a:gd name="connsiteX23" fmla="*/ 206799 w 768774"/>
              <a:gd name="connsiteY23" fmla="*/ 248757 h 1086957"/>
              <a:gd name="connsiteX24" fmla="*/ 181399 w 768774"/>
              <a:gd name="connsiteY24" fmla="*/ 286857 h 1086957"/>
              <a:gd name="connsiteX25" fmla="*/ 168699 w 768774"/>
              <a:gd name="connsiteY25" fmla="*/ 305907 h 1086957"/>
              <a:gd name="connsiteX26" fmla="*/ 159174 w 768774"/>
              <a:gd name="connsiteY26" fmla="*/ 312257 h 1086957"/>
              <a:gd name="connsiteX27" fmla="*/ 155999 w 768774"/>
              <a:gd name="connsiteY27" fmla="*/ 321782 h 1086957"/>
              <a:gd name="connsiteX28" fmla="*/ 146474 w 768774"/>
              <a:gd name="connsiteY28" fmla="*/ 328132 h 1086957"/>
              <a:gd name="connsiteX29" fmla="*/ 136949 w 768774"/>
              <a:gd name="connsiteY29" fmla="*/ 337657 h 1086957"/>
              <a:gd name="connsiteX30" fmla="*/ 133774 w 768774"/>
              <a:gd name="connsiteY30" fmla="*/ 347182 h 1086957"/>
              <a:gd name="connsiteX31" fmla="*/ 121074 w 768774"/>
              <a:gd name="connsiteY31" fmla="*/ 366232 h 1086957"/>
              <a:gd name="connsiteX32" fmla="*/ 114724 w 768774"/>
              <a:gd name="connsiteY32" fmla="*/ 375757 h 1086957"/>
              <a:gd name="connsiteX33" fmla="*/ 95674 w 768774"/>
              <a:gd name="connsiteY33" fmla="*/ 404332 h 1086957"/>
              <a:gd name="connsiteX34" fmla="*/ 89324 w 768774"/>
              <a:gd name="connsiteY34" fmla="*/ 417032 h 1086957"/>
              <a:gd name="connsiteX35" fmla="*/ 79799 w 768774"/>
              <a:gd name="connsiteY35" fmla="*/ 429732 h 1086957"/>
              <a:gd name="connsiteX36" fmla="*/ 76624 w 768774"/>
              <a:gd name="connsiteY36" fmla="*/ 439257 h 1086957"/>
              <a:gd name="connsiteX37" fmla="*/ 60749 w 768774"/>
              <a:gd name="connsiteY37" fmla="*/ 458307 h 1086957"/>
              <a:gd name="connsiteX38" fmla="*/ 54399 w 768774"/>
              <a:gd name="connsiteY38" fmla="*/ 477357 h 1086957"/>
              <a:gd name="connsiteX39" fmla="*/ 48049 w 768774"/>
              <a:gd name="connsiteY39" fmla="*/ 486882 h 1086957"/>
              <a:gd name="connsiteX40" fmla="*/ 41699 w 768774"/>
              <a:gd name="connsiteY40" fmla="*/ 505932 h 1086957"/>
              <a:gd name="connsiteX41" fmla="*/ 35349 w 768774"/>
              <a:gd name="connsiteY41" fmla="*/ 515457 h 1086957"/>
              <a:gd name="connsiteX42" fmla="*/ 28999 w 768774"/>
              <a:gd name="connsiteY42" fmla="*/ 534507 h 1086957"/>
              <a:gd name="connsiteX43" fmla="*/ 22649 w 768774"/>
              <a:gd name="connsiteY43" fmla="*/ 553557 h 1086957"/>
              <a:gd name="connsiteX44" fmla="*/ 19474 w 768774"/>
              <a:gd name="connsiteY44" fmla="*/ 563082 h 1086957"/>
              <a:gd name="connsiteX45" fmla="*/ 13124 w 768774"/>
              <a:gd name="connsiteY45" fmla="*/ 572607 h 1086957"/>
              <a:gd name="connsiteX46" fmla="*/ 9949 w 768774"/>
              <a:gd name="connsiteY46" fmla="*/ 585307 h 1086957"/>
              <a:gd name="connsiteX47" fmla="*/ 3599 w 768774"/>
              <a:gd name="connsiteY47" fmla="*/ 604357 h 1086957"/>
              <a:gd name="connsiteX48" fmla="*/ 3599 w 768774"/>
              <a:gd name="connsiteY48" fmla="*/ 680557 h 1086957"/>
              <a:gd name="connsiteX49" fmla="*/ 19474 w 768774"/>
              <a:gd name="connsiteY49" fmla="*/ 705957 h 1086957"/>
              <a:gd name="connsiteX50" fmla="*/ 22649 w 768774"/>
              <a:gd name="connsiteY50" fmla="*/ 715482 h 1086957"/>
              <a:gd name="connsiteX51" fmla="*/ 38524 w 768774"/>
              <a:gd name="connsiteY51" fmla="*/ 734532 h 1086957"/>
              <a:gd name="connsiteX52" fmla="*/ 57574 w 768774"/>
              <a:gd name="connsiteY52" fmla="*/ 747232 h 1086957"/>
              <a:gd name="connsiteX53" fmla="*/ 73449 w 768774"/>
              <a:gd name="connsiteY53" fmla="*/ 763107 h 1086957"/>
              <a:gd name="connsiteX54" fmla="*/ 79799 w 768774"/>
              <a:gd name="connsiteY54" fmla="*/ 772632 h 1086957"/>
              <a:gd name="connsiteX55" fmla="*/ 89324 w 768774"/>
              <a:gd name="connsiteY55" fmla="*/ 782157 h 1086957"/>
              <a:gd name="connsiteX56" fmla="*/ 102024 w 768774"/>
              <a:gd name="connsiteY56" fmla="*/ 801207 h 1086957"/>
              <a:gd name="connsiteX57" fmla="*/ 108374 w 768774"/>
              <a:gd name="connsiteY57" fmla="*/ 810732 h 1086957"/>
              <a:gd name="connsiteX58" fmla="*/ 117899 w 768774"/>
              <a:gd name="connsiteY58" fmla="*/ 820257 h 1086957"/>
              <a:gd name="connsiteX59" fmla="*/ 130599 w 768774"/>
              <a:gd name="connsiteY59" fmla="*/ 839307 h 1086957"/>
              <a:gd name="connsiteX60" fmla="*/ 143299 w 768774"/>
              <a:gd name="connsiteY60" fmla="*/ 858357 h 1086957"/>
              <a:gd name="connsiteX61" fmla="*/ 155999 w 768774"/>
              <a:gd name="connsiteY61" fmla="*/ 877407 h 1086957"/>
              <a:gd name="connsiteX62" fmla="*/ 165524 w 768774"/>
              <a:gd name="connsiteY62" fmla="*/ 896457 h 1086957"/>
              <a:gd name="connsiteX63" fmla="*/ 168699 w 768774"/>
              <a:gd name="connsiteY63" fmla="*/ 905982 h 1086957"/>
              <a:gd name="connsiteX64" fmla="*/ 187749 w 768774"/>
              <a:gd name="connsiteY64" fmla="*/ 937732 h 1086957"/>
              <a:gd name="connsiteX65" fmla="*/ 194099 w 768774"/>
              <a:gd name="connsiteY65" fmla="*/ 947257 h 1086957"/>
              <a:gd name="connsiteX66" fmla="*/ 203624 w 768774"/>
              <a:gd name="connsiteY66" fmla="*/ 953607 h 1086957"/>
              <a:gd name="connsiteX67" fmla="*/ 222674 w 768774"/>
              <a:gd name="connsiteY67" fmla="*/ 972657 h 1086957"/>
              <a:gd name="connsiteX68" fmla="*/ 251249 w 768774"/>
              <a:gd name="connsiteY68" fmla="*/ 988532 h 1086957"/>
              <a:gd name="connsiteX69" fmla="*/ 270299 w 768774"/>
              <a:gd name="connsiteY69" fmla="*/ 998057 h 1086957"/>
              <a:gd name="connsiteX70" fmla="*/ 279824 w 768774"/>
              <a:gd name="connsiteY70" fmla="*/ 1004407 h 1086957"/>
              <a:gd name="connsiteX71" fmla="*/ 298874 w 768774"/>
              <a:gd name="connsiteY71" fmla="*/ 1010757 h 1086957"/>
              <a:gd name="connsiteX72" fmla="*/ 317924 w 768774"/>
              <a:gd name="connsiteY72" fmla="*/ 1020282 h 1086957"/>
              <a:gd name="connsiteX73" fmla="*/ 327449 w 768774"/>
              <a:gd name="connsiteY73" fmla="*/ 1026632 h 1086957"/>
              <a:gd name="connsiteX74" fmla="*/ 346499 w 768774"/>
              <a:gd name="connsiteY74" fmla="*/ 1032982 h 1086957"/>
              <a:gd name="connsiteX75" fmla="*/ 365549 w 768774"/>
              <a:gd name="connsiteY75" fmla="*/ 1039332 h 1086957"/>
              <a:gd name="connsiteX76" fmla="*/ 387774 w 768774"/>
              <a:gd name="connsiteY76" fmla="*/ 1052032 h 1086957"/>
              <a:gd name="connsiteX77" fmla="*/ 400474 w 768774"/>
              <a:gd name="connsiteY77" fmla="*/ 1055207 h 1086957"/>
              <a:gd name="connsiteX78" fmla="*/ 435399 w 768774"/>
              <a:gd name="connsiteY78" fmla="*/ 1058382 h 1086957"/>
              <a:gd name="connsiteX79" fmla="*/ 454449 w 768774"/>
              <a:gd name="connsiteY79" fmla="*/ 1061557 h 1086957"/>
              <a:gd name="connsiteX80" fmla="*/ 502074 w 768774"/>
              <a:gd name="connsiteY80" fmla="*/ 1077432 h 1086957"/>
              <a:gd name="connsiteX81" fmla="*/ 521124 w 768774"/>
              <a:gd name="connsiteY81" fmla="*/ 1080607 h 1086957"/>
              <a:gd name="connsiteX82" fmla="*/ 543349 w 768774"/>
              <a:gd name="connsiteY82" fmla="*/ 1086957 h 1086957"/>
              <a:gd name="connsiteX83" fmla="*/ 581449 w 768774"/>
              <a:gd name="connsiteY83" fmla="*/ 1083782 h 1086957"/>
              <a:gd name="connsiteX84" fmla="*/ 600499 w 768774"/>
              <a:gd name="connsiteY84" fmla="*/ 1077432 h 1086957"/>
              <a:gd name="connsiteX85" fmla="*/ 610024 w 768774"/>
              <a:gd name="connsiteY85" fmla="*/ 1074257 h 1086957"/>
              <a:gd name="connsiteX86" fmla="*/ 629074 w 768774"/>
              <a:gd name="connsiteY86" fmla="*/ 1061557 h 1086957"/>
              <a:gd name="connsiteX87" fmla="*/ 648124 w 768774"/>
              <a:gd name="connsiteY87" fmla="*/ 1055207 h 1086957"/>
              <a:gd name="connsiteX88" fmla="*/ 667174 w 768774"/>
              <a:gd name="connsiteY88" fmla="*/ 1042507 h 1086957"/>
              <a:gd name="connsiteX89" fmla="*/ 676699 w 768774"/>
              <a:gd name="connsiteY89" fmla="*/ 1036157 h 1086957"/>
              <a:gd name="connsiteX90" fmla="*/ 686224 w 768774"/>
              <a:gd name="connsiteY90" fmla="*/ 1032982 h 1086957"/>
              <a:gd name="connsiteX91" fmla="*/ 692574 w 768774"/>
              <a:gd name="connsiteY91" fmla="*/ 1023457 h 1086957"/>
              <a:gd name="connsiteX92" fmla="*/ 714799 w 768774"/>
              <a:gd name="connsiteY92" fmla="*/ 1001232 h 1086957"/>
              <a:gd name="connsiteX93" fmla="*/ 730674 w 768774"/>
              <a:gd name="connsiteY93" fmla="*/ 972657 h 1086957"/>
              <a:gd name="connsiteX94" fmla="*/ 737024 w 768774"/>
              <a:gd name="connsiteY94" fmla="*/ 963132 h 1086957"/>
              <a:gd name="connsiteX95" fmla="*/ 746549 w 768774"/>
              <a:gd name="connsiteY95" fmla="*/ 944082 h 1086957"/>
              <a:gd name="connsiteX96" fmla="*/ 759249 w 768774"/>
              <a:gd name="connsiteY96" fmla="*/ 915507 h 1086957"/>
              <a:gd name="connsiteX97" fmla="*/ 762424 w 768774"/>
              <a:gd name="connsiteY97" fmla="*/ 899632 h 1086957"/>
              <a:gd name="connsiteX98" fmla="*/ 768774 w 768774"/>
              <a:gd name="connsiteY98" fmla="*/ 836132 h 1086957"/>
              <a:gd name="connsiteX99" fmla="*/ 765599 w 768774"/>
              <a:gd name="connsiteY99" fmla="*/ 756757 h 1086957"/>
              <a:gd name="connsiteX100" fmla="*/ 762424 w 768774"/>
              <a:gd name="connsiteY100" fmla="*/ 744057 h 1086957"/>
              <a:gd name="connsiteX101" fmla="*/ 752899 w 768774"/>
              <a:gd name="connsiteY101" fmla="*/ 705957 h 1086957"/>
              <a:gd name="connsiteX102" fmla="*/ 749724 w 768774"/>
              <a:gd name="connsiteY102" fmla="*/ 696432 h 1086957"/>
              <a:gd name="connsiteX103" fmla="*/ 746549 w 768774"/>
              <a:gd name="connsiteY103" fmla="*/ 667857 h 1086957"/>
              <a:gd name="connsiteX104" fmla="*/ 740199 w 768774"/>
              <a:gd name="connsiteY104" fmla="*/ 648807 h 1086957"/>
              <a:gd name="connsiteX105" fmla="*/ 730674 w 768774"/>
              <a:gd name="connsiteY105" fmla="*/ 626582 h 1086957"/>
              <a:gd name="connsiteX106" fmla="*/ 727499 w 768774"/>
              <a:gd name="connsiteY106" fmla="*/ 610707 h 1086957"/>
              <a:gd name="connsiteX107" fmla="*/ 724324 w 768774"/>
              <a:gd name="connsiteY107" fmla="*/ 601182 h 1086957"/>
              <a:gd name="connsiteX108" fmla="*/ 721149 w 768774"/>
              <a:gd name="connsiteY108" fmla="*/ 556732 h 1086957"/>
              <a:gd name="connsiteX109" fmla="*/ 730674 w 768774"/>
              <a:gd name="connsiteY109" fmla="*/ 480532 h 1086957"/>
              <a:gd name="connsiteX110" fmla="*/ 737024 w 768774"/>
              <a:gd name="connsiteY110" fmla="*/ 471007 h 1086957"/>
              <a:gd name="connsiteX111" fmla="*/ 737024 w 768774"/>
              <a:gd name="connsiteY111" fmla="*/ 356707 h 1086957"/>
              <a:gd name="connsiteX112" fmla="*/ 730674 w 768774"/>
              <a:gd name="connsiteY112" fmla="*/ 328132 h 1086957"/>
              <a:gd name="connsiteX113" fmla="*/ 727499 w 768774"/>
              <a:gd name="connsiteY113" fmla="*/ 315432 h 1086957"/>
              <a:gd name="connsiteX114" fmla="*/ 721149 w 768774"/>
              <a:gd name="connsiteY114" fmla="*/ 274157 h 1086957"/>
              <a:gd name="connsiteX115" fmla="*/ 717974 w 768774"/>
              <a:gd name="connsiteY115" fmla="*/ 261457 h 1086957"/>
              <a:gd name="connsiteX116" fmla="*/ 711624 w 768774"/>
              <a:gd name="connsiteY116" fmla="*/ 251932 h 1086957"/>
              <a:gd name="connsiteX117" fmla="*/ 692574 w 768774"/>
              <a:gd name="connsiteY117" fmla="*/ 220182 h 1086957"/>
              <a:gd name="connsiteX118" fmla="*/ 676699 w 768774"/>
              <a:gd name="connsiteY118" fmla="*/ 201132 h 1086957"/>
              <a:gd name="connsiteX119" fmla="*/ 670349 w 768774"/>
              <a:gd name="connsiteY119" fmla="*/ 178907 h 1086957"/>
              <a:gd name="connsiteX120" fmla="*/ 663999 w 768774"/>
              <a:gd name="connsiteY120" fmla="*/ 169382 h 1086957"/>
              <a:gd name="connsiteX121" fmla="*/ 657649 w 768774"/>
              <a:gd name="connsiteY121" fmla="*/ 150332 h 1086957"/>
              <a:gd name="connsiteX122" fmla="*/ 651299 w 768774"/>
              <a:gd name="connsiteY122" fmla="*/ 140807 h 1086957"/>
              <a:gd name="connsiteX123" fmla="*/ 641774 w 768774"/>
              <a:gd name="connsiteY123" fmla="*/ 121757 h 1086957"/>
              <a:gd name="connsiteX124" fmla="*/ 632249 w 768774"/>
              <a:gd name="connsiteY124" fmla="*/ 115407 h 1086957"/>
              <a:gd name="connsiteX125" fmla="*/ 619549 w 768774"/>
              <a:gd name="connsiteY125" fmla="*/ 99532 h 1086957"/>
              <a:gd name="connsiteX126" fmla="*/ 606849 w 768774"/>
              <a:gd name="connsiteY126" fmla="*/ 80482 h 1086957"/>
              <a:gd name="connsiteX127" fmla="*/ 578274 w 768774"/>
              <a:gd name="connsiteY127" fmla="*/ 61432 h 1086957"/>
              <a:gd name="connsiteX128" fmla="*/ 568749 w 768774"/>
              <a:gd name="connsiteY128" fmla="*/ 55082 h 1086957"/>
              <a:gd name="connsiteX129" fmla="*/ 549699 w 768774"/>
              <a:gd name="connsiteY129" fmla="*/ 42382 h 1086957"/>
              <a:gd name="connsiteX130" fmla="*/ 540174 w 768774"/>
              <a:gd name="connsiteY130" fmla="*/ 36032 h 1086957"/>
              <a:gd name="connsiteX131" fmla="*/ 530649 w 768774"/>
              <a:gd name="connsiteY131" fmla="*/ 32857 h 1086957"/>
              <a:gd name="connsiteX132" fmla="*/ 511599 w 768774"/>
              <a:gd name="connsiteY132" fmla="*/ 20157 h 1086957"/>
              <a:gd name="connsiteX133" fmla="*/ 486199 w 768774"/>
              <a:gd name="connsiteY133" fmla="*/ 1107 h 108695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</a:cxnLst>
            <a:rect l="l" t="t" r="r" b="b"/>
            <a:pathLst>
              <a:path w="768774" h="1086957">
                <a:moveTo>
                  <a:pt x="486199" y="1107"/>
                </a:moveTo>
                <a:cubicBezTo>
                  <a:pt x="479320" y="-1539"/>
                  <a:pt x="474584" y="969"/>
                  <a:pt x="470324" y="4282"/>
                </a:cubicBezTo>
                <a:cubicBezTo>
                  <a:pt x="464300" y="8967"/>
                  <a:pt x="461857" y="16982"/>
                  <a:pt x="457624" y="23332"/>
                </a:cubicBezTo>
                <a:lnTo>
                  <a:pt x="444924" y="42382"/>
                </a:lnTo>
                <a:cubicBezTo>
                  <a:pt x="443068" y="45167"/>
                  <a:pt x="443605" y="49122"/>
                  <a:pt x="441749" y="51907"/>
                </a:cubicBezTo>
                <a:cubicBezTo>
                  <a:pt x="427705" y="72973"/>
                  <a:pt x="436262" y="50182"/>
                  <a:pt x="425874" y="70957"/>
                </a:cubicBezTo>
                <a:cubicBezTo>
                  <a:pt x="420709" y="81286"/>
                  <a:pt x="425448" y="80908"/>
                  <a:pt x="416349" y="90007"/>
                </a:cubicBezTo>
                <a:cubicBezTo>
                  <a:pt x="413651" y="92705"/>
                  <a:pt x="409999" y="94240"/>
                  <a:pt x="406824" y="96357"/>
                </a:cubicBezTo>
                <a:cubicBezTo>
                  <a:pt x="404707" y="99532"/>
                  <a:pt x="403710" y="103860"/>
                  <a:pt x="400474" y="105882"/>
                </a:cubicBezTo>
                <a:cubicBezTo>
                  <a:pt x="394798" y="109430"/>
                  <a:pt x="381424" y="112232"/>
                  <a:pt x="381424" y="112232"/>
                </a:cubicBezTo>
                <a:lnTo>
                  <a:pt x="362374" y="124932"/>
                </a:lnTo>
                <a:cubicBezTo>
                  <a:pt x="359199" y="127049"/>
                  <a:pt x="356551" y="130357"/>
                  <a:pt x="352849" y="131282"/>
                </a:cubicBezTo>
                <a:lnTo>
                  <a:pt x="340149" y="134457"/>
                </a:lnTo>
                <a:lnTo>
                  <a:pt x="311574" y="153507"/>
                </a:lnTo>
                <a:cubicBezTo>
                  <a:pt x="308789" y="155363"/>
                  <a:pt x="305224" y="155624"/>
                  <a:pt x="302049" y="156682"/>
                </a:cubicBezTo>
                <a:cubicBezTo>
                  <a:pt x="298874" y="158799"/>
                  <a:pt x="295455" y="160589"/>
                  <a:pt x="292524" y="163032"/>
                </a:cubicBezTo>
                <a:cubicBezTo>
                  <a:pt x="289075" y="165907"/>
                  <a:pt x="286735" y="170066"/>
                  <a:pt x="282999" y="172557"/>
                </a:cubicBezTo>
                <a:cubicBezTo>
                  <a:pt x="280214" y="174413"/>
                  <a:pt x="276649" y="174674"/>
                  <a:pt x="273474" y="175732"/>
                </a:cubicBezTo>
                <a:cubicBezTo>
                  <a:pt x="269241" y="182082"/>
                  <a:pt x="267124" y="190549"/>
                  <a:pt x="260774" y="194782"/>
                </a:cubicBezTo>
                <a:cubicBezTo>
                  <a:pt x="251408" y="201026"/>
                  <a:pt x="249364" y="201490"/>
                  <a:pt x="241724" y="210657"/>
                </a:cubicBezTo>
                <a:cubicBezTo>
                  <a:pt x="230677" y="223914"/>
                  <a:pt x="241486" y="218145"/>
                  <a:pt x="225849" y="223357"/>
                </a:cubicBezTo>
                <a:cubicBezTo>
                  <a:pt x="223732" y="226532"/>
                  <a:pt x="221206" y="229469"/>
                  <a:pt x="219499" y="232882"/>
                </a:cubicBezTo>
                <a:cubicBezTo>
                  <a:pt x="218002" y="235875"/>
                  <a:pt x="218415" y="239794"/>
                  <a:pt x="216324" y="242407"/>
                </a:cubicBezTo>
                <a:cubicBezTo>
                  <a:pt x="213940" y="245387"/>
                  <a:pt x="209974" y="246640"/>
                  <a:pt x="206799" y="248757"/>
                </a:cubicBezTo>
                <a:lnTo>
                  <a:pt x="181399" y="286857"/>
                </a:lnTo>
                <a:lnTo>
                  <a:pt x="168699" y="305907"/>
                </a:lnTo>
                <a:cubicBezTo>
                  <a:pt x="166582" y="309082"/>
                  <a:pt x="162349" y="310140"/>
                  <a:pt x="159174" y="312257"/>
                </a:cubicBezTo>
                <a:cubicBezTo>
                  <a:pt x="158116" y="315432"/>
                  <a:pt x="158090" y="319169"/>
                  <a:pt x="155999" y="321782"/>
                </a:cubicBezTo>
                <a:cubicBezTo>
                  <a:pt x="153615" y="324762"/>
                  <a:pt x="149405" y="325689"/>
                  <a:pt x="146474" y="328132"/>
                </a:cubicBezTo>
                <a:cubicBezTo>
                  <a:pt x="143025" y="331007"/>
                  <a:pt x="140124" y="334482"/>
                  <a:pt x="136949" y="337657"/>
                </a:cubicBezTo>
                <a:cubicBezTo>
                  <a:pt x="135891" y="340832"/>
                  <a:pt x="135399" y="344256"/>
                  <a:pt x="133774" y="347182"/>
                </a:cubicBezTo>
                <a:cubicBezTo>
                  <a:pt x="130068" y="353853"/>
                  <a:pt x="125307" y="359882"/>
                  <a:pt x="121074" y="366232"/>
                </a:cubicBezTo>
                <a:lnTo>
                  <a:pt x="114724" y="375757"/>
                </a:lnTo>
                <a:lnTo>
                  <a:pt x="95674" y="404332"/>
                </a:lnTo>
                <a:cubicBezTo>
                  <a:pt x="93049" y="408270"/>
                  <a:pt x="91832" y="413018"/>
                  <a:pt x="89324" y="417032"/>
                </a:cubicBezTo>
                <a:cubicBezTo>
                  <a:pt x="86519" y="421519"/>
                  <a:pt x="82974" y="425499"/>
                  <a:pt x="79799" y="429732"/>
                </a:cubicBezTo>
                <a:cubicBezTo>
                  <a:pt x="78741" y="432907"/>
                  <a:pt x="78480" y="436472"/>
                  <a:pt x="76624" y="439257"/>
                </a:cubicBezTo>
                <a:cubicBezTo>
                  <a:pt x="66655" y="454211"/>
                  <a:pt x="67674" y="442725"/>
                  <a:pt x="60749" y="458307"/>
                </a:cubicBezTo>
                <a:cubicBezTo>
                  <a:pt x="58031" y="464424"/>
                  <a:pt x="58112" y="471788"/>
                  <a:pt x="54399" y="477357"/>
                </a:cubicBezTo>
                <a:cubicBezTo>
                  <a:pt x="52282" y="480532"/>
                  <a:pt x="49599" y="483395"/>
                  <a:pt x="48049" y="486882"/>
                </a:cubicBezTo>
                <a:cubicBezTo>
                  <a:pt x="45331" y="492999"/>
                  <a:pt x="45412" y="500363"/>
                  <a:pt x="41699" y="505932"/>
                </a:cubicBezTo>
                <a:cubicBezTo>
                  <a:pt x="39582" y="509107"/>
                  <a:pt x="36899" y="511970"/>
                  <a:pt x="35349" y="515457"/>
                </a:cubicBezTo>
                <a:cubicBezTo>
                  <a:pt x="32631" y="521574"/>
                  <a:pt x="31116" y="528157"/>
                  <a:pt x="28999" y="534507"/>
                </a:cubicBezTo>
                <a:lnTo>
                  <a:pt x="22649" y="553557"/>
                </a:lnTo>
                <a:cubicBezTo>
                  <a:pt x="21591" y="556732"/>
                  <a:pt x="21330" y="560297"/>
                  <a:pt x="19474" y="563082"/>
                </a:cubicBezTo>
                <a:lnTo>
                  <a:pt x="13124" y="572607"/>
                </a:lnTo>
                <a:cubicBezTo>
                  <a:pt x="12066" y="576840"/>
                  <a:pt x="11203" y="581127"/>
                  <a:pt x="9949" y="585307"/>
                </a:cubicBezTo>
                <a:cubicBezTo>
                  <a:pt x="8026" y="591718"/>
                  <a:pt x="3599" y="604357"/>
                  <a:pt x="3599" y="604357"/>
                </a:cubicBezTo>
                <a:cubicBezTo>
                  <a:pt x="-185" y="638411"/>
                  <a:pt x="-2120" y="640526"/>
                  <a:pt x="3599" y="680557"/>
                </a:cubicBezTo>
                <a:cubicBezTo>
                  <a:pt x="6383" y="700045"/>
                  <a:pt x="7101" y="697708"/>
                  <a:pt x="19474" y="705957"/>
                </a:cubicBezTo>
                <a:cubicBezTo>
                  <a:pt x="20532" y="709132"/>
                  <a:pt x="21152" y="712489"/>
                  <a:pt x="22649" y="715482"/>
                </a:cubicBezTo>
                <a:cubicBezTo>
                  <a:pt x="25984" y="722153"/>
                  <a:pt x="32779" y="730064"/>
                  <a:pt x="38524" y="734532"/>
                </a:cubicBezTo>
                <a:cubicBezTo>
                  <a:pt x="44548" y="739217"/>
                  <a:pt x="57574" y="747232"/>
                  <a:pt x="57574" y="747232"/>
                </a:cubicBezTo>
                <a:cubicBezTo>
                  <a:pt x="74507" y="772632"/>
                  <a:pt x="52282" y="741940"/>
                  <a:pt x="73449" y="763107"/>
                </a:cubicBezTo>
                <a:cubicBezTo>
                  <a:pt x="76147" y="765805"/>
                  <a:pt x="77356" y="769701"/>
                  <a:pt x="79799" y="772632"/>
                </a:cubicBezTo>
                <a:cubicBezTo>
                  <a:pt x="82674" y="776081"/>
                  <a:pt x="86567" y="778613"/>
                  <a:pt x="89324" y="782157"/>
                </a:cubicBezTo>
                <a:cubicBezTo>
                  <a:pt x="94009" y="788181"/>
                  <a:pt x="97791" y="794857"/>
                  <a:pt x="102024" y="801207"/>
                </a:cubicBezTo>
                <a:lnTo>
                  <a:pt x="108374" y="810732"/>
                </a:lnTo>
                <a:cubicBezTo>
                  <a:pt x="110865" y="814468"/>
                  <a:pt x="115142" y="816713"/>
                  <a:pt x="117899" y="820257"/>
                </a:cubicBezTo>
                <a:cubicBezTo>
                  <a:pt x="122584" y="826281"/>
                  <a:pt x="126366" y="832957"/>
                  <a:pt x="130599" y="839307"/>
                </a:cubicBezTo>
                <a:lnTo>
                  <a:pt x="143299" y="858357"/>
                </a:lnTo>
                <a:cubicBezTo>
                  <a:pt x="161679" y="885926"/>
                  <a:pt x="125613" y="847021"/>
                  <a:pt x="155999" y="877407"/>
                </a:cubicBezTo>
                <a:cubicBezTo>
                  <a:pt x="163979" y="901348"/>
                  <a:pt x="153214" y="871838"/>
                  <a:pt x="165524" y="896457"/>
                </a:cubicBezTo>
                <a:cubicBezTo>
                  <a:pt x="167021" y="899450"/>
                  <a:pt x="167381" y="902906"/>
                  <a:pt x="168699" y="905982"/>
                </a:cubicBezTo>
                <a:cubicBezTo>
                  <a:pt x="174557" y="919650"/>
                  <a:pt x="178721" y="924189"/>
                  <a:pt x="187749" y="937732"/>
                </a:cubicBezTo>
                <a:cubicBezTo>
                  <a:pt x="189866" y="940907"/>
                  <a:pt x="190924" y="945140"/>
                  <a:pt x="194099" y="947257"/>
                </a:cubicBezTo>
                <a:cubicBezTo>
                  <a:pt x="197274" y="949374"/>
                  <a:pt x="200772" y="951072"/>
                  <a:pt x="203624" y="953607"/>
                </a:cubicBezTo>
                <a:cubicBezTo>
                  <a:pt x="210336" y="959573"/>
                  <a:pt x="215202" y="967676"/>
                  <a:pt x="222674" y="972657"/>
                </a:cubicBezTo>
                <a:cubicBezTo>
                  <a:pt x="244509" y="987213"/>
                  <a:pt x="234484" y="982944"/>
                  <a:pt x="251249" y="988532"/>
                </a:cubicBezTo>
                <a:cubicBezTo>
                  <a:pt x="278546" y="1006730"/>
                  <a:pt x="244009" y="984912"/>
                  <a:pt x="270299" y="998057"/>
                </a:cubicBezTo>
                <a:cubicBezTo>
                  <a:pt x="273712" y="999764"/>
                  <a:pt x="276337" y="1002857"/>
                  <a:pt x="279824" y="1004407"/>
                </a:cubicBezTo>
                <a:cubicBezTo>
                  <a:pt x="285941" y="1007125"/>
                  <a:pt x="298874" y="1010757"/>
                  <a:pt x="298874" y="1010757"/>
                </a:cubicBezTo>
                <a:cubicBezTo>
                  <a:pt x="326171" y="1028955"/>
                  <a:pt x="291634" y="1007137"/>
                  <a:pt x="317924" y="1020282"/>
                </a:cubicBezTo>
                <a:cubicBezTo>
                  <a:pt x="321337" y="1021989"/>
                  <a:pt x="323962" y="1025082"/>
                  <a:pt x="327449" y="1026632"/>
                </a:cubicBezTo>
                <a:cubicBezTo>
                  <a:pt x="333566" y="1029350"/>
                  <a:pt x="340149" y="1030865"/>
                  <a:pt x="346499" y="1032982"/>
                </a:cubicBezTo>
                <a:lnTo>
                  <a:pt x="365549" y="1039332"/>
                </a:lnTo>
                <a:cubicBezTo>
                  <a:pt x="395212" y="1049220"/>
                  <a:pt x="363387" y="1041580"/>
                  <a:pt x="387774" y="1052032"/>
                </a:cubicBezTo>
                <a:cubicBezTo>
                  <a:pt x="391785" y="1053751"/>
                  <a:pt x="396149" y="1054630"/>
                  <a:pt x="400474" y="1055207"/>
                </a:cubicBezTo>
                <a:cubicBezTo>
                  <a:pt x="412061" y="1056752"/>
                  <a:pt x="423789" y="1057016"/>
                  <a:pt x="435399" y="1058382"/>
                </a:cubicBezTo>
                <a:cubicBezTo>
                  <a:pt x="441792" y="1059134"/>
                  <a:pt x="448099" y="1060499"/>
                  <a:pt x="454449" y="1061557"/>
                </a:cubicBezTo>
                <a:lnTo>
                  <a:pt x="502074" y="1077432"/>
                </a:lnTo>
                <a:cubicBezTo>
                  <a:pt x="508181" y="1079468"/>
                  <a:pt x="514774" y="1079549"/>
                  <a:pt x="521124" y="1080607"/>
                </a:cubicBezTo>
                <a:cubicBezTo>
                  <a:pt x="525616" y="1082104"/>
                  <a:pt x="539362" y="1086957"/>
                  <a:pt x="543349" y="1086957"/>
                </a:cubicBezTo>
                <a:cubicBezTo>
                  <a:pt x="556093" y="1086957"/>
                  <a:pt x="568749" y="1084840"/>
                  <a:pt x="581449" y="1083782"/>
                </a:cubicBezTo>
                <a:lnTo>
                  <a:pt x="600499" y="1077432"/>
                </a:lnTo>
                <a:lnTo>
                  <a:pt x="610024" y="1074257"/>
                </a:lnTo>
                <a:cubicBezTo>
                  <a:pt x="616374" y="1070024"/>
                  <a:pt x="621834" y="1063970"/>
                  <a:pt x="629074" y="1061557"/>
                </a:cubicBezTo>
                <a:lnTo>
                  <a:pt x="648124" y="1055207"/>
                </a:lnTo>
                <a:lnTo>
                  <a:pt x="667174" y="1042507"/>
                </a:lnTo>
                <a:cubicBezTo>
                  <a:pt x="670349" y="1040390"/>
                  <a:pt x="673079" y="1037364"/>
                  <a:pt x="676699" y="1036157"/>
                </a:cubicBezTo>
                <a:lnTo>
                  <a:pt x="686224" y="1032982"/>
                </a:lnTo>
                <a:cubicBezTo>
                  <a:pt x="688341" y="1029807"/>
                  <a:pt x="689594" y="1025841"/>
                  <a:pt x="692574" y="1023457"/>
                </a:cubicBezTo>
                <a:cubicBezTo>
                  <a:pt x="708543" y="1010682"/>
                  <a:pt x="702058" y="1039455"/>
                  <a:pt x="714799" y="1001232"/>
                </a:cubicBezTo>
                <a:cubicBezTo>
                  <a:pt x="720387" y="984467"/>
                  <a:pt x="716118" y="994492"/>
                  <a:pt x="730674" y="972657"/>
                </a:cubicBezTo>
                <a:cubicBezTo>
                  <a:pt x="732791" y="969482"/>
                  <a:pt x="735817" y="966752"/>
                  <a:pt x="737024" y="963132"/>
                </a:cubicBezTo>
                <a:cubicBezTo>
                  <a:pt x="748603" y="928394"/>
                  <a:pt x="730136" y="981011"/>
                  <a:pt x="746549" y="944082"/>
                </a:cubicBezTo>
                <a:cubicBezTo>
                  <a:pt x="761662" y="910077"/>
                  <a:pt x="744878" y="937063"/>
                  <a:pt x="759249" y="915507"/>
                </a:cubicBezTo>
                <a:cubicBezTo>
                  <a:pt x="760307" y="910215"/>
                  <a:pt x="761603" y="904966"/>
                  <a:pt x="762424" y="899632"/>
                </a:cubicBezTo>
                <a:cubicBezTo>
                  <a:pt x="765883" y="877151"/>
                  <a:pt x="766828" y="859489"/>
                  <a:pt x="768774" y="836132"/>
                </a:cubicBezTo>
                <a:cubicBezTo>
                  <a:pt x="767716" y="809674"/>
                  <a:pt x="767421" y="783174"/>
                  <a:pt x="765599" y="756757"/>
                </a:cubicBezTo>
                <a:cubicBezTo>
                  <a:pt x="765299" y="752404"/>
                  <a:pt x="763280" y="748336"/>
                  <a:pt x="762424" y="744057"/>
                </a:cubicBezTo>
                <a:cubicBezTo>
                  <a:pt x="756011" y="711991"/>
                  <a:pt x="763507" y="737782"/>
                  <a:pt x="752899" y="705957"/>
                </a:cubicBezTo>
                <a:lnTo>
                  <a:pt x="749724" y="696432"/>
                </a:lnTo>
                <a:cubicBezTo>
                  <a:pt x="748666" y="686907"/>
                  <a:pt x="748429" y="677255"/>
                  <a:pt x="746549" y="667857"/>
                </a:cubicBezTo>
                <a:cubicBezTo>
                  <a:pt x="745236" y="661293"/>
                  <a:pt x="742316" y="655157"/>
                  <a:pt x="740199" y="648807"/>
                </a:cubicBezTo>
                <a:cubicBezTo>
                  <a:pt x="735527" y="634792"/>
                  <a:pt x="738521" y="642275"/>
                  <a:pt x="730674" y="626582"/>
                </a:cubicBezTo>
                <a:cubicBezTo>
                  <a:pt x="729616" y="621290"/>
                  <a:pt x="728808" y="615942"/>
                  <a:pt x="727499" y="610707"/>
                </a:cubicBezTo>
                <a:cubicBezTo>
                  <a:pt x="726687" y="607460"/>
                  <a:pt x="724715" y="604506"/>
                  <a:pt x="724324" y="601182"/>
                </a:cubicBezTo>
                <a:cubicBezTo>
                  <a:pt x="722588" y="586429"/>
                  <a:pt x="722207" y="571549"/>
                  <a:pt x="721149" y="556732"/>
                </a:cubicBezTo>
                <a:cubicBezTo>
                  <a:pt x="724695" y="492899"/>
                  <a:pt x="718291" y="517682"/>
                  <a:pt x="730674" y="480532"/>
                </a:cubicBezTo>
                <a:cubicBezTo>
                  <a:pt x="731881" y="476912"/>
                  <a:pt x="734907" y="474182"/>
                  <a:pt x="737024" y="471007"/>
                </a:cubicBezTo>
                <a:cubicBezTo>
                  <a:pt x="741691" y="415003"/>
                  <a:pt x="741965" y="430818"/>
                  <a:pt x="737024" y="356707"/>
                </a:cubicBezTo>
                <a:cubicBezTo>
                  <a:pt x="735778" y="338023"/>
                  <a:pt x="734596" y="341858"/>
                  <a:pt x="730674" y="328132"/>
                </a:cubicBezTo>
                <a:cubicBezTo>
                  <a:pt x="729475" y="323936"/>
                  <a:pt x="728557" y="319665"/>
                  <a:pt x="727499" y="315432"/>
                </a:cubicBezTo>
                <a:cubicBezTo>
                  <a:pt x="722393" y="264368"/>
                  <a:pt x="728190" y="298802"/>
                  <a:pt x="721149" y="274157"/>
                </a:cubicBezTo>
                <a:cubicBezTo>
                  <a:pt x="719950" y="269961"/>
                  <a:pt x="719693" y="265468"/>
                  <a:pt x="717974" y="261457"/>
                </a:cubicBezTo>
                <a:cubicBezTo>
                  <a:pt x="716471" y="257950"/>
                  <a:pt x="713517" y="255245"/>
                  <a:pt x="711624" y="251932"/>
                </a:cubicBezTo>
                <a:cubicBezTo>
                  <a:pt x="704943" y="240240"/>
                  <a:pt x="702930" y="230538"/>
                  <a:pt x="692574" y="220182"/>
                </a:cubicBezTo>
                <a:cubicBezTo>
                  <a:pt x="680351" y="207959"/>
                  <a:pt x="685540" y="214393"/>
                  <a:pt x="676699" y="201132"/>
                </a:cubicBezTo>
                <a:cubicBezTo>
                  <a:pt x="675682" y="197063"/>
                  <a:pt x="672626" y="183462"/>
                  <a:pt x="670349" y="178907"/>
                </a:cubicBezTo>
                <a:cubicBezTo>
                  <a:pt x="668642" y="175494"/>
                  <a:pt x="665549" y="172869"/>
                  <a:pt x="663999" y="169382"/>
                </a:cubicBezTo>
                <a:cubicBezTo>
                  <a:pt x="661281" y="163265"/>
                  <a:pt x="661362" y="155901"/>
                  <a:pt x="657649" y="150332"/>
                </a:cubicBezTo>
                <a:cubicBezTo>
                  <a:pt x="655532" y="147157"/>
                  <a:pt x="653006" y="144220"/>
                  <a:pt x="651299" y="140807"/>
                </a:cubicBezTo>
                <a:cubicBezTo>
                  <a:pt x="646134" y="130478"/>
                  <a:pt x="650873" y="130856"/>
                  <a:pt x="641774" y="121757"/>
                </a:cubicBezTo>
                <a:cubicBezTo>
                  <a:pt x="639076" y="119059"/>
                  <a:pt x="635424" y="117524"/>
                  <a:pt x="632249" y="115407"/>
                </a:cubicBezTo>
                <a:cubicBezTo>
                  <a:pt x="625099" y="93957"/>
                  <a:pt x="635015" y="117207"/>
                  <a:pt x="619549" y="99532"/>
                </a:cubicBezTo>
                <a:cubicBezTo>
                  <a:pt x="614523" y="93789"/>
                  <a:pt x="613199" y="84715"/>
                  <a:pt x="606849" y="80482"/>
                </a:cubicBezTo>
                <a:lnTo>
                  <a:pt x="578274" y="61432"/>
                </a:lnTo>
                <a:cubicBezTo>
                  <a:pt x="575099" y="59315"/>
                  <a:pt x="571447" y="57780"/>
                  <a:pt x="568749" y="55082"/>
                </a:cubicBezTo>
                <a:cubicBezTo>
                  <a:pt x="556857" y="43190"/>
                  <a:pt x="563484" y="46977"/>
                  <a:pt x="549699" y="42382"/>
                </a:cubicBezTo>
                <a:cubicBezTo>
                  <a:pt x="546524" y="40265"/>
                  <a:pt x="543587" y="37739"/>
                  <a:pt x="540174" y="36032"/>
                </a:cubicBezTo>
                <a:cubicBezTo>
                  <a:pt x="537181" y="34535"/>
                  <a:pt x="533575" y="34482"/>
                  <a:pt x="530649" y="32857"/>
                </a:cubicBezTo>
                <a:cubicBezTo>
                  <a:pt x="523978" y="29151"/>
                  <a:pt x="519003" y="22008"/>
                  <a:pt x="511599" y="20157"/>
                </a:cubicBezTo>
                <a:cubicBezTo>
                  <a:pt x="479012" y="12010"/>
                  <a:pt x="493078" y="3753"/>
                  <a:pt x="486199" y="1107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0" name="フリーフォーム 69"/>
          <p:cNvSpPr/>
          <p:nvPr/>
        </p:nvSpPr>
        <p:spPr>
          <a:xfrm>
            <a:off x="1991834" y="3520742"/>
            <a:ext cx="768774" cy="1086957"/>
          </a:xfrm>
          <a:custGeom>
            <a:avLst/>
            <a:gdLst>
              <a:gd name="connsiteX0" fmla="*/ 486199 w 768774"/>
              <a:gd name="connsiteY0" fmla="*/ 1107 h 1086957"/>
              <a:gd name="connsiteX1" fmla="*/ 470324 w 768774"/>
              <a:gd name="connsiteY1" fmla="*/ 4282 h 1086957"/>
              <a:gd name="connsiteX2" fmla="*/ 457624 w 768774"/>
              <a:gd name="connsiteY2" fmla="*/ 23332 h 1086957"/>
              <a:gd name="connsiteX3" fmla="*/ 444924 w 768774"/>
              <a:gd name="connsiteY3" fmla="*/ 42382 h 1086957"/>
              <a:gd name="connsiteX4" fmla="*/ 441749 w 768774"/>
              <a:gd name="connsiteY4" fmla="*/ 51907 h 1086957"/>
              <a:gd name="connsiteX5" fmla="*/ 425874 w 768774"/>
              <a:gd name="connsiteY5" fmla="*/ 70957 h 1086957"/>
              <a:gd name="connsiteX6" fmla="*/ 416349 w 768774"/>
              <a:gd name="connsiteY6" fmla="*/ 90007 h 1086957"/>
              <a:gd name="connsiteX7" fmla="*/ 406824 w 768774"/>
              <a:gd name="connsiteY7" fmla="*/ 96357 h 1086957"/>
              <a:gd name="connsiteX8" fmla="*/ 400474 w 768774"/>
              <a:gd name="connsiteY8" fmla="*/ 105882 h 1086957"/>
              <a:gd name="connsiteX9" fmla="*/ 381424 w 768774"/>
              <a:gd name="connsiteY9" fmla="*/ 112232 h 1086957"/>
              <a:gd name="connsiteX10" fmla="*/ 362374 w 768774"/>
              <a:gd name="connsiteY10" fmla="*/ 124932 h 1086957"/>
              <a:gd name="connsiteX11" fmla="*/ 352849 w 768774"/>
              <a:gd name="connsiteY11" fmla="*/ 131282 h 1086957"/>
              <a:gd name="connsiteX12" fmla="*/ 340149 w 768774"/>
              <a:gd name="connsiteY12" fmla="*/ 134457 h 1086957"/>
              <a:gd name="connsiteX13" fmla="*/ 311574 w 768774"/>
              <a:gd name="connsiteY13" fmla="*/ 153507 h 1086957"/>
              <a:gd name="connsiteX14" fmla="*/ 302049 w 768774"/>
              <a:gd name="connsiteY14" fmla="*/ 156682 h 1086957"/>
              <a:gd name="connsiteX15" fmla="*/ 292524 w 768774"/>
              <a:gd name="connsiteY15" fmla="*/ 163032 h 1086957"/>
              <a:gd name="connsiteX16" fmla="*/ 282999 w 768774"/>
              <a:gd name="connsiteY16" fmla="*/ 172557 h 1086957"/>
              <a:gd name="connsiteX17" fmla="*/ 273474 w 768774"/>
              <a:gd name="connsiteY17" fmla="*/ 175732 h 1086957"/>
              <a:gd name="connsiteX18" fmla="*/ 260774 w 768774"/>
              <a:gd name="connsiteY18" fmla="*/ 194782 h 1086957"/>
              <a:gd name="connsiteX19" fmla="*/ 241724 w 768774"/>
              <a:gd name="connsiteY19" fmla="*/ 210657 h 1086957"/>
              <a:gd name="connsiteX20" fmla="*/ 225849 w 768774"/>
              <a:gd name="connsiteY20" fmla="*/ 223357 h 1086957"/>
              <a:gd name="connsiteX21" fmla="*/ 219499 w 768774"/>
              <a:gd name="connsiteY21" fmla="*/ 232882 h 1086957"/>
              <a:gd name="connsiteX22" fmla="*/ 216324 w 768774"/>
              <a:gd name="connsiteY22" fmla="*/ 242407 h 1086957"/>
              <a:gd name="connsiteX23" fmla="*/ 206799 w 768774"/>
              <a:gd name="connsiteY23" fmla="*/ 248757 h 1086957"/>
              <a:gd name="connsiteX24" fmla="*/ 181399 w 768774"/>
              <a:gd name="connsiteY24" fmla="*/ 286857 h 1086957"/>
              <a:gd name="connsiteX25" fmla="*/ 168699 w 768774"/>
              <a:gd name="connsiteY25" fmla="*/ 305907 h 1086957"/>
              <a:gd name="connsiteX26" fmla="*/ 159174 w 768774"/>
              <a:gd name="connsiteY26" fmla="*/ 312257 h 1086957"/>
              <a:gd name="connsiteX27" fmla="*/ 155999 w 768774"/>
              <a:gd name="connsiteY27" fmla="*/ 321782 h 1086957"/>
              <a:gd name="connsiteX28" fmla="*/ 146474 w 768774"/>
              <a:gd name="connsiteY28" fmla="*/ 328132 h 1086957"/>
              <a:gd name="connsiteX29" fmla="*/ 136949 w 768774"/>
              <a:gd name="connsiteY29" fmla="*/ 337657 h 1086957"/>
              <a:gd name="connsiteX30" fmla="*/ 133774 w 768774"/>
              <a:gd name="connsiteY30" fmla="*/ 347182 h 1086957"/>
              <a:gd name="connsiteX31" fmla="*/ 121074 w 768774"/>
              <a:gd name="connsiteY31" fmla="*/ 366232 h 1086957"/>
              <a:gd name="connsiteX32" fmla="*/ 114724 w 768774"/>
              <a:gd name="connsiteY32" fmla="*/ 375757 h 1086957"/>
              <a:gd name="connsiteX33" fmla="*/ 95674 w 768774"/>
              <a:gd name="connsiteY33" fmla="*/ 404332 h 1086957"/>
              <a:gd name="connsiteX34" fmla="*/ 89324 w 768774"/>
              <a:gd name="connsiteY34" fmla="*/ 417032 h 1086957"/>
              <a:gd name="connsiteX35" fmla="*/ 79799 w 768774"/>
              <a:gd name="connsiteY35" fmla="*/ 429732 h 1086957"/>
              <a:gd name="connsiteX36" fmla="*/ 76624 w 768774"/>
              <a:gd name="connsiteY36" fmla="*/ 439257 h 1086957"/>
              <a:gd name="connsiteX37" fmla="*/ 60749 w 768774"/>
              <a:gd name="connsiteY37" fmla="*/ 458307 h 1086957"/>
              <a:gd name="connsiteX38" fmla="*/ 54399 w 768774"/>
              <a:gd name="connsiteY38" fmla="*/ 477357 h 1086957"/>
              <a:gd name="connsiteX39" fmla="*/ 48049 w 768774"/>
              <a:gd name="connsiteY39" fmla="*/ 486882 h 1086957"/>
              <a:gd name="connsiteX40" fmla="*/ 41699 w 768774"/>
              <a:gd name="connsiteY40" fmla="*/ 505932 h 1086957"/>
              <a:gd name="connsiteX41" fmla="*/ 35349 w 768774"/>
              <a:gd name="connsiteY41" fmla="*/ 515457 h 1086957"/>
              <a:gd name="connsiteX42" fmla="*/ 28999 w 768774"/>
              <a:gd name="connsiteY42" fmla="*/ 534507 h 1086957"/>
              <a:gd name="connsiteX43" fmla="*/ 22649 w 768774"/>
              <a:gd name="connsiteY43" fmla="*/ 553557 h 1086957"/>
              <a:gd name="connsiteX44" fmla="*/ 19474 w 768774"/>
              <a:gd name="connsiteY44" fmla="*/ 563082 h 1086957"/>
              <a:gd name="connsiteX45" fmla="*/ 13124 w 768774"/>
              <a:gd name="connsiteY45" fmla="*/ 572607 h 1086957"/>
              <a:gd name="connsiteX46" fmla="*/ 9949 w 768774"/>
              <a:gd name="connsiteY46" fmla="*/ 585307 h 1086957"/>
              <a:gd name="connsiteX47" fmla="*/ 3599 w 768774"/>
              <a:gd name="connsiteY47" fmla="*/ 604357 h 1086957"/>
              <a:gd name="connsiteX48" fmla="*/ 3599 w 768774"/>
              <a:gd name="connsiteY48" fmla="*/ 680557 h 1086957"/>
              <a:gd name="connsiteX49" fmla="*/ 19474 w 768774"/>
              <a:gd name="connsiteY49" fmla="*/ 705957 h 1086957"/>
              <a:gd name="connsiteX50" fmla="*/ 22649 w 768774"/>
              <a:gd name="connsiteY50" fmla="*/ 715482 h 1086957"/>
              <a:gd name="connsiteX51" fmla="*/ 38524 w 768774"/>
              <a:gd name="connsiteY51" fmla="*/ 734532 h 1086957"/>
              <a:gd name="connsiteX52" fmla="*/ 57574 w 768774"/>
              <a:gd name="connsiteY52" fmla="*/ 747232 h 1086957"/>
              <a:gd name="connsiteX53" fmla="*/ 73449 w 768774"/>
              <a:gd name="connsiteY53" fmla="*/ 763107 h 1086957"/>
              <a:gd name="connsiteX54" fmla="*/ 79799 w 768774"/>
              <a:gd name="connsiteY54" fmla="*/ 772632 h 1086957"/>
              <a:gd name="connsiteX55" fmla="*/ 89324 w 768774"/>
              <a:gd name="connsiteY55" fmla="*/ 782157 h 1086957"/>
              <a:gd name="connsiteX56" fmla="*/ 102024 w 768774"/>
              <a:gd name="connsiteY56" fmla="*/ 801207 h 1086957"/>
              <a:gd name="connsiteX57" fmla="*/ 108374 w 768774"/>
              <a:gd name="connsiteY57" fmla="*/ 810732 h 1086957"/>
              <a:gd name="connsiteX58" fmla="*/ 117899 w 768774"/>
              <a:gd name="connsiteY58" fmla="*/ 820257 h 1086957"/>
              <a:gd name="connsiteX59" fmla="*/ 130599 w 768774"/>
              <a:gd name="connsiteY59" fmla="*/ 839307 h 1086957"/>
              <a:gd name="connsiteX60" fmla="*/ 143299 w 768774"/>
              <a:gd name="connsiteY60" fmla="*/ 858357 h 1086957"/>
              <a:gd name="connsiteX61" fmla="*/ 155999 w 768774"/>
              <a:gd name="connsiteY61" fmla="*/ 877407 h 1086957"/>
              <a:gd name="connsiteX62" fmla="*/ 165524 w 768774"/>
              <a:gd name="connsiteY62" fmla="*/ 896457 h 1086957"/>
              <a:gd name="connsiteX63" fmla="*/ 168699 w 768774"/>
              <a:gd name="connsiteY63" fmla="*/ 905982 h 1086957"/>
              <a:gd name="connsiteX64" fmla="*/ 187749 w 768774"/>
              <a:gd name="connsiteY64" fmla="*/ 937732 h 1086957"/>
              <a:gd name="connsiteX65" fmla="*/ 194099 w 768774"/>
              <a:gd name="connsiteY65" fmla="*/ 947257 h 1086957"/>
              <a:gd name="connsiteX66" fmla="*/ 203624 w 768774"/>
              <a:gd name="connsiteY66" fmla="*/ 953607 h 1086957"/>
              <a:gd name="connsiteX67" fmla="*/ 222674 w 768774"/>
              <a:gd name="connsiteY67" fmla="*/ 972657 h 1086957"/>
              <a:gd name="connsiteX68" fmla="*/ 251249 w 768774"/>
              <a:gd name="connsiteY68" fmla="*/ 988532 h 1086957"/>
              <a:gd name="connsiteX69" fmla="*/ 270299 w 768774"/>
              <a:gd name="connsiteY69" fmla="*/ 998057 h 1086957"/>
              <a:gd name="connsiteX70" fmla="*/ 279824 w 768774"/>
              <a:gd name="connsiteY70" fmla="*/ 1004407 h 1086957"/>
              <a:gd name="connsiteX71" fmla="*/ 298874 w 768774"/>
              <a:gd name="connsiteY71" fmla="*/ 1010757 h 1086957"/>
              <a:gd name="connsiteX72" fmla="*/ 317924 w 768774"/>
              <a:gd name="connsiteY72" fmla="*/ 1020282 h 1086957"/>
              <a:gd name="connsiteX73" fmla="*/ 327449 w 768774"/>
              <a:gd name="connsiteY73" fmla="*/ 1026632 h 1086957"/>
              <a:gd name="connsiteX74" fmla="*/ 346499 w 768774"/>
              <a:gd name="connsiteY74" fmla="*/ 1032982 h 1086957"/>
              <a:gd name="connsiteX75" fmla="*/ 365549 w 768774"/>
              <a:gd name="connsiteY75" fmla="*/ 1039332 h 1086957"/>
              <a:gd name="connsiteX76" fmla="*/ 387774 w 768774"/>
              <a:gd name="connsiteY76" fmla="*/ 1052032 h 1086957"/>
              <a:gd name="connsiteX77" fmla="*/ 400474 w 768774"/>
              <a:gd name="connsiteY77" fmla="*/ 1055207 h 1086957"/>
              <a:gd name="connsiteX78" fmla="*/ 435399 w 768774"/>
              <a:gd name="connsiteY78" fmla="*/ 1058382 h 1086957"/>
              <a:gd name="connsiteX79" fmla="*/ 454449 w 768774"/>
              <a:gd name="connsiteY79" fmla="*/ 1061557 h 1086957"/>
              <a:gd name="connsiteX80" fmla="*/ 502074 w 768774"/>
              <a:gd name="connsiteY80" fmla="*/ 1077432 h 1086957"/>
              <a:gd name="connsiteX81" fmla="*/ 521124 w 768774"/>
              <a:gd name="connsiteY81" fmla="*/ 1080607 h 1086957"/>
              <a:gd name="connsiteX82" fmla="*/ 543349 w 768774"/>
              <a:gd name="connsiteY82" fmla="*/ 1086957 h 1086957"/>
              <a:gd name="connsiteX83" fmla="*/ 581449 w 768774"/>
              <a:gd name="connsiteY83" fmla="*/ 1083782 h 1086957"/>
              <a:gd name="connsiteX84" fmla="*/ 600499 w 768774"/>
              <a:gd name="connsiteY84" fmla="*/ 1077432 h 1086957"/>
              <a:gd name="connsiteX85" fmla="*/ 610024 w 768774"/>
              <a:gd name="connsiteY85" fmla="*/ 1074257 h 1086957"/>
              <a:gd name="connsiteX86" fmla="*/ 629074 w 768774"/>
              <a:gd name="connsiteY86" fmla="*/ 1061557 h 1086957"/>
              <a:gd name="connsiteX87" fmla="*/ 648124 w 768774"/>
              <a:gd name="connsiteY87" fmla="*/ 1055207 h 1086957"/>
              <a:gd name="connsiteX88" fmla="*/ 667174 w 768774"/>
              <a:gd name="connsiteY88" fmla="*/ 1042507 h 1086957"/>
              <a:gd name="connsiteX89" fmla="*/ 676699 w 768774"/>
              <a:gd name="connsiteY89" fmla="*/ 1036157 h 1086957"/>
              <a:gd name="connsiteX90" fmla="*/ 686224 w 768774"/>
              <a:gd name="connsiteY90" fmla="*/ 1032982 h 1086957"/>
              <a:gd name="connsiteX91" fmla="*/ 692574 w 768774"/>
              <a:gd name="connsiteY91" fmla="*/ 1023457 h 1086957"/>
              <a:gd name="connsiteX92" fmla="*/ 714799 w 768774"/>
              <a:gd name="connsiteY92" fmla="*/ 1001232 h 1086957"/>
              <a:gd name="connsiteX93" fmla="*/ 730674 w 768774"/>
              <a:gd name="connsiteY93" fmla="*/ 972657 h 1086957"/>
              <a:gd name="connsiteX94" fmla="*/ 737024 w 768774"/>
              <a:gd name="connsiteY94" fmla="*/ 963132 h 1086957"/>
              <a:gd name="connsiteX95" fmla="*/ 746549 w 768774"/>
              <a:gd name="connsiteY95" fmla="*/ 944082 h 1086957"/>
              <a:gd name="connsiteX96" fmla="*/ 759249 w 768774"/>
              <a:gd name="connsiteY96" fmla="*/ 915507 h 1086957"/>
              <a:gd name="connsiteX97" fmla="*/ 762424 w 768774"/>
              <a:gd name="connsiteY97" fmla="*/ 899632 h 1086957"/>
              <a:gd name="connsiteX98" fmla="*/ 768774 w 768774"/>
              <a:gd name="connsiteY98" fmla="*/ 836132 h 1086957"/>
              <a:gd name="connsiteX99" fmla="*/ 765599 w 768774"/>
              <a:gd name="connsiteY99" fmla="*/ 756757 h 1086957"/>
              <a:gd name="connsiteX100" fmla="*/ 762424 w 768774"/>
              <a:gd name="connsiteY100" fmla="*/ 744057 h 1086957"/>
              <a:gd name="connsiteX101" fmla="*/ 752899 w 768774"/>
              <a:gd name="connsiteY101" fmla="*/ 705957 h 1086957"/>
              <a:gd name="connsiteX102" fmla="*/ 749724 w 768774"/>
              <a:gd name="connsiteY102" fmla="*/ 696432 h 1086957"/>
              <a:gd name="connsiteX103" fmla="*/ 746549 w 768774"/>
              <a:gd name="connsiteY103" fmla="*/ 667857 h 1086957"/>
              <a:gd name="connsiteX104" fmla="*/ 740199 w 768774"/>
              <a:gd name="connsiteY104" fmla="*/ 648807 h 1086957"/>
              <a:gd name="connsiteX105" fmla="*/ 730674 w 768774"/>
              <a:gd name="connsiteY105" fmla="*/ 626582 h 1086957"/>
              <a:gd name="connsiteX106" fmla="*/ 727499 w 768774"/>
              <a:gd name="connsiteY106" fmla="*/ 610707 h 1086957"/>
              <a:gd name="connsiteX107" fmla="*/ 724324 w 768774"/>
              <a:gd name="connsiteY107" fmla="*/ 601182 h 1086957"/>
              <a:gd name="connsiteX108" fmla="*/ 721149 w 768774"/>
              <a:gd name="connsiteY108" fmla="*/ 556732 h 1086957"/>
              <a:gd name="connsiteX109" fmla="*/ 730674 w 768774"/>
              <a:gd name="connsiteY109" fmla="*/ 480532 h 1086957"/>
              <a:gd name="connsiteX110" fmla="*/ 737024 w 768774"/>
              <a:gd name="connsiteY110" fmla="*/ 471007 h 1086957"/>
              <a:gd name="connsiteX111" fmla="*/ 737024 w 768774"/>
              <a:gd name="connsiteY111" fmla="*/ 356707 h 1086957"/>
              <a:gd name="connsiteX112" fmla="*/ 730674 w 768774"/>
              <a:gd name="connsiteY112" fmla="*/ 328132 h 1086957"/>
              <a:gd name="connsiteX113" fmla="*/ 727499 w 768774"/>
              <a:gd name="connsiteY113" fmla="*/ 315432 h 1086957"/>
              <a:gd name="connsiteX114" fmla="*/ 721149 w 768774"/>
              <a:gd name="connsiteY114" fmla="*/ 274157 h 1086957"/>
              <a:gd name="connsiteX115" fmla="*/ 717974 w 768774"/>
              <a:gd name="connsiteY115" fmla="*/ 261457 h 1086957"/>
              <a:gd name="connsiteX116" fmla="*/ 711624 w 768774"/>
              <a:gd name="connsiteY116" fmla="*/ 251932 h 1086957"/>
              <a:gd name="connsiteX117" fmla="*/ 692574 w 768774"/>
              <a:gd name="connsiteY117" fmla="*/ 220182 h 1086957"/>
              <a:gd name="connsiteX118" fmla="*/ 676699 w 768774"/>
              <a:gd name="connsiteY118" fmla="*/ 201132 h 1086957"/>
              <a:gd name="connsiteX119" fmla="*/ 670349 w 768774"/>
              <a:gd name="connsiteY119" fmla="*/ 178907 h 1086957"/>
              <a:gd name="connsiteX120" fmla="*/ 663999 w 768774"/>
              <a:gd name="connsiteY120" fmla="*/ 169382 h 1086957"/>
              <a:gd name="connsiteX121" fmla="*/ 657649 w 768774"/>
              <a:gd name="connsiteY121" fmla="*/ 150332 h 1086957"/>
              <a:gd name="connsiteX122" fmla="*/ 651299 w 768774"/>
              <a:gd name="connsiteY122" fmla="*/ 140807 h 1086957"/>
              <a:gd name="connsiteX123" fmla="*/ 641774 w 768774"/>
              <a:gd name="connsiteY123" fmla="*/ 121757 h 1086957"/>
              <a:gd name="connsiteX124" fmla="*/ 632249 w 768774"/>
              <a:gd name="connsiteY124" fmla="*/ 115407 h 1086957"/>
              <a:gd name="connsiteX125" fmla="*/ 619549 w 768774"/>
              <a:gd name="connsiteY125" fmla="*/ 99532 h 1086957"/>
              <a:gd name="connsiteX126" fmla="*/ 606849 w 768774"/>
              <a:gd name="connsiteY126" fmla="*/ 80482 h 1086957"/>
              <a:gd name="connsiteX127" fmla="*/ 578274 w 768774"/>
              <a:gd name="connsiteY127" fmla="*/ 61432 h 1086957"/>
              <a:gd name="connsiteX128" fmla="*/ 568749 w 768774"/>
              <a:gd name="connsiteY128" fmla="*/ 55082 h 1086957"/>
              <a:gd name="connsiteX129" fmla="*/ 549699 w 768774"/>
              <a:gd name="connsiteY129" fmla="*/ 42382 h 1086957"/>
              <a:gd name="connsiteX130" fmla="*/ 540174 w 768774"/>
              <a:gd name="connsiteY130" fmla="*/ 36032 h 1086957"/>
              <a:gd name="connsiteX131" fmla="*/ 530649 w 768774"/>
              <a:gd name="connsiteY131" fmla="*/ 32857 h 1086957"/>
              <a:gd name="connsiteX132" fmla="*/ 511599 w 768774"/>
              <a:gd name="connsiteY132" fmla="*/ 20157 h 1086957"/>
              <a:gd name="connsiteX133" fmla="*/ 486199 w 768774"/>
              <a:gd name="connsiteY133" fmla="*/ 1107 h 108695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</a:cxnLst>
            <a:rect l="l" t="t" r="r" b="b"/>
            <a:pathLst>
              <a:path w="768774" h="1086957">
                <a:moveTo>
                  <a:pt x="486199" y="1107"/>
                </a:moveTo>
                <a:cubicBezTo>
                  <a:pt x="479320" y="-1539"/>
                  <a:pt x="474584" y="969"/>
                  <a:pt x="470324" y="4282"/>
                </a:cubicBezTo>
                <a:cubicBezTo>
                  <a:pt x="464300" y="8967"/>
                  <a:pt x="461857" y="16982"/>
                  <a:pt x="457624" y="23332"/>
                </a:cubicBezTo>
                <a:lnTo>
                  <a:pt x="444924" y="42382"/>
                </a:lnTo>
                <a:cubicBezTo>
                  <a:pt x="443068" y="45167"/>
                  <a:pt x="443605" y="49122"/>
                  <a:pt x="441749" y="51907"/>
                </a:cubicBezTo>
                <a:cubicBezTo>
                  <a:pt x="427705" y="72973"/>
                  <a:pt x="436262" y="50182"/>
                  <a:pt x="425874" y="70957"/>
                </a:cubicBezTo>
                <a:cubicBezTo>
                  <a:pt x="420709" y="81286"/>
                  <a:pt x="425448" y="80908"/>
                  <a:pt x="416349" y="90007"/>
                </a:cubicBezTo>
                <a:cubicBezTo>
                  <a:pt x="413651" y="92705"/>
                  <a:pt x="409999" y="94240"/>
                  <a:pt x="406824" y="96357"/>
                </a:cubicBezTo>
                <a:cubicBezTo>
                  <a:pt x="404707" y="99532"/>
                  <a:pt x="403710" y="103860"/>
                  <a:pt x="400474" y="105882"/>
                </a:cubicBezTo>
                <a:cubicBezTo>
                  <a:pt x="394798" y="109430"/>
                  <a:pt x="381424" y="112232"/>
                  <a:pt x="381424" y="112232"/>
                </a:cubicBezTo>
                <a:lnTo>
                  <a:pt x="362374" y="124932"/>
                </a:lnTo>
                <a:cubicBezTo>
                  <a:pt x="359199" y="127049"/>
                  <a:pt x="356551" y="130357"/>
                  <a:pt x="352849" y="131282"/>
                </a:cubicBezTo>
                <a:lnTo>
                  <a:pt x="340149" y="134457"/>
                </a:lnTo>
                <a:lnTo>
                  <a:pt x="311574" y="153507"/>
                </a:lnTo>
                <a:cubicBezTo>
                  <a:pt x="308789" y="155363"/>
                  <a:pt x="305224" y="155624"/>
                  <a:pt x="302049" y="156682"/>
                </a:cubicBezTo>
                <a:cubicBezTo>
                  <a:pt x="298874" y="158799"/>
                  <a:pt x="295455" y="160589"/>
                  <a:pt x="292524" y="163032"/>
                </a:cubicBezTo>
                <a:cubicBezTo>
                  <a:pt x="289075" y="165907"/>
                  <a:pt x="286735" y="170066"/>
                  <a:pt x="282999" y="172557"/>
                </a:cubicBezTo>
                <a:cubicBezTo>
                  <a:pt x="280214" y="174413"/>
                  <a:pt x="276649" y="174674"/>
                  <a:pt x="273474" y="175732"/>
                </a:cubicBezTo>
                <a:cubicBezTo>
                  <a:pt x="269241" y="182082"/>
                  <a:pt x="267124" y="190549"/>
                  <a:pt x="260774" y="194782"/>
                </a:cubicBezTo>
                <a:cubicBezTo>
                  <a:pt x="251408" y="201026"/>
                  <a:pt x="249364" y="201490"/>
                  <a:pt x="241724" y="210657"/>
                </a:cubicBezTo>
                <a:cubicBezTo>
                  <a:pt x="230677" y="223914"/>
                  <a:pt x="241486" y="218145"/>
                  <a:pt x="225849" y="223357"/>
                </a:cubicBezTo>
                <a:cubicBezTo>
                  <a:pt x="223732" y="226532"/>
                  <a:pt x="221206" y="229469"/>
                  <a:pt x="219499" y="232882"/>
                </a:cubicBezTo>
                <a:cubicBezTo>
                  <a:pt x="218002" y="235875"/>
                  <a:pt x="218415" y="239794"/>
                  <a:pt x="216324" y="242407"/>
                </a:cubicBezTo>
                <a:cubicBezTo>
                  <a:pt x="213940" y="245387"/>
                  <a:pt x="209974" y="246640"/>
                  <a:pt x="206799" y="248757"/>
                </a:cubicBezTo>
                <a:lnTo>
                  <a:pt x="181399" y="286857"/>
                </a:lnTo>
                <a:lnTo>
                  <a:pt x="168699" y="305907"/>
                </a:lnTo>
                <a:cubicBezTo>
                  <a:pt x="166582" y="309082"/>
                  <a:pt x="162349" y="310140"/>
                  <a:pt x="159174" y="312257"/>
                </a:cubicBezTo>
                <a:cubicBezTo>
                  <a:pt x="158116" y="315432"/>
                  <a:pt x="158090" y="319169"/>
                  <a:pt x="155999" y="321782"/>
                </a:cubicBezTo>
                <a:cubicBezTo>
                  <a:pt x="153615" y="324762"/>
                  <a:pt x="149405" y="325689"/>
                  <a:pt x="146474" y="328132"/>
                </a:cubicBezTo>
                <a:cubicBezTo>
                  <a:pt x="143025" y="331007"/>
                  <a:pt x="140124" y="334482"/>
                  <a:pt x="136949" y="337657"/>
                </a:cubicBezTo>
                <a:cubicBezTo>
                  <a:pt x="135891" y="340832"/>
                  <a:pt x="135399" y="344256"/>
                  <a:pt x="133774" y="347182"/>
                </a:cubicBezTo>
                <a:cubicBezTo>
                  <a:pt x="130068" y="353853"/>
                  <a:pt x="125307" y="359882"/>
                  <a:pt x="121074" y="366232"/>
                </a:cubicBezTo>
                <a:lnTo>
                  <a:pt x="114724" y="375757"/>
                </a:lnTo>
                <a:lnTo>
                  <a:pt x="95674" y="404332"/>
                </a:lnTo>
                <a:cubicBezTo>
                  <a:pt x="93049" y="408270"/>
                  <a:pt x="91832" y="413018"/>
                  <a:pt x="89324" y="417032"/>
                </a:cubicBezTo>
                <a:cubicBezTo>
                  <a:pt x="86519" y="421519"/>
                  <a:pt x="82974" y="425499"/>
                  <a:pt x="79799" y="429732"/>
                </a:cubicBezTo>
                <a:cubicBezTo>
                  <a:pt x="78741" y="432907"/>
                  <a:pt x="78480" y="436472"/>
                  <a:pt x="76624" y="439257"/>
                </a:cubicBezTo>
                <a:cubicBezTo>
                  <a:pt x="66655" y="454211"/>
                  <a:pt x="67674" y="442725"/>
                  <a:pt x="60749" y="458307"/>
                </a:cubicBezTo>
                <a:cubicBezTo>
                  <a:pt x="58031" y="464424"/>
                  <a:pt x="58112" y="471788"/>
                  <a:pt x="54399" y="477357"/>
                </a:cubicBezTo>
                <a:cubicBezTo>
                  <a:pt x="52282" y="480532"/>
                  <a:pt x="49599" y="483395"/>
                  <a:pt x="48049" y="486882"/>
                </a:cubicBezTo>
                <a:cubicBezTo>
                  <a:pt x="45331" y="492999"/>
                  <a:pt x="45412" y="500363"/>
                  <a:pt x="41699" y="505932"/>
                </a:cubicBezTo>
                <a:cubicBezTo>
                  <a:pt x="39582" y="509107"/>
                  <a:pt x="36899" y="511970"/>
                  <a:pt x="35349" y="515457"/>
                </a:cubicBezTo>
                <a:cubicBezTo>
                  <a:pt x="32631" y="521574"/>
                  <a:pt x="31116" y="528157"/>
                  <a:pt x="28999" y="534507"/>
                </a:cubicBezTo>
                <a:lnTo>
                  <a:pt x="22649" y="553557"/>
                </a:lnTo>
                <a:cubicBezTo>
                  <a:pt x="21591" y="556732"/>
                  <a:pt x="21330" y="560297"/>
                  <a:pt x="19474" y="563082"/>
                </a:cubicBezTo>
                <a:lnTo>
                  <a:pt x="13124" y="572607"/>
                </a:lnTo>
                <a:cubicBezTo>
                  <a:pt x="12066" y="576840"/>
                  <a:pt x="11203" y="581127"/>
                  <a:pt x="9949" y="585307"/>
                </a:cubicBezTo>
                <a:cubicBezTo>
                  <a:pt x="8026" y="591718"/>
                  <a:pt x="3599" y="604357"/>
                  <a:pt x="3599" y="604357"/>
                </a:cubicBezTo>
                <a:cubicBezTo>
                  <a:pt x="-185" y="638411"/>
                  <a:pt x="-2120" y="640526"/>
                  <a:pt x="3599" y="680557"/>
                </a:cubicBezTo>
                <a:cubicBezTo>
                  <a:pt x="6383" y="700045"/>
                  <a:pt x="7101" y="697708"/>
                  <a:pt x="19474" y="705957"/>
                </a:cubicBezTo>
                <a:cubicBezTo>
                  <a:pt x="20532" y="709132"/>
                  <a:pt x="21152" y="712489"/>
                  <a:pt x="22649" y="715482"/>
                </a:cubicBezTo>
                <a:cubicBezTo>
                  <a:pt x="25984" y="722153"/>
                  <a:pt x="32779" y="730064"/>
                  <a:pt x="38524" y="734532"/>
                </a:cubicBezTo>
                <a:cubicBezTo>
                  <a:pt x="44548" y="739217"/>
                  <a:pt x="57574" y="747232"/>
                  <a:pt x="57574" y="747232"/>
                </a:cubicBezTo>
                <a:cubicBezTo>
                  <a:pt x="74507" y="772632"/>
                  <a:pt x="52282" y="741940"/>
                  <a:pt x="73449" y="763107"/>
                </a:cubicBezTo>
                <a:cubicBezTo>
                  <a:pt x="76147" y="765805"/>
                  <a:pt x="77356" y="769701"/>
                  <a:pt x="79799" y="772632"/>
                </a:cubicBezTo>
                <a:cubicBezTo>
                  <a:pt x="82674" y="776081"/>
                  <a:pt x="86567" y="778613"/>
                  <a:pt x="89324" y="782157"/>
                </a:cubicBezTo>
                <a:cubicBezTo>
                  <a:pt x="94009" y="788181"/>
                  <a:pt x="97791" y="794857"/>
                  <a:pt x="102024" y="801207"/>
                </a:cubicBezTo>
                <a:lnTo>
                  <a:pt x="108374" y="810732"/>
                </a:lnTo>
                <a:cubicBezTo>
                  <a:pt x="110865" y="814468"/>
                  <a:pt x="115142" y="816713"/>
                  <a:pt x="117899" y="820257"/>
                </a:cubicBezTo>
                <a:cubicBezTo>
                  <a:pt x="122584" y="826281"/>
                  <a:pt x="126366" y="832957"/>
                  <a:pt x="130599" y="839307"/>
                </a:cubicBezTo>
                <a:lnTo>
                  <a:pt x="143299" y="858357"/>
                </a:lnTo>
                <a:cubicBezTo>
                  <a:pt x="161679" y="885926"/>
                  <a:pt x="125613" y="847021"/>
                  <a:pt x="155999" y="877407"/>
                </a:cubicBezTo>
                <a:cubicBezTo>
                  <a:pt x="163979" y="901348"/>
                  <a:pt x="153214" y="871838"/>
                  <a:pt x="165524" y="896457"/>
                </a:cubicBezTo>
                <a:cubicBezTo>
                  <a:pt x="167021" y="899450"/>
                  <a:pt x="167381" y="902906"/>
                  <a:pt x="168699" y="905982"/>
                </a:cubicBezTo>
                <a:cubicBezTo>
                  <a:pt x="174557" y="919650"/>
                  <a:pt x="178721" y="924189"/>
                  <a:pt x="187749" y="937732"/>
                </a:cubicBezTo>
                <a:cubicBezTo>
                  <a:pt x="189866" y="940907"/>
                  <a:pt x="190924" y="945140"/>
                  <a:pt x="194099" y="947257"/>
                </a:cubicBezTo>
                <a:cubicBezTo>
                  <a:pt x="197274" y="949374"/>
                  <a:pt x="200772" y="951072"/>
                  <a:pt x="203624" y="953607"/>
                </a:cubicBezTo>
                <a:cubicBezTo>
                  <a:pt x="210336" y="959573"/>
                  <a:pt x="215202" y="967676"/>
                  <a:pt x="222674" y="972657"/>
                </a:cubicBezTo>
                <a:cubicBezTo>
                  <a:pt x="244509" y="987213"/>
                  <a:pt x="234484" y="982944"/>
                  <a:pt x="251249" y="988532"/>
                </a:cubicBezTo>
                <a:cubicBezTo>
                  <a:pt x="278546" y="1006730"/>
                  <a:pt x="244009" y="984912"/>
                  <a:pt x="270299" y="998057"/>
                </a:cubicBezTo>
                <a:cubicBezTo>
                  <a:pt x="273712" y="999764"/>
                  <a:pt x="276337" y="1002857"/>
                  <a:pt x="279824" y="1004407"/>
                </a:cubicBezTo>
                <a:cubicBezTo>
                  <a:pt x="285941" y="1007125"/>
                  <a:pt x="298874" y="1010757"/>
                  <a:pt x="298874" y="1010757"/>
                </a:cubicBezTo>
                <a:cubicBezTo>
                  <a:pt x="326171" y="1028955"/>
                  <a:pt x="291634" y="1007137"/>
                  <a:pt x="317924" y="1020282"/>
                </a:cubicBezTo>
                <a:cubicBezTo>
                  <a:pt x="321337" y="1021989"/>
                  <a:pt x="323962" y="1025082"/>
                  <a:pt x="327449" y="1026632"/>
                </a:cubicBezTo>
                <a:cubicBezTo>
                  <a:pt x="333566" y="1029350"/>
                  <a:pt x="340149" y="1030865"/>
                  <a:pt x="346499" y="1032982"/>
                </a:cubicBezTo>
                <a:lnTo>
                  <a:pt x="365549" y="1039332"/>
                </a:lnTo>
                <a:cubicBezTo>
                  <a:pt x="395212" y="1049220"/>
                  <a:pt x="363387" y="1041580"/>
                  <a:pt x="387774" y="1052032"/>
                </a:cubicBezTo>
                <a:cubicBezTo>
                  <a:pt x="391785" y="1053751"/>
                  <a:pt x="396149" y="1054630"/>
                  <a:pt x="400474" y="1055207"/>
                </a:cubicBezTo>
                <a:cubicBezTo>
                  <a:pt x="412061" y="1056752"/>
                  <a:pt x="423789" y="1057016"/>
                  <a:pt x="435399" y="1058382"/>
                </a:cubicBezTo>
                <a:cubicBezTo>
                  <a:pt x="441792" y="1059134"/>
                  <a:pt x="448099" y="1060499"/>
                  <a:pt x="454449" y="1061557"/>
                </a:cubicBezTo>
                <a:lnTo>
                  <a:pt x="502074" y="1077432"/>
                </a:lnTo>
                <a:cubicBezTo>
                  <a:pt x="508181" y="1079468"/>
                  <a:pt x="514774" y="1079549"/>
                  <a:pt x="521124" y="1080607"/>
                </a:cubicBezTo>
                <a:cubicBezTo>
                  <a:pt x="525616" y="1082104"/>
                  <a:pt x="539362" y="1086957"/>
                  <a:pt x="543349" y="1086957"/>
                </a:cubicBezTo>
                <a:cubicBezTo>
                  <a:pt x="556093" y="1086957"/>
                  <a:pt x="568749" y="1084840"/>
                  <a:pt x="581449" y="1083782"/>
                </a:cubicBezTo>
                <a:lnTo>
                  <a:pt x="600499" y="1077432"/>
                </a:lnTo>
                <a:lnTo>
                  <a:pt x="610024" y="1074257"/>
                </a:lnTo>
                <a:cubicBezTo>
                  <a:pt x="616374" y="1070024"/>
                  <a:pt x="621834" y="1063970"/>
                  <a:pt x="629074" y="1061557"/>
                </a:cubicBezTo>
                <a:lnTo>
                  <a:pt x="648124" y="1055207"/>
                </a:lnTo>
                <a:lnTo>
                  <a:pt x="667174" y="1042507"/>
                </a:lnTo>
                <a:cubicBezTo>
                  <a:pt x="670349" y="1040390"/>
                  <a:pt x="673079" y="1037364"/>
                  <a:pt x="676699" y="1036157"/>
                </a:cubicBezTo>
                <a:lnTo>
                  <a:pt x="686224" y="1032982"/>
                </a:lnTo>
                <a:cubicBezTo>
                  <a:pt x="688341" y="1029807"/>
                  <a:pt x="689594" y="1025841"/>
                  <a:pt x="692574" y="1023457"/>
                </a:cubicBezTo>
                <a:cubicBezTo>
                  <a:pt x="708543" y="1010682"/>
                  <a:pt x="702058" y="1039455"/>
                  <a:pt x="714799" y="1001232"/>
                </a:cubicBezTo>
                <a:cubicBezTo>
                  <a:pt x="720387" y="984467"/>
                  <a:pt x="716118" y="994492"/>
                  <a:pt x="730674" y="972657"/>
                </a:cubicBezTo>
                <a:cubicBezTo>
                  <a:pt x="732791" y="969482"/>
                  <a:pt x="735817" y="966752"/>
                  <a:pt x="737024" y="963132"/>
                </a:cubicBezTo>
                <a:cubicBezTo>
                  <a:pt x="748603" y="928394"/>
                  <a:pt x="730136" y="981011"/>
                  <a:pt x="746549" y="944082"/>
                </a:cubicBezTo>
                <a:cubicBezTo>
                  <a:pt x="761662" y="910077"/>
                  <a:pt x="744878" y="937063"/>
                  <a:pt x="759249" y="915507"/>
                </a:cubicBezTo>
                <a:cubicBezTo>
                  <a:pt x="760307" y="910215"/>
                  <a:pt x="761603" y="904966"/>
                  <a:pt x="762424" y="899632"/>
                </a:cubicBezTo>
                <a:cubicBezTo>
                  <a:pt x="765883" y="877151"/>
                  <a:pt x="766828" y="859489"/>
                  <a:pt x="768774" y="836132"/>
                </a:cubicBezTo>
                <a:cubicBezTo>
                  <a:pt x="767716" y="809674"/>
                  <a:pt x="767421" y="783174"/>
                  <a:pt x="765599" y="756757"/>
                </a:cubicBezTo>
                <a:cubicBezTo>
                  <a:pt x="765299" y="752404"/>
                  <a:pt x="763280" y="748336"/>
                  <a:pt x="762424" y="744057"/>
                </a:cubicBezTo>
                <a:cubicBezTo>
                  <a:pt x="756011" y="711991"/>
                  <a:pt x="763507" y="737782"/>
                  <a:pt x="752899" y="705957"/>
                </a:cubicBezTo>
                <a:lnTo>
                  <a:pt x="749724" y="696432"/>
                </a:lnTo>
                <a:cubicBezTo>
                  <a:pt x="748666" y="686907"/>
                  <a:pt x="748429" y="677255"/>
                  <a:pt x="746549" y="667857"/>
                </a:cubicBezTo>
                <a:cubicBezTo>
                  <a:pt x="745236" y="661293"/>
                  <a:pt x="742316" y="655157"/>
                  <a:pt x="740199" y="648807"/>
                </a:cubicBezTo>
                <a:cubicBezTo>
                  <a:pt x="735527" y="634792"/>
                  <a:pt x="738521" y="642275"/>
                  <a:pt x="730674" y="626582"/>
                </a:cubicBezTo>
                <a:cubicBezTo>
                  <a:pt x="729616" y="621290"/>
                  <a:pt x="728808" y="615942"/>
                  <a:pt x="727499" y="610707"/>
                </a:cubicBezTo>
                <a:cubicBezTo>
                  <a:pt x="726687" y="607460"/>
                  <a:pt x="724715" y="604506"/>
                  <a:pt x="724324" y="601182"/>
                </a:cubicBezTo>
                <a:cubicBezTo>
                  <a:pt x="722588" y="586429"/>
                  <a:pt x="722207" y="571549"/>
                  <a:pt x="721149" y="556732"/>
                </a:cubicBezTo>
                <a:cubicBezTo>
                  <a:pt x="724695" y="492899"/>
                  <a:pt x="718291" y="517682"/>
                  <a:pt x="730674" y="480532"/>
                </a:cubicBezTo>
                <a:cubicBezTo>
                  <a:pt x="731881" y="476912"/>
                  <a:pt x="734907" y="474182"/>
                  <a:pt x="737024" y="471007"/>
                </a:cubicBezTo>
                <a:cubicBezTo>
                  <a:pt x="741691" y="415003"/>
                  <a:pt x="741965" y="430818"/>
                  <a:pt x="737024" y="356707"/>
                </a:cubicBezTo>
                <a:cubicBezTo>
                  <a:pt x="735778" y="338023"/>
                  <a:pt x="734596" y="341858"/>
                  <a:pt x="730674" y="328132"/>
                </a:cubicBezTo>
                <a:cubicBezTo>
                  <a:pt x="729475" y="323936"/>
                  <a:pt x="728557" y="319665"/>
                  <a:pt x="727499" y="315432"/>
                </a:cubicBezTo>
                <a:cubicBezTo>
                  <a:pt x="722393" y="264368"/>
                  <a:pt x="728190" y="298802"/>
                  <a:pt x="721149" y="274157"/>
                </a:cubicBezTo>
                <a:cubicBezTo>
                  <a:pt x="719950" y="269961"/>
                  <a:pt x="719693" y="265468"/>
                  <a:pt x="717974" y="261457"/>
                </a:cubicBezTo>
                <a:cubicBezTo>
                  <a:pt x="716471" y="257950"/>
                  <a:pt x="713517" y="255245"/>
                  <a:pt x="711624" y="251932"/>
                </a:cubicBezTo>
                <a:cubicBezTo>
                  <a:pt x="704943" y="240240"/>
                  <a:pt x="702930" y="230538"/>
                  <a:pt x="692574" y="220182"/>
                </a:cubicBezTo>
                <a:cubicBezTo>
                  <a:pt x="680351" y="207959"/>
                  <a:pt x="685540" y="214393"/>
                  <a:pt x="676699" y="201132"/>
                </a:cubicBezTo>
                <a:cubicBezTo>
                  <a:pt x="675682" y="197063"/>
                  <a:pt x="672626" y="183462"/>
                  <a:pt x="670349" y="178907"/>
                </a:cubicBezTo>
                <a:cubicBezTo>
                  <a:pt x="668642" y="175494"/>
                  <a:pt x="665549" y="172869"/>
                  <a:pt x="663999" y="169382"/>
                </a:cubicBezTo>
                <a:cubicBezTo>
                  <a:pt x="661281" y="163265"/>
                  <a:pt x="661362" y="155901"/>
                  <a:pt x="657649" y="150332"/>
                </a:cubicBezTo>
                <a:cubicBezTo>
                  <a:pt x="655532" y="147157"/>
                  <a:pt x="653006" y="144220"/>
                  <a:pt x="651299" y="140807"/>
                </a:cubicBezTo>
                <a:cubicBezTo>
                  <a:pt x="646134" y="130478"/>
                  <a:pt x="650873" y="130856"/>
                  <a:pt x="641774" y="121757"/>
                </a:cubicBezTo>
                <a:cubicBezTo>
                  <a:pt x="639076" y="119059"/>
                  <a:pt x="635424" y="117524"/>
                  <a:pt x="632249" y="115407"/>
                </a:cubicBezTo>
                <a:cubicBezTo>
                  <a:pt x="625099" y="93957"/>
                  <a:pt x="635015" y="117207"/>
                  <a:pt x="619549" y="99532"/>
                </a:cubicBezTo>
                <a:cubicBezTo>
                  <a:pt x="614523" y="93789"/>
                  <a:pt x="613199" y="84715"/>
                  <a:pt x="606849" y="80482"/>
                </a:cubicBezTo>
                <a:lnTo>
                  <a:pt x="578274" y="61432"/>
                </a:lnTo>
                <a:cubicBezTo>
                  <a:pt x="575099" y="59315"/>
                  <a:pt x="571447" y="57780"/>
                  <a:pt x="568749" y="55082"/>
                </a:cubicBezTo>
                <a:cubicBezTo>
                  <a:pt x="556857" y="43190"/>
                  <a:pt x="563484" y="46977"/>
                  <a:pt x="549699" y="42382"/>
                </a:cubicBezTo>
                <a:cubicBezTo>
                  <a:pt x="546524" y="40265"/>
                  <a:pt x="543587" y="37739"/>
                  <a:pt x="540174" y="36032"/>
                </a:cubicBezTo>
                <a:cubicBezTo>
                  <a:pt x="537181" y="34535"/>
                  <a:pt x="533575" y="34482"/>
                  <a:pt x="530649" y="32857"/>
                </a:cubicBezTo>
                <a:cubicBezTo>
                  <a:pt x="523978" y="29151"/>
                  <a:pt x="519003" y="22008"/>
                  <a:pt x="511599" y="20157"/>
                </a:cubicBezTo>
                <a:cubicBezTo>
                  <a:pt x="479012" y="12010"/>
                  <a:pt x="493078" y="3753"/>
                  <a:pt x="486199" y="1107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0" y="596597"/>
            <a:ext cx="1834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r>
              <a:rPr kumimoji="1" lang="en-US" altLang="ja-JP" sz="16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ontrol case (C4)</a:t>
            </a:r>
            <a:endParaRPr kumimoji="1" lang="ja-JP" altLang="en-US" sz="1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297159" y="899423"/>
            <a:ext cx="1537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</a:t>
            </a:r>
            <a:r>
              <a:rPr lang="en-US" altLang="ja-JP" sz="1200" b="1" dirty="0" smtClean="0">
                <a:solidFill>
                  <a:srgbClr val="008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/</a:t>
            </a:r>
            <a:r>
              <a:rPr lang="en-US" altLang="ja-JP" sz="1200" b="1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Hoechst</a:t>
            </a:r>
            <a:endParaRPr lang="ja-JP" altLang="en-US" sz="1200" b="1" dirty="0">
              <a:solidFill>
                <a:schemeClr val="tx2">
                  <a:lumMod val="60000"/>
                  <a:lumOff val="40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2289402" y="902419"/>
            <a:ext cx="1453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</a:t>
            </a:r>
            <a:endParaRPr lang="en-US" altLang="ja-JP" sz="120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4024983" y="904982"/>
            <a:ext cx="1147699" cy="276999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SF/</a:t>
            </a:r>
            <a:r>
              <a:rPr kumimoji="1" lang="en-US" altLang="ja-JP" sz="1200" b="1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Hoechst</a:t>
            </a:r>
            <a:endParaRPr kumimoji="1" lang="ja-JP" altLang="en-US" sz="1200" b="1" dirty="0">
              <a:solidFill>
                <a:schemeClr val="tx2">
                  <a:lumMod val="60000"/>
                  <a:lumOff val="40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6297902" y="910216"/>
            <a:ext cx="590925" cy="276999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solidFill>
                  <a:schemeClr val="bg1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SF</a:t>
            </a:r>
            <a:endParaRPr kumimoji="1" lang="ja-JP" altLang="en-US" sz="1200" b="1" dirty="0">
              <a:solidFill>
                <a:schemeClr val="bg1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7301799" y="899587"/>
            <a:ext cx="18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2/</a:t>
            </a:r>
            <a:r>
              <a:rPr lang="en-US" altLang="ja-JP" sz="1200" b="1" dirty="0" smtClean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PSP1</a:t>
            </a:r>
            <a:endParaRPr lang="ja-JP" altLang="en-US" sz="1200" b="1" dirty="0">
              <a:solidFill>
                <a:srgbClr val="FF000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106" name="直線コネクタ 105"/>
          <p:cNvCxnSpPr/>
          <p:nvPr/>
        </p:nvCxnSpPr>
        <p:spPr>
          <a:xfrm>
            <a:off x="6132397" y="2521527"/>
            <a:ext cx="54113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フリーフォーム 45"/>
          <p:cNvSpPr/>
          <p:nvPr/>
        </p:nvSpPr>
        <p:spPr>
          <a:xfrm>
            <a:off x="5394681" y="1268787"/>
            <a:ext cx="1006475" cy="867832"/>
          </a:xfrm>
          <a:custGeom>
            <a:avLst/>
            <a:gdLst>
              <a:gd name="connsiteX0" fmla="*/ 841375 w 1006475"/>
              <a:gd name="connsiteY0" fmla="*/ 239182 h 867832"/>
              <a:gd name="connsiteX1" fmla="*/ 784225 w 1006475"/>
              <a:gd name="connsiteY1" fmla="*/ 229657 h 867832"/>
              <a:gd name="connsiteX2" fmla="*/ 765175 w 1006475"/>
              <a:gd name="connsiteY2" fmla="*/ 223307 h 867832"/>
              <a:gd name="connsiteX3" fmla="*/ 755650 w 1006475"/>
              <a:gd name="connsiteY3" fmla="*/ 216957 h 867832"/>
              <a:gd name="connsiteX4" fmla="*/ 746125 w 1006475"/>
              <a:gd name="connsiteY4" fmla="*/ 213782 h 867832"/>
              <a:gd name="connsiteX5" fmla="*/ 727075 w 1006475"/>
              <a:gd name="connsiteY5" fmla="*/ 201082 h 867832"/>
              <a:gd name="connsiteX6" fmla="*/ 720725 w 1006475"/>
              <a:gd name="connsiteY6" fmla="*/ 191557 h 867832"/>
              <a:gd name="connsiteX7" fmla="*/ 711200 w 1006475"/>
              <a:gd name="connsiteY7" fmla="*/ 185207 h 867832"/>
              <a:gd name="connsiteX8" fmla="*/ 708025 w 1006475"/>
              <a:gd name="connsiteY8" fmla="*/ 175682 h 867832"/>
              <a:gd name="connsiteX9" fmla="*/ 688975 w 1006475"/>
              <a:gd name="connsiteY9" fmla="*/ 162982 h 867832"/>
              <a:gd name="connsiteX10" fmla="*/ 669925 w 1006475"/>
              <a:gd name="connsiteY10" fmla="*/ 153457 h 867832"/>
              <a:gd name="connsiteX11" fmla="*/ 660400 w 1006475"/>
              <a:gd name="connsiteY11" fmla="*/ 147107 h 867832"/>
              <a:gd name="connsiteX12" fmla="*/ 641350 w 1006475"/>
              <a:gd name="connsiteY12" fmla="*/ 143932 h 867832"/>
              <a:gd name="connsiteX13" fmla="*/ 625475 w 1006475"/>
              <a:gd name="connsiteY13" fmla="*/ 140757 h 867832"/>
              <a:gd name="connsiteX14" fmla="*/ 596900 w 1006475"/>
              <a:gd name="connsiteY14" fmla="*/ 124882 h 867832"/>
              <a:gd name="connsiteX15" fmla="*/ 581025 w 1006475"/>
              <a:gd name="connsiteY15" fmla="*/ 109007 h 867832"/>
              <a:gd name="connsiteX16" fmla="*/ 574675 w 1006475"/>
              <a:gd name="connsiteY16" fmla="*/ 99482 h 867832"/>
              <a:gd name="connsiteX17" fmla="*/ 546100 w 1006475"/>
              <a:gd name="connsiteY17" fmla="*/ 77257 h 867832"/>
              <a:gd name="connsiteX18" fmla="*/ 530225 w 1006475"/>
              <a:gd name="connsiteY18" fmla="*/ 58207 h 867832"/>
              <a:gd name="connsiteX19" fmla="*/ 520700 w 1006475"/>
              <a:gd name="connsiteY19" fmla="*/ 55032 h 867832"/>
              <a:gd name="connsiteX20" fmla="*/ 498475 w 1006475"/>
              <a:gd name="connsiteY20" fmla="*/ 32807 h 867832"/>
              <a:gd name="connsiteX21" fmla="*/ 488950 w 1006475"/>
              <a:gd name="connsiteY21" fmla="*/ 26457 h 867832"/>
              <a:gd name="connsiteX22" fmla="*/ 479425 w 1006475"/>
              <a:gd name="connsiteY22" fmla="*/ 16932 h 867832"/>
              <a:gd name="connsiteX23" fmla="*/ 460375 w 1006475"/>
              <a:gd name="connsiteY23" fmla="*/ 10582 h 867832"/>
              <a:gd name="connsiteX24" fmla="*/ 450850 w 1006475"/>
              <a:gd name="connsiteY24" fmla="*/ 4232 h 867832"/>
              <a:gd name="connsiteX25" fmla="*/ 390525 w 1006475"/>
              <a:gd name="connsiteY25" fmla="*/ 4232 h 867832"/>
              <a:gd name="connsiteX26" fmla="*/ 374650 w 1006475"/>
              <a:gd name="connsiteY26" fmla="*/ 7407 h 867832"/>
              <a:gd name="connsiteX27" fmla="*/ 361950 w 1006475"/>
              <a:gd name="connsiteY27" fmla="*/ 10582 h 867832"/>
              <a:gd name="connsiteX28" fmla="*/ 327025 w 1006475"/>
              <a:gd name="connsiteY28" fmla="*/ 13757 h 867832"/>
              <a:gd name="connsiteX29" fmla="*/ 209550 w 1006475"/>
              <a:gd name="connsiteY29" fmla="*/ 20107 h 867832"/>
              <a:gd name="connsiteX30" fmla="*/ 174625 w 1006475"/>
              <a:gd name="connsiteY30" fmla="*/ 26457 h 867832"/>
              <a:gd name="connsiteX31" fmla="*/ 155575 w 1006475"/>
              <a:gd name="connsiteY31" fmla="*/ 39157 h 867832"/>
              <a:gd name="connsiteX32" fmla="*/ 149225 w 1006475"/>
              <a:gd name="connsiteY32" fmla="*/ 48682 h 867832"/>
              <a:gd name="connsiteX33" fmla="*/ 130175 w 1006475"/>
              <a:gd name="connsiteY33" fmla="*/ 61382 h 867832"/>
              <a:gd name="connsiteX34" fmla="*/ 123825 w 1006475"/>
              <a:gd name="connsiteY34" fmla="*/ 70907 h 867832"/>
              <a:gd name="connsiteX35" fmla="*/ 114300 w 1006475"/>
              <a:gd name="connsiteY35" fmla="*/ 80432 h 867832"/>
              <a:gd name="connsiteX36" fmla="*/ 107950 w 1006475"/>
              <a:gd name="connsiteY36" fmla="*/ 99482 h 867832"/>
              <a:gd name="connsiteX37" fmla="*/ 95250 w 1006475"/>
              <a:gd name="connsiteY37" fmla="*/ 118532 h 867832"/>
              <a:gd name="connsiteX38" fmla="*/ 88900 w 1006475"/>
              <a:gd name="connsiteY38" fmla="*/ 137582 h 867832"/>
              <a:gd name="connsiteX39" fmla="*/ 79375 w 1006475"/>
              <a:gd name="connsiteY39" fmla="*/ 156632 h 867832"/>
              <a:gd name="connsiteX40" fmla="*/ 73025 w 1006475"/>
              <a:gd name="connsiteY40" fmla="*/ 166157 h 867832"/>
              <a:gd name="connsiteX41" fmla="*/ 66675 w 1006475"/>
              <a:gd name="connsiteY41" fmla="*/ 185207 h 867832"/>
              <a:gd name="connsiteX42" fmla="*/ 63500 w 1006475"/>
              <a:gd name="connsiteY42" fmla="*/ 194732 h 867832"/>
              <a:gd name="connsiteX43" fmla="*/ 50800 w 1006475"/>
              <a:gd name="connsiteY43" fmla="*/ 213782 h 867832"/>
              <a:gd name="connsiteX44" fmla="*/ 44450 w 1006475"/>
              <a:gd name="connsiteY44" fmla="*/ 236007 h 867832"/>
              <a:gd name="connsiteX45" fmla="*/ 38100 w 1006475"/>
              <a:gd name="connsiteY45" fmla="*/ 245532 h 867832"/>
              <a:gd name="connsiteX46" fmla="*/ 28575 w 1006475"/>
              <a:gd name="connsiteY46" fmla="*/ 264582 h 867832"/>
              <a:gd name="connsiteX47" fmla="*/ 15875 w 1006475"/>
              <a:gd name="connsiteY47" fmla="*/ 315382 h 867832"/>
              <a:gd name="connsiteX48" fmla="*/ 9525 w 1006475"/>
              <a:gd name="connsiteY48" fmla="*/ 324907 h 867832"/>
              <a:gd name="connsiteX49" fmla="*/ 6350 w 1006475"/>
              <a:gd name="connsiteY49" fmla="*/ 334432 h 867832"/>
              <a:gd name="connsiteX50" fmla="*/ 3175 w 1006475"/>
              <a:gd name="connsiteY50" fmla="*/ 359832 h 867832"/>
              <a:gd name="connsiteX51" fmla="*/ 0 w 1006475"/>
              <a:gd name="connsiteY51" fmla="*/ 369357 h 867832"/>
              <a:gd name="connsiteX52" fmla="*/ 6350 w 1006475"/>
              <a:gd name="connsiteY52" fmla="*/ 436032 h 867832"/>
              <a:gd name="connsiteX53" fmla="*/ 15875 w 1006475"/>
              <a:gd name="connsiteY53" fmla="*/ 467782 h 867832"/>
              <a:gd name="connsiteX54" fmla="*/ 22225 w 1006475"/>
              <a:gd name="connsiteY54" fmla="*/ 477307 h 867832"/>
              <a:gd name="connsiteX55" fmla="*/ 28575 w 1006475"/>
              <a:gd name="connsiteY55" fmla="*/ 496357 h 867832"/>
              <a:gd name="connsiteX56" fmla="*/ 34925 w 1006475"/>
              <a:gd name="connsiteY56" fmla="*/ 505882 h 867832"/>
              <a:gd name="connsiteX57" fmla="*/ 38100 w 1006475"/>
              <a:gd name="connsiteY57" fmla="*/ 515407 h 867832"/>
              <a:gd name="connsiteX58" fmla="*/ 44450 w 1006475"/>
              <a:gd name="connsiteY58" fmla="*/ 524932 h 867832"/>
              <a:gd name="connsiteX59" fmla="*/ 50800 w 1006475"/>
              <a:gd name="connsiteY59" fmla="*/ 543982 h 867832"/>
              <a:gd name="connsiteX60" fmla="*/ 57150 w 1006475"/>
              <a:gd name="connsiteY60" fmla="*/ 553507 h 867832"/>
              <a:gd name="connsiteX61" fmla="*/ 60325 w 1006475"/>
              <a:gd name="connsiteY61" fmla="*/ 563032 h 867832"/>
              <a:gd name="connsiteX62" fmla="*/ 69850 w 1006475"/>
              <a:gd name="connsiteY62" fmla="*/ 572557 h 867832"/>
              <a:gd name="connsiteX63" fmla="*/ 79375 w 1006475"/>
              <a:gd name="connsiteY63" fmla="*/ 591607 h 867832"/>
              <a:gd name="connsiteX64" fmla="*/ 82550 w 1006475"/>
              <a:gd name="connsiteY64" fmla="*/ 601132 h 867832"/>
              <a:gd name="connsiteX65" fmla="*/ 95250 w 1006475"/>
              <a:gd name="connsiteY65" fmla="*/ 620182 h 867832"/>
              <a:gd name="connsiteX66" fmla="*/ 101600 w 1006475"/>
              <a:gd name="connsiteY66" fmla="*/ 629707 h 867832"/>
              <a:gd name="connsiteX67" fmla="*/ 111125 w 1006475"/>
              <a:gd name="connsiteY67" fmla="*/ 639232 h 867832"/>
              <a:gd name="connsiteX68" fmla="*/ 123825 w 1006475"/>
              <a:gd name="connsiteY68" fmla="*/ 655107 h 867832"/>
              <a:gd name="connsiteX69" fmla="*/ 130175 w 1006475"/>
              <a:gd name="connsiteY69" fmla="*/ 664632 h 867832"/>
              <a:gd name="connsiteX70" fmla="*/ 133350 w 1006475"/>
              <a:gd name="connsiteY70" fmla="*/ 674157 h 867832"/>
              <a:gd name="connsiteX71" fmla="*/ 142875 w 1006475"/>
              <a:gd name="connsiteY71" fmla="*/ 677332 h 867832"/>
              <a:gd name="connsiteX72" fmla="*/ 152400 w 1006475"/>
              <a:gd name="connsiteY72" fmla="*/ 683682 h 867832"/>
              <a:gd name="connsiteX73" fmla="*/ 165100 w 1006475"/>
              <a:gd name="connsiteY73" fmla="*/ 696382 h 867832"/>
              <a:gd name="connsiteX74" fmla="*/ 193675 w 1006475"/>
              <a:gd name="connsiteY74" fmla="*/ 718607 h 867832"/>
              <a:gd name="connsiteX75" fmla="*/ 212725 w 1006475"/>
              <a:gd name="connsiteY75" fmla="*/ 731307 h 867832"/>
              <a:gd name="connsiteX76" fmla="*/ 231775 w 1006475"/>
              <a:gd name="connsiteY76" fmla="*/ 744007 h 867832"/>
              <a:gd name="connsiteX77" fmla="*/ 238125 w 1006475"/>
              <a:gd name="connsiteY77" fmla="*/ 753532 h 867832"/>
              <a:gd name="connsiteX78" fmla="*/ 266700 w 1006475"/>
              <a:gd name="connsiteY78" fmla="*/ 772582 h 867832"/>
              <a:gd name="connsiteX79" fmla="*/ 276225 w 1006475"/>
              <a:gd name="connsiteY79" fmla="*/ 778932 h 867832"/>
              <a:gd name="connsiteX80" fmla="*/ 285750 w 1006475"/>
              <a:gd name="connsiteY80" fmla="*/ 785282 h 867832"/>
              <a:gd name="connsiteX81" fmla="*/ 390525 w 1006475"/>
              <a:gd name="connsiteY81" fmla="*/ 782107 h 867832"/>
              <a:gd name="connsiteX82" fmla="*/ 406400 w 1006475"/>
              <a:gd name="connsiteY82" fmla="*/ 778932 h 867832"/>
              <a:gd name="connsiteX83" fmla="*/ 466725 w 1006475"/>
              <a:gd name="connsiteY83" fmla="*/ 782107 h 867832"/>
              <a:gd name="connsiteX84" fmla="*/ 501650 w 1006475"/>
              <a:gd name="connsiteY84" fmla="*/ 788457 h 867832"/>
              <a:gd name="connsiteX85" fmla="*/ 511175 w 1006475"/>
              <a:gd name="connsiteY85" fmla="*/ 791632 h 867832"/>
              <a:gd name="connsiteX86" fmla="*/ 523875 w 1006475"/>
              <a:gd name="connsiteY86" fmla="*/ 794807 h 867832"/>
              <a:gd name="connsiteX87" fmla="*/ 555625 w 1006475"/>
              <a:gd name="connsiteY87" fmla="*/ 804332 h 867832"/>
              <a:gd name="connsiteX88" fmla="*/ 612775 w 1006475"/>
              <a:gd name="connsiteY88" fmla="*/ 810682 h 867832"/>
              <a:gd name="connsiteX89" fmla="*/ 631825 w 1006475"/>
              <a:gd name="connsiteY89" fmla="*/ 817032 h 867832"/>
              <a:gd name="connsiteX90" fmla="*/ 641350 w 1006475"/>
              <a:gd name="connsiteY90" fmla="*/ 820207 h 867832"/>
              <a:gd name="connsiteX91" fmla="*/ 669925 w 1006475"/>
              <a:gd name="connsiteY91" fmla="*/ 832907 h 867832"/>
              <a:gd name="connsiteX92" fmla="*/ 679450 w 1006475"/>
              <a:gd name="connsiteY92" fmla="*/ 836082 h 867832"/>
              <a:gd name="connsiteX93" fmla="*/ 698500 w 1006475"/>
              <a:gd name="connsiteY93" fmla="*/ 848782 h 867832"/>
              <a:gd name="connsiteX94" fmla="*/ 746125 w 1006475"/>
              <a:gd name="connsiteY94" fmla="*/ 864657 h 867832"/>
              <a:gd name="connsiteX95" fmla="*/ 762000 w 1006475"/>
              <a:gd name="connsiteY95" fmla="*/ 867832 h 867832"/>
              <a:gd name="connsiteX96" fmla="*/ 796925 w 1006475"/>
              <a:gd name="connsiteY96" fmla="*/ 864657 h 867832"/>
              <a:gd name="connsiteX97" fmla="*/ 815975 w 1006475"/>
              <a:gd name="connsiteY97" fmla="*/ 858307 h 867832"/>
              <a:gd name="connsiteX98" fmla="*/ 825500 w 1006475"/>
              <a:gd name="connsiteY98" fmla="*/ 855132 h 867832"/>
              <a:gd name="connsiteX99" fmla="*/ 854075 w 1006475"/>
              <a:gd name="connsiteY99" fmla="*/ 836082 h 867832"/>
              <a:gd name="connsiteX100" fmla="*/ 873125 w 1006475"/>
              <a:gd name="connsiteY100" fmla="*/ 829732 h 867832"/>
              <a:gd name="connsiteX101" fmla="*/ 901700 w 1006475"/>
              <a:gd name="connsiteY101" fmla="*/ 810682 h 867832"/>
              <a:gd name="connsiteX102" fmla="*/ 920750 w 1006475"/>
              <a:gd name="connsiteY102" fmla="*/ 804332 h 867832"/>
              <a:gd name="connsiteX103" fmla="*/ 930275 w 1006475"/>
              <a:gd name="connsiteY103" fmla="*/ 794807 h 867832"/>
              <a:gd name="connsiteX104" fmla="*/ 933450 w 1006475"/>
              <a:gd name="connsiteY104" fmla="*/ 785282 h 867832"/>
              <a:gd name="connsiteX105" fmla="*/ 939800 w 1006475"/>
              <a:gd name="connsiteY105" fmla="*/ 775757 h 867832"/>
              <a:gd name="connsiteX106" fmla="*/ 952500 w 1006475"/>
              <a:gd name="connsiteY106" fmla="*/ 747182 h 867832"/>
              <a:gd name="connsiteX107" fmla="*/ 958850 w 1006475"/>
              <a:gd name="connsiteY107" fmla="*/ 724957 h 867832"/>
              <a:gd name="connsiteX108" fmla="*/ 965200 w 1006475"/>
              <a:gd name="connsiteY108" fmla="*/ 715432 h 867832"/>
              <a:gd name="connsiteX109" fmla="*/ 974725 w 1006475"/>
              <a:gd name="connsiteY109" fmla="*/ 683682 h 867832"/>
              <a:gd name="connsiteX110" fmla="*/ 981075 w 1006475"/>
              <a:gd name="connsiteY110" fmla="*/ 664632 h 867832"/>
              <a:gd name="connsiteX111" fmla="*/ 987425 w 1006475"/>
              <a:gd name="connsiteY111" fmla="*/ 655107 h 867832"/>
              <a:gd name="connsiteX112" fmla="*/ 993775 w 1006475"/>
              <a:gd name="connsiteY112" fmla="*/ 636057 h 867832"/>
              <a:gd name="connsiteX113" fmla="*/ 1003300 w 1006475"/>
              <a:gd name="connsiteY113" fmla="*/ 591607 h 867832"/>
              <a:gd name="connsiteX114" fmla="*/ 1006475 w 1006475"/>
              <a:gd name="connsiteY114" fmla="*/ 582082 h 867832"/>
              <a:gd name="connsiteX115" fmla="*/ 1000125 w 1006475"/>
              <a:gd name="connsiteY115" fmla="*/ 528107 h 867832"/>
              <a:gd name="connsiteX116" fmla="*/ 996950 w 1006475"/>
              <a:gd name="connsiteY116" fmla="*/ 518582 h 867832"/>
              <a:gd name="connsiteX117" fmla="*/ 993775 w 1006475"/>
              <a:gd name="connsiteY117" fmla="*/ 474132 h 867832"/>
              <a:gd name="connsiteX118" fmla="*/ 981075 w 1006475"/>
              <a:gd name="connsiteY118" fmla="*/ 445557 h 867832"/>
              <a:gd name="connsiteX119" fmla="*/ 974725 w 1006475"/>
              <a:gd name="connsiteY119" fmla="*/ 426507 h 867832"/>
              <a:gd name="connsiteX120" fmla="*/ 955675 w 1006475"/>
              <a:gd name="connsiteY120" fmla="*/ 397932 h 867832"/>
              <a:gd name="connsiteX121" fmla="*/ 952500 w 1006475"/>
              <a:gd name="connsiteY121" fmla="*/ 388407 h 867832"/>
              <a:gd name="connsiteX122" fmla="*/ 946150 w 1006475"/>
              <a:gd name="connsiteY122" fmla="*/ 378882 h 867832"/>
              <a:gd name="connsiteX123" fmla="*/ 942975 w 1006475"/>
              <a:gd name="connsiteY123" fmla="*/ 369357 h 867832"/>
              <a:gd name="connsiteX124" fmla="*/ 930275 w 1006475"/>
              <a:gd name="connsiteY124" fmla="*/ 350307 h 867832"/>
              <a:gd name="connsiteX125" fmla="*/ 917575 w 1006475"/>
              <a:gd name="connsiteY125" fmla="*/ 331257 h 867832"/>
              <a:gd name="connsiteX126" fmla="*/ 904875 w 1006475"/>
              <a:gd name="connsiteY126" fmla="*/ 315382 h 867832"/>
              <a:gd name="connsiteX127" fmla="*/ 889000 w 1006475"/>
              <a:gd name="connsiteY127" fmla="*/ 299507 h 867832"/>
              <a:gd name="connsiteX128" fmla="*/ 879475 w 1006475"/>
              <a:gd name="connsiteY128" fmla="*/ 280457 h 867832"/>
              <a:gd name="connsiteX129" fmla="*/ 869950 w 1006475"/>
              <a:gd name="connsiteY129" fmla="*/ 277282 h 867832"/>
              <a:gd name="connsiteX130" fmla="*/ 850900 w 1006475"/>
              <a:gd name="connsiteY130" fmla="*/ 264582 h 867832"/>
              <a:gd name="connsiteX131" fmla="*/ 841375 w 1006475"/>
              <a:gd name="connsiteY131" fmla="*/ 258232 h 867832"/>
              <a:gd name="connsiteX132" fmla="*/ 841375 w 1006475"/>
              <a:gd name="connsiteY132" fmla="*/ 239182 h 867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</a:cxnLst>
            <a:rect l="l" t="t" r="r" b="b"/>
            <a:pathLst>
              <a:path w="1006475" h="867832">
                <a:moveTo>
                  <a:pt x="841375" y="239182"/>
                </a:moveTo>
                <a:cubicBezTo>
                  <a:pt x="831850" y="234419"/>
                  <a:pt x="802784" y="235225"/>
                  <a:pt x="784225" y="229657"/>
                </a:cubicBezTo>
                <a:cubicBezTo>
                  <a:pt x="777814" y="227734"/>
                  <a:pt x="765175" y="223307"/>
                  <a:pt x="765175" y="223307"/>
                </a:cubicBezTo>
                <a:cubicBezTo>
                  <a:pt x="762000" y="221190"/>
                  <a:pt x="759063" y="218664"/>
                  <a:pt x="755650" y="216957"/>
                </a:cubicBezTo>
                <a:cubicBezTo>
                  <a:pt x="752657" y="215460"/>
                  <a:pt x="749051" y="215407"/>
                  <a:pt x="746125" y="213782"/>
                </a:cubicBezTo>
                <a:cubicBezTo>
                  <a:pt x="739454" y="210076"/>
                  <a:pt x="727075" y="201082"/>
                  <a:pt x="727075" y="201082"/>
                </a:cubicBezTo>
                <a:cubicBezTo>
                  <a:pt x="724958" y="197907"/>
                  <a:pt x="723423" y="194255"/>
                  <a:pt x="720725" y="191557"/>
                </a:cubicBezTo>
                <a:cubicBezTo>
                  <a:pt x="718027" y="188859"/>
                  <a:pt x="713584" y="188187"/>
                  <a:pt x="711200" y="185207"/>
                </a:cubicBezTo>
                <a:cubicBezTo>
                  <a:pt x="709109" y="182594"/>
                  <a:pt x="710392" y="178049"/>
                  <a:pt x="708025" y="175682"/>
                </a:cubicBezTo>
                <a:cubicBezTo>
                  <a:pt x="702629" y="170286"/>
                  <a:pt x="695325" y="167215"/>
                  <a:pt x="688975" y="162982"/>
                </a:cubicBezTo>
                <a:cubicBezTo>
                  <a:pt x="676665" y="154776"/>
                  <a:pt x="683070" y="157839"/>
                  <a:pt x="669925" y="153457"/>
                </a:cubicBezTo>
                <a:cubicBezTo>
                  <a:pt x="666750" y="151340"/>
                  <a:pt x="664020" y="148314"/>
                  <a:pt x="660400" y="147107"/>
                </a:cubicBezTo>
                <a:cubicBezTo>
                  <a:pt x="654293" y="145071"/>
                  <a:pt x="647684" y="145084"/>
                  <a:pt x="641350" y="143932"/>
                </a:cubicBezTo>
                <a:cubicBezTo>
                  <a:pt x="636041" y="142967"/>
                  <a:pt x="630767" y="141815"/>
                  <a:pt x="625475" y="140757"/>
                </a:cubicBezTo>
                <a:cubicBezTo>
                  <a:pt x="603640" y="126201"/>
                  <a:pt x="613665" y="130470"/>
                  <a:pt x="596900" y="124882"/>
                </a:cubicBezTo>
                <a:cubicBezTo>
                  <a:pt x="579967" y="99482"/>
                  <a:pt x="602192" y="130174"/>
                  <a:pt x="581025" y="109007"/>
                </a:cubicBezTo>
                <a:cubicBezTo>
                  <a:pt x="578327" y="106309"/>
                  <a:pt x="577118" y="102413"/>
                  <a:pt x="574675" y="99482"/>
                </a:cubicBezTo>
                <a:cubicBezTo>
                  <a:pt x="565349" y="88291"/>
                  <a:pt x="559375" y="86107"/>
                  <a:pt x="546100" y="77257"/>
                </a:cubicBezTo>
                <a:cubicBezTo>
                  <a:pt x="509820" y="53070"/>
                  <a:pt x="559510" y="81635"/>
                  <a:pt x="530225" y="58207"/>
                </a:cubicBezTo>
                <a:cubicBezTo>
                  <a:pt x="527612" y="56116"/>
                  <a:pt x="523875" y="56090"/>
                  <a:pt x="520700" y="55032"/>
                </a:cubicBezTo>
                <a:cubicBezTo>
                  <a:pt x="506144" y="33197"/>
                  <a:pt x="515240" y="38395"/>
                  <a:pt x="498475" y="32807"/>
                </a:cubicBezTo>
                <a:cubicBezTo>
                  <a:pt x="495300" y="30690"/>
                  <a:pt x="491881" y="28900"/>
                  <a:pt x="488950" y="26457"/>
                </a:cubicBezTo>
                <a:cubicBezTo>
                  <a:pt x="485501" y="23582"/>
                  <a:pt x="483350" y="19113"/>
                  <a:pt x="479425" y="16932"/>
                </a:cubicBezTo>
                <a:cubicBezTo>
                  <a:pt x="473574" y="13681"/>
                  <a:pt x="460375" y="10582"/>
                  <a:pt x="460375" y="10582"/>
                </a:cubicBezTo>
                <a:cubicBezTo>
                  <a:pt x="457200" y="8465"/>
                  <a:pt x="454263" y="5939"/>
                  <a:pt x="450850" y="4232"/>
                </a:cubicBezTo>
                <a:cubicBezTo>
                  <a:pt x="432821" y="-4783"/>
                  <a:pt x="406181" y="3254"/>
                  <a:pt x="390525" y="4232"/>
                </a:cubicBezTo>
                <a:cubicBezTo>
                  <a:pt x="385233" y="5290"/>
                  <a:pt x="379918" y="6236"/>
                  <a:pt x="374650" y="7407"/>
                </a:cubicBezTo>
                <a:cubicBezTo>
                  <a:pt x="370390" y="8354"/>
                  <a:pt x="366275" y="10005"/>
                  <a:pt x="361950" y="10582"/>
                </a:cubicBezTo>
                <a:cubicBezTo>
                  <a:pt x="350363" y="12127"/>
                  <a:pt x="338674" y="12786"/>
                  <a:pt x="327025" y="13757"/>
                </a:cubicBezTo>
                <a:cubicBezTo>
                  <a:pt x="270652" y="18455"/>
                  <a:pt x="280654" y="17144"/>
                  <a:pt x="209550" y="20107"/>
                </a:cubicBezTo>
                <a:cubicBezTo>
                  <a:pt x="204014" y="20799"/>
                  <a:pt x="183151" y="21721"/>
                  <a:pt x="174625" y="26457"/>
                </a:cubicBezTo>
                <a:cubicBezTo>
                  <a:pt x="167954" y="30163"/>
                  <a:pt x="155575" y="39157"/>
                  <a:pt x="155575" y="39157"/>
                </a:cubicBezTo>
                <a:cubicBezTo>
                  <a:pt x="153458" y="42332"/>
                  <a:pt x="152097" y="46169"/>
                  <a:pt x="149225" y="48682"/>
                </a:cubicBezTo>
                <a:cubicBezTo>
                  <a:pt x="143482" y="53708"/>
                  <a:pt x="130175" y="61382"/>
                  <a:pt x="130175" y="61382"/>
                </a:cubicBezTo>
                <a:cubicBezTo>
                  <a:pt x="128058" y="64557"/>
                  <a:pt x="126268" y="67976"/>
                  <a:pt x="123825" y="70907"/>
                </a:cubicBezTo>
                <a:cubicBezTo>
                  <a:pt x="120950" y="74356"/>
                  <a:pt x="116481" y="76507"/>
                  <a:pt x="114300" y="80432"/>
                </a:cubicBezTo>
                <a:cubicBezTo>
                  <a:pt x="111049" y="86283"/>
                  <a:pt x="110067" y="93132"/>
                  <a:pt x="107950" y="99482"/>
                </a:cubicBezTo>
                <a:cubicBezTo>
                  <a:pt x="105537" y="106722"/>
                  <a:pt x="99483" y="112182"/>
                  <a:pt x="95250" y="118532"/>
                </a:cubicBezTo>
                <a:cubicBezTo>
                  <a:pt x="91537" y="124101"/>
                  <a:pt x="92613" y="132013"/>
                  <a:pt x="88900" y="137582"/>
                </a:cubicBezTo>
                <a:cubicBezTo>
                  <a:pt x="70702" y="164879"/>
                  <a:pt x="92520" y="130342"/>
                  <a:pt x="79375" y="156632"/>
                </a:cubicBezTo>
                <a:cubicBezTo>
                  <a:pt x="77668" y="160045"/>
                  <a:pt x="74575" y="162670"/>
                  <a:pt x="73025" y="166157"/>
                </a:cubicBezTo>
                <a:cubicBezTo>
                  <a:pt x="70307" y="172274"/>
                  <a:pt x="68792" y="178857"/>
                  <a:pt x="66675" y="185207"/>
                </a:cubicBezTo>
                <a:lnTo>
                  <a:pt x="63500" y="194732"/>
                </a:lnTo>
                <a:cubicBezTo>
                  <a:pt x="61087" y="201972"/>
                  <a:pt x="50800" y="213782"/>
                  <a:pt x="50800" y="213782"/>
                </a:cubicBezTo>
                <a:cubicBezTo>
                  <a:pt x="49783" y="217851"/>
                  <a:pt x="46727" y="231452"/>
                  <a:pt x="44450" y="236007"/>
                </a:cubicBezTo>
                <a:cubicBezTo>
                  <a:pt x="42743" y="239420"/>
                  <a:pt x="39807" y="242119"/>
                  <a:pt x="38100" y="245532"/>
                </a:cubicBezTo>
                <a:cubicBezTo>
                  <a:pt x="24955" y="271822"/>
                  <a:pt x="46773" y="237285"/>
                  <a:pt x="28575" y="264582"/>
                </a:cubicBezTo>
                <a:cubicBezTo>
                  <a:pt x="20912" y="302896"/>
                  <a:pt x="25638" y="286093"/>
                  <a:pt x="15875" y="315382"/>
                </a:cubicBezTo>
                <a:cubicBezTo>
                  <a:pt x="14668" y="319002"/>
                  <a:pt x="11232" y="321494"/>
                  <a:pt x="9525" y="324907"/>
                </a:cubicBezTo>
                <a:cubicBezTo>
                  <a:pt x="8028" y="327900"/>
                  <a:pt x="7408" y="331257"/>
                  <a:pt x="6350" y="334432"/>
                </a:cubicBezTo>
                <a:cubicBezTo>
                  <a:pt x="5292" y="342899"/>
                  <a:pt x="4701" y="351437"/>
                  <a:pt x="3175" y="359832"/>
                </a:cubicBezTo>
                <a:cubicBezTo>
                  <a:pt x="2576" y="363125"/>
                  <a:pt x="0" y="366010"/>
                  <a:pt x="0" y="369357"/>
                </a:cubicBezTo>
                <a:cubicBezTo>
                  <a:pt x="0" y="391078"/>
                  <a:pt x="2017" y="414369"/>
                  <a:pt x="6350" y="436032"/>
                </a:cubicBezTo>
                <a:cubicBezTo>
                  <a:pt x="8749" y="448028"/>
                  <a:pt x="11825" y="455633"/>
                  <a:pt x="15875" y="467782"/>
                </a:cubicBezTo>
                <a:cubicBezTo>
                  <a:pt x="17082" y="471402"/>
                  <a:pt x="20675" y="473820"/>
                  <a:pt x="22225" y="477307"/>
                </a:cubicBezTo>
                <a:cubicBezTo>
                  <a:pt x="24943" y="483424"/>
                  <a:pt x="26458" y="490007"/>
                  <a:pt x="28575" y="496357"/>
                </a:cubicBezTo>
                <a:cubicBezTo>
                  <a:pt x="29782" y="499977"/>
                  <a:pt x="33218" y="502469"/>
                  <a:pt x="34925" y="505882"/>
                </a:cubicBezTo>
                <a:cubicBezTo>
                  <a:pt x="36422" y="508875"/>
                  <a:pt x="36603" y="512414"/>
                  <a:pt x="38100" y="515407"/>
                </a:cubicBezTo>
                <a:cubicBezTo>
                  <a:pt x="39807" y="518820"/>
                  <a:pt x="42900" y="521445"/>
                  <a:pt x="44450" y="524932"/>
                </a:cubicBezTo>
                <a:cubicBezTo>
                  <a:pt x="47168" y="531049"/>
                  <a:pt x="47087" y="538413"/>
                  <a:pt x="50800" y="543982"/>
                </a:cubicBezTo>
                <a:cubicBezTo>
                  <a:pt x="52917" y="547157"/>
                  <a:pt x="55443" y="550094"/>
                  <a:pt x="57150" y="553507"/>
                </a:cubicBezTo>
                <a:cubicBezTo>
                  <a:pt x="58647" y="556500"/>
                  <a:pt x="58469" y="560247"/>
                  <a:pt x="60325" y="563032"/>
                </a:cubicBezTo>
                <a:cubicBezTo>
                  <a:pt x="62816" y="566768"/>
                  <a:pt x="66675" y="569382"/>
                  <a:pt x="69850" y="572557"/>
                </a:cubicBezTo>
                <a:cubicBezTo>
                  <a:pt x="77830" y="596498"/>
                  <a:pt x="67065" y="566988"/>
                  <a:pt x="79375" y="591607"/>
                </a:cubicBezTo>
                <a:cubicBezTo>
                  <a:pt x="80872" y="594600"/>
                  <a:pt x="80925" y="598206"/>
                  <a:pt x="82550" y="601132"/>
                </a:cubicBezTo>
                <a:cubicBezTo>
                  <a:pt x="86256" y="607803"/>
                  <a:pt x="91017" y="613832"/>
                  <a:pt x="95250" y="620182"/>
                </a:cubicBezTo>
                <a:cubicBezTo>
                  <a:pt x="97367" y="623357"/>
                  <a:pt x="98902" y="627009"/>
                  <a:pt x="101600" y="629707"/>
                </a:cubicBezTo>
                <a:lnTo>
                  <a:pt x="111125" y="639232"/>
                </a:lnTo>
                <a:cubicBezTo>
                  <a:pt x="117306" y="657775"/>
                  <a:pt x="109464" y="640746"/>
                  <a:pt x="123825" y="655107"/>
                </a:cubicBezTo>
                <a:cubicBezTo>
                  <a:pt x="126523" y="657805"/>
                  <a:pt x="128468" y="661219"/>
                  <a:pt x="130175" y="664632"/>
                </a:cubicBezTo>
                <a:cubicBezTo>
                  <a:pt x="131672" y="667625"/>
                  <a:pt x="130983" y="671790"/>
                  <a:pt x="133350" y="674157"/>
                </a:cubicBezTo>
                <a:cubicBezTo>
                  <a:pt x="135717" y="676524"/>
                  <a:pt x="139700" y="676274"/>
                  <a:pt x="142875" y="677332"/>
                </a:cubicBezTo>
                <a:cubicBezTo>
                  <a:pt x="146050" y="679449"/>
                  <a:pt x="150016" y="680702"/>
                  <a:pt x="152400" y="683682"/>
                </a:cubicBezTo>
                <a:cubicBezTo>
                  <a:pt x="164715" y="699076"/>
                  <a:pt x="144318" y="689455"/>
                  <a:pt x="165100" y="696382"/>
                </a:cubicBezTo>
                <a:cubicBezTo>
                  <a:pt x="186517" y="717799"/>
                  <a:pt x="175631" y="712592"/>
                  <a:pt x="193675" y="718607"/>
                </a:cubicBezTo>
                <a:cubicBezTo>
                  <a:pt x="200025" y="722840"/>
                  <a:pt x="207329" y="725911"/>
                  <a:pt x="212725" y="731307"/>
                </a:cubicBezTo>
                <a:cubicBezTo>
                  <a:pt x="224617" y="743199"/>
                  <a:pt x="217990" y="739412"/>
                  <a:pt x="231775" y="744007"/>
                </a:cubicBezTo>
                <a:cubicBezTo>
                  <a:pt x="233892" y="747182"/>
                  <a:pt x="235253" y="751019"/>
                  <a:pt x="238125" y="753532"/>
                </a:cubicBezTo>
                <a:lnTo>
                  <a:pt x="266700" y="772582"/>
                </a:lnTo>
                <a:lnTo>
                  <a:pt x="276225" y="778932"/>
                </a:lnTo>
                <a:lnTo>
                  <a:pt x="285750" y="785282"/>
                </a:lnTo>
                <a:cubicBezTo>
                  <a:pt x="320675" y="784224"/>
                  <a:pt x="355632" y="783943"/>
                  <a:pt x="390525" y="782107"/>
                </a:cubicBezTo>
                <a:cubicBezTo>
                  <a:pt x="395914" y="781823"/>
                  <a:pt x="401004" y="778932"/>
                  <a:pt x="406400" y="778932"/>
                </a:cubicBezTo>
                <a:cubicBezTo>
                  <a:pt x="426536" y="778932"/>
                  <a:pt x="446617" y="781049"/>
                  <a:pt x="466725" y="782107"/>
                </a:cubicBezTo>
                <a:cubicBezTo>
                  <a:pt x="475217" y="783522"/>
                  <a:pt x="492775" y="786238"/>
                  <a:pt x="501650" y="788457"/>
                </a:cubicBezTo>
                <a:cubicBezTo>
                  <a:pt x="504897" y="789269"/>
                  <a:pt x="507957" y="790713"/>
                  <a:pt x="511175" y="791632"/>
                </a:cubicBezTo>
                <a:cubicBezTo>
                  <a:pt x="515371" y="792831"/>
                  <a:pt x="519695" y="793553"/>
                  <a:pt x="523875" y="794807"/>
                </a:cubicBezTo>
                <a:cubicBezTo>
                  <a:pt x="534461" y="797983"/>
                  <a:pt x="544648" y="802502"/>
                  <a:pt x="555625" y="804332"/>
                </a:cubicBezTo>
                <a:cubicBezTo>
                  <a:pt x="569108" y="806579"/>
                  <a:pt x="600546" y="809459"/>
                  <a:pt x="612775" y="810682"/>
                </a:cubicBezTo>
                <a:lnTo>
                  <a:pt x="631825" y="817032"/>
                </a:lnTo>
                <a:lnTo>
                  <a:pt x="641350" y="820207"/>
                </a:lnTo>
                <a:cubicBezTo>
                  <a:pt x="656444" y="830270"/>
                  <a:pt x="647255" y="825350"/>
                  <a:pt x="669925" y="832907"/>
                </a:cubicBezTo>
                <a:lnTo>
                  <a:pt x="679450" y="836082"/>
                </a:lnTo>
                <a:cubicBezTo>
                  <a:pt x="685800" y="840315"/>
                  <a:pt x="691260" y="846369"/>
                  <a:pt x="698500" y="848782"/>
                </a:cubicBezTo>
                <a:lnTo>
                  <a:pt x="746125" y="864657"/>
                </a:lnTo>
                <a:cubicBezTo>
                  <a:pt x="751245" y="866364"/>
                  <a:pt x="756708" y="866774"/>
                  <a:pt x="762000" y="867832"/>
                </a:cubicBezTo>
                <a:cubicBezTo>
                  <a:pt x="773642" y="866774"/>
                  <a:pt x="785413" y="866688"/>
                  <a:pt x="796925" y="864657"/>
                </a:cubicBezTo>
                <a:cubicBezTo>
                  <a:pt x="803517" y="863494"/>
                  <a:pt x="809625" y="860424"/>
                  <a:pt x="815975" y="858307"/>
                </a:cubicBezTo>
                <a:lnTo>
                  <a:pt x="825500" y="855132"/>
                </a:lnTo>
                <a:lnTo>
                  <a:pt x="854075" y="836082"/>
                </a:lnTo>
                <a:cubicBezTo>
                  <a:pt x="859644" y="832369"/>
                  <a:pt x="873125" y="829732"/>
                  <a:pt x="873125" y="829732"/>
                </a:cubicBezTo>
                <a:lnTo>
                  <a:pt x="901700" y="810682"/>
                </a:lnTo>
                <a:cubicBezTo>
                  <a:pt x="907269" y="806969"/>
                  <a:pt x="920750" y="804332"/>
                  <a:pt x="920750" y="804332"/>
                </a:cubicBezTo>
                <a:cubicBezTo>
                  <a:pt x="923925" y="801157"/>
                  <a:pt x="927784" y="798543"/>
                  <a:pt x="930275" y="794807"/>
                </a:cubicBezTo>
                <a:cubicBezTo>
                  <a:pt x="932131" y="792022"/>
                  <a:pt x="931953" y="788275"/>
                  <a:pt x="933450" y="785282"/>
                </a:cubicBezTo>
                <a:cubicBezTo>
                  <a:pt x="935157" y="781869"/>
                  <a:pt x="938250" y="779244"/>
                  <a:pt x="939800" y="775757"/>
                </a:cubicBezTo>
                <a:cubicBezTo>
                  <a:pt x="954913" y="741752"/>
                  <a:pt x="938129" y="768738"/>
                  <a:pt x="952500" y="747182"/>
                </a:cubicBezTo>
                <a:cubicBezTo>
                  <a:pt x="953517" y="743113"/>
                  <a:pt x="956573" y="729512"/>
                  <a:pt x="958850" y="724957"/>
                </a:cubicBezTo>
                <a:cubicBezTo>
                  <a:pt x="960557" y="721544"/>
                  <a:pt x="963650" y="718919"/>
                  <a:pt x="965200" y="715432"/>
                </a:cubicBezTo>
                <a:cubicBezTo>
                  <a:pt x="972108" y="699889"/>
                  <a:pt x="970462" y="697890"/>
                  <a:pt x="974725" y="683682"/>
                </a:cubicBezTo>
                <a:cubicBezTo>
                  <a:pt x="976648" y="677271"/>
                  <a:pt x="978958" y="670982"/>
                  <a:pt x="981075" y="664632"/>
                </a:cubicBezTo>
                <a:cubicBezTo>
                  <a:pt x="982282" y="661012"/>
                  <a:pt x="985875" y="658594"/>
                  <a:pt x="987425" y="655107"/>
                </a:cubicBezTo>
                <a:cubicBezTo>
                  <a:pt x="990143" y="648990"/>
                  <a:pt x="993775" y="636057"/>
                  <a:pt x="993775" y="636057"/>
                </a:cubicBezTo>
                <a:cubicBezTo>
                  <a:pt x="997780" y="604015"/>
                  <a:pt x="994252" y="618752"/>
                  <a:pt x="1003300" y="591607"/>
                </a:cubicBezTo>
                <a:lnTo>
                  <a:pt x="1006475" y="582082"/>
                </a:lnTo>
                <a:cubicBezTo>
                  <a:pt x="1004527" y="558704"/>
                  <a:pt x="1005090" y="547967"/>
                  <a:pt x="1000125" y="528107"/>
                </a:cubicBezTo>
                <a:cubicBezTo>
                  <a:pt x="999313" y="524860"/>
                  <a:pt x="998008" y="521757"/>
                  <a:pt x="996950" y="518582"/>
                </a:cubicBezTo>
                <a:cubicBezTo>
                  <a:pt x="995892" y="503765"/>
                  <a:pt x="995979" y="488822"/>
                  <a:pt x="993775" y="474132"/>
                </a:cubicBezTo>
                <a:cubicBezTo>
                  <a:pt x="989494" y="445594"/>
                  <a:pt x="989270" y="463996"/>
                  <a:pt x="981075" y="445557"/>
                </a:cubicBezTo>
                <a:cubicBezTo>
                  <a:pt x="978357" y="439440"/>
                  <a:pt x="976842" y="432857"/>
                  <a:pt x="974725" y="426507"/>
                </a:cubicBezTo>
                <a:lnTo>
                  <a:pt x="955675" y="397932"/>
                </a:lnTo>
                <a:cubicBezTo>
                  <a:pt x="953819" y="395147"/>
                  <a:pt x="953997" y="391400"/>
                  <a:pt x="952500" y="388407"/>
                </a:cubicBezTo>
                <a:cubicBezTo>
                  <a:pt x="950793" y="384994"/>
                  <a:pt x="947857" y="382295"/>
                  <a:pt x="946150" y="378882"/>
                </a:cubicBezTo>
                <a:cubicBezTo>
                  <a:pt x="944653" y="375889"/>
                  <a:pt x="944600" y="372283"/>
                  <a:pt x="942975" y="369357"/>
                </a:cubicBezTo>
                <a:cubicBezTo>
                  <a:pt x="939269" y="362686"/>
                  <a:pt x="932688" y="357547"/>
                  <a:pt x="930275" y="350307"/>
                </a:cubicBezTo>
                <a:cubicBezTo>
                  <a:pt x="925680" y="336522"/>
                  <a:pt x="929467" y="343149"/>
                  <a:pt x="917575" y="331257"/>
                </a:cubicBezTo>
                <a:cubicBezTo>
                  <a:pt x="911394" y="312714"/>
                  <a:pt x="919236" y="329743"/>
                  <a:pt x="904875" y="315382"/>
                </a:cubicBezTo>
                <a:cubicBezTo>
                  <a:pt x="883708" y="294215"/>
                  <a:pt x="914400" y="316440"/>
                  <a:pt x="889000" y="299507"/>
                </a:cubicBezTo>
                <a:cubicBezTo>
                  <a:pt x="886908" y="293232"/>
                  <a:pt x="885070" y="284933"/>
                  <a:pt x="879475" y="280457"/>
                </a:cubicBezTo>
                <a:cubicBezTo>
                  <a:pt x="876862" y="278366"/>
                  <a:pt x="873125" y="278340"/>
                  <a:pt x="869950" y="277282"/>
                </a:cubicBezTo>
                <a:lnTo>
                  <a:pt x="850900" y="264582"/>
                </a:lnTo>
                <a:cubicBezTo>
                  <a:pt x="847725" y="262465"/>
                  <a:pt x="845077" y="259157"/>
                  <a:pt x="841375" y="258232"/>
                </a:cubicBezTo>
                <a:cubicBezTo>
                  <a:pt x="826622" y="254544"/>
                  <a:pt x="850900" y="243945"/>
                  <a:pt x="841375" y="239182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9" name="フリーフォーム 108"/>
          <p:cNvSpPr/>
          <p:nvPr/>
        </p:nvSpPr>
        <p:spPr>
          <a:xfrm>
            <a:off x="3703223" y="1261296"/>
            <a:ext cx="1006475" cy="867832"/>
          </a:xfrm>
          <a:custGeom>
            <a:avLst/>
            <a:gdLst>
              <a:gd name="connsiteX0" fmla="*/ 841375 w 1006475"/>
              <a:gd name="connsiteY0" fmla="*/ 239182 h 867832"/>
              <a:gd name="connsiteX1" fmla="*/ 784225 w 1006475"/>
              <a:gd name="connsiteY1" fmla="*/ 229657 h 867832"/>
              <a:gd name="connsiteX2" fmla="*/ 765175 w 1006475"/>
              <a:gd name="connsiteY2" fmla="*/ 223307 h 867832"/>
              <a:gd name="connsiteX3" fmla="*/ 755650 w 1006475"/>
              <a:gd name="connsiteY3" fmla="*/ 216957 h 867832"/>
              <a:gd name="connsiteX4" fmla="*/ 746125 w 1006475"/>
              <a:gd name="connsiteY4" fmla="*/ 213782 h 867832"/>
              <a:gd name="connsiteX5" fmla="*/ 727075 w 1006475"/>
              <a:gd name="connsiteY5" fmla="*/ 201082 h 867832"/>
              <a:gd name="connsiteX6" fmla="*/ 720725 w 1006475"/>
              <a:gd name="connsiteY6" fmla="*/ 191557 h 867832"/>
              <a:gd name="connsiteX7" fmla="*/ 711200 w 1006475"/>
              <a:gd name="connsiteY7" fmla="*/ 185207 h 867832"/>
              <a:gd name="connsiteX8" fmla="*/ 708025 w 1006475"/>
              <a:gd name="connsiteY8" fmla="*/ 175682 h 867832"/>
              <a:gd name="connsiteX9" fmla="*/ 688975 w 1006475"/>
              <a:gd name="connsiteY9" fmla="*/ 162982 h 867832"/>
              <a:gd name="connsiteX10" fmla="*/ 669925 w 1006475"/>
              <a:gd name="connsiteY10" fmla="*/ 153457 h 867832"/>
              <a:gd name="connsiteX11" fmla="*/ 660400 w 1006475"/>
              <a:gd name="connsiteY11" fmla="*/ 147107 h 867832"/>
              <a:gd name="connsiteX12" fmla="*/ 641350 w 1006475"/>
              <a:gd name="connsiteY12" fmla="*/ 143932 h 867832"/>
              <a:gd name="connsiteX13" fmla="*/ 625475 w 1006475"/>
              <a:gd name="connsiteY13" fmla="*/ 140757 h 867832"/>
              <a:gd name="connsiteX14" fmla="*/ 596900 w 1006475"/>
              <a:gd name="connsiteY14" fmla="*/ 124882 h 867832"/>
              <a:gd name="connsiteX15" fmla="*/ 581025 w 1006475"/>
              <a:gd name="connsiteY15" fmla="*/ 109007 h 867832"/>
              <a:gd name="connsiteX16" fmla="*/ 574675 w 1006475"/>
              <a:gd name="connsiteY16" fmla="*/ 99482 h 867832"/>
              <a:gd name="connsiteX17" fmla="*/ 546100 w 1006475"/>
              <a:gd name="connsiteY17" fmla="*/ 77257 h 867832"/>
              <a:gd name="connsiteX18" fmla="*/ 530225 w 1006475"/>
              <a:gd name="connsiteY18" fmla="*/ 58207 h 867832"/>
              <a:gd name="connsiteX19" fmla="*/ 520700 w 1006475"/>
              <a:gd name="connsiteY19" fmla="*/ 55032 h 867832"/>
              <a:gd name="connsiteX20" fmla="*/ 498475 w 1006475"/>
              <a:gd name="connsiteY20" fmla="*/ 32807 h 867832"/>
              <a:gd name="connsiteX21" fmla="*/ 488950 w 1006475"/>
              <a:gd name="connsiteY21" fmla="*/ 26457 h 867832"/>
              <a:gd name="connsiteX22" fmla="*/ 479425 w 1006475"/>
              <a:gd name="connsiteY22" fmla="*/ 16932 h 867832"/>
              <a:gd name="connsiteX23" fmla="*/ 460375 w 1006475"/>
              <a:gd name="connsiteY23" fmla="*/ 10582 h 867832"/>
              <a:gd name="connsiteX24" fmla="*/ 450850 w 1006475"/>
              <a:gd name="connsiteY24" fmla="*/ 4232 h 867832"/>
              <a:gd name="connsiteX25" fmla="*/ 390525 w 1006475"/>
              <a:gd name="connsiteY25" fmla="*/ 4232 h 867832"/>
              <a:gd name="connsiteX26" fmla="*/ 374650 w 1006475"/>
              <a:gd name="connsiteY26" fmla="*/ 7407 h 867832"/>
              <a:gd name="connsiteX27" fmla="*/ 361950 w 1006475"/>
              <a:gd name="connsiteY27" fmla="*/ 10582 h 867832"/>
              <a:gd name="connsiteX28" fmla="*/ 327025 w 1006475"/>
              <a:gd name="connsiteY28" fmla="*/ 13757 h 867832"/>
              <a:gd name="connsiteX29" fmla="*/ 209550 w 1006475"/>
              <a:gd name="connsiteY29" fmla="*/ 20107 h 867832"/>
              <a:gd name="connsiteX30" fmla="*/ 174625 w 1006475"/>
              <a:gd name="connsiteY30" fmla="*/ 26457 h 867832"/>
              <a:gd name="connsiteX31" fmla="*/ 155575 w 1006475"/>
              <a:gd name="connsiteY31" fmla="*/ 39157 h 867832"/>
              <a:gd name="connsiteX32" fmla="*/ 149225 w 1006475"/>
              <a:gd name="connsiteY32" fmla="*/ 48682 h 867832"/>
              <a:gd name="connsiteX33" fmla="*/ 130175 w 1006475"/>
              <a:gd name="connsiteY33" fmla="*/ 61382 h 867832"/>
              <a:gd name="connsiteX34" fmla="*/ 123825 w 1006475"/>
              <a:gd name="connsiteY34" fmla="*/ 70907 h 867832"/>
              <a:gd name="connsiteX35" fmla="*/ 114300 w 1006475"/>
              <a:gd name="connsiteY35" fmla="*/ 80432 h 867832"/>
              <a:gd name="connsiteX36" fmla="*/ 107950 w 1006475"/>
              <a:gd name="connsiteY36" fmla="*/ 99482 h 867832"/>
              <a:gd name="connsiteX37" fmla="*/ 95250 w 1006475"/>
              <a:gd name="connsiteY37" fmla="*/ 118532 h 867832"/>
              <a:gd name="connsiteX38" fmla="*/ 88900 w 1006475"/>
              <a:gd name="connsiteY38" fmla="*/ 137582 h 867832"/>
              <a:gd name="connsiteX39" fmla="*/ 79375 w 1006475"/>
              <a:gd name="connsiteY39" fmla="*/ 156632 h 867832"/>
              <a:gd name="connsiteX40" fmla="*/ 73025 w 1006475"/>
              <a:gd name="connsiteY40" fmla="*/ 166157 h 867832"/>
              <a:gd name="connsiteX41" fmla="*/ 66675 w 1006475"/>
              <a:gd name="connsiteY41" fmla="*/ 185207 h 867832"/>
              <a:gd name="connsiteX42" fmla="*/ 63500 w 1006475"/>
              <a:gd name="connsiteY42" fmla="*/ 194732 h 867832"/>
              <a:gd name="connsiteX43" fmla="*/ 50800 w 1006475"/>
              <a:gd name="connsiteY43" fmla="*/ 213782 h 867832"/>
              <a:gd name="connsiteX44" fmla="*/ 44450 w 1006475"/>
              <a:gd name="connsiteY44" fmla="*/ 236007 h 867832"/>
              <a:gd name="connsiteX45" fmla="*/ 38100 w 1006475"/>
              <a:gd name="connsiteY45" fmla="*/ 245532 h 867832"/>
              <a:gd name="connsiteX46" fmla="*/ 28575 w 1006475"/>
              <a:gd name="connsiteY46" fmla="*/ 264582 h 867832"/>
              <a:gd name="connsiteX47" fmla="*/ 15875 w 1006475"/>
              <a:gd name="connsiteY47" fmla="*/ 315382 h 867832"/>
              <a:gd name="connsiteX48" fmla="*/ 9525 w 1006475"/>
              <a:gd name="connsiteY48" fmla="*/ 324907 h 867832"/>
              <a:gd name="connsiteX49" fmla="*/ 6350 w 1006475"/>
              <a:gd name="connsiteY49" fmla="*/ 334432 h 867832"/>
              <a:gd name="connsiteX50" fmla="*/ 3175 w 1006475"/>
              <a:gd name="connsiteY50" fmla="*/ 359832 h 867832"/>
              <a:gd name="connsiteX51" fmla="*/ 0 w 1006475"/>
              <a:gd name="connsiteY51" fmla="*/ 369357 h 867832"/>
              <a:gd name="connsiteX52" fmla="*/ 6350 w 1006475"/>
              <a:gd name="connsiteY52" fmla="*/ 436032 h 867832"/>
              <a:gd name="connsiteX53" fmla="*/ 15875 w 1006475"/>
              <a:gd name="connsiteY53" fmla="*/ 467782 h 867832"/>
              <a:gd name="connsiteX54" fmla="*/ 22225 w 1006475"/>
              <a:gd name="connsiteY54" fmla="*/ 477307 h 867832"/>
              <a:gd name="connsiteX55" fmla="*/ 28575 w 1006475"/>
              <a:gd name="connsiteY55" fmla="*/ 496357 h 867832"/>
              <a:gd name="connsiteX56" fmla="*/ 34925 w 1006475"/>
              <a:gd name="connsiteY56" fmla="*/ 505882 h 867832"/>
              <a:gd name="connsiteX57" fmla="*/ 38100 w 1006475"/>
              <a:gd name="connsiteY57" fmla="*/ 515407 h 867832"/>
              <a:gd name="connsiteX58" fmla="*/ 44450 w 1006475"/>
              <a:gd name="connsiteY58" fmla="*/ 524932 h 867832"/>
              <a:gd name="connsiteX59" fmla="*/ 50800 w 1006475"/>
              <a:gd name="connsiteY59" fmla="*/ 543982 h 867832"/>
              <a:gd name="connsiteX60" fmla="*/ 57150 w 1006475"/>
              <a:gd name="connsiteY60" fmla="*/ 553507 h 867832"/>
              <a:gd name="connsiteX61" fmla="*/ 60325 w 1006475"/>
              <a:gd name="connsiteY61" fmla="*/ 563032 h 867832"/>
              <a:gd name="connsiteX62" fmla="*/ 69850 w 1006475"/>
              <a:gd name="connsiteY62" fmla="*/ 572557 h 867832"/>
              <a:gd name="connsiteX63" fmla="*/ 79375 w 1006475"/>
              <a:gd name="connsiteY63" fmla="*/ 591607 h 867832"/>
              <a:gd name="connsiteX64" fmla="*/ 82550 w 1006475"/>
              <a:gd name="connsiteY64" fmla="*/ 601132 h 867832"/>
              <a:gd name="connsiteX65" fmla="*/ 95250 w 1006475"/>
              <a:gd name="connsiteY65" fmla="*/ 620182 h 867832"/>
              <a:gd name="connsiteX66" fmla="*/ 101600 w 1006475"/>
              <a:gd name="connsiteY66" fmla="*/ 629707 h 867832"/>
              <a:gd name="connsiteX67" fmla="*/ 111125 w 1006475"/>
              <a:gd name="connsiteY67" fmla="*/ 639232 h 867832"/>
              <a:gd name="connsiteX68" fmla="*/ 123825 w 1006475"/>
              <a:gd name="connsiteY68" fmla="*/ 655107 h 867832"/>
              <a:gd name="connsiteX69" fmla="*/ 130175 w 1006475"/>
              <a:gd name="connsiteY69" fmla="*/ 664632 h 867832"/>
              <a:gd name="connsiteX70" fmla="*/ 133350 w 1006475"/>
              <a:gd name="connsiteY70" fmla="*/ 674157 h 867832"/>
              <a:gd name="connsiteX71" fmla="*/ 142875 w 1006475"/>
              <a:gd name="connsiteY71" fmla="*/ 677332 h 867832"/>
              <a:gd name="connsiteX72" fmla="*/ 152400 w 1006475"/>
              <a:gd name="connsiteY72" fmla="*/ 683682 h 867832"/>
              <a:gd name="connsiteX73" fmla="*/ 165100 w 1006475"/>
              <a:gd name="connsiteY73" fmla="*/ 696382 h 867832"/>
              <a:gd name="connsiteX74" fmla="*/ 193675 w 1006475"/>
              <a:gd name="connsiteY74" fmla="*/ 718607 h 867832"/>
              <a:gd name="connsiteX75" fmla="*/ 212725 w 1006475"/>
              <a:gd name="connsiteY75" fmla="*/ 731307 h 867832"/>
              <a:gd name="connsiteX76" fmla="*/ 231775 w 1006475"/>
              <a:gd name="connsiteY76" fmla="*/ 744007 h 867832"/>
              <a:gd name="connsiteX77" fmla="*/ 238125 w 1006475"/>
              <a:gd name="connsiteY77" fmla="*/ 753532 h 867832"/>
              <a:gd name="connsiteX78" fmla="*/ 266700 w 1006475"/>
              <a:gd name="connsiteY78" fmla="*/ 772582 h 867832"/>
              <a:gd name="connsiteX79" fmla="*/ 276225 w 1006475"/>
              <a:gd name="connsiteY79" fmla="*/ 778932 h 867832"/>
              <a:gd name="connsiteX80" fmla="*/ 285750 w 1006475"/>
              <a:gd name="connsiteY80" fmla="*/ 785282 h 867832"/>
              <a:gd name="connsiteX81" fmla="*/ 390525 w 1006475"/>
              <a:gd name="connsiteY81" fmla="*/ 782107 h 867832"/>
              <a:gd name="connsiteX82" fmla="*/ 406400 w 1006475"/>
              <a:gd name="connsiteY82" fmla="*/ 778932 h 867832"/>
              <a:gd name="connsiteX83" fmla="*/ 466725 w 1006475"/>
              <a:gd name="connsiteY83" fmla="*/ 782107 h 867832"/>
              <a:gd name="connsiteX84" fmla="*/ 501650 w 1006475"/>
              <a:gd name="connsiteY84" fmla="*/ 788457 h 867832"/>
              <a:gd name="connsiteX85" fmla="*/ 511175 w 1006475"/>
              <a:gd name="connsiteY85" fmla="*/ 791632 h 867832"/>
              <a:gd name="connsiteX86" fmla="*/ 523875 w 1006475"/>
              <a:gd name="connsiteY86" fmla="*/ 794807 h 867832"/>
              <a:gd name="connsiteX87" fmla="*/ 555625 w 1006475"/>
              <a:gd name="connsiteY87" fmla="*/ 804332 h 867832"/>
              <a:gd name="connsiteX88" fmla="*/ 612775 w 1006475"/>
              <a:gd name="connsiteY88" fmla="*/ 810682 h 867832"/>
              <a:gd name="connsiteX89" fmla="*/ 631825 w 1006475"/>
              <a:gd name="connsiteY89" fmla="*/ 817032 h 867832"/>
              <a:gd name="connsiteX90" fmla="*/ 641350 w 1006475"/>
              <a:gd name="connsiteY90" fmla="*/ 820207 h 867832"/>
              <a:gd name="connsiteX91" fmla="*/ 669925 w 1006475"/>
              <a:gd name="connsiteY91" fmla="*/ 832907 h 867832"/>
              <a:gd name="connsiteX92" fmla="*/ 679450 w 1006475"/>
              <a:gd name="connsiteY92" fmla="*/ 836082 h 867832"/>
              <a:gd name="connsiteX93" fmla="*/ 698500 w 1006475"/>
              <a:gd name="connsiteY93" fmla="*/ 848782 h 867832"/>
              <a:gd name="connsiteX94" fmla="*/ 746125 w 1006475"/>
              <a:gd name="connsiteY94" fmla="*/ 864657 h 867832"/>
              <a:gd name="connsiteX95" fmla="*/ 762000 w 1006475"/>
              <a:gd name="connsiteY95" fmla="*/ 867832 h 867832"/>
              <a:gd name="connsiteX96" fmla="*/ 796925 w 1006475"/>
              <a:gd name="connsiteY96" fmla="*/ 864657 h 867832"/>
              <a:gd name="connsiteX97" fmla="*/ 815975 w 1006475"/>
              <a:gd name="connsiteY97" fmla="*/ 858307 h 867832"/>
              <a:gd name="connsiteX98" fmla="*/ 825500 w 1006475"/>
              <a:gd name="connsiteY98" fmla="*/ 855132 h 867832"/>
              <a:gd name="connsiteX99" fmla="*/ 854075 w 1006475"/>
              <a:gd name="connsiteY99" fmla="*/ 836082 h 867832"/>
              <a:gd name="connsiteX100" fmla="*/ 873125 w 1006475"/>
              <a:gd name="connsiteY100" fmla="*/ 829732 h 867832"/>
              <a:gd name="connsiteX101" fmla="*/ 901700 w 1006475"/>
              <a:gd name="connsiteY101" fmla="*/ 810682 h 867832"/>
              <a:gd name="connsiteX102" fmla="*/ 920750 w 1006475"/>
              <a:gd name="connsiteY102" fmla="*/ 804332 h 867832"/>
              <a:gd name="connsiteX103" fmla="*/ 930275 w 1006475"/>
              <a:gd name="connsiteY103" fmla="*/ 794807 h 867832"/>
              <a:gd name="connsiteX104" fmla="*/ 933450 w 1006475"/>
              <a:gd name="connsiteY104" fmla="*/ 785282 h 867832"/>
              <a:gd name="connsiteX105" fmla="*/ 939800 w 1006475"/>
              <a:gd name="connsiteY105" fmla="*/ 775757 h 867832"/>
              <a:gd name="connsiteX106" fmla="*/ 952500 w 1006475"/>
              <a:gd name="connsiteY106" fmla="*/ 747182 h 867832"/>
              <a:gd name="connsiteX107" fmla="*/ 958850 w 1006475"/>
              <a:gd name="connsiteY107" fmla="*/ 724957 h 867832"/>
              <a:gd name="connsiteX108" fmla="*/ 965200 w 1006475"/>
              <a:gd name="connsiteY108" fmla="*/ 715432 h 867832"/>
              <a:gd name="connsiteX109" fmla="*/ 974725 w 1006475"/>
              <a:gd name="connsiteY109" fmla="*/ 683682 h 867832"/>
              <a:gd name="connsiteX110" fmla="*/ 981075 w 1006475"/>
              <a:gd name="connsiteY110" fmla="*/ 664632 h 867832"/>
              <a:gd name="connsiteX111" fmla="*/ 987425 w 1006475"/>
              <a:gd name="connsiteY111" fmla="*/ 655107 h 867832"/>
              <a:gd name="connsiteX112" fmla="*/ 993775 w 1006475"/>
              <a:gd name="connsiteY112" fmla="*/ 636057 h 867832"/>
              <a:gd name="connsiteX113" fmla="*/ 1003300 w 1006475"/>
              <a:gd name="connsiteY113" fmla="*/ 591607 h 867832"/>
              <a:gd name="connsiteX114" fmla="*/ 1006475 w 1006475"/>
              <a:gd name="connsiteY114" fmla="*/ 582082 h 867832"/>
              <a:gd name="connsiteX115" fmla="*/ 1000125 w 1006475"/>
              <a:gd name="connsiteY115" fmla="*/ 528107 h 867832"/>
              <a:gd name="connsiteX116" fmla="*/ 996950 w 1006475"/>
              <a:gd name="connsiteY116" fmla="*/ 518582 h 867832"/>
              <a:gd name="connsiteX117" fmla="*/ 993775 w 1006475"/>
              <a:gd name="connsiteY117" fmla="*/ 474132 h 867832"/>
              <a:gd name="connsiteX118" fmla="*/ 981075 w 1006475"/>
              <a:gd name="connsiteY118" fmla="*/ 445557 h 867832"/>
              <a:gd name="connsiteX119" fmla="*/ 974725 w 1006475"/>
              <a:gd name="connsiteY119" fmla="*/ 426507 h 867832"/>
              <a:gd name="connsiteX120" fmla="*/ 955675 w 1006475"/>
              <a:gd name="connsiteY120" fmla="*/ 397932 h 867832"/>
              <a:gd name="connsiteX121" fmla="*/ 952500 w 1006475"/>
              <a:gd name="connsiteY121" fmla="*/ 388407 h 867832"/>
              <a:gd name="connsiteX122" fmla="*/ 946150 w 1006475"/>
              <a:gd name="connsiteY122" fmla="*/ 378882 h 867832"/>
              <a:gd name="connsiteX123" fmla="*/ 942975 w 1006475"/>
              <a:gd name="connsiteY123" fmla="*/ 369357 h 867832"/>
              <a:gd name="connsiteX124" fmla="*/ 930275 w 1006475"/>
              <a:gd name="connsiteY124" fmla="*/ 350307 h 867832"/>
              <a:gd name="connsiteX125" fmla="*/ 917575 w 1006475"/>
              <a:gd name="connsiteY125" fmla="*/ 331257 h 867832"/>
              <a:gd name="connsiteX126" fmla="*/ 904875 w 1006475"/>
              <a:gd name="connsiteY126" fmla="*/ 315382 h 867832"/>
              <a:gd name="connsiteX127" fmla="*/ 889000 w 1006475"/>
              <a:gd name="connsiteY127" fmla="*/ 299507 h 867832"/>
              <a:gd name="connsiteX128" fmla="*/ 879475 w 1006475"/>
              <a:gd name="connsiteY128" fmla="*/ 280457 h 867832"/>
              <a:gd name="connsiteX129" fmla="*/ 869950 w 1006475"/>
              <a:gd name="connsiteY129" fmla="*/ 277282 h 867832"/>
              <a:gd name="connsiteX130" fmla="*/ 850900 w 1006475"/>
              <a:gd name="connsiteY130" fmla="*/ 264582 h 867832"/>
              <a:gd name="connsiteX131" fmla="*/ 841375 w 1006475"/>
              <a:gd name="connsiteY131" fmla="*/ 258232 h 867832"/>
              <a:gd name="connsiteX132" fmla="*/ 841375 w 1006475"/>
              <a:gd name="connsiteY132" fmla="*/ 239182 h 867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</a:cxnLst>
            <a:rect l="l" t="t" r="r" b="b"/>
            <a:pathLst>
              <a:path w="1006475" h="867832">
                <a:moveTo>
                  <a:pt x="841375" y="239182"/>
                </a:moveTo>
                <a:cubicBezTo>
                  <a:pt x="831850" y="234419"/>
                  <a:pt x="802784" y="235225"/>
                  <a:pt x="784225" y="229657"/>
                </a:cubicBezTo>
                <a:cubicBezTo>
                  <a:pt x="777814" y="227734"/>
                  <a:pt x="765175" y="223307"/>
                  <a:pt x="765175" y="223307"/>
                </a:cubicBezTo>
                <a:cubicBezTo>
                  <a:pt x="762000" y="221190"/>
                  <a:pt x="759063" y="218664"/>
                  <a:pt x="755650" y="216957"/>
                </a:cubicBezTo>
                <a:cubicBezTo>
                  <a:pt x="752657" y="215460"/>
                  <a:pt x="749051" y="215407"/>
                  <a:pt x="746125" y="213782"/>
                </a:cubicBezTo>
                <a:cubicBezTo>
                  <a:pt x="739454" y="210076"/>
                  <a:pt x="727075" y="201082"/>
                  <a:pt x="727075" y="201082"/>
                </a:cubicBezTo>
                <a:cubicBezTo>
                  <a:pt x="724958" y="197907"/>
                  <a:pt x="723423" y="194255"/>
                  <a:pt x="720725" y="191557"/>
                </a:cubicBezTo>
                <a:cubicBezTo>
                  <a:pt x="718027" y="188859"/>
                  <a:pt x="713584" y="188187"/>
                  <a:pt x="711200" y="185207"/>
                </a:cubicBezTo>
                <a:cubicBezTo>
                  <a:pt x="709109" y="182594"/>
                  <a:pt x="710392" y="178049"/>
                  <a:pt x="708025" y="175682"/>
                </a:cubicBezTo>
                <a:cubicBezTo>
                  <a:pt x="702629" y="170286"/>
                  <a:pt x="695325" y="167215"/>
                  <a:pt x="688975" y="162982"/>
                </a:cubicBezTo>
                <a:cubicBezTo>
                  <a:pt x="676665" y="154776"/>
                  <a:pt x="683070" y="157839"/>
                  <a:pt x="669925" y="153457"/>
                </a:cubicBezTo>
                <a:cubicBezTo>
                  <a:pt x="666750" y="151340"/>
                  <a:pt x="664020" y="148314"/>
                  <a:pt x="660400" y="147107"/>
                </a:cubicBezTo>
                <a:cubicBezTo>
                  <a:pt x="654293" y="145071"/>
                  <a:pt x="647684" y="145084"/>
                  <a:pt x="641350" y="143932"/>
                </a:cubicBezTo>
                <a:cubicBezTo>
                  <a:pt x="636041" y="142967"/>
                  <a:pt x="630767" y="141815"/>
                  <a:pt x="625475" y="140757"/>
                </a:cubicBezTo>
                <a:cubicBezTo>
                  <a:pt x="603640" y="126201"/>
                  <a:pt x="613665" y="130470"/>
                  <a:pt x="596900" y="124882"/>
                </a:cubicBezTo>
                <a:cubicBezTo>
                  <a:pt x="579967" y="99482"/>
                  <a:pt x="602192" y="130174"/>
                  <a:pt x="581025" y="109007"/>
                </a:cubicBezTo>
                <a:cubicBezTo>
                  <a:pt x="578327" y="106309"/>
                  <a:pt x="577118" y="102413"/>
                  <a:pt x="574675" y="99482"/>
                </a:cubicBezTo>
                <a:cubicBezTo>
                  <a:pt x="565349" y="88291"/>
                  <a:pt x="559375" y="86107"/>
                  <a:pt x="546100" y="77257"/>
                </a:cubicBezTo>
                <a:cubicBezTo>
                  <a:pt x="509820" y="53070"/>
                  <a:pt x="559510" y="81635"/>
                  <a:pt x="530225" y="58207"/>
                </a:cubicBezTo>
                <a:cubicBezTo>
                  <a:pt x="527612" y="56116"/>
                  <a:pt x="523875" y="56090"/>
                  <a:pt x="520700" y="55032"/>
                </a:cubicBezTo>
                <a:cubicBezTo>
                  <a:pt x="506144" y="33197"/>
                  <a:pt x="515240" y="38395"/>
                  <a:pt x="498475" y="32807"/>
                </a:cubicBezTo>
                <a:cubicBezTo>
                  <a:pt x="495300" y="30690"/>
                  <a:pt x="491881" y="28900"/>
                  <a:pt x="488950" y="26457"/>
                </a:cubicBezTo>
                <a:cubicBezTo>
                  <a:pt x="485501" y="23582"/>
                  <a:pt x="483350" y="19113"/>
                  <a:pt x="479425" y="16932"/>
                </a:cubicBezTo>
                <a:cubicBezTo>
                  <a:pt x="473574" y="13681"/>
                  <a:pt x="460375" y="10582"/>
                  <a:pt x="460375" y="10582"/>
                </a:cubicBezTo>
                <a:cubicBezTo>
                  <a:pt x="457200" y="8465"/>
                  <a:pt x="454263" y="5939"/>
                  <a:pt x="450850" y="4232"/>
                </a:cubicBezTo>
                <a:cubicBezTo>
                  <a:pt x="432821" y="-4783"/>
                  <a:pt x="406181" y="3254"/>
                  <a:pt x="390525" y="4232"/>
                </a:cubicBezTo>
                <a:cubicBezTo>
                  <a:pt x="385233" y="5290"/>
                  <a:pt x="379918" y="6236"/>
                  <a:pt x="374650" y="7407"/>
                </a:cubicBezTo>
                <a:cubicBezTo>
                  <a:pt x="370390" y="8354"/>
                  <a:pt x="366275" y="10005"/>
                  <a:pt x="361950" y="10582"/>
                </a:cubicBezTo>
                <a:cubicBezTo>
                  <a:pt x="350363" y="12127"/>
                  <a:pt x="338674" y="12786"/>
                  <a:pt x="327025" y="13757"/>
                </a:cubicBezTo>
                <a:cubicBezTo>
                  <a:pt x="270652" y="18455"/>
                  <a:pt x="280654" y="17144"/>
                  <a:pt x="209550" y="20107"/>
                </a:cubicBezTo>
                <a:cubicBezTo>
                  <a:pt x="204014" y="20799"/>
                  <a:pt x="183151" y="21721"/>
                  <a:pt x="174625" y="26457"/>
                </a:cubicBezTo>
                <a:cubicBezTo>
                  <a:pt x="167954" y="30163"/>
                  <a:pt x="155575" y="39157"/>
                  <a:pt x="155575" y="39157"/>
                </a:cubicBezTo>
                <a:cubicBezTo>
                  <a:pt x="153458" y="42332"/>
                  <a:pt x="152097" y="46169"/>
                  <a:pt x="149225" y="48682"/>
                </a:cubicBezTo>
                <a:cubicBezTo>
                  <a:pt x="143482" y="53708"/>
                  <a:pt x="130175" y="61382"/>
                  <a:pt x="130175" y="61382"/>
                </a:cubicBezTo>
                <a:cubicBezTo>
                  <a:pt x="128058" y="64557"/>
                  <a:pt x="126268" y="67976"/>
                  <a:pt x="123825" y="70907"/>
                </a:cubicBezTo>
                <a:cubicBezTo>
                  <a:pt x="120950" y="74356"/>
                  <a:pt x="116481" y="76507"/>
                  <a:pt x="114300" y="80432"/>
                </a:cubicBezTo>
                <a:cubicBezTo>
                  <a:pt x="111049" y="86283"/>
                  <a:pt x="110067" y="93132"/>
                  <a:pt x="107950" y="99482"/>
                </a:cubicBezTo>
                <a:cubicBezTo>
                  <a:pt x="105537" y="106722"/>
                  <a:pt x="99483" y="112182"/>
                  <a:pt x="95250" y="118532"/>
                </a:cubicBezTo>
                <a:cubicBezTo>
                  <a:pt x="91537" y="124101"/>
                  <a:pt x="92613" y="132013"/>
                  <a:pt x="88900" y="137582"/>
                </a:cubicBezTo>
                <a:cubicBezTo>
                  <a:pt x="70702" y="164879"/>
                  <a:pt x="92520" y="130342"/>
                  <a:pt x="79375" y="156632"/>
                </a:cubicBezTo>
                <a:cubicBezTo>
                  <a:pt x="77668" y="160045"/>
                  <a:pt x="74575" y="162670"/>
                  <a:pt x="73025" y="166157"/>
                </a:cubicBezTo>
                <a:cubicBezTo>
                  <a:pt x="70307" y="172274"/>
                  <a:pt x="68792" y="178857"/>
                  <a:pt x="66675" y="185207"/>
                </a:cubicBezTo>
                <a:lnTo>
                  <a:pt x="63500" y="194732"/>
                </a:lnTo>
                <a:cubicBezTo>
                  <a:pt x="61087" y="201972"/>
                  <a:pt x="50800" y="213782"/>
                  <a:pt x="50800" y="213782"/>
                </a:cubicBezTo>
                <a:cubicBezTo>
                  <a:pt x="49783" y="217851"/>
                  <a:pt x="46727" y="231452"/>
                  <a:pt x="44450" y="236007"/>
                </a:cubicBezTo>
                <a:cubicBezTo>
                  <a:pt x="42743" y="239420"/>
                  <a:pt x="39807" y="242119"/>
                  <a:pt x="38100" y="245532"/>
                </a:cubicBezTo>
                <a:cubicBezTo>
                  <a:pt x="24955" y="271822"/>
                  <a:pt x="46773" y="237285"/>
                  <a:pt x="28575" y="264582"/>
                </a:cubicBezTo>
                <a:cubicBezTo>
                  <a:pt x="20912" y="302896"/>
                  <a:pt x="25638" y="286093"/>
                  <a:pt x="15875" y="315382"/>
                </a:cubicBezTo>
                <a:cubicBezTo>
                  <a:pt x="14668" y="319002"/>
                  <a:pt x="11232" y="321494"/>
                  <a:pt x="9525" y="324907"/>
                </a:cubicBezTo>
                <a:cubicBezTo>
                  <a:pt x="8028" y="327900"/>
                  <a:pt x="7408" y="331257"/>
                  <a:pt x="6350" y="334432"/>
                </a:cubicBezTo>
                <a:cubicBezTo>
                  <a:pt x="5292" y="342899"/>
                  <a:pt x="4701" y="351437"/>
                  <a:pt x="3175" y="359832"/>
                </a:cubicBezTo>
                <a:cubicBezTo>
                  <a:pt x="2576" y="363125"/>
                  <a:pt x="0" y="366010"/>
                  <a:pt x="0" y="369357"/>
                </a:cubicBezTo>
                <a:cubicBezTo>
                  <a:pt x="0" y="391078"/>
                  <a:pt x="2017" y="414369"/>
                  <a:pt x="6350" y="436032"/>
                </a:cubicBezTo>
                <a:cubicBezTo>
                  <a:pt x="8749" y="448028"/>
                  <a:pt x="11825" y="455633"/>
                  <a:pt x="15875" y="467782"/>
                </a:cubicBezTo>
                <a:cubicBezTo>
                  <a:pt x="17082" y="471402"/>
                  <a:pt x="20675" y="473820"/>
                  <a:pt x="22225" y="477307"/>
                </a:cubicBezTo>
                <a:cubicBezTo>
                  <a:pt x="24943" y="483424"/>
                  <a:pt x="26458" y="490007"/>
                  <a:pt x="28575" y="496357"/>
                </a:cubicBezTo>
                <a:cubicBezTo>
                  <a:pt x="29782" y="499977"/>
                  <a:pt x="33218" y="502469"/>
                  <a:pt x="34925" y="505882"/>
                </a:cubicBezTo>
                <a:cubicBezTo>
                  <a:pt x="36422" y="508875"/>
                  <a:pt x="36603" y="512414"/>
                  <a:pt x="38100" y="515407"/>
                </a:cubicBezTo>
                <a:cubicBezTo>
                  <a:pt x="39807" y="518820"/>
                  <a:pt x="42900" y="521445"/>
                  <a:pt x="44450" y="524932"/>
                </a:cubicBezTo>
                <a:cubicBezTo>
                  <a:pt x="47168" y="531049"/>
                  <a:pt x="47087" y="538413"/>
                  <a:pt x="50800" y="543982"/>
                </a:cubicBezTo>
                <a:cubicBezTo>
                  <a:pt x="52917" y="547157"/>
                  <a:pt x="55443" y="550094"/>
                  <a:pt x="57150" y="553507"/>
                </a:cubicBezTo>
                <a:cubicBezTo>
                  <a:pt x="58647" y="556500"/>
                  <a:pt x="58469" y="560247"/>
                  <a:pt x="60325" y="563032"/>
                </a:cubicBezTo>
                <a:cubicBezTo>
                  <a:pt x="62816" y="566768"/>
                  <a:pt x="66675" y="569382"/>
                  <a:pt x="69850" y="572557"/>
                </a:cubicBezTo>
                <a:cubicBezTo>
                  <a:pt x="77830" y="596498"/>
                  <a:pt x="67065" y="566988"/>
                  <a:pt x="79375" y="591607"/>
                </a:cubicBezTo>
                <a:cubicBezTo>
                  <a:pt x="80872" y="594600"/>
                  <a:pt x="80925" y="598206"/>
                  <a:pt x="82550" y="601132"/>
                </a:cubicBezTo>
                <a:cubicBezTo>
                  <a:pt x="86256" y="607803"/>
                  <a:pt x="91017" y="613832"/>
                  <a:pt x="95250" y="620182"/>
                </a:cubicBezTo>
                <a:cubicBezTo>
                  <a:pt x="97367" y="623357"/>
                  <a:pt x="98902" y="627009"/>
                  <a:pt x="101600" y="629707"/>
                </a:cubicBezTo>
                <a:lnTo>
                  <a:pt x="111125" y="639232"/>
                </a:lnTo>
                <a:cubicBezTo>
                  <a:pt x="117306" y="657775"/>
                  <a:pt x="109464" y="640746"/>
                  <a:pt x="123825" y="655107"/>
                </a:cubicBezTo>
                <a:cubicBezTo>
                  <a:pt x="126523" y="657805"/>
                  <a:pt x="128468" y="661219"/>
                  <a:pt x="130175" y="664632"/>
                </a:cubicBezTo>
                <a:cubicBezTo>
                  <a:pt x="131672" y="667625"/>
                  <a:pt x="130983" y="671790"/>
                  <a:pt x="133350" y="674157"/>
                </a:cubicBezTo>
                <a:cubicBezTo>
                  <a:pt x="135717" y="676524"/>
                  <a:pt x="139700" y="676274"/>
                  <a:pt x="142875" y="677332"/>
                </a:cubicBezTo>
                <a:cubicBezTo>
                  <a:pt x="146050" y="679449"/>
                  <a:pt x="150016" y="680702"/>
                  <a:pt x="152400" y="683682"/>
                </a:cubicBezTo>
                <a:cubicBezTo>
                  <a:pt x="164715" y="699076"/>
                  <a:pt x="144318" y="689455"/>
                  <a:pt x="165100" y="696382"/>
                </a:cubicBezTo>
                <a:cubicBezTo>
                  <a:pt x="186517" y="717799"/>
                  <a:pt x="175631" y="712592"/>
                  <a:pt x="193675" y="718607"/>
                </a:cubicBezTo>
                <a:cubicBezTo>
                  <a:pt x="200025" y="722840"/>
                  <a:pt x="207329" y="725911"/>
                  <a:pt x="212725" y="731307"/>
                </a:cubicBezTo>
                <a:cubicBezTo>
                  <a:pt x="224617" y="743199"/>
                  <a:pt x="217990" y="739412"/>
                  <a:pt x="231775" y="744007"/>
                </a:cubicBezTo>
                <a:cubicBezTo>
                  <a:pt x="233892" y="747182"/>
                  <a:pt x="235253" y="751019"/>
                  <a:pt x="238125" y="753532"/>
                </a:cubicBezTo>
                <a:lnTo>
                  <a:pt x="266700" y="772582"/>
                </a:lnTo>
                <a:lnTo>
                  <a:pt x="276225" y="778932"/>
                </a:lnTo>
                <a:lnTo>
                  <a:pt x="285750" y="785282"/>
                </a:lnTo>
                <a:cubicBezTo>
                  <a:pt x="320675" y="784224"/>
                  <a:pt x="355632" y="783943"/>
                  <a:pt x="390525" y="782107"/>
                </a:cubicBezTo>
                <a:cubicBezTo>
                  <a:pt x="395914" y="781823"/>
                  <a:pt x="401004" y="778932"/>
                  <a:pt x="406400" y="778932"/>
                </a:cubicBezTo>
                <a:cubicBezTo>
                  <a:pt x="426536" y="778932"/>
                  <a:pt x="446617" y="781049"/>
                  <a:pt x="466725" y="782107"/>
                </a:cubicBezTo>
                <a:cubicBezTo>
                  <a:pt x="475217" y="783522"/>
                  <a:pt x="492775" y="786238"/>
                  <a:pt x="501650" y="788457"/>
                </a:cubicBezTo>
                <a:cubicBezTo>
                  <a:pt x="504897" y="789269"/>
                  <a:pt x="507957" y="790713"/>
                  <a:pt x="511175" y="791632"/>
                </a:cubicBezTo>
                <a:cubicBezTo>
                  <a:pt x="515371" y="792831"/>
                  <a:pt x="519695" y="793553"/>
                  <a:pt x="523875" y="794807"/>
                </a:cubicBezTo>
                <a:cubicBezTo>
                  <a:pt x="534461" y="797983"/>
                  <a:pt x="544648" y="802502"/>
                  <a:pt x="555625" y="804332"/>
                </a:cubicBezTo>
                <a:cubicBezTo>
                  <a:pt x="569108" y="806579"/>
                  <a:pt x="600546" y="809459"/>
                  <a:pt x="612775" y="810682"/>
                </a:cubicBezTo>
                <a:lnTo>
                  <a:pt x="631825" y="817032"/>
                </a:lnTo>
                <a:lnTo>
                  <a:pt x="641350" y="820207"/>
                </a:lnTo>
                <a:cubicBezTo>
                  <a:pt x="656444" y="830270"/>
                  <a:pt x="647255" y="825350"/>
                  <a:pt x="669925" y="832907"/>
                </a:cubicBezTo>
                <a:lnTo>
                  <a:pt x="679450" y="836082"/>
                </a:lnTo>
                <a:cubicBezTo>
                  <a:pt x="685800" y="840315"/>
                  <a:pt x="691260" y="846369"/>
                  <a:pt x="698500" y="848782"/>
                </a:cubicBezTo>
                <a:lnTo>
                  <a:pt x="746125" y="864657"/>
                </a:lnTo>
                <a:cubicBezTo>
                  <a:pt x="751245" y="866364"/>
                  <a:pt x="756708" y="866774"/>
                  <a:pt x="762000" y="867832"/>
                </a:cubicBezTo>
                <a:cubicBezTo>
                  <a:pt x="773642" y="866774"/>
                  <a:pt x="785413" y="866688"/>
                  <a:pt x="796925" y="864657"/>
                </a:cubicBezTo>
                <a:cubicBezTo>
                  <a:pt x="803517" y="863494"/>
                  <a:pt x="809625" y="860424"/>
                  <a:pt x="815975" y="858307"/>
                </a:cubicBezTo>
                <a:lnTo>
                  <a:pt x="825500" y="855132"/>
                </a:lnTo>
                <a:lnTo>
                  <a:pt x="854075" y="836082"/>
                </a:lnTo>
                <a:cubicBezTo>
                  <a:pt x="859644" y="832369"/>
                  <a:pt x="873125" y="829732"/>
                  <a:pt x="873125" y="829732"/>
                </a:cubicBezTo>
                <a:lnTo>
                  <a:pt x="901700" y="810682"/>
                </a:lnTo>
                <a:cubicBezTo>
                  <a:pt x="907269" y="806969"/>
                  <a:pt x="920750" y="804332"/>
                  <a:pt x="920750" y="804332"/>
                </a:cubicBezTo>
                <a:cubicBezTo>
                  <a:pt x="923925" y="801157"/>
                  <a:pt x="927784" y="798543"/>
                  <a:pt x="930275" y="794807"/>
                </a:cubicBezTo>
                <a:cubicBezTo>
                  <a:pt x="932131" y="792022"/>
                  <a:pt x="931953" y="788275"/>
                  <a:pt x="933450" y="785282"/>
                </a:cubicBezTo>
                <a:cubicBezTo>
                  <a:pt x="935157" y="781869"/>
                  <a:pt x="938250" y="779244"/>
                  <a:pt x="939800" y="775757"/>
                </a:cubicBezTo>
                <a:cubicBezTo>
                  <a:pt x="954913" y="741752"/>
                  <a:pt x="938129" y="768738"/>
                  <a:pt x="952500" y="747182"/>
                </a:cubicBezTo>
                <a:cubicBezTo>
                  <a:pt x="953517" y="743113"/>
                  <a:pt x="956573" y="729512"/>
                  <a:pt x="958850" y="724957"/>
                </a:cubicBezTo>
                <a:cubicBezTo>
                  <a:pt x="960557" y="721544"/>
                  <a:pt x="963650" y="718919"/>
                  <a:pt x="965200" y="715432"/>
                </a:cubicBezTo>
                <a:cubicBezTo>
                  <a:pt x="972108" y="699889"/>
                  <a:pt x="970462" y="697890"/>
                  <a:pt x="974725" y="683682"/>
                </a:cubicBezTo>
                <a:cubicBezTo>
                  <a:pt x="976648" y="677271"/>
                  <a:pt x="978958" y="670982"/>
                  <a:pt x="981075" y="664632"/>
                </a:cubicBezTo>
                <a:cubicBezTo>
                  <a:pt x="982282" y="661012"/>
                  <a:pt x="985875" y="658594"/>
                  <a:pt x="987425" y="655107"/>
                </a:cubicBezTo>
                <a:cubicBezTo>
                  <a:pt x="990143" y="648990"/>
                  <a:pt x="993775" y="636057"/>
                  <a:pt x="993775" y="636057"/>
                </a:cubicBezTo>
                <a:cubicBezTo>
                  <a:pt x="997780" y="604015"/>
                  <a:pt x="994252" y="618752"/>
                  <a:pt x="1003300" y="591607"/>
                </a:cubicBezTo>
                <a:lnTo>
                  <a:pt x="1006475" y="582082"/>
                </a:lnTo>
                <a:cubicBezTo>
                  <a:pt x="1004527" y="558704"/>
                  <a:pt x="1005090" y="547967"/>
                  <a:pt x="1000125" y="528107"/>
                </a:cubicBezTo>
                <a:cubicBezTo>
                  <a:pt x="999313" y="524860"/>
                  <a:pt x="998008" y="521757"/>
                  <a:pt x="996950" y="518582"/>
                </a:cubicBezTo>
                <a:cubicBezTo>
                  <a:pt x="995892" y="503765"/>
                  <a:pt x="995979" y="488822"/>
                  <a:pt x="993775" y="474132"/>
                </a:cubicBezTo>
                <a:cubicBezTo>
                  <a:pt x="989494" y="445594"/>
                  <a:pt x="989270" y="463996"/>
                  <a:pt x="981075" y="445557"/>
                </a:cubicBezTo>
                <a:cubicBezTo>
                  <a:pt x="978357" y="439440"/>
                  <a:pt x="976842" y="432857"/>
                  <a:pt x="974725" y="426507"/>
                </a:cubicBezTo>
                <a:lnTo>
                  <a:pt x="955675" y="397932"/>
                </a:lnTo>
                <a:cubicBezTo>
                  <a:pt x="953819" y="395147"/>
                  <a:pt x="953997" y="391400"/>
                  <a:pt x="952500" y="388407"/>
                </a:cubicBezTo>
                <a:cubicBezTo>
                  <a:pt x="950793" y="384994"/>
                  <a:pt x="947857" y="382295"/>
                  <a:pt x="946150" y="378882"/>
                </a:cubicBezTo>
                <a:cubicBezTo>
                  <a:pt x="944653" y="375889"/>
                  <a:pt x="944600" y="372283"/>
                  <a:pt x="942975" y="369357"/>
                </a:cubicBezTo>
                <a:cubicBezTo>
                  <a:pt x="939269" y="362686"/>
                  <a:pt x="932688" y="357547"/>
                  <a:pt x="930275" y="350307"/>
                </a:cubicBezTo>
                <a:cubicBezTo>
                  <a:pt x="925680" y="336522"/>
                  <a:pt x="929467" y="343149"/>
                  <a:pt x="917575" y="331257"/>
                </a:cubicBezTo>
                <a:cubicBezTo>
                  <a:pt x="911394" y="312714"/>
                  <a:pt x="919236" y="329743"/>
                  <a:pt x="904875" y="315382"/>
                </a:cubicBezTo>
                <a:cubicBezTo>
                  <a:pt x="883708" y="294215"/>
                  <a:pt x="914400" y="316440"/>
                  <a:pt x="889000" y="299507"/>
                </a:cubicBezTo>
                <a:cubicBezTo>
                  <a:pt x="886908" y="293232"/>
                  <a:pt x="885070" y="284933"/>
                  <a:pt x="879475" y="280457"/>
                </a:cubicBezTo>
                <a:cubicBezTo>
                  <a:pt x="876862" y="278366"/>
                  <a:pt x="873125" y="278340"/>
                  <a:pt x="869950" y="277282"/>
                </a:cubicBezTo>
                <a:lnTo>
                  <a:pt x="850900" y="264582"/>
                </a:lnTo>
                <a:cubicBezTo>
                  <a:pt x="847725" y="262465"/>
                  <a:pt x="845077" y="259157"/>
                  <a:pt x="841375" y="258232"/>
                </a:cubicBezTo>
                <a:cubicBezTo>
                  <a:pt x="826622" y="254544"/>
                  <a:pt x="850900" y="243945"/>
                  <a:pt x="841375" y="239182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10" name="フリーフォーム 109"/>
          <p:cNvSpPr/>
          <p:nvPr/>
        </p:nvSpPr>
        <p:spPr>
          <a:xfrm>
            <a:off x="353922" y="1245421"/>
            <a:ext cx="1006475" cy="867832"/>
          </a:xfrm>
          <a:custGeom>
            <a:avLst/>
            <a:gdLst>
              <a:gd name="connsiteX0" fmla="*/ 841375 w 1006475"/>
              <a:gd name="connsiteY0" fmla="*/ 239182 h 867832"/>
              <a:gd name="connsiteX1" fmla="*/ 784225 w 1006475"/>
              <a:gd name="connsiteY1" fmla="*/ 229657 h 867832"/>
              <a:gd name="connsiteX2" fmla="*/ 765175 w 1006475"/>
              <a:gd name="connsiteY2" fmla="*/ 223307 h 867832"/>
              <a:gd name="connsiteX3" fmla="*/ 755650 w 1006475"/>
              <a:gd name="connsiteY3" fmla="*/ 216957 h 867832"/>
              <a:gd name="connsiteX4" fmla="*/ 746125 w 1006475"/>
              <a:gd name="connsiteY4" fmla="*/ 213782 h 867832"/>
              <a:gd name="connsiteX5" fmla="*/ 727075 w 1006475"/>
              <a:gd name="connsiteY5" fmla="*/ 201082 h 867832"/>
              <a:gd name="connsiteX6" fmla="*/ 720725 w 1006475"/>
              <a:gd name="connsiteY6" fmla="*/ 191557 h 867832"/>
              <a:gd name="connsiteX7" fmla="*/ 711200 w 1006475"/>
              <a:gd name="connsiteY7" fmla="*/ 185207 h 867832"/>
              <a:gd name="connsiteX8" fmla="*/ 708025 w 1006475"/>
              <a:gd name="connsiteY8" fmla="*/ 175682 h 867832"/>
              <a:gd name="connsiteX9" fmla="*/ 688975 w 1006475"/>
              <a:gd name="connsiteY9" fmla="*/ 162982 h 867832"/>
              <a:gd name="connsiteX10" fmla="*/ 669925 w 1006475"/>
              <a:gd name="connsiteY10" fmla="*/ 153457 h 867832"/>
              <a:gd name="connsiteX11" fmla="*/ 660400 w 1006475"/>
              <a:gd name="connsiteY11" fmla="*/ 147107 h 867832"/>
              <a:gd name="connsiteX12" fmla="*/ 641350 w 1006475"/>
              <a:gd name="connsiteY12" fmla="*/ 143932 h 867832"/>
              <a:gd name="connsiteX13" fmla="*/ 625475 w 1006475"/>
              <a:gd name="connsiteY13" fmla="*/ 140757 h 867832"/>
              <a:gd name="connsiteX14" fmla="*/ 596900 w 1006475"/>
              <a:gd name="connsiteY14" fmla="*/ 124882 h 867832"/>
              <a:gd name="connsiteX15" fmla="*/ 581025 w 1006475"/>
              <a:gd name="connsiteY15" fmla="*/ 109007 h 867832"/>
              <a:gd name="connsiteX16" fmla="*/ 574675 w 1006475"/>
              <a:gd name="connsiteY16" fmla="*/ 99482 h 867832"/>
              <a:gd name="connsiteX17" fmla="*/ 546100 w 1006475"/>
              <a:gd name="connsiteY17" fmla="*/ 77257 h 867832"/>
              <a:gd name="connsiteX18" fmla="*/ 530225 w 1006475"/>
              <a:gd name="connsiteY18" fmla="*/ 58207 h 867832"/>
              <a:gd name="connsiteX19" fmla="*/ 520700 w 1006475"/>
              <a:gd name="connsiteY19" fmla="*/ 55032 h 867832"/>
              <a:gd name="connsiteX20" fmla="*/ 498475 w 1006475"/>
              <a:gd name="connsiteY20" fmla="*/ 32807 h 867832"/>
              <a:gd name="connsiteX21" fmla="*/ 488950 w 1006475"/>
              <a:gd name="connsiteY21" fmla="*/ 26457 h 867832"/>
              <a:gd name="connsiteX22" fmla="*/ 479425 w 1006475"/>
              <a:gd name="connsiteY22" fmla="*/ 16932 h 867832"/>
              <a:gd name="connsiteX23" fmla="*/ 460375 w 1006475"/>
              <a:gd name="connsiteY23" fmla="*/ 10582 h 867832"/>
              <a:gd name="connsiteX24" fmla="*/ 450850 w 1006475"/>
              <a:gd name="connsiteY24" fmla="*/ 4232 h 867832"/>
              <a:gd name="connsiteX25" fmla="*/ 390525 w 1006475"/>
              <a:gd name="connsiteY25" fmla="*/ 4232 h 867832"/>
              <a:gd name="connsiteX26" fmla="*/ 374650 w 1006475"/>
              <a:gd name="connsiteY26" fmla="*/ 7407 h 867832"/>
              <a:gd name="connsiteX27" fmla="*/ 361950 w 1006475"/>
              <a:gd name="connsiteY27" fmla="*/ 10582 h 867832"/>
              <a:gd name="connsiteX28" fmla="*/ 327025 w 1006475"/>
              <a:gd name="connsiteY28" fmla="*/ 13757 h 867832"/>
              <a:gd name="connsiteX29" fmla="*/ 209550 w 1006475"/>
              <a:gd name="connsiteY29" fmla="*/ 20107 h 867832"/>
              <a:gd name="connsiteX30" fmla="*/ 174625 w 1006475"/>
              <a:gd name="connsiteY30" fmla="*/ 26457 h 867832"/>
              <a:gd name="connsiteX31" fmla="*/ 155575 w 1006475"/>
              <a:gd name="connsiteY31" fmla="*/ 39157 h 867832"/>
              <a:gd name="connsiteX32" fmla="*/ 149225 w 1006475"/>
              <a:gd name="connsiteY32" fmla="*/ 48682 h 867832"/>
              <a:gd name="connsiteX33" fmla="*/ 130175 w 1006475"/>
              <a:gd name="connsiteY33" fmla="*/ 61382 h 867832"/>
              <a:gd name="connsiteX34" fmla="*/ 123825 w 1006475"/>
              <a:gd name="connsiteY34" fmla="*/ 70907 h 867832"/>
              <a:gd name="connsiteX35" fmla="*/ 114300 w 1006475"/>
              <a:gd name="connsiteY35" fmla="*/ 80432 h 867832"/>
              <a:gd name="connsiteX36" fmla="*/ 107950 w 1006475"/>
              <a:gd name="connsiteY36" fmla="*/ 99482 h 867832"/>
              <a:gd name="connsiteX37" fmla="*/ 95250 w 1006475"/>
              <a:gd name="connsiteY37" fmla="*/ 118532 h 867832"/>
              <a:gd name="connsiteX38" fmla="*/ 88900 w 1006475"/>
              <a:gd name="connsiteY38" fmla="*/ 137582 h 867832"/>
              <a:gd name="connsiteX39" fmla="*/ 79375 w 1006475"/>
              <a:gd name="connsiteY39" fmla="*/ 156632 h 867832"/>
              <a:gd name="connsiteX40" fmla="*/ 73025 w 1006475"/>
              <a:gd name="connsiteY40" fmla="*/ 166157 h 867832"/>
              <a:gd name="connsiteX41" fmla="*/ 66675 w 1006475"/>
              <a:gd name="connsiteY41" fmla="*/ 185207 h 867832"/>
              <a:gd name="connsiteX42" fmla="*/ 63500 w 1006475"/>
              <a:gd name="connsiteY42" fmla="*/ 194732 h 867832"/>
              <a:gd name="connsiteX43" fmla="*/ 50800 w 1006475"/>
              <a:gd name="connsiteY43" fmla="*/ 213782 h 867832"/>
              <a:gd name="connsiteX44" fmla="*/ 44450 w 1006475"/>
              <a:gd name="connsiteY44" fmla="*/ 236007 h 867832"/>
              <a:gd name="connsiteX45" fmla="*/ 38100 w 1006475"/>
              <a:gd name="connsiteY45" fmla="*/ 245532 h 867832"/>
              <a:gd name="connsiteX46" fmla="*/ 28575 w 1006475"/>
              <a:gd name="connsiteY46" fmla="*/ 264582 h 867832"/>
              <a:gd name="connsiteX47" fmla="*/ 15875 w 1006475"/>
              <a:gd name="connsiteY47" fmla="*/ 315382 h 867832"/>
              <a:gd name="connsiteX48" fmla="*/ 9525 w 1006475"/>
              <a:gd name="connsiteY48" fmla="*/ 324907 h 867832"/>
              <a:gd name="connsiteX49" fmla="*/ 6350 w 1006475"/>
              <a:gd name="connsiteY49" fmla="*/ 334432 h 867832"/>
              <a:gd name="connsiteX50" fmla="*/ 3175 w 1006475"/>
              <a:gd name="connsiteY50" fmla="*/ 359832 h 867832"/>
              <a:gd name="connsiteX51" fmla="*/ 0 w 1006475"/>
              <a:gd name="connsiteY51" fmla="*/ 369357 h 867832"/>
              <a:gd name="connsiteX52" fmla="*/ 6350 w 1006475"/>
              <a:gd name="connsiteY52" fmla="*/ 436032 h 867832"/>
              <a:gd name="connsiteX53" fmla="*/ 15875 w 1006475"/>
              <a:gd name="connsiteY53" fmla="*/ 467782 h 867832"/>
              <a:gd name="connsiteX54" fmla="*/ 22225 w 1006475"/>
              <a:gd name="connsiteY54" fmla="*/ 477307 h 867832"/>
              <a:gd name="connsiteX55" fmla="*/ 28575 w 1006475"/>
              <a:gd name="connsiteY55" fmla="*/ 496357 h 867832"/>
              <a:gd name="connsiteX56" fmla="*/ 34925 w 1006475"/>
              <a:gd name="connsiteY56" fmla="*/ 505882 h 867832"/>
              <a:gd name="connsiteX57" fmla="*/ 38100 w 1006475"/>
              <a:gd name="connsiteY57" fmla="*/ 515407 h 867832"/>
              <a:gd name="connsiteX58" fmla="*/ 44450 w 1006475"/>
              <a:gd name="connsiteY58" fmla="*/ 524932 h 867832"/>
              <a:gd name="connsiteX59" fmla="*/ 50800 w 1006475"/>
              <a:gd name="connsiteY59" fmla="*/ 543982 h 867832"/>
              <a:gd name="connsiteX60" fmla="*/ 57150 w 1006475"/>
              <a:gd name="connsiteY60" fmla="*/ 553507 h 867832"/>
              <a:gd name="connsiteX61" fmla="*/ 60325 w 1006475"/>
              <a:gd name="connsiteY61" fmla="*/ 563032 h 867832"/>
              <a:gd name="connsiteX62" fmla="*/ 69850 w 1006475"/>
              <a:gd name="connsiteY62" fmla="*/ 572557 h 867832"/>
              <a:gd name="connsiteX63" fmla="*/ 79375 w 1006475"/>
              <a:gd name="connsiteY63" fmla="*/ 591607 h 867832"/>
              <a:gd name="connsiteX64" fmla="*/ 82550 w 1006475"/>
              <a:gd name="connsiteY64" fmla="*/ 601132 h 867832"/>
              <a:gd name="connsiteX65" fmla="*/ 95250 w 1006475"/>
              <a:gd name="connsiteY65" fmla="*/ 620182 h 867832"/>
              <a:gd name="connsiteX66" fmla="*/ 101600 w 1006475"/>
              <a:gd name="connsiteY66" fmla="*/ 629707 h 867832"/>
              <a:gd name="connsiteX67" fmla="*/ 111125 w 1006475"/>
              <a:gd name="connsiteY67" fmla="*/ 639232 h 867832"/>
              <a:gd name="connsiteX68" fmla="*/ 123825 w 1006475"/>
              <a:gd name="connsiteY68" fmla="*/ 655107 h 867832"/>
              <a:gd name="connsiteX69" fmla="*/ 130175 w 1006475"/>
              <a:gd name="connsiteY69" fmla="*/ 664632 h 867832"/>
              <a:gd name="connsiteX70" fmla="*/ 133350 w 1006475"/>
              <a:gd name="connsiteY70" fmla="*/ 674157 h 867832"/>
              <a:gd name="connsiteX71" fmla="*/ 142875 w 1006475"/>
              <a:gd name="connsiteY71" fmla="*/ 677332 h 867832"/>
              <a:gd name="connsiteX72" fmla="*/ 152400 w 1006475"/>
              <a:gd name="connsiteY72" fmla="*/ 683682 h 867832"/>
              <a:gd name="connsiteX73" fmla="*/ 165100 w 1006475"/>
              <a:gd name="connsiteY73" fmla="*/ 696382 h 867832"/>
              <a:gd name="connsiteX74" fmla="*/ 193675 w 1006475"/>
              <a:gd name="connsiteY74" fmla="*/ 718607 h 867832"/>
              <a:gd name="connsiteX75" fmla="*/ 212725 w 1006475"/>
              <a:gd name="connsiteY75" fmla="*/ 731307 h 867832"/>
              <a:gd name="connsiteX76" fmla="*/ 231775 w 1006475"/>
              <a:gd name="connsiteY76" fmla="*/ 744007 h 867832"/>
              <a:gd name="connsiteX77" fmla="*/ 238125 w 1006475"/>
              <a:gd name="connsiteY77" fmla="*/ 753532 h 867832"/>
              <a:gd name="connsiteX78" fmla="*/ 266700 w 1006475"/>
              <a:gd name="connsiteY78" fmla="*/ 772582 h 867832"/>
              <a:gd name="connsiteX79" fmla="*/ 276225 w 1006475"/>
              <a:gd name="connsiteY79" fmla="*/ 778932 h 867832"/>
              <a:gd name="connsiteX80" fmla="*/ 285750 w 1006475"/>
              <a:gd name="connsiteY80" fmla="*/ 785282 h 867832"/>
              <a:gd name="connsiteX81" fmla="*/ 390525 w 1006475"/>
              <a:gd name="connsiteY81" fmla="*/ 782107 h 867832"/>
              <a:gd name="connsiteX82" fmla="*/ 406400 w 1006475"/>
              <a:gd name="connsiteY82" fmla="*/ 778932 h 867832"/>
              <a:gd name="connsiteX83" fmla="*/ 466725 w 1006475"/>
              <a:gd name="connsiteY83" fmla="*/ 782107 h 867832"/>
              <a:gd name="connsiteX84" fmla="*/ 501650 w 1006475"/>
              <a:gd name="connsiteY84" fmla="*/ 788457 h 867832"/>
              <a:gd name="connsiteX85" fmla="*/ 511175 w 1006475"/>
              <a:gd name="connsiteY85" fmla="*/ 791632 h 867832"/>
              <a:gd name="connsiteX86" fmla="*/ 523875 w 1006475"/>
              <a:gd name="connsiteY86" fmla="*/ 794807 h 867832"/>
              <a:gd name="connsiteX87" fmla="*/ 555625 w 1006475"/>
              <a:gd name="connsiteY87" fmla="*/ 804332 h 867832"/>
              <a:gd name="connsiteX88" fmla="*/ 612775 w 1006475"/>
              <a:gd name="connsiteY88" fmla="*/ 810682 h 867832"/>
              <a:gd name="connsiteX89" fmla="*/ 631825 w 1006475"/>
              <a:gd name="connsiteY89" fmla="*/ 817032 h 867832"/>
              <a:gd name="connsiteX90" fmla="*/ 641350 w 1006475"/>
              <a:gd name="connsiteY90" fmla="*/ 820207 h 867832"/>
              <a:gd name="connsiteX91" fmla="*/ 669925 w 1006475"/>
              <a:gd name="connsiteY91" fmla="*/ 832907 h 867832"/>
              <a:gd name="connsiteX92" fmla="*/ 679450 w 1006475"/>
              <a:gd name="connsiteY92" fmla="*/ 836082 h 867832"/>
              <a:gd name="connsiteX93" fmla="*/ 698500 w 1006475"/>
              <a:gd name="connsiteY93" fmla="*/ 848782 h 867832"/>
              <a:gd name="connsiteX94" fmla="*/ 746125 w 1006475"/>
              <a:gd name="connsiteY94" fmla="*/ 864657 h 867832"/>
              <a:gd name="connsiteX95" fmla="*/ 762000 w 1006475"/>
              <a:gd name="connsiteY95" fmla="*/ 867832 h 867832"/>
              <a:gd name="connsiteX96" fmla="*/ 796925 w 1006475"/>
              <a:gd name="connsiteY96" fmla="*/ 864657 h 867832"/>
              <a:gd name="connsiteX97" fmla="*/ 815975 w 1006475"/>
              <a:gd name="connsiteY97" fmla="*/ 858307 h 867832"/>
              <a:gd name="connsiteX98" fmla="*/ 825500 w 1006475"/>
              <a:gd name="connsiteY98" fmla="*/ 855132 h 867832"/>
              <a:gd name="connsiteX99" fmla="*/ 854075 w 1006475"/>
              <a:gd name="connsiteY99" fmla="*/ 836082 h 867832"/>
              <a:gd name="connsiteX100" fmla="*/ 873125 w 1006475"/>
              <a:gd name="connsiteY100" fmla="*/ 829732 h 867832"/>
              <a:gd name="connsiteX101" fmla="*/ 901700 w 1006475"/>
              <a:gd name="connsiteY101" fmla="*/ 810682 h 867832"/>
              <a:gd name="connsiteX102" fmla="*/ 920750 w 1006475"/>
              <a:gd name="connsiteY102" fmla="*/ 804332 h 867832"/>
              <a:gd name="connsiteX103" fmla="*/ 930275 w 1006475"/>
              <a:gd name="connsiteY103" fmla="*/ 794807 h 867832"/>
              <a:gd name="connsiteX104" fmla="*/ 933450 w 1006475"/>
              <a:gd name="connsiteY104" fmla="*/ 785282 h 867832"/>
              <a:gd name="connsiteX105" fmla="*/ 939800 w 1006475"/>
              <a:gd name="connsiteY105" fmla="*/ 775757 h 867832"/>
              <a:gd name="connsiteX106" fmla="*/ 952500 w 1006475"/>
              <a:gd name="connsiteY106" fmla="*/ 747182 h 867832"/>
              <a:gd name="connsiteX107" fmla="*/ 958850 w 1006475"/>
              <a:gd name="connsiteY107" fmla="*/ 724957 h 867832"/>
              <a:gd name="connsiteX108" fmla="*/ 965200 w 1006475"/>
              <a:gd name="connsiteY108" fmla="*/ 715432 h 867832"/>
              <a:gd name="connsiteX109" fmla="*/ 974725 w 1006475"/>
              <a:gd name="connsiteY109" fmla="*/ 683682 h 867832"/>
              <a:gd name="connsiteX110" fmla="*/ 981075 w 1006475"/>
              <a:gd name="connsiteY110" fmla="*/ 664632 h 867832"/>
              <a:gd name="connsiteX111" fmla="*/ 987425 w 1006475"/>
              <a:gd name="connsiteY111" fmla="*/ 655107 h 867832"/>
              <a:gd name="connsiteX112" fmla="*/ 993775 w 1006475"/>
              <a:gd name="connsiteY112" fmla="*/ 636057 h 867832"/>
              <a:gd name="connsiteX113" fmla="*/ 1003300 w 1006475"/>
              <a:gd name="connsiteY113" fmla="*/ 591607 h 867832"/>
              <a:gd name="connsiteX114" fmla="*/ 1006475 w 1006475"/>
              <a:gd name="connsiteY114" fmla="*/ 582082 h 867832"/>
              <a:gd name="connsiteX115" fmla="*/ 1000125 w 1006475"/>
              <a:gd name="connsiteY115" fmla="*/ 528107 h 867832"/>
              <a:gd name="connsiteX116" fmla="*/ 996950 w 1006475"/>
              <a:gd name="connsiteY116" fmla="*/ 518582 h 867832"/>
              <a:gd name="connsiteX117" fmla="*/ 993775 w 1006475"/>
              <a:gd name="connsiteY117" fmla="*/ 474132 h 867832"/>
              <a:gd name="connsiteX118" fmla="*/ 981075 w 1006475"/>
              <a:gd name="connsiteY118" fmla="*/ 445557 h 867832"/>
              <a:gd name="connsiteX119" fmla="*/ 974725 w 1006475"/>
              <a:gd name="connsiteY119" fmla="*/ 426507 h 867832"/>
              <a:gd name="connsiteX120" fmla="*/ 955675 w 1006475"/>
              <a:gd name="connsiteY120" fmla="*/ 397932 h 867832"/>
              <a:gd name="connsiteX121" fmla="*/ 952500 w 1006475"/>
              <a:gd name="connsiteY121" fmla="*/ 388407 h 867832"/>
              <a:gd name="connsiteX122" fmla="*/ 946150 w 1006475"/>
              <a:gd name="connsiteY122" fmla="*/ 378882 h 867832"/>
              <a:gd name="connsiteX123" fmla="*/ 942975 w 1006475"/>
              <a:gd name="connsiteY123" fmla="*/ 369357 h 867832"/>
              <a:gd name="connsiteX124" fmla="*/ 930275 w 1006475"/>
              <a:gd name="connsiteY124" fmla="*/ 350307 h 867832"/>
              <a:gd name="connsiteX125" fmla="*/ 917575 w 1006475"/>
              <a:gd name="connsiteY125" fmla="*/ 331257 h 867832"/>
              <a:gd name="connsiteX126" fmla="*/ 904875 w 1006475"/>
              <a:gd name="connsiteY126" fmla="*/ 315382 h 867832"/>
              <a:gd name="connsiteX127" fmla="*/ 889000 w 1006475"/>
              <a:gd name="connsiteY127" fmla="*/ 299507 h 867832"/>
              <a:gd name="connsiteX128" fmla="*/ 879475 w 1006475"/>
              <a:gd name="connsiteY128" fmla="*/ 280457 h 867832"/>
              <a:gd name="connsiteX129" fmla="*/ 869950 w 1006475"/>
              <a:gd name="connsiteY129" fmla="*/ 277282 h 867832"/>
              <a:gd name="connsiteX130" fmla="*/ 850900 w 1006475"/>
              <a:gd name="connsiteY130" fmla="*/ 264582 h 867832"/>
              <a:gd name="connsiteX131" fmla="*/ 841375 w 1006475"/>
              <a:gd name="connsiteY131" fmla="*/ 258232 h 867832"/>
              <a:gd name="connsiteX132" fmla="*/ 841375 w 1006475"/>
              <a:gd name="connsiteY132" fmla="*/ 239182 h 867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</a:cxnLst>
            <a:rect l="l" t="t" r="r" b="b"/>
            <a:pathLst>
              <a:path w="1006475" h="867832">
                <a:moveTo>
                  <a:pt x="841375" y="239182"/>
                </a:moveTo>
                <a:cubicBezTo>
                  <a:pt x="831850" y="234419"/>
                  <a:pt x="802784" y="235225"/>
                  <a:pt x="784225" y="229657"/>
                </a:cubicBezTo>
                <a:cubicBezTo>
                  <a:pt x="777814" y="227734"/>
                  <a:pt x="765175" y="223307"/>
                  <a:pt x="765175" y="223307"/>
                </a:cubicBezTo>
                <a:cubicBezTo>
                  <a:pt x="762000" y="221190"/>
                  <a:pt x="759063" y="218664"/>
                  <a:pt x="755650" y="216957"/>
                </a:cubicBezTo>
                <a:cubicBezTo>
                  <a:pt x="752657" y="215460"/>
                  <a:pt x="749051" y="215407"/>
                  <a:pt x="746125" y="213782"/>
                </a:cubicBezTo>
                <a:cubicBezTo>
                  <a:pt x="739454" y="210076"/>
                  <a:pt x="727075" y="201082"/>
                  <a:pt x="727075" y="201082"/>
                </a:cubicBezTo>
                <a:cubicBezTo>
                  <a:pt x="724958" y="197907"/>
                  <a:pt x="723423" y="194255"/>
                  <a:pt x="720725" y="191557"/>
                </a:cubicBezTo>
                <a:cubicBezTo>
                  <a:pt x="718027" y="188859"/>
                  <a:pt x="713584" y="188187"/>
                  <a:pt x="711200" y="185207"/>
                </a:cubicBezTo>
                <a:cubicBezTo>
                  <a:pt x="709109" y="182594"/>
                  <a:pt x="710392" y="178049"/>
                  <a:pt x="708025" y="175682"/>
                </a:cubicBezTo>
                <a:cubicBezTo>
                  <a:pt x="702629" y="170286"/>
                  <a:pt x="695325" y="167215"/>
                  <a:pt x="688975" y="162982"/>
                </a:cubicBezTo>
                <a:cubicBezTo>
                  <a:pt x="676665" y="154776"/>
                  <a:pt x="683070" y="157839"/>
                  <a:pt x="669925" y="153457"/>
                </a:cubicBezTo>
                <a:cubicBezTo>
                  <a:pt x="666750" y="151340"/>
                  <a:pt x="664020" y="148314"/>
                  <a:pt x="660400" y="147107"/>
                </a:cubicBezTo>
                <a:cubicBezTo>
                  <a:pt x="654293" y="145071"/>
                  <a:pt x="647684" y="145084"/>
                  <a:pt x="641350" y="143932"/>
                </a:cubicBezTo>
                <a:cubicBezTo>
                  <a:pt x="636041" y="142967"/>
                  <a:pt x="630767" y="141815"/>
                  <a:pt x="625475" y="140757"/>
                </a:cubicBezTo>
                <a:cubicBezTo>
                  <a:pt x="603640" y="126201"/>
                  <a:pt x="613665" y="130470"/>
                  <a:pt x="596900" y="124882"/>
                </a:cubicBezTo>
                <a:cubicBezTo>
                  <a:pt x="579967" y="99482"/>
                  <a:pt x="602192" y="130174"/>
                  <a:pt x="581025" y="109007"/>
                </a:cubicBezTo>
                <a:cubicBezTo>
                  <a:pt x="578327" y="106309"/>
                  <a:pt x="577118" y="102413"/>
                  <a:pt x="574675" y="99482"/>
                </a:cubicBezTo>
                <a:cubicBezTo>
                  <a:pt x="565349" y="88291"/>
                  <a:pt x="559375" y="86107"/>
                  <a:pt x="546100" y="77257"/>
                </a:cubicBezTo>
                <a:cubicBezTo>
                  <a:pt x="509820" y="53070"/>
                  <a:pt x="559510" y="81635"/>
                  <a:pt x="530225" y="58207"/>
                </a:cubicBezTo>
                <a:cubicBezTo>
                  <a:pt x="527612" y="56116"/>
                  <a:pt x="523875" y="56090"/>
                  <a:pt x="520700" y="55032"/>
                </a:cubicBezTo>
                <a:cubicBezTo>
                  <a:pt x="506144" y="33197"/>
                  <a:pt x="515240" y="38395"/>
                  <a:pt x="498475" y="32807"/>
                </a:cubicBezTo>
                <a:cubicBezTo>
                  <a:pt x="495300" y="30690"/>
                  <a:pt x="491881" y="28900"/>
                  <a:pt x="488950" y="26457"/>
                </a:cubicBezTo>
                <a:cubicBezTo>
                  <a:pt x="485501" y="23582"/>
                  <a:pt x="483350" y="19113"/>
                  <a:pt x="479425" y="16932"/>
                </a:cubicBezTo>
                <a:cubicBezTo>
                  <a:pt x="473574" y="13681"/>
                  <a:pt x="460375" y="10582"/>
                  <a:pt x="460375" y="10582"/>
                </a:cubicBezTo>
                <a:cubicBezTo>
                  <a:pt x="457200" y="8465"/>
                  <a:pt x="454263" y="5939"/>
                  <a:pt x="450850" y="4232"/>
                </a:cubicBezTo>
                <a:cubicBezTo>
                  <a:pt x="432821" y="-4783"/>
                  <a:pt x="406181" y="3254"/>
                  <a:pt x="390525" y="4232"/>
                </a:cubicBezTo>
                <a:cubicBezTo>
                  <a:pt x="385233" y="5290"/>
                  <a:pt x="379918" y="6236"/>
                  <a:pt x="374650" y="7407"/>
                </a:cubicBezTo>
                <a:cubicBezTo>
                  <a:pt x="370390" y="8354"/>
                  <a:pt x="366275" y="10005"/>
                  <a:pt x="361950" y="10582"/>
                </a:cubicBezTo>
                <a:cubicBezTo>
                  <a:pt x="350363" y="12127"/>
                  <a:pt x="338674" y="12786"/>
                  <a:pt x="327025" y="13757"/>
                </a:cubicBezTo>
                <a:cubicBezTo>
                  <a:pt x="270652" y="18455"/>
                  <a:pt x="280654" y="17144"/>
                  <a:pt x="209550" y="20107"/>
                </a:cubicBezTo>
                <a:cubicBezTo>
                  <a:pt x="204014" y="20799"/>
                  <a:pt x="183151" y="21721"/>
                  <a:pt x="174625" y="26457"/>
                </a:cubicBezTo>
                <a:cubicBezTo>
                  <a:pt x="167954" y="30163"/>
                  <a:pt x="155575" y="39157"/>
                  <a:pt x="155575" y="39157"/>
                </a:cubicBezTo>
                <a:cubicBezTo>
                  <a:pt x="153458" y="42332"/>
                  <a:pt x="152097" y="46169"/>
                  <a:pt x="149225" y="48682"/>
                </a:cubicBezTo>
                <a:cubicBezTo>
                  <a:pt x="143482" y="53708"/>
                  <a:pt x="130175" y="61382"/>
                  <a:pt x="130175" y="61382"/>
                </a:cubicBezTo>
                <a:cubicBezTo>
                  <a:pt x="128058" y="64557"/>
                  <a:pt x="126268" y="67976"/>
                  <a:pt x="123825" y="70907"/>
                </a:cubicBezTo>
                <a:cubicBezTo>
                  <a:pt x="120950" y="74356"/>
                  <a:pt x="116481" y="76507"/>
                  <a:pt x="114300" y="80432"/>
                </a:cubicBezTo>
                <a:cubicBezTo>
                  <a:pt x="111049" y="86283"/>
                  <a:pt x="110067" y="93132"/>
                  <a:pt x="107950" y="99482"/>
                </a:cubicBezTo>
                <a:cubicBezTo>
                  <a:pt x="105537" y="106722"/>
                  <a:pt x="99483" y="112182"/>
                  <a:pt x="95250" y="118532"/>
                </a:cubicBezTo>
                <a:cubicBezTo>
                  <a:pt x="91537" y="124101"/>
                  <a:pt x="92613" y="132013"/>
                  <a:pt x="88900" y="137582"/>
                </a:cubicBezTo>
                <a:cubicBezTo>
                  <a:pt x="70702" y="164879"/>
                  <a:pt x="92520" y="130342"/>
                  <a:pt x="79375" y="156632"/>
                </a:cubicBezTo>
                <a:cubicBezTo>
                  <a:pt x="77668" y="160045"/>
                  <a:pt x="74575" y="162670"/>
                  <a:pt x="73025" y="166157"/>
                </a:cubicBezTo>
                <a:cubicBezTo>
                  <a:pt x="70307" y="172274"/>
                  <a:pt x="68792" y="178857"/>
                  <a:pt x="66675" y="185207"/>
                </a:cubicBezTo>
                <a:lnTo>
                  <a:pt x="63500" y="194732"/>
                </a:lnTo>
                <a:cubicBezTo>
                  <a:pt x="61087" y="201972"/>
                  <a:pt x="50800" y="213782"/>
                  <a:pt x="50800" y="213782"/>
                </a:cubicBezTo>
                <a:cubicBezTo>
                  <a:pt x="49783" y="217851"/>
                  <a:pt x="46727" y="231452"/>
                  <a:pt x="44450" y="236007"/>
                </a:cubicBezTo>
                <a:cubicBezTo>
                  <a:pt x="42743" y="239420"/>
                  <a:pt x="39807" y="242119"/>
                  <a:pt x="38100" y="245532"/>
                </a:cubicBezTo>
                <a:cubicBezTo>
                  <a:pt x="24955" y="271822"/>
                  <a:pt x="46773" y="237285"/>
                  <a:pt x="28575" y="264582"/>
                </a:cubicBezTo>
                <a:cubicBezTo>
                  <a:pt x="20912" y="302896"/>
                  <a:pt x="25638" y="286093"/>
                  <a:pt x="15875" y="315382"/>
                </a:cubicBezTo>
                <a:cubicBezTo>
                  <a:pt x="14668" y="319002"/>
                  <a:pt x="11232" y="321494"/>
                  <a:pt x="9525" y="324907"/>
                </a:cubicBezTo>
                <a:cubicBezTo>
                  <a:pt x="8028" y="327900"/>
                  <a:pt x="7408" y="331257"/>
                  <a:pt x="6350" y="334432"/>
                </a:cubicBezTo>
                <a:cubicBezTo>
                  <a:pt x="5292" y="342899"/>
                  <a:pt x="4701" y="351437"/>
                  <a:pt x="3175" y="359832"/>
                </a:cubicBezTo>
                <a:cubicBezTo>
                  <a:pt x="2576" y="363125"/>
                  <a:pt x="0" y="366010"/>
                  <a:pt x="0" y="369357"/>
                </a:cubicBezTo>
                <a:cubicBezTo>
                  <a:pt x="0" y="391078"/>
                  <a:pt x="2017" y="414369"/>
                  <a:pt x="6350" y="436032"/>
                </a:cubicBezTo>
                <a:cubicBezTo>
                  <a:pt x="8749" y="448028"/>
                  <a:pt x="11825" y="455633"/>
                  <a:pt x="15875" y="467782"/>
                </a:cubicBezTo>
                <a:cubicBezTo>
                  <a:pt x="17082" y="471402"/>
                  <a:pt x="20675" y="473820"/>
                  <a:pt x="22225" y="477307"/>
                </a:cubicBezTo>
                <a:cubicBezTo>
                  <a:pt x="24943" y="483424"/>
                  <a:pt x="26458" y="490007"/>
                  <a:pt x="28575" y="496357"/>
                </a:cubicBezTo>
                <a:cubicBezTo>
                  <a:pt x="29782" y="499977"/>
                  <a:pt x="33218" y="502469"/>
                  <a:pt x="34925" y="505882"/>
                </a:cubicBezTo>
                <a:cubicBezTo>
                  <a:pt x="36422" y="508875"/>
                  <a:pt x="36603" y="512414"/>
                  <a:pt x="38100" y="515407"/>
                </a:cubicBezTo>
                <a:cubicBezTo>
                  <a:pt x="39807" y="518820"/>
                  <a:pt x="42900" y="521445"/>
                  <a:pt x="44450" y="524932"/>
                </a:cubicBezTo>
                <a:cubicBezTo>
                  <a:pt x="47168" y="531049"/>
                  <a:pt x="47087" y="538413"/>
                  <a:pt x="50800" y="543982"/>
                </a:cubicBezTo>
                <a:cubicBezTo>
                  <a:pt x="52917" y="547157"/>
                  <a:pt x="55443" y="550094"/>
                  <a:pt x="57150" y="553507"/>
                </a:cubicBezTo>
                <a:cubicBezTo>
                  <a:pt x="58647" y="556500"/>
                  <a:pt x="58469" y="560247"/>
                  <a:pt x="60325" y="563032"/>
                </a:cubicBezTo>
                <a:cubicBezTo>
                  <a:pt x="62816" y="566768"/>
                  <a:pt x="66675" y="569382"/>
                  <a:pt x="69850" y="572557"/>
                </a:cubicBezTo>
                <a:cubicBezTo>
                  <a:pt x="77830" y="596498"/>
                  <a:pt x="67065" y="566988"/>
                  <a:pt x="79375" y="591607"/>
                </a:cubicBezTo>
                <a:cubicBezTo>
                  <a:pt x="80872" y="594600"/>
                  <a:pt x="80925" y="598206"/>
                  <a:pt x="82550" y="601132"/>
                </a:cubicBezTo>
                <a:cubicBezTo>
                  <a:pt x="86256" y="607803"/>
                  <a:pt x="91017" y="613832"/>
                  <a:pt x="95250" y="620182"/>
                </a:cubicBezTo>
                <a:cubicBezTo>
                  <a:pt x="97367" y="623357"/>
                  <a:pt x="98902" y="627009"/>
                  <a:pt x="101600" y="629707"/>
                </a:cubicBezTo>
                <a:lnTo>
                  <a:pt x="111125" y="639232"/>
                </a:lnTo>
                <a:cubicBezTo>
                  <a:pt x="117306" y="657775"/>
                  <a:pt x="109464" y="640746"/>
                  <a:pt x="123825" y="655107"/>
                </a:cubicBezTo>
                <a:cubicBezTo>
                  <a:pt x="126523" y="657805"/>
                  <a:pt x="128468" y="661219"/>
                  <a:pt x="130175" y="664632"/>
                </a:cubicBezTo>
                <a:cubicBezTo>
                  <a:pt x="131672" y="667625"/>
                  <a:pt x="130983" y="671790"/>
                  <a:pt x="133350" y="674157"/>
                </a:cubicBezTo>
                <a:cubicBezTo>
                  <a:pt x="135717" y="676524"/>
                  <a:pt x="139700" y="676274"/>
                  <a:pt x="142875" y="677332"/>
                </a:cubicBezTo>
                <a:cubicBezTo>
                  <a:pt x="146050" y="679449"/>
                  <a:pt x="150016" y="680702"/>
                  <a:pt x="152400" y="683682"/>
                </a:cubicBezTo>
                <a:cubicBezTo>
                  <a:pt x="164715" y="699076"/>
                  <a:pt x="144318" y="689455"/>
                  <a:pt x="165100" y="696382"/>
                </a:cubicBezTo>
                <a:cubicBezTo>
                  <a:pt x="186517" y="717799"/>
                  <a:pt x="175631" y="712592"/>
                  <a:pt x="193675" y="718607"/>
                </a:cubicBezTo>
                <a:cubicBezTo>
                  <a:pt x="200025" y="722840"/>
                  <a:pt x="207329" y="725911"/>
                  <a:pt x="212725" y="731307"/>
                </a:cubicBezTo>
                <a:cubicBezTo>
                  <a:pt x="224617" y="743199"/>
                  <a:pt x="217990" y="739412"/>
                  <a:pt x="231775" y="744007"/>
                </a:cubicBezTo>
                <a:cubicBezTo>
                  <a:pt x="233892" y="747182"/>
                  <a:pt x="235253" y="751019"/>
                  <a:pt x="238125" y="753532"/>
                </a:cubicBezTo>
                <a:lnTo>
                  <a:pt x="266700" y="772582"/>
                </a:lnTo>
                <a:lnTo>
                  <a:pt x="276225" y="778932"/>
                </a:lnTo>
                <a:lnTo>
                  <a:pt x="285750" y="785282"/>
                </a:lnTo>
                <a:cubicBezTo>
                  <a:pt x="320675" y="784224"/>
                  <a:pt x="355632" y="783943"/>
                  <a:pt x="390525" y="782107"/>
                </a:cubicBezTo>
                <a:cubicBezTo>
                  <a:pt x="395914" y="781823"/>
                  <a:pt x="401004" y="778932"/>
                  <a:pt x="406400" y="778932"/>
                </a:cubicBezTo>
                <a:cubicBezTo>
                  <a:pt x="426536" y="778932"/>
                  <a:pt x="446617" y="781049"/>
                  <a:pt x="466725" y="782107"/>
                </a:cubicBezTo>
                <a:cubicBezTo>
                  <a:pt x="475217" y="783522"/>
                  <a:pt x="492775" y="786238"/>
                  <a:pt x="501650" y="788457"/>
                </a:cubicBezTo>
                <a:cubicBezTo>
                  <a:pt x="504897" y="789269"/>
                  <a:pt x="507957" y="790713"/>
                  <a:pt x="511175" y="791632"/>
                </a:cubicBezTo>
                <a:cubicBezTo>
                  <a:pt x="515371" y="792831"/>
                  <a:pt x="519695" y="793553"/>
                  <a:pt x="523875" y="794807"/>
                </a:cubicBezTo>
                <a:cubicBezTo>
                  <a:pt x="534461" y="797983"/>
                  <a:pt x="544648" y="802502"/>
                  <a:pt x="555625" y="804332"/>
                </a:cubicBezTo>
                <a:cubicBezTo>
                  <a:pt x="569108" y="806579"/>
                  <a:pt x="600546" y="809459"/>
                  <a:pt x="612775" y="810682"/>
                </a:cubicBezTo>
                <a:lnTo>
                  <a:pt x="631825" y="817032"/>
                </a:lnTo>
                <a:lnTo>
                  <a:pt x="641350" y="820207"/>
                </a:lnTo>
                <a:cubicBezTo>
                  <a:pt x="656444" y="830270"/>
                  <a:pt x="647255" y="825350"/>
                  <a:pt x="669925" y="832907"/>
                </a:cubicBezTo>
                <a:lnTo>
                  <a:pt x="679450" y="836082"/>
                </a:lnTo>
                <a:cubicBezTo>
                  <a:pt x="685800" y="840315"/>
                  <a:pt x="691260" y="846369"/>
                  <a:pt x="698500" y="848782"/>
                </a:cubicBezTo>
                <a:lnTo>
                  <a:pt x="746125" y="864657"/>
                </a:lnTo>
                <a:cubicBezTo>
                  <a:pt x="751245" y="866364"/>
                  <a:pt x="756708" y="866774"/>
                  <a:pt x="762000" y="867832"/>
                </a:cubicBezTo>
                <a:cubicBezTo>
                  <a:pt x="773642" y="866774"/>
                  <a:pt x="785413" y="866688"/>
                  <a:pt x="796925" y="864657"/>
                </a:cubicBezTo>
                <a:cubicBezTo>
                  <a:pt x="803517" y="863494"/>
                  <a:pt x="809625" y="860424"/>
                  <a:pt x="815975" y="858307"/>
                </a:cubicBezTo>
                <a:lnTo>
                  <a:pt x="825500" y="855132"/>
                </a:lnTo>
                <a:lnTo>
                  <a:pt x="854075" y="836082"/>
                </a:lnTo>
                <a:cubicBezTo>
                  <a:pt x="859644" y="832369"/>
                  <a:pt x="873125" y="829732"/>
                  <a:pt x="873125" y="829732"/>
                </a:cubicBezTo>
                <a:lnTo>
                  <a:pt x="901700" y="810682"/>
                </a:lnTo>
                <a:cubicBezTo>
                  <a:pt x="907269" y="806969"/>
                  <a:pt x="920750" y="804332"/>
                  <a:pt x="920750" y="804332"/>
                </a:cubicBezTo>
                <a:cubicBezTo>
                  <a:pt x="923925" y="801157"/>
                  <a:pt x="927784" y="798543"/>
                  <a:pt x="930275" y="794807"/>
                </a:cubicBezTo>
                <a:cubicBezTo>
                  <a:pt x="932131" y="792022"/>
                  <a:pt x="931953" y="788275"/>
                  <a:pt x="933450" y="785282"/>
                </a:cubicBezTo>
                <a:cubicBezTo>
                  <a:pt x="935157" y="781869"/>
                  <a:pt x="938250" y="779244"/>
                  <a:pt x="939800" y="775757"/>
                </a:cubicBezTo>
                <a:cubicBezTo>
                  <a:pt x="954913" y="741752"/>
                  <a:pt x="938129" y="768738"/>
                  <a:pt x="952500" y="747182"/>
                </a:cubicBezTo>
                <a:cubicBezTo>
                  <a:pt x="953517" y="743113"/>
                  <a:pt x="956573" y="729512"/>
                  <a:pt x="958850" y="724957"/>
                </a:cubicBezTo>
                <a:cubicBezTo>
                  <a:pt x="960557" y="721544"/>
                  <a:pt x="963650" y="718919"/>
                  <a:pt x="965200" y="715432"/>
                </a:cubicBezTo>
                <a:cubicBezTo>
                  <a:pt x="972108" y="699889"/>
                  <a:pt x="970462" y="697890"/>
                  <a:pt x="974725" y="683682"/>
                </a:cubicBezTo>
                <a:cubicBezTo>
                  <a:pt x="976648" y="677271"/>
                  <a:pt x="978958" y="670982"/>
                  <a:pt x="981075" y="664632"/>
                </a:cubicBezTo>
                <a:cubicBezTo>
                  <a:pt x="982282" y="661012"/>
                  <a:pt x="985875" y="658594"/>
                  <a:pt x="987425" y="655107"/>
                </a:cubicBezTo>
                <a:cubicBezTo>
                  <a:pt x="990143" y="648990"/>
                  <a:pt x="993775" y="636057"/>
                  <a:pt x="993775" y="636057"/>
                </a:cubicBezTo>
                <a:cubicBezTo>
                  <a:pt x="997780" y="604015"/>
                  <a:pt x="994252" y="618752"/>
                  <a:pt x="1003300" y="591607"/>
                </a:cubicBezTo>
                <a:lnTo>
                  <a:pt x="1006475" y="582082"/>
                </a:lnTo>
                <a:cubicBezTo>
                  <a:pt x="1004527" y="558704"/>
                  <a:pt x="1005090" y="547967"/>
                  <a:pt x="1000125" y="528107"/>
                </a:cubicBezTo>
                <a:cubicBezTo>
                  <a:pt x="999313" y="524860"/>
                  <a:pt x="998008" y="521757"/>
                  <a:pt x="996950" y="518582"/>
                </a:cubicBezTo>
                <a:cubicBezTo>
                  <a:pt x="995892" y="503765"/>
                  <a:pt x="995979" y="488822"/>
                  <a:pt x="993775" y="474132"/>
                </a:cubicBezTo>
                <a:cubicBezTo>
                  <a:pt x="989494" y="445594"/>
                  <a:pt x="989270" y="463996"/>
                  <a:pt x="981075" y="445557"/>
                </a:cubicBezTo>
                <a:cubicBezTo>
                  <a:pt x="978357" y="439440"/>
                  <a:pt x="976842" y="432857"/>
                  <a:pt x="974725" y="426507"/>
                </a:cubicBezTo>
                <a:lnTo>
                  <a:pt x="955675" y="397932"/>
                </a:lnTo>
                <a:cubicBezTo>
                  <a:pt x="953819" y="395147"/>
                  <a:pt x="953997" y="391400"/>
                  <a:pt x="952500" y="388407"/>
                </a:cubicBezTo>
                <a:cubicBezTo>
                  <a:pt x="950793" y="384994"/>
                  <a:pt x="947857" y="382295"/>
                  <a:pt x="946150" y="378882"/>
                </a:cubicBezTo>
                <a:cubicBezTo>
                  <a:pt x="944653" y="375889"/>
                  <a:pt x="944600" y="372283"/>
                  <a:pt x="942975" y="369357"/>
                </a:cubicBezTo>
                <a:cubicBezTo>
                  <a:pt x="939269" y="362686"/>
                  <a:pt x="932688" y="357547"/>
                  <a:pt x="930275" y="350307"/>
                </a:cubicBezTo>
                <a:cubicBezTo>
                  <a:pt x="925680" y="336522"/>
                  <a:pt x="929467" y="343149"/>
                  <a:pt x="917575" y="331257"/>
                </a:cubicBezTo>
                <a:cubicBezTo>
                  <a:pt x="911394" y="312714"/>
                  <a:pt x="919236" y="329743"/>
                  <a:pt x="904875" y="315382"/>
                </a:cubicBezTo>
                <a:cubicBezTo>
                  <a:pt x="883708" y="294215"/>
                  <a:pt x="914400" y="316440"/>
                  <a:pt x="889000" y="299507"/>
                </a:cubicBezTo>
                <a:cubicBezTo>
                  <a:pt x="886908" y="293232"/>
                  <a:pt x="885070" y="284933"/>
                  <a:pt x="879475" y="280457"/>
                </a:cubicBezTo>
                <a:cubicBezTo>
                  <a:pt x="876862" y="278366"/>
                  <a:pt x="873125" y="278340"/>
                  <a:pt x="869950" y="277282"/>
                </a:cubicBezTo>
                <a:lnTo>
                  <a:pt x="850900" y="264582"/>
                </a:lnTo>
                <a:cubicBezTo>
                  <a:pt x="847725" y="262465"/>
                  <a:pt x="845077" y="259157"/>
                  <a:pt x="841375" y="258232"/>
                </a:cubicBezTo>
                <a:cubicBezTo>
                  <a:pt x="826622" y="254544"/>
                  <a:pt x="850900" y="243945"/>
                  <a:pt x="841375" y="239182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11" name="フリーフォーム 110"/>
          <p:cNvSpPr/>
          <p:nvPr/>
        </p:nvSpPr>
        <p:spPr>
          <a:xfrm>
            <a:off x="2024766" y="1237474"/>
            <a:ext cx="1006475" cy="867832"/>
          </a:xfrm>
          <a:custGeom>
            <a:avLst/>
            <a:gdLst>
              <a:gd name="connsiteX0" fmla="*/ 841375 w 1006475"/>
              <a:gd name="connsiteY0" fmla="*/ 239182 h 867832"/>
              <a:gd name="connsiteX1" fmla="*/ 784225 w 1006475"/>
              <a:gd name="connsiteY1" fmla="*/ 229657 h 867832"/>
              <a:gd name="connsiteX2" fmla="*/ 765175 w 1006475"/>
              <a:gd name="connsiteY2" fmla="*/ 223307 h 867832"/>
              <a:gd name="connsiteX3" fmla="*/ 755650 w 1006475"/>
              <a:gd name="connsiteY3" fmla="*/ 216957 h 867832"/>
              <a:gd name="connsiteX4" fmla="*/ 746125 w 1006475"/>
              <a:gd name="connsiteY4" fmla="*/ 213782 h 867832"/>
              <a:gd name="connsiteX5" fmla="*/ 727075 w 1006475"/>
              <a:gd name="connsiteY5" fmla="*/ 201082 h 867832"/>
              <a:gd name="connsiteX6" fmla="*/ 720725 w 1006475"/>
              <a:gd name="connsiteY6" fmla="*/ 191557 h 867832"/>
              <a:gd name="connsiteX7" fmla="*/ 711200 w 1006475"/>
              <a:gd name="connsiteY7" fmla="*/ 185207 h 867832"/>
              <a:gd name="connsiteX8" fmla="*/ 708025 w 1006475"/>
              <a:gd name="connsiteY8" fmla="*/ 175682 h 867832"/>
              <a:gd name="connsiteX9" fmla="*/ 688975 w 1006475"/>
              <a:gd name="connsiteY9" fmla="*/ 162982 h 867832"/>
              <a:gd name="connsiteX10" fmla="*/ 669925 w 1006475"/>
              <a:gd name="connsiteY10" fmla="*/ 153457 h 867832"/>
              <a:gd name="connsiteX11" fmla="*/ 660400 w 1006475"/>
              <a:gd name="connsiteY11" fmla="*/ 147107 h 867832"/>
              <a:gd name="connsiteX12" fmla="*/ 641350 w 1006475"/>
              <a:gd name="connsiteY12" fmla="*/ 143932 h 867832"/>
              <a:gd name="connsiteX13" fmla="*/ 625475 w 1006475"/>
              <a:gd name="connsiteY13" fmla="*/ 140757 h 867832"/>
              <a:gd name="connsiteX14" fmla="*/ 596900 w 1006475"/>
              <a:gd name="connsiteY14" fmla="*/ 124882 h 867832"/>
              <a:gd name="connsiteX15" fmla="*/ 581025 w 1006475"/>
              <a:gd name="connsiteY15" fmla="*/ 109007 h 867832"/>
              <a:gd name="connsiteX16" fmla="*/ 574675 w 1006475"/>
              <a:gd name="connsiteY16" fmla="*/ 99482 h 867832"/>
              <a:gd name="connsiteX17" fmla="*/ 546100 w 1006475"/>
              <a:gd name="connsiteY17" fmla="*/ 77257 h 867832"/>
              <a:gd name="connsiteX18" fmla="*/ 530225 w 1006475"/>
              <a:gd name="connsiteY18" fmla="*/ 58207 h 867832"/>
              <a:gd name="connsiteX19" fmla="*/ 520700 w 1006475"/>
              <a:gd name="connsiteY19" fmla="*/ 55032 h 867832"/>
              <a:gd name="connsiteX20" fmla="*/ 498475 w 1006475"/>
              <a:gd name="connsiteY20" fmla="*/ 32807 h 867832"/>
              <a:gd name="connsiteX21" fmla="*/ 488950 w 1006475"/>
              <a:gd name="connsiteY21" fmla="*/ 26457 h 867832"/>
              <a:gd name="connsiteX22" fmla="*/ 479425 w 1006475"/>
              <a:gd name="connsiteY22" fmla="*/ 16932 h 867832"/>
              <a:gd name="connsiteX23" fmla="*/ 460375 w 1006475"/>
              <a:gd name="connsiteY23" fmla="*/ 10582 h 867832"/>
              <a:gd name="connsiteX24" fmla="*/ 450850 w 1006475"/>
              <a:gd name="connsiteY24" fmla="*/ 4232 h 867832"/>
              <a:gd name="connsiteX25" fmla="*/ 390525 w 1006475"/>
              <a:gd name="connsiteY25" fmla="*/ 4232 h 867832"/>
              <a:gd name="connsiteX26" fmla="*/ 374650 w 1006475"/>
              <a:gd name="connsiteY26" fmla="*/ 7407 h 867832"/>
              <a:gd name="connsiteX27" fmla="*/ 361950 w 1006475"/>
              <a:gd name="connsiteY27" fmla="*/ 10582 h 867832"/>
              <a:gd name="connsiteX28" fmla="*/ 327025 w 1006475"/>
              <a:gd name="connsiteY28" fmla="*/ 13757 h 867832"/>
              <a:gd name="connsiteX29" fmla="*/ 209550 w 1006475"/>
              <a:gd name="connsiteY29" fmla="*/ 20107 h 867832"/>
              <a:gd name="connsiteX30" fmla="*/ 174625 w 1006475"/>
              <a:gd name="connsiteY30" fmla="*/ 26457 h 867832"/>
              <a:gd name="connsiteX31" fmla="*/ 155575 w 1006475"/>
              <a:gd name="connsiteY31" fmla="*/ 39157 h 867832"/>
              <a:gd name="connsiteX32" fmla="*/ 149225 w 1006475"/>
              <a:gd name="connsiteY32" fmla="*/ 48682 h 867832"/>
              <a:gd name="connsiteX33" fmla="*/ 130175 w 1006475"/>
              <a:gd name="connsiteY33" fmla="*/ 61382 h 867832"/>
              <a:gd name="connsiteX34" fmla="*/ 123825 w 1006475"/>
              <a:gd name="connsiteY34" fmla="*/ 70907 h 867832"/>
              <a:gd name="connsiteX35" fmla="*/ 114300 w 1006475"/>
              <a:gd name="connsiteY35" fmla="*/ 80432 h 867832"/>
              <a:gd name="connsiteX36" fmla="*/ 107950 w 1006475"/>
              <a:gd name="connsiteY36" fmla="*/ 99482 h 867832"/>
              <a:gd name="connsiteX37" fmla="*/ 95250 w 1006475"/>
              <a:gd name="connsiteY37" fmla="*/ 118532 h 867832"/>
              <a:gd name="connsiteX38" fmla="*/ 88900 w 1006475"/>
              <a:gd name="connsiteY38" fmla="*/ 137582 h 867832"/>
              <a:gd name="connsiteX39" fmla="*/ 79375 w 1006475"/>
              <a:gd name="connsiteY39" fmla="*/ 156632 h 867832"/>
              <a:gd name="connsiteX40" fmla="*/ 73025 w 1006475"/>
              <a:gd name="connsiteY40" fmla="*/ 166157 h 867832"/>
              <a:gd name="connsiteX41" fmla="*/ 66675 w 1006475"/>
              <a:gd name="connsiteY41" fmla="*/ 185207 h 867832"/>
              <a:gd name="connsiteX42" fmla="*/ 63500 w 1006475"/>
              <a:gd name="connsiteY42" fmla="*/ 194732 h 867832"/>
              <a:gd name="connsiteX43" fmla="*/ 50800 w 1006475"/>
              <a:gd name="connsiteY43" fmla="*/ 213782 h 867832"/>
              <a:gd name="connsiteX44" fmla="*/ 44450 w 1006475"/>
              <a:gd name="connsiteY44" fmla="*/ 236007 h 867832"/>
              <a:gd name="connsiteX45" fmla="*/ 38100 w 1006475"/>
              <a:gd name="connsiteY45" fmla="*/ 245532 h 867832"/>
              <a:gd name="connsiteX46" fmla="*/ 28575 w 1006475"/>
              <a:gd name="connsiteY46" fmla="*/ 264582 h 867832"/>
              <a:gd name="connsiteX47" fmla="*/ 15875 w 1006475"/>
              <a:gd name="connsiteY47" fmla="*/ 315382 h 867832"/>
              <a:gd name="connsiteX48" fmla="*/ 9525 w 1006475"/>
              <a:gd name="connsiteY48" fmla="*/ 324907 h 867832"/>
              <a:gd name="connsiteX49" fmla="*/ 6350 w 1006475"/>
              <a:gd name="connsiteY49" fmla="*/ 334432 h 867832"/>
              <a:gd name="connsiteX50" fmla="*/ 3175 w 1006475"/>
              <a:gd name="connsiteY50" fmla="*/ 359832 h 867832"/>
              <a:gd name="connsiteX51" fmla="*/ 0 w 1006475"/>
              <a:gd name="connsiteY51" fmla="*/ 369357 h 867832"/>
              <a:gd name="connsiteX52" fmla="*/ 6350 w 1006475"/>
              <a:gd name="connsiteY52" fmla="*/ 436032 h 867832"/>
              <a:gd name="connsiteX53" fmla="*/ 15875 w 1006475"/>
              <a:gd name="connsiteY53" fmla="*/ 467782 h 867832"/>
              <a:gd name="connsiteX54" fmla="*/ 22225 w 1006475"/>
              <a:gd name="connsiteY54" fmla="*/ 477307 h 867832"/>
              <a:gd name="connsiteX55" fmla="*/ 28575 w 1006475"/>
              <a:gd name="connsiteY55" fmla="*/ 496357 h 867832"/>
              <a:gd name="connsiteX56" fmla="*/ 34925 w 1006475"/>
              <a:gd name="connsiteY56" fmla="*/ 505882 h 867832"/>
              <a:gd name="connsiteX57" fmla="*/ 38100 w 1006475"/>
              <a:gd name="connsiteY57" fmla="*/ 515407 h 867832"/>
              <a:gd name="connsiteX58" fmla="*/ 44450 w 1006475"/>
              <a:gd name="connsiteY58" fmla="*/ 524932 h 867832"/>
              <a:gd name="connsiteX59" fmla="*/ 50800 w 1006475"/>
              <a:gd name="connsiteY59" fmla="*/ 543982 h 867832"/>
              <a:gd name="connsiteX60" fmla="*/ 57150 w 1006475"/>
              <a:gd name="connsiteY60" fmla="*/ 553507 h 867832"/>
              <a:gd name="connsiteX61" fmla="*/ 60325 w 1006475"/>
              <a:gd name="connsiteY61" fmla="*/ 563032 h 867832"/>
              <a:gd name="connsiteX62" fmla="*/ 69850 w 1006475"/>
              <a:gd name="connsiteY62" fmla="*/ 572557 h 867832"/>
              <a:gd name="connsiteX63" fmla="*/ 79375 w 1006475"/>
              <a:gd name="connsiteY63" fmla="*/ 591607 h 867832"/>
              <a:gd name="connsiteX64" fmla="*/ 82550 w 1006475"/>
              <a:gd name="connsiteY64" fmla="*/ 601132 h 867832"/>
              <a:gd name="connsiteX65" fmla="*/ 95250 w 1006475"/>
              <a:gd name="connsiteY65" fmla="*/ 620182 h 867832"/>
              <a:gd name="connsiteX66" fmla="*/ 101600 w 1006475"/>
              <a:gd name="connsiteY66" fmla="*/ 629707 h 867832"/>
              <a:gd name="connsiteX67" fmla="*/ 111125 w 1006475"/>
              <a:gd name="connsiteY67" fmla="*/ 639232 h 867832"/>
              <a:gd name="connsiteX68" fmla="*/ 123825 w 1006475"/>
              <a:gd name="connsiteY68" fmla="*/ 655107 h 867832"/>
              <a:gd name="connsiteX69" fmla="*/ 130175 w 1006475"/>
              <a:gd name="connsiteY69" fmla="*/ 664632 h 867832"/>
              <a:gd name="connsiteX70" fmla="*/ 133350 w 1006475"/>
              <a:gd name="connsiteY70" fmla="*/ 674157 h 867832"/>
              <a:gd name="connsiteX71" fmla="*/ 142875 w 1006475"/>
              <a:gd name="connsiteY71" fmla="*/ 677332 h 867832"/>
              <a:gd name="connsiteX72" fmla="*/ 152400 w 1006475"/>
              <a:gd name="connsiteY72" fmla="*/ 683682 h 867832"/>
              <a:gd name="connsiteX73" fmla="*/ 165100 w 1006475"/>
              <a:gd name="connsiteY73" fmla="*/ 696382 h 867832"/>
              <a:gd name="connsiteX74" fmla="*/ 193675 w 1006475"/>
              <a:gd name="connsiteY74" fmla="*/ 718607 h 867832"/>
              <a:gd name="connsiteX75" fmla="*/ 212725 w 1006475"/>
              <a:gd name="connsiteY75" fmla="*/ 731307 h 867832"/>
              <a:gd name="connsiteX76" fmla="*/ 231775 w 1006475"/>
              <a:gd name="connsiteY76" fmla="*/ 744007 h 867832"/>
              <a:gd name="connsiteX77" fmla="*/ 238125 w 1006475"/>
              <a:gd name="connsiteY77" fmla="*/ 753532 h 867832"/>
              <a:gd name="connsiteX78" fmla="*/ 266700 w 1006475"/>
              <a:gd name="connsiteY78" fmla="*/ 772582 h 867832"/>
              <a:gd name="connsiteX79" fmla="*/ 276225 w 1006475"/>
              <a:gd name="connsiteY79" fmla="*/ 778932 h 867832"/>
              <a:gd name="connsiteX80" fmla="*/ 285750 w 1006475"/>
              <a:gd name="connsiteY80" fmla="*/ 785282 h 867832"/>
              <a:gd name="connsiteX81" fmla="*/ 390525 w 1006475"/>
              <a:gd name="connsiteY81" fmla="*/ 782107 h 867832"/>
              <a:gd name="connsiteX82" fmla="*/ 406400 w 1006475"/>
              <a:gd name="connsiteY82" fmla="*/ 778932 h 867832"/>
              <a:gd name="connsiteX83" fmla="*/ 466725 w 1006475"/>
              <a:gd name="connsiteY83" fmla="*/ 782107 h 867832"/>
              <a:gd name="connsiteX84" fmla="*/ 501650 w 1006475"/>
              <a:gd name="connsiteY84" fmla="*/ 788457 h 867832"/>
              <a:gd name="connsiteX85" fmla="*/ 511175 w 1006475"/>
              <a:gd name="connsiteY85" fmla="*/ 791632 h 867832"/>
              <a:gd name="connsiteX86" fmla="*/ 523875 w 1006475"/>
              <a:gd name="connsiteY86" fmla="*/ 794807 h 867832"/>
              <a:gd name="connsiteX87" fmla="*/ 555625 w 1006475"/>
              <a:gd name="connsiteY87" fmla="*/ 804332 h 867832"/>
              <a:gd name="connsiteX88" fmla="*/ 612775 w 1006475"/>
              <a:gd name="connsiteY88" fmla="*/ 810682 h 867832"/>
              <a:gd name="connsiteX89" fmla="*/ 631825 w 1006475"/>
              <a:gd name="connsiteY89" fmla="*/ 817032 h 867832"/>
              <a:gd name="connsiteX90" fmla="*/ 641350 w 1006475"/>
              <a:gd name="connsiteY90" fmla="*/ 820207 h 867832"/>
              <a:gd name="connsiteX91" fmla="*/ 669925 w 1006475"/>
              <a:gd name="connsiteY91" fmla="*/ 832907 h 867832"/>
              <a:gd name="connsiteX92" fmla="*/ 679450 w 1006475"/>
              <a:gd name="connsiteY92" fmla="*/ 836082 h 867832"/>
              <a:gd name="connsiteX93" fmla="*/ 698500 w 1006475"/>
              <a:gd name="connsiteY93" fmla="*/ 848782 h 867832"/>
              <a:gd name="connsiteX94" fmla="*/ 746125 w 1006475"/>
              <a:gd name="connsiteY94" fmla="*/ 864657 h 867832"/>
              <a:gd name="connsiteX95" fmla="*/ 762000 w 1006475"/>
              <a:gd name="connsiteY95" fmla="*/ 867832 h 867832"/>
              <a:gd name="connsiteX96" fmla="*/ 796925 w 1006475"/>
              <a:gd name="connsiteY96" fmla="*/ 864657 h 867832"/>
              <a:gd name="connsiteX97" fmla="*/ 815975 w 1006475"/>
              <a:gd name="connsiteY97" fmla="*/ 858307 h 867832"/>
              <a:gd name="connsiteX98" fmla="*/ 825500 w 1006475"/>
              <a:gd name="connsiteY98" fmla="*/ 855132 h 867832"/>
              <a:gd name="connsiteX99" fmla="*/ 854075 w 1006475"/>
              <a:gd name="connsiteY99" fmla="*/ 836082 h 867832"/>
              <a:gd name="connsiteX100" fmla="*/ 873125 w 1006475"/>
              <a:gd name="connsiteY100" fmla="*/ 829732 h 867832"/>
              <a:gd name="connsiteX101" fmla="*/ 901700 w 1006475"/>
              <a:gd name="connsiteY101" fmla="*/ 810682 h 867832"/>
              <a:gd name="connsiteX102" fmla="*/ 920750 w 1006475"/>
              <a:gd name="connsiteY102" fmla="*/ 804332 h 867832"/>
              <a:gd name="connsiteX103" fmla="*/ 930275 w 1006475"/>
              <a:gd name="connsiteY103" fmla="*/ 794807 h 867832"/>
              <a:gd name="connsiteX104" fmla="*/ 933450 w 1006475"/>
              <a:gd name="connsiteY104" fmla="*/ 785282 h 867832"/>
              <a:gd name="connsiteX105" fmla="*/ 939800 w 1006475"/>
              <a:gd name="connsiteY105" fmla="*/ 775757 h 867832"/>
              <a:gd name="connsiteX106" fmla="*/ 952500 w 1006475"/>
              <a:gd name="connsiteY106" fmla="*/ 747182 h 867832"/>
              <a:gd name="connsiteX107" fmla="*/ 958850 w 1006475"/>
              <a:gd name="connsiteY107" fmla="*/ 724957 h 867832"/>
              <a:gd name="connsiteX108" fmla="*/ 965200 w 1006475"/>
              <a:gd name="connsiteY108" fmla="*/ 715432 h 867832"/>
              <a:gd name="connsiteX109" fmla="*/ 974725 w 1006475"/>
              <a:gd name="connsiteY109" fmla="*/ 683682 h 867832"/>
              <a:gd name="connsiteX110" fmla="*/ 981075 w 1006475"/>
              <a:gd name="connsiteY110" fmla="*/ 664632 h 867832"/>
              <a:gd name="connsiteX111" fmla="*/ 987425 w 1006475"/>
              <a:gd name="connsiteY111" fmla="*/ 655107 h 867832"/>
              <a:gd name="connsiteX112" fmla="*/ 993775 w 1006475"/>
              <a:gd name="connsiteY112" fmla="*/ 636057 h 867832"/>
              <a:gd name="connsiteX113" fmla="*/ 1003300 w 1006475"/>
              <a:gd name="connsiteY113" fmla="*/ 591607 h 867832"/>
              <a:gd name="connsiteX114" fmla="*/ 1006475 w 1006475"/>
              <a:gd name="connsiteY114" fmla="*/ 582082 h 867832"/>
              <a:gd name="connsiteX115" fmla="*/ 1000125 w 1006475"/>
              <a:gd name="connsiteY115" fmla="*/ 528107 h 867832"/>
              <a:gd name="connsiteX116" fmla="*/ 996950 w 1006475"/>
              <a:gd name="connsiteY116" fmla="*/ 518582 h 867832"/>
              <a:gd name="connsiteX117" fmla="*/ 993775 w 1006475"/>
              <a:gd name="connsiteY117" fmla="*/ 474132 h 867832"/>
              <a:gd name="connsiteX118" fmla="*/ 981075 w 1006475"/>
              <a:gd name="connsiteY118" fmla="*/ 445557 h 867832"/>
              <a:gd name="connsiteX119" fmla="*/ 974725 w 1006475"/>
              <a:gd name="connsiteY119" fmla="*/ 426507 h 867832"/>
              <a:gd name="connsiteX120" fmla="*/ 955675 w 1006475"/>
              <a:gd name="connsiteY120" fmla="*/ 397932 h 867832"/>
              <a:gd name="connsiteX121" fmla="*/ 952500 w 1006475"/>
              <a:gd name="connsiteY121" fmla="*/ 388407 h 867832"/>
              <a:gd name="connsiteX122" fmla="*/ 946150 w 1006475"/>
              <a:gd name="connsiteY122" fmla="*/ 378882 h 867832"/>
              <a:gd name="connsiteX123" fmla="*/ 942975 w 1006475"/>
              <a:gd name="connsiteY123" fmla="*/ 369357 h 867832"/>
              <a:gd name="connsiteX124" fmla="*/ 930275 w 1006475"/>
              <a:gd name="connsiteY124" fmla="*/ 350307 h 867832"/>
              <a:gd name="connsiteX125" fmla="*/ 917575 w 1006475"/>
              <a:gd name="connsiteY125" fmla="*/ 331257 h 867832"/>
              <a:gd name="connsiteX126" fmla="*/ 904875 w 1006475"/>
              <a:gd name="connsiteY126" fmla="*/ 315382 h 867832"/>
              <a:gd name="connsiteX127" fmla="*/ 889000 w 1006475"/>
              <a:gd name="connsiteY127" fmla="*/ 299507 h 867832"/>
              <a:gd name="connsiteX128" fmla="*/ 879475 w 1006475"/>
              <a:gd name="connsiteY128" fmla="*/ 280457 h 867832"/>
              <a:gd name="connsiteX129" fmla="*/ 869950 w 1006475"/>
              <a:gd name="connsiteY129" fmla="*/ 277282 h 867832"/>
              <a:gd name="connsiteX130" fmla="*/ 850900 w 1006475"/>
              <a:gd name="connsiteY130" fmla="*/ 264582 h 867832"/>
              <a:gd name="connsiteX131" fmla="*/ 841375 w 1006475"/>
              <a:gd name="connsiteY131" fmla="*/ 258232 h 867832"/>
              <a:gd name="connsiteX132" fmla="*/ 841375 w 1006475"/>
              <a:gd name="connsiteY132" fmla="*/ 239182 h 867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</a:cxnLst>
            <a:rect l="l" t="t" r="r" b="b"/>
            <a:pathLst>
              <a:path w="1006475" h="867832">
                <a:moveTo>
                  <a:pt x="841375" y="239182"/>
                </a:moveTo>
                <a:cubicBezTo>
                  <a:pt x="831850" y="234419"/>
                  <a:pt x="802784" y="235225"/>
                  <a:pt x="784225" y="229657"/>
                </a:cubicBezTo>
                <a:cubicBezTo>
                  <a:pt x="777814" y="227734"/>
                  <a:pt x="765175" y="223307"/>
                  <a:pt x="765175" y="223307"/>
                </a:cubicBezTo>
                <a:cubicBezTo>
                  <a:pt x="762000" y="221190"/>
                  <a:pt x="759063" y="218664"/>
                  <a:pt x="755650" y="216957"/>
                </a:cubicBezTo>
                <a:cubicBezTo>
                  <a:pt x="752657" y="215460"/>
                  <a:pt x="749051" y="215407"/>
                  <a:pt x="746125" y="213782"/>
                </a:cubicBezTo>
                <a:cubicBezTo>
                  <a:pt x="739454" y="210076"/>
                  <a:pt x="727075" y="201082"/>
                  <a:pt x="727075" y="201082"/>
                </a:cubicBezTo>
                <a:cubicBezTo>
                  <a:pt x="724958" y="197907"/>
                  <a:pt x="723423" y="194255"/>
                  <a:pt x="720725" y="191557"/>
                </a:cubicBezTo>
                <a:cubicBezTo>
                  <a:pt x="718027" y="188859"/>
                  <a:pt x="713584" y="188187"/>
                  <a:pt x="711200" y="185207"/>
                </a:cubicBezTo>
                <a:cubicBezTo>
                  <a:pt x="709109" y="182594"/>
                  <a:pt x="710392" y="178049"/>
                  <a:pt x="708025" y="175682"/>
                </a:cubicBezTo>
                <a:cubicBezTo>
                  <a:pt x="702629" y="170286"/>
                  <a:pt x="695325" y="167215"/>
                  <a:pt x="688975" y="162982"/>
                </a:cubicBezTo>
                <a:cubicBezTo>
                  <a:pt x="676665" y="154776"/>
                  <a:pt x="683070" y="157839"/>
                  <a:pt x="669925" y="153457"/>
                </a:cubicBezTo>
                <a:cubicBezTo>
                  <a:pt x="666750" y="151340"/>
                  <a:pt x="664020" y="148314"/>
                  <a:pt x="660400" y="147107"/>
                </a:cubicBezTo>
                <a:cubicBezTo>
                  <a:pt x="654293" y="145071"/>
                  <a:pt x="647684" y="145084"/>
                  <a:pt x="641350" y="143932"/>
                </a:cubicBezTo>
                <a:cubicBezTo>
                  <a:pt x="636041" y="142967"/>
                  <a:pt x="630767" y="141815"/>
                  <a:pt x="625475" y="140757"/>
                </a:cubicBezTo>
                <a:cubicBezTo>
                  <a:pt x="603640" y="126201"/>
                  <a:pt x="613665" y="130470"/>
                  <a:pt x="596900" y="124882"/>
                </a:cubicBezTo>
                <a:cubicBezTo>
                  <a:pt x="579967" y="99482"/>
                  <a:pt x="602192" y="130174"/>
                  <a:pt x="581025" y="109007"/>
                </a:cubicBezTo>
                <a:cubicBezTo>
                  <a:pt x="578327" y="106309"/>
                  <a:pt x="577118" y="102413"/>
                  <a:pt x="574675" y="99482"/>
                </a:cubicBezTo>
                <a:cubicBezTo>
                  <a:pt x="565349" y="88291"/>
                  <a:pt x="559375" y="86107"/>
                  <a:pt x="546100" y="77257"/>
                </a:cubicBezTo>
                <a:cubicBezTo>
                  <a:pt x="509820" y="53070"/>
                  <a:pt x="559510" y="81635"/>
                  <a:pt x="530225" y="58207"/>
                </a:cubicBezTo>
                <a:cubicBezTo>
                  <a:pt x="527612" y="56116"/>
                  <a:pt x="523875" y="56090"/>
                  <a:pt x="520700" y="55032"/>
                </a:cubicBezTo>
                <a:cubicBezTo>
                  <a:pt x="506144" y="33197"/>
                  <a:pt x="515240" y="38395"/>
                  <a:pt x="498475" y="32807"/>
                </a:cubicBezTo>
                <a:cubicBezTo>
                  <a:pt x="495300" y="30690"/>
                  <a:pt x="491881" y="28900"/>
                  <a:pt x="488950" y="26457"/>
                </a:cubicBezTo>
                <a:cubicBezTo>
                  <a:pt x="485501" y="23582"/>
                  <a:pt x="483350" y="19113"/>
                  <a:pt x="479425" y="16932"/>
                </a:cubicBezTo>
                <a:cubicBezTo>
                  <a:pt x="473574" y="13681"/>
                  <a:pt x="460375" y="10582"/>
                  <a:pt x="460375" y="10582"/>
                </a:cubicBezTo>
                <a:cubicBezTo>
                  <a:pt x="457200" y="8465"/>
                  <a:pt x="454263" y="5939"/>
                  <a:pt x="450850" y="4232"/>
                </a:cubicBezTo>
                <a:cubicBezTo>
                  <a:pt x="432821" y="-4783"/>
                  <a:pt x="406181" y="3254"/>
                  <a:pt x="390525" y="4232"/>
                </a:cubicBezTo>
                <a:cubicBezTo>
                  <a:pt x="385233" y="5290"/>
                  <a:pt x="379918" y="6236"/>
                  <a:pt x="374650" y="7407"/>
                </a:cubicBezTo>
                <a:cubicBezTo>
                  <a:pt x="370390" y="8354"/>
                  <a:pt x="366275" y="10005"/>
                  <a:pt x="361950" y="10582"/>
                </a:cubicBezTo>
                <a:cubicBezTo>
                  <a:pt x="350363" y="12127"/>
                  <a:pt x="338674" y="12786"/>
                  <a:pt x="327025" y="13757"/>
                </a:cubicBezTo>
                <a:cubicBezTo>
                  <a:pt x="270652" y="18455"/>
                  <a:pt x="280654" y="17144"/>
                  <a:pt x="209550" y="20107"/>
                </a:cubicBezTo>
                <a:cubicBezTo>
                  <a:pt x="204014" y="20799"/>
                  <a:pt x="183151" y="21721"/>
                  <a:pt x="174625" y="26457"/>
                </a:cubicBezTo>
                <a:cubicBezTo>
                  <a:pt x="167954" y="30163"/>
                  <a:pt x="155575" y="39157"/>
                  <a:pt x="155575" y="39157"/>
                </a:cubicBezTo>
                <a:cubicBezTo>
                  <a:pt x="153458" y="42332"/>
                  <a:pt x="152097" y="46169"/>
                  <a:pt x="149225" y="48682"/>
                </a:cubicBezTo>
                <a:cubicBezTo>
                  <a:pt x="143482" y="53708"/>
                  <a:pt x="130175" y="61382"/>
                  <a:pt x="130175" y="61382"/>
                </a:cubicBezTo>
                <a:cubicBezTo>
                  <a:pt x="128058" y="64557"/>
                  <a:pt x="126268" y="67976"/>
                  <a:pt x="123825" y="70907"/>
                </a:cubicBezTo>
                <a:cubicBezTo>
                  <a:pt x="120950" y="74356"/>
                  <a:pt x="116481" y="76507"/>
                  <a:pt x="114300" y="80432"/>
                </a:cubicBezTo>
                <a:cubicBezTo>
                  <a:pt x="111049" y="86283"/>
                  <a:pt x="110067" y="93132"/>
                  <a:pt x="107950" y="99482"/>
                </a:cubicBezTo>
                <a:cubicBezTo>
                  <a:pt x="105537" y="106722"/>
                  <a:pt x="99483" y="112182"/>
                  <a:pt x="95250" y="118532"/>
                </a:cubicBezTo>
                <a:cubicBezTo>
                  <a:pt x="91537" y="124101"/>
                  <a:pt x="92613" y="132013"/>
                  <a:pt x="88900" y="137582"/>
                </a:cubicBezTo>
                <a:cubicBezTo>
                  <a:pt x="70702" y="164879"/>
                  <a:pt x="92520" y="130342"/>
                  <a:pt x="79375" y="156632"/>
                </a:cubicBezTo>
                <a:cubicBezTo>
                  <a:pt x="77668" y="160045"/>
                  <a:pt x="74575" y="162670"/>
                  <a:pt x="73025" y="166157"/>
                </a:cubicBezTo>
                <a:cubicBezTo>
                  <a:pt x="70307" y="172274"/>
                  <a:pt x="68792" y="178857"/>
                  <a:pt x="66675" y="185207"/>
                </a:cubicBezTo>
                <a:lnTo>
                  <a:pt x="63500" y="194732"/>
                </a:lnTo>
                <a:cubicBezTo>
                  <a:pt x="61087" y="201972"/>
                  <a:pt x="50800" y="213782"/>
                  <a:pt x="50800" y="213782"/>
                </a:cubicBezTo>
                <a:cubicBezTo>
                  <a:pt x="49783" y="217851"/>
                  <a:pt x="46727" y="231452"/>
                  <a:pt x="44450" y="236007"/>
                </a:cubicBezTo>
                <a:cubicBezTo>
                  <a:pt x="42743" y="239420"/>
                  <a:pt x="39807" y="242119"/>
                  <a:pt x="38100" y="245532"/>
                </a:cubicBezTo>
                <a:cubicBezTo>
                  <a:pt x="24955" y="271822"/>
                  <a:pt x="46773" y="237285"/>
                  <a:pt x="28575" y="264582"/>
                </a:cubicBezTo>
                <a:cubicBezTo>
                  <a:pt x="20912" y="302896"/>
                  <a:pt x="25638" y="286093"/>
                  <a:pt x="15875" y="315382"/>
                </a:cubicBezTo>
                <a:cubicBezTo>
                  <a:pt x="14668" y="319002"/>
                  <a:pt x="11232" y="321494"/>
                  <a:pt x="9525" y="324907"/>
                </a:cubicBezTo>
                <a:cubicBezTo>
                  <a:pt x="8028" y="327900"/>
                  <a:pt x="7408" y="331257"/>
                  <a:pt x="6350" y="334432"/>
                </a:cubicBezTo>
                <a:cubicBezTo>
                  <a:pt x="5292" y="342899"/>
                  <a:pt x="4701" y="351437"/>
                  <a:pt x="3175" y="359832"/>
                </a:cubicBezTo>
                <a:cubicBezTo>
                  <a:pt x="2576" y="363125"/>
                  <a:pt x="0" y="366010"/>
                  <a:pt x="0" y="369357"/>
                </a:cubicBezTo>
                <a:cubicBezTo>
                  <a:pt x="0" y="391078"/>
                  <a:pt x="2017" y="414369"/>
                  <a:pt x="6350" y="436032"/>
                </a:cubicBezTo>
                <a:cubicBezTo>
                  <a:pt x="8749" y="448028"/>
                  <a:pt x="11825" y="455633"/>
                  <a:pt x="15875" y="467782"/>
                </a:cubicBezTo>
                <a:cubicBezTo>
                  <a:pt x="17082" y="471402"/>
                  <a:pt x="20675" y="473820"/>
                  <a:pt x="22225" y="477307"/>
                </a:cubicBezTo>
                <a:cubicBezTo>
                  <a:pt x="24943" y="483424"/>
                  <a:pt x="26458" y="490007"/>
                  <a:pt x="28575" y="496357"/>
                </a:cubicBezTo>
                <a:cubicBezTo>
                  <a:pt x="29782" y="499977"/>
                  <a:pt x="33218" y="502469"/>
                  <a:pt x="34925" y="505882"/>
                </a:cubicBezTo>
                <a:cubicBezTo>
                  <a:pt x="36422" y="508875"/>
                  <a:pt x="36603" y="512414"/>
                  <a:pt x="38100" y="515407"/>
                </a:cubicBezTo>
                <a:cubicBezTo>
                  <a:pt x="39807" y="518820"/>
                  <a:pt x="42900" y="521445"/>
                  <a:pt x="44450" y="524932"/>
                </a:cubicBezTo>
                <a:cubicBezTo>
                  <a:pt x="47168" y="531049"/>
                  <a:pt x="47087" y="538413"/>
                  <a:pt x="50800" y="543982"/>
                </a:cubicBezTo>
                <a:cubicBezTo>
                  <a:pt x="52917" y="547157"/>
                  <a:pt x="55443" y="550094"/>
                  <a:pt x="57150" y="553507"/>
                </a:cubicBezTo>
                <a:cubicBezTo>
                  <a:pt x="58647" y="556500"/>
                  <a:pt x="58469" y="560247"/>
                  <a:pt x="60325" y="563032"/>
                </a:cubicBezTo>
                <a:cubicBezTo>
                  <a:pt x="62816" y="566768"/>
                  <a:pt x="66675" y="569382"/>
                  <a:pt x="69850" y="572557"/>
                </a:cubicBezTo>
                <a:cubicBezTo>
                  <a:pt x="77830" y="596498"/>
                  <a:pt x="67065" y="566988"/>
                  <a:pt x="79375" y="591607"/>
                </a:cubicBezTo>
                <a:cubicBezTo>
                  <a:pt x="80872" y="594600"/>
                  <a:pt x="80925" y="598206"/>
                  <a:pt x="82550" y="601132"/>
                </a:cubicBezTo>
                <a:cubicBezTo>
                  <a:pt x="86256" y="607803"/>
                  <a:pt x="91017" y="613832"/>
                  <a:pt x="95250" y="620182"/>
                </a:cubicBezTo>
                <a:cubicBezTo>
                  <a:pt x="97367" y="623357"/>
                  <a:pt x="98902" y="627009"/>
                  <a:pt x="101600" y="629707"/>
                </a:cubicBezTo>
                <a:lnTo>
                  <a:pt x="111125" y="639232"/>
                </a:lnTo>
                <a:cubicBezTo>
                  <a:pt x="117306" y="657775"/>
                  <a:pt x="109464" y="640746"/>
                  <a:pt x="123825" y="655107"/>
                </a:cubicBezTo>
                <a:cubicBezTo>
                  <a:pt x="126523" y="657805"/>
                  <a:pt x="128468" y="661219"/>
                  <a:pt x="130175" y="664632"/>
                </a:cubicBezTo>
                <a:cubicBezTo>
                  <a:pt x="131672" y="667625"/>
                  <a:pt x="130983" y="671790"/>
                  <a:pt x="133350" y="674157"/>
                </a:cubicBezTo>
                <a:cubicBezTo>
                  <a:pt x="135717" y="676524"/>
                  <a:pt x="139700" y="676274"/>
                  <a:pt x="142875" y="677332"/>
                </a:cubicBezTo>
                <a:cubicBezTo>
                  <a:pt x="146050" y="679449"/>
                  <a:pt x="150016" y="680702"/>
                  <a:pt x="152400" y="683682"/>
                </a:cubicBezTo>
                <a:cubicBezTo>
                  <a:pt x="164715" y="699076"/>
                  <a:pt x="144318" y="689455"/>
                  <a:pt x="165100" y="696382"/>
                </a:cubicBezTo>
                <a:cubicBezTo>
                  <a:pt x="186517" y="717799"/>
                  <a:pt x="175631" y="712592"/>
                  <a:pt x="193675" y="718607"/>
                </a:cubicBezTo>
                <a:cubicBezTo>
                  <a:pt x="200025" y="722840"/>
                  <a:pt x="207329" y="725911"/>
                  <a:pt x="212725" y="731307"/>
                </a:cubicBezTo>
                <a:cubicBezTo>
                  <a:pt x="224617" y="743199"/>
                  <a:pt x="217990" y="739412"/>
                  <a:pt x="231775" y="744007"/>
                </a:cubicBezTo>
                <a:cubicBezTo>
                  <a:pt x="233892" y="747182"/>
                  <a:pt x="235253" y="751019"/>
                  <a:pt x="238125" y="753532"/>
                </a:cubicBezTo>
                <a:lnTo>
                  <a:pt x="266700" y="772582"/>
                </a:lnTo>
                <a:lnTo>
                  <a:pt x="276225" y="778932"/>
                </a:lnTo>
                <a:lnTo>
                  <a:pt x="285750" y="785282"/>
                </a:lnTo>
                <a:cubicBezTo>
                  <a:pt x="320675" y="784224"/>
                  <a:pt x="355632" y="783943"/>
                  <a:pt x="390525" y="782107"/>
                </a:cubicBezTo>
                <a:cubicBezTo>
                  <a:pt x="395914" y="781823"/>
                  <a:pt x="401004" y="778932"/>
                  <a:pt x="406400" y="778932"/>
                </a:cubicBezTo>
                <a:cubicBezTo>
                  <a:pt x="426536" y="778932"/>
                  <a:pt x="446617" y="781049"/>
                  <a:pt x="466725" y="782107"/>
                </a:cubicBezTo>
                <a:cubicBezTo>
                  <a:pt x="475217" y="783522"/>
                  <a:pt x="492775" y="786238"/>
                  <a:pt x="501650" y="788457"/>
                </a:cubicBezTo>
                <a:cubicBezTo>
                  <a:pt x="504897" y="789269"/>
                  <a:pt x="507957" y="790713"/>
                  <a:pt x="511175" y="791632"/>
                </a:cubicBezTo>
                <a:cubicBezTo>
                  <a:pt x="515371" y="792831"/>
                  <a:pt x="519695" y="793553"/>
                  <a:pt x="523875" y="794807"/>
                </a:cubicBezTo>
                <a:cubicBezTo>
                  <a:pt x="534461" y="797983"/>
                  <a:pt x="544648" y="802502"/>
                  <a:pt x="555625" y="804332"/>
                </a:cubicBezTo>
                <a:cubicBezTo>
                  <a:pt x="569108" y="806579"/>
                  <a:pt x="600546" y="809459"/>
                  <a:pt x="612775" y="810682"/>
                </a:cubicBezTo>
                <a:lnTo>
                  <a:pt x="631825" y="817032"/>
                </a:lnTo>
                <a:lnTo>
                  <a:pt x="641350" y="820207"/>
                </a:lnTo>
                <a:cubicBezTo>
                  <a:pt x="656444" y="830270"/>
                  <a:pt x="647255" y="825350"/>
                  <a:pt x="669925" y="832907"/>
                </a:cubicBezTo>
                <a:lnTo>
                  <a:pt x="679450" y="836082"/>
                </a:lnTo>
                <a:cubicBezTo>
                  <a:pt x="685800" y="840315"/>
                  <a:pt x="691260" y="846369"/>
                  <a:pt x="698500" y="848782"/>
                </a:cubicBezTo>
                <a:lnTo>
                  <a:pt x="746125" y="864657"/>
                </a:lnTo>
                <a:cubicBezTo>
                  <a:pt x="751245" y="866364"/>
                  <a:pt x="756708" y="866774"/>
                  <a:pt x="762000" y="867832"/>
                </a:cubicBezTo>
                <a:cubicBezTo>
                  <a:pt x="773642" y="866774"/>
                  <a:pt x="785413" y="866688"/>
                  <a:pt x="796925" y="864657"/>
                </a:cubicBezTo>
                <a:cubicBezTo>
                  <a:pt x="803517" y="863494"/>
                  <a:pt x="809625" y="860424"/>
                  <a:pt x="815975" y="858307"/>
                </a:cubicBezTo>
                <a:lnTo>
                  <a:pt x="825500" y="855132"/>
                </a:lnTo>
                <a:lnTo>
                  <a:pt x="854075" y="836082"/>
                </a:lnTo>
                <a:cubicBezTo>
                  <a:pt x="859644" y="832369"/>
                  <a:pt x="873125" y="829732"/>
                  <a:pt x="873125" y="829732"/>
                </a:cubicBezTo>
                <a:lnTo>
                  <a:pt x="901700" y="810682"/>
                </a:lnTo>
                <a:cubicBezTo>
                  <a:pt x="907269" y="806969"/>
                  <a:pt x="920750" y="804332"/>
                  <a:pt x="920750" y="804332"/>
                </a:cubicBezTo>
                <a:cubicBezTo>
                  <a:pt x="923925" y="801157"/>
                  <a:pt x="927784" y="798543"/>
                  <a:pt x="930275" y="794807"/>
                </a:cubicBezTo>
                <a:cubicBezTo>
                  <a:pt x="932131" y="792022"/>
                  <a:pt x="931953" y="788275"/>
                  <a:pt x="933450" y="785282"/>
                </a:cubicBezTo>
                <a:cubicBezTo>
                  <a:pt x="935157" y="781869"/>
                  <a:pt x="938250" y="779244"/>
                  <a:pt x="939800" y="775757"/>
                </a:cubicBezTo>
                <a:cubicBezTo>
                  <a:pt x="954913" y="741752"/>
                  <a:pt x="938129" y="768738"/>
                  <a:pt x="952500" y="747182"/>
                </a:cubicBezTo>
                <a:cubicBezTo>
                  <a:pt x="953517" y="743113"/>
                  <a:pt x="956573" y="729512"/>
                  <a:pt x="958850" y="724957"/>
                </a:cubicBezTo>
                <a:cubicBezTo>
                  <a:pt x="960557" y="721544"/>
                  <a:pt x="963650" y="718919"/>
                  <a:pt x="965200" y="715432"/>
                </a:cubicBezTo>
                <a:cubicBezTo>
                  <a:pt x="972108" y="699889"/>
                  <a:pt x="970462" y="697890"/>
                  <a:pt x="974725" y="683682"/>
                </a:cubicBezTo>
                <a:cubicBezTo>
                  <a:pt x="976648" y="677271"/>
                  <a:pt x="978958" y="670982"/>
                  <a:pt x="981075" y="664632"/>
                </a:cubicBezTo>
                <a:cubicBezTo>
                  <a:pt x="982282" y="661012"/>
                  <a:pt x="985875" y="658594"/>
                  <a:pt x="987425" y="655107"/>
                </a:cubicBezTo>
                <a:cubicBezTo>
                  <a:pt x="990143" y="648990"/>
                  <a:pt x="993775" y="636057"/>
                  <a:pt x="993775" y="636057"/>
                </a:cubicBezTo>
                <a:cubicBezTo>
                  <a:pt x="997780" y="604015"/>
                  <a:pt x="994252" y="618752"/>
                  <a:pt x="1003300" y="591607"/>
                </a:cubicBezTo>
                <a:lnTo>
                  <a:pt x="1006475" y="582082"/>
                </a:lnTo>
                <a:cubicBezTo>
                  <a:pt x="1004527" y="558704"/>
                  <a:pt x="1005090" y="547967"/>
                  <a:pt x="1000125" y="528107"/>
                </a:cubicBezTo>
                <a:cubicBezTo>
                  <a:pt x="999313" y="524860"/>
                  <a:pt x="998008" y="521757"/>
                  <a:pt x="996950" y="518582"/>
                </a:cubicBezTo>
                <a:cubicBezTo>
                  <a:pt x="995892" y="503765"/>
                  <a:pt x="995979" y="488822"/>
                  <a:pt x="993775" y="474132"/>
                </a:cubicBezTo>
                <a:cubicBezTo>
                  <a:pt x="989494" y="445594"/>
                  <a:pt x="989270" y="463996"/>
                  <a:pt x="981075" y="445557"/>
                </a:cubicBezTo>
                <a:cubicBezTo>
                  <a:pt x="978357" y="439440"/>
                  <a:pt x="976842" y="432857"/>
                  <a:pt x="974725" y="426507"/>
                </a:cubicBezTo>
                <a:lnTo>
                  <a:pt x="955675" y="397932"/>
                </a:lnTo>
                <a:cubicBezTo>
                  <a:pt x="953819" y="395147"/>
                  <a:pt x="953997" y="391400"/>
                  <a:pt x="952500" y="388407"/>
                </a:cubicBezTo>
                <a:cubicBezTo>
                  <a:pt x="950793" y="384994"/>
                  <a:pt x="947857" y="382295"/>
                  <a:pt x="946150" y="378882"/>
                </a:cubicBezTo>
                <a:cubicBezTo>
                  <a:pt x="944653" y="375889"/>
                  <a:pt x="944600" y="372283"/>
                  <a:pt x="942975" y="369357"/>
                </a:cubicBezTo>
                <a:cubicBezTo>
                  <a:pt x="939269" y="362686"/>
                  <a:pt x="932688" y="357547"/>
                  <a:pt x="930275" y="350307"/>
                </a:cubicBezTo>
                <a:cubicBezTo>
                  <a:pt x="925680" y="336522"/>
                  <a:pt x="929467" y="343149"/>
                  <a:pt x="917575" y="331257"/>
                </a:cubicBezTo>
                <a:cubicBezTo>
                  <a:pt x="911394" y="312714"/>
                  <a:pt x="919236" y="329743"/>
                  <a:pt x="904875" y="315382"/>
                </a:cubicBezTo>
                <a:cubicBezTo>
                  <a:pt x="883708" y="294215"/>
                  <a:pt x="914400" y="316440"/>
                  <a:pt x="889000" y="299507"/>
                </a:cubicBezTo>
                <a:cubicBezTo>
                  <a:pt x="886908" y="293232"/>
                  <a:pt x="885070" y="284933"/>
                  <a:pt x="879475" y="280457"/>
                </a:cubicBezTo>
                <a:cubicBezTo>
                  <a:pt x="876862" y="278366"/>
                  <a:pt x="873125" y="278340"/>
                  <a:pt x="869950" y="277282"/>
                </a:cubicBezTo>
                <a:lnTo>
                  <a:pt x="850900" y="264582"/>
                </a:lnTo>
                <a:cubicBezTo>
                  <a:pt x="847725" y="262465"/>
                  <a:pt x="845077" y="259157"/>
                  <a:pt x="841375" y="258232"/>
                </a:cubicBezTo>
                <a:cubicBezTo>
                  <a:pt x="826622" y="254544"/>
                  <a:pt x="850900" y="243945"/>
                  <a:pt x="841375" y="239182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2" name="正方形/長方形 41"/>
          <p:cNvSpPr/>
          <p:nvPr/>
        </p:nvSpPr>
        <p:spPr>
          <a:xfrm>
            <a:off x="1712801" y="332656"/>
            <a:ext cx="45719" cy="51414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3" name="正方形/長方形 42"/>
          <p:cNvSpPr/>
          <p:nvPr/>
        </p:nvSpPr>
        <p:spPr>
          <a:xfrm>
            <a:off x="3401400" y="433540"/>
            <a:ext cx="45719" cy="51414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4" name="正方形/長方形 43"/>
          <p:cNvSpPr/>
          <p:nvPr/>
        </p:nvSpPr>
        <p:spPr>
          <a:xfrm>
            <a:off x="5091229" y="433540"/>
            <a:ext cx="45719" cy="51414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5" name="正方形/長方形 44"/>
          <p:cNvSpPr/>
          <p:nvPr/>
        </p:nvSpPr>
        <p:spPr>
          <a:xfrm>
            <a:off x="6767304" y="485056"/>
            <a:ext cx="45719" cy="51414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7" name="フリーフォーム 46"/>
          <p:cNvSpPr/>
          <p:nvPr/>
        </p:nvSpPr>
        <p:spPr>
          <a:xfrm>
            <a:off x="7071294" y="3519678"/>
            <a:ext cx="768774" cy="1086957"/>
          </a:xfrm>
          <a:custGeom>
            <a:avLst/>
            <a:gdLst>
              <a:gd name="connsiteX0" fmla="*/ 486199 w 768774"/>
              <a:gd name="connsiteY0" fmla="*/ 1107 h 1086957"/>
              <a:gd name="connsiteX1" fmla="*/ 470324 w 768774"/>
              <a:gd name="connsiteY1" fmla="*/ 4282 h 1086957"/>
              <a:gd name="connsiteX2" fmla="*/ 457624 w 768774"/>
              <a:gd name="connsiteY2" fmla="*/ 23332 h 1086957"/>
              <a:gd name="connsiteX3" fmla="*/ 444924 w 768774"/>
              <a:gd name="connsiteY3" fmla="*/ 42382 h 1086957"/>
              <a:gd name="connsiteX4" fmla="*/ 441749 w 768774"/>
              <a:gd name="connsiteY4" fmla="*/ 51907 h 1086957"/>
              <a:gd name="connsiteX5" fmla="*/ 425874 w 768774"/>
              <a:gd name="connsiteY5" fmla="*/ 70957 h 1086957"/>
              <a:gd name="connsiteX6" fmla="*/ 416349 w 768774"/>
              <a:gd name="connsiteY6" fmla="*/ 90007 h 1086957"/>
              <a:gd name="connsiteX7" fmla="*/ 406824 w 768774"/>
              <a:gd name="connsiteY7" fmla="*/ 96357 h 1086957"/>
              <a:gd name="connsiteX8" fmla="*/ 400474 w 768774"/>
              <a:gd name="connsiteY8" fmla="*/ 105882 h 1086957"/>
              <a:gd name="connsiteX9" fmla="*/ 381424 w 768774"/>
              <a:gd name="connsiteY9" fmla="*/ 112232 h 1086957"/>
              <a:gd name="connsiteX10" fmla="*/ 362374 w 768774"/>
              <a:gd name="connsiteY10" fmla="*/ 124932 h 1086957"/>
              <a:gd name="connsiteX11" fmla="*/ 352849 w 768774"/>
              <a:gd name="connsiteY11" fmla="*/ 131282 h 1086957"/>
              <a:gd name="connsiteX12" fmla="*/ 340149 w 768774"/>
              <a:gd name="connsiteY12" fmla="*/ 134457 h 1086957"/>
              <a:gd name="connsiteX13" fmla="*/ 311574 w 768774"/>
              <a:gd name="connsiteY13" fmla="*/ 153507 h 1086957"/>
              <a:gd name="connsiteX14" fmla="*/ 302049 w 768774"/>
              <a:gd name="connsiteY14" fmla="*/ 156682 h 1086957"/>
              <a:gd name="connsiteX15" fmla="*/ 292524 w 768774"/>
              <a:gd name="connsiteY15" fmla="*/ 163032 h 1086957"/>
              <a:gd name="connsiteX16" fmla="*/ 282999 w 768774"/>
              <a:gd name="connsiteY16" fmla="*/ 172557 h 1086957"/>
              <a:gd name="connsiteX17" fmla="*/ 273474 w 768774"/>
              <a:gd name="connsiteY17" fmla="*/ 175732 h 1086957"/>
              <a:gd name="connsiteX18" fmla="*/ 260774 w 768774"/>
              <a:gd name="connsiteY18" fmla="*/ 194782 h 1086957"/>
              <a:gd name="connsiteX19" fmla="*/ 241724 w 768774"/>
              <a:gd name="connsiteY19" fmla="*/ 210657 h 1086957"/>
              <a:gd name="connsiteX20" fmla="*/ 225849 w 768774"/>
              <a:gd name="connsiteY20" fmla="*/ 223357 h 1086957"/>
              <a:gd name="connsiteX21" fmla="*/ 219499 w 768774"/>
              <a:gd name="connsiteY21" fmla="*/ 232882 h 1086957"/>
              <a:gd name="connsiteX22" fmla="*/ 216324 w 768774"/>
              <a:gd name="connsiteY22" fmla="*/ 242407 h 1086957"/>
              <a:gd name="connsiteX23" fmla="*/ 206799 w 768774"/>
              <a:gd name="connsiteY23" fmla="*/ 248757 h 1086957"/>
              <a:gd name="connsiteX24" fmla="*/ 181399 w 768774"/>
              <a:gd name="connsiteY24" fmla="*/ 286857 h 1086957"/>
              <a:gd name="connsiteX25" fmla="*/ 168699 w 768774"/>
              <a:gd name="connsiteY25" fmla="*/ 305907 h 1086957"/>
              <a:gd name="connsiteX26" fmla="*/ 159174 w 768774"/>
              <a:gd name="connsiteY26" fmla="*/ 312257 h 1086957"/>
              <a:gd name="connsiteX27" fmla="*/ 155999 w 768774"/>
              <a:gd name="connsiteY27" fmla="*/ 321782 h 1086957"/>
              <a:gd name="connsiteX28" fmla="*/ 146474 w 768774"/>
              <a:gd name="connsiteY28" fmla="*/ 328132 h 1086957"/>
              <a:gd name="connsiteX29" fmla="*/ 136949 w 768774"/>
              <a:gd name="connsiteY29" fmla="*/ 337657 h 1086957"/>
              <a:gd name="connsiteX30" fmla="*/ 133774 w 768774"/>
              <a:gd name="connsiteY30" fmla="*/ 347182 h 1086957"/>
              <a:gd name="connsiteX31" fmla="*/ 121074 w 768774"/>
              <a:gd name="connsiteY31" fmla="*/ 366232 h 1086957"/>
              <a:gd name="connsiteX32" fmla="*/ 114724 w 768774"/>
              <a:gd name="connsiteY32" fmla="*/ 375757 h 1086957"/>
              <a:gd name="connsiteX33" fmla="*/ 95674 w 768774"/>
              <a:gd name="connsiteY33" fmla="*/ 404332 h 1086957"/>
              <a:gd name="connsiteX34" fmla="*/ 89324 w 768774"/>
              <a:gd name="connsiteY34" fmla="*/ 417032 h 1086957"/>
              <a:gd name="connsiteX35" fmla="*/ 79799 w 768774"/>
              <a:gd name="connsiteY35" fmla="*/ 429732 h 1086957"/>
              <a:gd name="connsiteX36" fmla="*/ 76624 w 768774"/>
              <a:gd name="connsiteY36" fmla="*/ 439257 h 1086957"/>
              <a:gd name="connsiteX37" fmla="*/ 60749 w 768774"/>
              <a:gd name="connsiteY37" fmla="*/ 458307 h 1086957"/>
              <a:gd name="connsiteX38" fmla="*/ 54399 w 768774"/>
              <a:gd name="connsiteY38" fmla="*/ 477357 h 1086957"/>
              <a:gd name="connsiteX39" fmla="*/ 48049 w 768774"/>
              <a:gd name="connsiteY39" fmla="*/ 486882 h 1086957"/>
              <a:gd name="connsiteX40" fmla="*/ 41699 w 768774"/>
              <a:gd name="connsiteY40" fmla="*/ 505932 h 1086957"/>
              <a:gd name="connsiteX41" fmla="*/ 35349 w 768774"/>
              <a:gd name="connsiteY41" fmla="*/ 515457 h 1086957"/>
              <a:gd name="connsiteX42" fmla="*/ 28999 w 768774"/>
              <a:gd name="connsiteY42" fmla="*/ 534507 h 1086957"/>
              <a:gd name="connsiteX43" fmla="*/ 22649 w 768774"/>
              <a:gd name="connsiteY43" fmla="*/ 553557 h 1086957"/>
              <a:gd name="connsiteX44" fmla="*/ 19474 w 768774"/>
              <a:gd name="connsiteY44" fmla="*/ 563082 h 1086957"/>
              <a:gd name="connsiteX45" fmla="*/ 13124 w 768774"/>
              <a:gd name="connsiteY45" fmla="*/ 572607 h 1086957"/>
              <a:gd name="connsiteX46" fmla="*/ 9949 w 768774"/>
              <a:gd name="connsiteY46" fmla="*/ 585307 h 1086957"/>
              <a:gd name="connsiteX47" fmla="*/ 3599 w 768774"/>
              <a:gd name="connsiteY47" fmla="*/ 604357 h 1086957"/>
              <a:gd name="connsiteX48" fmla="*/ 3599 w 768774"/>
              <a:gd name="connsiteY48" fmla="*/ 680557 h 1086957"/>
              <a:gd name="connsiteX49" fmla="*/ 19474 w 768774"/>
              <a:gd name="connsiteY49" fmla="*/ 705957 h 1086957"/>
              <a:gd name="connsiteX50" fmla="*/ 22649 w 768774"/>
              <a:gd name="connsiteY50" fmla="*/ 715482 h 1086957"/>
              <a:gd name="connsiteX51" fmla="*/ 38524 w 768774"/>
              <a:gd name="connsiteY51" fmla="*/ 734532 h 1086957"/>
              <a:gd name="connsiteX52" fmla="*/ 57574 w 768774"/>
              <a:gd name="connsiteY52" fmla="*/ 747232 h 1086957"/>
              <a:gd name="connsiteX53" fmla="*/ 73449 w 768774"/>
              <a:gd name="connsiteY53" fmla="*/ 763107 h 1086957"/>
              <a:gd name="connsiteX54" fmla="*/ 79799 w 768774"/>
              <a:gd name="connsiteY54" fmla="*/ 772632 h 1086957"/>
              <a:gd name="connsiteX55" fmla="*/ 89324 w 768774"/>
              <a:gd name="connsiteY55" fmla="*/ 782157 h 1086957"/>
              <a:gd name="connsiteX56" fmla="*/ 102024 w 768774"/>
              <a:gd name="connsiteY56" fmla="*/ 801207 h 1086957"/>
              <a:gd name="connsiteX57" fmla="*/ 108374 w 768774"/>
              <a:gd name="connsiteY57" fmla="*/ 810732 h 1086957"/>
              <a:gd name="connsiteX58" fmla="*/ 117899 w 768774"/>
              <a:gd name="connsiteY58" fmla="*/ 820257 h 1086957"/>
              <a:gd name="connsiteX59" fmla="*/ 130599 w 768774"/>
              <a:gd name="connsiteY59" fmla="*/ 839307 h 1086957"/>
              <a:gd name="connsiteX60" fmla="*/ 143299 w 768774"/>
              <a:gd name="connsiteY60" fmla="*/ 858357 h 1086957"/>
              <a:gd name="connsiteX61" fmla="*/ 155999 w 768774"/>
              <a:gd name="connsiteY61" fmla="*/ 877407 h 1086957"/>
              <a:gd name="connsiteX62" fmla="*/ 165524 w 768774"/>
              <a:gd name="connsiteY62" fmla="*/ 896457 h 1086957"/>
              <a:gd name="connsiteX63" fmla="*/ 168699 w 768774"/>
              <a:gd name="connsiteY63" fmla="*/ 905982 h 1086957"/>
              <a:gd name="connsiteX64" fmla="*/ 187749 w 768774"/>
              <a:gd name="connsiteY64" fmla="*/ 937732 h 1086957"/>
              <a:gd name="connsiteX65" fmla="*/ 194099 w 768774"/>
              <a:gd name="connsiteY65" fmla="*/ 947257 h 1086957"/>
              <a:gd name="connsiteX66" fmla="*/ 203624 w 768774"/>
              <a:gd name="connsiteY66" fmla="*/ 953607 h 1086957"/>
              <a:gd name="connsiteX67" fmla="*/ 222674 w 768774"/>
              <a:gd name="connsiteY67" fmla="*/ 972657 h 1086957"/>
              <a:gd name="connsiteX68" fmla="*/ 251249 w 768774"/>
              <a:gd name="connsiteY68" fmla="*/ 988532 h 1086957"/>
              <a:gd name="connsiteX69" fmla="*/ 270299 w 768774"/>
              <a:gd name="connsiteY69" fmla="*/ 998057 h 1086957"/>
              <a:gd name="connsiteX70" fmla="*/ 279824 w 768774"/>
              <a:gd name="connsiteY70" fmla="*/ 1004407 h 1086957"/>
              <a:gd name="connsiteX71" fmla="*/ 298874 w 768774"/>
              <a:gd name="connsiteY71" fmla="*/ 1010757 h 1086957"/>
              <a:gd name="connsiteX72" fmla="*/ 317924 w 768774"/>
              <a:gd name="connsiteY72" fmla="*/ 1020282 h 1086957"/>
              <a:gd name="connsiteX73" fmla="*/ 327449 w 768774"/>
              <a:gd name="connsiteY73" fmla="*/ 1026632 h 1086957"/>
              <a:gd name="connsiteX74" fmla="*/ 346499 w 768774"/>
              <a:gd name="connsiteY74" fmla="*/ 1032982 h 1086957"/>
              <a:gd name="connsiteX75" fmla="*/ 365549 w 768774"/>
              <a:gd name="connsiteY75" fmla="*/ 1039332 h 1086957"/>
              <a:gd name="connsiteX76" fmla="*/ 387774 w 768774"/>
              <a:gd name="connsiteY76" fmla="*/ 1052032 h 1086957"/>
              <a:gd name="connsiteX77" fmla="*/ 400474 w 768774"/>
              <a:gd name="connsiteY77" fmla="*/ 1055207 h 1086957"/>
              <a:gd name="connsiteX78" fmla="*/ 435399 w 768774"/>
              <a:gd name="connsiteY78" fmla="*/ 1058382 h 1086957"/>
              <a:gd name="connsiteX79" fmla="*/ 454449 w 768774"/>
              <a:gd name="connsiteY79" fmla="*/ 1061557 h 1086957"/>
              <a:gd name="connsiteX80" fmla="*/ 502074 w 768774"/>
              <a:gd name="connsiteY80" fmla="*/ 1077432 h 1086957"/>
              <a:gd name="connsiteX81" fmla="*/ 521124 w 768774"/>
              <a:gd name="connsiteY81" fmla="*/ 1080607 h 1086957"/>
              <a:gd name="connsiteX82" fmla="*/ 543349 w 768774"/>
              <a:gd name="connsiteY82" fmla="*/ 1086957 h 1086957"/>
              <a:gd name="connsiteX83" fmla="*/ 581449 w 768774"/>
              <a:gd name="connsiteY83" fmla="*/ 1083782 h 1086957"/>
              <a:gd name="connsiteX84" fmla="*/ 600499 w 768774"/>
              <a:gd name="connsiteY84" fmla="*/ 1077432 h 1086957"/>
              <a:gd name="connsiteX85" fmla="*/ 610024 w 768774"/>
              <a:gd name="connsiteY85" fmla="*/ 1074257 h 1086957"/>
              <a:gd name="connsiteX86" fmla="*/ 629074 w 768774"/>
              <a:gd name="connsiteY86" fmla="*/ 1061557 h 1086957"/>
              <a:gd name="connsiteX87" fmla="*/ 648124 w 768774"/>
              <a:gd name="connsiteY87" fmla="*/ 1055207 h 1086957"/>
              <a:gd name="connsiteX88" fmla="*/ 667174 w 768774"/>
              <a:gd name="connsiteY88" fmla="*/ 1042507 h 1086957"/>
              <a:gd name="connsiteX89" fmla="*/ 676699 w 768774"/>
              <a:gd name="connsiteY89" fmla="*/ 1036157 h 1086957"/>
              <a:gd name="connsiteX90" fmla="*/ 686224 w 768774"/>
              <a:gd name="connsiteY90" fmla="*/ 1032982 h 1086957"/>
              <a:gd name="connsiteX91" fmla="*/ 692574 w 768774"/>
              <a:gd name="connsiteY91" fmla="*/ 1023457 h 1086957"/>
              <a:gd name="connsiteX92" fmla="*/ 714799 w 768774"/>
              <a:gd name="connsiteY92" fmla="*/ 1001232 h 1086957"/>
              <a:gd name="connsiteX93" fmla="*/ 730674 w 768774"/>
              <a:gd name="connsiteY93" fmla="*/ 972657 h 1086957"/>
              <a:gd name="connsiteX94" fmla="*/ 737024 w 768774"/>
              <a:gd name="connsiteY94" fmla="*/ 963132 h 1086957"/>
              <a:gd name="connsiteX95" fmla="*/ 746549 w 768774"/>
              <a:gd name="connsiteY95" fmla="*/ 944082 h 1086957"/>
              <a:gd name="connsiteX96" fmla="*/ 759249 w 768774"/>
              <a:gd name="connsiteY96" fmla="*/ 915507 h 1086957"/>
              <a:gd name="connsiteX97" fmla="*/ 762424 w 768774"/>
              <a:gd name="connsiteY97" fmla="*/ 899632 h 1086957"/>
              <a:gd name="connsiteX98" fmla="*/ 768774 w 768774"/>
              <a:gd name="connsiteY98" fmla="*/ 836132 h 1086957"/>
              <a:gd name="connsiteX99" fmla="*/ 765599 w 768774"/>
              <a:gd name="connsiteY99" fmla="*/ 756757 h 1086957"/>
              <a:gd name="connsiteX100" fmla="*/ 762424 w 768774"/>
              <a:gd name="connsiteY100" fmla="*/ 744057 h 1086957"/>
              <a:gd name="connsiteX101" fmla="*/ 752899 w 768774"/>
              <a:gd name="connsiteY101" fmla="*/ 705957 h 1086957"/>
              <a:gd name="connsiteX102" fmla="*/ 749724 w 768774"/>
              <a:gd name="connsiteY102" fmla="*/ 696432 h 1086957"/>
              <a:gd name="connsiteX103" fmla="*/ 746549 w 768774"/>
              <a:gd name="connsiteY103" fmla="*/ 667857 h 1086957"/>
              <a:gd name="connsiteX104" fmla="*/ 740199 w 768774"/>
              <a:gd name="connsiteY104" fmla="*/ 648807 h 1086957"/>
              <a:gd name="connsiteX105" fmla="*/ 730674 w 768774"/>
              <a:gd name="connsiteY105" fmla="*/ 626582 h 1086957"/>
              <a:gd name="connsiteX106" fmla="*/ 727499 w 768774"/>
              <a:gd name="connsiteY106" fmla="*/ 610707 h 1086957"/>
              <a:gd name="connsiteX107" fmla="*/ 724324 w 768774"/>
              <a:gd name="connsiteY107" fmla="*/ 601182 h 1086957"/>
              <a:gd name="connsiteX108" fmla="*/ 721149 w 768774"/>
              <a:gd name="connsiteY108" fmla="*/ 556732 h 1086957"/>
              <a:gd name="connsiteX109" fmla="*/ 730674 w 768774"/>
              <a:gd name="connsiteY109" fmla="*/ 480532 h 1086957"/>
              <a:gd name="connsiteX110" fmla="*/ 737024 w 768774"/>
              <a:gd name="connsiteY110" fmla="*/ 471007 h 1086957"/>
              <a:gd name="connsiteX111" fmla="*/ 737024 w 768774"/>
              <a:gd name="connsiteY111" fmla="*/ 356707 h 1086957"/>
              <a:gd name="connsiteX112" fmla="*/ 730674 w 768774"/>
              <a:gd name="connsiteY112" fmla="*/ 328132 h 1086957"/>
              <a:gd name="connsiteX113" fmla="*/ 727499 w 768774"/>
              <a:gd name="connsiteY113" fmla="*/ 315432 h 1086957"/>
              <a:gd name="connsiteX114" fmla="*/ 721149 w 768774"/>
              <a:gd name="connsiteY114" fmla="*/ 274157 h 1086957"/>
              <a:gd name="connsiteX115" fmla="*/ 717974 w 768774"/>
              <a:gd name="connsiteY115" fmla="*/ 261457 h 1086957"/>
              <a:gd name="connsiteX116" fmla="*/ 711624 w 768774"/>
              <a:gd name="connsiteY116" fmla="*/ 251932 h 1086957"/>
              <a:gd name="connsiteX117" fmla="*/ 692574 w 768774"/>
              <a:gd name="connsiteY117" fmla="*/ 220182 h 1086957"/>
              <a:gd name="connsiteX118" fmla="*/ 676699 w 768774"/>
              <a:gd name="connsiteY118" fmla="*/ 201132 h 1086957"/>
              <a:gd name="connsiteX119" fmla="*/ 670349 w 768774"/>
              <a:gd name="connsiteY119" fmla="*/ 178907 h 1086957"/>
              <a:gd name="connsiteX120" fmla="*/ 663999 w 768774"/>
              <a:gd name="connsiteY120" fmla="*/ 169382 h 1086957"/>
              <a:gd name="connsiteX121" fmla="*/ 657649 w 768774"/>
              <a:gd name="connsiteY121" fmla="*/ 150332 h 1086957"/>
              <a:gd name="connsiteX122" fmla="*/ 651299 w 768774"/>
              <a:gd name="connsiteY122" fmla="*/ 140807 h 1086957"/>
              <a:gd name="connsiteX123" fmla="*/ 641774 w 768774"/>
              <a:gd name="connsiteY123" fmla="*/ 121757 h 1086957"/>
              <a:gd name="connsiteX124" fmla="*/ 632249 w 768774"/>
              <a:gd name="connsiteY124" fmla="*/ 115407 h 1086957"/>
              <a:gd name="connsiteX125" fmla="*/ 619549 w 768774"/>
              <a:gd name="connsiteY125" fmla="*/ 99532 h 1086957"/>
              <a:gd name="connsiteX126" fmla="*/ 606849 w 768774"/>
              <a:gd name="connsiteY126" fmla="*/ 80482 h 1086957"/>
              <a:gd name="connsiteX127" fmla="*/ 578274 w 768774"/>
              <a:gd name="connsiteY127" fmla="*/ 61432 h 1086957"/>
              <a:gd name="connsiteX128" fmla="*/ 568749 w 768774"/>
              <a:gd name="connsiteY128" fmla="*/ 55082 h 1086957"/>
              <a:gd name="connsiteX129" fmla="*/ 549699 w 768774"/>
              <a:gd name="connsiteY129" fmla="*/ 42382 h 1086957"/>
              <a:gd name="connsiteX130" fmla="*/ 540174 w 768774"/>
              <a:gd name="connsiteY130" fmla="*/ 36032 h 1086957"/>
              <a:gd name="connsiteX131" fmla="*/ 530649 w 768774"/>
              <a:gd name="connsiteY131" fmla="*/ 32857 h 1086957"/>
              <a:gd name="connsiteX132" fmla="*/ 511599 w 768774"/>
              <a:gd name="connsiteY132" fmla="*/ 20157 h 1086957"/>
              <a:gd name="connsiteX133" fmla="*/ 486199 w 768774"/>
              <a:gd name="connsiteY133" fmla="*/ 1107 h 108695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</a:cxnLst>
            <a:rect l="l" t="t" r="r" b="b"/>
            <a:pathLst>
              <a:path w="768774" h="1086957">
                <a:moveTo>
                  <a:pt x="486199" y="1107"/>
                </a:moveTo>
                <a:cubicBezTo>
                  <a:pt x="479320" y="-1539"/>
                  <a:pt x="474584" y="969"/>
                  <a:pt x="470324" y="4282"/>
                </a:cubicBezTo>
                <a:cubicBezTo>
                  <a:pt x="464300" y="8967"/>
                  <a:pt x="461857" y="16982"/>
                  <a:pt x="457624" y="23332"/>
                </a:cubicBezTo>
                <a:lnTo>
                  <a:pt x="444924" y="42382"/>
                </a:lnTo>
                <a:cubicBezTo>
                  <a:pt x="443068" y="45167"/>
                  <a:pt x="443605" y="49122"/>
                  <a:pt x="441749" y="51907"/>
                </a:cubicBezTo>
                <a:cubicBezTo>
                  <a:pt x="427705" y="72973"/>
                  <a:pt x="436262" y="50182"/>
                  <a:pt x="425874" y="70957"/>
                </a:cubicBezTo>
                <a:cubicBezTo>
                  <a:pt x="420709" y="81286"/>
                  <a:pt x="425448" y="80908"/>
                  <a:pt x="416349" y="90007"/>
                </a:cubicBezTo>
                <a:cubicBezTo>
                  <a:pt x="413651" y="92705"/>
                  <a:pt x="409999" y="94240"/>
                  <a:pt x="406824" y="96357"/>
                </a:cubicBezTo>
                <a:cubicBezTo>
                  <a:pt x="404707" y="99532"/>
                  <a:pt x="403710" y="103860"/>
                  <a:pt x="400474" y="105882"/>
                </a:cubicBezTo>
                <a:cubicBezTo>
                  <a:pt x="394798" y="109430"/>
                  <a:pt x="381424" y="112232"/>
                  <a:pt x="381424" y="112232"/>
                </a:cubicBezTo>
                <a:lnTo>
                  <a:pt x="362374" y="124932"/>
                </a:lnTo>
                <a:cubicBezTo>
                  <a:pt x="359199" y="127049"/>
                  <a:pt x="356551" y="130357"/>
                  <a:pt x="352849" y="131282"/>
                </a:cubicBezTo>
                <a:lnTo>
                  <a:pt x="340149" y="134457"/>
                </a:lnTo>
                <a:lnTo>
                  <a:pt x="311574" y="153507"/>
                </a:lnTo>
                <a:cubicBezTo>
                  <a:pt x="308789" y="155363"/>
                  <a:pt x="305224" y="155624"/>
                  <a:pt x="302049" y="156682"/>
                </a:cubicBezTo>
                <a:cubicBezTo>
                  <a:pt x="298874" y="158799"/>
                  <a:pt x="295455" y="160589"/>
                  <a:pt x="292524" y="163032"/>
                </a:cubicBezTo>
                <a:cubicBezTo>
                  <a:pt x="289075" y="165907"/>
                  <a:pt x="286735" y="170066"/>
                  <a:pt x="282999" y="172557"/>
                </a:cubicBezTo>
                <a:cubicBezTo>
                  <a:pt x="280214" y="174413"/>
                  <a:pt x="276649" y="174674"/>
                  <a:pt x="273474" y="175732"/>
                </a:cubicBezTo>
                <a:cubicBezTo>
                  <a:pt x="269241" y="182082"/>
                  <a:pt x="267124" y="190549"/>
                  <a:pt x="260774" y="194782"/>
                </a:cubicBezTo>
                <a:cubicBezTo>
                  <a:pt x="251408" y="201026"/>
                  <a:pt x="249364" y="201490"/>
                  <a:pt x="241724" y="210657"/>
                </a:cubicBezTo>
                <a:cubicBezTo>
                  <a:pt x="230677" y="223914"/>
                  <a:pt x="241486" y="218145"/>
                  <a:pt x="225849" y="223357"/>
                </a:cubicBezTo>
                <a:cubicBezTo>
                  <a:pt x="223732" y="226532"/>
                  <a:pt x="221206" y="229469"/>
                  <a:pt x="219499" y="232882"/>
                </a:cubicBezTo>
                <a:cubicBezTo>
                  <a:pt x="218002" y="235875"/>
                  <a:pt x="218415" y="239794"/>
                  <a:pt x="216324" y="242407"/>
                </a:cubicBezTo>
                <a:cubicBezTo>
                  <a:pt x="213940" y="245387"/>
                  <a:pt x="209974" y="246640"/>
                  <a:pt x="206799" y="248757"/>
                </a:cubicBezTo>
                <a:lnTo>
                  <a:pt x="181399" y="286857"/>
                </a:lnTo>
                <a:lnTo>
                  <a:pt x="168699" y="305907"/>
                </a:lnTo>
                <a:cubicBezTo>
                  <a:pt x="166582" y="309082"/>
                  <a:pt x="162349" y="310140"/>
                  <a:pt x="159174" y="312257"/>
                </a:cubicBezTo>
                <a:cubicBezTo>
                  <a:pt x="158116" y="315432"/>
                  <a:pt x="158090" y="319169"/>
                  <a:pt x="155999" y="321782"/>
                </a:cubicBezTo>
                <a:cubicBezTo>
                  <a:pt x="153615" y="324762"/>
                  <a:pt x="149405" y="325689"/>
                  <a:pt x="146474" y="328132"/>
                </a:cubicBezTo>
                <a:cubicBezTo>
                  <a:pt x="143025" y="331007"/>
                  <a:pt x="140124" y="334482"/>
                  <a:pt x="136949" y="337657"/>
                </a:cubicBezTo>
                <a:cubicBezTo>
                  <a:pt x="135891" y="340832"/>
                  <a:pt x="135399" y="344256"/>
                  <a:pt x="133774" y="347182"/>
                </a:cubicBezTo>
                <a:cubicBezTo>
                  <a:pt x="130068" y="353853"/>
                  <a:pt x="125307" y="359882"/>
                  <a:pt x="121074" y="366232"/>
                </a:cubicBezTo>
                <a:lnTo>
                  <a:pt x="114724" y="375757"/>
                </a:lnTo>
                <a:lnTo>
                  <a:pt x="95674" y="404332"/>
                </a:lnTo>
                <a:cubicBezTo>
                  <a:pt x="93049" y="408270"/>
                  <a:pt x="91832" y="413018"/>
                  <a:pt x="89324" y="417032"/>
                </a:cubicBezTo>
                <a:cubicBezTo>
                  <a:pt x="86519" y="421519"/>
                  <a:pt x="82974" y="425499"/>
                  <a:pt x="79799" y="429732"/>
                </a:cubicBezTo>
                <a:cubicBezTo>
                  <a:pt x="78741" y="432907"/>
                  <a:pt x="78480" y="436472"/>
                  <a:pt x="76624" y="439257"/>
                </a:cubicBezTo>
                <a:cubicBezTo>
                  <a:pt x="66655" y="454211"/>
                  <a:pt x="67674" y="442725"/>
                  <a:pt x="60749" y="458307"/>
                </a:cubicBezTo>
                <a:cubicBezTo>
                  <a:pt x="58031" y="464424"/>
                  <a:pt x="58112" y="471788"/>
                  <a:pt x="54399" y="477357"/>
                </a:cubicBezTo>
                <a:cubicBezTo>
                  <a:pt x="52282" y="480532"/>
                  <a:pt x="49599" y="483395"/>
                  <a:pt x="48049" y="486882"/>
                </a:cubicBezTo>
                <a:cubicBezTo>
                  <a:pt x="45331" y="492999"/>
                  <a:pt x="45412" y="500363"/>
                  <a:pt x="41699" y="505932"/>
                </a:cubicBezTo>
                <a:cubicBezTo>
                  <a:pt x="39582" y="509107"/>
                  <a:pt x="36899" y="511970"/>
                  <a:pt x="35349" y="515457"/>
                </a:cubicBezTo>
                <a:cubicBezTo>
                  <a:pt x="32631" y="521574"/>
                  <a:pt x="31116" y="528157"/>
                  <a:pt x="28999" y="534507"/>
                </a:cubicBezTo>
                <a:lnTo>
                  <a:pt x="22649" y="553557"/>
                </a:lnTo>
                <a:cubicBezTo>
                  <a:pt x="21591" y="556732"/>
                  <a:pt x="21330" y="560297"/>
                  <a:pt x="19474" y="563082"/>
                </a:cubicBezTo>
                <a:lnTo>
                  <a:pt x="13124" y="572607"/>
                </a:lnTo>
                <a:cubicBezTo>
                  <a:pt x="12066" y="576840"/>
                  <a:pt x="11203" y="581127"/>
                  <a:pt x="9949" y="585307"/>
                </a:cubicBezTo>
                <a:cubicBezTo>
                  <a:pt x="8026" y="591718"/>
                  <a:pt x="3599" y="604357"/>
                  <a:pt x="3599" y="604357"/>
                </a:cubicBezTo>
                <a:cubicBezTo>
                  <a:pt x="-185" y="638411"/>
                  <a:pt x="-2120" y="640526"/>
                  <a:pt x="3599" y="680557"/>
                </a:cubicBezTo>
                <a:cubicBezTo>
                  <a:pt x="6383" y="700045"/>
                  <a:pt x="7101" y="697708"/>
                  <a:pt x="19474" y="705957"/>
                </a:cubicBezTo>
                <a:cubicBezTo>
                  <a:pt x="20532" y="709132"/>
                  <a:pt x="21152" y="712489"/>
                  <a:pt x="22649" y="715482"/>
                </a:cubicBezTo>
                <a:cubicBezTo>
                  <a:pt x="25984" y="722153"/>
                  <a:pt x="32779" y="730064"/>
                  <a:pt x="38524" y="734532"/>
                </a:cubicBezTo>
                <a:cubicBezTo>
                  <a:pt x="44548" y="739217"/>
                  <a:pt x="57574" y="747232"/>
                  <a:pt x="57574" y="747232"/>
                </a:cubicBezTo>
                <a:cubicBezTo>
                  <a:pt x="74507" y="772632"/>
                  <a:pt x="52282" y="741940"/>
                  <a:pt x="73449" y="763107"/>
                </a:cubicBezTo>
                <a:cubicBezTo>
                  <a:pt x="76147" y="765805"/>
                  <a:pt x="77356" y="769701"/>
                  <a:pt x="79799" y="772632"/>
                </a:cubicBezTo>
                <a:cubicBezTo>
                  <a:pt x="82674" y="776081"/>
                  <a:pt x="86567" y="778613"/>
                  <a:pt x="89324" y="782157"/>
                </a:cubicBezTo>
                <a:cubicBezTo>
                  <a:pt x="94009" y="788181"/>
                  <a:pt x="97791" y="794857"/>
                  <a:pt x="102024" y="801207"/>
                </a:cubicBezTo>
                <a:lnTo>
                  <a:pt x="108374" y="810732"/>
                </a:lnTo>
                <a:cubicBezTo>
                  <a:pt x="110865" y="814468"/>
                  <a:pt x="115142" y="816713"/>
                  <a:pt x="117899" y="820257"/>
                </a:cubicBezTo>
                <a:cubicBezTo>
                  <a:pt x="122584" y="826281"/>
                  <a:pt x="126366" y="832957"/>
                  <a:pt x="130599" y="839307"/>
                </a:cubicBezTo>
                <a:lnTo>
                  <a:pt x="143299" y="858357"/>
                </a:lnTo>
                <a:cubicBezTo>
                  <a:pt x="161679" y="885926"/>
                  <a:pt x="125613" y="847021"/>
                  <a:pt x="155999" y="877407"/>
                </a:cubicBezTo>
                <a:cubicBezTo>
                  <a:pt x="163979" y="901348"/>
                  <a:pt x="153214" y="871838"/>
                  <a:pt x="165524" y="896457"/>
                </a:cubicBezTo>
                <a:cubicBezTo>
                  <a:pt x="167021" y="899450"/>
                  <a:pt x="167381" y="902906"/>
                  <a:pt x="168699" y="905982"/>
                </a:cubicBezTo>
                <a:cubicBezTo>
                  <a:pt x="174557" y="919650"/>
                  <a:pt x="178721" y="924189"/>
                  <a:pt x="187749" y="937732"/>
                </a:cubicBezTo>
                <a:cubicBezTo>
                  <a:pt x="189866" y="940907"/>
                  <a:pt x="190924" y="945140"/>
                  <a:pt x="194099" y="947257"/>
                </a:cubicBezTo>
                <a:cubicBezTo>
                  <a:pt x="197274" y="949374"/>
                  <a:pt x="200772" y="951072"/>
                  <a:pt x="203624" y="953607"/>
                </a:cubicBezTo>
                <a:cubicBezTo>
                  <a:pt x="210336" y="959573"/>
                  <a:pt x="215202" y="967676"/>
                  <a:pt x="222674" y="972657"/>
                </a:cubicBezTo>
                <a:cubicBezTo>
                  <a:pt x="244509" y="987213"/>
                  <a:pt x="234484" y="982944"/>
                  <a:pt x="251249" y="988532"/>
                </a:cubicBezTo>
                <a:cubicBezTo>
                  <a:pt x="278546" y="1006730"/>
                  <a:pt x="244009" y="984912"/>
                  <a:pt x="270299" y="998057"/>
                </a:cubicBezTo>
                <a:cubicBezTo>
                  <a:pt x="273712" y="999764"/>
                  <a:pt x="276337" y="1002857"/>
                  <a:pt x="279824" y="1004407"/>
                </a:cubicBezTo>
                <a:cubicBezTo>
                  <a:pt x="285941" y="1007125"/>
                  <a:pt x="298874" y="1010757"/>
                  <a:pt x="298874" y="1010757"/>
                </a:cubicBezTo>
                <a:cubicBezTo>
                  <a:pt x="326171" y="1028955"/>
                  <a:pt x="291634" y="1007137"/>
                  <a:pt x="317924" y="1020282"/>
                </a:cubicBezTo>
                <a:cubicBezTo>
                  <a:pt x="321337" y="1021989"/>
                  <a:pt x="323962" y="1025082"/>
                  <a:pt x="327449" y="1026632"/>
                </a:cubicBezTo>
                <a:cubicBezTo>
                  <a:pt x="333566" y="1029350"/>
                  <a:pt x="340149" y="1030865"/>
                  <a:pt x="346499" y="1032982"/>
                </a:cubicBezTo>
                <a:lnTo>
                  <a:pt x="365549" y="1039332"/>
                </a:lnTo>
                <a:cubicBezTo>
                  <a:pt x="395212" y="1049220"/>
                  <a:pt x="363387" y="1041580"/>
                  <a:pt x="387774" y="1052032"/>
                </a:cubicBezTo>
                <a:cubicBezTo>
                  <a:pt x="391785" y="1053751"/>
                  <a:pt x="396149" y="1054630"/>
                  <a:pt x="400474" y="1055207"/>
                </a:cubicBezTo>
                <a:cubicBezTo>
                  <a:pt x="412061" y="1056752"/>
                  <a:pt x="423789" y="1057016"/>
                  <a:pt x="435399" y="1058382"/>
                </a:cubicBezTo>
                <a:cubicBezTo>
                  <a:pt x="441792" y="1059134"/>
                  <a:pt x="448099" y="1060499"/>
                  <a:pt x="454449" y="1061557"/>
                </a:cubicBezTo>
                <a:lnTo>
                  <a:pt x="502074" y="1077432"/>
                </a:lnTo>
                <a:cubicBezTo>
                  <a:pt x="508181" y="1079468"/>
                  <a:pt x="514774" y="1079549"/>
                  <a:pt x="521124" y="1080607"/>
                </a:cubicBezTo>
                <a:cubicBezTo>
                  <a:pt x="525616" y="1082104"/>
                  <a:pt x="539362" y="1086957"/>
                  <a:pt x="543349" y="1086957"/>
                </a:cubicBezTo>
                <a:cubicBezTo>
                  <a:pt x="556093" y="1086957"/>
                  <a:pt x="568749" y="1084840"/>
                  <a:pt x="581449" y="1083782"/>
                </a:cubicBezTo>
                <a:lnTo>
                  <a:pt x="600499" y="1077432"/>
                </a:lnTo>
                <a:lnTo>
                  <a:pt x="610024" y="1074257"/>
                </a:lnTo>
                <a:cubicBezTo>
                  <a:pt x="616374" y="1070024"/>
                  <a:pt x="621834" y="1063970"/>
                  <a:pt x="629074" y="1061557"/>
                </a:cubicBezTo>
                <a:lnTo>
                  <a:pt x="648124" y="1055207"/>
                </a:lnTo>
                <a:lnTo>
                  <a:pt x="667174" y="1042507"/>
                </a:lnTo>
                <a:cubicBezTo>
                  <a:pt x="670349" y="1040390"/>
                  <a:pt x="673079" y="1037364"/>
                  <a:pt x="676699" y="1036157"/>
                </a:cubicBezTo>
                <a:lnTo>
                  <a:pt x="686224" y="1032982"/>
                </a:lnTo>
                <a:cubicBezTo>
                  <a:pt x="688341" y="1029807"/>
                  <a:pt x="689594" y="1025841"/>
                  <a:pt x="692574" y="1023457"/>
                </a:cubicBezTo>
                <a:cubicBezTo>
                  <a:pt x="708543" y="1010682"/>
                  <a:pt x="702058" y="1039455"/>
                  <a:pt x="714799" y="1001232"/>
                </a:cubicBezTo>
                <a:cubicBezTo>
                  <a:pt x="720387" y="984467"/>
                  <a:pt x="716118" y="994492"/>
                  <a:pt x="730674" y="972657"/>
                </a:cubicBezTo>
                <a:cubicBezTo>
                  <a:pt x="732791" y="969482"/>
                  <a:pt x="735817" y="966752"/>
                  <a:pt x="737024" y="963132"/>
                </a:cubicBezTo>
                <a:cubicBezTo>
                  <a:pt x="748603" y="928394"/>
                  <a:pt x="730136" y="981011"/>
                  <a:pt x="746549" y="944082"/>
                </a:cubicBezTo>
                <a:cubicBezTo>
                  <a:pt x="761662" y="910077"/>
                  <a:pt x="744878" y="937063"/>
                  <a:pt x="759249" y="915507"/>
                </a:cubicBezTo>
                <a:cubicBezTo>
                  <a:pt x="760307" y="910215"/>
                  <a:pt x="761603" y="904966"/>
                  <a:pt x="762424" y="899632"/>
                </a:cubicBezTo>
                <a:cubicBezTo>
                  <a:pt x="765883" y="877151"/>
                  <a:pt x="766828" y="859489"/>
                  <a:pt x="768774" y="836132"/>
                </a:cubicBezTo>
                <a:cubicBezTo>
                  <a:pt x="767716" y="809674"/>
                  <a:pt x="767421" y="783174"/>
                  <a:pt x="765599" y="756757"/>
                </a:cubicBezTo>
                <a:cubicBezTo>
                  <a:pt x="765299" y="752404"/>
                  <a:pt x="763280" y="748336"/>
                  <a:pt x="762424" y="744057"/>
                </a:cubicBezTo>
                <a:cubicBezTo>
                  <a:pt x="756011" y="711991"/>
                  <a:pt x="763507" y="737782"/>
                  <a:pt x="752899" y="705957"/>
                </a:cubicBezTo>
                <a:lnTo>
                  <a:pt x="749724" y="696432"/>
                </a:lnTo>
                <a:cubicBezTo>
                  <a:pt x="748666" y="686907"/>
                  <a:pt x="748429" y="677255"/>
                  <a:pt x="746549" y="667857"/>
                </a:cubicBezTo>
                <a:cubicBezTo>
                  <a:pt x="745236" y="661293"/>
                  <a:pt x="742316" y="655157"/>
                  <a:pt x="740199" y="648807"/>
                </a:cubicBezTo>
                <a:cubicBezTo>
                  <a:pt x="735527" y="634792"/>
                  <a:pt x="738521" y="642275"/>
                  <a:pt x="730674" y="626582"/>
                </a:cubicBezTo>
                <a:cubicBezTo>
                  <a:pt x="729616" y="621290"/>
                  <a:pt x="728808" y="615942"/>
                  <a:pt x="727499" y="610707"/>
                </a:cubicBezTo>
                <a:cubicBezTo>
                  <a:pt x="726687" y="607460"/>
                  <a:pt x="724715" y="604506"/>
                  <a:pt x="724324" y="601182"/>
                </a:cubicBezTo>
                <a:cubicBezTo>
                  <a:pt x="722588" y="586429"/>
                  <a:pt x="722207" y="571549"/>
                  <a:pt x="721149" y="556732"/>
                </a:cubicBezTo>
                <a:cubicBezTo>
                  <a:pt x="724695" y="492899"/>
                  <a:pt x="718291" y="517682"/>
                  <a:pt x="730674" y="480532"/>
                </a:cubicBezTo>
                <a:cubicBezTo>
                  <a:pt x="731881" y="476912"/>
                  <a:pt x="734907" y="474182"/>
                  <a:pt x="737024" y="471007"/>
                </a:cubicBezTo>
                <a:cubicBezTo>
                  <a:pt x="741691" y="415003"/>
                  <a:pt x="741965" y="430818"/>
                  <a:pt x="737024" y="356707"/>
                </a:cubicBezTo>
                <a:cubicBezTo>
                  <a:pt x="735778" y="338023"/>
                  <a:pt x="734596" y="341858"/>
                  <a:pt x="730674" y="328132"/>
                </a:cubicBezTo>
                <a:cubicBezTo>
                  <a:pt x="729475" y="323936"/>
                  <a:pt x="728557" y="319665"/>
                  <a:pt x="727499" y="315432"/>
                </a:cubicBezTo>
                <a:cubicBezTo>
                  <a:pt x="722393" y="264368"/>
                  <a:pt x="728190" y="298802"/>
                  <a:pt x="721149" y="274157"/>
                </a:cubicBezTo>
                <a:cubicBezTo>
                  <a:pt x="719950" y="269961"/>
                  <a:pt x="719693" y="265468"/>
                  <a:pt x="717974" y="261457"/>
                </a:cubicBezTo>
                <a:cubicBezTo>
                  <a:pt x="716471" y="257950"/>
                  <a:pt x="713517" y="255245"/>
                  <a:pt x="711624" y="251932"/>
                </a:cubicBezTo>
                <a:cubicBezTo>
                  <a:pt x="704943" y="240240"/>
                  <a:pt x="702930" y="230538"/>
                  <a:pt x="692574" y="220182"/>
                </a:cubicBezTo>
                <a:cubicBezTo>
                  <a:pt x="680351" y="207959"/>
                  <a:pt x="685540" y="214393"/>
                  <a:pt x="676699" y="201132"/>
                </a:cubicBezTo>
                <a:cubicBezTo>
                  <a:pt x="675682" y="197063"/>
                  <a:pt x="672626" y="183462"/>
                  <a:pt x="670349" y="178907"/>
                </a:cubicBezTo>
                <a:cubicBezTo>
                  <a:pt x="668642" y="175494"/>
                  <a:pt x="665549" y="172869"/>
                  <a:pt x="663999" y="169382"/>
                </a:cubicBezTo>
                <a:cubicBezTo>
                  <a:pt x="661281" y="163265"/>
                  <a:pt x="661362" y="155901"/>
                  <a:pt x="657649" y="150332"/>
                </a:cubicBezTo>
                <a:cubicBezTo>
                  <a:pt x="655532" y="147157"/>
                  <a:pt x="653006" y="144220"/>
                  <a:pt x="651299" y="140807"/>
                </a:cubicBezTo>
                <a:cubicBezTo>
                  <a:pt x="646134" y="130478"/>
                  <a:pt x="650873" y="130856"/>
                  <a:pt x="641774" y="121757"/>
                </a:cubicBezTo>
                <a:cubicBezTo>
                  <a:pt x="639076" y="119059"/>
                  <a:pt x="635424" y="117524"/>
                  <a:pt x="632249" y="115407"/>
                </a:cubicBezTo>
                <a:cubicBezTo>
                  <a:pt x="625099" y="93957"/>
                  <a:pt x="635015" y="117207"/>
                  <a:pt x="619549" y="99532"/>
                </a:cubicBezTo>
                <a:cubicBezTo>
                  <a:pt x="614523" y="93789"/>
                  <a:pt x="613199" y="84715"/>
                  <a:pt x="606849" y="80482"/>
                </a:cubicBezTo>
                <a:lnTo>
                  <a:pt x="578274" y="61432"/>
                </a:lnTo>
                <a:cubicBezTo>
                  <a:pt x="575099" y="59315"/>
                  <a:pt x="571447" y="57780"/>
                  <a:pt x="568749" y="55082"/>
                </a:cubicBezTo>
                <a:cubicBezTo>
                  <a:pt x="556857" y="43190"/>
                  <a:pt x="563484" y="46977"/>
                  <a:pt x="549699" y="42382"/>
                </a:cubicBezTo>
                <a:cubicBezTo>
                  <a:pt x="546524" y="40265"/>
                  <a:pt x="543587" y="37739"/>
                  <a:pt x="540174" y="36032"/>
                </a:cubicBezTo>
                <a:cubicBezTo>
                  <a:pt x="537181" y="34535"/>
                  <a:pt x="533575" y="34482"/>
                  <a:pt x="530649" y="32857"/>
                </a:cubicBezTo>
                <a:cubicBezTo>
                  <a:pt x="523978" y="29151"/>
                  <a:pt x="519003" y="22008"/>
                  <a:pt x="511599" y="20157"/>
                </a:cubicBezTo>
                <a:cubicBezTo>
                  <a:pt x="479012" y="12010"/>
                  <a:pt x="493078" y="3753"/>
                  <a:pt x="486199" y="1107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8" name="フリーフォーム 47"/>
          <p:cNvSpPr/>
          <p:nvPr/>
        </p:nvSpPr>
        <p:spPr>
          <a:xfrm>
            <a:off x="7093917" y="1181265"/>
            <a:ext cx="1150491" cy="1008113"/>
          </a:xfrm>
          <a:custGeom>
            <a:avLst/>
            <a:gdLst>
              <a:gd name="connsiteX0" fmla="*/ 841375 w 1006475"/>
              <a:gd name="connsiteY0" fmla="*/ 239182 h 867832"/>
              <a:gd name="connsiteX1" fmla="*/ 784225 w 1006475"/>
              <a:gd name="connsiteY1" fmla="*/ 229657 h 867832"/>
              <a:gd name="connsiteX2" fmla="*/ 765175 w 1006475"/>
              <a:gd name="connsiteY2" fmla="*/ 223307 h 867832"/>
              <a:gd name="connsiteX3" fmla="*/ 755650 w 1006475"/>
              <a:gd name="connsiteY3" fmla="*/ 216957 h 867832"/>
              <a:gd name="connsiteX4" fmla="*/ 746125 w 1006475"/>
              <a:gd name="connsiteY4" fmla="*/ 213782 h 867832"/>
              <a:gd name="connsiteX5" fmla="*/ 727075 w 1006475"/>
              <a:gd name="connsiteY5" fmla="*/ 201082 h 867832"/>
              <a:gd name="connsiteX6" fmla="*/ 720725 w 1006475"/>
              <a:gd name="connsiteY6" fmla="*/ 191557 h 867832"/>
              <a:gd name="connsiteX7" fmla="*/ 711200 w 1006475"/>
              <a:gd name="connsiteY7" fmla="*/ 185207 h 867832"/>
              <a:gd name="connsiteX8" fmla="*/ 708025 w 1006475"/>
              <a:gd name="connsiteY8" fmla="*/ 175682 h 867832"/>
              <a:gd name="connsiteX9" fmla="*/ 688975 w 1006475"/>
              <a:gd name="connsiteY9" fmla="*/ 162982 h 867832"/>
              <a:gd name="connsiteX10" fmla="*/ 669925 w 1006475"/>
              <a:gd name="connsiteY10" fmla="*/ 153457 h 867832"/>
              <a:gd name="connsiteX11" fmla="*/ 660400 w 1006475"/>
              <a:gd name="connsiteY11" fmla="*/ 147107 h 867832"/>
              <a:gd name="connsiteX12" fmla="*/ 641350 w 1006475"/>
              <a:gd name="connsiteY12" fmla="*/ 143932 h 867832"/>
              <a:gd name="connsiteX13" fmla="*/ 625475 w 1006475"/>
              <a:gd name="connsiteY13" fmla="*/ 140757 h 867832"/>
              <a:gd name="connsiteX14" fmla="*/ 596900 w 1006475"/>
              <a:gd name="connsiteY14" fmla="*/ 124882 h 867832"/>
              <a:gd name="connsiteX15" fmla="*/ 581025 w 1006475"/>
              <a:gd name="connsiteY15" fmla="*/ 109007 h 867832"/>
              <a:gd name="connsiteX16" fmla="*/ 574675 w 1006475"/>
              <a:gd name="connsiteY16" fmla="*/ 99482 h 867832"/>
              <a:gd name="connsiteX17" fmla="*/ 546100 w 1006475"/>
              <a:gd name="connsiteY17" fmla="*/ 77257 h 867832"/>
              <a:gd name="connsiteX18" fmla="*/ 530225 w 1006475"/>
              <a:gd name="connsiteY18" fmla="*/ 58207 h 867832"/>
              <a:gd name="connsiteX19" fmla="*/ 520700 w 1006475"/>
              <a:gd name="connsiteY19" fmla="*/ 55032 h 867832"/>
              <a:gd name="connsiteX20" fmla="*/ 498475 w 1006475"/>
              <a:gd name="connsiteY20" fmla="*/ 32807 h 867832"/>
              <a:gd name="connsiteX21" fmla="*/ 488950 w 1006475"/>
              <a:gd name="connsiteY21" fmla="*/ 26457 h 867832"/>
              <a:gd name="connsiteX22" fmla="*/ 479425 w 1006475"/>
              <a:gd name="connsiteY22" fmla="*/ 16932 h 867832"/>
              <a:gd name="connsiteX23" fmla="*/ 460375 w 1006475"/>
              <a:gd name="connsiteY23" fmla="*/ 10582 h 867832"/>
              <a:gd name="connsiteX24" fmla="*/ 450850 w 1006475"/>
              <a:gd name="connsiteY24" fmla="*/ 4232 h 867832"/>
              <a:gd name="connsiteX25" fmla="*/ 390525 w 1006475"/>
              <a:gd name="connsiteY25" fmla="*/ 4232 h 867832"/>
              <a:gd name="connsiteX26" fmla="*/ 374650 w 1006475"/>
              <a:gd name="connsiteY26" fmla="*/ 7407 h 867832"/>
              <a:gd name="connsiteX27" fmla="*/ 361950 w 1006475"/>
              <a:gd name="connsiteY27" fmla="*/ 10582 h 867832"/>
              <a:gd name="connsiteX28" fmla="*/ 327025 w 1006475"/>
              <a:gd name="connsiteY28" fmla="*/ 13757 h 867832"/>
              <a:gd name="connsiteX29" fmla="*/ 209550 w 1006475"/>
              <a:gd name="connsiteY29" fmla="*/ 20107 h 867832"/>
              <a:gd name="connsiteX30" fmla="*/ 174625 w 1006475"/>
              <a:gd name="connsiteY30" fmla="*/ 26457 h 867832"/>
              <a:gd name="connsiteX31" fmla="*/ 155575 w 1006475"/>
              <a:gd name="connsiteY31" fmla="*/ 39157 h 867832"/>
              <a:gd name="connsiteX32" fmla="*/ 149225 w 1006475"/>
              <a:gd name="connsiteY32" fmla="*/ 48682 h 867832"/>
              <a:gd name="connsiteX33" fmla="*/ 130175 w 1006475"/>
              <a:gd name="connsiteY33" fmla="*/ 61382 h 867832"/>
              <a:gd name="connsiteX34" fmla="*/ 123825 w 1006475"/>
              <a:gd name="connsiteY34" fmla="*/ 70907 h 867832"/>
              <a:gd name="connsiteX35" fmla="*/ 114300 w 1006475"/>
              <a:gd name="connsiteY35" fmla="*/ 80432 h 867832"/>
              <a:gd name="connsiteX36" fmla="*/ 107950 w 1006475"/>
              <a:gd name="connsiteY36" fmla="*/ 99482 h 867832"/>
              <a:gd name="connsiteX37" fmla="*/ 95250 w 1006475"/>
              <a:gd name="connsiteY37" fmla="*/ 118532 h 867832"/>
              <a:gd name="connsiteX38" fmla="*/ 88900 w 1006475"/>
              <a:gd name="connsiteY38" fmla="*/ 137582 h 867832"/>
              <a:gd name="connsiteX39" fmla="*/ 79375 w 1006475"/>
              <a:gd name="connsiteY39" fmla="*/ 156632 h 867832"/>
              <a:gd name="connsiteX40" fmla="*/ 73025 w 1006475"/>
              <a:gd name="connsiteY40" fmla="*/ 166157 h 867832"/>
              <a:gd name="connsiteX41" fmla="*/ 66675 w 1006475"/>
              <a:gd name="connsiteY41" fmla="*/ 185207 h 867832"/>
              <a:gd name="connsiteX42" fmla="*/ 63500 w 1006475"/>
              <a:gd name="connsiteY42" fmla="*/ 194732 h 867832"/>
              <a:gd name="connsiteX43" fmla="*/ 50800 w 1006475"/>
              <a:gd name="connsiteY43" fmla="*/ 213782 h 867832"/>
              <a:gd name="connsiteX44" fmla="*/ 44450 w 1006475"/>
              <a:gd name="connsiteY44" fmla="*/ 236007 h 867832"/>
              <a:gd name="connsiteX45" fmla="*/ 38100 w 1006475"/>
              <a:gd name="connsiteY45" fmla="*/ 245532 h 867832"/>
              <a:gd name="connsiteX46" fmla="*/ 28575 w 1006475"/>
              <a:gd name="connsiteY46" fmla="*/ 264582 h 867832"/>
              <a:gd name="connsiteX47" fmla="*/ 15875 w 1006475"/>
              <a:gd name="connsiteY47" fmla="*/ 315382 h 867832"/>
              <a:gd name="connsiteX48" fmla="*/ 9525 w 1006475"/>
              <a:gd name="connsiteY48" fmla="*/ 324907 h 867832"/>
              <a:gd name="connsiteX49" fmla="*/ 6350 w 1006475"/>
              <a:gd name="connsiteY49" fmla="*/ 334432 h 867832"/>
              <a:gd name="connsiteX50" fmla="*/ 3175 w 1006475"/>
              <a:gd name="connsiteY50" fmla="*/ 359832 h 867832"/>
              <a:gd name="connsiteX51" fmla="*/ 0 w 1006475"/>
              <a:gd name="connsiteY51" fmla="*/ 369357 h 867832"/>
              <a:gd name="connsiteX52" fmla="*/ 6350 w 1006475"/>
              <a:gd name="connsiteY52" fmla="*/ 436032 h 867832"/>
              <a:gd name="connsiteX53" fmla="*/ 15875 w 1006475"/>
              <a:gd name="connsiteY53" fmla="*/ 467782 h 867832"/>
              <a:gd name="connsiteX54" fmla="*/ 22225 w 1006475"/>
              <a:gd name="connsiteY54" fmla="*/ 477307 h 867832"/>
              <a:gd name="connsiteX55" fmla="*/ 28575 w 1006475"/>
              <a:gd name="connsiteY55" fmla="*/ 496357 h 867832"/>
              <a:gd name="connsiteX56" fmla="*/ 34925 w 1006475"/>
              <a:gd name="connsiteY56" fmla="*/ 505882 h 867832"/>
              <a:gd name="connsiteX57" fmla="*/ 38100 w 1006475"/>
              <a:gd name="connsiteY57" fmla="*/ 515407 h 867832"/>
              <a:gd name="connsiteX58" fmla="*/ 44450 w 1006475"/>
              <a:gd name="connsiteY58" fmla="*/ 524932 h 867832"/>
              <a:gd name="connsiteX59" fmla="*/ 50800 w 1006475"/>
              <a:gd name="connsiteY59" fmla="*/ 543982 h 867832"/>
              <a:gd name="connsiteX60" fmla="*/ 57150 w 1006475"/>
              <a:gd name="connsiteY60" fmla="*/ 553507 h 867832"/>
              <a:gd name="connsiteX61" fmla="*/ 60325 w 1006475"/>
              <a:gd name="connsiteY61" fmla="*/ 563032 h 867832"/>
              <a:gd name="connsiteX62" fmla="*/ 69850 w 1006475"/>
              <a:gd name="connsiteY62" fmla="*/ 572557 h 867832"/>
              <a:gd name="connsiteX63" fmla="*/ 79375 w 1006475"/>
              <a:gd name="connsiteY63" fmla="*/ 591607 h 867832"/>
              <a:gd name="connsiteX64" fmla="*/ 82550 w 1006475"/>
              <a:gd name="connsiteY64" fmla="*/ 601132 h 867832"/>
              <a:gd name="connsiteX65" fmla="*/ 95250 w 1006475"/>
              <a:gd name="connsiteY65" fmla="*/ 620182 h 867832"/>
              <a:gd name="connsiteX66" fmla="*/ 101600 w 1006475"/>
              <a:gd name="connsiteY66" fmla="*/ 629707 h 867832"/>
              <a:gd name="connsiteX67" fmla="*/ 111125 w 1006475"/>
              <a:gd name="connsiteY67" fmla="*/ 639232 h 867832"/>
              <a:gd name="connsiteX68" fmla="*/ 123825 w 1006475"/>
              <a:gd name="connsiteY68" fmla="*/ 655107 h 867832"/>
              <a:gd name="connsiteX69" fmla="*/ 130175 w 1006475"/>
              <a:gd name="connsiteY69" fmla="*/ 664632 h 867832"/>
              <a:gd name="connsiteX70" fmla="*/ 133350 w 1006475"/>
              <a:gd name="connsiteY70" fmla="*/ 674157 h 867832"/>
              <a:gd name="connsiteX71" fmla="*/ 142875 w 1006475"/>
              <a:gd name="connsiteY71" fmla="*/ 677332 h 867832"/>
              <a:gd name="connsiteX72" fmla="*/ 152400 w 1006475"/>
              <a:gd name="connsiteY72" fmla="*/ 683682 h 867832"/>
              <a:gd name="connsiteX73" fmla="*/ 165100 w 1006475"/>
              <a:gd name="connsiteY73" fmla="*/ 696382 h 867832"/>
              <a:gd name="connsiteX74" fmla="*/ 193675 w 1006475"/>
              <a:gd name="connsiteY74" fmla="*/ 718607 h 867832"/>
              <a:gd name="connsiteX75" fmla="*/ 212725 w 1006475"/>
              <a:gd name="connsiteY75" fmla="*/ 731307 h 867832"/>
              <a:gd name="connsiteX76" fmla="*/ 231775 w 1006475"/>
              <a:gd name="connsiteY76" fmla="*/ 744007 h 867832"/>
              <a:gd name="connsiteX77" fmla="*/ 238125 w 1006475"/>
              <a:gd name="connsiteY77" fmla="*/ 753532 h 867832"/>
              <a:gd name="connsiteX78" fmla="*/ 266700 w 1006475"/>
              <a:gd name="connsiteY78" fmla="*/ 772582 h 867832"/>
              <a:gd name="connsiteX79" fmla="*/ 276225 w 1006475"/>
              <a:gd name="connsiteY79" fmla="*/ 778932 h 867832"/>
              <a:gd name="connsiteX80" fmla="*/ 285750 w 1006475"/>
              <a:gd name="connsiteY80" fmla="*/ 785282 h 867832"/>
              <a:gd name="connsiteX81" fmla="*/ 390525 w 1006475"/>
              <a:gd name="connsiteY81" fmla="*/ 782107 h 867832"/>
              <a:gd name="connsiteX82" fmla="*/ 406400 w 1006475"/>
              <a:gd name="connsiteY82" fmla="*/ 778932 h 867832"/>
              <a:gd name="connsiteX83" fmla="*/ 466725 w 1006475"/>
              <a:gd name="connsiteY83" fmla="*/ 782107 h 867832"/>
              <a:gd name="connsiteX84" fmla="*/ 501650 w 1006475"/>
              <a:gd name="connsiteY84" fmla="*/ 788457 h 867832"/>
              <a:gd name="connsiteX85" fmla="*/ 511175 w 1006475"/>
              <a:gd name="connsiteY85" fmla="*/ 791632 h 867832"/>
              <a:gd name="connsiteX86" fmla="*/ 523875 w 1006475"/>
              <a:gd name="connsiteY86" fmla="*/ 794807 h 867832"/>
              <a:gd name="connsiteX87" fmla="*/ 555625 w 1006475"/>
              <a:gd name="connsiteY87" fmla="*/ 804332 h 867832"/>
              <a:gd name="connsiteX88" fmla="*/ 612775 w 1006475"/>
              <a:gd name="connsiteY88" fmla="*/ 810682 h 867832"/>
              <a:gd name="connsiteX89" fmla="*/ 631825 w 1006475"/>
              <a:gd name="connsiteY89" fmla="*/ 817032 h 867832"/>
              <a:gd name="connsiteX90" fmla="*/ 641350 w 1006475"/>
              <a:gd name="connsiteY90" fmla="*/ 820207 h 867832"/>
              <a:gd name="connsiteX91" fmla="*/ 669925 w 1006475"/>
              <a:gd name="connsiteY91" fmla="*/ 832907 h 867832"/>
              <a:gd name="connsiteX92" fmla="*/ 679450 w 1006475"/>
              <a:gd name="connsiteY92" fmla="*/ 836082 h 867832"/>
              <a:gd name="connsiteX93" fmla="*/ 698500 w 1006475"/>
              <a:gd name="connsiteY93" fmla="*/ 848782 h 867832"/>
              <a:gd name="connsiteX94" fmla="*/ 746125 w 1006475"/>
              <a:gd name="connsiteY94" fmla="*/ 864657 h 867832"/>
              <a:gd name="connsiteX95" fmla="*/ 762000 w 1006475"/>
              <a:gd name="connsiteY95" fmla="*/ 867832 h 867832"/>
              <a:gd name="connsiteX96" fmla="*/ 796925 w 1006475"/>
              <a:gd name="connsiteY96" fmla="*/ 864657 h 867832"/>
              <a:gd name="connsiteX97" fmla="*/ 815975 w 1006475"/>
              <a:gd name="connsiteY97" fmla="*/ 858307 h 867832"/>
              <a:gd name="connsiteX98" fmla="*/ 825500 w 1006475"/>
              <a:gd name="connsiteY98" fmla="*/ 855132 h 867832"/>
              <a:gd name="connsiteX99" fmla="*/ 854075 w 1006475"/>
              <a:gd name="connsiteY99" fmla="*/ 836082 h 867832"/>
              <a:gd name="connsiteX100" fmla="*/ 873125 w 1006475"/>
              <a:gd name="connsiteY100" fmla="*/ 829732 h 867832"/>
              <a:gd name="connsiteX101" fmla="*/ 901700 w 1006475"/>
              <a:gd name="connsiteY101" fmla="*/ 810682 h 867832"/>
              <a:gd name="connsiteX102" fmla="*/ 920750 w 1006475"/>
              <a:gd name="connsiteY102" fmla="*/ 804332 h 867832"/>
              <a:gd name="connsiteX103" fmla="*/ 930275 w 1006475"/>
              <a:gd name="connsiteY103" fmla="*/ 794807 h 867832"/>
              <a:gd name="connsiteX104" fmla="*/ 933450 w 1006475"/>
              <a:gd name="connsiteY104" fmla="*/ 785282 h 867832"/>
              <a:gd name="connsiteX105" fmla="*/ 939800 w 1006475"/>
              <a:gd name="connsiteY105" fmla="*/ 775757 h 867832"/>
              <a:gd name="connsiteX106" fmla="*/ 952500 w 1006475"/>
              <a:gd name="connsiteY106" fmla="*/ 747182 h 867832"/>
              <a:gd name="connsiteX107" fmla="*/ 958850 w 1006475"/>
              <a:gd name="connsiteY107" fmla="*/ 724957 h 867832"/>
              <a:gd name="connsiteX108" fmla="*/ 965200 w 1006475"/>
              <a:gd name="connsiteY108" fmla="*/ 715432 h 867832"/>
              <a:gd name="connsiteX109" fmla="*/ 974725 w 1006475"/>
              <a:gd name="connsiteY109" fmla="*/ 683682 h 867832"/>
              <a:gd name="connsiteX110" fmla="*/ 981075 w 1006475"/>
              <a:gd name="connsiteY110" fmla="*/ 664632 h 867832"/>
              <a:gd name="connsiteX111" fmla="*/ 987425 w 1006475"/>
              <a:gd name="connsiteY111" fmla="*/ 655107 h 867832"/>
              <a:gd name="connsiteX112" fmla="*/ 993775 w 1006475"/>
              <a:gd name="connsiteY112" fmla="*/ 636057 h 867832"/>
              <a:gd name="connsiteX113" fmla="*/ 1003300 w 1006475"/>
              <a:gd name="connsiteY113" fmla="*/ 591607 h 867832"/>
              <a:gd name="connsiteX114" fmla="*/ 1006475 w 1006475"/>
              <a:gd name="connsiteY114" fmla="*/ 582082 h 867832"/>
              <a:gd name="connsiteX115" fmla="*/ 1000125 w 1006475"/>
              <a:gd name="connsiteY115" fmla="*/ 528107 h 867832"/>
              <a:gd name="connsiteX116" fmla="*/ 996950 w 1006475"/>
              <a:gd name="connsiteY116" fmla="*/ 518582 h 867832"/>
              <a:gd name="connsiteX117" fmla="*/ 993775 w 1006475"/>
              <a:gd name="connsiteY117" fmla="*/ 474132 h 867832"/>
              <a:gd name="connsiteX118" fmla="*/ 981075 w 1006475"/>
              <a:gd name="connsiteY118" fmla="*/ 445557 h 867832"/>
              <a:gd name="connsiteX119" fmla="*/ 974725 w 1006475"/>
              <a:gd name="connsiteY119" fmla="*/ 426507 h 867832"/>
              <a:gd name="connsiteX120" fmla="*/ 955675 w 1006475"/>
              <a:gd name="connsiteY120" fmla="*/ 397932 h 867832"/>
              <a:gd name="connsiteX121" fmla="*/ 952500 w 1006475"/>
              <a:gd name="connsiteY121" fmla="*/ 388407 h 867832"/>
              <a:gd name="connsiteX122" fmla="*/ 946150 w 1006475"/>
              <a:gd name="connsiteY122" fmla="*/ 378882 h 867832"/>
              <a:gd name="connsiteX123" fmla="*/ 942975 w 1006475"/>
              <a:gd name="connsiteY123" fmla="*/ 369357 h 867832"/>
              <a:gd name="connsiteX124" fmla="*/ 930275 w 1006475"/>
              <a:gd name="connsiteY124" fmla="*/ 350307 h 867832"/>
              <a:gd name="connsiteX125" fmla="*/ 917575 w 1006475"/>
              <a:gd name="connsiteY125" fmla="*/ 331257 h 867832"/>
              <a:gd name="connsiteX126" fmla="*/ 904875 w 1006475"/>
              <a:gd name="connsiteY126" fmla="*/ 315382 h 867832"/>
              <a:gd name="connsiteX127" fmla="*/ 889000 w 1006475"/>
              <a:gd name="connsiteY127" fmla="*/ 299507 h 867832"/>
              <a:gd name="connsiteX128" fmla="*/ 879475 w 1006475"/>
              <a:gd name="connsiteY128" fmla="*/ 280457 h 867832"/>
              <a:gd name="connsiteX129" fmla="*/ 869950 w 1006475"/>
              <a:gd name="connsiteY129" fmla="*/ 277282 h 867832"/>
              <a:gd name="connsiteX130" fmla="*/ 850900 w 1006475"/>
              <a:gd name="connsiteY130" fmla="*/ 264582 h 867832"/>
              <a:gd name="connsiteX131" fmla="*/ 841375 w 1006475"/>
              <a:gd name="connsiteY131" fmla="*/ 258232 h 867832"/>
              <a:gd name="connsiteX132" fmla="*/ 841375 w 1006475"/>
              <a:gd name="connsiteY132" fmla="*/ 239182 h 867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</a:cxnLst>
            <a:rect l="l" t="t" r="r" b="b"/>
            <a:pathLst>
              <a:path w="1006475" h="867832">
                <a:moveTo>
                  <a:pt x="841375" y="239182"/>
                </a:moveTo>
                <a:cubicBezTo>
                  <a:pt x="831850" y="234419"/>
                  <a:pt x="802784" y="235225"/>
                  <a:pt x="784225" y="229657"/>
                </a:cubicBezTo>
                <a:cubicBezTo>
                  <a:pt x="777814" y="227734"/>
                  <a:pt x="765175" y="223307"/>
                  <a:pt x="765175" y="223307"/>
                </a:cubicBezTo>
                <a:cubicBezTo>
                  <a:pt x="762000" y="221190"/>
                  <a:pt x="759063" y="218664"/>
                  <a:pt x="755650" y="216957"/>
                </a:cubicBezTo>
                <a:cubicBezTo>
                  <a:pt x="752657" y="215460"/>
                  <a:pt x="749051" y="215407"/>
                  <a:pt x="746125" y="213782"/>
                </a:cubicBezTo>
                <a:cubicBezTo>
                  <a:pt x="739454" y="210076"/>
                  <a:pt x="727075" y="201082"/>
                  <a:pt x="727075" y="201082"/>
                </a:cubicBezTo>
                <a:cubicBezTo>
                  <a:pt x="724958" y="197907"/>
                  <a:pt x="723423" y="194255"/>
                  <a:pt x="720725" y="191557"/>
                </a:cubicBezTo>
                <a:cubicBezTo>
                  <a:pt x="718027" y="188859"/>
                  <a:pt x="713584" y="188187"/>
                  <a:pt x="711200" y="185207"/>
                </a:cubicBezTo>
                <a:cubicBezTo>
                  <a:pt x="709109" y="182594"/>
                  <a:pt x="710392" y="178049"/>
                  <a:pt x="708025" y="175682"/>
                </a:cubicBezTo>
                <a:cubicBezTo>
                  <a:pt x="702629" y="170286"/>
                  <a:pt x="695325" y="167215"/>
                  <a:pt x="688975" y="162982"/>
                </a:cubicBezTo>
                <a:cubicBezTo>
                  <a:pt x="676665" y="154776"/>
                  <a:pt x="683070" y="157839"/>
                  <a:pt x="669925" y="153457"/>
                </a:cubicBezTo>
                <a:cubicBezTo>
                  <a:pt x="666750" y="151340"/>
                  <a:pt x="664020" y="148314"/>
                  <a:pt x="660400" y="147107"/>
                </a:cubicBezTo>
                <a:cubicBezTo>
                  <a:pt x="654293" y="145071"/>
                  <a:pt x="647684" y="145084"/>
                  <a:pt x="641350" y="143932"/>
                </a:cubicBezTo>
                <a:cubicBezTo>
                  <a:pt x="636041" y="142967"/>
                  <a:pt x="630767" y="141815"/>
                  <a:pt x="625475" y="140757"/>
                </a:cubicBezTo>
                <a:cubicBezTo>
                  <a:pt x="603640" y="126201"/>
                  <a:pt x="613665" y="130470"/>
                  <a:pt x="596900" y="124882"/>
                </a:cubicBezTo>
                <a:cubicBezTo>
                  <a:pt x="579967" y="99482"/>
                  <a:pt x="602192" y="130174"/>
                  <a:pt x="581025" y="109007"/>
                </a:cubicBezTo>
                <a:cubicBezTo>
                  <a:pt x="578327" y="106309"/>
                  <a:pt x="577118" y="102413"/>
                  <a:pt x="574675" y="99482"/>
                </a:cubicBezTo>
                <a:cubicBezTo>
                  <a:pt x="565349" y="88291"/>
                  <a:pt x="559375" y="86107"/>
                  <a:pt x="546100" y="77257"/>
                </a:cubicBezTo>
                <a:cubicBezTo>
                  <a:pt x="509820" y="53070"/>
                  <a:pt x="559510" y="81635"/>
                  <a:pt x="530225" y="58207"/>
                </a:cubicBezTo>
                <a:cubicBezTo>
                  <a:pt x="527612" y="56116"/>
                  <a:pt x="523875" y="56090"/>
                  <a:pt x="520700" y="55032"/>
                </a:cubicBezTo>
                <a:cubicBezTo>
                  <a:pt x="506144" y="33197"/>
                  <a:pt x="515240" y="38395"/>
                  <a:pt x="498475" y="32807"/>
                </a:cubicBezTo>
                <a:cubicBezTo>
                  <a:pt x="495300" y="30690"/>
                  <a:pt x="491881" y="28900"/>
                  <a:pt x="488950" y="26457"/>
                </a:cubicBezTo>
                <a:cubicBezTo>
                  <a:pt x="485501" y="23582"/>
                  <a:pt x="483350" y="19113"/>
                  <a:pt x="479425" y="16932"/>
                </a:cubicBezTo>
                <a:cubicBezTo>
                  <a:pt x="473574" y="13681"/>
                  <a:pt x="460375" y="10582"/>
                  <a:pt x="460375" y="10582"/>
                </a:cubicBezTo>
                <a:cubicBezTo>
                  <a:pt x="457200" y="8465"/>
                  <a:pt x="454263" y="5939"/>
                  <a:pt x="450850" y="4232"/>
                </a:cubicBezTo>
                <a:cubicBezTo>
                  <a:pt x="432821" y="-4783"/>
                  <a:pt x="406181" y="3254"/>
                  <a:pt x="390525" y="4232"/>
                </a:cubicBezTo>
                <a:cubicBezTo>
                  <a:pt x="385233" y="5290"/>
                  <a:pt x="379918" y="6236"/>
                  <a:pt x="374650" y="7407"/>
                </a:cubicBezTo>
                <a:cubicBezTo>
                  <a:pt x="370390" y="8354"/>
                  <a:pt x="366275" y="10005"/>
                  <a:pt x="361950" y="10582"/>
                </a:cubicBezTo>
                <a:cubicBezTo>
                  <a:pt x="350363" y="12127"/>
                  <a:pt x="338674" y="12786"/>
                  <a:pt x="327025" y="13757"/>
                </a:cubicBezTo>
                <a:cubicBezTo>
                  <a:pt x="270652" y="18455"/>
                  <a:pt x="280654" y="17144"/>
                  <a:pt x="209550" y="20107"/>
                </a:cubicBezTo>
                <a:cubicBezTo>
                  <a:pt x="204014" y="20799"/>
                  <a:pt x="183151" y="21721"/>
                  <a:pt x="174625" y="26457"/>
                </a:cubicBezTo>
                <a:cubicBezTo>
                  <a:pt x="167954" y="30163"/>
                  <a:pt x="155575" y="39157"/>
                  <a:pt x="155575" y="39157"/>
                </a:cubicBezTo>
                <a:cubicBezTo>
                  <a:pt x="153458" y="42332"/>
                  <a:pt x="152097" y="46169"/>
                  <a:pt x="149225" y="48682"/>
                </a:cubicBezTo>
                <a:cubicBezTo>
                  <a:pt x="143482" y="53708"/>
                  <a:pt x="130175" y="61382"/>
                  <a:pt x="130175" y="61382"/>
                </a:cubicBezTo>
                <a:cubicBezTo>
                  <a:pt x="128058" y="64557"/>
                  <a:pt x="126268" y="67976"/>
                  <a:pt x="123825" y="70907"/>
                </a:cubicBezTo>
                <a:cubicBezTo>
                  <a:pt x="120950" y="74356"/>
                  <a:pt x="116481" y="76507"/>
                  <a:pt x="114300" y="80432"/>
                </a:cubicBezTo>
                <a:cubicBezTo>
                  <a:pt x="111049" y="86283"/>
                  <a:pt x="110067" y="93132"/>
                  <a:pt x="107950" y="99482"/>
                </a:cubicBezTo>
                <a:cubicBezTo>
                  <a:pt x="105537" y="106722"/>
                  <a:pt x="99483" y="112182"/>
                  <a:pt x="95250" y="118532"/>
                </a:cubicBezTo>
                <a:cubicBezTo>
                  <a:pt x="91537" y="124101"/>
                  <a:pt x="92613" y="132013"/>
                  <a:pt x="88900" y="137582"/>
                </a:cubicBezTo>
                <a:cubicBezTo>
                  <a:pt x="70702" y="164879"/>
                  <a:pt x="92520" y="130342"/>
                  <a:pt x="79375" y="156632"/>
                </a:cubicBezTo>
                <a:cubicBezTo>
                  <a:pt x="77668" y="160045"/>
                  <a:pt x="74575" y="162670"/>
                  <a:pt x="73025" y="166157"/>
                </a:cubicBezTo>
                <a:cubicBezTo>
                  <a:pt x="70307" y="172274"/>
                  <a:pt x="68792" y="178857"/>
                  <a:pt x="66675" y="185207"/>
                </a:cubicBezTo>
                <a:lnTo>
                  <a:pt x="63500" y="194732"/>
                </a:lnTo>
                <a:cubicBezTo>
                  <a:pt x="61087" y="201972"/>
                  <a:pt x="50800" y="213782"/>
                  <a:pt x="50800" y="213782"/>
                </a:cubicBezTo>
                <a:cubicBezTo>
                  <a:pt x="49783" y="217851"/>
                  <a:pt x="46727" y="231452"/>
                  <a:pt x="44450" y="236007"/>
                </a:cubicBezTo>
                <a:cubicBezTo>
                  <a:pt x="42743" y="239420"/>
                  <a:pt x="39807" y="242119"/>
                  <a:pt x="38100" y="245532"/>
                </a:cubicBezTo>
                <a:cubicBezTo>
                  <a:pt x="24955" y="271822"/>
                  <a:pt x="46773" y="237285"/>
                  <a:pt x="28575" y="264582"/>
                </a:cubicBezTo>
                <a:cubicBezTo>
                  <a:pt x="20912" y="302896"/>
                  <a:pt x="25638" y="286093"/>
                  <a:pt x="15875" y="315382"/>
                </a:cubicBezTo>
                <a:cubicBezTo>
                  <a:pt x="14668" y="319002"/>
                  <a:pt x="11232" y="321494"/>
                  <a:pt x="9525" y="324907"/>
                </a:cubicBezTo>
                <a:cubicBezTo>
                  <a:pt x="8028" y="327900"/>
                  <a:pt x="7408" y="331257"/>
                  <a:pt x="6350" y="334432"/>
                </a:cubicBezTo>
                <a:cubicBezTo>
                  <a:pt x="5292" y="342899"/>
                  <a:pt x="4701" y="351437"/>
                  <a:pt x="3175" y="359832"/>
                </a:cubicBezTo>
                <a:cubicBezTo>
                  <a:pt x="2576" y="363125"/>
                  <a:pt x="0" y="366010"/>
                  <a:pt x="0" y="369357"/>
                </a:cubicBezTo>
                <a:cubicBezTo>
                  <a:pt x="0" y="391078"/>
                  <a:pt x="2017" y="414369"/>
                  <a:pt x="6350" y="436032"/>
                </a:cubicBezTo>
                <a:cubicBezTo>
                  <a:pt x="8749" y="448028"/>
                  <a:pt x="11825" y="455633"/>
                  <a:pt x="15875" y="467782"/>
                </a:cubicBezTo>
                <a:cubicBezTo>
                  <a:pt x="17082" y="471402"/>
                  <a:pt x="20675" y="473820"/>
                  <a:pt x="22225" y="477307"/>
                </a:cubicBezTo>
                <a:cubicBezTo>
                  <a:pt x="24943" y="483424"/>
                  <a:pt x="26458" y="490007"/>
                  <a:pt x="28575" y="496357"/>
                </a:cubicBezTo>
                <a:cubicBezTo>
                  <a:pt x="29782" y="499977"/>
                  <a:pt x="33218" y="502469"/>
                  <a:pt x="34925" y="505882"/>
                </a:cubicBezTo>
                <a:cubicBezTo>
                  <a:pt x="36422" y="508875"/>
                  <a:pt x="36603" y="512414"/>
                  <a:pt x="38100" y="515407"/>
                </a:cubicBezTo>
                <a:cubicBezTo>
                  <a:pt x="39807" y="518820"/>
                  <a:pt x="42900" y="521445"/>
                  <a:pt x="44450" y="524932"/>
                </a:cubicBezTo>
                <a:cubicBezTo>
                  <a:pt x="47168" y="531049"/>
                  <a:pt x="47087" y="538413"/>
                  <a:pt x="50800" y="543982"/>
                </a:cubicBezTo>
                <a:cubicBezTo>
                  <a:pt x="52917" y="547157"/>
                  <a:pt x="55443" y="550094"/>
                  <a:pt x="57150" y="553507"/>
                </a:cubicBezTo>
                <a:cubicBezTo>
                  <a:pt x="58647" y="556500"/>
                  <a:pt x="58469" y="560247"/>
                  <a:pt x="60325" y="563032"/>
                </a:cubicBezTo>
                <a:cubicBezTo>
                  <a:pt x="62816" y="566768"/>
                  <a:pt x="66675" y="569382"/>
                  <a:pt x="69850" y="572557"/>
                </a:cubicBezTo>
                <a:cubicBezTo>
                  <a:pt x="77830" y="596498"/>
                  <a:pt x="67065" y="566988"/>
                  <a:pt x="79375" y="591607"/>
                </a:cubicBezTo>
                <a:cubicBezTo>
                  <a:pt x="80872" y="594600"/>
                  <a:pt x="80925" y="598206"/>
                  <a:pt x="82550" y="601132"/>
                </a:cubicBezTo>
                <a:cubicBezTo>
                  <a:pt x="86256" y="607803"/>
                  <a:pt x="91017" y="613832"/>
                  <a:pt x="95250" y="620182"/>
                </a:cubicBezTo>
                <a:cubicBezTo>
                  <a:pt x="97367" y="623357"/>
                  <a:pt x="98902" y="627009"/>
                  <a:pt x="101600" y="629707"/>
                </a:cubicBezTo>
                <a:lnTo>
                  <a:pt x="111125" y="639232"/>
                </a:lnTo>
                <a:cubicBezTo>
                  <a:pt x="117306" y="657775"/>
                  <a:pt x="109464" y="640746"/>
                  <a:pt x="123825" y="655107"/>
                </a:cubicBezTo>
                <a:cubicBezTo>
                  <a:pt x="126523" y="657805"/>
                  <a:pt x="128468" y="661219"/>
                  <a:pt x="130175" y="664632"/>
                </a:cubicBezTo>
                <a:cubicBezTo>
                  <a:pt x="131672" y="667625"/>
                  <a:pt x="130983" y="671790"/>
                  <a:pt x="133350" y="674157"/>
                </a:cubicBezTo>
                <a:cubicBezTo>
                  <a:pt x="135717" y="676524"/>
                  <a:pt x="139700" y="676274"/>
                  <a:pt x="142875" y="677332"/>
                </a:cubicBezTo>
                <a:cubicBezTo>
                  <a:pt x="146050" y="679449"/>
                  <a:pt x="150016" y="680702"/>
                  <a:pt x="152400" y="683682"/>
                </a:cubicBezTo>
                <a:cubicBezTo>
                  <a:pt x="164715" y="699076"/>
                  <a:pt x="144318" y="689455"/>
                  <a:pt x="165100" y="696382"/>
                </a:cubicBezTo>
                <a:cubicBezTo>
                  <a:pt x="186517" y="717799"/>
                  <a:pt x="175631" y="712592"/>
                  <a:pt x="193675" y="718607"/>
                </a:cubicBezTo>
                <a:cubicBezTo>
                  <a:pt x="200025" y="722840"/>
                  <a:pt x="207329" y="725911"/>
                  <a:pt x="212725" y="731307"/>
                </a:cubicBezTo>
                <a:cubicBezTo>
                  <a:pt x="224617" y="743199"/>
                  <a:pt x="217990" y="739412"/>
                  <a:pt x="231775" y="744007"/>
                </a:cubicBezTo>
                <a:cubicBezTo>
                  <a:pt x="233892" y="747182"/>
                  <a:pt x="235253" y="751019"/>
                  <a:pt x="238125" y="753532"/>
                </a:cubicBezTo>
                <a:lnTo>
                  <a:pt x="266700" y="772582"/>
                </a:lnTo>
                <a:lnTo>
                  <a:pt x="276225" y="778932"/>
                </a:lnTo>
                <a:lnTo>
                  <a:pt x="285750" y="785282"/>
                </a:lnTo>
                <a:cubicBezTo>
                  <a:pt x="320675" y="784224"/>
                  <a:pt x="355632" y="783943"/>
                  <a:pt x="390525" y="782107"/>
                </a:cubicBezTo>
                <a:cubicBezTo>
                  <a:pt x="395914" y="781823"/>
                  <a:pt x="401004" y="778932"/>
                  <a:pt x="406400" y="778932"/>
                </a:cubicBezTo>
                <a:cubicBezTo>
                  <a:pt x="426536" y="778932"/>
                  <a:pt x="446617" y="781049"/>
                  <a:pt x="466725" y="782107"/>
                </a:cubicBezTo>
                <a:cubicBezTo>
                  <a:pt x="475217" y="783522"/>
                  <a:pt x="492775" y="786238"/>
                  <a:pt x="501650" y="788457"/>
                </a:cubicBezTo>
                <a:cubicBezTo>
                  <a:pt x="504897" y="789269"/>
                  <a:pt x="507957" y="790713"/>
                  <a:pt x="511175" y="791632"/>
                </a:cubicBezTo>
                <a:cubicBezTo>
                  <a:pt x="515371" y="792831"/>
                  <a:pt x="519695" y="793553"/>
                  <a:pt x="523875" y="794807"/>
                </a:cubicBezTo>
                <a:cubicBezTo>
                  <a:pt x="534461" y="797983"/>
                  <a:pt x="544648" y="802502"/>
                  <a:pt x="555625" y="804332"/>
                </a:cubicBezTo>
                <a:cubicBezTo>
                  <a:pt x="569108" y="806579"/>
                  <a:pt x="600546" y="809459"/>
                  <a:pt x="612775" y="810682"/>
                </a:cubicBezTo>
                <a:lnTo>
                  <a:pt x="631825" y="817032"/>
                </a:lnTo>
                <a:lnTo>
                  <a:pt x="641350" y="820207"/>
                </a:lnTo>
                <a:cubicBezTo>
                  <a:pt x="656444" y="830270"/>
                  <a:pt x="647255" y="825350"/>
                  <a:pt x="669925" y="832907"/>
                </a:cubicBezTo>
                <a:lnTo>
                  <a:pt x="679450" y="836082"/>
                </a:lnTo>
                <a:cubicBezTo>
                  <a:pt x="685800" y="840315"/>
                  <a:pt x="691260" y="846369"/>
                  <a:pt x="698500" y="848782"/>
                </a:cubicBezTo>
                <a:lnTo>
                  <a:pt x="746125" y="864657"/>
                </a:lnTo>
                <a:cubicBezTo>
                  <a:pt x="751245" y="866364"/>
                  <a:pt x="756708" y="866774"/>
                  <a:pt x="762000" y="867832"/>
                </a:cubicBezTo>
                <a:cubicBezTo>
                  <a:pt x="773642" y="866774"/>
                  <a:pt x="785413" y="866688"/>
                  <a:pt x="796925" y="864657"/>
                </a:cubicBezTo>
                <a:cubicBezTo>
                  <a:pt x="803517" y="863494"/>
                  <a:pt x="809625" y="860424"/>
                  <a:pt x="815975" y="858307"/>
                </a:cubicBezTo>
                <a:lnTo>
                  <a:pt x="825500" y="855132"/>
                </a:lnTo>
                <a:lnTo>
                  <a:pt x="854075" y="836082"/>
                </a:lnTo>
                <a:cubicBezTo>
                  <a:pt x="859644" y="832369"/>
                  <a:pt x="873125" y="829732"/>
                  <a:pt x="873125" y="829732"/>
                </a:cubicBezTo>
                <a:lnTo>
                  <a:pt x="901700" y="810682"/>
                </a:lnTo>
                <a:cubicBezTo>
                  <a:pt x="907269" y="806969"/>
                  <a:pt x="920750" y="804332"/>
                  <a:pt x="920750" y="804332"/>
                </a:cubicBezTo>
                <a:cubicBezTo>
                  <a:pt x="923925" y="801157"/>
                  <a:pt x="927784" y="798543"/>
                  <a:pt x="930275" y="794807"/>
                </a:cubicBezTo>
                <a:cubicBezTo>
                  <a:pt x="932131" y="792022"/>
                  <a:pt x="931953" y="788275"/>
                  <a:pt x="933450" y="785282"/>
                </a:cubicBezTo>
                <a:cubicBezTo>
                  <a:pt x="935157" y="781869"/>
                  <a:pt x="938250" y="779244"/>
                  <a:pt x="939800" y="775757"/>
                </a:cubicBezTo>
                <a:cubicBezTo>
                  <a:pt x="954913" y="741752"/>
                  <a:pt x="938129" y="768738"/>
                  <a:pt x="952500" y="747182"/>
                </a:cubicBezTo>
                <a:cubicBezTo>
                  <a:pt x="953517" y="743113"/>
                  <a:pt x="956573" y="729512"/>
                  <a:pt x="958850" y="724957"/>
                </a:cubicBezTo>
                <a:cubicBezTo>
                  <a:pt x="960557" y="721544"/>
                  <a:pt x="963650" y="718919"/>
                  <a:pt x="965200" y="715432"/>
                </a:cubicBezTo>
                <a:cubicBezTo>
                  <a:pt x="972108" y="699889"/>
                  <a:pt x="970462" y="697890"/>
                  <a:pt x="974725" y="683682"/>
                </a:cubicBezTo>
                <a:cubicBezTo>
                  <a:pt x="976648" y="677271"/>
                  <a:pt x="978958" y="670982"/>
                  <a:pt x="981075" y="664632"/>
                </a:cubicBezTo>
                <a:cubicBezTo>
                  <a:pt x="982282" y="661012"/>
                  <a:pt x="985875" y="658594"/>
                  <a:pt x="987425" y="655107"/>
                </a:cubicBezTo>
                <a:cubicBezTo>
                  <a:pt x="990143" y="648990"/>
                  <a:pt x="993775" y="636057"/>
                  <a:pt x="993775" y="636057"/>
                </a:cubicBezTo>
                <a:cubicBezTo>
                  <a:pt x="997780" y="604015"/>
                  <a:pt x="994252" y="618752"/>
                  <a:pt x="1003300" y="591607"/>
                </a:cubicBezTo>
                <a:lnTo>
                  <a:pt x="1006475" y="582082"/>
                </a:lnTo>
                <a:cubicBezTo>
                  <a:pt x="1004527" y="558704"/>
                  <a:pt x="1005090" y="547967"/>
                  <a:pt x="1000125" y="528107"/>
                </a:cubicBezTo>
                <a:cubicBezTo>
                  <a:pt x="999313" y="524860"/>
                  <a:pt x="998008" y="521757"/>
                  <a:pt x="996950" y="518582"/>
                </a:cubicBezTo>
                <a:cubicBezTo>
                  <a:pt x="995892" y="503765"/>
                  <a:pt x="995979" y="488822"/>
                  <a:pt x="993775" y="474132"/>
                </a:cubicBezTo>
                <a:cubicBezTo>
                  <a:pt x="989494" y="445594"/>
                  <a:pt x="989270" y="463996"/>
                  <a:pt x="981075" y="445557"/>
                </a:cubicBezTo>
                <a:cubicBezTo>
                  <a:pt x="978357" y="439440"/>
                  <a:pt x="976842" y="432857"/>
                  <a:pt x="974725" y="426507"/>
                </a:cubicBezTo>
                <a:lnTo>
                  <a:pt x="955675" y="397932"/>
                </a:lnTo>
                <a:cubicBezTo>
                  <a:pt x="953819" y="395147"/>
                  <a:pt x="953997" y="391400"/>
                  <a:pt x="952500" y="388407"/>
                </a:cubicBezTo>
                <a:cubicBezTo>
                  <a:pt x="950793" y="384994"/>
                  <a:pt x="947857" y="382295"/>
                  <a:pt x="946150" y="378882"/>
                </a:cubicBezTo>
                <a:cubicBezTo>
                  <a:pt x="944653" y="375889"/>
                  <a:pt x="944600" y="372283"/>
                  <a:pt x="942975" y="369357"/>
                </a:cubicBezTo>
                <a:cubicBezTo>
                  <a:pt x="939269" y="362686"/>
                  <a:pt x="932688" y="357547"/>
                  <a:pt x="930275" y="350307"/>
                </a:cubicBezTo>
                <a:cubicBezTo>
                  <a:pt x="925680" y="336522"/>
                  <a:pt x="929467" y="343149"/>
                  <a:pt x="917575" y="331257"/>
                </a:cubicBezTo>
                <a:cubicBezTo>
                  <a:pt x="911394" y="312714"/>
                  <a:pt x="919236" y="329743"/>
                  <a:pt x="904875" y="315382"/>
                </a:cubicBezTo>
                <a:cubicBezTo>
                  <a:pt x="883708" y="294215"/>
                  <a:pt x="914400" y="316440"/>
                  <a:pt x="889000" y="299507"/>
                </a:cubicBezTo>
                <a:cubicBezTo>
                  <a:pt x="886908" y="293232"/>
                  <a:pt x="885070" y="284933"/>
                  <a:pt x="879475" y="280457"/>
                </a:cubicBezTo>
                <a:cubicBezTo>
                  <a:pt x="876862" y="278366"/>
                  <a:pt x="873125" y="278340"/>
                  <a:pt x="869950" y="277282"/>
                </a:cubicBezTo>
                <a:lnTo>
                  <a:pt x="850900" y="264582"/>
                </a:lnTo>
                <a:cubicBezTo>
                  <a:pt x="847725" y="262465"/>
                  <a:pt x="845077" y="259157"/>
                  <a:pt x="841375" y="258232"/>
                </a:cubicBezTo>
                <a:cubicBezTo>
                  <a:pt x="826622" y="254544"/>
                  <a:pt x="850900" y="243945"/>
                  <a:pt x="841375" y="239182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5298348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5</TotalTime>
  <Words>48</Words>
  <Application>Microsoft Office PowerPoint</Application>
  <PresentationFormat>画面に合わせる (4:3)</PresentationFormat>
  <Paragraphs>28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Office ​​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nori</dc:creator>
  <cp:lastModifiedBy>Yoshinori</cp:lastModifiedBy>
  <cp:revision>37</cp:revision>
  <cp:lastPrinted>2012-12-12T09:07:08Z</cp:lastPrinted>
  <dcterms:created xsi:type="dcterms:W3CDTF">2012-11-08T08:31:02Z</dcterms:created>
  <dcterms:modified xsi:type="dcterms:W3CDTF">2013-06-18T01:53:42Z</dcterms:modified>
</cp:coreProperties>
</file>